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Ex1.xml" ContentType="application/vnd.ms-office.chartex+xml"/>
  <Override PartName="/ppt/charts/style1.xml" ContentType="application/vnd.ms-office.chartstyle+xml"/>
  <Override PartName="/ppt/charts/colors1.xml" ContentType="application/vnd.ms-office.chartcolorstyle+xml"/>
  <Override PartName="/ppt/charts/chartEx2.xml" ContentType="application/vnd.ms-office.chartex+xml"/>
  <Override PartName="/ppt/charts/style2.xml" ContentType="application/vnd.ms-office.chartstyle+xml"/>
  <Override PartName="/ppt/charts/colors2.xml" ContentType="application/vnd.ms-office.chartcolorstyle+xml"/>
  <Override PartName="/ppt/charts/chartEx3.xml" ContentType="application/vnd.ms-office.chartex+xml"/>
  <Override PartName="/ppt/charts/style3.xml" ContentType="application/vnd.ms-office.chartstyle+xml"/>
  <Override PartName="/ppt/charts/colors3.xml" ContentType="application/vnd.ms-office.chartcolorstyle+xml"/>
  <Override PartName="/ppt/charts/chartEx4.xml" ContentType="application/vnd.ms-office.chartex+xml"/>
  <Override PartName="/ppt/charts/style4.xml" ContentType="application/vnd.ms-office.chartstyle+xml"/>
  <Override PartName="/ppt/charts/colors4.xml" ContentType="application/vnd.ms-office.chartcolorstyle+xml"/>
  <Override PartName="/ppt/charts/chartEx5.xml" ContentType="application/vnd.ms-office.chartex+xml"/>
  <Override PartName="/ppt/charts/style5.xml" ContentType="application/vnd.ms-office.chartstyle+xml"/>
  <Override PartName="/ppt/charts/colors5.xml" ContentType="application/vnd.ms-office.chartcolorstyle+xml"/>
  <Override PartName="/ppt/charts/chartEx6.xml" ContentType="application/vnd.ms-office.chartex+xml"/>
  <Override PartName="/ppt/charts/style6.xml" ContentType="application/vnd.ms-office.chartstyle+xml"/>
  <Override PartName="/ppt/charts/colors6.xml" ContentType="application/vnd.ms-office.chartcolorstyle+xml"/>
  <Override PartName="/ppt/charts/chartEx7.xml" ContentType="application/vnd.ms-office.chartex+xml"/>
  <Override PartName="/ppt/charts/style7.xml" ContentType="application/vnd.ms-office.chartstyle+xml"/>
  <Override PartName="/ppt/charts/colors7.xml" ContentType="application/vnd.ms-office.chartcolorstyle+xml"/>
  <Override PartName="/ppt/charts/chartEx8.xml" ContentType="application/vnd.ms-office.chartex+xml"/>
  <Override PartName="/ppt/charts/style8.xml" ContentType="application/vnd.ms-office.chartstyle+xml"/>
  <Override PartName="/ppt/charts/colors8.xml" ContentType="application/vnd.ms-office.chartcolorstyle+xml"/>
  <Override PartName="/ppt/charts/chartEx9.xml" ContentType="application/vnd.ms-office.chartex+xml"/>
  <Override PartName="/ppt/charts/style9.xml" ContentType="application/vnd.ms-office.chartstyle+xml"/>
  <Override PartName="/ppt/charts/colors9.xml" ContentType="application/vnd.ms-office.chartcolorstyle+xml"/>
  <Override PartName="/ppt/charts/chartEx10.xml" ContentType="application/vnd.ms-office.chartex+xml"/>
  <Override PartName="/ppt/charts/style10.xml" ContentType="application/vnd.ms-office.chartstyle+xml"/>
  <Override PartName="/ppt/charts/colors10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FBFB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03" autoAdjust="0"/>
    <p:restoredTop sz="94660"/>
  </p:normalViewPr>
  <p:slideViewPr>
    <p:cSldViewPr snapToGrid="0">
      <p:cViewPr varScale="1">
        <p:scale>
          <a:sx n="72" d="100"/>
          <a:sy n="72" d="100"/>
        </p:scale>
        <p:origin x="53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Ex1.xml.rels><?xml version="1.0" encoding="UTF-8" standalone="yes"?>
<Relationships xmlns="http://schemas.openxmlformats.org/package/2006/relationships"><Relationship Id="rId3" Type="http://schemas.microsoft.com/office/2011/relationships/chartColorStyle" Target="colors1.xml"/><Relationship Id="rId2" Type="http://schemas.microsoft.com/office/2011/relationships/chartStyle" Target="style1.xml"/><Relationship Id="rId1" Type="http://schemas.openxmlformats.org/officeDocument/2006/relationships/oleObject" Target="NULL" TargetMode="External"/></Relationships>
</file>

<file path=ppt/charts/_rels/chartEx10.xml.rels><?xml version="1.0" encoding="UTF-8" standalone="yes"?>
<Relationships xmlns="http://schemas.openxmlformats.org/package/2006/relationships"><Relationship Id="rId3" Type="http://schemas.microsoft.com/office/2011/relationships/chartColorStyle" Target="colors10.xml"/><Relationship Id="rId2" Type="http://schemas.microsoft.com/office/2011/relationships/chartStyle" Target="style10.xml"/><Relationship Id="rId1" Type="http://schemas.openxmlformats.org/officeDocument/2006/relationships/oleObject" Target="NULL" TargetMode="External"/></Relationships>
</file>

<file path=ppt/charts/_rels/chartEx2.xml.rels><?xml version="1.0" encoding="UTF-8" standalone="yes"?>
<Relationships xmlns="http://schemas.openxmlformats.org/package/2006/relationships"><Relationship Id="rId3" Type="http://schemas.microsoft.com/office/2011/relationships/chartColorStyle" Target="colors2.xml"/><Relationship Id="rId2" Type="http://schemas.microsoft.com/office/2011/relationships/chartStyle" Target="style2.xml"/><Relationship Id="rId1" Type="http://schemas.openxmlformats.org/officeDocument/2006/relationships/oleObject" Target="NULL" TargetMode="External"/></Relationships>
</file>

<file path=ppt/charts/_rels/chartEx3.xml.rels><?xml version="1.0" encoding="UTF-8" standalone="yes"?>
<Relationships xmlns="http://schemas.openxmlformats.org/package/2006/relationships"><Relationship Id="rId3" Type="http://schemas.microsoft.com/office/2011/relationships/chartColorStyle" Target="colors3.xml"/><Relationship Id="rId2" Type="http://schemas.microsoft.com/office/2011/relationships/chartStyle" Target="style3.xml"/><Relationship Id="rId1" Type="http://schemas.openxmlformats.org/officeDocument/2006/relationships/oleObject" Target="NULL" TargetMode="External"/></Relationships>
</file>

<file path=ppt/charts/_rels/chartEx4.xml.rels><?xml version="1.0" encoding="UTF-8" standalone="yes"?>
<Relationships xmlns="http://schemas.openxmlformats.org/package/2006/relationships"><Relationship Id="rId3" Type="http://schemas.microsoft.com/office/2011/relationships/chartColorStyle" Target="colors4.xml"/><Relationship Id="rId2" Type="http://schemas.microsoft.com/office/2011/relationships/chartStyle" Target="style4.xml"/><Relationship Id="rId1" Type="http://schemas.openxmlformats.org/officeDocument/2006/relationships/oleObject" Target="NULL" TargetMode="External"/></Relationships>
</file>

<file path=ppt/charts/_rels/chartEx5.xml.rels><?xml version="1.0" encoding="UTF-8" standalone="yes"?>
<Relationships xmlns="http://schemas.openxmlformats.org/package/2006/relationships"><Relationship Id="rId3" Type="http://schemas.microsoft.com/office/2011/relationships/chartColorStyle" Target="colors5.xml"/><Relationship Id="rId2" Type="http://schemas.microsoft.com/office/2011/relationships/chartStyle" Target="style5.xml"/><Relationship Id="rId1" Type="http://schemas.openxmlformats.org/officeDocument/2006/relationships/oleObject" Target="NULL" TargetMode="External"/></Relationships>
</file>

<file path=ppt/charts/_rels/chartEx6.xml.rels><?xml version="1.0" encoding="UTF-8" standalone="yes"?>
<Relationships xmlns="http://schemas.openxmlformats.org/package/2006/relationships"><Relationship Id="rId3" Type="http://schemas.microsoft.com/office/2011/relationships/chartColorStyle" Target="colors6.xml"/><Relationship Id="rId2" Type="http://schemas.microsoft.com/office/2011/relationships/chartStyle" Target="style6.xml"/><Relationship Id="rId1" Type="http://schemas.openxmlformats.org/officeDocument/2006/relationships/oleObject" Target="NULL" TargetMode="External"/></Relationships>
</file>

<file path=ppt/charts/_rels/chartEx7.xml.rels><?xml version="1.0" encoding="UTF-8" standalone="yes"?>
<Relationships xmlns="http://schemas.openxmlformats.org/package/2006/relationships"><Relationship Id="rId3" Type="http://schemas.microsoft.com/office/2011/relationships/chartColorStyle" Target="colors7.xml"/><Relationship Id="rId2" Type="http://schemas.microsoft.com/office/2011/relationships/chartStyle" Target="style7.xml"/><Relationship Id="rId1" Type="http://schemas.openxmlformats.org/officeDocument/2006/relationships/oleObject" Target="NULL" TargetMode="External"/></Relationships>
</file>

<file path=ppt/charts/_rels/chartEx8.xml.rels><?xml version="1.0" encoding="UTF-8" standalone="yes"?>
<Relationships xmlns="http://schemas.openxmlformats.org/package/2006/relationships"><Relationship Id="rId3" Type="http://schemas.microsoft.com/office/2011/relationships/chartColorStyle" Target="colors8.xml"/><Relationship Id="rId2" Type="http://schemas.microsoft.com/office/2011/relationships/chartStyle" Target="style8.xml"/><Relationship Id="rId1" Type="http://schemas.openxmlformats.org/officeDocument/2006/relationships/oleObject" Target="NULL" TargetMode="External"/></Relationships>
</file>

<file path=ppt/charts/_rels/chartEx9.xml.rels><?xml version="1.0" encoding="UTF-8" standalone="yes"?>
<Relationships xmlns="http://schemas.openxmlformats.org/package/2006/relationships"><Relationship Id="rId3" Type="http://schemas.microsoft.com/office/2011/relationships/chartColorStyle" Target="colors9.xml"/><Relationship Id="rId2" Type="http://schemas.microsoft.com/office/2011/relationships/chartStyle" Target="style9.xml"/><Relationship Id="rId1" Type="http://schemas.openxmlformats.org/officeDocument/2006/relationships/oleObject" Target="NULL" TargetMode="External"/></Relationships>
</file>

<file path=ppt/charts/chartEx1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lvl ptCount="520">
          <cx:pt idx="0">Copra, ITS-VWD, Plisten</cx:pt>
          <cx:pt idx="1">Copra, ITS-VWD, Plisten</cx:pt>
          <cx:pt idx="2">Copra, ITS-VWD, Plisten</cx:pt>
          <cx:pt idx="3">Copra, ITS-VWD, Plisten</cx:pt>
          <cx:pt idx="4">Copra, ITS-VWD, Plisten</cx:pt>
          <cx:pt idx="5">Copra, ITS-VWD, Plisten</cx:pt>
          <cx:pt idx="6">Copra, ITS-VWD, Plisten</cx:pt>
          <cx:pt idx="7">Copra, ITS-VWD, Plisten</cx:pt>
          <cx:pt idx="8">Copra, ITS-VWD, Plisten</cx:pt>
          <cx:pt idx="9">Copra, ITS-VWD, Plisten</cx:pt>
          <cx:pt idx="10">Copra, ITS-VWD, Plisten</cx:pt>
          <cx:pt idx="11">Copra, ITS-VWD, Plisten</cx:pt>
          <cx:pt idx="12">Copra, ITS-VWD, Plisten</cx:pt>
          <cx:pt idx="13">Copra, ITS-VWD, Plisten</cx:pt>
          <cx:pt idx="14">Copra, ITS-VWD, Plisten</cx:pt>
          <cx:pt idx="15">Copra, ITS-VWD, Plisten</cx:pt>
          <cx:pt idx="16">Copra, ITS-VWD, Plisten</cx:pt>
          <cx:pt idx="17">Copra, ITS-VWD, Plisten</cx:pt>
          <cx:pt idx="18">Copra, ITS-VWD, Plisten</cx:pt>
          <cx:pt idx="19">Copra, ITS-VWD, Plisten</cx:pt>
          <cx:pt idx="20">Copra, ITS-VWD, Plisten</cx:pt>
          <cx:pt idx="21">Copra, ITS-VWD, Plisten</cx:pt>
          <cx:pt idx="22">Copra, ITS-VWD, Plisten</cx:pt>
          <cx:pt idx="23">Copra, ITS-VWD, Plisten</cx:pt>
          <cx:pt idx="24">Copra, ITS-VWD, Plisten</cx:pt>
          <cx:pt idx="25">Copra, ITS-VWD, Plisten</cx:pt>
          <cx:pt idx="26">Copra, ITS-VWD, Plisten</cx:pt>
          <cx:pt idx="27">Copra, ITS-VWD, Plisten</cx:pt>
          <cx:pt idx="28">Copra, ITS-VWD, Plisten</cx:pt>
          <cx:pt idx="29">Copra, ITS-VWD, Plisten</cx:pt>
          <cx:pt idx="30">Copra, ITS-VWD, Plisten</cx:pt>
          <cx:pt idx="31">Copra, ITS-VWD, Plisten</cx:pt>
          <cx:pt idx="32">Copra, ITS-VWD, Plisten</cx:pt>
          <cx:pt idx="33">Copra, ITS-VWD, Plisten</cx:pt>
          <cx:pt idx="34">Copra, ITS-VWD, Plisten</cx:pt>
          <cx:pt idx="35">Copra, ITS-VWD, Plisten</cx:pt>
          <cx:pt idx="36">Copra, ITS-VWD, Plisten</cx:pt>
          <cx:pt idx="37">Copra, ITS-VWD, Plisten</cx:pt>
          <cx:pt idx="38">Copra, ITS-VWD, Plisten</cx:pt>
          <cx:pt idx="39">Copra, ITS-VWD, Plisten</cx:pt>
          <cx:pt idx="40">Copra, ITS-VWD, Plisten</cx:pt>
          <cx:pt idx="41">Copra, ITS-VWD, Plisten</cx:pt>
          <cx:pt idx="42">Copra, ITS-VWD, Plisten</cx:pt>
          <cx:pt idx="43">Copra, ITS-VWD, Plisten</cx:pt>
          <cx:pt idx="44">Copra, ITS-VWD, Plisten</cx:pt>
          <cx:pt idx="45">Copra, ITS-VWD, Plisten</cx:pt>
          <cx:pt idx="46">Copra, ITS-VWD, Plisten</cx:pt>
          <cx:pt idx="47">Copra, ITS-VWD, Plisten</cx:pt>
          <cx:pt idx="48">Copra, ITS-VWD, Plisten</cx:pt>
          <cx:pt idx="49">Copra, ITS-VWD, Plisten</cx:pt>
          <cx:pt idx="50">Copra, ITS-VWD, Plisten</cx:pt>
          <cx:pt idx="51">Copra, ITS-VWD, Plisten</cx:pt>
          <cx:pt idx="52">Copra, ITS-VWD, Plisten</cx:pt>
          <cx:pt idx="53">Copra, ITS-VWD, Plisten</cx:pt>
          <cx:pt idx="54">Copra, ITS-VWD, Plisten</cx:pt>
          <cx:pt idx="55">Copra, ITS-VWD, Plisten</cx:pt>
          <cx:pt idx="56">Copra, ITS-VWD, Plisten</cx:pt>
          <cx:pt idx="57">Copra, ITS-VWD, Plisten</cx:pt>
          <cx:pt idx="58">Copra, ITS-VWD, Plisten</cx:pt>
          <cx:pt idx="59">Copra, ITS-VWD, Plisten</cx:pt>
          <cx:pt idx="60">Copra, ITS-VWD, Plisten</cx:pt>
          <cx:pt idx="61">Copra, ITS-VWD, Plisten</cx:pt>
          <cx:pt idx="62">Copra, ITS-VWD, Plisten</cx:pt>
          <cx:pt idx="63">Copra, ITS-VWD, Plisten</cx:pt>
          <cx:pt idx="64">Copra, ITS-VWD, Plisten</cx:pt>
          <cx:pt idx="65">Copra, ITS-VWD, Plisten</cx:pt>
          <cx:pt idx="66">Copra, ITS-VWD, Plisten</cx:pt>
          <cx:pt idx="67">Copra, ITS-VWD, Plisten</cx:pt>
          <cx:pt idx="68">Copra, ITS-VWD, Plisten</cx:pt>
          <cx:pt idx="69">Copra, ITS-VWD, Plisten</cx:pt>
          <cx:pt idx="70">Copra, ITS-VWD, Plisten</cx:pt>
          <cx:pt idx="71">Copra, ITS-VWD, Plisten</cx:pt>
          <cx:pt idx="72">Copra, ITS-VWD, Plisten</cx:pt>
          <cx:pt idx="73">Copra, ITS-VWD, Plisten</cx:pt>
          <cx:pt idx="74">Copra, ITS-VWD, Plisten</cx:pt>
          <cx:pt idx="75">Copra, ITS-VWD, Plisten</cx:pt>
          <cx:pt idx="76">Copra, ITS-VWD, Plisten</cx:pt>
          <cx:pt idx="77">Copra, ITS-VWD, Plisten</cx:pt>
          <cx:pt idx="78">Copra, ITS-VWD, Plisten</cx:pt>
          <cx:pt idx="79">Copra, ITS-VWD, Plisten</cx:pt>
          <cx:pt idx="80">Copra, ITS-VWD, Plisten</cx:pt>
          <cx:pt idx="81">Copra, ITS-VWD, Plisten</cx:pt>
          <cx:pt idx="82">Copra, ITS-VWD, Plisten</cx:pt>
          <cx:pt idx="83">Copra, ITS-VWD, Plisten</cx:pt>
          <cx:pt idx="84">Copra, ITS-VWD, Plisten</cx:pt>
          <cx:pt idx="85">Copra, ITS-VWD, Plisten</cx:pt>
          <cx:pt idx="86">Copra, ITS-VWD, Plisten</cx:pt>
          <cx:pt idx="87">Copra, ITS-VWD, Plisten</cx:pt>
          <cx:pt idx="88">Copra, ITS-VWD, Plisten</cx:pt>
          <cx:pt idx="89">Copra, ITS-VWD, Plisten</cx:pt>
          <cx:pt idx="90">Copra, ITS-VWD, Plisten</cx:pt>
          <cx:pt idx="91">Copra, ITS-VWD, Plisten</cx:pt>
          <cx:pt idx="92">Copra, ITS-VWD, Plisten</cx:pt>
          <cx:pt idx="93">Copra, ITS-VWD, Plisten</cx:pt>
          <cx:pt idx="94">Copra, ITS-VWD, Plisten</cx:pt>
          <cx:pt idx="95">Copra, ITS-VWD, Plisten</cx:pt>
          <cx:pt idx="96">Copra, ITS-VWD, Plisten</cx:pt>
          <cx:pt idx="97">Copra, ITS-VWD, Plisten</cx:pt>
          <cx:pt idx="98">Copra, ITS-VWD, Plisten</cx:pt>
          <cx:pt idx="99">Copra, ITS-VWD, Plisten</cx:pt>
          <cx:pt idx="100">Copra, ITS-VWD, Plisten</cx:pt>
          <cx:pt idx="101">Copra, ITS-VWD, Plisten</cx:pt>
          <cx:pt idx="102">Copra, ITS-VWD, Plisten</cx:pt>
          <cx:pt idx="103">Copra, ITS-VWD, Plisten</cx:pt>
          <cx:pt idx="104">Copra, ITS-VWD, Plisten</cx:pt>
          <cx:pt idx="105">Copra, ITS-VWD, Plisten</cx:pt>
          <cx:pt idx="106">Copra, ITS-VWD, Plisten</cx:pt>
          <cx:pt idx="107">Copra, ITS-VWD, Plisten</cx:pt>
          <cx:pt idx="108">Copra, ITS-VWD, Plisten</cx:pt>
          <cx:pt idx="109">Copra, ITS-VWD, Plisten</cx:pt>
          <cx:pt idx="110">Copra, ITS-VWD, Plisten</cx:pt>
          <cx:pt idx="111">Copra, ITS-VWD, Plisten</cx:pt>
          <cx:pt idx="112">Copra, ITS-VWD, Plisten</cx:pt>
          <cx:pt idx="113">Copra, ITS-VWD, Plisten</cx:pt>
          <cx:pt idx="114">Copra, ITS-VWD, Plisten</cx:pt>
          <cx:pt idx="115">Copra, ITS-VWD, Plisten</cx:pt>
          <cx:pt idx="116">Copra, ITS-VWD, Plisten</cx:pt>
          <cx:pt idx="117">Copra, ITS-VWD, Plisten</cx:pt>
          <cx:pt idx="118">Copra, ITS-VWD, Plisten</cx:pt>
          <cx:pt idx="119">Copra, ITS-VWD, Plisten</cx:pt>
          <cx:pt idx="120">Copra, ITS-VWD, Plisten</cx:pt>
          <cx:pt idx="121">Copra, ITS-VWD, Plisten</cx:pt>
          <cx:pt idx="122">Copra, ITS-VWD, Plisten</cx:pt>
          <cx:pt idx="123">Copra, ITS-VWD, Plisten</cx:pt>
          <cx:pt idx="124">Copra, ITS-VWD, Plisten</cx:pt>
          <cx:pt idx="125">Copra, ITS-VWD, Plisten</cx:pt>
          <cx:pt idx="126">Copra, ITS-VWD, Plisten</cx:pt>
          <cx:pt idx="127">Copra, ITS-VWD, Plisten</cx:pt>
          <cx:pt idx="128">Copra, ITS-VWD, Plisten</cx:pt>
          <cx:pt idx="129">Copra, ITS-VWD, Plisten</cx:pt>
          <cx:pt idx="130">Copra, ITS-VWD, Plisten</cx:pt>
          <cx:pt idx="131">Copra, ITS-VWD, Plisten</cx:pt>
          <cx:pt idx="132">Copra, ITS-VWD, Plisten</cx:pt>
          <cx:pt idx="133">Copra, ITS-VWD, Plisten</cx:pt>
          <cx:pt idx="134">Copra, ITS-VWD, Plisten</cx:pt>
          <cx:pt idx="135">Copra, ITS-VWD, Plisten</cx:pt>
          <cx:pt idx="136">Copra, ITS-VWD, Plisten</cx:pt>
          <cx:pt idx="137">Copra, ITS-VWD, Plisten</cx:pt>
          <cx:pt idx="138">Copra, ITS-VWD, Plisten</cx:pt>
          <cx:pt idx="139">Copra, ITS-VWD, Plisten</cx:pt>
          <cx:pt idx="140">Copra, ITS-VWD, Plisten</cx:pt>
          <cx:pt idx="141">Copra, ITS-VWD, Plisten</cx:pt>
          <cx:pt idx="142">Copra, ITS-VWD, Plisten</cx:pt>
          <cx:pt idx="143">Copra, ITS-VWD, Plisten</cx:pt>
          <cx:pt idx="144">Copra, ITS-VWD, Plisten</cx:pt>
          <cx:pt idx="145">Copra, ITS-VWD, Plisten</cx:pt>
          <cx:pt idx="146">Copra, ITS-VWD, Plisten</cx:pt>
          <cx:pt idx="147">Copra, ITS-VWD, Plisten</cx:pt>
          <cx:pt idx="148">Copra, ITS-VWD, Plisten</cx:pt>
          <cx:pt idx="149">Copra, ITS-VWD, Plisten</cx:pt>
          <cx:pt idx="150">Copra, ITS-VWD, Plisten</cx:pt>
          <cx:pt idx="151">Copra, ITS-VWD, Plisten</cx:pt>
          <cx:pt idx="152">Copra, ITS-VWD, Plisten</cx:pt>
          <cx:pt idx="153">Copra, ITS-VWD, Plisten</cx:pt>
          <cx:pt idx="154">Copra, ITS-VWD, Plisten</cx:pt>
          <cx:pt idx="155">Copra, ITS-VWD, Plisten</cx:pt>
          <cx:pt idx="156">Copra, ITS-VWD, Plisten</cx:pt>
          <cx:pt idx="157">Copra, ITS-VWD, Plisten</cx:pt>
          <cx:pt idx="158">Copra, ITS-VWD, Plisten</cx:pt>
          <cx:pt idx="159">Copra, ITS-VWD, Plisten</cx:pt>
          <cx:pt idx="160">Copra, ITS-VWD, Plisten</cx:pt>
          <cx:pt idx="161">Copra, ITS-VWD, Plisten</cx:pt>
          <cx:pt idx="162">Copra, ITS-VWD, Plisten</cx:pt>
          <cx:pt idx="163">Copra, ITS-VWD, Plisten</cx:pt>
          <cx:pt idx="164">Copra, ITS-VWD, Plisten</cx:pt>
          <cx:pt idx="165">Copra, ITS-VWD, Plisten</cx:pt>
          <cx:pt idx="166">Copra, ITS-VWD, Plisten</cx:pt>
          <cx:pt idx="167">Copra, ITS-VWD, Plisten</cx:pt>
          <cx:pt idx="168">Copra, ITS-VWD, Plisten</cx:pt>
          <cx:pt idx="169">Copra, ITS-VWD, Plisten</cx:pt>
          <cx:pt idx="170">Copra, ITS-VWD, Plisten</cx:pt>
          <cx:pt idx="171">Copra, ITS-VWD, Plisten</cx:pt>
          <cx:pt idx="172">Copra, ITS-VWD, Plisten</cx:pt>
          <cx:pt idx="173">Copra, ITS-VWD, Plisten</cx:pt>
          <cx:pt idx="174">Copra, ITS-VWD, Plisten</cx:pt>
          <cx:pt idx="175">Copra, ITS-VWD, Plisten</cx:pt>
          <cx:pt idx="176">Copra, ITS-VWD, Plisten</cx:pt>
          <cx:pt idx="177">Copra, ITS-VWD, Plisten</cx:pt>
          <cx:pt idx="178">Copra, ITS-VWD, Plisten</cx:pt>
          <cx:pt idx="179">Copra, ITS-VWD, Plisten</cx:pt>
          <cx:pt idx="180">Copra, ITS-VWD, Plisten</cx:pt>
          <cx:pt idx="181">Copra, ITS-VWD, Plisten</cx:pt>
          <cx:pt idx="182">Copra, ITS-VWD, Plisten</cx:pt>
          <cx:pt idx="183">Copra, ITS-VWD, Plisten</cx:pt>
          <cx:pt idx="184">Copra, ITS-VWD, Plisten</cx:pt>
          <cx:pt idx="185">Copra, ITS-VWD, Plisten</cx:pt>
          <cx:pt idx="186">Copra, ITS-VWD, Plisten</cx:pt>
          <cx:pt idx="187">Copra, ITS-VWD, Plisten</cx:pt>
          <cx:pt idx="188">Copra, ITS-VWD, Plisten</cx:pt>
          <cx:pt idx="189">Copra, ITS-VWD, Plisten</cx:pt>
          <cx:pt idx="190">Copra, ITS-VWD, Plisten</cx:pt>
          <cx:pt idx="191">Copra, ITS-VWD, Plisten</cx:pt>
          <cx:pt idx="192">Copra, ITS-VWD, Plisten</cx:pt>
          <cx:pt idx="193">Copra, ITS-VWD, Plisten</cx:pt>
          <cx:pt idx="194">Copra, ITS-VWD, Plisten</cx:pt>
          <cx:pt idx="195">Copra, ITS-VWD, Plisten</cx:pt>
          <cx:pt idx="196">Copra, ITS-VWD, Plisten</cx:pt>
          <cx:pt idx="197">Copra, ITS-VWD, Plisten</cx:pt>
          <cx:pt idx="198">Copra, ITS-VWD, Plisten</cx:pt>
          <cx:pt idx="199">Copra, ITS-VWD, Plisten</cx:pt>
          <cx:pt idx="200">Copra, ITS-VWD, Plisten</cx:pt>
          <cx:pt idx="201">Copra, ITS-VWD, Plisten</cx:pt>
          <cx:pt idx="202">Copra, ITS-VWD, Plisten</cx:pt>
          <cx:pt idx="203">Copra, ITS-VWD, Plisten</cx:pt>
          <cx:pt idx="204">Copra, ITS-VWD, Plisten</cx:pt>
          <cx:pt idx="205">Copra, ITS-VWD, Plisten</cx:pt>
          <cx:pt idx="206">Copra, ITS-VWD, Plisten</cx:pt>
          <cx:pt idx="207">Copra, ITS-VWD, Plisten</cx:pt>
          <cx:pt idx="208">Copra, ITS-VWD, Plisten</cx:pt>
          <cx:pt idx="209">Copra, ITS-VWD, Plisten</cx:pt>
          <cx:pt idx="210">Copra, ITS-VWD, Plisten</cx:pt>
          <cx:pt idx="211">Copra, ITS-VWD, Plisten</cx:pt>
          <cx:pt idx="212">Copra, ITS-VWD, Plisten</cx:pt>
          <cx:pt idx="213">Copra, ITS-VWD, Plisten</cx:pt>
          <cx:pt idx="214">Copra, ITS-VWD, Plisten</cx:pt>
          <cx:pt idx="215">Copra, ITS-VWD, Plisten</cx:pt>
          <cx:pt idx="216">Copra, ITS-VWD, Plisten</cx:pt>
          <cx:pt idx="217">Copra, ITS-VWD, Plisten</cx:pt>
          <cx:pt idx="218">Copra, ITS-VWD, Plisten</cx:pt>
          <cx:pt idx="219">Copra, ITS-VWD, Plisten</cx:pt>
          <cx:pt idx="220">Copra, ITS-VWD, Plisten</cx:pt>
          <cx:pt idx="221">Copra, ITS-VWD, Plisten</cx:pt>
          <cx:pt idx="222">Copra, ITS-VWD, Plisten</cx:pt>
          <cx:pt idx="223">Copra, ITS-VWD, Plisten</cx:pt>
          <cx:pt idx="224">Copra, ITS-VWD, Plisten</cx:pt>
          <cx:pt idx="225">Copra, ITS-VWD, Plisten</cx:pt>
          <cx:pt idx="226">Copra, ITS-VWD, Plisten</cx:pt>
          <cx:pt idx="227">Copra, ITS-VWD, Plisten</cx:pt>
          <cx:pt idx="228">Copra, ITS-VWD, Plisten</cx:pt>
          <cx:pt idx="229">Copra, ITS-VWD, Plisten</cx:pt>
          <cx:pt idx="230">Copra, ITS-VWD, Plisten</cx:pt>
          <cx:pt idx="231">Copra, ITS-VWD, Plisten</cx:pt>
          <cx:pt idx="232">Copra, ITS-VWD, Plisten</cx:pt>
          <cx:pt idx="233">Copra, ITS-VWD, Plisten</cx:pt>
          <cx:pt idx="234">Copra, ITS-VWD, Plisten</cx:pt>
          <cx:pt idx="235">Copra, ITS-VWD, Plisten</cx:pt>
          <cx:pt idx="236">Copra, ITS-VWD, Plisten</cx:pt>
          <cx:pt idx="237">Copra, ITS-VWD, Plisten</cx:pt>
          <cx:pt idx="238">Copra, ITS-VWD, Plisten</cx:pt>
          <cx:pt idx="239">Copra, ITS-VWD, Plisten</cx:pt>
          <cx:pt idx="240">Copra, ITS-VWD, Plisten</cx:pt>
          <cx:pt idx="241">Copra, ITS-VWD, Plisten</cx:pt>
          <cx:pt idx="242">Copra, ITS-VWD, Plisten</cx:pt>
          <cx:pt idx="243">Copra, ITS-VWD, Plisten</cx:pt>
          <cx:pt idx="244">Copra, ITS-VWD, Plisten</cx:pt>
          <cx:pt idx="245">Copra, ITS-VWD, Plisten</cx:pt>
          <cx:pt idx="246">Copra, ITS-VWD, Plisten</cx:pt>
          <cx:pt idx="247">Copra, ITS-VWD, Plisten</cx:pt>
          <cx:pt idx="248">Copra, ITS-VWD, Plisten</cx:pt>
          <cx:pt idx="249">Copra, ITS-VWD, Plisten</cx:pt>
          <cx:pt idx="250">Copra, ITS-VWD, Plisten</cx:pt>
          <cx:pt idx="251">Copra, ITS-VWD, Plisten</cx:pt>
          <cx:pt idx="252">Copra, ITS-VWD, Plisten</cx:pt>
          <cx:pt idx="253">Copra, ITS-VWD, Plisten</cx:pt>
          <cx:pt idx="254">Copra, ITS-VWD, Plisten</cx:pt>
          <cx:pt idx="255">Copra, ITS-VWD, Plisten</cx:pt>
          <cx:pt idx="256">Copra, ITS-VWD, Plisten</cx:pt>
          <cx:pt idx="257">Copra, ITS-VWD, Plisten</cx:pt>
          <cx:pt idx="258">Copra, ITS-VWD, Plisten</cx:pt>
          <cx:pt idx="259">Copra, ITS-VWD, Plisten</cx:pt>
          <cx:pt idx="260">Copra, ITS-VWD, Plisten</cx:pt>
          <cx:pt idx="261">Copra, ITS-VWD, Plisten</cx:pt>
          <cx:pt idx="262">Copra, ITS-VWD, Plisten</cx:pt>
          <cx:pt idx="263">Copra, ITS-VWD, Plisten</cx:pt>
          <cx:pt idx="264">Copra, ITS-VWD, Plisten</cx:pt>
          <cx:pt idx="265">Copra, ITS-VWD, Plisten</cx:pt>
          <cx:pt idx="266">Copra, ITS-VWD, Plisten</cx:pt>
          <cx:pt idx="267">Copra, ITS-VWD, Plisten</cx:pt>
          <cx:pt idx="268">Copra, ITS-VWD, Plisten</cx:pt>
          <cx:pt idx="269">Copra, ITS-VWD, Plisten</cx:pt>
          <cx:pt idx="270">Copra, ITS-VWD, Plisten</cx:pt>
          <cx:pt idx="271">Copra, ITS-VWD, Plisten</cx:pt>
          <cx:pt idx="272">Copra, ITS-VWD, Plisten</cx:pt>
          <cx:pt idx="273">Copra, ITS-VWD, Plisten</cx:pt>
          <cx:pt idx="274">Copra, ITS-VWD, Plisten</cx:pt>
          <cx:pt idx="275">Copra, ITS-VWD, Plisten</cx:pt>
          <cx:pt idx="276">Copra, ITS-VWD, Plisten</cx:pt>
          <cx:pt idx="277">Copra, ITS-VWD, Plisten</cx:pt>
          <cx:pt idx="278">Copra, ITS-VWD, Plisten</cx:pt>
          <cx:pt idx="279">Copra, ITS-VWD, Plisten</cx:pt>
          <cx:pt idx="280">Copra, ITS-VWD, Plisten</cx:pt>
          <cx:pt idx="281">Copra, ITS-VWD, Plisten</cx:pt>
          <cx:pt idx="282">Copra, ITS-VWD, Plisten</cx:pt>
          <cx:pt idx="283">Copra, ITS-VWD, Plisten</cx:pt>
          <cx:pt idx="284">Copra, ITS-VWD, Plisten</cx:pt>
          <cx:pt idx="285">Copra, ITS-VWD, Plisten</cx:pt>
          <cx:pt idx="286">Copra, ITS-VWD, Plisten</cx:pt>
          <cx:pt idx="287">Copra, ITS-VWD, Plisten</cx:pt>
          <cx:pt idx="288">Copra, ITS-VWD, Plisten</cx:pt>
          <cx:pt idx="289">Copra, ITS-VWD, Plisten</cx:pt>
          <cx:pt idx="290">Copra, ITS-VWD, Plisten</cx:pt>
          <cx:pt idx="291">Copra, ITS-VWD, Plisten</cx:pt>
          <cx:pt idx="292">Copra, ITS-VWD, Plisten</cx:pt>
          <cx:pt idx="293">Copra, ITS-VWD, Plisten</cx:pt>
          <cx:pt idx="294">Copra, ITS-VWD, Plisten</cx:pt>
          <cx:pt idx="295">Copra, ITS-VWD, Plisten</cx:pt>
          <cx:pt idx="296">Copra, ITS-VWD, Plisten</cx:pt>
          <cx:pt idx="297">Copra, ITS-VWD, Plisten</cx:pt>
          <cx:pt idx="298">Copra, ITS-VWD, Plisten</cx:pt>
          <cx:pt idx="299">Copra, ITS-VWD, Plisten</cx:pt>
          <cx:pt idx="300">Copra, ITS-VWD, Plisten</cx:pt>
          <cx:pt idx="301">Copra, ITS-VWD, Plisten</cx:pt>
          <cx:pt idx="302">Copra, ITS-VWD, Plisten</cx:pt>
          <cx:pt idx="303">Copra, ITS-VWD, Plisten</cx:pt>
          <cx:pt idx="304">Copra, ITS-VWD, Plisten</cx:pt>
          <cx:pt idx="305">Copra, ITS-VWD, Plisten</cx:pt>
          <cx:pt idx="306">Copra, ITS-VWD, Plisten</cx:pt>
          <cx:pt idx="307">Copra, ITS-VWD, Plisten</cx:pt>
          <cx:pt idx="308">Copra, ITS-VWD, Plisten</cx:pt>
          <cx:pt idx="309">Copra, ITS-VWD, Plisten</cx:pt>
          <cx:pt idx="310">Copra, ITS-VWD, Plisten</cx:pt>
          <cx:pt idx="311">Copra, ITS-VWD, Plisten</cx:pt>
          <cx:pt idx="312">Copra, ITS-VWD, Plisten</cx:pt>
          <cx:pt idx="313">Copra, ITS-VWD, Plisten</cx:pt>
          <cx:pt idx="314">Copra, ITS-VWD, Plisten</cx:pt>
          <cx:pt idx="315">Copra, ITS-VWD, Plisten</cx:pt>
          <cx:pt idx="316">Copra, ITS-VWD, Plisten</cx:pt>
          <cx:pt idx="317">Copra, ITS-VWD, Plisten</cx:pt>
          <cx:pt idx="318">Copra, ITS-VWD, Plisten</cx:pt>
          <cx:pt idx="319">Copra, ITS-VWD, Plisten</cx:pt>
          <cx:pt idx="320">Copra, ITS-VWD, Plisten</cx:pt>
          <cx:pt idx="321">Copra, ITS-VWD, Plisten</cx:pt>
          <cx:pt idx="322">Copra, ITS-VWD, Plisten</cx:pt>
          <cx:pt idx="323">Copra, ITS-VWD, Plisten</cx:pt>
          <cx:pt idx="324">Copra, ITS-VWD, Plisten</cx:pt>
          <cx:pt idx="325">Copra, ITS-VWD, Plisten</cx:pt>
          <cx:pt idx="326">Copra, ITS-VWD, Plisten</cx:pt>
          <cx:pt idx="327">Copra, ITS-VWD, Plisten</cx:pt>
          <cx:pt idx="328">Copra, ITS-VWD, Plisten</cx:pt>
          <cx:pt idx="329">Copra, ITS-VWD, Plisten</cx:pt>
          <cx:pt idx="330">Copra, ITS-VWD, Plisten</cx:pt>
          <cx:pt idx="331">Copra, ITS-VWD, Plisten</cx:pt>
          <cx:pt idx="332">Copra, ITS-VWD, Plisten</cx:pt>
          <cx:pt idx="333">Copra, ITS-VWD, Plisten</cx:pt>
          <cx:pt idx="334">Copra, ITS-VWD, Plisten</cx:pt>
          <cx:pt idx="335">Copra, ITS-VWD, Plisten</cx:pt>
          <cx:pt idx="336">Copra, ITS-VWD, Plisten</cx:pt>
          <cx:pt idx="337">Copra, ITS-VWD, Plisten</cx:pt>
          <cx:pt idx="338">Copra, ITS-VWD, Plisten</cx:pt>
          <cx:pt idx="339">Copra, ITS-VWD, Plisten</cx:pt>
          <cx:pt idx="340">Copra, ITS-VWD, Plisten</cx:pt>
          <cx:pt idx="341">Copra, ITS-VWD, Plisten</cx:pt>
          <cx:pt idx="342">Copra, ITS-VWD, Plisten</cx:pt>
          <cx:pt idx="343">Copra, ITS-VWD, Plisten</cx:pt>
          <cx:pt idx="344">Copra, ITS-VWD, Plisten</cx:pt>
          <cx:pt idx="345">Copra, ITS-VWD, Plisten</cx:pt>
          <cx:pt idx="346">Copra, ITS-VWD, Plisten</cx:pt>
          <cx:pt idx="347">Copra, ITS-VWD, Plisten</cx:pt>
          <cx:pt idx="348">Copra, ITS-VWD, Plisten</cx:pt>
          <cx:pt idx="349">Copra, ITS-VWD, Plisten</cx:pt>
          <cx:pt idx="350">Copra, ITS-VWD, Plisten</cx:pt>
          <cx:pt idx="351">Copra, ITS-VWD, Plisten</cx:pt>
          <cx:pt idx="352">Copra, ITS-VWD, Plisten</cx:pt>
          <cx:pt idx="353">Copra, ITS-VWD, Plisten</cx:pt>
          <cx:pt idx="354">Copra, ITS-VWD, Plisten</cx:pt>
          <cx:pt idx="355">Copra, ITS-VWD, Plisten</cx:pt>
          <cx:pt idx="356">Copra, ITS-VWD, Plisten</cx:pt>
          <cx:pt idx="357">Copra, ITS-VWD, Plisten</cx:pt>
          <cx:pt idx="358">Copra, ITS-VWD, Plisten</cx:pt>
          <cx:pt idx="359">Copra, ITS-VWD, Plisten</cx:pt>
          <cx:pt idx="360">Copra, ITS-VWD, Plisten</cx:pt>
          <cx:pt idx="361">Copra, ITS-VWD, Plisten</cx:pt>
          <cx:pt idx="362">Copra, ITS-VWD, Plisten</cx:pt>
          <cx:pt idx="363">Copra, ITS-VWD, Plisten</cx:pt>
          <cx:pt idx="364">Copra, ITS-VWD, Plisten</cx:pt>
          <cx:pt idx="365">Copra, ITS-VWD, Plisten</cx:pt>
          <cx:pt idx="366">Copra, ITS-VWD, Plisten</cx:pt>
          <cx:pt idx="367">Copra, ITS-VWD, Plisten</cx:pt>
          <cx:pt idx="368">Copra, ITS-VWD, Plisten</cx:pt>
          <cx:pt idx="369">Copra, ITS-VWD, Plisten</cx:pt>
          <cx:pt idx="370">Copra, ITS-VWD, Plisten</cx:pt>
          <cx:pt idx="371">Copra, ITS-VWD, Plisten</cx:pt>
          <cx:pt idx="372">Copra, ITS-VWD, Plisten</cx:pt>
          <cx:pt idx="373">Copra, ITS-VWD, Plisten</cx:pt>
          <cx:pt idx="374">Copra, ITS-VWD, Plisten</cx:pt>
          <cx:pt idx="375">Copra, ITS-VWD, Plisten</cx:pt>
          <cx:pt idx="376">Copra, ITS-VWD, Plisten</cx:pt>
          <cx:pt idx="377">Copra, ITS-VWD, Plisten</cx:pt>
          <cx:pt idx="378">Copra, ITS-VWD, Plisten</cx:pt>
          <cx:pt idx="379">Copra, ITS-VWD, Plisten</cx:pt>
          <cx:pt idx="380">Copra, ITS-VWD, Plisten</cx:pt>
          <cx:pt idx="381">Copra, ITS-VWD, Plisten</cx:pt>
          <cx:pt idx="382">Copra, ITS-VWD, Plisten</cx:pt>
          <cx:pt idx="383">Copra, ITS-VWD, Plisten</cx:pt>
          <cx:pt idx="384">Copra, ITS-VWD, Plisten</cx:pt>
          <cx:pt idx="385">Copra, ITS-VWD, Plisten</cx:pt>
          <cx:pt idx="386">Copra, ITS-VWD, Plisten</cx:pt>
          <cx:pt idx="387">Copra, ITS-VWD, Plisten</cx:pt>
          <cx:pt idx="388">Copra, ITS-VWD, Plisten</cx:pt>
          <cx:pt idx="389">Copra, ITS-VWD, Plisten</cx:pt>
          <cx:pt idx="390">Copra, ITS-VWD, Plisten</cx:pt>
          <cx:pt idx="391">Copra, ITS-VWD, Plisten</cx:pt>
          <cx:pt idx="392">Copra, ITS-VWD, Plisten</cx:pt>
          <cx:pt idx="393">Copra, ITS-VWD, Plisten</cx:pt>
          <cx:pt idx="394">Copra, ITS-VWD, Plisten</cx:pt>
          <cx:pt idx="395">Copra, ITS-VWD, Plisten</cx:pt>
          <cx:pt idx="396">Copra, ITS-VWD, Plisten</cx:pt>
          <cx:pt idx="397">Copra, ITS-VWD, Plisten</cx:pt>
          <cx:pt idx="398">Copra, ITS-VWD, Plisten</cx:pt>
          <cx:pt idx="399">Copra, ITS-VWD, Plisten</cx:pt>
          <cx:pt idx="400">Copra, ITS-VWD, Plisten</cx:pt>
          <cx:pt idx="401">Copra, ITS-VWD, Plisten</cx:pt>
          <cx:pt idx="402">Copra, ITS-VWD, Plisten</cx:pt>
          <cx:pt idx="403">Copra, ITS-VWD, Plisten</cx:pt>
          <cx:pt idx="404">Copra, ITS-VWD, Plisten</cx:pt>
          <cx:pt idx="405">Copra, ITS-VWD, Plisten</cx:pt>
          <cx:pt idx="406">Copra, ITS-VWD, Plisten</cx:pt>
          <cx:pt idx="407">Copra, ITS-VWD, Plisten</cx:pt>
          <cx:pt idx="408">Copra, ITS-VWD, Plisten</cx:pt>
          <cx:pt idx="409">Copra, ITS-VWD, Plisten</cx:pt>
          <cx:pt idx="410">Copra, ITS-VWD, Plisten</cx:pt>
          <cx:pt idx="411">Copra, ITS-VWD, Plisten</cx:pt>
          <cx:pt idx="412">Copra, ITS-VWD, Plisten</cx:pt>
          <cx:pt idx="413">Copra, ITS-VWD, Plisten</cx:pt>
          <cx:pt idx="414">Copra, ITS-VWD, Plisten</cx:pt>
          <cx:pt idx="415">Copra, ITS-VWD, Plisten</cx:pt>
          <cx:pt idx="416">Copra, ITS-VWD, Plisten</cx:pt>
          <cx:pt idx="417">Copra, ITS-VWD, Plisten</cx:pt>
          <cx:pt idx="418">Copra, ITS-VWD, Plisten</cx:pt>
          <cx:pt idx="419">Copra, ITS-VWD, Plisten</cx:pt>
          <cx:pt idx="420">Copra, ITS-VWD, Plisten</cx:pt>
          <cx:pt idx="421">Copra, ITS-VWD, Plisten</cx:pt>
          <cx:pt idx="422">Copra, ITS-VWD, Plisten</cx:pt>
          <cx:pt idx="423">Copra, ITS-VWD, Plisten</cx:pt>
          <cx:pt idx="424">Copra, ITS-VWD, Plisten</cx:pt>
          <cx:pt idx="425">Copra, ITS-VWD, Plisten</cx:pt>
          <cx:pt idx="426">Copra, ITS-VWD, Plisten</cx:pt>
          <cx:pt idx="427">Copra, ITS-VWD, Plisten</cx:pt>
          <cx:pt idx="428">Copra, ITS-VWD, Plisten</cx:pt>
          <cx:pt idx="429">Copra, ITS-VWD, Plisten</cx:pt>
          <cx:pt idx="430">Copra, ITS-VWD, Plisten</cx:pt>
          <cx:pt idx="431">Copra, ITS-VWD, Plisten</cx:pt>
          <cx:pt idx="432">Copra, ITS-VWD, Plisten</cx:pt>
          <cx:pt idx="433">Copra, ITS-VWD, Plisten</cx:pt>
          <cx:pt idx="434">Copra, ITS-VWD, Plisten</cx:pt>
          <cx:pt idx="435">Copra, ITS-VWD, Plisten</cx:pt>
          <cx:pt idx="436">Copra, ITS-VWD, Plisten</cx:pt>
          <cx:pt idx="437">Copra, ITS-VWD, Plisten</cx:pt>
          <cx:pt idx="438">Copra, ITS-VWD, Plisten</cx:pt>
          <cx:pt idx="439">Copra, ITS-VWD, Plisten</cx:pt>
          <cx:pt idx="440">Copra, ITS-VWD, Plisten</cx:pt>
          <cx:pt idx="441">Copra, ITS-VWD, Plisten</cx:pt>
          <cx:pt idx="442">Copra, ITS-VWD, Plisten</cx:pt>
          <cx:pt idx="443">Copra, ITS-VWD, Plisten</cx:pt>
          <cx:pt idx="444">Copra, ITS-VWD, Plisten</cx:pt>
          <cx:pt idx="445">Copra, ITS-VWD, Plisten</cx:pt>
          <cx:pt idx="446">Copra, ITS-VWD, Plisten</cx:pt>
          <cx:pt idx="447">Copra, ITS-VWD, Plisten</cx:pt>
          <cx:pt idx="448">Copra, ITS-VWD, Plisten</cx:pt>
          <cx:pt idx="449">Copra, ITS-VWD, Plisten</cx:pt>
          <cx:pt idx="450">Copra, ITS-VWD, Plisten</cx:pt>
          <cx:pt idx="451">Copra, ITS-VWD, Plisten</cx:pt>
          <cx:pt idx="452">Copra, ITS-VWD, Plisten</cx:pt>
          <cx:pt idx="453">Copra, ITS-VWD, Plisten</cx:pt>
          <cx:pt idx="454">Copra, ITS-VWD, Plisten</cx:pt>
          <cx:pt idx="455">Copra, ITS-VWD, Plisten</cx:pt>
          <cx:pt idx="456">Copra, ITS-VWD, Plisten</cx:pt>
          <cx:pt idx="457">Copra, ITS-VWD, Plisten</cx:pt>
          <cx:pt idx="458">Copra, ITS-VWD, Plisten</cx:pt>
          <cx:pt idx="459">Copra, ITS-VWD, Plisten</cx:pt>
          <cx:pt idx="460">Copra, ITS-VWD, Plisten</cx:pt>
          <cx:pt idx="461">Copra, ITS-VWD, Plisten</cx:pt>
          <cx:pt idx="462">Copra, ITS-VWD, Plisten</cx:pt>
          <cx:pt idx="463">Copra, ITS-VWD, Plisten</cx:pt>
          <cx:pt idx="464">Copra, ITS-VWD, Plisten</cx:pt>
          <cx:pt idx="465">Copra, ITS-VWD, Plisten</cx:pt>
          <cx:pt idx="466">Copra, ITS-VWD, Plisten</cx:pt>
          <cx:pt idx="467">Copra, ITS-VWD, Plisten</cx:pt>
          <cx:pt idx="468">Copra, ITS-VWD, Plisten</cx:pt>
          <cx:pt idx="469">Copra, ITS-VWD, Plisten</cx:pt>
          <cx:pt idx="470">Copra, ITS-VWD, Plisten</cx:pt>
          <cx:pt idx="471">Copra, ITS-VWD, Plisten</cx:pt>
          <cx:pt idx="472">Copra, ITS-VWD, Plisten</cx:pt>
          <cx:pt idx="473">Copra, ITS-VWD, Plisten</cx:pt>
          <cx:pt idx="474">Copra, ITS-VWD, Plisten</cx:pt>
          <cx:pt idx="475">Copra, ITS-VWD, Plisten</cx:pt>
          <cx:pt idx="476">Copra, ITS-VWD, Plisten</cx:pt>
          <cx:pt idx="477">Copra, ITS-VWD, Plisten</cx:pt>
          <cx:pt idx="478">Copra, ITS-VWD, Plisten</cx:pt>
          <cx:pt idx="479">Copra, ITS-VWD, Plisten</cx:pt>
          <cx:pt idx="480">Copra, ITS-VWD, Plisten</cx:pt>
          <cx:pt idx="481">Copra, ITS-VWD, Plisten</cx:pt>
          <cx:pt idx="482">Copra, ITS-VWD, Plisten</cx:pt>
          <cx:pt idx="483">Copra, ITS-VWD, Plisten</cx:pt>
          <cx:pt idx="484">Copra, ITS-VWD, Plisten</cx:pt>
          <cx:pt idx="485">Copra, ITS-VWD, Plisten</cx:pt>
          <cx:pt idx="486">Copra, ITS-VWD, Plisten</cx:pt>
          <cx:pt idx="487">Copra, ITS-VWD, Plisten</cx:pt>
          <cx:pt idx="488">Copra, ITS-VWD, Plisten</cx:pt>
          <cx:pt idx="489">Copra, ITS-VWD, Plisten</cx:pt>
          <cx:pt idx="490">Copra, ITS-VWD, Plisten</cx:pt>
          <cx:pt idx="491">Copra, ITS-VWD, Plisten</cx:pt>
          <cx:pt idx="492">Copra, ITS-VWD, Plisten</cx:pt>
          <cx:pt idx="493">Copra, ITS-VWD, Plisten</cx:pt>
          <cx:pt idx="494">Copra, ITS-VWD, Plisten</cx:pt>
          <cx:pt idx="495">Copra, ITS-VWD, Plisten</cx:pt>
          <cx:pt idx="496">Copra, ITS-VWD, Plisten</cx:pt>
          <cx:pt idx="497">Copra, ITS-VWD, Plisten</cx:pt>
          <cx:pt idx="498">Copra, ITS-VWD, Plisten</cx:pt>
          <cx:pt idx="499">Copra, ITS-VWD, Plisten</cx:pt>
          <cx:pt idx="500">Copra, ITS-VWD, Plisten</cx:pt>
          <cx:pt idx="501">Copra, ITS-VWD, Plisten</cx:pt>
          <cx:pt idx="502">Copra, ITS-VWD, Plisten</cx:pt>
          <cx:pt idx="503">Copra, ITS-VWD, Plisten</cx:pt>
          <cx:pt idx="504">Copra, ITS-VWD, Plisten</cx:pt>
          <cx:pt idx="505">Copra, ITS-VWD, Plisten</cx:pt>
          <cx:pt idx="506">Copra, ITS-VWD, Plisten</cx:pt>
          <cx:pt idx="507">Copra, ITS-VWD, Plisten</cx:pt>
          <cx:pt idx="508">Copra, ITS-VWD, Plisten</cx:pt>
          <cx:pt idx="509">Copra, ITS-VWD, Plisten</cx:pt>
          <cx:pt idx="510">Copra, ITS-VWD, Plisten</cx:pt>
          <cx:pt idx="511">Copra, ITS-VWD, Plisten</cx:pt>
          <cx:pt idx="512">Copra, ITS-VWD, Plisten</cx:pt>
          <cx:pt idx="513">Copra, ITS-VWD, Plisten</cx:pt>
          <cx:pt idx="514">Copra, ITS-VWD, Plisten</cx:pt>
          <cx:pt idx="515">Copra, ITS-VWD, Plisten</cx:pt>
          <cx:pt idx="516">Copra, ITS-VWD, Plisten</cx:pt>
          <cx:pt idx="517">Copra, ITS-VWD, Plisten</cx:pt>
          <cx:pt idx="518">Copra, ITS-VWD, Plisten</cx:pt>
          <cx:pt idx="519">Copra, ITS-VWD, Plisten</cx:pt>
        </cx:lvl>
      </cx:strDim>
      <cx:numDim type="val">
        <cx:lvl ptCount="520" formatCode="General">
          <cx:pt idx="0">2</cx:pt>
          <cx:pt idx="1">2</cx:pt>
          <cx:pt idx="2">2</cx:pt>
          <cx:pt idx="3">2</cx:pt>
          <cx:pt idx="4">2</cx:pt>
          <cx:pt idx="5">2</cx:pt>
          <cx:pt idx="6">2</cx:pt>
          <cx:pt idx="7">2</cx:pt>
          <cx:pt idx="8">2</cx:pt>
          <cx:pt idx="9">2</cx:pt>
          <cx:pt idx="10">2</cx:pt>
          <cx:pt idx="11">2</cx:pt>
          <cx:pt idx="12">2</cx:pt>
          <cx:pt idx="13">2</cx:pt>
          <cx:pt idx="14">2</cx:pt>
          <cx:pt idx="15">2</cx:pt>
          <cx:pt idx="16">2</cx:pt>
          <cx:pt idx="17">2</cx:pt>
          <cx:pt idx="18">2</cx:pt>
          <cx:pt idx="19">2</cx:pt>
          <cx:pt idx="20">2</cx:pt>
          <cx:pt idx="21">2</cx:pt>
          <cx:pt idx="22">2</cx:pt>
          <cx:pt idx="23">2</cx:pt>
          <cx:pt idx="24">2</cx:pt>
          <cx:pt idx="25">2</cx:pt>
          <cx:pt idx="26">2</cx:pt>
          <cx:pt idx="27">2</cx:pt>
          <cx:pt idx="28">2</cx:pt>
          <cx:pt idx="29">2</cx:pt>
          <cx:pt idx="30">2</cx:pt>
          <cx:pt idx="31">2</cx:pt>
          <cx:pt idx="32">2</cx:pt>
          <cx:pt idx="33">2</cx:pt>
          <cx:pt idx="34">2</cx:pt>
          <cx:pt idx="35">2</cx:pt>
          <cx:pt idx="36">2</cx:pt>
          <cx:pt idx="37">2</cx:pt>
          <cx:pt idx="38">2</cx:pt>
          <cx:pt idx="39">2</cx:pt>
          <cx:pt idx="40">2</cx:pt>
          <cx:pt idx="41">2</cx:pt>
          <cx:pt idx="42">2</cx:pt>
          <cx:pt idx="43">2</cx:pt>
          <cx:pt idx="44">2</cx:pt>
          <cx:pt idx="45">2</cx:pt>
          <cx:pt idx="46">2</cx:pt>
          <cx:pt idx="47">2</cx:pt>
          <cx:pt idx="48">2</cx:pt>
          <cx:pt idx="49">2</cx:pt>
          <cx:pt idx="50">2</cx:pt>
          <cx:pt idx="51">2</cx:pt>
          <cx:pt idx="52">2</cx:pt>
          <cx:pt idx="53">2</cx:pt>
          <cx:pt idx="54">2</cx:pt>
          <cx:pt idx="55">2</cx:pt>
          <cx:pt idx="56">2</cx:pt>
          <cx:pt idx="57">2</cx:pt>
          <cx:pt idx="58">2</cx:pt>
          <cx:pt idx="59">2</cx:pt>
          <cx:pt idx="60">2</cx:pt>
          <cx:pt idx="61">2</cx:pt>
          <cx:pt idx="62">2</cx:pt>
          <cx:pt idx="63">2</cx:pt>
          <cx:pt idx="64">2</cx:pt>
          <cx:pt idx="65">2</cx:pt>
          <cx:pt idx="66">2</cx:pt>
          <cx:pt idx="67">2</cx:pt>
          <cx:pt idx="68">2</cx:pt>
          <cx:pt idx="69">2</cx:pt>
          <cx:pt idx="70">2</cx:pt>
          <cx:pt idx="71">2</cx:pt>
          <cx:pt idx="72">2</cx:pt>
          <cx:pt idx="73">2</cx:pt>
          <cx:pt idx="74">2</cx:pt>
          <cx:pt idx="75">2</cx:pt>
          <cx:pt idx="76">2</cx:pt>
          <cx:pt idx="77">2</cx:pt>
          <cx:pt idx="78">2</cx:pt>
          <cx:pt idx="79">2</cx:pt>
          <cx:pt idx="80">2</cx:pt>
          <cx:pt idx="81">2</cx:pt>
          <cx:pt idx="82">2</cx:pt>
          <cx:pt idx="83">2</cx:pt>
          <cx:pt idx="84">2</cx:pt>
          <cx:pt idx="85">2</cx:pt>
          <cx:pt idx="86">2</cx:pt>
          <cx:pt idx="87">2</cx:pt>
          <cx:pt idx="88">2</cx:pt>
          <cx:pt idx="89">2</cx:pt>
          <cx:pt idx="90">2</cx:pt>
          <cx:pt idx="91">2</cx:pt>
          <cx:pt idx="92">2</cx:pt>
          <cx:pt idx="93">2</cx:pt>
          <cx:pt idx="94">2</cx:pt>
          <cx:pt idx="95">2</cx:pt>
          <cx:pt idx="96">2</cx:pt>
          <cx:pt idx="97">2</cx:pt>
          <cx:pt idx="98">2</cx:pt>
          <cx:pt idx="99">2</cx:pt>
          <cx:pt idx="100">2</cx:pt>
          <cx:pt idx="101">2</cx:pt>
          <cx:pt idx="102">2</cx:pt>
          <cx:pt idx="103">2</cx:pt>
          <cx:pt idx="104">2</cx:pt>
          <cx:pt idx="105">2</cx:pt>
          <cx:pt idx="106">2</cx:pt>
          <cx:pt idx="107">2</cx:pt>
          <cx:pt idx="108">2</cx:pt>
          <cx:pt idx="109">2</cx:pt>
          <cx:pt idx="110">2</cx:pt>
          <cx:pt idx="111">2</cx:pt>
          <cx:pt idx="112">2</cx:pt>
          <cx:pt idx="113">2</cx:pt>
          <cx:pt idx="114">2</cx:pt>
          <cx:pt idx="115">2</cx:pt>
          <cx:pt idx="116">2</cx:pt>
          <cx:pt idx="117">2</cx:pt>
          <cx:pt idx="118">2</cx:pt>
          <cx:pt idx="119">2</cx:pt>
          <cx:pt idx="120">2</cx:pt>
          <cx:pt idx="121">2</cx:pt>
          <cx:pt idx="122">2</cx:pt>
          <cx:pt idx="123">2</cx:pt>
          <cx:pt idx="124">2</cx:pt>
          <cx:pt idx="125">2</cx:pt>
          <cx:pt idx="126">2</cx:pt>
          <cx:pt idx="127">2</cx:pt>
          <cx:pt idx="128">2</cx:pt>
          <cx:pt idx="129">2</cx:pt>
          <cx:pt idx="130">2</cx:pt>
          <cx:pt idx="131">2</cx:pt>
          <cx:pt idx="132">2</cx:pt>
          <cx:pt idx="133">2</cx:pt>
          <cx:pt idx="134">2</cx:pt>
          <cx:pt idx="135">2</cx:pt>
          <cx:pt idx="136">2</cx:pt>
          <cx:pt idx="137">2</cx:pt>
          <cx:pt idx="138">2</cx:pt>
          <cx:pt idx="139">2</cx:pt>
          <cx:pt idx="140">2</cx:pt>
          <cx:pt idx="141">2</cx:pt>
          <cx:pt idx="142">2</cx:pt>
          <cx:pt idx="143">2</cx:pt>
          <cx:pt idx="144">2</cx:pt>
          <cx:pt idx="145">2</cx:pt>
          <cx:pt idx="146">2</cx:pt>
          <cx:pt idx="147">2</cx:pt>
          <cx:pt idx="148">2</cx:pt>
          <cx:pt idx="149">2</cx:pt>
          <cx:pt idx="150">2</cx:pt>
          <cx:pt idx="151">2</cx:pt>
          <cx:pt idx="152">2</cx:pt>
          <cx:pt idx="153">2</cx:pt>
          <cx:pt idx="154">2</cx:pt>
          <cx:pt idx="155">2</cx:pt>
          <cx:pt idx="156">2</cx:pt>
          <cx:pt idx="157">2</cx:pt>
          <cx:pt idx="158">2</cx:pt>
          <cx:pt idx="159">2</cx:pt>
          <cx:pt idx="160">2</cx:pt>
          <cx:pt idx="161">2</cx:pt>
          <cx:pt idx="162">2</cx:pt>
          <cx:pt idx="163">2</cx:pt>
          <cx:pt idx="164">2</cx:pt>
          <cx:pt idx="165">2</cx:pt>
          <cx:pt idx="166">2</cx:pt>
          <cx:pt idx="167">2</cx:pt>
          <cx:pt idx="168">2</cx:pt>
          <cx:pt idx="169">2</cx:pt>
          <cx:pt idx="170">2</cx:pt>
          <cx:pt idx="171">2</cx:pt>
          <cx:pt idx="172">2</cx:pt>
          <cx:pt idx="173">2</cx:pt>
          <cx:pt idx="174">2</cx:pt>
          <cx:pt idx="175">2</cx:pt>
          <cx:pt idx="176">2</cx:pt>
          <cx:pt idx="177">2</cx:pt>
          <cx:pt idx="178">2</cx:pt>
          <cx:pt idx="179">2</cx:pt>
          <cx:pt idx="180">2</cx:pt>
          <cx:pt idx="181">2</cx:pt>
          <cx:pt idx="182">2</cx:pt>
          <cx:pt idx="183">2</cx:pt>
          <cx:pt idx="184">2</cx:pt>
          <cx:pt idx="185">2</cx:pt>
          <cx:pt idx="186">2</cx:pt>
          <cx:pt idx="187">2</cx:pt>
          <cx:pt idx="188">2</cx:pt>
          <cx:pt idx="189">2</cx:pt>
          <cx:pt idx="190">2</cx:pt>
          <cx:pt idx="191">2</cx:pt>
          <cx:pt idx="192">2</cx:pt>
          <cx:pt idx="193">2</cx:pt>
          <cx:pt idx="194">2</cx:pt>
          <cx:pt idx="195">2</cx:pt>
          <cx:pt idx="196">2</cx:pt>
          <cx:pt idx="197">2</cx:pt>
          <cx:pt idx="198">2</cx:pt>
          <cx:pt idx="199">2</cx:pt>
          <cx:pt idx="200">2</cx:pt>
          <cx:pt idx="201">2</cx:pt>
          <cx:pt idx="202">2</cx:pt>
          <cx:pt idx="203">2</cx:pt>
          <cx:pt idx="204">2</cx:pt>
          <cx:pt idx="205">2</cx:pt>
          <cx:pt idx="206">2</cx:pt>
          <cx:pt idx="207">2</cx:pt>
          <cx:pt idx="208">2</cx:pt>
          <cx:pt idx="209">2</cx:pt>
          <cx:pt idx="210">2</cx:pt>
          <cx:pt idx="211">2</cx:pt>
          <cx:pt idx="212">2</cx:pt>
          <cx:pt idx="213">2</cx:pt>
          <cx:pt idx="214">2</cx:pt>
          <cx:pt idx="215">2</cx:pt>
          <cx:pt idx="216">2</cx:pt>
          <cx:pt idx="217">2</cx:pt>
          <cx:pt idx="218">2</cx:pt>
          <cx:pt idx="219">2</cx:pt>
          <cx:pt idx="220">3</cx:pt>
          <cx:pt idx="221">3</cx:pt>
          <cx:pt idx="222">3</cx:pt>
          <cx:pt idx="223">3</cx:pt>
          <cx:pt idx="224">3</cx:pt>
          <cx:pt idx="225">3</cx:pt>
          <cx:pt idx="226">3</cx:pt>
          <cx:pt idx="227">3</cx:pt>
          <cx:pt idx="228">3</cx:pt>
          <cx:pt idx="229">3</cx:pt>
          <cx:pt idx="230">3</cx:pt>
          <cx:pt idx="231">3</cx:pt>
          <cx:pt idx="232">3</cx:pt>
          <cx:pt idx="233">3</cx:pt>
          <cx:pt idx="234">3</cx:pt>
          <cx:pt idx="235">3</cx:pt>
          <cx:pt idx="236">3</cx:pt>
          <cx:pt idx="237">3</cx:pt>
          <cx:pt idx="238">3</cx:pt>
          <cx:pt idx="239">3</cx:pt>
          <cx:pt idx="240">3</cx:pt>
          <cx:pt idx="241">3</cx:pt>
          <cx:pt idx="242">3</cx:pt>
          <cx:pt idx="243">3</cx:pt>
          <cx:pt idx="244">3</cx:pt>
          <cx:pt idx="245">3</cx:pt>
          <cx:pt idx="246">3</cx:pt>
          <cx:pt idx="247">3</cx:pt>
          <cx:pt idx="248">3</cx:pt>
          <cx:pt idx="249">3</cx:pt>
          <cx:pt idx="250">3</cx:pt>
          <cx:pt idx="251">3</cx:pt>
          <cx:pt idx="252">3</cx:pt>
          <cx:pt idx="253">3</cx:pt>
          <cx:pt idx="254">3</cx:pt>
          <cx:pt idx="255">3</cx:pt>
          <cx:pt idx="256">3</cx:pt>
          <cx:pt idx="257">3</cx:pt>
          <cx:pt idx="258">3</cx:pt>
          <cx:pt idx="259">3</cx:pt>
          <cx:pt idx="260">3</cx:pt>
          <cx:pt idx="261">3</cx:pt>
          <cx:pt idx="262">3</cx:pt>
          <cx:pt idx="263">3</cx:pt>
          <cx:pt idx="264">3</cx:pt>
          <cx:pt idx="265">3</cx:pt>
          <cx:pt idx="266">3</cx:pt>
          <cx:pt idx="267">3</cx:pt>
          <cx:pt idx="268">3</cx:pt>
          <cx:pt idx="269">3</cx:pt>
          <cx:pt idx="270">3</cx:pt>
          <cx:pt idx="271">3</cx:pt>
          <cx:pt idx="272">3</cx:pt>
          <cx:pt idx="273">3</cx:pt>
          <cx:pt idx="274">3</cx:pt>
          <cx:pt idx="275">3</cx:pt>
          <cx:pt idx="276">3</cx:pt>
          <cx:pt idx="277">3</cx:pt>
          <cx:pt idx="278">3</cx:pt>
          <cx:pt idx="279">3</cx:pt>
          <cx:pt idx="280">3</cx:pt>
          <cx:pt idx="281">3</cx:pt>
          <cx:pt idx="282">3</cx:pt>
          <cx:pt idx="283">3</cx:pt>
          <cx:pt idx="284">3</cx:pt>
          <cx:pt idx="285">3</cx:pt>
          <cx:pt idx="286">3</cx:pt>
          <cx:pt idx="287">3</cx:pt>
          <cx:pt idx="288">3</cx:pt>
          <cx:pt idx="289">3</cx:pt>
          <cx:pt idx="290">3</cx:pt>
          <cx:pt idx="291">3</cx:pt>
          <cx:pt idx="292">3</cx:pt>
          <cx:pt idx="293">3</cx:pt>
          <cx:pt idx="294">3</cx:pt>
          <cx:pt idx="295">3</cx:pt>
          <cx:pt idx="296">3</cx:pt>
          <cx:pt idx="297">3</cx:pt>
          <cx:pt idx="298">3</cx:pt>
          <cx:pt idx="299">3</cx:pt>
          <cx:pt idx="300">3</cx:pt>
          <cx:pt idx="301">3</cx:pt>
          <cx:pt idx="302">3</cx:pt>
          <cx:pt idx="303">3</cx:pt>
          <cx:pt idx="304">3</cx:pt>
          <cx:pt idx="305">3</cx:pt>
          <cx:pt idx="306">3</cx:pt>
          <cx:pt idx="307">3</cx:pt>
          <cx:pt idx="308">3</cx:pt>
          <cx:pt idx="309">3</cx:pt>
          <cx:pt idx="310">3</cx:pt>
          <cx:pt idx="311">3</cx:pt>
          <cx:pt idx="312">3</cx:pt>
          <cx:pt idx="313">4</cx:pt>
          <cx:pt idx="314">4</cx:pt>
          <cx:pt idx="315">4</cx:pt>
          <cx:pt idx="316">4</cx:pt>
          <cx:pt idx="317">4</cx:pt>
          <cx:pt idx="318">4</cx:pt>
          <cx:pt idx="319">4</cx:pt>
          <cx:pt idx="320">4</cx:pt>
          <cx:pt idx="321">4</cx:pt>
          <cx:pt idx="322">4</cx:pt>
          <cx:pt idx="323">4</cx:pt>
          <cx:pt idx="324">4</cx:pt>
          <cx:pt idx="325">4</cx:pt>
          <cx:pt idx="326">4</cx:pt>
          <cx:pt idx="327">4</cx:pt>
          <cx:pt idx="328">4</cx:pt>
          <cx:pt idx="329">4</cx:pt>
          <cx:pt idx="330">4</cx:pt>
          <cx:pt idx="331">4</cx:pt>
          <cx:pt idx="332">4</cx:pt>
          <cx:pt idx="333">4</cx:pt>
          <cx:pt idx="334">4</cx:pt>
          <cx:pt idx="335">4</cx:pt>
          <cx:pt idx="336">4</cx:pt>
          <cx:pt idx="337">4</cx:pt>
          <cx:pt idx="338">4</cx:pt>
          <cx:pt idx="339">4</cx:pt>
          <cx:pt idx="340">4</cx:pt>
          <cx:pt idx="341">4</cx:pt>
          <cx:pt idx="342">4</cx:pt>
          <cx:pt idx="343">4</cx:pt>
          <cx:pt idx="344">4</cx:pt>
          <cx:pt idx="345">4</cx:pt>
          <cx:pt idx="346">4</cx:pt>
          <cx:pt idx="347">4</cx:pt>
          <cx:pt idx="348">4</cx:pt>
          <cx:pt idx="349">4</cx:pt>
          <cx:pt idx="350">4</cx:pt>
          <cx:pt idx="351">4</cx:pt>
          <cx:pt idx="352">4</cx:pt>
          <cx:pt idx="353">4</cx:pt>
          <cx:pt idx="354">4</cx:pt>
          <cx:pt idx="355">4</cx:pt>
          <cx:pt idx="356">4</cx:pt>
          <cx:pt idx="357">4</cx:pt>
          <cx:pt idx="358">4</cx:pt>
          <cx:pt idx="359">4</cx:pt>
          <cx:pt idx="360">4</cx:pt>
          <cx:pt idx="361">4</cx:pt>
          <cx:pt idx="362">4</cx:pt>
          <cx:pt idx="363">4</cx:pt>
          <cx:pt idx="364">4</cx:pt>
          <cx:pt idx="365">4</cx:pt>
          <cx:pt idx="366">4</cx:pt>
          <cx:pt idx="367">4</cx:pt>
          <cx:pt idx="368">4</cx:pt>
          <cx:pt idx="369">4</cx:pt>
          <cx:pt idx="370">4</cx:pt>
          <cx:pt idx="371">4</cx:pt>
          <cx:pt idx="372">4</cx:pt>
          <cx:pt idx="373">4</cx:pt>
          <cx:pt idx="374">4</cx:pt>
          <cx:pt idx="375">4</cx:pt>
          <cx:pt idx="376">4</cx:pt>
          <cx:pt idx="377">4</cx:pt>
          <cx:pt idx="378">4</cx:pt>
          <cx:pt idx="379">4</cx:pt>
          <cx:pt idx="380">4</cx:pt>
          <cx:pt idx="381">4</cx:pt>
          <cx:pt idx="382">4</cx:pt>
          <cx:pt idx="383">4</cx:pt>
          <cx:pt idx="384">4</cx:pt>
          <cx:pt idx="385">4</cx:pt>
          <cx:pt idx="386">4</cx:pt>
          <cx:pt idx="387">4</cx:pt>
          <cx:pt idx="388">4</cx:pt>
          <cx:pt idx="389">4</cx:pt>
          <cx:pt idx="390">4</cx:pt>
          <cx:pt idx="391">4</cx:pt>
          <cx:pt idx="392">4</cx:pt>
          <cx:pt idx="393">4</cx:pt>
          <cx:pt idx="394">4</cx:pt>
          <cx:pt idx="395">4</cx:pt>
          <cx:pt idx="396">5</cx:pt>
          <cx:pt idx="397">5</cx:pt>
          <cx:pt idx="398">5</cx:pt>
          <cx:pt idx="399">5</cx:pt>
          <cx:pt idx="400">5</cx:pt>
          <cx:pt idx="401">5</cx:pt>
          <cx:pt idx="402">5</cx:pt>
          <cx:pt idx="403">5</cx:pt>
          <cx:pt idx="404">5</cx:pt>
          <cx:pt idx="405">5</cx:pt>
          <cx:pt idx="406">5</cx:pt>
          <cx:pt idx="407">5</cx:pt>
          <cx:pt idx="408">5</cx:pt>
          <cx:pt idx="409">5</cx:pt>
          <cx:pt idx="410">5</cx:pt>
          <cx:pt idx="411">5</cx:pt>
          <cx:pt idx="412">5</cx:pt>
          <cx:pt idx="413">5</cx:pt>
          <cx:pt idx="414">5</cx:pt>
          <cx:pt idx="415">5</cx:pt>
          <cx:pt idx="416">5</cx:pt>
          <cx:pt idx="417">5</cx:pt>
          <cx:pt idx="418">5</cx:pt>
          <cx:pt idx="419">5</cx:pt>
          <cx:pt idx="420">5</cx:pt>
          <cx:pt idx="421">5</cx:pt>
          <cx:pt idx="422">5</cx:pt>
          <cx:pt idx="423">5</cx:pt>
          <cx:pt idx="424">5</cx:pt>
          <cx:pt idx="425">5</cx:pt>
          <cx:pt idx="426">5</cx:pt>
          <cx:pt idx="427">5</cx:pt>
          <cx:pt idx="428">5</cx:pt>
          <cx:pt idx="429">5</cx:pt>
          <cx:pt idx="430">5</cx:pt>
          <cx:pt idx="431">5</cx:pt>
          <cx:pt idx="432">5</cx:pt>
          <cx:pt idx="433">5</cx:pt>
          <cx:pt idx="434">5</cx:pt>
          <cx:pt idx="435">5</cx:pt>
          <cx:pt idx="436">5</cx:pt>
          <cx:pt idx="437">5</cx:pt>
          <cx:pt idx="438">5</cx:pt>
          <cx:pt idx="439">6</cx:pt>
          <cx:pt idx="440">6</cx:pt>
          <cx:pt idx="441">6</cx:pt>
          <cx:pt idx="442">6</cx:pt>
          <cx:pt idx="443">6</cx:pt>
          <cx:pt idx="444">6</cx:pt>
          <cx:pt idx="445">6</cx:pt>
          <cx:pt idx="446">6</cx:pt>
          <cx:pt idx="447">6</cx:pt>
          <cx:pt idx="448">6</cx:pt>
          <cx:pt idx="449">6</cx:pt>
          <cx:pt idx="450">6</cx:pt>
          <cx:pt idx="451">6</cx:pt>
          <cx:pt idx="452">6</cx:pt>
          <cx:pt idx="453">6</cx:pt>
          <cx:pt idx="454">6</cx:pt>
          <cx:pt idx="455">6</cx:pt>
          <cx:pt idx="456">6</cx:pt>
          <cx:pt idx="457">6</cx:pt>
          <cx:pt idx="458">6</cx:pt>
          <cx:pt idx="459">6</cx:pt>
          <cx:pt idx="460">6</cx:pt>
          <cx:pt idx="461">6</cx:pt>
          <cx:pt idx="462">6</cx:pt>
          <cx:pt idx="463">6</cx:pt>
          <cx:pt idx="464">6</cx:pt>
          <cx:pt idx="465">6</cx:pt>
          <cx:pt idx="466">6</cx:pt>
          <cx:pt idx="467">6</cx:pt>
          <cx:pt idx="468">7</cx:pt>
          <cx:pt idx="469">7</cx:pt>
          <cx:pt idx="470">7</cx:pt>
          <cx:pt idx="471">7</cx:pt>
          <cx:pt idx="472">7</cx:pt>
          <cx:pt idx="473">7</cx:pt>
          <cx:pt idx="474">7</cx:pt>
          <cx:pt idx="475">7</cx:pt>
          <cx:pt idx="476">7</cx:pt>
          <cx:pt idx="477">7</cx:pt>
          <cx:pt idx="478">7</cx:pt>
          <cx:pt idx="479">7</cx:pt>
          <cx:pt idx="480">7</cx:pt>
          <cx:pt idx="481">7</cx:pt>
          <cx:pt idx="482">7</cx:pt>
          <cx:pt idx="483">7</cx:pt>
          <cx:pt idx="484">7</cx:pt>
          <cx:pt idx="485">7</cx:pt>
          <cx:pt idx="486">7</cx:pt>
          <cx:pt idx="487">7</cx:pt>
          <cx:pt idx="488">7</cx:pt>
          <cx:pt idx="489">8</cx:pt>
          <cx:pt idx="490">8</cx:pt>
          <cx:pt idx="491">8</cx:pt>
          <cx:pt idx="492">8</cx:pt>
          <cx:pt idx="493">8</cx:pt>
          <cx:pt idx="494">8</cx:pt>
          <cx:pt idx="495">8</cx:pt>
          <cx:pt idx="496">8</cx:pt>
          <cx:pt idx="497">8</cx:pt>
          <cx:pt idx="498">8</cx:pt>
          <cx:pt idx="499">9</cx:pt>
          <cx:pt idx="500">9</cx:pt>
          <cx:pt idx="501">9</cx:pt>
          <cx:pt idx="502">9</cx:pt>
          <cx:pt idx="503">9</cx:pt>
          <cx:pt idx="504">9</cx:pt>
          <cx:pt idx="505">9</cx:pt>
          <cx:pt idx="506">9</cx:pt>
          <cx:pt idx="507">10</cx:pt>
          <cx:pt idx="508">10</cx:pt>
          <cx:pt idx="509">10</cx:pt>
          <cx:pt idx="510">10</cx:pt>
          <cx:pt idx="511">10</cx:pt>
          <cx:pt idx="512">10</cx:pt>
          <cx:pt idx="513">11</cx:pt>
          <cx:pt idx="514">11</cx:pt>
          <cx:pt idx="515">11</cx:pt>
          <cx:pt idx="516">12</cx:pt>
          <cx:pt idx="517">14</cx:pt>
          <cx:pt idx="518">15</cx:pt>
          <cx:pt idx="519">17</cx:pt>
        </cx:lvl>
      </cx:numDim>
    </cx:data>
  </cx:chartData>
  <cx:chart>
    <cx:title pos="t" align="ctr" overlay="0">
      <cx:tx>
        <cx:txData>
          <cx:v/>
        </cx:txData>
      </cx:tx>
      <cx:txPr>
        <a:bodyPr spcFirstLastPara="1" vertOverflow="ellipsis" wrap="square" lIns="0" tIns="0" rIns="0" bIns="0" anchor="ctr" anchorCtr="1"/>
        <a:lstStyle/>
        <a:p>
          <a:pPr algn="ctr">
            <a:defRPr/>
          </a:pPr>
          <a:endParaRPr/>
        </a:p>
      </cx:txPr>
    </cx:title>
    <cx:plotArea>
      <cx:plotAreaRegion>
        <cx:series layoutId="boxWhisker" uniqueId="{4182C088-BBF1-40C3-8A6B-46B290DE937D}">
          <cx:dataId val="0"/>
          <cx:layoutPr>
            <cx:visibility meanLine="0" meanMarker="1" nonoutliers="0" outliers="1"/>
            <cx:statistics quartileMethod="exclusive"/>
          </cx:layoutPr>
        </cx:series>
      </cx:plotAreaRegion>
      <cx:axis id="0">
        <cx:catScaling gapWidth="1"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tickLabels/>
      </cx:axis>
      <cx:axis id="1">
        <cx:valScaling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majorGridlines/>
        <cx:tickLabels/>
      </cx:axis>
    </cx:plotArea>
  </cx:chart>
</cx:chartSpace>
</file>

<file path=ppt/charts/chartEx10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lvl ptCount="803">
          <cx:pt idx="0">Gewinn UC pro Tag</cx:pt>
          <cx:pt idx="1">Gewinn UC pro Tag</cx:pt>
          <cx:pt idx="2">Gewinn UC pro Tag</cx:pt>
          <cx:pt idx="3">Gewinn UC pro Tag</cx:pt>
          <cx:pt idx="4">Gewinn UC pro Tag</cx:pt>
          <cx:pt idx="5">Gewinn UC pro Tag</cx:pt>
          <cx:pt idx="6">Gewinn UC pro Tag</cx:pt>
          <cx:pt idx="7">Gewinn UC pro Tag</cx:pt>
          <cx:pt idx="8">Gewinn UC pro Tag</cx:pt>
          <cx:pt idx="9">Gewinn UC pro Tag</cx:pt>
          <cx:pt idx="10">Gewinn UC pro Tag</cx:pt>
          <cx:pt idx="11">Gewinn UC pro Tag</cx:pt>
          <cx:pt idx="12">Gewinn UC pro Tag</cx:pt>
          <cx:pt idx="13">Gewinn UC pro Tag</cx:pt>
          <cx:pt idx="14">Gewinn UC pro Tag</cx:pt>
          <cx:pt idx="15">Gewinn UC pro Tag</cx:pt>
          <cx:pt idx="16">Gewinn UC pro Tag</cx:pt>
          <cx:pt idx="17">Gewinn UC pro Tag</cx:pt>
          <cx:pt idx="18">Gewinn UC pro Tag</cx:pt>
          <cx:pt idx="19">Gewinn UC pro Tag</cx:pt>
          <cx:pt idx="20">Gewinn UC pro Tag</cx:pt>
          <cx:pt idx="21">Gewinn UC pro Tag</cx:pt>
          <cx:pt idx="22">Gewinn UC pro Tag</cx:pt>
          <cx:pt idx="23">Gewinn UC pro Tag</cx:pt>
          <cx:pt idx="24">Gewinn UC pro Tag</cx:pt>
          <cx:pt idx="25">Gewinn UC pro Tag</cx:pt>
          <cx:pt idx="26">Gewinn UC pro Tag</cx:pt>
          <cx:pt idx="27">Gewinn UC pro Tag</cx:pt>
          <cx:pt idx="28">Gewinn UC pro Tag</cx:pt>
          <cx:pt idx="29">Gewinn UC pro Tag</cx:pt>
          <cx:pt idx="30">Gewinn UC pro Tag</cx:pt>
          <cx:pt idx="31">Gewinn UC pro Tag</cx:pt>
          <cx:pt idx="32">Gewinn UC pro Tag</cx:pt>
          <cx:pt idx="33">Gewinn UC pro Tag</cx:pt>
          <cx:pt idx="34">Gewinn UC pro Tag</cx:pt>
          <cx:pt idx="35">Gewinn UC pro Tag</cx:pt>
          <cx:pt idx="36">Gewinn UC pro Tag</cx:pt>
          <cx:pt idx="37">Gewinn UC pro Tag</cx:pt>
          <cx:pt idx="38">Gewinn UC pro Tag</cx:pt>
          <cx:pt idx="39">Gewinn UC pro Tag</cx:pt>
          <cx:pt idx="40">Gewinn UC pro Tag</cx:pt>
          <cx:pt idx="41">Gewinn UC pro Tag</cx:pt>
          <cx:pt idx="42">Gewinn UC pro Tag</cx:pt>
          <cx:pt idx="43">Gewinn UC pro Tag</cx:pt>
          <cx:pt idx="44">Gewinn UC pro Tag</cx:pt>
          <cx:pt idx="45">Gewinn UC pro Tag</cx:pt>
          <cx:pt idx="46">Gewinn UC pro Tag</cx:pt>
          <cx:pt idx="47">Gewinn UC pro Tag</cx:pt>
          <cx:pt idx="48">Gewinn UC pro Tag</cx:pt>
          <cx:pt idx="49">Gewinn UC pro Tag</cx:pt>
          <cx:pt idx="50">Gewinn UC pro Tag</cx:pt>
          <cx:pt idx="51">Gewinn UC pro Tag</cx:pt>
          <cx:pt idx="52">Gewinn UC pro Tag</cx:pt>
          <cx:pt idx="53">Gewinn UC pro Tag</cx:pt>
          <cx:pt idx="54">Gewinn UC pro Tag</cx:pt>
          <cx:pt idx="55">Gewinn UC pro Tag</cx:pt>
          <cx:pt idx="56">Gewinn UC pro Tag</cx:pt>
          <cx:pt idx="57">Gewinn UC pro Tag</cx:pt>
          <cx:pt idx="58">Gewinn UC pro Tag</cx:pt>
          <cx:pt idx="59">Gewinn UC pro Tag</cx:pt>
          <cx:pt idx="60">Gewinn UC pro Tag</cx:pt>
          <cx:pt idx="61">Gewinn UC pro Tag</cx:pt>
          <cx:pt idx="62">Gewinn UC pro Tag</cx:pt>
          <cx:pt idx="63">Gewinn UC pro Tag</cx:pt>
          <cx:pt idx="64">Gewinn UC pro Tag</cx:pt>
          <cx:pt idx="65">Gewinn UC pro Tag</cx:pt>
          <cx:pt idx="66">Gewinn UC pro Tag</cx:pt>
          <cx:pt idx="67">Gewinn UC pro Tag</cx:pt>
          <cx:pt idx="68">Gewinn UC pro Tag</cx:pt>
          <cx:pt idx="69">Gewinn UC pro Tag</cx:pt>
          <cx:pt idx="70">Gewinn UC pro Tag</cx:pt>
          <cx:pt idx="71">Gewinn UC pro Tag</cx:pt>
          <cx:pt idx="72">Gewinn UC pro Tag</cx:pt>
          <cx:pt idx="73">Gewinn UC pro Tag</cx:pt>
          <cx:pt idx="74">Gewinn UC pro Tag</cx:pt>
          <cx:pt idx="75">Gewinn UC pro Tag</cx:pt>
          <cx:pt idx="76">Gewinn UC pro Tag</cx:pt>
          <cx:pt idx="77">Gewinn UC pro Tag</cx:pt>
          <cx:pt idx="78">Gewinn UC pro Tag</cx:pt>
          <cx:pt idx="79">Gewinn UC pro Tag</cx:pt>
          <cx:pt idx="80">Gewinn UC pro Tag</cx:pt>
          <cx:pt idx="81">Gewinn UC pro Tag</cx:pt>
          <cx:pt idx="82">Gewinn UC pro Tag</cx:pt>
          <cx:pt idx="83">Gewinn UC pro Tag</cx:pt>
          <cx:pt idx="84">Gewinn UC pro Tag</cx:pt>
          <cx:pt idx="85">Gewinn UC pro Tag</cx:pt>
          <cx:pt idx="86">Gewinn UC pro Tag</cx:pt>
          <cx:pt idx="87">Gewinn UC pro Tag</cx:pt>
          <cx:pt idx="88">Gewinn UC pro Tag</cx:pt>
          <cx:pt idx="89">Gewinn UC pro Tag</cx:pt>
          <cx:pt idx="90">Gewinn UC pro Tag</cx:pt>
          <cx:pt idx="91">Gewinn UC pro Tag</cx:pt>
          <cx:pt idx="92">Gewinn UC pro Tag</cx:pt>
          <cx:pt idx="93">Gewinn UC pro Tag</cx:pt>
          <cx:pt idx="94">Gewinn UC pro Tag</cx:pt>
          <cx:pt idx="95">Gewinn UC pro Tag</cx:pt>
          <cx:pt idx="96">Gewinn UC pro Tag</cx:pt>
          <cx:pt idx="97">Gewinn UC pro Tag</cx:pt>
          <cx:pt idx="98">Gewinn UC pro Tag</cx:pt>
          <cx:pt idx="99">Gewinn UC pro Tag</cx:pt>
          <cx:pt idx="100">Gewinn UC pro Tag</cx:pt>
          <cx:pt idx="101">Gewinn UC pro Tag</cx:pt>
          <cx:pt idx="102">Gewinn UC pro Tag</cx:pt>
          <cx:pt idx="103">Gewinn UC pro Tag</cx:pt>
          <cx:pt idx="104">Gewinn UC pro Tag</cx:pt>
          <cx:pt idx="105">Gewinn UC pro Tag</cx:pt>
          <cx:pt idx="106">Gewinn UC pro Tag</cx:pt>
          <cx:pt idx="107">Gewinn UC pro Tag</cx:pt>
          <cx:pt idx="108">Gewinn UC pro Tag</cx:pt>
          <cx:pt idx="109">Gewinn UC pro Tag</cx:pt>
          <cx:pt idx="110">Gewinn UC pro Tag</cx:pt>
          <cx:pt idx="111">Gewinn UC pro Tag</cx:pt>
          <cx:pt idx="112">Gewinn UC pro Tag</cx:pt>
          <cx:pt idx="113">Gewinn UC pro Tag</cx:pt>
          <cx:pt idx="114">Gewinn UC pro Tag</cx:pt>
          <cx:pt idx="115">Gewinn UC pro Tag</cx:pt>
          <cx:pt idx="116">Gewinn UC pro Tag</cx:pt>
          <cx:pt idx="117">Gewinn UC pro Tag</cx:pt>
          <cx:pt idx="118">Gewinn UC pro Tag</cx:pt>
          <cx:pt idx="119">Gewinn UC pro Tag</cx:pt>
          <cx:pt idx="120">Gewinn UC pro Tag</cx:pt>
          <cx:pt idx="121">Gewinn UC pro Tag</cx:pt>
          <cx:pt idx="122">Gewinn UC pro Tag</cx:pt>
          <cx:pt idx="123">Gewinn UC pro Tag</cx:pt>
          <cx:pt idx="124">Gewinn UC pro Tag</cx:pt>
          <cx:pt idx="125">Gewinn UC pro Tag</cx:pt>
          <cx:pt idx="126">Gewinn UC pro Tag</cx:pt>
          <cx:pt idx="127">Gewinn UC pro Tag</cx:pt>
          <cx:pt idx="128">Gewinn UC pro Tag</cx:pt>
          <cx:pt idx="129">Gewinn UC pro Tag</cx:pt>
          <cx:pt idx="130">Gewinn UC pro Tag</cx:pt>
          <cx:pt idx="131">Gewinn UC pro Tag</cx:pt>
          <cx:pt idx="132">Gewinn UC pro Tag</cx:pt>
          <cx:pt idx="133">Gewinn UC pro Tag</cx:pt>
          <cx:pt idx="134">Gewinn UC pro Tag</cx:pt>
          <cx:pt idx="135">Gewinn UC pro Tag</cx:pt>
          <cx:pt idx="136">Gewinn UC pro Tag</cx:pt>
          <cx:pt idx="137">Gewinn UC pro Tag</cx:pt>
          <cx:pt idx="138">Gewinn UC pro Tag</cx:pt>
          <cx:pt idx="139">Gewinn UC pro Tag</cx:pt>
          <cx:pt idx="140">Gewinn UC pro Tag</cx:pt>
          <cx:pt idx="141">Gewinn UC pro Tag</cx:pt>
          <cx:pt idx="142">Gewinn UC pro Tag</cx:pt>
          <cx:pt idx="143">Gewinn UC pro Tag</cx:pt>
          <cx:pt idx="144">Gewinn UC pro Tag</cx:pt>
          <cx:pt idx="145">Gewinn UC pro Tag</cx:pt>
          <cx:pt idx="146">Gewinn UC pro Tag</cx:pt>
          <cx:pt idx="147">Gewinn UC pro Tag</cx:pt>
          <cx:pt idx="148">Gewinn UC pro Tag</cx:pt>
          <cx:pt idx="149">Gewinn UC pro Tag</cx:pt>
          <cx:pt idx="150">Gewinn UC pro Tag</cx:pt>
          <cx:pt idx="151">Gewinn UC pro Tag</cx:pt>
          <cx:pt idx="152">Gewinn UC pro Tag</cx:pt>
          <cx:pt idx="153">Gewinn UC pro Tag</cx:pt>
          <cx:pt idx="154">Gewinn UC pro Tag</cx:pt>
          <cx:pt idx="155">Gewinn UC pro Tag</cx:pt>
          <cx:pt idx="156">Gewinn UC pro Tag</cx:pt>
          <cx:pt idx="157">Gewinn UC pro Tag</cx:pt>
          <cx:pt idx="158">Gewinn UC pro Tag</cx:pt>
          <cx:pt idx="159">Gewinn UC pro Tag</cx:pt>
          <cx:pt idx="160">Gewinn UC pro Tag</cx:pt>
          <cx:pt idx="161">Gewinn UC pro Tag</cx:pt>
          <cx:pt idx="162">Gewinn UC pro Tag</cx:pt>
          <cx:pt idx="163">Gewinn UC pro Tag</cx:pt>
          <cx:pt idx="164">Gewinn UC pro Tag</cx:pt>
          <cx:pt idx="165">Gewinn UC pro Tag</cx:pt>
          <cx:pt idx="166">Gewinn UC pro Tag</cx:pt>
          <cx:pt idx="167">Gewinn UC pro Tag</cx:pt>
          <cx:pt idx="168">Gewinn UC pro Tag</cx:pt>
          <cx:pt idx="169">Gewinn UC pro Tag</cx:pt>
          <cx:pt idx="170">Gewinn UC pro Tag</cx:pt>
          <cx:pt idx="171">Gewinn UC pro Tag</cx:pt>
          <cx:pt idx="172">Gewinn UC pro Tag</cx:pt>
          <cx:pt idx="173">Gewinn UC pro Tag</cx:pt>
          <cx:pt idx="174">Gewinn UC pro Tag</cx:pt>
          <cx:pt idx="175">Gewinn UC pro Tag</cx:pt>
          <cx:pt idx="176">Gewinn UC pro Tag</cx:pt>
          <cx:pt idx="177">Gewinn UC pro Tag</cx:pt>
          <cx:pt idx="178">Gewinn UC pro Tag</cx:pt>
          <cx:pt idx="179">Gewinn UC pro Tag</cx:pt>
          <cx:pt idx="180">Gewinn UC pro Tag</cx:pt>
          <cx:pt idx="181">Gewinn UC pro Tag</cx:pt>
          <cx:pt idx="182">Gewinn UC pro Tag</cx:pt>
          <cx:pt idx="183">Gewinn UC pro Tag</cx:pt>
          <cx:pt idx="184">Gewinn UC pro Tag</cx:pt>
          <cx:pt idx="185">Gewinn UC pro Tag</cx:pt>
          <cx:pt idx="186">Gewinn UC pro Tag</cx:pt>
          <cx:pt idx="187">Gewinn UC pro Tag</cx:pt>
          <cx:pt idx="188">Gewinn UC pro Tag</cx:pt>
          <cx:pt idx="189">Gewinn UC pro Tag</cx:pt>
          <cx:pt idx="190">Gewinn UC pro Tag</cx:pt>
          <cx:pt idx="191">Gewinn UC pro Tag</cx:pt>
          <cx:pt idx="192">Gewinn UC pro Tag</cx:pt>
          <cx:pt idx="193">Gewinn UC pro Tag</cx:pt>
          <cx:pt idx="194">Gewinn UC pro Tag</cx:pt>
          <cx:pt idx="195">Gewinn UC pro Tag</cx:pt>
          <cx:pt idx="196">Gewinn UC pro Tag</cx:pt>
          <cx:pt idx="197">Gewinn UC pro Tag</cx:pt>
          <cx:pt idx="198">Gewinn UC pro Tag</cx:pt>
          <cx:pt idx="199">Gewinn UC pro Tag</cx:pt>
          <cx:pt idx="200">Gewinn UC pro Tag</cx:pt>
          <cx:pt idx="201">Gewinn UC pro Tag</cx:pt>
          <cx:pt idx="202">Gewinn UC pro Tag</cx:pt>
          <cx:pt idx="203">Gewinn UC pro Tag</cx:pt>
          <cx:pt idx="204">Gewinn UC pro Tag</cx:pt>
          <cx:pt idx="205">Gewinn UC pro Tag</cx:pt>
          <cx:pt idx="206">Gewinn UC pro Tag</cx:pt>
          <cx:pt idx="207">Gewinn UC pro Tag</cx:pt>
          <cx:pt idx="208">Gewinn UC pro Tag</cx:pt>
          <cx:pt idx="209">Gewinn UC pro Tag</cx:pt>
          <cx:pt idx="210">Gewinn UC pro Tag</cx:pt>
          <cx:pt idx="211">Gewinn UC pro Tag</cx:pt>
          <cx:pt idx="212">Gewinn UC pro Tag</cx:pt>
          <cx:pt idx="213">Gewinn UC pro Tag</cx:pt>
          <cx:pt idx="214">Gewinn UC pro Tag</cx:pt>
          <cx:pt idx="215">Gewinn UC pro Tag</cx:pt>
          <cx:pt idx="216">Gewinn UC pro Tag</cx:pt>
          <cx:pt idx="217">Gewinn UC pro Tag</cx:pt>
          <cx:pt idx="218">Gewinn UC pro Tag</cx:pt>
          <cx:pt idx="219">Gewinn UC pro Tag</cx:pt>
          <cx:pt idx="220">Gewinn UC pro Tag</cx:pt>
          <cx:pt idx="221">Gewinn UC pro Tag</cx:pt>
          <cx:pt idx="222">Gewinn UC pro Tag</cx:pt>
          <cx:pt idx="223">Gewinn UC pro Tag</cx:pt>
          <cx:pt idx="224">Gewinn UC pro Tag</cx:pt>
          <cx:pt idx="225">Gewinn UC pro Tag</cx:pt>
          <cx:pt idx="226">Gewinn UC pro Tag</cx:pt>
          <cx:pt idx="227">Gewinn UC pro Tag</cx:pt>
          <cx:pt idx="228">Gewinn UC pro Tag</cx:pt>
          <cx:pt idx="229">Gewinn UC pro Tag</cx:pt>
          <cx:pt idx="230">Gewinn UC pro Tag</cx:pt>
          <cx:pt idx="231">Gewinn UC pro Tag</cx:pt>
          <cx:pt idx="232">Gewinn UC pro Tag</cx:pt>
          <cx:pt idx="233">Gewinn UC pro Tag</cx:pt>
          <cx:pt idx="234">Gewinn UC pro Tag</cx:pt>
          <cx:pt idx="235">Gewinn UC pro Tag</cx:pt>
          <cx:pt idx="236">Gewinn UC pro Tag</cx:pt>
          <cx:pt idx="237">Gewinn UC pro Tag</cx:pt>
          <cx:pt idx="238">Gewinn UC pro Tag</cx:pt>
          <cx:pt idx="239">Gewinn UC pro Tag</cx:pt>
          <cx:pt idx="240">Gewinn UC pro Tag</cx:pt>
          <cx:pt idx="241">Gewinn UC pro Tag</cx:pt>
          <cx:pt idx="242">Gewinn UC pro Tag</cx:pt>
          <cx:pt idx="243">Gewinn UC pro Tag</cx:pt>
          <cx:pt idx="244">Gewinn UC pro Tag</cx:pt>
          <cx:pt idx="245">Gewinn UC pro Tag</cx:pt>
          <cx:pt idx="246">Gewinn UC pro Tag</cx:pt>
          <cx:pt idx="247">Gewinn UC pro Tag</cx:pt>
          <cx:pt idx="248">Gewinn UC pro Tag</cx:pt>
          <cx:pt idx="249">Gewinn UC pro Tag</cx:pt>
          <cx:pt idx="250">Gewinn UC pro Tag</cx:pt>
          <cx:pt idx="251">Gewinn UC pro Tag</cx:pt>
          <cx:pt idx="252">Gewinn UC pro Tag</cx:pt>
          <cx:pt idx="253">Gewinn UC pro Tag</cx:pt>
          <cx:pt idx="254">Gewinn UC pro Tag</cx:pt>
          <cx:pt idx="255">Gewinn UC pro Tag</cx:pt>
          <cx:pt idx="256">Gewinn UC pro Tag</cx:pt>
          <cx:pt idx="257">Gewinn UC pro Tag</cx:pt>
          <cx:pt idx="258">Gewinn UC pro Tag</cx:pt>
          <cx:pt idx="259">Gewinn UC pro Tag</cx:pt>
          <cx:pt idx="260">Gewinn UC pro Tag</cx:pt>
          <cx:pt idx="261">Gewinn UC pro Tag</cx:pt>
          <cx:pt idx="262">Gewinn UC pro Tag</cx:pt>
          <cx:pt idx="263">Gewinn UC pro Tag</cx:pt>
          <cx:pt idx="264">Gewinn UC pro Tag</cx:pt>
          <cx:pt idx="265">Gewinn UC pro Tag</cx:pt>
          <cx:pt idx="266">Gewinn UC pro Tag</cx:pt>
          <cx:pt idx="267">Gewinn UC pro Tag</cx:pt>
          <cx:pt idx="268">Gewinn UC pro Tag</cx:pt>
          <cx:pt idx="269">Gewinn UC pro Tag</cx:pt>
          <cx:pt idx="270">Gewinn UC pro Tag</cx:pt>
          <cx:pt idx="271">Gewinn UC pro Tag</cx:pt>
          <cx:pt idx="272">Gewinn UC pro Tag</cx:pt>
          <cx:pt idx="273">Gewinn UC pro Tag</cx:pt>
          <cx:pt idx="274">Gewinn UC pro Tag</cx:pt>
          <cx:pt idx="275">Gewinn UC pro Tag</cx:pt>
          <cx:pt idx="276">Gewinn UC pro Tag</cx:pt>
          <cx:pt idx="277">Gewinn UC pro Tag</cx:pt>
          <cx:pt idx="278">Gewinn UC pro Tag</cx:pt>
          <cx:pt idx="279">Gewinn UC pro Tag</cx:pt>
          <cx:pt idx="280">Gewinn UC pro Tag</cx:pt>
          <cx:pt idx="281">Gewinn UC pro Tag</cx:pt>
          <cx:pt idx="282">Gewinn UC pro Tag</cx:pt>
          <cx:pt idx="283">Gewinn UC pro Tag</cx:pt>
          <cx:pt idx="284">Gewinn UC pro Tag</cx:pt>
          <cx:pt idx="285">Gewinn UC pro Tag</cx:pt>
          <cx:pt idx="286">Gewinn UC pro Tag</cx:pt>
          <cx:pt idx="287">Gewinn UC pro Tag</cx:pt>
          <cx:pt idx="288">Gewinn UC pro Tag</cx:pt>
          <cx:pt idx="289">Gewinn UC pro Tag</cx:pt>
          <cx:pt idx="290">Gewinn UC pro Tag</cx:pt>
          <cx:pt idx="291">Gewinn UC pro Tag</cx:pt>
          <cx:pt idx="292">Gewinn UC pro Tag</cx:pt>
          <cx:pt idx="293">Gewinn UC pro Tag</cx:pt>
          <cx:pt idx="294">Gewinn UC pro Tag</cx:pt>
          <cx:pt idx="295">Gewinn UC pro Tag</cx:pt>
          <cx:pt idx="296">Gewinn UC pro Tag</cx:pt>
          <cx:pt idx="297">Gewinn UC pro Tag</cx:pt>
          <cx:pt idx="298">Gewinn UC pro Tag</cx:pt>
          <cx:pt idx="299">Gewinn UC pro Tag</cx:pt>
          <cx:pt idx="300">Gewinn UC pro Tag</cx:pt>
          <cx:pt idx="301">Gewinn UC pro Tag</cx:pt>
          <cx:pt idx="302">Gewinn UC pro Tag</cx:pt>
          <cx:pt idx="303">Gewinn UC pro Tag</cx:pt>
          <cx:pt idx="304">Gewinn UC pro Tag</cx:pt>
          <cx:pt idx="305">Gewinn UC pro Tag</cx:pt>
          <cx:pt idx="306">Gewinn UC pro Tag</cx:pt>
          <cx:pt idx="307">Gewinn UC pro Tag</cx:pt>
          <cx:pt idx="308">Gewinn UC pro Tag</cx:pt>
          <cx:pt idx="309">Gewinn UC pro Tag</cx:pt>
          <cx:pt idx="310">Gewinn UC pro Tag</cx:pt>
          <cx:pt idx="311">Gewinn UC pro Tag</cx:pt>
          <cx:pt idx="312">Gewinn UC pro Tag</cx:pt>
          <cx:pt idx="313">Gewinn UC pro Tag</cx:pt>
          <cx:pt idx="314">Gewinn UC pro Tag</cx:pt>
          <cx:pt idx="315">Gewinn UC pro Tag</cx:pt>
          <cx:pt idx="316">Gewinn UC pro Tag</cx:pt>
          <cx:pt idx="317">Gewinn UC pro Tag</cx:pt>
          <cx:pt idx="318">Gewinn UC pro Tag</cx:pt>
          <cx:pt idx="319">Gewinn UC pro Tag</cx:pt>
          <cx:pt idx="320">Gewinn UC pro Tag</cx:pt>
          <cx:pt idx="321">Gewinn UC pro Tag</cx:pt>
          <cx:pt idx="322">Gewinn UC pro Tag</cx:pt>
          <cx:pt idx="323">Gewinn UC pro Tag</cx:pt>
          <cx:pt idx="324">Gewinn UC pro Tag</cx:pt>
          <cx:pt idx="325">Gewinn UC pro Tag</cx:pt>
          <cx:pt idx="326">Gewinn UC pro Tag</cx:pt>
          <cx:pt idx="327">Gewinn UC pro Tag</cx:pt>
          <cx:pt idx="328">Gewinn UC pro Tag</cx:pt>
          <cx:pt idx="329">Gewinn UC pro Tag</cx:pt>
          <cx:pt idx="330">Gewinn UC pro Tag</cx:pt>
          <cx:pt idx="331">Gewinn UC pro Tag</cx:pt>
          <cx:pt idx="332">Gewinn UC pro Tag</cx:pt>
          <cx:pt idx="333">Gewinn UC pro Tag</cx:pt>
          <cx:pt idx="334">Gewinn UC pro Tag</cx:pt>
          <cx:pt idx="335">Gewinn UC pro Tag</cx:pt>
          <cx:pt idx="336">Gewinn UC pro Tag</cx:pt>
          <cx:pt idx="337">Gewinn UC pro Tag</cx:pt>
          <cx:pt idx="338">Gewinn UC pro Tag</cx:pt>
          <cx:pt idx="339">Gewinn UC pro Tag</cx:pt>
          <cx:pt idx="340">Gewinn UC pro Tag</cx:pt>
          <cx:pt idx="341">Gewinn UC pro Tag</cx:pt>
          <cx:pt idx="342">Gewinn UC pro Tag</cx:pt>
          <cx:pt idx="343">Gewinn UC pro Tag</cx:pt>
          <cx:pt idx="344">Gewinn UC pro Tag</cx:pt>
          <cx:pt idx="345">Gewinn UC pro Tag</cx:pt>
          <cx:pt idx="346">Gewinn UC pro Tag</cx:pt>
          <cx:pt idx="347">Gewinn UC pro Tag</cx:pt>
          <cx:pt idx="348">Gewinn UC pro Tag</cx:pt>
          <cx:pt idx="349">Gewinn UC pro Tag</cx:pt>
          <cx:pt idx="350">Gewinn UC pro Tag</cx:pt>
          <cx:pt idx="351">Gewinn UC pro Tag</cx:pt>
          <cx:pt idx="352">Gewinn UC pro Tag</cx:pt>
          <cx:pt idx="353">Gewinn UC pro Tag</cx:pt>
          <cx:pt idx="354">Gewinn UC pro Tag</cx:pt>
          <cx:pt idx="355">Gewinn UC pro Tag</cx:pt>
          <cx:pt idx="356">Gewinn UC pro Tag</cx:pt>
          <cx:pt idx="357">Gewinn UC pro Tag</cx:pt>
          <cx:pt idx="358">Gewinn UC pro Tag</cx:pt>
          <cx:pt idx="359">Gewinn UC pro Tag</cx:pt>
          <cx:pt idx="360">Gewinn UC pro Tag</cx:pt>
          <cx:pt idx="361">Gewinn UC pro Tag</cx:pt>
          <cx:pt idx="362">Gewinn UC pro Tag</cx:pt>
          <cx:pt idx="363">Gewinn UC pro Tag</cx:pt>
          <cx:pt idx="364">Gewinn UC pro Tag</cx:pt>
          <cx:pt idx="365">Gewinn UC pro Tag</cx:pt>
          <cx:pt idx="366">Gewinn UC pro Tag</cx:pt>
          <cx:pt idx="367">Gewinn UC pro Tag</cx:pt>
          <cx:pt idx="368">Gewinn UC pro Tag</cx:pt>
          <cx:pt idx="369">Gewinn UC pro Tag</cx:pt>
          <cx:pt idx="370">Gewinn UC pro Tag</cx:pt>
          <cx:pt idx="371">Gewinn UC pro Tag</cx:pt>
          <cx:pt idx="372">Gewinn UC pro Tag</cx:pt>
          <cx:pt idx="373">Gewinn UC pro Tag</cx:pt>
          <cx:pt idx="374">Gewinn UC pro Tag</cx:pt>
          <cx:pt idx="375">Gewinn UC pro Tag</cx:pt>
          <cx:pt idx="376">Gewinn UC pro Tag</cx:pt>
          <cx:pt idx="377">Gewinn UC pro Tag</cx:pt>
          <cx:pt idx="378">Gewinn UC pro Tag</cx:pt>
          <cx:pt idx="379">Gewinn UC pro Tag</cx:pt>
          <cx:pt idx="380">Gewinn UC pro Tag</cx:pt>
          <cx:pt idx="381">Gewinn UC pro Tag</cx:pt>
          <cx:pt idx="382">Gewinn UC pro Tag</cx:pt>
          <cx:pt idx="383">Gewinn UC pro Tag</cx:pt>
          <cx:pt idx="384">Gewinn UC pro Tag</cx:pt>
          <cx:pt idx="385">Gewinn UC pro Tag</cx:pt>
          <cx:pt idx="386">Gewinn UC pro Tag</cx:pt>
          <cx:pt idx="387">Gewinn UC pro Tag</cx:pt>
          <cx:pt idx="388">Gewinn UC pro Tag</cx:pt>
          <cx:pt idx="389">Gewinn UC pro Tag</cx:pt>
          <cx:pt idx="390">Gewinn UC pro Tag</cx:pt>
          <cx:pt idx="391">Gewinn UC pro Tag</cx:pt>
          <cx:pt idx="392">Gewinn UC pro Tag</cx:pt>
          <cx:pt idx="393">Gewinn UC pro Tag</cx:pt>
          <cx:pt idx="394">Gewinn UC pro Tag</cx:pt>
          <cx:pt idx="395">Gewinn UC pro Tag</cx:pt>
          <cx:pt idx="396">Gewinn UC pro Tag</cx:pt>
          <cx:pt idx="397">Gewinn UC pro Tag</cx:pt>
          <cx:pt idx="398">Gewinn UC pro Tag</cx:pt>
          <cx:pt idx="399">Gewinn UC pro Tag</cx:pt>
          <cx:pt idx="400">Gewinn UC pro Tag</cx:pt>
          <cx:pt idx="401">Gewinn UC pro Tag</cx:pt>
          <cx:pt idx="402">Gewinn UC pro Tag</cx:pt>
          <cx:pt idx="403">Gewinn UC pro Tag</cx:pt>
          <cx:pt idx="404">Gewinn UC pro Tag</cx:pt>
          <cx:pt idx="405">Gewinn UC pro Tag</cx:pt>
          <cx:pt idx="406">Gewinn UC pro Tag</cx:pt>
          <cx:pt idx="407">Gewinn UC pro Tag</cx:pt>
          <cx:pt idx="408">Gewinn UC pro Tag</cx:pt>
          <cx:pt idx="409">Gewinn UC pro Tag</cx:pt>
          <cx:pt idx="410">Gewinn UC pro Tag</cx:pt>
          <cx:pt idx="411">Gewinn UC pro Tag</cx:pt>
          <cx:pt idx="412">Gewinn UC pro Tag</cx:pt>
          <cx:pt idx="413">Gewinn UC pro Tag</cx:pt>
          <cx:pt idx="414">Gewinn UC pro Tag</cx:pt>
          <cx:pt idx="415">Gewinn UC pro Tag</cx:pt>
          <cx:pt idx="416">Gewinn UC pro Tag</cx:pt>
          <cx:pt idx="417">Gewinn UC pro Tag</cx:pt>
          <cx:pt idx="418">Gewinn UC pro Tag</cx:pt>
          <cx:pt idx="419">Gewinn UC pro Tag</cx:pt>
          <cx:pt idx="420">Gewinn UC pro Tag</cx:pt>
          <cx:pt idx="421">Gewinn UC pro Tag</cx:pt>
          <cx:pt idx="422">Gewinn UC pro Tag</cx:pt>
          <cx:pt idx="423">Gewinn UC pro Tag</cx:pt>
          <cx:pt idx="424">Gewinn UC pro Tag</cx:pt>
          <cx:pt idx="425">Gewinn UC pro Tag</cx:pt>
          <cx:pt idx="426">Gewinn UC pro Tag</cx:pt>
          <cx:pt idx="427">Gewinn UC pro Tag</cx:pt>
          <cx:pt idx="428">Gewinn UC pro Tag</cx:pt>
          <cx:pt idx="429">Gewinn UC pro Tag</cx:pt>
          <cx:pt idx="430">Gewinn UC pro Tag</cx:pt>
          <cx:pt idx="431">Gewinn UC pro Tag</cx:pt>
          <cx:pt idx="432">Gewinn UC pro Tag</cx:pt>
          <cx:pt idx="433">Gewinn UC pro Tag</cx:pt>
          <cx:pt idx="434">Gewinn UC pro Tag</cx:pt>
          <cx:pt idx="435">Gewinn UC pro Tag</cx:pt>
          <cx:pt idx="436">Gewinn UC pro Tag</cx:pt>
          <cx:pt idx="437">Gewinn UC pro Tag</cx:pt>
          <cx:pt idx="438">Gewinn UC pro Tag</cx:pt>
          <cx:pt idx="439">Gewinn UC pro Tag</cx:pt>
          <cx:pt idx="440">Gewinn UC pro Tag</cx:pt>
          <cx:pt idx="441">Gewinn UC pro Tag</cx:pt>
          <cx:pt idx="442">Gewinn UC pro Tag</cx:pt>
          <cx:pt idx="443">Gewinn UC pro Tag</cx:pt>
          <cx:pt idx="444">Gewinn UC pro Tag</cx:pt>
          <cx:pt idx="445">Gewinn UC pro Tag</cx:pt>
          <cx:pt idx="446">Gewinn UC pro Tag</cx:pt>
          <cx:pt idx="447">Gewinn UC pro Tag</cx:pt>
          <cx:pt idx="448">Gewinn UC pro Tag</cx:pt>
          <cx:pt idx="449">Gewinn UC pro Tag</cx:pt>
          <cx:pt idx="450">Gewinn UC pro Tag</cx:pt>
          <cx:pt idx="451">Gewinn UC pro Tag</cx:pt>
          <cx:pt idx="452">Gewinn UC pro Tag</cx:pt>
          <cx:pt idx="453">Gewinn UC pro Tag</cx:pt>
          <cx:pt idx="454">Gewinn UC pro Tag</cx:pt>
          <cx:pt idx="455">Gewinn UC pro Tag</cx:pt>
          <cx:pt idx="456">Gewinn UC pro Tag</cx:pt>
          <cx:pt idx="457">Gewinn UC pro Tag</cx:pt>
          <cx:pt idx="458">Gewinn UC pro Tag</cx:pt>
          <cx:pt idx="459">Gewinn UC pro Tag</cx:pt>
          <cx:pt idx="460">Gewinn UC pro Tag</cx:pt>
          <cx:pt idx="461">Gewinn UC pro Tag</cx:pt>
          <cx:pt idx="462">Gewinn UC pro Tag</cx:pt>
          <cx:pt idx="463">Gewinn UC pro Tag</cx:pt>
          <cx:pt idx="464">Gewinn UC pro Tag</cx:pt>
          <cx:pt idx="465">Gewinn UC pro Tag</cx:pt>
          <cx:pt idx="466">Gewinn UC pro Tag</cx:pt>
          <cx:pt idx="467">Gewinn UC pro Tag</cx:pt>
          <cx:pt idx="468">Gewinn UC pro Tag</cx:pt>
          <cx:pt idx="469">Gewinn UC pro Tag</cx:pt>
          <cx:pt idx="470">Gewinn UC pro Tag</cx:pt>
          <cx:pt idx="471">Gewinn UC pro Tag</cx:pt>
          <cx:pt idx="472">Gewinn UC pro Tag</cx:pt>
          <cx:pt idx="473">Gewinn UC pro Tag</cx:pt>
          <cx:pt idx="474">Gewinn UC pro Tag</cx:pt>
          <cx:pt idx="475">Gewinn UC pro Tag</cx:pt>
          <cx:pt idx="476">Gewinn UC pro Tag</cx:pt>
          <cx:pt idx="477">Gewinn UC pro Tag</cx:pt>
          <cx:pt idx="478">Gewinn UC pro Tag</cx:pt>
          <cx:pt idx="479">Gewinn UC pro Tag</cx:pt>
          <cx:pt idx="480">Gewinn UC pro Tag</cx:pt>
          <cx:pt idx="481">Gewinn UC pro Tag</cx:pt>
          <cx:pt idx="482">Gewinn UC pro Tag</cx:pt>
          <cx:pt idx="483">Gewinn UC pro Tag</cx:pt>
          <cx:pt idx="484">Gewinn UC pro Tag</cx:pt>
          <cx:pt idx="485">Gewinn UC pro Tag</cx:pt>
          <cx:pt idx="486">Gewinn UC pro Tag</cx:pt>
          <cx:pt idx="487">Gewinn UC pro Tag</cx:pt>
          <cx:pt idx="488">Gewinn UC pro Tag</cx:pt>
          <cx:pt idx="489">Gewinn UC pro Tag</cx:pt>
          <cx:pt idx="490">Gewinn UC pro Tag</cx:pt>
          <cx:pt idx="491">Gewinn UC pro Tag</cx:pt>
          <cx:pt idx="492">Gewinn UC pro Tag</cx:pt>
          <cx:pt idx="493">Gewinn UC pro Tag</cx:pt>
          <cx:pt idx="494">Gewinn UC pro Tag</cx:pt>
          <cx:pt idx="495">Gewinn UC pro Tag</cx:pt>
          <cx:pt idx="496">Gewinn UC pro Tag</cx:pt>
          <cx:pt idx="497">Gewinn UC pro Tag</cx:pt>
          <cx:pt idx="498">Gewinn UC pro Tag</cx:pt>
          <cx:pt idx="499">Gewinn UC pro Tag</cx:pt>
          <cx:pt idx="500">Gewinn UC pro Tag</cx:pt>
          <cx:pt idx="501">Gewinn UC pro Tag</cx:pt>
          <cx:pt idx="502">Gewinn UC pro Tag</cx:pt>
          <cx:pt idx="503">Gewinn UC pro Tag</cx:pt>
          <cx:pt idx="504">Gewinn UC pro Tag</cx:pt>
          <cx:pt idx="505">Gewinn UC pro Tag</cx:pt>
          <cx:pt idx="506">Gewinn UC pro Tag</cx:pt>
          <cx:pt idx="507">Gewinn UC pro Tag</cx:pt>
          <cx:pt idx="508">Gewinn UC pro Tag</cx:pt>
          <cx:pt idx="509">Gewinn UC pro Tag</cx:pt>
          <cx:pt idx="510">Gewinn UC pro Tag</cx:pt>
          <cx:pt idx="511">Gewinn UC pro Tag</cx:pt>
          <cx:pt idx="512">Gewinn UC pro Tag</cx:pt>
          <cx:pt idx="513">Gewinn UC pro Tag</cx:pt>
          <cx:pt idx="514">Gewinn UC pro Tag</cx:pt>
          <cx:pt idx="515">Gewinn UC pro Tag</cx:pt>
          <cx:pt idx="516">Gewinn UC pro Tag</cx:pt>
          <cx:pt idx="517">Gewinn UC pro Tag</cx:pt>
          <cx:pt idx="518">Gewinn UC pro Tag</cx:pt>
          <cx:pt idx="519">Gewinn UC pro Tag</cx:pt>
          <cx:pt idx="520">Gewinn UC pro Tag</cx:pt>
          <cx:pt idx="521">Gewinn UC pro Tag</cx:pt>
          <cx:pt idx="522">Gewinn UC pro Tag</cx:pt>
          <cx:pt idx="523">Gewinn UC pro Tag</cx:pt>
          <cx:pt idx="524">Gewinn UC pro Tag</cx:pt>
          <cx:pt idx="525">Gewinn UC pro Tag</cx:pt>
          <cx:pt idx="526">Gewinn UC pro Tag</cx:pt>
          <cx:pt idx="527">Gewinn UC pro Tag</cx:pt>
          <cx:pt idx="528">Gewinn UC pro Tag</cx:pt>
          <cx:pt idx="529">Gewinn UC pro Tag</cx:pt>
          <cx:pt idx="530">Gewinn UC pro Tag</cx:pt>
          <cx:pt idx="531">Gewinn UC pro Tag</cx:pt>
          <cx:pt idx="532">Gewinn UC pro Tag</cx:pt>
          <cx:pt idx="533">Gewinn UC pro Tag</cx:pt>
          <cx:pt idx="534">Gewinn UC pro Tag</cx:pt>
          <cx:pt idx="535">Gewinn UC pro Tag</cx:pt>
          <cx:pt idx="536">Gewinn UC pro Tag</cx:pt>
          <cx:pt idx="537">Gewinn UC pro Tag</cx:pt>
          <cx:pt idx="538">Gewinn UC pro Tag</cx:pt>
          <cx:pt idx="539">Gewinn UC pro Tag</cx:pt>
          <cx:pt idx="540">Gewinn UC pro Tag</cx:pt>
          <cx:pt idx="541">Gewinn UC pro Tag</cx:pt>
          <cx:pt idx="542">Gewinn UC pro Tag</cx:pt>
          <cx:pt idx="543">Gewinn UC pro Tag</cx:pt>
          <cx:pt idx="544">Gewinn UC pro Tag</cx:pt>
          <cx:pt idx="545">Gewinn UC pro Tag</cx:pt>
          <cx:pt idx="546">Gewinn UC pro Tag</cx:pt>
          <cx:pt idx="547">Gewinn UC pro Tag</cx:pt>
          <cx:pt idx="548">Gewinn UC pro Tag</cx:pt>
          <cx:pt idx="549">Gewinn UC pro Tag</cx:pt>
          <cx:pt idx="550">Gewinn UC pro Tag</cx:pt>
          <cx:pt idx="551">Gewinn UC pro Tag</cx:pt>
          <cx:pt idx="552">Gewinn UC pro Tag</cx:pt>
          <cx:pt idx="553">Gewinn UC pro Tag</cx:pt>
          <cx:pt idx="554">Gewinn UC pro Tag</cx:pt>
          <cx:pt idx="555">Gewinn UC pro Tag</cx:pt>
          <cx:pt idx="556">Gewinn UC pro Tag</cx:pt>
          <cx:pt idx="557">Gewinn UC pro Tag</cx:pt>
          <cx:pt idx="558">Gewinn UC pro Tag</cx:pt>
          <cx:pt idx="559">Gewinn UC pro Tag</cx:pt>
          <cx:pt idx="560">Gewinn UC pro Tag</cx:pt>
          <cx:pt idx="561">Gewinn UC pro Tag</cx:pt>
          <cx:pt idx="562">Gewinn UC pro Tag</cx:pt>
          <cx:pt idx="563">Gewinn UC pro Tag</cx:pt>
          <cx:pt idx="564">Gewinn UC pro Tag</cx:pt>
          <cx:pt idx="565">Gewinn UC pro Tag</cx:pt>
          <cx:pt idx="566">Gewinn UC pro Tag</cx:pt>
          <cx:pt idx="567">Gewinn UC pro Tag</cx:pt>
          <cx:pt idx="568">Gewinn UC pro Tag</cx:pt>
          <cx:pt idx="569">Gewinn UC pro Tag</cx:pt>
          <cx:pt idx="570">Gewinn UC pro Tag</cx:pt>
          <cx:pt idx="571">Gewinn UC pro Tag</cx:pt>
          <cx:pt idx="572">Gewinn UC pro Tag</cx:pt>
          <cx:pt idx="573">Gewinn UC pro Tag</cx:pt>
          <cx:pt idx="574">Gewinn UC pro Tag</cx:pt>
          <cx:pt idx="575">Gewinn UC pro Tag</cx:pt>
          <cx:pt idx="576">Gewinn UC pro Tag</cx:pt>
          <cx:pt idx="577">Gewinn UC pro Tag</cx:pt>
          <cx:pt idx="578">Gewinn UC pro Tag</cx:pt>
          <cx:pt idx="579">Gewinn UC pro Tag</cx:pt>
          <cx:pt idx="580">Gewinn UC pro Tag</cx:pt>
          <cx:pt idx="581">Gewinn UC pro Tag</cx:pt>
          <cx:pt idx="582">Gewinn UC pro Tag</cx:pt>
          <cx:pt idx="583">Gewinn UC pro Tag</cx:pt>
          <cx:pt idx="584">Gewinn UC pro Tag</cx:pt>
          <cx:pt idx="585">Gewinn UC pro Tag</cx:pt>
          <cx:pt idx="586">Gewinn UC pro Tag</cx:pt>
          <cx:pt idx="587">Gewinn UC pro Tag</cx:pt>
          <cx:pt idx="588">Gewinn UC pro Tag</cx:pt>
          <cx:pt idx="589">Gewinn UC pro Tag</cx:pt>
          <cx:pt idx="590">Gewinn UC pro Tag</cx:pt>
          <cx:pt idx="591">Gewinn UC pro Tag</cx:pt>
          <cx:pt idx="592">Gewinn UC pro Tag</cx:pt>
          <cx:pt idx="593">Gewinn UC pro Tag</cx:pt>
          <cx:pt idx="594">Gewinn UC pro Tag</cx:pt>
          <cx:pt idx="595">Gewinn UC pro Tag</cx:pt>
          <cx:pt idx="596">Gewinn UC pro Tag</cx:pt>
          <cx:pt idx="597">Gewinn UC pro Tag</cx:pt>
          <cx:pt idx="598">Gewinn UC pro Tag</cx:pt>
          <cx:pt idx="599">Gewinn UC pro Tag</cx:pt>
          <cx:pt idx="600">Gewinn UC pro Tag</cx:pt>
          <cx:pt idx="601">Gewinn UC pro Tag</cx:pt>
          <cx:pt idx="602">Gewinn UC pro Tag</cx:pt>
          <cx:pt idx="603">Gewinn UC pro Tag</cx:pt>
          <cx:pt idx="604">Gewinn UC pro Tag</cx:pt>
          <cx:pt idx="605">Gewinn UC pro Tag</cx:pt>
          <cx:pt idx="606">Gewinn UC pro Tag</cx:pt>
          <cx:pt idx="607">Gewinn UC pro Tag</cx:pt>
          <cx:pt idx="608">Gewinn UC pro Tag</cx:pt>
          <cx:pt idx="609">Gewinn UC pro Tag</cx:pt>
          <cx:pt idx="610">Gewinn UC pro Tag</cx:pt>
          <cx:pt idx="611">Gewinn UC pro Tag</cx:pt>
          <cx:pt idx="612">Gewinn UC pro Tag</cx:pt>
          <cx:pt idx="613">Gewinn UC pro Tag</cx:pt>
          <cx:pt idx="614">Gewinn UC pro Tag</cx:pt>
          <cx:pt idx="615">Gewinn UC pro Tag</cx:pt>
          <cx:pt idx="616">Gewinn UC pro Tag</cx:pt>
          <cx:pt idx="617">Gewinn UC pro Tag</cx:pt>
          <cx:pt idx="618">Gewinn UC pro Tag</cx:pt>
          <cx:pt idx="619">Gewinn UC pro Tag</cx:pt>
          <cx:pt idx="620">Gewinn UC pro Tag</cx:pt>
          <cx:pt idx="621">Gewinn UC pro Tag</cx:pt>
          <cx:pt idx="622">Gewinn UC pro Tag</cx:pt>
          <cx:pt idx="623">Gewinn UC pro Tag</cx:pt>
          <cx:pt idx="624">Gewinn UC pro Tag</cx:pt>
          <cx:pt idx="625">Gewinn UC pro Tag</cx:pt>
          <cx:pt idx="626">Gewinn UC pro Tag</cx:pt>
          <cx:pt idx="627">Gewinn UC pro Tag</cx:pt>
          <cx:pt idx="628">Gewinn UC pro Tag</cx:pt>
          <cx:pt idx="629">Gewinn UC pro Tag</cx:pt>
          <cx:pt idx="630">Gewinn UC pro Tag</cx:pt>
          <cx:pt idx="631">Gewinn UC pro Tag</cx:pt>
          <cx:pt idx="632">Gewinn UC pro Tag</cx:pt>
          <cx:pt idx="633">Gewinn UC pro Tag</cx:pt>
          <cx:pt idx="634">Gewinn UC pro Tag</cx:pt>
          <cx:pt idx="635">Gewinn UC pro Tag</cx:pt>
          <cx:pt idx="636">Gewinn UC pro Tag</cx:pt>
          <cx:pt idx="637">Gewinn UC pro Tag</cx:pt>
          <cx:pt idx="638">Gewinn UC pro Tag</cx:pt>
          <cx:pt idx="639">Gewinn UC pro Tag</cx:pt>
          <cx:pt idx="640">Gewinn UC pro Tag</cx:pt>
          <cx:pt idx="641">Gewinn UC pro Tag</cx:pt>
          <cx:pt idx="642">Gewinn UC pro Tag</cx:pt>
          <cx:pt idx="643">Gewinn UC pro Tag</cx:pt>
          <cx:pt idx="644">Gewinn UC pro Tag</cx:pt>
          <cx:pt idx="645">Gewinn UC pro Tag</cx:pt>
          <cx:pt idx="646">Gewinn UC pro Tag</cx:pt>
          <cx:pt idx="647">Gewinn UC pro Tag</cx:pt>
          <cx:pt idx="648">Gewinn UC pro Tag</cx:pt>
          <cx:pt idx="649">Gewinn UC pro Tag</cx:pt>
          <cx:pt idx="650">Gewinn UC pro Tag</cx:pt>
          <cx:pt idx="651">Gewinn UC pro Tag</cx:pt>
          <cx:pt idx="652">Gewinn UC pro Tag</cx:pt>
          <cx:pt idx="653">Gewinn UC pro Tag</cx:pt>
          <cx:pt idx="654">Gewinn UC pro Tag</cx:pt>
          <cx:pt idx="655">Gewinn UC pro Tag</cx:pt>
          <cx:pt idx="656">Gewinn UC pro Tag</cx:pt>
          <cx:pt idx="657">Gewinn UC pro Tag</cx:pt>
          <cx:pt idx="658">Gewinn UC pro Tag</cx:pt>
          <cx:pt idx="659">Gewinn UC pro Tag</cx:pt>
          <cx:pt idx="660">Gewinn UC pro Tag</cx:pt>
          <cx:pt idx="661">Gewinn UC pro Tag</cx:pt>
          <cx:pt idx="662">Gewinn UC pro Tag</cx:pt>
          <cx:pt idx="663">Gewinn UC pro Tag</cx:pt>
          <cx:pt idx="664">Gewinn UC pro Tag</cx:pt>
          <cx:pt idx="665">Gewinn UC pro Tag</cx:pt>
          <cx:pt idx="666">Gewinn UC pro Tag</cx:pt>
          <cx:pt idx="667">Gewinn UC pro Tag</cx:pt>
          <cx:pt idx="668">Gewinn UC pro Tag</cx:pt>
          <cx:pt idx="669">Gewinn UC pro Tag</cx:pt>
          <cx:pt idx="670">Gewinn UC pro Tag</cx:pt>
          <cx:pt idx="671">Gewinn UC pro Tag</cx:pt>
          <cx:pt idx="672">Gewinn UC pro Tag</cx:pt>
          <cx:pt idx="673">Gewinn UC pro Tag</cx:pt>
          <cx:pt idx="674">Gewinn UC pro Tag</cx:pt>
          <cx:pt idx="675">Gewinn UC pro Tag</cx:pt>
          <cx:pt idx="676">Gewinn UC pro Tag</cx:pt>
          <cx:pt idx="677">Gewinn UC pro Tag</cx:pt>
          <cx:pt idx="678">Gewinn UC pro Tag</cx:pt>
          <cx:pt idx="679">Gewinn UC pro Tag</cx:pt>
          <cx:pt idx="680">Gewinn UC pro Tag</cx:pt>
          <cx:pt idx="681">Gewinn UC pro Tag</cx:pt>
          <cx:pt idx="682">Gewinn UC pro Tag</cx:pt>
          <cx:pt idx="683">Gewinn UC pro Tag</cx:pt>
          <cx:pt idx="684">Gewinn UC pro Tag</cx:pt>
          <cx:pt idx="685">Gewinn UC pro Tag</cx:pt>
          <cx:pt idx="686">Gewinn UC pro Tag</cx:pt>
          <cx:pt idx="687">Gewinn UC pro Tag</cx:pt>
          <cx:pt idx="688">Gewinn UC pro Tag</cx:pt>
          <cx:pt idx="689">Gewinn UC pro Tag</cx:pt>
          <cx:pt idx="690">Gewinn UC pro Tag</cx:pt>
          <cx:pt idx="691">Gewinn UC pro Tag</cx:pt>
          <cx:pt idx="692">Gewinn UC pro Tag</cx:pt>
          <cx:pt idx="693">Gewinn UC pro Tag</cx:pt>
          <cx:pt idx="694">Gewinn UC pro Tag</cx:pt>
          <cx:pt idx="695">Gewinn UC pro Tag</cx:pt>
          <cx:pt idx="696">Gewinn UC pro Tag</cx:pt>
          <cx:pt idx="697">Gewinn UC pro Tag</cx:pt>
          <cx:pt idx="698">Gewinn UC pro Tag</cx:pt>
          <cx:pt idx="699">Gewinn UC pro Tag</cx:pt>
          <cx:pt idx="700">Gewinn UC pro Tag</cx:pt>
          <cx:pt idx="701">Gewinn UC pro Tag</cx:pt>
          <cx:pt idx="702">Gewinn UC pro Tag</cx:pt>
          <cx:pt idx="703">Gewinn UC pro Tag</cx:pt>
          <cx:pt idx="704">Gewinn UC pro Tag</cx:pt>
          <cx:pt idx="705">Gewinn UC pro Tag</cx:pt>
          <cx:pt idx="706">Gewinn UC pro Tag</cx:pt>
          <cx:pt idx="707">Gewinn UC pro Tag</cx:pt>
          <cx:pt idx="708">Gewinn UC pro Tag</cx:pt>
          <cx:pt idx="709">Gewinn UC pro Tag</cx:pt>
          <cx:pt idx="710">Gewinn UC pro Tag</cx:pt>
          <cx:pt idx="711">Gewinn UC pro Tag</cx:pt>
          <cx:pt idx="712">Gewinn UC pro Tag</cx:pt>
          <cx:pt idx="713">Gewinn UC pro Tag</cx:pt>
          <cx:pt idx="714">Gewinn UC pro Tag</cx:pt>
          <cx:pt idx="715">Gewinn UC pro Tag</cx:pt>
          <cx:pt idx="716">Gewinn UC pro Tag</cx:pt>
          <cx:pt idx="717">Gewinn UC pro Tag</cx:pt>
          <cx:pt idx="718">Gewinn UC pro Tag</cx:pt>
          <cx:pt idx="719">Gewinn UC pro Tag</cx:pt>
          <cx:pt idx="720">Gewinn UC pro Tag</cx:pt>
          <cx:pt idx="721">Gewinn UC pro Tag</cx:pt>
          <cx:pt idx="722">Gewinn UC pro Tag</cx:pt>
          <cx:pt idx="723">Gewinn UC pro Tag</cx:pt>
          <cx:pt idx="724">Gewinn UC pro Tag</cx:pt>
          <cx:pt idx="725">Gewinn UC pro Tag</cx:pt>
          <cx:pt idx="726">Gewinn UC pro Tag</cx:pt>
          <cx:pt idx="727">Gewinn UC pro Tag</cx:pt>
          <cx:pt idx="728">Gewinn UC pro Tag</cx:pt>
          <cx:pt idx="729">Gewinn UC pro Tag</cx:pt>
          <cx:pt idx="730">Gewinn UC pro Tag</cx:pt>
          <cx:pt idx="731">Gewinn UC pro Tag</cx:pt>
          <cx:pt idx="732">Gewinn UC pro Tag</cx:pt>
          <cx:pt idx="733">Gewinn UC pro Tag</cx:pt>
          <cx:pt idx="734">Gewinn UC pro Tag</cx:pt>
          <cx:pt idx="735">Gewinn UC pro Tag</cx:pt>
          <cx:pt idx="736">Gewinn UC pro Tag</cx:pt>
          <cx:pt idx="737">Gewinn UC pro Tag</cx:pt>
          <cx:pt idx="738">Gewinn UC pro Tag</cx:pt>
          <cx:pt idx="739">Gewinn UC pro Tag</cx:pt>
          <cx:pt idx="740">Gewinn UC pro Tag</cx:pt>
          <cx:pt idx="741">Gewinn UC pro Tag</cx:pt>
          <cx:pt idx="742">Gewinn UC pro Tag</cx:pt>
          <cx:pt idx="743">Gewinn UC pro Tag</cx:pt>
          <cx:pt idx="744">Gewinn UC pro Tag</cx:pt>
          <cx:pt idx="745">Gewinn UC pro Tag</cx:pt>
          <cx:pt idx="746">Gewinn UC pro Tag</cx:pt>
          <cx:pt idx="747">Gewinn UC pro Tag</cx:pt>
          <cx:pt idx="748">Gewinn UC pro Tag</cx:pt>
          <cx:pt idx="749">Gewinn UC pro Tag</cx:pt>
          <cx:pt idx="750">Gewinn UC pro Tag</cx:pt>
          <cx:pt idx="751">Gewinn UC pro Tag</cx:pt>
          <cx:pt idx="752">Gewinn UC pro Tag</cx:pt>
          <cx:pt idx="753">Gewinn UC pro Tag</cx:pt>
          <cx:pt idx="754">Gewinn UC pro Tag</cx:pt>
          <cx:pt idx="755">Gewinn UC pro Tag</cx:pt>
          <cx:pt idx="756">Gewinn UC pro Tag</cx:pt>
          <cx:pt idx="757">Gewinn UC pro Tag</cx:pt>
          <cx:pt idx="758">Gewinn UC pro Tag</cx:pt>
          <cx:pt idx="759">Gewinn UC pro Tag</cx:pt>
          <cx:pt idx="760">Gewinn UC pro Tag</cx:pt>
          <cx:pt idx="761">Gewinn UC pro Tag</cx:pt>
          <cx:pt idx="762">Gewinn UC pro Tag</cx:pt>
          <cx:pt idx="763">Gewinn UC pro Tag</cx:pt>
          <cx:pt idx="764">Gewinn UC pro Tag</cx:pt>
          <cx:pt idx="765">Gewinn UC pro Tag</cx:pt>
          <cx:pt idx="766">Gewinn UC pro Tag</cx:pt>
          <cx:pt idx="767">Gewinn UC pro Tag</cx:pt>
          <cx:pt idx="768">Gewinn UC pro Tag</cx:pt>
          <cx:pt idx="769">Gewinn UC pro Tag</cx:pt>
          <cx:pt idx="770">Gewinn UC pro Tag</cx:pt>
          <cx:pt idx="771">Gewinn UC pro Tag</cx:pt>
          <cx:pt idx="772">Gewinn UC pro Tag</cx:pt>
          <cx:pt idx="773">Gewinn UC pro Tag</cx:pt>
          <cx:pt idx="774">Gewinn UC pro Tag</cx:pt>
          <cx:pt idx="775">Gewinn UC pro Tag</cx:pt>
          <cx:pt idx="776">Gewinn UC pro Tag</cx:pt>
          <cx:pt idx="777">Gewinn UC pro Tag</cx:pt>
          <cx:pt idx="778">Gewinn UC pro Tag</cx:pt>
          <cx:pt idx="779">Gewinn UC pro Tag</cx:pt>
          <cx:pt idx="780">Gewinn UC pro Tag</cx:pt>
          <cx:pt idx="781">Gewinn UC pro Tag</cx:pt>
          <cx:pt idx="782">Gewinn UC pro Tag</cx:pt>
          <cx:pt idx="783">Gewinn UC pro Tag</cx:pt>
          <cx:pt idx="784">Gewinn UC pro Tag</cx:pt>
          <cx:pt idx="785">Gewinn UC pro Tag</cx:pt>
          <cx:pt idx="786">Gewinn UC pro Tag</cx:pt>
          <cx:pt idx="787">Gewinn UC pro Tag</cx:pt>
          <cx:pt idx="788">Gewinn UC pro Tag</cx:pt>
          <cx:pt idx="789">Gewinn UC pro Tag</cx:pt>
          <cx:pt idx="790">Gewinn UC pro Tag</cx:pt>
          <cx:pt idx="791">Gewinn UC pro Tag</cx:pt>
          <cx:pt idx="792">Gewinn UC pro Tag</cx:pt>
          <cx:pt idx="793">Gewinn UC pro Tag</cx:pt>
          <cx:pt idx="794">Gewinn UC pro Tag</cx:pt>
          <cx:pt idx="795">Gewinn UC pro Tag</cx:pt>
          <cx:pt idx="796">Gewinn UC pro Tag</cx:pt>
          <cx:pt idx="797">Gewinn UC pro Tag</cx:pt>
          <cx:pt idx="798">Gewinn UC pro Tag</cx:pt>
          <cx:pt idx="799">Gewinn UC pro Tag</cx:pt>
          <cx:pt idx="800">Gewinn UC pro Tag</cx:pt>
          <cx:pt idx="801">Gewinn UC pro Tag</cx:pt>
          <cx:pt idx="802">Gewinn UC pro Tag</cx:pt>
        </cx:lvl>
      </cx:strDim>
      <cx:numDim type="val">
        <cx:lvl ptCount="803" formatCode="General">
          <cx:pt idx="0">-1623.8633333333339</cx:pt>
          <cx:pt idx="1">-1610.9860000000001</cx:pt>
          <cx:pt idx="2">-1406.6327272727269</cx:pt>
          <cx:pt idx="3">-1360.659090909091</cx:pt>
          <cx:pt idx="4">-1331.7763636363641</cx:pt>
          <cx:pt idx="5">-1179.732857142857</cx:pt>
          <cx:pt idx="6">-1134.49</cx:pt>
          <cx:pt idx="7">-1086.9823529411769</cx:pt>
          <cx:pt idx="8">-1059.015625</cx:pt>
          <cx:pt idx="9">-989.46000000000004</cx:pt>
          <cx:pt idx="10">-989.10333333333335</cx:pt>
          <cx:pt idx="11">-979.55999999999995</cx:pt>
          <cx:pt idx="12">-964.30285714285708</cx:pt>
          <cx:pt idx="13">-955.5771428571428</cx:pt>
          <cx:pt idx="14">-919.7171428571429</cx:pt>
          <cx:pt idx="15">-877.58000000000004</cx:pt>
          <cx:pt idx="16">-875.09199999999998</cx:pt>
          <cx:pt idx="17">-870.33000000000004</cx:pt>
          <cx:pt idx="18">-863.25916666666672</cx:pt>
          <cx:pt idx="19">-857.79750000000001</cx:pt>
          <cx:pt idx="20">-842.54833333333329</cx:pt>
          <cx:pt idx="21">-831.8042857142857</cx:pt>
          <cx:pt idx="22">-819.96916666666664</cx:pt>
          <cx:pt idx="23">-814.99925925925925</cx:pt>
          <cx:pt idx="24">-812.01099999999997</cx:pt>
          <cx:pt idx="25">-802.75374999999997</cx:pt>
          <cx:pt idx="26">-801.27750000000003</cx:pt>
          <cx:pt idx="27">-799.74166666666667</cx:pt>
          <cx:pt idx="28">-773.255</cx:pt>
          <cx:pt idx="29">-766.58000000000004</cx:pt>
          <cx:pt idx="30">-764.70142857142855</cx:pt>
          <cx:pt idx="31">-753.40875000000005</cx:pt>
          <cx:pt idx="32">-747.26625000000001</cx:pt>
          <cx:pt idx="33">-738.93769230769237</cx:pt>
          <cx:pt idx="34">-722.10909090909092</cx:pt>
          <cx:pt idx="35">-721.78399999999999</cx:pt>
          <cx:pt idx="36">-700.77666666666664</cx:pt>
          <cx:pt idx="37">-676.62625000000003</cx:pt>
          <cx:pt idx="38">-662.49000000000001</cx:pt>
          <cx:pt idx="39">-661.42666666666662</cx:pt>
          <cx:pt idx="40">-648.01874999999995</cx:pt>
          <cx:pt idx="41">-646.74363636363637</cx:pt>
          <cx:pt idx="42">-646.03111111111104</cx:pt>
          <cx:pt idx="43">-642.50625000000002</cx:pt>
          <cx:pt idx="44">-632.50874999999996</cx:pt>
          <cx:pt idx="45">-624.49333333333334</cx:pt>
          <cx:pt idx="46">-622.86759259259259</cx:pt>
          <cx:pt idx="47">-609.68000000000006</cx:pt>
          <cx:pt idx="48">-604.25333333333333</cx:pt>
          <cx:pt idx="49">-603.91250000000002</cx:pt>
          <cx:pt idx="50">-591.87909090909091</cx:pt>
          <cx:pt idx="51">-586.60500000000002</cx:pt>
          <cx:pt idx="52">-584.29099999999994</cx:pt>
          <cx:pt idx="53">-584.10142857142853</cx:pt>
          <cx:pt idx="54">-576.46076923076919</cx:pt>
          <cx:pt idx="55">-569.26350000000002</cx:pt>
          <cx:pt idx="56">-547.6904545454546</cx:pt>
          <cx:pt idx="57">-546.90230769230766</cx:pt>
          <cx:pt idx="58">-537.41499999999996</cx:pt>
          <cx:pt idx="59">-535.68102564102571</cx:pt>
          <cx:pt idx="60">-528.50222222222226</cx:pt>
          <cx:pt idx="61">-528.44375000000002</cx:pt>
          <cx:pt idx="62">-527.1105</cx:pt>
          <cx:pt idx="63">-523.04538461538459</cx:pt>
          <cx:pt idx="64">-522.86884615384611</cx:pt>
          <cx:pt idx="65">-521.93714285714282</cx:pt>
          <cx:pt idx="66">-521.36874999999998</cx:pt>
          <cx:pt idx="67">-514.20666666666659</cx:pt>
          <cx:pt idx="68">-510.95999999999998</cx:pt>
          <cx:pt idx="69">-499.458125</cx:pt>
          <cx:pt idx="70">-497.65499999999997</cx:pt>
          <cx:pt idx="71">-496.72500000000002</cx:pt>
          <cx:pt idx="72">-496.20166666666671</cx:pt>
          <cx:pt idx="73">-490.1238461538461</cx:pt>
          <cx:pt idx="74">-484.71148148148143</cx:pt>
          <cx:pt idx="75">-476.21526315789481</cx:pt>
          <cx:pt idx="76">-475.54428571428571</cx:pt>
          <cx:pt idx="77">-475.428</cx:pt>
          <cx:pt idx="78">-472.71333333333342</cx:pt>
          <cx:pt idx="79">-465.86909090909103</cx:pt>
          <cx:pt idx="80">-465.47384615384613</cx:pt>
          <cx:pt idx="81">-461.99736842105261</cx:pt>
          <cx:pt idx="82">-461.39125000000001</cx:pt>
          <cx:pt idx="83">-447.99294117647059</cx:pt>
          <cx:pt idx="84">-447.14508771929832</cx:pt>
          <cx:pt idx="85">-445.94274999999999</cx:pt>
          <cx:pt idx="86">-444.86250000000001</cx:pt>
          <cx:pt idx="87">-444.44600000000003</cx:pt>
          <cx:pt idx="88">-443.59363636363628</cx:pt>
          <cx:pt idx="89">-439.60411764705879</cx:pt>
          <cx:pt idx="90">-438.78181818181821</cx:pt>
          <cx:pt idx="91">-438.6685714285714</cx:pt>
          <cx:pt idx="92">-435.9885714285715</cx:pt>
          <cx:pt idx="93">-434.81533333333329</cx:pt>
          <cx:pt idx="94">-434.01100000000002</cx:pt>
          <cx:pt idx="95">-427.17655172413788</cx:pt>
          <cx:pt idx="96">-425.96153846153851</cx:pt>
          <cx:pt idx="97">-425.46033333333332</cx:pt>
          <cx:pt idx="98">-420.06833333333333</cx:pt>
          <cx:pt idx="99">-410.25590909090897</cx:pt>
          <cx:pt idx="100">-408.18142857142863</cx:pt>
          <cx:pt idx="101">-402.23250000000002</cx:pt>
          <cx:pt idx="102">-399.21181818181822</cx:pt>
          <cx:pt idx="103">-397.66142857142859</cx:pt>
          <cx:pt idx="104">-391.99730769230769</cx:pt>
          <cx:pt idx="105">-387.19999999999999</cx:pt>
          <cx:pt idx="106">-385.435</cx:pt>
          <cx:pt idx="107">-383.5884615384615</cx:pt>
          <cx:pt idx="108">-383.25181818181818</cx:pt>
          <cx:pt idx="109">-381.05799999999999</cx:pt>
          <cx:pt idx="110">-377.45666666666671</cx:pt>
          <cx:pt idx="111">-374.53444444444438</cx:pt>
          <cx:pt idx="112">-372.99624999999997</cx:pt>
          <cx:pt idx="113">-371.28529411764708</cx:pt>
          <cx:pt idx="114">-370.298</cx:pt>
          <cx:pt idx="115">-370.05076923076922</cx:pt>
          <cx:pt idx="116">-368.01547619047619</cx:pt>
          <cx:pt idx="117">-359.35941176470578</cx:pt>
          <cx:pt idx="118">-355.42944444444441</cx:pt>
          <cx:pt idx="119">-354.39625000000001</cx:pt>
          <cx:pt idx="120">-349.48555555555561</cx:pt>
          <cx:pt idx="121">-346.45291666666668</cx:pt>
          <cx:pt idx="122">-346.30500000000001</cx:pt>
          <cx:pt idx="123">-346.2569230769231</cx:pt>
          <cx:pt idx="124">-339.87826086956522</cx:pt>
          <cx:pt idx="125">-339.04529411764707</cx:pt>
          <cx:pt idx="126">-338.65081967213121</cx:pt>
          <cx:pt idx="127">-338.55304347826092</cx:pt>
          <cx:pt idx="128">-338.23833333333329</cx:pt>
          <cx:pt idx="129">-337.48816513761471</cx:pt>
          <cx:pt idx="130">-335.50999999999999</cx:pt>
          <cx:pt idx="131">-334.40842105263158</cx:pt>
          <cx:pt idx="132">-332.82873015873008</cx:pt>
          <cx:pt idx="133">-326.25181818181818</cx:pt>
          <cx:pt idx="134">-325.22160000000002</cx:pt>
          <cx:pt idx="135">-316.79500000000002</cx:pt>
          <cx:pt idx="136">-316.26333333333332</cx:pt>
          <cx:pt idx="137">-315.16250000000002</cx:pt>
          <cx:pt idx="138">-314.83749999999998</cx:pt>
          <cx:pt idx="139">-312.07681818181823</cx:pt>
          <cx:pt idx="140">-311.19272727272732</cx:pt>
          <cx:pt idx="141">-310.84399999999999</cx:pt>
          <cx:pt idx="142">-310.00647058823529</cx:pt>
          <cx:pt idx="143">-309.94999999999999</cx:pt>
          <cx:pt idx="144">-309.79538461538471</cx:pt>
          <cx:pt idx="145">-309.63499999999999</cx:pt>
          <cx:pt idx="146">-308.32187499999998</cx:pt>
          <cx:pt idx="147">-308.06915254237288</cx:pt>
          <cx:pt idx="148">-306.03733333333338</cx:pt>
          <cx:pt idx="149">-305.53818181818178</cx:pt>
          <cx:pt idx="150">-305.01499999999999</cx:pt>
          <cx:pt idx="151">-304.42526315789468</cx:pt>
          <cx:pt idx="152">-303.61833333333328</cx:pt>
          <cx:pt idx="153">-301.28642857142859</cx:pt>
          <cx:pt idx="154">-300.01333333333332</cx:pt>
          <cx:pt idx="155">-299.59571428571428</cx:pt>
          <cx:pt idx="156">-297.80857142857138</cx:pt>
          <cx:pt idx="157">-297.20375000000001</cx:pt>
          <cx:pt idx="158">-291.02454545454538</cx:pt>
          <cx:pt idx="159">-288.9711111111111</cx:pt>
          <cx:pt idx="160">-286.35199999999998</cx:pt>
          <cx:pt idx="161">-286.18900000000002</cx:pt>
          <cx:pt idx="162">-285.97363636363639</cx:pt>
          <cx:pt idx="163">-285.32749999999999</cx:pt>
          <cx:pt idx="164">-282.51499999999999</cx:pt>
          <cx:pt idx="165">-281.36724137931031</cx:pt>
          <cx:pt idx="166">-280.74472222222221</cx:pt>
          <cx:pt idx="167">-280.4646153846154</cx:pt>
          <cx:pt idx="168">-280.11948717948718</cx:pt>
          <cx:pt idx="169">-276.26848484848489</cx:pt>
          <cx:pt idx="170">-274.87194444444441</cx:pt>
          <cx:pt idx="171">-274.70111111111112</cx:pt>
          <cx:pt idx="172">-269.45454545454538</cx:pt>
          <cx:pt idx="173">-269.1882352941177</cx:pt>
          <cx:pt idx="174">-268.96625</cx:pt>
          <cx:pt idx="175">-261.57357142857143</cx:pt>
          <cx:pt idx="176">-261.48166666666668</cx:pt>
          <cx:pt idx="177">-259.98571428571432</cx:pt>
          <cx:pt idx="178">-258.09236842105258</cx:pt>
          <cx:pt idx="179">-255.35260869565221</cx:pt>
          <cx:pt idx="180">-254.44071428571431</cx:pt>
          <cx:pt idx="181">-252.20666666666671</cx:pt>
          <cx:pt idx="182">-251.72399999999999</cx:pt>
          <cx:pt idx="183">-251.34375</cx:pt>
          <cx:pt idx="184">-248.90212121212119</cx:pt>
          <cx:pt idx="185">-246.07499999999999</cx:pt>
          <cx:pt idx="186">-245.3653333333333</cx:pt>
          <cx:pt idx="187">-244.77181818181819</cx:pt>
          <cx:pt idx="188">-242.47499999999999</cx:pt>
          <cx:pt idx="189">-237.71000000000001</cx:pt>
          <cx:pt idx="190">-237.2970833333334</cx:pt>
          <cx:pt idx="191">-235.05833333333331</cx:pt>
          <cx:pt idx="192">-234.68303030303031</cx:pt>
          <cx:pt idx="193">-233.7607142857143</cx:pt>
          <cx:pt idx="194">-233.3723529411765</cx:pt>
          <cx:pt idx="195">-230.28450000000001</cx:pt>
          <cx:pt idx="196">-230.21375</cx:pt>
          <cx:pt idx="197">-229.89375000000001</cx:pt>
          <cx:pt idx="198">-228.03727272727269</cx:pt>
          <cx:pt idx="199">-225.33000000000001</cx:pt>
          <cx:pt idx="200">-223.61866666666671</cx:pt>
          <cx:pt idx="201">-222.75130434782611</cx:pt>
          <cx:pt idx="202">-221.71119999999999</cx:pt>
          <cx:pt idx="203">-221.64272727272731</cx:pt>
          <cx:pt idx="204">-220.5857894736842</cx:pt>
          <cx:pt idx="205">-216.96687499999999</cx:pt>
          <cx:pt idx="206">-216.14517241379309</cx:pt>
          <cx:pt idx="207">-215.81187499999999</cx:pt>
          <cx:pt idx="208">-212.9014285714286</cx:pt>
          <cx:pt idx="209">-212.04174603174599</cx:pt>
          <cx:pt idx="210">-211.6539130434783</cx:pt>
          <cx:pt idx="211">-210.81117647058821</cx:pt>
          <cx:pt idx="212">-210.26055555555561</cx:pt>
          <cx:pt idx="213">-208.46444444444441</cx:pt>
          <cx:pt idx="214">-208.02074074074079</cx:pt>
          <cx:pt idx="215">-207.53357142857141</cx:pt>
          <cx:pt idx="216">-204.31187499999999</cx:pt>
          <cx:pt idx="217">-203.6276</cx:pt>
          <cx:pt idx="218">-202.65066666666669</cx:pt>
          <cx:pt idx="219">-201.66142857142859</cx:pt>
          <cx:pt idx="220">-200.32897959183671</cx:pt>
          <cx:pt idx="221">-197.95416666666671</cx:pt>
          <cx:pt idx="222">-196.3222727272728</cx:pt>
          <cx:pt idx="223">-195.77000000000001</cx:pt>
          <cx:pt idx="224">-194.3434482758621</cx:pt>
          <cx:pt idx="225">-194.32111111111109</cx:pt>
          <cx:pt idx="226">-184.74296296296299</cx:pt>
          <cx:pt idx="227">-184.6275</cx:pt>
          <cx:pt idx="228">-183.6525</cx:pt>
          <cx:pt idx="229">-181.5</cx:pt>
          <cx:pt idx="230">-180.18238095238101</cx:pt>
          <cx:pt idx="231">-179.62033333333329</cx:pt>
          <cx:pt idx="232">-179.38499999999999</cx:pt>
          <cx:pt idx="233">-178.50470588235291</cx:pt>
          <cx:pt idx="234">-177.98599999999999</cx:pt>
          <cx:pt idx="235">-176.57833333333329</cx:pt>
          <cx:pt idx="236">-173.87125</cx:pt>
          <cx:pt idx="237">-172.92250000000001</cx:pt>
          <cx:pt idx="238">-172.91826086956519</cx:pt>
          <cx:pt idx="239">-172.8066666666667</cx:pt>
          <cx:pt idx="240">-169.44166666666669</cx:pt>
          <cx:pt idx="241">-169.08500000000001</cx:pt>
          <cx:pt idx="242">-168.72120000000001</cx:pt>
          <cx:pt idx="243">-167.9978571428571</cx:pt>
          <cx:pt idx="244">-167.0728571428572</cx:pt>
          <cx:pt idx="245">-161.30000000000001</cx:pt>
          <cx:pt idx="246">-160.93600000000001</cx:pt>
          <cx:pt idx="247">-160.01615384615391</cx:pt>
          <cx:pt idx="248">-159.83500000000001</cx:pt>
          <cx:pt idx="249">-157.29138888888889</cx:pt>
          <cx:pt idx="250">-151.80000000000001</cx:pt>
          <cx:pt idx="251">-151.33285714285711</cx:pt>
          <cx:pt idx="252">-149.91560000000001</cx:pt>
          <cx:pt idx="253">-149.74000000000001</cx:pt>
          <cx:pt idx="254">-148.875</cx:pt>
          <cx:pt idx="255">-148.045625</cx:pt>
          <cx:pt idx="256">-147.85791666666671</cx:pt>
          <cx:pt idx="257">-147.64760000000001</cx:pt>
          <cx:pt idx="258">-146.26535714285711</cx:pt>
          <cx:pt idx="259">-145.83741935483869</cx:pt>
          <cx:pt idx="260">-145.6492307692308</cx:pt>
          <cx:pt idx="261">-145.19</cx:pt>
          <cx:pt idx="262">-145.17896551724141</cx:pt>
          <cx:pt idx="263">-143.18636363636361</cx:pt>
          <cx:pt idx="264">-142.86781250000001</cx:pt>
          <cx:pt idx="265">-141.11600000000001</cx:pt>
          <cx:pt idx="266">-141.09428571428569</cx:pt>
          <cx:pt idx="267">-138.59</cx:pt>
          <cx:pt idx="268">-137.53314814814809</cx:pt>
          <cx:pt idx="269">-135.91800000000001</cx:pt>
          <cx:pt idx="270">-134.8955555555556</cx:pt>
          <cx:pt idx="271">-133.24464285714291</cx:pt>
          <cx:pt idx="272">-131.86250000000001</cx:pt>
          <cx:pt idx="273">-131.215</cx:pt>
          <cx:pt idx="274">-129.7026315789474</cx:pt>
          <cx:pt idx="275">-125.4620833333333</cx:pt>
          <cx:pt idx="276">-124.804</cx:pt>
          <cx:pt idx="277">-124.1658823529412</cx:pt>
          <cx:pt idx="278">-122.8557142857143</cx:pt>
          <cx:pt idx="279">-122.33964285714291</cx:pt>
          <cx:pt idx="280">-120.3992307692308</cx:pt>
          <cx:pt idx="281">-119.105652173913</cx:pt>
          <cx:pt idx="282">-118.2925</cx:pt>
          <cx:pt idx="283">-115.2763636363636</cx:pt>
          <cx:pt idx="284">-114.65000000000001</cx:pt>
          <cx:pt idx="285">-114.1185714285714</cx:pt>
          <cx:pt idx="286">-112.1621951219512</cx:pt>
          <cx:pt idx="287">-111.87</cx:pt>
          <cx:pt idx="288">-111.096</cx:pt>
          <cx:pt idx="289">-105.57827586206901</cx:pt>
          <cx:pt idx="290">-105.4046478873239</cx:pt>
          <cx:pt idx="291">-105.14</cx:pt>
          <cx:pt idx="292">-103.6321428571429</cx:pt>
          <cx:pt idx="293">-101.8792307692308</cx:pt>
          <cx:pt idx="294">-100.34</cx:pt>
          <cx:pt idx="295">-99.528913043478255</cx:pt>
          <cx:pt idx="296">-93.148695652173913</cx:pt>
          <cx:pt idx="297">-92.447500000000005</cx:pt>
          <cx:pt idx="298">-91.947619047619057</cx:pt>
          <cx:pt idx="299">-91.084285714285713</cx:pt>
          <cx:pt idx="300">-90.607352941176472</cx:pt>
          <cx:pt idx="301">-87.353333333333339</cx:pt>
          <cx:pt idx="302">-86.034000000000006</cx:pt>
          <cx:pt idx="303">-85.629166666666663</cx:pt>
          <cx:pt idx="304">-85.080689655172421</cx:pt>
          <cx:pt idx="305">-84.705263157894748</cx:pt>
          <cx:pt idx="306">-82.956969696969693</cx:pt>
          <cx:pt idx="307">-82.193636363636358</cx:pt>
          <cx:pt idx="308">-80.927916666666661</cx:pt>
          <cx:pt idx="309">-80.471000000000004</cx:pt>
          <cx:pt idx="310">-78.385999999999996</cx:pt>
          <cx:pt idx="311">-77.955714285714294</cx:pt>
          <cx:pt idx="312">-77.281428571428577</cx:pt>
          <cx:pt idx="313">-76.60842105263157</cx:pt>
          <cx:pt idx="314">-73.34571428571428</cx:pt>
          <cx:pt idx="315">-73.175714285714292</cx:pt>
          <cx:pt idx="316">-72.179473684210535</cx:pt>
          <cx:pt idx="317">-71.577307692307699</cx:pt>
          <cx:pt idx="318">-71.340400000000002</cx:pt>
          <cx:pt idx="319">-71.185500000000005</cx:pt>
          <cx:pt idx="320">-66.334523809523816</cx:pt>
          <cx:pt idx="321">-62.829473684210527</cx:pt>
          <cx:pt idx="322">-62.700000000000003</cx:pt>
          <cx:pt idx="323">-60.711475409836069</cx:pt>
          <cx:pt idx="324">-60.011428571428567</cx:pt>
          <cx:pt idx="325">-59.959333333333333</cx:pt>
          <cx:pt idx="326">-58.884999999999998</cx:pt>
          <cx:pt idx="327">-58.59375</cx:pt>
          <cx:pt idx="328">-57.844999999999999</cx:pt>
          <cx:pt idx="329">-57.509333333333331</cx:pt>
          <cx:pt idx="330">-55.488399999999999</cx:pt>
          <cx:pt idx="331">-52.327500000000001</cx:pt>
          <cx:pt idx="332">-51.554444444444442</cx:pt>
          <cx:pt idx="333">-51.124285714285712</cx:pt>
          <cx:pt idx="334">-49.520000000000003</cx:pt>
          <cx:pt idx="335">-48.65291666666667</cx:pt>
          <cx:pt idx="336">-47.717500000000001</cx:pt>
          <cx:pt idx="337">-45.539999999999999</cx:pt>
          <cx:pt idx="338">-44.834166666666668</cx:pt>
          <cx:pt idx="339">-43.928823529411773</cx:pt>
          <cx:pt idx="340">-43.083333333333343</cx:pt>
          <cx:pt idx="341">-43.012962962962959</cx:pt>
          <cx:pt idx="342">-42.590000000000003</cx:pt>
          <cx:pt idx="343">-42.041923076923077</cx:pt>
          <cx:pt idx="344">-39.713333333333338</cx:pt>
          <cx:pt idx="345">-39.266800000000003</cx:pt>
          <cx:pt idx="346">-38.259999999999998</cx:pt>
          <cx:pt idx="347">-37.829444444444441</cx:pt>
          <cx:pt idx="348">-37.328421052631583</cx:pt>
          <cx:pt idx="349">-33.900882352941181</cx:pt>
          <cx:pt idx="350">-32.925454545454549</cx:pt>
          <cx:pt idx="351">-32.152500000000003</cx:pt>
          <cx:pt idx="352">-31.791538461538462</cx:pt>
          <cx:pt idx="353">-31.23714285714286</cx:pt>
          <cx:pt idx="354">-31.076521739130438</cx:pt>
          <cx:pt idx="355">-27.483333333333331</cx:pt>
          <cx:pt idx="356">-26.926818181818181</cx:pt>
          <cx:pt idx="357">-26.008947368421062</cx:pt>
          <cx:pt idx="358">-25.59333333333333</cx:pt>
          <cx:pt idx="359">-24.606562499999999</cx:pt>
          <cx:pt idx="360">-24.506499999999999</cx:pt>
          <cx:pt idx="361">-23.334399999999999</cx:pt>
          <cx:pt idx="362">-20.22727272727273</cx:pt>
          <cx:pt idx="363">-18.896000000000001</cx:pt>
          <cx:pt idx="364">-13.080399999999999</cx:pt>
          <cx:pt idx="365">-12.368</cx:pt>
          <cx:pt idx="366">-12.01052631578947</cx:pt>
          <cx:pt idx="367">-11.608000000000001</cx:pt>
          <cx:pt idx="368">-11.60125</cx:pt>
          <cx:pt idx="369">-9.7480000000000011</cx:pt>
          <cx:pt idx="370">-8.7245833333333334</cx:pt>
          <cx:pt idx="371">-6.8914285714285723</cx:pt>
          <cx:pt idx="372">-6.3300000000000001</cx:pt>
          <cx:pt idx="373">-4.4923999999999999</cx:pt>
          <cx:pt idx="374">-2.7041666666666671</cx:pt>
          <cx:pt idx="375">-0.60999999999999999</cx:pt>
          <cx:pt idx="376">0.043939393939393938</cx:pt>
          <cx:pt idx="377">0.68846153846153846</cx:pt>
          <cx:pt idx="378">1.531428571428572</cx:pt>
          <cx:pt idx="379">2.4361904761904758</cx:pt>
          <cx:pt idx="380">2.9746153846153849</cx:pt>
          <cx:pt idx="381">3.3420000000000001</cx:pt>
          <cx:pt idx="382">5.2400000000000002</cx:pt>
          <cx:pt idx="383">6.0739999999999998</cx:pt>
          <cx:pt idx="384">6.5259375000000004</cx:pt>
          <cx:pt idx="385">10.21678571428572</cx:pt>
          <cx:pt idx="386">10.877333333333331</cx:pt>
          <cx:pt idx="387">11.050000000000001</cx:pt>
          <cx:pt idx="388">12.35</cx:pt>
          <cx:pt idx="389">12.890000000000001</cx:pt>
          <cx:pt idx="390">14.44576923076923</cx:pt>
          <cx:pt idx="391">18.278749999999999</cx:pt>
          <cx:pt idx="392">19.21142857142857</cx:pt>
          <cx:pt idx="393">20.15666666666667</cx:pt>
          <cx:pt idx="394">20.651250000000001</cx:pt>
          <cx:pt idx="395">21.095769230769228</cx:pt>
          <cx:pt idx="396">21.22444444444444</cx:pt>
          <cx:pt idx="397">22.370000000000001</cx:pt>
          <cx:pt idx="398">22.772500000000001</cx:pt>
          <cx:pt idx="399">24.6325</cx:pt>
          <cx:pt idx="400">26.51227272727273</cx:pt>
          <cx:pt idx="401">27.40285714285714</cx:pt>
          <cx:pt idx="402">31.087</cx:pt>
          <cx:pt idx="403">34.001176470588227</cx:pt>
          <cx:pt idx="404">34.54684210526316</cx:pt>
          <cx:pt idx="405">34.9925</cx:pt>
          <cx:pt idx="406">35.366999999999997</cx:pt>
          <cx:pt idx="407">37.798333333333332</cx:pt>
          <cx:pt idx="408">38.127499999999998</cx:pt>
          <cx:pt idx="409">38.187659574468093</cx:pt>
          <cx:pt idx="410">39.007666666666672</cx:pt>
          <cx:pt idx="411">41.511842105263163</cx:pt>
          <cx:pt idx="412">43.052926829268287</cx:pt>
          <cx:pt idx="413">43.211428571428577</cx:pt>
          <cx:pt idx="414">43.347499999999997</cx:pt>
          <cx:pt idx="415">43.534999999999997</cx:pt>
          <cx:pt idx="416">44.401395348837212</cx:pt>
          <cx:pt idx="417">45.623333333333342</cx:pt>
          <cx:pt idx="418">45.646470588235303</cx:pt>
          <cx:pt idx="419">47.613076923076932</cx:pt>
          <cx:pt idx="420">50.413076923076922</cx:pt>
          <cx:pt idx="421">61.872500000000002</cx:pt>
          <cx:pt idx="422">62.978571428571442</cx:pt>
          <cx:pt idx="423">63.816000000000003</cx:pt>
          <cx:pt idx="424">64.303333333333327</cx:pt>
          <cx:pt idx="425">64.505263157894731</cx:pt>
          <cx:pt idx="426">65.726500000000001</cx:pt>
          <cx:pt idx="427">67.552999999999997</cx:pt>
          <cx:pt idx="428">68.01157894736842</cx:pt>
          <cx:pt idx="429">70.068333333333342</cx:pt>
          <cx:pt idx="430">70.341176470588238</cx:pt>
          <cx:pt idx="431">70.432068965517246</cx:pt>
          <cx:pt idx="432">72.157857142857139</cx:pt>
          <cx:pt idx="433">73.445999999999998</cx:pt>
          <cx:pt idx="434">73.991851851851848</cx:pt>
          <cx:pt idx="435">74.061470588235295</cx:pt>
          <cx:pt idx="436">75.021428571428572</cx:pt>
          <cx:pt idx="437">75.0625</cx:pt>
          <cx:pt idx="438">78.135833333333338</cx:pt>
          <cx:pt idx="439">78.789999999999992</cx:pt>
          <cx:pt idx="440">79.180000000000007</cx:pt>
          <cx:pt idx="441">79.381428571428572</cx:pt>
          <cx:pt idx="442">82.494262295081967</cx:pt>
          <cx:pt idx="443">90.392499999999998</cx:pt>
          <cx:pt idx="444">90.620000000000005</cx:pt>
          <cx:pt idx="445">92.317999999999998</cx:pt>
          <cx:pt idx="446">94.392857142857139</cx:pt>
          <cx:pt idx="447">95.625588235294117</cx:pt>
          <cx:pt idx="448">96.387594936708865</cx:pt>
          <cx:pt idx="449">96.438181818181818</cx:pt>
          <cx:pt idx="450">101.86</cx:pt>
          <cx:pt idx="451">103.453</cx:pt>
          <cx:pt idx="452">103.7435416666667</cx:pt>
          <cx:pt idx="453">106.38811320754721</cx:pt>
          <cx:pt idx="454">109.3317391304348</cx:pt>
          <cx:pt idx="455">110.0964</cx:pt>
          <cx:pt idx="456">115.8642307692308</cx:pt>
          <cx:pt idx="457">118.875</cx:pt>
          <cx:pt idx="458">120.19880000000001</cx:pt>
          <cx:pt idx="459">120.518</cx:pt>
          <cx:pt idx="460">121.38</cx:pt>
          <cx:pt idx="461">121.421875</cx:pt>
          <cx:pt idx="462">122.55448275862069</cx:pt>
          <cx:pt idx="463">126.8488571428571</cx:pt>
          <cx:pt idx="464">128.46428571428569</cx:pt>
          <cx:pt idx="465">129.2033333333334</cx:pt>
          <cx:pt idx="466">130.49117647058819</cx:pt>
          <cx:pt idx="467">133.03047619047621</cx:pt>
          <cx:pt idx="468">136.84999999999999</cx:pt>
          <cx:pt idx="469">144.1305263157895</cx:pt>
          <cx:pt idx="470">144.5891666666667</cx:pt>
          <cx:pt idx="471">147.05199999999999</cx:pt>
          <cx:pt idx="472">148.94846153846149</cx:pt>
          <cx:pt idx="473">155.88791666666671</cx:pt>
          <cx:pt idx="474">161.273</cx:pt>
          <cx:pt idx="475">161.36866666666671</cx:pt>
          <cx:pt idx="476">162.2682352941176</cx:pt>
          <cx:pt idx="477">162.98809523809521</cx:pt>
          <cx:pt idx="478">167.39500000000001</cx:pt>
          <cx:pt idx="479">171.66874999999999</cx:pt>
          <cx:pt idx="480">173.505</cx:pt>
          <cx:pt idx="481">179.1998412698413</cx:pt>
          <cx:pt idx="482">179.63</cx:pt>
          <cx:pt idx="483">184.88874999999999</cx:pt>
          <cx:pt idx="484">187.324375</cx:pt>
          <cx:pt idx="485">189.09</cx:pt>
          <cx:pt idx="486">194.43666666666661</cx:pt>
          <cx:pt idx="487">194.44999999999999</cx:pt>
          <cx:pt idx="488">194.72380952380951</cx:pt>
          <cx:pt idx="489">197.0176923076923</cx:pt>
          <cx:pt idx="490">197.77250000000001</cx:pt>
          <cx:pt idx="491">202.47725</cx:pt>
          <cx:pt idx="492">202.61714285714291</cx:pt>
          <cx:pt idx="493">203.06</cx:pt>
          <cx:pt idx="494">210.1622222222222</cx:pt>
          <cx:pt idx="495">210.36333333333329</cx:pt>
          <cx:pt idx="496">212.59100000000001</cx:pt>
          <cx:pt idx="497">217.94499999999999</cx:pt>
          <cx:pt idx="498">219.6729411764706</cx:pt>
          <cx:pt idx="499">219.97</cx:pt>
          <cx:pt idx="500">220.0033333333333</cx:pt>
          <cx:pt idx="501">221.965</cx:pt>
          <cx:pt idx="502">222.1875</cx:pt>
          <cx:pt idx="503">222.88399999999999</cx:pt>
          <cx:pt idx="504">224.56142857142859</cx:pt>
          <cx:pt idx="505">225.4583870967742</cx:pt>
          <cx:pt idx="506">226.48692307692309</cx:pt>
          <cx:pt idx="507">226.65799999999999</cx:pt>
          <cx:pt idx="508">228.8568181818182</cx:pt>
          <cx:pt idx="509">230.34333333333339</cx:pt>
          <cx:pt idx="510">231.28919999999999</cx:pt>
          <cx:pt idx="511">234.86250000000001</cx:pt>
          <cx:pt idx="512">237.40238095238101</cx:pt>
          <cx:pt idx="513">244.2464705882353</cx:pt>
          <cx:pt idx="514">246.4355555555556</cx:pt>
          <cx:pt idx="515">247.19999999999999</cx:pt>
          <cx:pt idx="516">250.35272727272729</cx:pt>
          <cx:pt idx="517">253.44499999999999</cx:pt>
          <cx:pt idx="518">253.71846153846161</cx:pt>
          <cx:pt idx="519">257.83127272727268</cx:pt>
          <cx:pt idx="520">261.6825</cx:pt>
          <cx:pt idx="521">262.39416666666671</cx:pt>
          <cx:pt idx="522">263.08125000000001</cx:pt>
          <cx:pt idx="523">265.77666666666659</cx:pt>
          <cx:pt idx="524">274.10913043478263</cx:pt>
          <cx:pt idx="525">274.58666666666659</cx:pt>
          <cx:pt idx="526">275.89749999999998</cx:pt>
          <cx:pt idx="527">276.00071428571431</cx:pt>
          <cx:pt idx="528">277.43666666666672</cx:pt>
          <cx:pt idx="529">278.04000000000002</cx:pt>
          <cx:pt idx="530">279.09916666666669</cx:pt>
          <cx:pt idx="531">280.11619047619052</cx:pt>
          <cx:pt idx="532">281.73642857142858</cx:pt>
          <cx:pt idx="533">286.488</cx:pt>
          <cx:pt idx="534">286.88999999999999</cx:pt>
          <cx:pt idx="535">290.46277777777777</cx:pt>
          <cx:pt idx="536">291.56396226415092</cx:pt>
          <cx:pt idx="537">297.16705882352937</cx:pt>
          <cx:pt idx="538">297.83055555555552</cx:pt>
          <cx:pt idx="539">301.29166666666669</cx:pt>
          <cx:pt idx="540">304.37700000000001</cx:pt>
          <cx:pt idx="541">304.85899999999998</cx:pt>
          <cx:pt idx="542">308.73000000000002</cx:pt>
          <cx:pt idx="543">310.3870588235294</cx:pt>
          <cx:pt idx="544">318.09714285714279</cx:pt>
          <cx:pt idx="545">319.20672413793108</cx:pt>
          <cx:pt idx="546">327.69363636363641</cx:pt>
          <cx:pt idx="547">330.35923076923081</cx:pt>
          <cx:pt idx="548">331.52769230769229</cx:pt>
          <cx:pt idx="549">332.56400000000002</cx:pt>
          <cx:pt idx="550">333.19</cx:pt>
          <cx:pt idx="551">344.56176470588241</cx:pt>
          <cx:pt idx="552">360.48071428571433</cx:pt>
          <cx:pt idx="553">361.22703703703701</cx:pt>
          <cx:pt idx="554">361.6875</cx:pt>
          <cx:pt idx="555">363.07538461538462</cx:pt>
          <cx:pt idx="556">364.49200000000002</cx:pt>
          <cx:pt idx="557">365.81615384615378</cx:pt>
          <cx:pt idx="558">366.47235294117638</cx:pt>
          <cx:pt idx="559">367.45600000000002</cx:pt>
          <cx:pt idx="560">371.82866666666672</cx:pt>
          <cx:pt idx="561">371.98000000000002</cx:pt>
          <cx:pt idx="562">372.47199999999998</cx:pt>
          <cx:pt idx="563">372.83333333333331</cx:pt>
          <cx:pt idx="564">372.98461538461538</cx:pt>
          <cx:pt idx="565">374.39022222222218</cx:pt>
          <cx:pt idx="566">378.42434782608689</cx:pt>
          <cx:pt idx="567">379.1247619047619</cx:pt>
          <cx:pt idx="568">381.57666666666671</cx:pt>
          <cx:pt idx="569">383.59260869565207</cx:pt>
          <cx:pt idx="570">383.90529411764709</cx:pt>
          <cx:pt idx="571">383.99461538461537</cx:pt>
          <cx:pt idx="572">385.06714285714281</cx:pt>
          <cx:pt idx="573">392.79599999999999</cx:pt>
          <cx:pt idx="574">395.44960784313719</cx:pt>
          <cx:pt idx="575">397.10454545454542</cx:pt>
          <cx:pt idx="576">398.19857142857143</cx:pt>
          <cx:pt idx="577">401.36250000000001</cx:pt>
          <cx:pt idx="578">402.62230769230769</cx:pt>
          <cx:pt idx="579">406.83647058823527</cx:pt>
          <cx:pt idx="580">409.5214285714286</cx:pt>
          <cx:pt idx="581">409.76285714285717</cx:pt>
          <cx:pt idx="582">413.06058823529412</cx:pt>
          <cx:pt idx="583">415.76833333333337</cx:pt>
          <cx:pt idx="584">423.71074074074068</cx:pt>
          <cx:pt idx="585">425.43153846153842</cx:pt>
          <cx:pt idx="586">425.52875</cx:pt>
          <cx:pt idx="587">440.73200000000003</cx:pt>
          <cx:pt idx="588">442.6875</cx:pt>
          <cx:pt idx="589">443.25818181818181</cx:pt>
          <cx:pt idx="590">445.28642857142859</cx:pt>
          <cx:pt idx="591">450.83666666666659</cx:pt>
          <cx:pt idx="592">451.33875</cx:pt>
          <cx:pt idx="593">459.14333333333337</cx:pt>
          <cx:pt idx="594">467.726</cx:pt>
          <cx:pt idx="595">475.20285714285723</cx:pt>
          <cx:pt idx="596">477.17886075949372</cx:pt>
          <cx:pt idx="597">477.54071428571427</cx:pt>
          <cx:pt idx="598">490.09875</cx:pt>
          <cx:pt idx="599">492.15499999999997</cx:pt>
          <cx:pt idx="600">493.43000000000001</cx:pt>
          <cx:pt idx="601">494.96100000000001</cx:pt>
          <cx:pt idx="602">496.29857142857151</cx:pt>
          <cx:pt idx="603">504.98399999999998</cx:pt>
          <cx:pt idx="604">507.87777777777768</cx:pt>
          <cx:pt idx="605">519.32466666666664</cx:pt>
          <cx:pt idx="606">522.25200000000007</cx:pt>
          <cx:pt idx="607">526.15083333333337</cx:pt>
          <cx:pt idx="608">529.22578947368424</cx:pt>
          <cx:pt idx="609">530.85400000000004</cx:pt>
          <cx:pt idx="610">537.34142857142854</cx:pt>
          <cx:pt idx="611">550.8609090909091</cx:pt>
          <cx:pt idx="612">558.9823076923077</cx:pt>
          <cx:pt idx="613">560.06000000000006</cx:pt>
          <cx:pt idx="614">575.15333333333331</cx:pt>
          <cx:pt idx="615">577.72363636363639</cx:pt>
          <cx:pt idx="616">580.02999999999997</cx:pt>
          <cx:pt idx="617">584.29642857142858</cx:pt>
          <cx:pt idx="618">585.6344444444444</cx:pt>
          <cx:pt idx="619">586.38315789473688</cx:pt>
          <cx:pt idx="620">589.27150000000006</cx:pt>
          <cx:pt idx="621">593.30500000000006</cx:pt>
          <cx:pt idx="622">605.47249999999997</cx:pt>
          <cx:pt idx="623">609.55250000000001</cx:pt>
          <cx:pt idx="624">612.55066666666664</cx:pt>
          <cx:pt idx="625">613.85846153846148</cx:pt>
          <cx:pt idx="626">617.01874999999995</cx:pt>
          <cx:pt idx="627">620.91666666666663</cx:pt>
          <cx:pt idx="628">625.26839999999993</cx:pt>
          <cx:pt idx="629">625.38100000000009</cx:pt>
          <cx:pt idx="630">629.40090909090907</cx:pt>
          <cx:pt idx="631">635.09249999999997</cx:pt>
          <cx:pt idx="632">635.85000000000002</cx:pt>
          <cx:pt idx="633">643.58357142857142</cx:pt>
          <cx:pt idx="634">648.30600000000004</cx:pt>
          <cx:pt idx="635">649.14999999999998</cx:pt>
          <cx:pt idx="636">649.67849999999999</cx:pt>
          <cx:pt idx="637">657.048</cx:pt>
          <cx:pt idx="638">657.28666666666663</cx:pt>
          <cx:pt idx="639">657.73695652173922</cx:pt>
          <cx:pt idx="640">662.39266666666663</cx:pt>
          <cx:pt idx="641">671.59899999999993</cx:pt>
          <cx:pt idx="642">677.32875000000001</cx:pt>
          <cx:pt idx="643">677.60125000000005</cx:pt>
          <cx:pt idx="644">682.77250000000004</cx:pt>
          <cx:pt idx="645">687.09090909090912</cx:pt>
          <cx:pt idx="646">687.15333333333331</cx:pt>
          <cx:pt idx="647">696.00454545454545</cx:pt>
          <cx:pt idx="648">700.02812500000005</cx:pt>
          <cx:pt idx="649">701.02499999999998</cx:pt>
          <cx:pt idx="650">702.44444444444446</cx:pt>
          <cx:pt idx="651">709.8421428571429</cx:pt>
          <cx:pt idx="652">711.875</cx:pt>
          <cx:pt idx="653">711.89600000000007</cx:pt>
          <cx:pt idx="654">723.79076923076923</cx:pt>
          <cx:pt idx="655">724.88800000000003</cx:pt>
          <cx:pt idx="656">728.09000000000003</cx:pt>
          <cx:pt idx="657">730.01363636363635</cx:pt>
          <cx:pt idx="658">738.69428571428568</cx:pt>
          <cx:pt idx="659">739.47299999999996</cx:pt>
          <cx:pt idx="660">740.09999999999991</cx:pt>
          <cx:pt idx="661">743.18428571428569</cx:pt>
          <cx:pt idx="662">744.52666666666664</cx:pt>
          <cx:pt idx="663">757.36642857142851</cx:pt>
          <cx:pt idx="664">762.77588235294115</cx:pt>
          <cx:pt idx="665">764.03454545454542</cx:pt>
          <cx:pt idx="666">766.63874999999996</cx:pt>
          <cx:pt idx="667">777.32111111111112</cx:pt>
          <cx:pt idx="668">781.39750000000004</cx:pt>
          <cx:pt idx="669">795.80899999999997</cx:pt>
          <cx:pt idx="670">798.49583333333339</cx:pt>
          <cx:pt idx="671">805.69083333333344</cx:pt>
          <cx:pt idx="672">805.88499999999999</cx:pt>
          <cx:pt idx="673">810.84399999999994</cx:pt>
          <cx:pt idx="674">821.23500000000001</cx:pt>
          <cx:pt idx="675">828.7883333333333</cx:pt>
          <cx:pt idx="676">829.15999999999997</cx:pt>
          <cx:pt idx="677">837.55466666666666</cx:pt>
          <cx:pt idx="678">837.65090909090907</cx:pt>
          <cx:pt idx="679">839.81636363636358</cx:pt>
          <cx:pt idx="680">846.9276315789474</cx:pt>
          <cx:pt idx="681">855.95666666666659</cx:pt>
          <cx:pt idx="682">857.822</cx:pt>
          <cx:pt idx="683">858.62777777777774</cx:pt>
          <cx:pt idx="684">869.19833333333327</cx:pt>
          <cx:pt idx="685">874.54384615384618</cx:pt>
          <cx:pt idx="686">874.77833333333331</cx:pt>
          <cx:pt idx="687">876.16875000000005</cx:pt>
          <cx:pt idx="688">878.64799999999991</cx:pt>
          <cx:pt idx="689">878.70333333333338</cx:pt>
          <cx:pt idx="690">881.55111111111114</cx:pt>
          <cx:pt idx="691">884.24333333333334</cx:pt>
          <cx:pt idx="692">885.39833333333343</cx:pt>
          <cx:pt idx="693">891.13</cx:pt>
          <cx:pt idx="694">891.27428571428572</cx:pt>
          <cx:pt idx="695">905.54999999999995</cx:pt>
          <cx:pt idx="696">921.63681818181806</cx:pt>
          <cx:pt idx="697">923.09222222222218</cx:pt>
          <cx:pt idx="698">929.4615</cx:pt>
          <cx:pt idx="699">930.02157894736843</cx:pt>
          <cx:pt idx="700">933.90374999999995</cx:pt>
          <cx:pt idx="701">934.05000000000007</cx:pt>
          <cx:pt idx="702">938.64125000000001</cx:pt>
          <cx:pt idx="703">938.69500000000005</cx:pt>
          <cx:pt idx="704">944.51033333333339</cx:pt>
          <cx:pt idx="705">952.96000000000004</cx:pt>
          <cx:pt idx="706">964.96699999999998</cx:pt>
          <cx:pt idx="707">966.34461538461539</cx:pt>
          <cx:pt idx="708">968.59666666666669</cx:pt>
          <cx:pt idx="709">972.11666666666667</cx:pt>
          <cx:pt idx="710">976.58562500000005</cx:pt>
          <cx:pt idx="711">987.49000000000001</cx:pt>
          <cx:pt idx="712">989.21375</cx:pt>
          <cx:pt idx="713">997.95000000000005</cx:pt>
          <cx:pt idx="714">1014.1275000000001</cx:pt>
          <cx:pt idx="715">1016.635714285714</cx:pt>
          <cx:pt idx="716">1018.4450000000001</cx:pt>
          <cx:pt idx="717">1018.882222222222</cx:pt>
          <cx:pt idx="718">1019.413333333333</cx:pt>
          <cx:pt idx="719">1019.698181818182</cx:pt>
          <cx:pt idx="720">1023.1108333333329</cx:pt>
          <cx:pt idx="721">1028.155</cx:pt>
          <cx:pt idx="722">1028.6300000000001</cx:pt>
          <cx:pt idx="723">1031.2750000000001</cx:pt>
          <cx:pt idx="724">1040.2774999999999</cx:pt>
          <cx:pt idx="725">1059.6199999999999</cx:pt>
          <cx:pt idx="726">1061.5274999999999</cx:pt>
          <cx:pt idx="727">1062.5139999999999</cx:pt>
          <cx:pt idx="728">1063.7137499999999</cx:pt>
          <cx:pt idx="729">1067.4154545454551</cx:pt>
          <cx:pt idx="730">1069.9608333333331</cx:pt>
          <cx:pt idx="731">1070.545555555555</cx:pt>
          <cx:pt idx="732">1071.8975</cx:pt>
          <cx:pt idx="733">1088.1300000000001</cx:pt>
          <cx:pt idx="734">1089.669230769231</cx:pt>
          <cx:pt idx="735">1091.22</cx:pt>
          <cx:pt idx="736">1092.416666666667</cx:pt>
          <cx:pt idx="737">1106.8607692307689</cx:pt>
          <cx:pt idx="738">1110.796875</cx:pt>
          <cx:pt idx="739">1110.8399999999999</cx:pt>
          <cx:pt idx="740">1135.6444444444439</cx:pt>
          <cx:pt idx="741">1136.2842857142859</cx:pt>
          <cx:pt idx="742">1137.9324999999999</cx:pt>
          <cx:pt idx="743">1147.2974999999999</cx:pt>
          <cx:pt idx="744">1153.76</cx:pt>
          <cx:pt idx="745">1156.9877777777781</cx:pt>
          <cx:pt idx="746">1170.5115000000001</cx:pt>
          <cx:pt idx="747">1178.0161538461541</cx:pt>
          <cx:pt idx="748">1187.355</cx:pt>
          <cx:pt idx="749">1221.508181818182</cx:pt>
          <cx:pt idx="750">1252.8557142857139</cx:pt>
          <cx:pt idx="751">1253.6663636363639</cx:pt>
          <cx:pt idx="752">1258.4175</cx:pt>
          <cx:pt idx="753">1285.5771428571429</cx:pt>
          <cx:pt idx="754">1290.562727272727</cx:pt>
          <cx:pt idx="755">1291.985714285714</cx:pt>
          <cx:pt idx="756">1300.0111111111109</cx:pt>
          <cx:pt idx="757">1305.421111111111</cx:pt>
          <cx:pt idx="758">1306.3125</cx:pt>
          <cx:pt idx="759">1310.8255555555561</cx:pt>
          <cx:pt idx="760">1340.842272727273</cx:pt>
          <cx:pt idx="761">1346.208461538462</cx:pt>
          <cx:pt idx="762">1407.8533333333339</cx:pt>
          <cx:pt idx="763">1414.16625</cx:pt>
          <cx:pt idx="764">1417.008636363636</cx:pt>
          <cx:pt idx="765">1427.9375</cx:pt>
          <cx:pt idx="766">1436.625</cx:pt>
          <cx:pt idx="767">1443.158571428572</cx:pt>
          <cx:pt idx="768">1461.3142857142859</cx:pt>
          <cx:pt idx="769">1467.75</cx:pt>
          <cx:pt idx="770">1496.2337500000001</cx:pt>
          <cx:pt idx="771">1513.531538461539</cx:pt>
          <cx:pt idx="772">1538.5928571428569</cx:pt>
          <cx:pt idx="773">1550.9000000000001</cx:pt>
          <cx:pt idx="774">1560.041176470588</cx:pt>
          <cx:pt idx="775">1566.0111111111109</cx:pt>
          <cx:pt idx="776">1572.604444444444</cx:pt>
          <cx:pt idx="777">1578.4224999999999</cx:pt>
          <cx:pt idx="778">1584.9109090909089</cx:pt>
          <cx:pt idx="779">1593.954</cx:pt>
          <cx:pt idx="780">1602.962857142857</cx:pt>
          <cx:pt idx="781">1609.2333333333329</cx:pt>
          <cx:pt idx="782">1628.1577777777779</cx:pt>
          <cx:pt idx="783">1659.2625</cx:pt>
          <cx:pt idx="784">1681.4833333333329</cx:pt>
          <cx:pt idx="785">1686.7112500000001</cx:pt>
          <cx:pt idx="786">1686.8291666666671</cx:pt>
          <cx:pt idx="787">1688.7333333333329</cx:pt>
          <cx:pt idx="788">1689.3093333333329</cx:pt>
          <cx:pt idx="789">1698.99</cx:pt>
          <cx:pt idx="790">1722.471666666667</cx:pt>
          <cx:pt idx="791">1786.8214285714289</cx:pt>
          <cx:pt idx="792">1804.5599999999999</cx:pt>
          <cx:pt idx="793">1862.7283333333339</cx:pt>
          <cx:pt idx="794">1885.8800000000001</cx:pt>
          <cx:pt idx="795">1900.2650000000001</cx:pt>
          <cx:pt idx="796">1931.1128571428569</cx:pt>
          <cx:pt idx="797">1932.254285714286</cx:pt>
          <cx:pt idx="798">2002.6679999999999</cx:pt>
          <cx:pt idx="799">2041.1285714285709</cx:pt>
          <cx:pt idx="800">2215.6950000000002</cx:pt>
          <cx:pt idx="801">2570.7775000000001</cx:pt>
          <cx:pt idx="802">3687.415</cx:pt>
        </cx:lvl>
      </cx:numDim>
    </cx:data>
  </cx:chartData>
  <cx:chart>
    <cx:title pos="t" align="ctr" overlay="0">
      <cx:tx>
        <cx:txData>
          <cx:v/>
        </cx:txData>
      </cx:tx>
      <cx:txPr>
        <a:bodyPr spcFirstLastPara="1" vertOverflow="ellipsis" wrap="square" lIns="0" tIns="0" rIns="0" bIns="0" anchor="ctr" anchorCtr="1"/>
        <a:lstStyle/>
        <a:p>
          <a:pPr algn="ctr">
            <a:defRPr/>
          </a:pPr>
          <a:endParaRPr/>
        </a:p>
      </cx:txPr>
    </cx:title>
    <cx:plotArea>
      <cx:plotAreaRegion>
        <cx:series layoutId="boxWhisker" uniqueId="{4182C088-BBF1-40C3-8A6B-46B290DE937D}">
          <cx:dataId val="0"/>
          <cx:layoutPr>
            <cx:visibility meanLine="0" meanMarker="1" nonoutliers="0" outliers="1"/>
            <cx:statistics quartileMethod="exclusive"/>
          </cx:layoutPr>
        </cx:series>
      </cx:plotAreaRegion>
      <cx:axis id="0">
        <cx:catScaling gapWidth="1"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tickLabels/>
      </cx:axis>
      <cx:axis id="1">
        <cx:valScaling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majorGridlines/>
        <cx:tickLabels/>
      </cx:axis>
    </cx:plotArea>
  </cx:chart>
</cx:chartSpace>
</file>

<file path=ppt/charts/chartEx2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lvl ptCount="520">
          <cx:pt idx="0">KH VWD (SAP, 21 FALL)</cx:pt>
          <cx:pt idx="1">KH VWD (SAP, 21 FALL)</cx:pt>
          <cx:pt idx="2">KH VWD (SAP, 21 FALL)</cx:pt>
          <cx:pt idx="3">KH VWD (SAP, 21 FALL)</cx:pt>
          <cx:pt idx="4">KH VWD (SAP, 21 FALL)</cx:pt>
          <cx:pt idx="5">KH VWD (SAP, 21 FALL)</cx:pt>
          <cx:pt idx="6">KH VWD (SAP, 21 FALL)</cx:pt>
          <cx:pt idx="7">KH VWD (SAP, 21 FALL)</cx:pt>
          <cx:pt idx="8">KH VWD (SAP, 21 FALL)</cx:pt>
          <cx:pt idx="9">KH VWD (SAP, 21 FALL)</cx:pt>
          <cx:pt idx="10">KH VWD (SAP, 21 FALL)</cx:pt>
          <cx:pt idx="11">KH VWD (SAP, 21 FALL)</cx:pt>
          <cx:pt idx="12">KH VWD (SAP, 21 FALL)</cx:pt>
          <cx:pt idx="13">KH VWD (SAP, 21 FALL)</cx:pt>
          <cx:pt idx="14">KH VWD (SAP, 21 FALL)</cx:pt>
          <cx:pt idx="15">KH VWD (SAP, 21 FALL)</cx:pt>
          <cx:pt idx="16">KH VWD (SAP, 21 FALL)</cx:pt>
          <cx:pt idx="17">KH VWD (SAP, 21 FALL)</cx:pt>
          <cx:pt idx="18">KH VWD (SAP, 21 FALL)</cx:pt>
          <cx:pt idx="19">KH VWD (SAP, 21 FALL)</cx:pt>
          <cx:pt idx="20">KH VWD (SAP, 21 FALL)</cx:pt>
          <cx:pt idx="21">KH VWD (SAP, 21 FALL)</cx:pt>
          <cx:pt idx="22">KH VWD (SAP, 21 FALL)</cx:pt>
          <cx:pt idx="23">KH VWD (SAP, 21 FALL)</cx:pt>
          <cx:pt idx="24">KH VWD (SAP, 21 FALL)</cx:pt>
          <cx:pt idx="25">KH VWD (SAP, 21 FALL)</cx:pt>
          <cx:pt idx="26">KH VWD (SAP, 21 FALL)</cx:pt>
          <cx:pt idx="27">KH VWD (SAP, 21 FALL)</cx:pt>
          <cx:pt idx="28">KH VWD (SAP, 21 FALL)</cx:pt>
          <cx:pt idx="29">KH VWD (SAP, 21 FALL)</cx:pt>
          <cx:pt idx="30">KH VWD (SAP, 21 FALL)</cx:pt>
          <cx:pt idx="31">KH VWD (SAP, 21 FALL)</cx:pt>
          <cx:pt idx="32">KH VWD (SAP, 21 FALL)</cx:pt>
          <cx:pt idx="33">KH VWD (SAP, 21 FALL)</cx:pt>
          <cx:pt idx="34">KH VWD (SAP, 21 FALL)</cx:pt>
          <cx:pt idx="35">KH VWD (SAP, 21 FALL)</cx:pt>
          <cx:pt idx="36">KH VWD (SAP, 21 FALL)</cx:pt>
          <cx:pt idx="37">KH VWD (SAP, 21 FALL)</cx:pt>
          <cx:pt idx="38">KH VWD (SAP, 21 FALL)</cx:pt>
          <cx:pt idx="39">KH VWD (SAP, 21 FALL)</cx:pt>
          <cx:pt idx="40">KH VWD (SAP, 21 FALL)</cx:pt>
          <cx:pt idx="41">KH VWD (SAP, 21 FALL)</cx:pt>
          <cx:pt idx="42">KH VWD (SAP, 21 FALL)</cx:pt>
          <cx:pt idx="43">KH VWD (SAP, 21 FALL)</cx:pt>
          <cx:pt idx="44">KH VWD (SAP, 21 FALL)</cx:pt>
          <cx:pt idx="45">KH VWD (SAP, 21 FALL)</cx:pt>
          <cx:pt idx="46">KH VWD (SAP, 21 FALL)</cx:pt>
          <cx:pt idx="47">KH VWD (SAP, 21 FALL)</cx:pt>
          <cx:pt idx="48">KH VWD (SAP, 21 FALL)</cx:pt>
          <cx:pt idx="49">KH VWD (SAP, 21 FALL)</cx:pt>
          <cx:pt idx="50">KH VWD (SAP, 21 FALL)</cx:pt>
          <cx:pt idx="51">KH VWD (SAP, 21 FALL)</cx:pt>
          <cx:pt idx="52">KH VWD (SAP, 21 FALL)</cx:pt>
          <cx:pt idx="53">KH VWD (SAP, 21 FALL)</cx:pt>
          <cx:pt idx="54">KH VWD (SAP, 21 FALL)</cx:pt>
          <cx:pt idx="55">KH VWD (SAP, 21 FALL)</cx:pt>
          <cx:pt idx="56">KH VWD (SAP, 21 FALL)</cx:pt>
          <cx:pt idx="57">KH VWD (SAP, 21 FALL)</cx:pt>
          <cx:pt idx="58">KH VWD (SAP, 21 FALL)</cx:pt>
          <cx:pt idx="59">KH VWD (SAP, 21 FALL)</cx:pt>
          <cx:pt idx="60">KH VWD (SAP, 21 FALL)</cx:pt>
          <cx:pt idx="61">KH VWD (SAP, 21 FALL)</cx:pt>
          <cx:pt idx="62">KH VWD (SAP, 21 FALL)</cx:pt>
          <cx:pt idx="63">KH VWD (SAP, 21 FALL)</cx:pt>
          <cx:pt idx="64">KH VWD (SAP, 21 FALL)</cx:pt>
          <cx:pt idx="65">KH VWD (SAP, 21 FALL)</cx:pt>
          <cx:pt idx="66">KH VWD (SAP, 21 FALL)</cx:pt>
          <cx:pt idx="67">KH VWD (SAP, 21 FALL)</cx:pt>
          <cx:pt idx="68">KH VWD (SAP, 21 FALL)</cx:pt>
          <cx:pt idx="69">KH VWD (SAP, 21 FALL)</cx:pt>
          <cx:pt idx="70">KH VWD (SAP, 21 FALL)</cx:pt>
          <cx:pt idx="71">KH VWD (SAP, 21 FALL)</cx:pt>
          <cx:pt idx="72">KH VWD (SAP, 21 FALL)</cx:pt>
          <cx:pt idx="73">KH VWD (SAP, 21 FALL)</cx:pt>
          <cx:pt idx="74">KH VWD (SAP, 21 FALL)</cx:pt>
          <cx:pt idx="75">KH VWD (SAP, 21 FALL)</cx:pt>
          <cx:pt idx="76">KH VWD (SAP, 21 FALL)</cx:pt>
          <cx:pt idx="77">KH VWD (SAP, 21 FALL)</cx:pt>
          <cx:pt idx="78">KH VWD (SAP, 21 FALL)</cx:pt>
          <cx:pt idx="79">KH VWD (SAP, 21 FALL)</cx:pt>
          <cx:pt idx="80">KH VWD (SAP, 21 FALL)</cx:pt>
          <cx:pt idx="81">KH VWD (SAP, 21 FALL)</cx:pt>
          <cx:pt idx="82">KH VWD (SAP, 21 FALL)</cx:pt>
          <cx:pt idx="83">KH VWD (SAP, 21 FALL)</cx:pt>
          <cx:pt idx="84">KH VWD (SAP, 21 FALL)</cx:pt>
          <cx:pt idx="85">KH VWD (SAP, 21 FALL)</cx:pt>
          <cx:pt idx="86">KH VWD (SAP, 21 FALL)</cx:pt>
          <cx:pt idx="87">KH VWD (SAP, 21 FALL)</cx:pt>
          <cx:pt idx="88">KH VWD (SAP, 21 FALL)</cx:pt>
          <cx:pt idx="89">KH VWD (SAP, 21 FALL)</cx:pt>
          <cx:pt idx="90">KH VWD (SAP, 21 FALL)</cx:pt>
          <cx:pt idx="91">KH VWD (SAP, 21 FALL)</cx:pt>
          <cx:pt idx="92">KH VWD (SAP, 21 FALL)</cx:pt>
          <cx:pt idx="93">KH VWD (SAP, 21 FALL)</cx:pt>
          <cx:pt idx="94">KH VWD (SAP, 21 FALL)</cx:pt>
          <cx:pt idx="95">KH VWD (SAP, 21 FALL)</cx:pt>
          <cx:pt idx="96">KH VWD (SAP, 21 FALL)</cx:pt>
          <cx:pt idx="97">KH VWD (SAP, 21 FALL)</cx:pt>
          <cx:pt idx="98">KH VWD (SAP, 21 FALL)</cx:pt>
          <cx:pt idx="99">KH VWD (SAP, 21 FALL)</cx:pt>
          <cx:pt idx="100">KH VWD (SAP, 21 FALL)</cx:pt>
          <cx:pt idx="101">KH VWD (SAP, 21 FALL)</cx:pt>
          <cx:pt idx="102">KH VWD (SAP, 21 FALL)</cx:pt>
          <cx:pt idx="103">KH VWD (SAP, 21 FALL)</cx:pt>
          <cx:pt idx="104">KH VWD (SAP, 21 FALL)</cx:pt>
          <cx:pt idx="105">KH VWD (SAP, 21 FALL)</cx:pt>
          <cx:pt idx="106">KH VWD (SAP, 21 FALL)</cx:pt>
          <cx:pt idx="107">KH VWD (SAP, 21 FALL)</cx:pt>
          <cx:pt idx="108">KH VWD (SAP, 21 FALL)</cx:pt>
          <cx:pt idx="109">KH VWD (SAP, 21 FALL)</cx:pt>
          <cx:pt idx="110">KH VWD (SAP, 21 FALL)</cx:pt>
          <cx:pt idx="111">KH VWD (SAP, 21 FALL)</cx:pt>
          <cx:pt idx="112">KH VWD (SAP, 21 FALL)</cx:pt>
          <cx:pt idx="113">KH VWD (SAP, 21 FALL)</cx:pt>
          <cx:pt idx="114">KH VWD (SAP, 21 FALL)</cx:pt>
          <cx:pt idx="115">KH VWD (SAP, 21 FALL)</cx:pt>
          <cx:pt idx="116">KH VWD (SAP, 21 FALL)</cx:pt>
          <cx:pt idx="117">KH VWD (SAP, 21 FALL)</cx:pt>
          <cx:pt idx="118">KH VWD (SAP, 21 FALL)</cx:pt>
          <cx:pt idx="119">KH VWD (SAP, 21 FALL)</cx:pt>
          <cx:pt idx="120">KH VWD (SAP, 21 FALL)</cx:pt>
          <cx:pt idx="121">KH VWD (SAP, 21 FALL)</cx:pt>
          <cx:pt idx="122">KH VWD (SAP, 21 FALL)</cx:pt>
          <cx:pt idx="123">KH VWD (SAP, 21 FALL)</cx:pt>
          <cx:pt idx="124">KH VWD (SAP, 21 FALL)</cx:pt>
          <cx:pt idx="125">KH VWD (SAP, 21 FALL)</cx:pt>
          <cx:pt idx="126">KH VWD (SAP, 21 FALL)</cx:pt>
          <cx:pt idx="127">KH VWD (SAP, 21 FALL)</cx:pt>
          <cx:pt idx="128">KH VWD (SAP, 21 FALL)</cx:pt>
          <cx:pt idx="129">KH VWD (SAP, 21 FALL)</cx:pt>
          <cx:pt idx="130">KH VWD (SAP, 21 FALL)</cx:pt>
          <cx:pt idx="131">KH VWD (SAP, 21 FALL)</cx:pt>
          <cx:pt idx="132">KH VWD (SAP, 21 FALL)</cx:pt>
          <cx:pt idx="133">KH VWD (SAP, 21 FALL)</cx:pt>
          <cx:pt idx="134">KH VWD (SAP, 21 FALL)</cx:pt>
          <cx:pt idx="135">KH VWD (SAP, 21 FALL)</cx:pt>
          <cx:pt idx="136">KH VWD (SAP, 21 FALL)</cx:pt>
          <cx:pt idx="137">KH VWD (SAP, 21 FALL)</cx:pt>
          <cx:pt idx="138">KH VWD (SAP, 21 FALL)</cx:pt>
          <cx:pt idx="139">KH VWD (SAP, 21 FALL)</cx:pt>
          <cx:pt idx="140">KH VWD (SAP, 21 FALL)</cx:pt>
          <cx:pt idx="141">KH VWD (SAP, 21 FALL)</cx:pt>
          <cx:pt idx="142">KH VWD (SAP, 21 FALL)</cx:pt>
          <cx:pt idx="143">KH VWD (SAP, 21 FALL)</cx:pt>
          <cx:pt idx="144">KH VWD (SAP, 21 FALL)</cx:pt>
          <cx:pt idx="145">KH VWD (SAP, 21 FALL)</cx:pt>
          <cx:pt idx="146">KH VWD (SAP, 21 FALL)</cx:pt>
          <cx:pt idx="147">KH VWD (SAP, 21 FALL)</cx:pt>
          <cx:pt idx="148">KH VWD (SAP, 21 FALL)</cx:pt>
          <cx:pt idx="149">KH VWD (SAP, 21 FALL)</cx:pt>
          <cx:pt idx="150">KH VWD (SAP, 21 FALL)</cx:pt>
          <cx:pt idx="151">KH VWD (SAP, 21 FALL)</cx:pt>
          <cx:pt idx="152">KH VWD (SAP, 21 FALL)</cx:pt>
          <cx:pt idx="153">KH VWD (SAP, 21 FALL)</cx:pt>
          <cx:pt idx="154">KH VWD (SAP, 21 FALL)</cx:pt>
          <cx:pt idx="155">KH VWD (SAP, 21 FALL)</cx:pt>
          <cx:pt idx="156">KH VWD (SAP, 21 FALL)</cx:pt>
          <cx:pt idx="157">KH VWD (SAP, 21 FALL)</cx:pt>
          <cx:pt idx="158">KH VWD (SAP, 21 FALL)</cx:pt>
          <cx:pt idx="159">KH VWD (SAP, 21 FALL)</cx:pt>
          <cx:pt idx="160">KH VWD (SAP, 21 FALL)</cx:pt>
          <cx:pt idx="161">KH VWD (SAP, 21 FALL)</cx:pt>
          <cx:pt idx="162">KH VWD (SAP, 21 FALL)</cx:pt>
          <cx:pt idx="163">KH VWD (SAP, 21 FALL)</cx:pt>
          <cx:pt idx="164">KH VWD (SAP, 21 FALL)</cx:pt>
          <cx:pt idx="165">KH VWD (SAP, 21 FALL)</cx:pt>
          <cx:pt idx="166">KH VWD (SAP, 21 FALL)</cx:pt>
          <cx:pt idx="167">KH VWD (SAP, 21 FALL)</cx:pt>
          <cx:pt idx="168">KH VWD (SAP, 21 FALL)</cx:pt>
          <cx:pt idx="169">KH VWD (SAP, 21 FALL)</cx:pt>
          <cx:pt idx="170">KH VWD (SAP, 21 FALL)</cx:pt>
          <cx:pt idx="171">KH VWD (SAP, 21 FALL)</cx:pt>
          <cx:pt idx="172">KH VWD (SAP, 21 FALL)</cx:pt>
          <cx:pt idx="173">KH VWD (SAP, 21 FALL)</cx:pt>
          <cx:pt idx="174">KH VWD (SAP, 21 FALL)</cx:pt>
          <cx:pt idx="175">KH VWD (SAP, 21 FALL)</cx:pt>
          <cx:pt idx="176">KH VWD (SAP, 21 FALL)</cx:pt>
          <cx:pt idx="177">KH VWD (SAP, 21 FALL)</cx:pt>
          <cx:pt idx="178">KH VWD (SAP, 21 FALL)</cx:pt>
          <cx:pt idx="179">KH VWD (SAP, 21 FALL)</cx:pt>
          <cx:pt idx="180">KH VWD (SAP, 21 FALL)</cx:pt>
          <cx:pt idx="181">KH VWD (SAP, 21 FALL)</cx:pt>
          <cx:pt idx="182">KH VWD (SAP, 21 FALL)</cx:pt>
          <cx:pt idx="183">KH VWD (SAP, 21 FALL)</cx:pt>
          <cx:pt idx="184">KH VWD (SAP, 21 FALL)</cx:pt>
          <cx:pt idx="185">KH VWD (SAP, 21 FALL)</cx:pt>
          <cx:pt idx="186">KH VWD (SAP, 21 FALL)</cx:pt>
          <cx:pt idx="187">KH VWD (SAP, 21 FALL)</cx:pt>
          <cx:pt idx="188">KH VWD (SAP, 21 FALL)</cx:pt>
          <cx:pt idx="189">KH VWD (SAP, 21 FALL)</cx:pt>
          <cx:pt idx="190">KH VWD (SAP, 21 FALL)</cx:pt>
          <cx:pt idx="191">KH VWD (SAP, 21 FALL)</cx:pt>
          <cx:pt idx="192">KH VWD (SAP, 21 FALL)</cx:pt>
          <cx:pt idx="193">KH VWD (SAP, 21 FALL)</cx:pt>
          <cx:pt idx="194">KH VWD (SAP, 21 FALL)</cx:pt>
          <cx:pt idx="195">KH VWD (SAP, 21 FALL)</cx:pt>
          <cx:pt idx="196">KH VWD (SAP, 21 FALL)</cx:pt>
          <cx:pt idx="197">KH VWD (SAP, 21 FALL)</cx:pt>
          <cx:pt idx="198">KH VWD (SAP, 21 FALL)</cx:pt>
          <cx:pt idx="199">KH VWD (SAP, 21 FALL)</cx:pt>
          <cx:pt idx="200">KH VWD (SAP, 21 FALL)</cx:pt>
          <cx:pt idx="201">KH VWD (SAP, 21 FALL)</cx:pt>
          <cx:pt idx="202">KH VWD (SAP, 21 FALL)</cx:pt>
          <cx:pt idx="203">KH VWD (SAP, 21 FALL)</cx:pt>
          <cx:pt idx="204">KH VWD (SAP, 21 FALL)</cx:pt>
          <cx:pt idx="205">KH VWD (SAP, 21 FALL)</cx:pt>
          <cx:pt idx="206">KH VWD (SAP, 21 FALL)</cx:pt>
          <cx:pt idx="207">KH VWD (SAP, 21 FALL)</cx:pt>
          <cx:pt idx="208">KH VWD (SAP, 21 FALL)</cx:pt>
          <cx:pt idx="209">KH VWD (SAP, 21 FALL)</cx:pt>
          <cx:pt idx="210">KH VWD (SAP, 21 FALL)</cx:pt>
          <cx:pt idx="211">KH VWD (SAP, 21 FALL)</cx:pt>
          <cx:pt idx="212">KH VWD (SAP, 21 FALL)</cx:pt>
          <cx:pt idx="213">KH VWD (SAP, 21 FALL)</cx:pt>
          <cx:pt idx="214">KH VWD (SAP, 21 FALL)</cx:pt>
          <cx:pt idx="215">KH VWD (SAP, 21 FALL)</cx:pt>
          <cx:pt idx="216">KH VWD (SAP, 21 FALL)</cx:pt>
          <cx:pt idx="217">KH VWD (SAP, 21 FALL)</cx:pt>
          <cx:pt idx="218">KH VWD (SAP, 21 FALL)</cx:pt>
          <cx:pt idx="219">KH VWD (SAP, 21 FALL)</cx:pt>
          <cx:pt idx="220">KH VWD (SAP, 21 FALL)</cx:pt>
          <cx:pt idx="221">KH VWD (SAP, 21 FALL)</cx:pt>
          <cx:pt idx="222">KH VWD (SAP, 21 FALL)</cx:pt>
          <cx:pt idx="223">KH VWD (SAP, 21 FALL)</cx:pt>
          <cx:pt idx="224">KH VWD (SAP, 21 FALL)</cx:pt>
          <cx:pt idx="225">KH VWD (SAP, 21 FALL)</cx:pt>
          <cx:pt idx="226">KH VWD (SAP, 21 FALL)</cx:pt>
          <cx:pt idx="227">KH VWD (SAP, 21 FALL)</cx:pt>
          <cx:pt idx="228">KH VWD (SAP, 21 FALL)</cx:pt>
          <cx:pt idx="229">KH VWD (SAP, 21 FALL)</cx:pt>
          <cx:pt idx="230">KH VWD (SAP, 21 FALL)</cx:pt>
          <cx:pt idx="231">KH VWD (SAP, 21 FALL)</cx:pt>
          <cx:pt idx="232">KH VWD (SAP, 21 FALL)</cx:pt>
          <cx:pt idx="233">KH VWD (SAP, 21 FALL)</cx:pt>
          <cx:pt idx="234">KH VWD (SAP, 21 FALL)</cx:pt>
          <cx:pt idx="235">KH VWD (SAP, 21 FALL)</cx:pt>
          <cx:pt idx="236">KH VWD (SAP, 21 FALL)</cx:pt>
          <cx:pt idx="237">KH VWD (SAP, 21 FALL)</cx:pt>
          <cx:pt idx="238">KH VWD (SAP, 21 FALL)</cx:pt>
          <cx:pt idx="239">KH VWD (SAP, 21 FALL)</cx:pt>
          <cx:pt idx="240">KH VWD (SAP, 21 FALL)</cx:pt>
          <cx:pt idx="241">KH VWD (SAP, 21 FALL)</cx:pt>
          <cx:pt idx="242">KH VWD (SAP, 21 FALL)</cx:pt>
          <cx:pt idx="243">KH VWD (SAP, 21 FALL)</cx:pt>
          <cx:pt idx="244">KH VWD (SAP, 21 FALL)</cx:pt>
          <cx:pt idx="245">KH VWD (SAP, 21 FALL)</cx:pt>
          <cx:pt idx="246">KH VWD (SAP, 21 FALL)</cx:pt>
          <cx:pt idx="247">KH VWD (SAP, 21 FALL)</cx:pt>
          <cx:pt idx="248">KH VWD (SAP, 21 FALL)</cx:pt>
          <cx:pt idx="249">KH VWD (SAP, 21 FALL)</cx:pt>
          <cx:pt idx="250">KH VWD (SAP, 21 FALL)</cx:pt>
          <cx:pt idx="251">KH VWD (SAP, 21 FALL)</cx:pt>
          <cx:pt idx="252">KH VWD (SAP, 21 FALL)</cx:pt>
          <cx:pt idx="253">KH VWD (SAP, 21 FALL)</cx:pt>
          <cx:pt idx="254">KH VWD (SAP, 21 FALL)</cx:pt>
          <cx:pt idx="255">KH VWD (SAP, 21 FALL)</cx:pt>
          <cx:pt idx="256">KH VWD (SAP, 21 FALL)</cx:pt>
          <cx:pt idx="257">KH VWD (SAP, 21 FALL)</cx:pt>
          <cx:pt idx="258">KH VWD (SAP, 21 FALL)</cx:pt>
          <cx:pt idx="259">KH VWD (SAP, 21 FALL)</cx:pt>
          <cx:pt idx="260">KH VWD (SAP, 21 FALL)</cx:pt>
          <cx:pt idx="261">KH VWD (SAP, 21 FALL)</cx:pt>
          <cx:pt idx="262">KH VWD (SAP, 21 FALL)</cx:pt>
          <cx:pt idx="263">KH VWD (SAP, 21 FALL)</cx:pt>
          <cx:pt idx="264">KH VWD (SAP, 21 FALL)</cx:pt>
          <cx:pt idx="265">KH VWD (SAP, 21 FALL)</cx:pt>
          <cx:pt idx="266">KH VWD (SAP, 21 FALL)</cx:pt>
          <cx:pt idx="267">KH VWD (SAP, 21 FALL)</cx:pt>
          <cx:pt idx="268">KH VWD (SAP, 21 FALL)</cx:pt>
          <cx:pt idx="269">KH VWD (SAP, 21 FALL)</cx:pt>
          <cx:pt idx="270">KH VWD (SAP, 21 FALL)</cx:pt>
          <cx:pt idx="271">KH VWD (SAP, 21 FALL)</cx:pt>
          <cx:pt idx="272">KH VWD (SAP, 21 FALL)</cx:pt>
          <cx:pt idx="273">KH VWD (SAP, 21 FALL)</cx:pt>
          <cx:pt idx="274">KH VWD (SAP, 21 FALL)</cx:pt>
          <cx:pt idx="275">KH VWD (SAP, 21 FALL)</cx:pt>
          <cx:pt idx="276">KH VWD (SAP, 21 FALL)</cx:pt>
          <cx:pt idx="277">KH VWD (SAP, 21 FALL)</cx:pt>
          <cx:pt idx="278">KH VWD (SAP, 21 FALL)</cx:pt>
          <cx:pt idx="279">KH VWD (SAP, 21 FALL)</cx:pt>
          <cx:pt idx="280">KH VWD (SAP, 21 FALL)</cx:pt>
          <cx:pt idx="281">KH VWD (SAP, 21 FALL)</cx:pt>
          <cx:pt idx="282">KH VWD (SAP, 21 FALL)</cx:pt>
          <cx:pt idx="283">KH VWD (SAP, 21 FALL)</cx:pt>
          <cx:pt idx="284">KH VWD (SAP, 21 FALL)</cx:pt>
          <cx:pt idx="285">KH VWD (SAP, 21 FALL)</cx:pt>
          <cx:pt idx="286">KH VWD (SAP, 21 FALL)</cx:pt>
          <cx:pt idx="287">KH VWD (SAP, 21 FALL)</cx:pt>
          <cx:pt idx="288">KH VWD (SAP, 21 FALL)</cx:pt>
          <cx:pt idx="289">KH VWD (SAP, 21 FALL)</cx:pt>
          <cx:pt idx="290">KH VWD (SAP, 21 FALL)</cx:pt>
          <cx:pt idx="291">KH VWD (SAP, 21 FALL)</cx:pt>
          <cx:pt idx="292">KH VWD (SAP, 21 FALL)</cx:pt>
          <cx:pt idx="293">KH VWD (SAP, 21 FALL)</cx:pt>
          <cx:pt idx="294">KH VWD (SAP, 21 FALL)</cx:pt>
          <cx:pt idx="295">KH VWD (SAP, 21 FALL)</cx:pt>
          <cx:pt idx="296">KH VWD (SAP, 21 FALL)</cx:pt>
          <cx:pt idx="297">KH VWD (SAP, 21 FALL)</cx:pt>
          <cx:pt idx="298">KH VWD (SAP, 21 FALL)</cx:pt>
          <cx:pt idx="299">KH VWD (SAP, 21 FALL)</cx:pt>
          <cx:pt idx="300">KH VWD (SAP, 21 FALL)</cx:pt>
          <cx:pt idx="301">KH VWD (SAP, 21 FALL)</cx:pt>
          <cx:pt idx="302">KH VWD (SAP, 21 FALL)</cx:pt>
          <cx:pt idx="303">KH VWD (SAP, 21 FALL)</cx:pt>
          <cx:pt idx="304">KH VWD (SAP, 21 FALL)</cx:pt>
          <cx:pt idx="305">KH VWD (SAP, 21 FALL)</cx:pt>
          <cx:pt idx="306">KH VWD (SAP, 21 FALL)</cx:pt>
          <cx:pt idx="307">KH VWD (SAP, 21 FALL)</cx:pt>
          <cx:pt idx="308">KH VWD (SAP, 21 FALL)</cx:pt>
          <cx:pt idx="309">KH VWD (SAP, 21 FALL)</cx:pt>
          <cx:pt idx="310">KH VWD (SAP, 21 FALL)</cx:pt>
          <cx:pt idx="311">KH VWD (SAP, 21 FALL)</cx:pt>
          <cx:pt idx="312">KH VWD (SAP, 21 FALL)</cx:pt>
          <cx:pt idx="313">KH VWD (SAP, 21 FALL)</cx:pt>
          <cx:pt idx="314">KH VWD (SAP, 21 FALL)</cx:pt>
          <cx:pt idx="315">KH VWD (SAP, 21 FALL)</cx:pt>
          <cx:pt idx="316">KH VWD (SAP, 21 FALL)</cx:pt>
          <cx:pt idx="317">KH VWD (SAP, 21 FALL)</cx:pt>
          <cx:pt idx="318">KH VWD (SAP, 21 FALL)</cx:pt>
          <cx:pt idx="319">KH VWD (SAP, 21 FALL)</cx:pt>
          <cx:pt idx="320">KH VWD (SAP, 21 FALL)</cx:pt>
          <cx:pt idx="321">KH VWD (SAP, 21 FALL)</cx:pt>
          <cx:pt idx="322">KH VWD (SAP, 21 FALL)</cx:pt>
          <cx:pt idx="323">KH VWD (SAP, 21 FALL)</cx:pt>
          <cx:pt idx="324">KH VWD (SAP, 21 FALL)</cx:pt>
          <cx:pt idx="325">KH VWD (SAP, 21 FALL)</cx:pt>
          <cx:pt idx="326">KH VWD (SAP, 21 FALL)</cx:pt>
          <cx:pt idx="327">KH VWD (SAP, 21 FALL)</cx:pt>
          <cx:pt idx="328">KH VWD (SAP, 21 FALL)</cx:pt>
          <cx:pt idx="329">KH VWD (SAP, 21 FALL)</cx:pt>
          <cx:pt idx="330">KH VWD (SAP, 21 FALL)</cx:pt>
          <cx:pt idx="331">KH VWD (SAP, 21 FALL)</cx:pt>
          <cx:pt idx="332">KH VWD (SAP, 21 FALL)</cx:pt>
          <cx:pt idx="333">KH VWD (SAP, 21 FALL)</cx:pt>
          <cx:pt idx="334">KH VWD (SAP, 21 FALL)</cx:pt>
          <cx:pt idx="335">KH VWD (SAP, 21 FALL)</cx:pt>
          <cx:pt idx="336">KH VWD (SAP, 21 FALL)</cx:pt>
          <cx:pt idx="337">KH VWD (SAP, 21 FALL)</cx:pt>
          <cx:pt idx="338">KH VWD (SAP, 21 FALL)</cx:pt>
          <cx:pt idx="339">KH VWD (SAP, 21 FALL)</cx:pt>
          <cx:pt idx="340">KH VWD (SAP, 21 FALL)</cx:pt>
          <cx:pt idx="341">KH VWD (SAP, 21 FALL)</cx:pt>
          <cx:pt idx="342">KH VWD (SAP, 21 FALL)</cx:pt>
          <cx:pt idx="343">KH VWD (SAP, 21 FALL)</cx:pt>
          <cx:pt idx="344">KH VWD (SAP, 21 FALL)</cx:pt>
          <cx:pt idx="345">KH VWD (SAP, 21 FALL)</cx:pt>
          <cx:pt idx="346">KH VWD (SAP, 21 FALL)</cx:pt>
          <cx:pt idx="347">KH VWD (SAP, 21 FALL)</cx:pt>
          <cx:pt idx="348">KH VWD (SAP, 21 FALL)</cx:pt>
          <cx:pt idx="349">KH VWD (SAP, 21 FALL)</cx:pt>
          <cx:pt idx="350">KH VWD (SAP, 21 FALL)</cx:pt>
          <cx:pt idx="351">KH VWD (SAP, 21 FALL)</cx:pt>
          <cx:pt idx="352">KH VWD (SAP, 21 FALL)</cx:pt>
          <cx:pt idx="353">KH VWD (SAP, 21 FALL)</cx:pt>
          <cx:pt idx="354">KH VWD (SAP, 21 FALL)</cx:pt>
          <cx:pt idx="355">KH VWD (SAP, 21 FALL)</cx:pt>
          <cx:pt idx="356">KH VWD (SAP, 21 FALL)</cx:pt>
          <cx:pt idx="357">KH VWD (SAP, 21 FALL)</cx:pt>
          <cx:pt idx="358">KH VWD (SAP, 21 FALL)</cx:pt>
          <cx:pt idx="359">KH VWD (SAP, 21 FALL)</cx:pt>
          <cx:pt idx="360">KH VWD (SAP, 21 FALL)</cx:pt>
          <cx:pt idx="361">KH VWD (SAP, 21 FALL)</cx:pt>
          <cx:pt idx="362">KH VWD (SAP, 21 FALL)</cx:pt>
          <cx:pt idx="363">KH VWD (SAP, 21 FALL)</cx:pt>
          <cx:pt idx="364">KH VWD (SAP, 21 FALL)</cx:pt>
          <cx:pt idx="365">KH VWD (SAP, 21 FALL)</cx:pt>
          <cx:pt idx="366">KH VWD (SAP, 21 FALL)</cx:pt>
          <cx:pt idx="367">KH VWD (SAP, 21 FALL)</cx:pt>
          <cx:pt idx="368">KH VWD (SAP, 21 FALL)</cx:pt>
          <cx:pt idx="369">KH VWD (SAP, 21 FALL)</cx:pt>
          <cx:pt idx="370">KH VWD (SAP, 21 FALL)</cx:pt>
          <cx:pt idx="371">KH VWD (SAP, 21 FALL)</cx:pt>
          <cx:pt idx="372">KH VWD (SAP, 21 FALL)</cx:pt>
          <cx:pt idx="373">KH VWD (SAP, 21 FALL)</cx:pt>
          <cx:pt idx="374">KH VWD (SAP, 21 FALL)</cx:pt>
          <cx:pt idx="375">KH VWD (SAP, 21 FALL)</cx:pt>
          <cx:pt idx="376">KH VWD (SAP, 21 FALL)</cx:pt>
          <cx:pt idx="377">KH VWD (SAP, 21 FALL)</cx:pt>
          <cx:pt idx="378">KH VWD (SAP, 21 FALL)</cx:pt>
          <cx:pt idx="379">KH VWD (SAP, 21 FALL)</cx:pt>
          <cx:pt idx="380">KH VWD (SAP, 21 FALL)</cx:pt>
          <cx:pt idx="381">KH VWD (SAP, 21 FALL)</cx:pt>
          <cx:pt idx="382">KH VWD (SAP, 21 FALL)</cx:pt>
          <cx:pt idx="383">KH VWD (SAP, 21 FALL)</cx:pt>
          <cx:pt idx="384">KH VWD (SAP, 21 FALL)</cx:pt>
          <cx:pt idx="385">KH VWD (SAP, 21 FALL)</cx:pt>
          <cx:pt idx="386">KH VWD (SAP, 21 FALL)</cx:pt>
          <cx:pt idx="387">KH VWD (SAP, 21 FALL)</cx:pt>
          <cx:pt idx="388">KH VWD (SAP, 21 FALL)</cx:pt>
          <cx:pt idx="389">KH VWD (SAP, 21 FALL)</cx:pt>
          <cx:pt idx="390">KH VWD (SAP, 21 FALL)</cx:pt>
          <cx:pt idx="391">KH VWD (SAP, 21 FALL)</cx:pt>
          <cx:pt idx="392">KH VWD (SAP, 21 FALL)</cx:pt>
          <cx:pt idx="393">KH VWD (SAP, 21 FALL)</cx:pt>
          <cx:pt idx="394">KH VWD (SAP, 21 FALL)</cx:pt>
          <cx:pt idx="395">KH VWD (SAP, 21 FALL)</cx:pt>
          <cx:pt idx="396">KH VWD (SAP, 21 FALL)</cx:pt>
          <cx:pt idx="397">KH VWD (SAP, 21 FALL)</cx:pt>
          <cx:pt idx="398">KH VWD (SAP, 21 FALL)</cx:pt>
          <cx:pt idx="399">KH VWD (SAP, 21 FALL)</cx:pt>
          <cx:pt idx="400">KH VWD (SAP, 21 FALL)</cx:pt>
          <cx:pt idx="401">KH VWD (SAP, 21 FALL)</cx:pt>
          <cx:pt idx="402">KH VWD (SAP, 21 FALL)</cx:pt>
          <cx:pt idx="403">KH VWD (SAP, 21 FALL)</cx:pt>
          <cx:pt idx="404">KH VWD (SAP, 21 FALL)</cx:pt>
          <cx:pt idx="405">KH VWD (SAP, 21 FALL)</cx:pt>
          <cx:pt idx="406">KH VWD (SAP, 21 FALL)</cx:pt>
          <cx:pt idx="407">KH VWD (SAP, 21 FALL)</cx:pt>
          <cx:pt idx="408">KH VWD (SAP, 21 FALL)</cx:pt>
          <cx:pt idx="409">KH VWD (SAP, 21 FALL)</cx:pt>
          <cx:pt idx="410">KH VWD (SAP, 21 FALL)</cx:pt>
          <cx:pt idx="411">KH VWD (SAP, 21 FALL)</cx:pt>
          <cx:pt idx="412">KH VWD (SAP, 21 FALL)</cx:pt>
          <cx:pt idx="413">KH VWD (SAP, 21 FALL)</cx:pt>
          <cx:pt idx="414">KH VWD (SAP, 21 FALL)</cx:pt>
          <cx:pt idx="415">KH VWD (SAP, 21 FALL)</cx:pt>
          <cx:pt idx="416">KH VWD (SAP, 21 FALL)</cx:pt>
          <cx:pt idx="417">KH VWD (SAP, 21 FALL)</cx:pt>
          <cx:pt idx="418">KH VWD (SAP, 21 FALL)</cx:pt>
          <cx:pt idx="419">KH VWD (SAP, 21 FALL)</cx:pt>
          <cx:pt idx="420">KH VWD (SAP, 21 FALL)</cx:pt>
          <cx:pt idx="421">KH VWD (SAP, 21 FALL)</cx:pt>
          <cx:pt idx="422">KH VWD (SAP, 21 FALL)</cx:pt>
          <cx:pt idx="423">KH VWD (SAP, 21 FALL)</cx:pt>
          <cx:pt idx="424">KH VWD (SAP, 21 FALL)</cx:pt>
          <cx:pt idx="425">KH VWD (SAP, 21 FALL)</cx:pt>
          <cx:pt idx="426">KH VWD (SAP, 21 FALL)</cx:pt>
          <cx:pt idx="427">KH VWD (SAP, 21 FALL)</cx:pt>
          <cx:pt idx="428">KH VWD (SAP, 21 FALL)</cx:pt>
          <cx:pt idx="429">KH VWD (SAP, 21 FALL)</cx:pt>
          <cx:pt idx="430">KH VWD (SAP, 21 FALL)</cx:pt>
          <cx:pt idx="431">KH VWD (SAP, 21 FALL)</cx:pt>
          <cx:pt idx="432">KH VWD (SAP, 21 FALL)</cx:pt>
          <cx:pt idx="433">KH VWD (SAP, 21 FALL)</cx:pt>
          <cx:pt idx="434">KH VWD (SAP, 21 FALL)</cx:pt>
          <cx:pt idx="435">KH VWD (SAP, 21 FALL)</cx:pt>
          <cx:pt idx="436">KH VWD (SAP, 21 FALL)</cx:pt>
          <cx:pt idx="437">KH VWD (SAP, 21 FALL)</cx:pt>
          <cx:pt idx="438">KH VWD (SAP, 21 FALL)</cx:pt>
          <cx:pt idx="439">KH VWD (SAP, 21 FALL)</cx:pt>
          <cx:pt idx="440">KH VWD (SAP, 21 FALL)</cx:pt>
          <cx:pt idx="441">KH VWD (SAP, 21 FALL)</cx:pt>
          <cx:pt idx="442">KH VWD (SAP, 21 FALL)</cx:pt>
          <cx:pt idx="443">KH VWD (SAP, 21 FALL)</cx:pt>
          <cx:pt idx="444">KH VWD (SAP, 21 FALL)</cx:pt>
          <cx:pt idx="445">KH VWD (SAP, 21 FALL)</cx:pt>
          <cx:pt idx="446">KH VWD (SAP, 21 FALL)</cx:pt>
          <cx:pt idx="447">KH VWD (SAP, 21 FALL)</cx:pt>
          <cx:pt idx="448">KH VWD (SAP, 21 FALL)</cx:pt>
          <cx:pt idx="449">KH VWD (SAP, 21 FALL)</cx:pt>
          <cx:pt idx="450">KH VWD (SAP, 21 FALL)</cx:pt>
          <cx:pt idx="451">KH VWD (SAP, 21 FALL)</cx:pt>
          <cx:pt idx="452">KH VWD (SAP, 21 FALL)</cx:pt>
          <cx:pt idx="453">KH VWD (SAP, 21 FALL)</cx:pt>
          <cx:pt idx="454">KH VWD (SAP, 21 FALL)</cx:pt>
          <cx:pt idx="455">KH VWD (SAP, 21 FALL)</cx:pt>
          <cx:pt idx="456">KH VWD (SAP, 21 FALL)</cx:pt>
          <cx:pt idx="457">KH VWD (SAP, 21 FALL)</cx:pt>
          <cx:pt idx="458">KH VWD (SAP, 21 FALL)</cx:pt>
          <cx:pt idx="459">KH VWD (SAP, 21 FALL)</cx:pt>
          <cx:pt idx="460">KH VWD (SAP, 21 FALL)</cx:pt>
          <cx:pt idx="461">KH VWD (SAP, 21 FALL)</cx:pt>
          <cx:pt idx="462">KH VWD (SAP, 21 FALL)</cx:pt>
          <cx:pt idx="463">KH VWD (SAP, 21 FALL)</cx:pt>
          <cx:pt idx="464">KH VWD (SAP, 21 FALL)</cx:pt>
          <cx:pt idx="465">KH VWD (SAP, 21 FALL)</cx:pt>
          <cx:pt idx="466">KH VWD (SAP, 21 FALL)</cx:pt>
          <cx:pt idx="467">KH VWD (SAP, 21 FALL)</cx:pt>
          <cx:pt idx="468">KH VWD (SAP, 21 FALL)</cx:pt>
          <cx:pt idx="469">KH VWD (SAP, 21 FALL)</cx:pt>
          <cx:pt idx="470">KH VWD (SAP, 21 FALL)</cx:pt>
          <cx:pt idx="471">KH VWD (SAP, 21 FALL)</cx:pt>
          <cx:pt idx="472">KH VWD (SAP, 21 FALL)</cx:pt>
          <cx:pt idx="473">KH VWD (SAP, 21 FALL)</cx:pt>
          <cx:pt idx="474">KH VWD (SAP, 21 FALL)</cx:pt>
          <cx:pt idx="475">KH VWD (SAP, 21 FALL)</cx:pt>
          <cx:pt idx="476">KH VWD (SAP, 21 FALL)</cx:pt>
          <cx:pt idx="477">KH VWD (SAP, 21 FALL)</cx:pt>
          <cx:pt idx="478">KH VWD (SAP, 21 FALL)</cx:pt>
          <cx:pt idx="479">KH VWD (SAP, 21 FALL)</cx:pt>
          <cx:pt idx="480">KH VWD (SAP, 21 FALL)</cx:pt>
          <cx:pt idx="481">KH VWD (SAP, 21 FALL)</cx:pt>
          <cx:pt idx="482">KH VWD (SAP, 21 FALL)</cx:pt>
          <cx:pt idx="483">KH VWD (SAP, 21 FALL)</cx:pt>
          <cx:pt idx="484">KH VWD (SAP, 21 FALL)</cx:pt>
          <cx:pt idx="485">KH VWD (SAP, 21 FALL)</cx:pt>
          <cx:pt idx="486">KH VWD (SAP, 21 FALL)</cx:pt>
          <cx:pt idx="487">KH VWD (SAP, 21 FALL)</cx:pt>
          <cx:pt idx="488">KH VWD (SAP, 21 FALL)</cx:pt>
          <cx:pt idx="489">KH VWD (SAP, 21 FALL)</cx:pt>
          <cx:pt idx="490">KH VWD (SAP, 21 FALL)</cx:pt>
          <cx:pt idx="491">KH VWD (SAP, 21 FALL)</cx:pt>
          <cx:pt idx="492">KH VWD (SAP, 21 FALL)</cx:pt>
          <cx:pt idx="493">KH VWD (SAP, 21 FALL)</cx:pt>
          <cx:pt idx="494">KH VWD (SAP, 21 FALL)</cx:pt>
          <cx:pt idx="495">KH VWD (SAP, 21 FALL)</cx:pt>
          <cx:pt idx="496">KH VWD (SAP, 21 FALL)</cx:pt>
          <cx:pt idx="497">KH VWD (SAP, 21 FALL)</cx:pt>
          <cx:pt idx="498">KH VWD (SAP, 21 FALL)</cx:pt>
          <cx:pt idx="499">KH VWD (SAP, 21 FALL)</cx:pt>
          <cx:pt idx="500">KH VWD (SAP, 21 FALL)</cx:pt>
          <cx:pt idx="501">KH VWD (SAP, 21 FALL)</cx:pt>
          <cx:pt idx="502">KH VWD (SAP, 21 FALL)</cx:pt>
          <cx:pt idx="503">KH VWD (SAP, 21 FALL)</cx:pt>
          <cx:pt idx="504">KH VWD (SAP, 21 FALL)</cx:pt>
          <cx:pt idx="505">KH VWD (SAP, 21 FALL)</cx:pt>
          <cx:pt idx="506">KH VWD (SAP, 21 FALL)</cx:pt>
          <cx:pt idx="507">KH VWD (SAP, 21 FALL)</cx:pt>
          <cx:pt idx="508">KH VWD (SAP, 21 FALL)</cx:pt>
          <cx:pt idx="509">KH VWD (SAP, 21 FALL)</cx:pt>
          <cx:pt idx="510">KH VWD (SAP, 21 FALL)</cx:pt>
          <cx:pt idx="511">KH VWD (SAP, 21 FALL)</cx:pt>
          <cx:pt idx="512">KH VWD (SAP, 21 FALL)</cx:pt>
          <cx:pt idx="513">KH VWD (SAP, 21 FALL)</cx:pt>
          <cx:pt idx="514">KH VWD (SAP, 21 FALL)</cx:pt>
          <cx:pt idx="515">KH VWD (SAP, 21 FALL)</cx:pt>
          <cx:pt idx="516">KH VWD (SAP, 21 FALL)</cx:pt>
          <cx:pt idx="517">KH VWD (SAP, 21 FALL)</cx:pt>
          <cx:pt idx="518">KH VWD (SAP, 21 FALL)</cx:pt>
          <cx:pt idx="519">KH VWD (SAP, 21 FALL)</cx:pt>
        </cx:lvl>
      </cx:strDim>
      <cx:numDim type="val">
        <cx:lvl ptCount="520" formatCode="General">
          <cx:pt idx="0">2</cx:pt>
          <cx:pt idx="1">2</cx:pt>
          <cx:pt idx="2">2</cx:pt>
          <cx:pt idx="3">2</cx:pt>
          <cx:pt idx="4">2</cx:pt>
          <cx:pt idx="5">2</cx:pt>
          <cx:pt idx="6">2</cx:pt>
          <cx:pt idx="7">2</cx:pt>
          <cx:pt idx="8">2</cx:pt>
          <cx:pt idx="9">2</cx:pt>
          <cx:pt idx="10">2</cx:pt>
          <cx:pt idx="11">2</cx:pt>
          <cx:pt idx="12">3</cx:pt>
          <cx:pt idx="13">3</cx:pt>
          <cx:pt idx="14">3</cx:pt>
          <cx:pt idx="15">3</cx:pt>
          <cx:pt idx="16">3</cx:pt>
          <cx:pt idx="17">3</cx:pt>
          <cx:pt idx="18">3</cx:pt>
          <cx:pt idx="19">3</cx:pt>
          <cx:pt idx="20">4</cx:pt>
          <cx:pt idx="21">4</cx:pt>
          <cx:pt idx="22">4</cx:pt>
          <cx:pt idx="23">4</cx:pt>
          <cx:pt idx="24">4</cx:pt>
          <cx:pt idx="25">4</cx:pt>
          <cx:pt idx="26">4</cx:pt>
          <cx:pt idx="27">4</cx:pt>
          <cx:pt idx="28">4</cx:pt>
          <cx:pt idx="29">4</cx:pt>
          <cx:pt idx="30">4</cx:pt>
          <cx:pt idx="31">4</cx:pt>
          <cx:pt idx="32">4</cx:pt>
          <cx:pt idx="33">4</cx:pt>
          <cx:pt idx="34">4</cx:pt>
          <cx:pt idx="35">4</cx:pt>
          <cx:pt idx="36">4</cx:pt>
          <cx:pt idx="37">4</cx:pt>
          <cx:pt idx="38">4</cx:pt>
          <cx:pt idx="39">4</cx:pt>
          <cx:pt idx="40">4</cx:pt>
          <cx:pt idx="41">4</cx:pt>
          <cx:pt idx="42">4</cx:pt>
          <cx:pt idx="43">4</cx:pt>
          <cx:pt idx="44">4</cx:pt>
          <cx:pt idx="45">4</cx:pt>
          <cx:pt idx="46">4</cx:pt>
          <cx:pt idx="47">4</cx:pt>
          <cx:pt idx="48">4</cx:pt>
          <cx:pt idx="49">4</cx:pt>
          <cx:pt idx="50">4</cx:pt>
          <cx:pt idx="51">4</cx:pt>
          <cx:pt idx="52">4</cx:pt>
          <cx:pt idx="53">4</cx:pt>
          <cx:pt idx="54">5</cx:pt>
          <cx:pt idx="55">5</cx:pt>
          <cx:pt idx="56">5</cx:pt>
          <cx:pt idx="57">5</cx:pt>
          <cx:pt idx="58">5</cx:pt>
          <cx:pt idx="59">5</cx:pt>
          <cx:pt idx="60">5</cx:pt>
          <cx:pt idx="61">5</cx:pt>
          <cx:pt idx="62">5</cx:pt>
          <cx:pt idx="63">5</cx:pt>
          <cx:pt idx="64">5</cx:pt>
          <cx:pt idx="65">5</cx:pt>
          <cx:pt idx="66">5</cx:pt>
          <cx:pt idx="67">5</cx:pt>
          <cx:pt idx="68">5</cx:pt>
          <cx:pt idx="69">5</cx:pt>
          <cx:pt idx="70">5</cx:pt>
          <cx:pt idx="71">5</cx:pt>
          <cx:pt idx="72">5</cx:pt>
          <cx:pt idx="73">5</cx:pt>
          <cx:pt idx="74">5</cx:pt>
          <cx:pt idx="75">5</cx:pt>
          <cx:pt idx="76">5</cx:pt>
          <cx:pt idx="77">5</cx:pt>
          <cx:pt idx="78">5</cx:pt>
          <cx:pt idx="79">5</cx:pt>
          <cx:pt idx="80">5</cx:pt>
          <cx:pt idx="81">5</cx:pt>
          <cx:pt idx="82">5</cx:pt>
          <cx:pt idx="83">5</cx:pt>
          <cx:pt idx="84">5</cx:pt>
          <cx:pt idx="85">6</cx:pt>
          <cx:pt idx="86">6</cx:pt>
          <cx:pt idx="87">6</cx:pt>
          <cx:pt idx="88">6</cx:pt>
          <cx:pt idx="89">6</cx:pt>
          <cx:pt idx="90">6</cx:pt>
          <cx:pt idx="91">6</cx:pt>
          <cx:pt idx="92">6</cx:pt>
          <cx:pt idx="93">6</cx:pt>
          <cx:pt idx="94">6</cx:pt>
          <cx:pt idx="95">6</cx:pt>
          <cx:pt idx="96">6</cx:pt>
          <cx:pt idx="97">6</cx:pt>
          <cx:pt idx="98">6</cx:pt>
          <cx:pt idx="99">6</cx:pt>
          <cx:pt idx="100">6</cx:pt>
          <cx:pt idx="101">6</cx:pt>
          <cx:pt idx="102">6</cx:pt>
          <cx:pt idx="103">6</cx:pt>
          <cx:pt idx="104">6</cx:pt>
          <cx:pt idx="105">6</cx:pt>
          <cx:pt idx="106">6</cx:pt>
          <cx:pt idx="107">6</cx:pt>
          <cx:pt idx="108">6</cx:pt>
          <cx:pt idx="109">6</cx:pt>
          <cx:pt idx="110">6</cx:pt>
          <cx:pt idx="111">6</cx:pt>
          <cx:pt idx="112">6</cx:pt>
          <cx:pt idx="113">6</cx:pt>
          <cx:pt idx="114">6</cx:pt>
          <cx:pt idx="115">6</cx:pt>
          <cx:pt idx="116">6</cx:pt>
          <cx:pt idx="117">6</cx:pt>
          <cx:pt idx="118">6</cx:pt>
          <cx:pt idx="119">6</cx:pt>
          <cx:pt idx="120">6</cx:pt>
          <cx:pt idx="121">6</cx:pt>
          <cx:pt idx="122">6</cx:pt>
          <cx:pt idx="123">6</cx:pt>
          <cx:pt idx="124">6</cx:pt>
          <cx:pt idx="125">6</cx:pt>
          <cx:pt idx="126">6</cx:pt>
          <cx:pt idx="127">6</cx:pt>
          <cx:pt idx="128">6</cx:pt>
          <cx:pt idx="129">6</cx:pt>
          <cx:pt idx="130">6</cx:pt>
          <cx:pt idx="131">7</cx:pt>
          <cx:pt idx="132">7</cx:pt>
          <cx:pt idx="133">7</cx:pt>
          <cx:pt idx="134">7</cx:pt>
          <cx:pt idx="135">7</cx:pt>
          <cx:pt idx="136">7</cx:pt>
          <cx:pt idx="137">7</cx:pt>
          <cx:pt idx="138">7</cx:pt>
          <cx:pt idx="139">7</cx:pt>
          <cx:pt idx="140">7</cx:pt>
          <cx:pt idx="141">7</cx:pt>
          <cx:pt idx="142">7</cx:pt>
          <cx:pt idx="143">7</cx:pt>
          <cx:pt idx="144">7</cx:pt>
          <cx:pt idx="145">7</cx:pt>
          <cx:pt idx="146">7</cx:pt>
          <cx:pt idx="147">7</cx:pt>
          <cx:pt idx="148">7</cx:pt>
          <cx:pt idx="149">7</cx:pt>
          <cx:pt idx="150">7</cx:pt>
          <cx:pt idx="151">7</cx:pt>
          <cx:pt idx="152">7</cx:pt>
          <cx:pt idx="153">7</cx:pt>
          <cx:pt idx="154">7</cx:pt>
          <cx:pt idx="155">7</cx:pt>
          <cx:pt idx="156">7</cx:pt>
          <cx:pt idx="157">7</cx:pt>
          <cx:pt idx="158">7</cx:pt>
          <cx:pt idx="159">7</cx:pt>
          <cx:pt idx="160">7</cx:pt>
          <cx:pt idx="161">7</cx:pt>
          <cx:pt idx="162">7</cx:pt>
          <cx:pt idx="163">7</cx:pt>
          <cx:pt idx="164">7</cx:pt>
          <cx:pt idx="165">7</cx:pt>
          <cx:pt idx="166">7</cx:pt>
          <cx:pt idx="167">7</cx:pt>
          <cx:pt idx="168">7</cx:pt>
          <cx:pt idx="169">7</cx:pt>
          <cx:pt idx="170">7</cx:pt>
          <cx:pt idx="171">8</cx:pt>
          <cx:pt idx="172">8</cx:pt>
          <cx:pt idx="173">8</cx:pt>
          <cx:pt idx="174">8</cx:pt>
          <cx:pt idx="175">8</cx:pt>
          <cx:pt idx="176">8</cx:pt>
          <cx:pt idx="177">8</cx:pt>
          <cx:pt idx="178">8</cx:pt>
          <cx:pt idx="179">8</cx:pt>
          <cx:pt idx="180">8</cx:pt>
          <cx:pt idx="181">8</cx:pt>
          <cx:pt idx="182">8</cx:pt>
          <cx:pt idx="183">8</cx:pt>
          <cx:pt idx="184">8</cx:pt>
          <cx:pt idx="185">8</cx:pt>
          <cx:pt idx="186">8</cx:pt>
          <cx:pt idx="187">8</cx:pt>
          <cx:pt idx="188">8</cx:pt>
          <cx:pt idx="189">8</cx:pt>
          <cx:pt idx="190">8</cx:pt>
          <cx:pt idx="191">8</cx:pt>
          <cx:pt idx="192">8</cx:pt>
          <cx:pt idx="193">8</cx:pt>
          <cx:pt idx="194">8</cx:pt>
          <cx:pt idx="195">8</cx:pt>
          <cx:pt idx="196">8</cx:pt>
          <cx:pt idx="197">8</cx:pt>
          <cx:pt idx="198">8</cx:pt>
          <cx:pt idx="199">8</cx:pt>
          <cx:pt idx="200">8</cx:pt>
          <cx:pt idx="201">8</cx:pt>
          <cx:pt idx="202">8</cx:pt>
          <cx:pt idx="203">8</cx:pt>
          <cx:pt idx="204">8</cx:pt>
          <cx:pt idx="205">8</cx:pt>
          <cx:pt idx="206">8</cx:pt>
          <cx:pt idx="207">8</cx:pt>
          <cx:pt idx="208">8</cx:pt>
          <cx:pt idx="209">8</cx:pt>
          <cx:pt idx="210">8</cx:pt>
          <cx:pt idx="211">8</cx:pt>
          <cx:pt idx="212">8</cx:pt>
          <cx:pt idx="213">8</cx:pt>
          <cx:pt idx="214">8</cx:pt>
          <cx:pt idx="215">8</cx:pt>
          <cx:pt idx="216">8</cx:pt>
          <cx:pt idx="217">9</cx:pt>
          <cx:pt idx="218">9</cx:pt>
          <cx:pt idx="219">9</cx:pt>
          <cx:pt idx="220">9</cx:pt>
          <cx:pt idx="221">9</cx:pt>
          <cx:pt idx="222">9</cx:pt>
          <cx:pt idx="223">9</cx:pt>
          <cx:pt idx="224">9</cx:pt>
          <cx:pt idx="225">9</cx:pt>
          <cx:pt idx="226">9</cx:pt>
          <cx:pt idx="227">9</cx:pt>
          <cx:pt idx="228">9</cx:pt>
          <cx:pt idx="229">9</cx:pt>
          <cx:pt idx="230">9</cx:pt>
          <cx:pt idx="231">9</cx:pt>
          <cx:pt idx="232">9</cx:pt>
          <cx:pt idx="233">9</cx:pt>
          <cx:pt idx="234">9</cx:pt>
          <cx:pt idx="235">9</cx:pt>
          <cx:pt idx="236">9</cx:pt>
          <cx:pt idx="237">9</cx:pt>
          <cx:pt idx="238">9</cx:pt>
          <cx:pt idx="239">9</cx:pt>
          <cx:pt idx="240">9</cx:pt>
          <cx:pt idx="241">9</cx:pt>
          <cx:pt idx="242">9</cx:pt>
          <cx:pt idx="243">9</cx:pt>
          <cx:pt idx="244">9</cx:pt>
          <cx:pt idx="245">9</cx:pt>
          <cx:pt idx="246">9</cx:pt>
          <cx:pt idx="247">9</cx:pt>
          <cx:pt idx="248">9</cx:pt>
          <cx:pt idx="249">9</cx:pt>
          <cx:pt idx="250">9</cx:pt>
          <cx:pt idx="251">9</cx:pt>
          <cx:pt idx="252">9</cx:pt>
          <cx:pt idx="253">10</cx:pt>
          <cx:pt idx="254">10</cx:pt>
          <cx:pt idx="255">10</cx:pt>
          <cx:pt idx="256">10</cx:pt>
          <cx:pt idx="257">10</cx:pt>
          <cx:pt idx="258">10</cx:pt>
          <cx:pt idx="259">10</cx:pt>
          <cx:pt idx="260">10</cx:pt>
          <cx:pt idx="261">10</cx:pt>
          <cx:pt idx="262">10</cx:pt>
          <cx:pt idx="263">10</cx:pt>
          <cx:pt idx="264">10</cx:pt>
          <cx:pt idx="265">10</cx:pt>
          <cx:pt idx="266">10</cx:pt>
          <cx:pt idx="267">10</cx:pt>
          <cx:pt idx="268">10</cx:pt>
          <cx:pt idx="269">10</cx:pt>
          <cx:pt idx="270">10</cx:pt>
          <cx:pt idx="271">10</cx:pt>
          <cx:pt idx="272">10</cx:pt>
          <cx:pt idx="273">10</cx:pt>
          <cx:pt idx="274">10</cx:pt>
          <cx:pt idx="275">10</cx:pt>
          <cx:pt idx="276">10</cx:pt>
          <cx:pt idx="277">10</cx:pt>
          <cx:pt idx="278">10</cx:pt>
          <cx:pt idx="279">10</cx:pt>
          <cx:pt idx="280">10</cx:pt>
          <cx:pt idx="281">10</cx:pt>
          <cx:pt idx="282">10</cx:pt>
          <cx:pt idx="283">11</cx:pt>
          <cx:pt idx="284">11</cx:pt>
          <cx:pt idx="285">11</cx:pt>
          <cx:pt idx="286">11</cx:pt>
          <cx:pt idx="287">11</cx:pt>
          <cx:pt idx="288">11</cx:pt>
          <cx:pt idx="289">11</cx:pt>
          <cx:pt idx="290">11</cx:pt>
          <cx:pt idx="291">11</cx:pt>
          <cx:pt idx="292">11</cx:pt>
          <cx:pt idx="293">11</cx:pt>
          <cx:pt idx="294">11</cx:pt>
          <cx:pt idx="295">11</cx:pt>
          <cx:pt idx="296">11</cx:pt>
          <cx:pt idx="297">11</cx:pt>
          <cx:pt idx="298">11</cx:pt>
          <cx:pt idx="299">11</cx:pt>
          <cx:pt idx="300">11</cx:pt>
          <cx:pt idx="301">11</cx:pt>
          <cx:pt idx="302">11</cx:pt>
          <cx:pt idx="303">11</cx:pt>
          <cx:pt idx="304">11</cx:pt>
          <cx:pt idx="305">11</cx:pt>
          <cx:pt idx="306">11</cx:pt>
          <cx:pt idx="307">12</cx:pt>
          <cx:pt idx="308">12</cx:pt>
          <cx:pt idx="309">12</cx:pt>
          <cx:pt idx="310">12</cx:pt>
          <cx:pt idx="311">12</cx:pt>
          <cx:pt idx="312">12</cx:pt>
          <cx:pt idx="313">12</cx:pt>
          <cx:pt idx="314">12</cx:pt>
          <cx:pt idx="315">12</cx:pt>
          <cx:pt idx="316">12</cx:pt>
          <cx:pt idx="317">12</cx:pt>
          <cx:pt idx="318">12</cx:pt>
          <cx:pt idx="319">12</cx:pt>
          <cx:pt idx="320">12</cx:pt>
          <cx:pt idx="321">12</cx:pt>
          <cx:pt idx="322">12</cx:pt>
          <cx:pt idx="323">12</cx:pt>
          <cx:pt idx="324">12</cx:pt>
          <cx:pt idx="325">12</cx:pt>
          <cx:pt idx="326">12</cx:pt>
          <cx:pt idx="327">13</cx:pt>
          <cx:pt idx="328">13</cx:pt>
          <cx:pt idx="329">13</cx:pt>
          <cx:pt idx="330">13</cx:pt>
          <cx:pt idx="331">13</cx:pt>
          <cx:pt idx="332">13</cx:pt>
          <cx:pt idx="333">13</cx:pt>
          <cx:pt idx="334">13</cx:pt>
          <cx:pt idx="335">13</cx:pt>
          <cx:pt idx="336">13</cx:pt>
          <cx:pt idx="337">13</cx:pt>
          <cx:pt idx="338">13</cx:pt>
          <cx:pt idx="339">13</cx:pt>
          <cx:pt idx="340">13</cx:pt>
          <cx:pt idx="341">13</cx:pt>
          <cx:pt idx="342">13</cx:pt>
          <cx:pt idx="343">13</cx:pt>
          <cx:pt idx="344">13</cx:pt>
          <cx:pt idx="345">13</cx:pt>
          <cx:pt idx="346">13</cx:pt>
          <cx:pt idx="347">13</cx:pt>
          <cx:pt idx="348">13</cx:pt>
          <cx:pt idx="349">13</cx:pt>
          <cx:pt idx="350">13</cx:pt>
          <cx:pt idx="351">13</cx:pt>
          <cx:pt idx="352">13</cx:pt>
          <cx:pt idx="353">13</cx:pt>
          <cx:pt idx="354">13</cx:pt>
          <cx:pt idx="355">13</cx:pt>
          <cx:pt idx="356">13</cx:pt>
          <cx:pt idx="357">13</cx:pt>
          <cx:pt idx="358">13</cx:pt>
          <cx:pt idx="359">14</cx:pt>
          <cx:pt idx="360">14</cx:pt>
          <cx:pt idx="361">14</cx:pt>
          <cx:pt idx="362">14</cx:pt>
          <cx:pt idx="363">14</cx:pt>
          <cx:pt idx="364">14</cx:pt>
          <cx:pt idx="365">14</cx:pt>
          <cx:pt idx="366">14</cx:pt>
          <cx:pt idx="367">14</cx:pt>
          <cx:pt idx="368">14</cx:pt>
          <cx:pt idx="369">14</cx:pt>
          <cx:pt idx="370">14</cx:pt>
          <cx:pt idx="371">14</cx:pt>
          <cx:pt idx="372">14</cx:pt>
          <cx:pt idx="373">14</cx:pt>
          <cx:pt idx="374">14</cx:pt>
          <cx:pt idx="375">14</cx:pt>
          <cx:pt idx="376">14</cx:pt>
          <cx:pt idx="377">14</cx:pt>
          <cx:pt idx="378">14</cx:pt>
          <cx:pt idx="379">14</cx:pt>
          <cx:pt idx="380">14</cx:pt>
          <cx:pt idx="381">14</cx:pt>
          <cx:pt idx="382">14</cx:pt>
          <cx:pt idx="383">14</cx:pt>
          <cx:pt idx="384">14</cx:pt>
          <cx:pt idx="385">14</cx:pt>
          <cx:pt idx="386">14</cx:pt>
          <cx:pt idx="387">14</cx:pt>
          <cx:pt idx="388">15</cx:pt>
          <cx:pt idx="389">15</cx:pt>
          <cx:pt idx="390">15</cx:pt>
          <cx:pt idx="391">15</cx:pt>
          <cx:pt idx="392">15</cx:pt>
          <cx:pt idx="393">15</cx:pt>
          <cx:pt idx="394">15</cx:pt>
          <cx:pt idx="395">15</cx:pt>
          <cx:pt idx="396">15</cx:pt>
          <cx:pt idx="397">15</cx:pt>
          <cx:pt idx="398">15</cx:pt>
          <cx:pt idx="399">15</cx:pt>
          <cx:pt idx="400">15</cx:pt>
          <cx:pt idx="401">15</cx:pt>
          <cx:pt idx="402">15</cx:pt>
          <cx:pt idx="403">16</cx:pt>
          <cx:pt idx="404">16</cx:pt>
          <cx:pt idx="405">16</cx:pt>
          <cx:pt idx="406">16</cx:pt>
          <cx:pt idx="407">16</cx:pt>
          <cx:pt idx="408">16</cx:pt>
          <cx:pt idx="409">16</cx:pt>
          <cx:pt idx="410">16</cx:pt>
          <cx:pt idx="411">16</cx:pt>
          <cx:pt idx="412">16</cx:pt>
          <cx:pt idx="413">16</cx:pt>
          <cx:pt idx="414">16</cx:pt>
          <cx:pt idx="415">16</cx:pt>
          <cx:pt idx="416">17</cx:pt>
          <cx:pt idx="417">17</cx:pt>
          <cx:pt idx="418">17</cx:pt>
          <cx:pt idx="419">17</cx:pt>
          <cx:pt idx="420">17</cx:pt>
          <cx:pt idx="421">17</cx:pt>
          <cx:pt idx="422">17</cx:pt>
          <cx:pt idx="423">17</cx:pt>
          <cx:pt idx="424">17</cx:pt>
          <cx:pt idx="425">17</cx:pt>
          <cx:pt idx="426">17</cx:pt>
          <cx:pt idx="427">17</cx:pt>
          <cx:pt idx="428">17</cx:pt>
          <cx:pt idx="429">17</cx:pt>
          <cx:pt idx="430">18</cx:pt>
          <cx:pt idx="431">18</cx:pt>
          <cx:pt idx="432">18</cx:pt>
          <cx:pt idx="433">18</cx:pt>
          <cx:pt idx="434">18</cx:pt>
          <cx:pt idx="435">18</cx:pt>
          <cx:pt idx="436">18</cx:pt>
          <cx:pt idx="437">18</cx:pt>
          <cx:pt idx="438">18</cx:pt>
          <cx:pt idx="439">18</cx:pt>
          <cx:pt idx="440">18</cx:pt>
          <cx:pt idx="441">18</cx:pt>
          <cx:pt idx="442">18</cx:pt>
          <cx:pt idx="443">18</cx:pt>
          <cx:pt idx="444">19</cx:pt>
          <cx:pt idx="445">19</cx:pt>
          <cx:pt idx="446">19</cx:pt>
          <cx:pt idx="447">19</cx:pt>
          <cx:pt idx="448">19</cx:pt>
          <cx:pt idx="449">19</cx:pt>
          <cx:pt idx="450">19</cx:pt>
          <cx:pt idx="451">19</cx:pt>
          <cx:pt idx="452">19</cx:pt>
          <cx:pt idx="453">20</cx:pt>
          <cx:pt idx="454">20</cx:pt>
          <cx:pt idx="455">20</cx:pt>
          <cx:pt idx="456">20</cx:pt>
          <cx:pt idx="457">20</cx:pt>
          <cx:pt idx="458">20</cx:pt>
          <cx:pt idx="459">20</cx:pt>
          <cx:pt idx="460">20</cx:pt>
          <cx:pt idx="461">20</cx:pt>
          <cx:pt idx="462">20</cx:pt>
          <cx:pt idx="463">21</cx:pt>
          <cx:pt idx="464">21</cx:pt>
          <cx:pt idx="465">21</cx:pt>
          <cx:pt idx="466">21</cx:pt>
          <cx:pt idx="467">21</cx:pt>
          <cx:pt idx="468">21</cx:pt>
          <cx:pt idx="469">21</cx:pt>
          <cx:pt idx="470">22</cx:pt>
          <cx:pt idx="471">22</cx:pt>
          <cx:pt idx="472">22</cx:pt>
          <cx:pt idx="473">22</cx:pt>
          <cx:pt idx="474">22</cx:pt>
          <cx:pt idx="475">22</cx:pt>
          <cx:pt idx="476">22</cx:pt>
          <cx:pt idx="477">23</cx:pt>
          <cx:pt idx="478">23</cx:pt>
          <cx:pt idx="479">23</cx:pt>
          <cx:pt idx="480">24</cx:pt>
          <cx:pt idx="481">24</cx:pt>
          <cx:pt idx="482">24</cx:pt>
          <cx:pt idx="483">25</cx:pt>
          <cx:pt idx="484">25</cx:pt>
          <cx:pt idx="485">26</cx:pt>
          <cx:pt idx="486">26</cx:pt>
          <cx:pt idx="487">26</cx:pt>
          <cx:pt idx="488">26</cx:pt>
          <cx:pt idx="489">26</cx:pt>
          <cx:pt idx="490">27</cx:pt>
          <cx:pt idx="491">27</cx:pt>
          <cx:pt idx="492">27</cx:pt>
          <cx:pt idx="493">27</cx:pt>
          <cx:pt idx="494">27</cx:pt>
          <cx:pt idx="495">28</cx:pt>
          <cx:pt idx="496">28</cx:pt>
          <cx:pt idx="497">28</cx:pt>
          <cx:pt idx="498">29</cx:pt>
          <cx:pt idx="499">29</cx:pt>
          <cx:pt idx="500">29</cx:pt>
          <cx:pt idx="501">30</cx:pt>
          <cx:pt idx="502">30</cx:pt>
          <cx:pt idx="503">33</cx:pt>
          <cx:pt idx="504">34</cx:pt>
          <cx:pt idx="505">34</cx:pt>
          <cx:pt idx="506">35</cx:pt>
          <cx:pt idx="507">35</cx:pt>
          <cx:pt idx="508">35</cx:pt>
          <cx:pt idx="509">37</cx:pt>
          <cx:pt idx="510">39</cx:pt>
          <cx:pt idx="511">39</cx:pt>
          <cx:pt idx="512">40</cx:pt>
          <cx:pt idx="513">40</cx:pt>
          <cx:pt idx="514">44</cx:pt>
          <cx:pt idx="515">50</cx:pt>
          <cx:pt idx="516">53</cx:pt>
          <cx:pt idx="517">58</cx:pt>
          <cx:pt idx="518">62</cx:pt>
          <cx:pt idx="519">64</cx:pt>
        </cx:lvl>
      </cx:numDim>
    </cx:data>
  </cx:chartData>
  <cx:chart>
    <cx:title pos="t" align="ctr" overlay="0">
      <cx:tx>
        <cx:txData>
          <cx:v/>
        </cx:txData>
      </cx:tx>
      <cx:txPr>
        <a:bodyPr spcFirstLastPara="1" vertOverflow="ellipsis" wrap="square" lIns="0" tIns="0" rIns="0" bIns="0" anchor="ctr" anchorCtr="1"/>
        <a:lstStyle/>
        <a:p>
          <a:pPr algn="ctr">
            <a:defRPr/>
          </a:pPr>
          <a:endParaRPr/>
        </a:p>
      </cx:txPr>
    </cx:title>
    <cx:plotArea>
      <cx:plotAreaRegion>
        <cx:series layoutId="boxWhisker" uniqueId="{4182C088-BBF1-40C3-8A6B-46B290DE937D}">
          <cx:dataId val="0"/>
          <cx:layoutPr>
            <cx:visibility meanLine="0" meanMarker="1" nonoutliers="0" outliers="1"/>
            <cx:statistics quartileMethod="exclusive"/>
          </cx:layoutPr>
        </cx:series>
      </cx:plotAreaRegion>
      <cx:axis id="0">
        <cx:catScaling gapWidth="1"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tickLabels/>
      </cx:axis>
      <cx:axis id="1">
        <cx:valScaling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majorGridlines/>
        <cx:tickLabels/>
      </cx:axis>
    </cx:plotArea>
  </cx:chart>
</cx:chartSpace>
</file>

<file path=ppt/charts/chartEx3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lvl ptCount="520">
          <cx:pt idx="0">Beatmung (SAP, 21 FALL)</cx:pt>
          <cx:pt idx="1">Beatmung (SAP, 21 FALL)</cx:pt>
          <cx:pt idx="2">Beatmung (SAP, 21 FALL)</cx:pt>
          <cx:pt idx="3">Beatmung (SAP, 21 FALL)</cx:pt>
          <cx:pt idx="4">Beatmung (SAP, 21 FALL)</cx:pt>
          <cx:pt idx="5">Beatmung (SAP, 21 FALL)</cx:pt>
          <cx:pt idx="6">Beatmung (SAP, 21 FALL)</cx:pt>
          <cx:pt idx="7">Beatmung (SAP, 21 FALL)</cx:pt>
          <cx:pt idx="8">Beatmung (SAP, 21 FALL)</cx:pt>
          <cx:pt idx="9">Beatmung (SAP, 21 FALL)</cx:pt>
          <cx:pt idx="10">Beatmung (SAP, 21 FALL)</cx:pt>
          <cx:pt idx="11">Beatmung (SAP, 21 FALL)</cx:pt>
          <cx:pt idx="12">Beatmung (SAP, 21 FALL)</cx:pt>
          <cx:pt idx="13">Beatmung (SAP, 21 FALL)</cx:pt>
          <cx:pt idx="14">Beatmung (SAP, 21 FALL)</cx:pt>
          <cx:pt idx="15">Beatmung (SAP, 21 FALL)</cx:pt>
          <cx:pt idx="16">Beatmung (SAP, 21 FALL)</cx:pt>
          <cx:pt idx="17">Beatmung (SAP, 21 FALL)</cx:pt>
          <cx:pt idx="18">Beatmung (SAP, 21 FALL)</cx:pt>
          <cx:pt idx="19">Beatmung (SAP, 21 FALL)</cx:pt>
          <cx:pt idx="20">Beatmung (SAP, 21 FALL)</cx:pt>
          <cx:pt idx="21">Beatmung (SAP, 21 FALL)</cx:pt>
          <cx:pt idx="22">Beatmung (SAP, 21 FALL)</cx:pt>
          <cx:pt idx="23">Beatmung (SAP, 21 FALL)</cx:pt>
          <cx:pt idx="24">Beatmung (SAP, 21 FALL)</cx:pt>
          <cx:pt idx="25">Beatmung (SAP, 21 FALL)</cx:pt>
          <cx:pt idx="26">Beatmung (SAP, 21 FALL)</cx:pt>
          <cx:pt idx="27">Beatmung (SAP, 21 FALL)</cx:pt>
          <cx:pt idx="28">Beatmung (SAP, 21 FALL)</cx:pt>
          <cx:pt idx="29">Beatmung (SAP, 21 FALL)</cx:pt>
          <cx:pt idx="30">Beatmung (SAP, 21 FALL)</cx:pt>
          <cx:pt idx="31">Beatmung (SAP, 21 FALL)</cx:pt>
          <cx:pt idx="32">Beatmung (SAP, 21 FALL)</cx:pt>
          <cx:pt idx="33">Beatmung (SAP, 21 FALL)</cx:pt>
          <cx:pt idx="34">Beatmung (SAP, 21 FALL)</cx:pt>
          <cx:pt idx="35">Beatmung (SAP, 21 FALL)</cx:pt>
          <cx:pt idx="36">Beatmung (SAP, 21 FALL)</cx:pt>
          <cx:pt idx="37">Beatmung (SAP, 21 FALL)</cx:pt>
          <cx:pt idx="38">Beatmung (SAP, 21 FALL)</cx:pt>
          <cx:pt idx="39">Beatmung (SAP, 21 FALL)</cx:pt>
          <cx:pt idx="40">Beatmung (SAP, 21 FALL)</cx:pt>
          <cx:pt idx="41">Beatmung (SAP, 21 FALL)</cx:pt>
          <cx:pt idx="42">Beatmung (SAP, 21 FALL)</cx:pt>
          <cx:pt idx="43">Beatmung (SAP, 21 FALL)</cx:pt>
          <cx:pt idx="44">Beatmung (SAP, 21 FALL)</cx:pt>
          <cx:pt idx="45">Beatmung (SAP, 21 FALL)</cx:pt>
          <cx:pt idx="46">Beatmung (SAP, 21 FALL)</cx:pt>
          <cx:pt idx="47">Beatmung (SAP, 21 FALL)</cx:pt>
          <cx:pt idx="48">Beatmung (SAP, 21 FALL)</cx:pt>
          <cx:pt idx="49">Beatmung (SAP, 21 FALL)</cx:pt>
          <cx:pt idx="50">Beatmung (SAP, 21 FALL)</cx:pt>
          <cx:pt idx="51">Beatmung (SAP, 21 FALL)</cx:pt>
          <cx:pt idx="52">Beatmung (SAP, 21 FALL)</cx:pt>
          <cx:pt idx="53">Beatmung (SAP, 21 FALL)</cx:pt>
          <cx:pt idx="54">Beatmung (SAP, 21 FALL)</cx:pt>
          <cx:pt idx="55">Beatmung (SAP, 21 FALL)</cx:pt>
          <cx:pt idx="56">Beatmung (SAP, 21 FALL)</cx:pt>
          <cx:pt idx="57">Beatmung (SAP, 21 FALL)</cx:pt>
          <cx:pt idx="58">Beatmung (SAP, 21 FALL)</cx:pt>
          <cx:pt idx="59">Beatmung (SAP, 21 FALL)</cx:pt>
          <cx:pt idx="60">Beatmung (SAP, 21 FALL)</cx:pt>
          <cx:pt idx="61">Beatmung (SAP, 21 FALL)</cx:pt>
          <cx:pt idx="62">Beatmung (SAP, 21 FALL)</cx:pt>
          <cx:pt idx="63">Beatmung (SAP, 21 FALL)</cx:pt>
          <cx:pt idx="64">Beatmung (SAP, 21 FALL)</cx:pt>
          <cx:pt idx="65">Beatmung (SAP, 21 FALL)</cx:pt>
          <cx:pt idx="66">Beatmung (SAP, 21 FALL)</cx:pt>
          <cx:pt idx="67">Beatmung (SAP, 21 FALL)</cx:pt>
          <cx:pt idx="68">Beatmung (SAP, 21 FALL)</cx:pt>
          <cx:pt idx="69">Beatmung (SAP, 21 FALL)</cx:pt>
          <cx:pt idx="70">Beatmung (SAP, 21 FALL)</cx:pt>
          <cx:pt idx="71">Beatmung (SAP, 21 FALL)</cx:pt>
          <cx:pt idx="72">Beatmung (SAP, 21 FALL)</cx:pt>
          <cx:pt idx="73">Beatmung (SAP, 21 FALL)</cx:pt>
          <cx:pt idx="74">Beatmung (SAP, 21 FALL)</cx:pt>
          <cx:pt idx="75">Beatmung (SAP, 21 FALL)</cx:pt>
          <cx:pt idx="76">Beatmung (SAP, 21 FALL)</cx:pt>
          <cx:pt idx="77">Beatmung (SAP, 21 FALL)</cx:pt>
          <cx:pt idx="78">Beatmung (SAP, 21 FALL)</cx:pt>
          <cx:pt idx="79">Beatmung (SAP, 21 FALL)</cx:pt>
          <cx:pt idx="80">Beatmung (SAP, 21 FALL)</cx:pt>
          <cx:pt idx="81">Beatmung (SAP, 21 FALL)</cx:pt>
          <cx:pt idx="82">Beatmung (SAP, 21 FALL)</cx:pt>
          <cx:pt idx="83">Beatmung (SAP, 21 FALL)</cx:pt>
          <cx:pt idx="84">Beatmung (SAP, 21 FALL)</cx:pt>
          <cx:pt idx="85">Beatmung (SAP, 21 FALL)</cx:pt>
          <cx:pt idx="86">Beatmung (SAP, 21 FALL)</cx:pt>
          <cx:pt idx="87">Beatmung (SAP, 21 FALL)</cx:pt>
          <cx:pt idx="88">Beatmung (SAP, 21 FALL)</cx:pt>
          <cx:pt idx="89">Beatmung (SAP, 21 FALL)</cx:pt>
          <cx:pt idx="90">Beatmung (SAP, 21 FALL)</cx:pt>
          <cx:pt idx="91">Beatmung (SAP, 21 FALL)</cx:pt>
          <cx:pt idx="92">Beatmung (SAP, 21 FALL)</cx:pt>
          <cx:pt idx="93">Beatmung (SAP, 21 FALL)</cx:pt>
          <cx:pt idx="94">Beatmung (SAP, 21 FALL)</cx:pt>
          <cx:pt idx="95">Beatmung (SAP, 21 FALL)</cx:pt>
          <cx:pt idx="96">Beatmung (SAP, 21 FALL)</cx:pt>
          <cx:pt idx="97">Beatmung (SAP, 21 FALL)</cx:pt>
          <cx:pt idx="98">Beatmung (SAP, 21 FALL)</cx:pt>
          <cx:pt idx="99">Beatmung (SAP, 21 FALL)</cx:pt>
          <cx:pt idx="100">Beatmung (SAP, 21 FALL)</cx:pt>
          <cx:pt idx="101">Beatmung (SAP, 21 FALL)</cx:pt>
          <cx:pt idx="102">Beatmung (SAP, 21 FALL)</cx:pt>
          <cx:pt idx="103">Beatmung (SAP, 21 FALL)</cx:pt>
          <cx:pt idx="104">Beatmung (SAP, 21 FALL)</cx:pt>
          <cx:pt idx="105">Beatmung (SAP, 21 FALL)</cx:pt>
          <cx:pt idx="106">Beatmung (SAP, 21 FALL)</cx:pt>
          <cx:pt idx="107">Beatmung (SAP, 21 FALL)</cx:pt>
          <cx:pt idx="108">Beatmung (SAP, 21 FALL)</cx:pt>
          <cx:pt idx="109">Beatmung (SAP, 21 FALL)</cx:pt>
          <cx:pt idx="110">Beatmung (SAP, 21 FALL)</cx:pt>
          <cx:pt idx="111">Beatmung (SAP, 21 FALL)</cx:pt>
          <cx:pt idx="112">Beatmung (SAP, 21 FALL)</cx:pt>
          <cx:pt idx="113">Beatmung (SAP, 21 FALL)</cx:pt>
          <cx:pt idx="114">Beatmung (SAP, 21 FALL)</cx:pt>
          <cx:pt idx="115">Beatmung (SAP, 21 FALL)</cx:pt>
          <cx:pt idx="116">Beatmung (SAP, 21 FALL)</cx:pt>
          <cx:pt idx="117">Beatmung (SAP, 21 FALL)</cx:pt>
          <cx:pt idx="118">Beatmung (SAP, 21 FALL)</cx:pt>
          <cx:pt idx="119">Beatmung (SAP, 21 FALL)</cx:pt>
          <cx:pt idx="120">Beatmung (SAP, 21 FALL)</cx:pt>
          <cx:pt idx="121">Beatmung (SAP, 21 FALL)</cx:pt>
          <cx:pt idx="122">Beatmung (SAP, 21 FALL)</cx:pt>
          <cx:pt idx="123">Beatmung (SAP, 21 FALL)</cx:pt>
          <cx:pt idx="124">Beatmung (SAP, 21 FALL)</cx:pt>
          <cx:pt idx="125">Beatmung (SAP, 21 FALL)</cx:pt>
          <cx:pt idx="126">Beatmung (SAP, 21 FALL)</cx:pt>
          <cx:pt idx="127">Beatmung (SAP, 21 FALL)</cx:pt>
          <cx:pt idx="128">Beatmung (SAP, 21 FALL)</cx:pt>
          <cx:pt idx="129">Beatmung (SAP, 21 FALL)</cx:pt>
          <cx:pt idx="130">Beatmung (SAP, 21 FALL)</cx:pt>
          <cx:pt idx="131">Beatmung (SAP, 21 FALL)</cx:pt>
          <cx:pt idx="132">Beatmung (SAP, 21 FALL)</cx:pt>
          <cx:pt idx="133">Beatmung (SAP, 21 FALL)</cx:pt>
          <cx:pt idx="134">Beatmung (SAP, 21 FALL)</cx:pt>
          <cx:pt idx="135">Beatmung (SAP, 21 FALL)</cx:pt>
          <cx:pt idx="136">Beatmung (SAP, 21 FALL)</cx:pt>
          <cx:pt idx="137">Beatmung (SAP, 21 FALL)</cx:pt>
          <cx:pt idx="138">Beatmung (SAP, 21 FALL)</cx:pt>
          <cx:pt idx="139">Beatmung (SAP, 21 FALL)</cx:pt>
          <cx:pt idx="140">Beatmung (SAP, 21 FALL)</cx:pt>
          <cx:pt idx="141">Beatmung (SAP, 21 FALL)</cx:pt>
          <cx:pt idx="142">Beatmung (SAP, 21 FALL)</cx:pt>
          <cx:pt idx="143">Beatmung (SAP, 21 FALL)</cx:pt>
          <cx:pt idx="144">Beatmung (SAP, 21 FALL)</cx:pt>
          <cx:pt idx="145">Beatmung (SAP, 21 FALL)</cx:pt>
          <cx:pt idx="146">Beatmung (SAP, 21 FALL)</cx:pt>
          <cx:pt idx="147">Beatmung (SAP, 21 FALL)</cx:pt>
          <cx:pt idx="148">Beatmung (SAP, 21 FALL)</cx:pt>
          <cx:pt idx="149">Beatmung (SAP, 21 FALL)</cx:pt>
          <cx:pt idx="150">Beatmung (SAP, 21 FALL)</cx:pt>
          <cx:pt idx="151">Beatmung (SAP, 21 FALL)</cx:pt>
          <cx:pt idx="152">Beatmung (SAP, 21 FALL)</cx:pt>
          <cx:pt idx="153">Beatmung (SAP, 21 FALL)</cx:pt>
          <cx:pt idx="154">Beatmung (SAP, 21 FALL)</cx:pt>
          <cx:pt idx="155">Beatmung (SAP, 21 FALL)</cx:pt>
          <cx:pt idx="156">Beatmung (SAP, 21 FALL)</cx:pt>
          <cx:pt idx="157">Beatmung (SAP, 21 FALL)</cx:pt>
          <cx:pt idx="158">Beatmung (SAP, 21 FALL)</cx:pt>
          <cx:pt idx="159">Beatmung (SAP, 21 FALL)</cx:pt>
          <cx:pt idx="160">Beatmung (SAP, 21 FALL)</cx:pt>
          <cx:pt idx="161">Beatmung (SAP, 21 FALL)</cx:pt>
          <cx:pt idx="162">Beatmung (SAP, 21 FALL)</cx:pt>
          <cx:pt idx="163">Beatmung (SAP, 21 FALL)</cx:pt>
          <cx:pt idx="164">Beatmung (SAP, 21 FALL)</cx:pt>
          <cx:pt idx="165">Beatmung (SAP, 21 FALL)</cx:pt>
          <cx:pt idx="166">Beatmung (SAP, 21 FALL)</cx:pt>
          <cx:pt idx="167">Beatmung (SAP, 21 FALL)</cx:pt>
          <cx:pt idx="168">Beatmung (SAP, 21 FALL)</cx:pt>
          <cx:pt idx="169">Beatmung (SAP, 21 FALL)</cx:pt>
          <cx:pt idx="170">Beatmung (SAP, 21 FALL)</cx:pt>
          <cx:pt idx="171">Beatmung (SAP, 21 FALL)</cx:pt>
          <cx:pt idx="172">Beatmung (SAP, 21 FALL)</cx:pt>
          <cx:pt idx="173">Beatmung (SAP, 21 FALL)</cx:pt>
          <cx:pt idx="174">Beatmung (SAP, 21 FALL)</cx:pt>
          <cx:pt idx="175">Beatmung (SAP, 21 FALL)</cx:pt>
          <cx:pt idx="176">Beatmung (SAP, 21 FALL)</cx:pt>
          <cx:pt idx="177">Beatmung (SAP, 21 FALL)</cx:pt>
          <cx:pt idx="178">Beatmung (SAP, 21 FALL)</cx:pt>
          <cx:pt idx="179">Beatmung (SAP, 21 FALL)</cx:pt>
          <cx:pt idx="180">Beatmung (SAP, 21 FALL)</cx:pt>
          <cx:pt idx="181">Beatmung (SAP, 21 FALL)</cx:pt>
          <cx:pt idx="182">Beatmung (SAP, 21 FALL)</cx:pt>
          <cx:pt idx="183">Beatmung (SAP, 21 FALL)</cx:pt>
          <cx:pt idx="184">Beatmung (SAP, 21 FALL)</cx:pt>
          <cx:pt idx="185">Beatmung (SAP, 21 FALL)</cx:pt>
          <cx:pt idx="186">Beatmung (SAP, 21 FALL)</cx:pt>
          <cx:pt idx="187">Beatmung (SAP, 21 FALL)</cx:pt>
          <cx:pt idx="188">Beatmung (SAP, 21 FALL)</cx:pt>
          <cx:pt idx="189">Beatmung (SAP, 21 FALL)</cx:pt>
          <cx:pt idx="190">Beatmung (SAP, 21 FALL)</cx:pt>
          <cx:pt idx="191">Beatmung (SAP, 21 FALL)</cx:pt>
          <cx:pt idx="192">Beatmung (SAP, 21 FALL)</cx:pt>
          <cx:pt idx="193">Beatmung (SAP, 21 FALL)</cx:pt>
          <cx:pt idx="194">Beatmung (SAP, 21 FALL)</cx:pt>
          <cx:pt idx="195">Beatmung (SAP, 21 FALL)</cx:pt>
          <cx:pt idx="196">Beatmung (SAP, 21 FALL)</cx:pt>
          <cx:pt idx="197">Beatmung (SAP, 21 FALL)</cx:pt>
          <cx:pt idx="198">Beatmung (SAP, 21 FALL)</cx:pt>
          <cx:pt idx="199">Beatmung (SAP, 21 FALL)</cx:pt>
          <cx:pt idx="200">Beatmung (SAP, 21 FALL)</cx:pt>
          <cx:pt idx="201">Beatmung (SAP, 21 FALL)</cx:pt>
          <cx:pt idx="202">Beatmung (SAP, 21 FALL)</cx:pt>
          <cx:pt idx="203">Beatmung (SAP, 21 FALL)</cx:pt>
          <cx:pt idx="204">Beatmung (SAP, 21 FALL)</cx:pt>
          <cx:pt idx="205">Beatmung (SAP, 21 FALL)</cx:pt>
          <cx:pt idx="206">Beatmung (SAP, 21 FALL)</cx:pt>
          <cx:pt idx="207">Beatmung (SAP, 21 FALL)</cx:pt>
          <cx:pt idx="208">Beatmung (SAP, 21 FALL)</cx:pt>
          <cx:pt idx="209">Beatmung (SAP, 21 FALL)</cx:pt>
          <cx:pt idx="210">Beatmung (SAP, 21 FALL)</cx:pt>
          <cx:pt idx="211">Beatmung (SAP, 21 FALL)</cx:pt>
          <cx:pt idx="212">Beatmung (SAP, 21 FALL)</cx:pt>
          <cx:pt idx="213">Beatmung (SAP, 21 FALL)</cx:pt>
          <cx:pt idx="214">Beatmung (SAP, 21 FALL)</cx:pt>
          <cx:pt idx="215">Beatmung (SAP, 21 FALL)</cx:pt>
          <cx:pt idx="216">Beatmung (SAP, 21 FALL)</cx:pt>
          <cx:pt idx="217">Beatmung (SAP, 21 FALL)</cx:pt>
          <cx:pt idx="218">Beatmung (SAP, 21 FALL)</cx:pt>
          <cx:pt idx="219">Beatmung (SAP, 21 FALL)</cx:pt>
          <cx:pt idx="220">Beatmung (SAP, 21 FALL)</cx:pt>
          <cx:pt idx="221">Beatmung (SAP, 21 FALL)</cx:pt>
          <cx:pt idx="222">Beatmung (SAP, 21 FALL)</cx:pt>
          <cx:pt idx="223">Beatmung (SAP, 21 FALL)</cx:pt>
          <cx:pt idx="224">Beatmung (SAP, 21 FALL)</cx:pt>
          <cx:pt idx="225">Beatmung (SAP, 21 FALL)</cx:pt>
          <cx:pt idx="226">Beatmung (SAP, 21 FALL)</cx:pt>
          <cx:pt idx="227">Beatmung (SAP, 21 FALL)</cx:pt>
          <cx:pt idx="228">Beatmung (SAP, 21 FALL)</cx:pt>
          <cx:pt idx="229">Beatmung (SAP, 21 FALL)</cx:pt>
          <cx:pt idx="230">Beatmung (SAP, 21 FALL)</cx:pt>
          <cx:pt idx="231">Beatmung (SAP, 21 FALL)</cx:pt>
          <cx:pt idx="232">Beatmung (SAP, 21 FALL)</cx:pt>
          <cx:pt idx="233">Beatmung (SAP, 21 FALL)</cx:pt>
          <cx:pt idx="234">Beatmung (SAP, 21 FALL)</cx:pt>
          <cx:pt idx="235">Beatmung (SAP, 21 FALL)</cx:pt>
          <cx:pt idx="236">Beatmung (SAP, 21 FALL)</cx:pt>
          <cx:pt idx="237">Beatmung (SAP, 21 FALL)</cx:pt>
          <cx:pt idx="238">Beatmung (SAP, 21 FALL)</cx:pt>
          <cx:pt idx="239">Beatmung (SAP, 21 FALL)</cx:pt>
          <cx:pt idx="240">Beatmung (SAP, 21 FALL)</cx:pt>
          <cx:pt idx="241">Beatmung (SAP, 21 FALL)</cx:pt>
          <cx:pt idx="242">Beatmung (SAP, 21 FALL)</cx:pt>
          <cx:pt idx="243">Beatmung (SAP, 21 FALL)</cx:pt>
          <cx:pt idx="244">Beatmung (SAP, 21 FALL)</cx:pt>
          <cx:pt idx="245">Beatmung (SAP, 21 FALL)</cx:pt>
          <cx:pt idx="246">Beatmung (SAP, 21 FALL)</cx:pt>
          <cx:pt idx="247">Beatmung (SAP, 21 FALL)</cx:pt>
          <cx:pt idx="248">Beatmung (SAP, 21 FALL)</cx:pt>
          <cx:pt idx="249">Beatmung (SAP, 21 FALL)</cx:pt>
          <cx:pt idx="250">Beatmung (SAP, 21 FALL)</cx:pt>
          <cx:pt idx="251">Beatmung (SAP, 21 FALL)</cx:pt>
          <cx:pt idx="252">Beatmung (SAP, 21 FALL)</cx:pt>
          <cx:pt idx="253">Beatmung (SAP, 21 FALL)</cx:pt>
          <cx:pt idx="254">Beatmung (SAP, 21 FALL)</cx:pt>
          <cx:pt idx="255">Beatmung (SAP, 21 FALL)</cx:pt>
          <cx:pt idx="256">Beatmung (SAP, 21 FALL)</cx:pt>
          <cx:pt idx="257">Beatmung (SAP, 21 FALL)</cx:pt>
          <cx:pt idx="258">Beatmung (SAP, 21 FALL)</cx:pt>
          <cx:pt idx="259">Beatmung (SAP, 21 FALL)</cx:pt>
          <cx:pt idx="260">Beatmung (SAP, 21 FALL)</cx:pt>
          <cx:pt idx="261">Beatmung (SAP, 21 FALL)</cx:pt>
          <cx:pt idx="262">Beatmung (SAP, 21 FALL)</cx:pt>
          <cx:pt idx="263">Beatmung (SAP, 21 FALL)</cx:pt>
          <cx:pt idx="264">Beatmung (SAP, 21 FALL)</cx:pt>
          <cx:pt idx="265">Beatmung (SAP, 21 FALL)</cx:pt>
          <cx:pt idx="266">Beatmung (SAP, 21 FALL)</cx:pt>
          <cx:pt idx="267">Beatmung (SAP, 21 FALL)</cx:pt>
          <cx:pt idx="268">Beatmung (SAP, 21 FALL)</cx:pt>
          <cx:pt idx="269">Beatmung (SAP, 21 FALL)</cx:pt>
          <cx:pt idx="270">Beatmung (SAP, 21 FALL)</cx:pt>
          <cx:pt idx="271">Beatmung (SAP, 21 FALL)</cx:pt>
          <cx:pt idx="272">Beatmung (SAP, 21 FALL)</cx:pt>
          <cx:pt idx="273">Beatmung (SAP, 21 FALL)</cx:pt>
          <cx:pt idx="274">Beatmung (SAP, 21 FALL)</cx:pt>
          <cx:pt idx="275">Beatmung (SAP, 21 FALL)</cx:pt>
          <cx:pt idx="276">Beatmung (SAP, 21 FALL)</cx:pt>
          <cx:pt idx="277">Beatmung (SAP, 21 FALL)</cx:pt>
          <cx:pt idx="278">Beatmung (SAP, 21 FALL)</cx:pt>
          <cx:pt idx="279">Beatmung (SAP, 21 FALL)</cx:pt>
          <cx:pt idx="280">Beatmung (SAP, 21 FALL)</cx:pt>
          <cx:pt idx="281">Beatmung (SAP, 21 FALL)</cx:pt>
          <cx:pt idx="282">Beatmung (SAP, 21 FALL)</cx:pt>
          <cx:pt idx="283">Beatmung (SAP, 21 FALL)</cx:pt>
          <cx:pt idx="284">Beatmung (SAP, 21 FALL)</cx:pt>
          <cx:pt idx="285">Beatmung (SAP, 21 FALL)</cx:pt>
          <cx:pt idx="286">Beatmung (SAP, 21 FALL)</cx:pt>
          <cx:pt idx="287">Beatmung (SAP, 21 FALL)</cx:pt>
          <cx:pt idx="288">Beatmung (SAP, 21 FALL)</cx:pt>
          <cx:pt idx="289">Beatmung (SAP, 21 FALL)</cx:pt>
          <cx:pt idx="290">Beatmung (SAP, 21 FALL)</cx:pt>
          <cx:pt idx="291">Beatmung (SAP, 21 FALL)</cx:pt>
          <cx:pt idx="292">Beatmung (SAP, 21 FALL)</cx:pt>
          <cx:pt idx="293">Beatmung (SAP, 21 FALL)</cx:pt>
          <cx:pt idx="294">Beatmung (SAP, 21 FALL)</cx:pt>
          <cx:pt idx="295">Beatmung (SAP, 21 FALL)</cx:pt>
          <cx:pt idx="296">Beatmung (SAP, 21 FALL)</cx:pt>
          <cx:pt idx="297">Beatmung (SAP, 21 FALL)</cx:pt>
          <cx:pt idx="298">Beatmung (SAP, 21 FALL)</cx:pt>
          <cx:pt idx="299">Beatmung (SAP, 21 FALL)</cx:pt>
          <cx:pt idx="300">Beatmung (SAP, 21 FALL)</cx:pt>
          <cx:pt idx="301">Beatmung (SAP, 21 FALL)</cx:pt>
          <cx:pt idx="302">Beatmung (SAP, 21 FALL)</cx:pt>
          <cx:pt idx="303">Beatmung (SAP, 21 FALL)</cx:pt>
          <cx:pt idx="304">Beatmung (SAP, 21 FALL)</cx:pt>
          <cx:pt idx="305">Beatmung (SAP, 21 FALL)</cx:pt>
          <cx:pt idx="306">Beatmung (SAP, 21 FALL)</cx:pt>
          <cx:pt idx="307">Beatmung (SAP, 21 FALL)</cx:pt>
          <cx:pt idx="308">Beatmung (SAP, 21 FALL)</cx:pt>
          <cx:pt idx="309">Beatmung (SAP, 21 FALL)</cx:pt>
          <cx:pt idx="310">Beatmung (SAP, 21 FALL)</cx:pt>
          <cx:pt idx="311">Beatmung (SAP, 21 FALL)</cx:pt>
          <cx:pt idx="312">Beatmung (SAP, 21 FALL)</cx:pt>
          <cx:pt idx="313">Beatmung (SAP, 21 FALL)</cx:pt>
          <cx:pt idx="314">Beatmung (SAP, 21 FALL)</cx:pt>
          <cx:pt idx="315">Beatmung (SAP, 21 FALL)</cx:pt>
          <cx:pt idx="316">Beatmung (SAP, 21 FALL)</cx:pt>
          <cx:pt idx="317">Beatmung (SAP, 21 FALL)</cx:pt>
          <cx:pt idx="318">Beatmung (SAP, 21 FALL)</cx:pt>
          <cx:pt idx="319">Beatmung (SAP, 21 FALL)</cx:pt>
          <cx:pt idx="320">Beatmung (SAP, 21 FALL)</cx:pt>
          <cx:pt idx="321">Beatmung (SAP, 21 FALL)</cx:pt>
          <cx:pt idx="322">Beatmung (SAP, 21 FALL)</cx:pt>
          <cx:pt idx="323">Beatmung (SAP, 21 FALL)</cx:pt>
          <cx:pt idx="324">Beatmung (SAP, 21 FALL)</cx:pt>
          <cx:pt idx="325">Beatmung (SAP, 21 FALL)</cx:pt>
          <cx:pt idx="326">Beatmung (SAP, 21 FALL)</cx:pt>
          <cx:pt idx="327">Beatmung (SAP, 21 FALL)</cx:pt>
          <cx:pt idx="328">Beatmung (SAP, 21 FALL)</cx:pt>
          <cx:pt idx="329">Beatmung (SAP, 21 FALL)</cx:pt>
          <cx:pt idx="330">Beatmung (SAP, 21 FALL)</cx:pt>
          <cx:pt idx="331">Beatmung (SAP, 21 FALL)</cx:pt>
          <cx:pt idx="332">Beatmung (SAP, 21 FALL)</cx:pt>
          <cx:pt idx="333">Beatmung (SAP, 21 FALL)</cx:pt>
          <cx:pt idx="334">Beatmung (SAP, 21 FALL)</cx:pt>
          <cx:pt idx="335">Beatmung (SAP, 21 FALL)</cx:pt>
          <cx:pt idx="336">Beatmung (SAP, 21 FALL)</cx:pt>
          <cx:pt idx="337">Beatmung (SAP, 21 FALL)</cx:pt>
          <cx:pt idx="338">Beatmung (SAP, 21 FALL)</cx:pt>
          <cx:pt idx="339">Beatmung (SAP, 21 FALL)</cx:pt>
          <cx:pt idx="340">Beatmung (SAP, 21 FALL)</cx:pt>
          <cx:pt idx="341">Beatmung (SAP, 21 FALL)</cx:pt>
          <cx:pt idx="342">Beatmung (SAP, 21 FALL)</cx:pt>
          <cx:pt idx="343">Beatmung (SAP, 21 FALL)</cx:pt>
          <cx:pt idx="344">Beatmung (SAP, 21 FALL)</cx:pt>
          <cx:pt idx="345">Beatmung (SAP, 21 FALL)</cx:pt>
          <cx:pt idx="346">Beatmung (SAP, 21 FALL)</cx:pt>
          <cx:pt idx="347">Beatmung (SAP, 21 FALL)</cx:pt>
          <cx:pt idx="348">Beatmung (SAP, 21 FALL)</cx:pt>
          <cx:pt idx="349">Beatmung (SAP, 21 FALL)</cx:pt>
          <cx:pt idx="350">Beatmung (SAP, 21 FALL)</cx:pt>
          <cx:pt idx="351">Beatmung (SAP, 21 FALL)</cx:pt>
          <cx:pt idx="352">Beatmung (SAP, 21 FALL)</cx:pt>
          <cx:pt idx="353">Beatmung (SAP, 21 FALL)</cx:pt>
          <cx:pt idx="354">Beatmung (SAP, 21 FALL)</cx:pt>
          <cx:pt idx="355">Beatmung (SAP, 21 FALL)</cx:pt>
          <cx:pt idx="356">Beatmung (SAP, 21 FALL)</cx:pt>
          <cx:pt idx="357">Beatmung (SAP, 21 FALL)</cx:pt>
          <cx:pt idx="358">Beatmung (SAP, 21 FALL)</cx:pt>
          <cx:pt idx="359">Beatmung (SAP, 21 FALL)</cx:pt>
          <cx:pt idx="360">Beatmung (SAP, 21 FALL)</cx:pt>
          <cx:pt idx="361">Beatmung (SAP, 21 FALL)</cx:pt>
          <cx:pt idx="362">Beatmung (SAP, 21 FALL)</cx:pt>
          <cx:pt idx="363">Beatmung (SAP, 21 FALL)</cx:pt>
          <cx:pt idx="364">Beatmung (SAP, 21 FALL)</cx:pt>
          <cx:pt idx="365">Beatmung (SAP, 21 FALL)</cx:pt>
          <cx:pt idx="366">Beatmung (SAP, 21 FALL)</cx:pt>
          <cx:pt idx="367">Beatmung (SAP, 21 FALL)</cx:pt>
          <cx:pt idx="368">Beatmung (SAP, 21 FALL)</cx:pt>
          <cx:pt idx="369">Beatmung (SAP, 21 FALL)</cx:pt>
          <cx:pt idx="370">Beatmung (SAP, 21 FALL)</cx:pt>
          <cx:pt idx="371">Beatmung (SAP, 21 FALL)</cx:pt>
          <cx:pt idx="372">Beatmung (SAP, 21 FALL)</cx:pt>
          <cx:pt idx="373">Beatmung (SAP, 21 FALL)</cx:pt>
          <cx:pt idx="374">Beatmung (SAP, 21 FALL)</cx:pt>
          <cx:pt idx="375">Beatmung (SAP, 21 FALL)</cx:pt>
          <cx:pt idx="376">Beatmung (SAP, 21 FALL)</cx:pt>
          <cx:pt idx="377">Beatmung (SAP, 21 FALL)</cx:pt>
          <cx:pt idx="378">Beatmung (SAP, 21 FALL)</cx:pt>
          <cx:pt idx="379">Beatmung (SAP, 21 FALL)</cx:pt>
          <cx:pt idx="380">Beatmung (SAP, 21 FALL)</cx:pt>
          <cx:pt idx="381">Beatmung (SAP, 21 FALL)</cx:pt>
          <cx:pt idx="382">Beatmung (SAP, 21 FALL)</cx:pt>
          <cx:pt idx="383">Beatmung (SAP, 21 FALL)</cx:pt>
          <cx:pt idx="384">Beatmung (SAP, 21 FALL)</cx:pt>
          <cx:pt idx="385">Beatmung (SAP, 21 FALL)</cx:pt>
          <cx:pt idx="386">Beatmung (SAP, 21 FALL)</cx:pt>
          <cx:pt idx="387">Beatmung (SAP, 21 FALL)</cx:pt>
          <cx:pt idx="388">Beatmung (SAP, 21 FALL)</cx:pt>
          <cx:pt idx="389">Beatmung (SAP, 21 FALL)</cx:pt>
          <cx:pt idx="390">Beatmung (SAP, 21 FALL)</cx:pt>
          <cx:pt idx="391">Beatmung (SAP, 21 FALL)</cx:pt>
          <cx:pt idx="392">Beatmung (SAP, 21 FALL)</cx:pt>
          <cx:pt idx="393">Beatmung (SAP, 21 FALL)</cx:pt>
          <cx:pt idx="394">Beatmung (SAP, 21 FALL)</cx:pt>
          <cx:pt idx="395">Beatmung (SAP, 21 FALL)</cx:pt>
          <cx:pt idx="396">Beatmung (SAP, 21 FALL)</cx:pt>
          <cx:pt idx="397">Beatmung (SAP, 21 FALL)</cx:pt>
          <cx:pt idx="398">Beatmung (SAP, 21 FALL)</cx:pt>
          <cx:pt idx="399">Beatmung (SAP, 21 FALL)</cx:pt>
          <cx:pt idx="400">Beatmung (SAP, 21 FALL)</cx:pt>
          <cx:pt idx="401">Beatmung (SAP, 21 FALL)</cx:pt>
          <cx:pt idx="402">Beatmung (SAP, 21 FALL)</cx:pt>
          <cx:pt idx="403">Beatmung (SAP, 21 FALL)</cx:pt>
          <cx:pt idx="404">Beatmung (SAP, 21 FALL)</cx:pt>
          <cx:pt idx="405">Beatmung (SAP, 21 FALL)</cx:pt>
          <cx:pt idx="406">Beatmung (SAP, 21 FALL)</cx:pt>
          <cx:pt idx="407">Beatmung (SAP, 21 FALL)</cx:pt>
          <cx:pt idx="408">Beatmung (SAP, 21 FALL)</cx:pt>
          <cx:pt idx="409">Beatmung (SAP, 21 FALL)</cx:pt>
          <cx:pt idx="410">Beatmung (SAP, 21 FALL)</cx:pt>
          <cx:pt idx="411">Beatmung (SAP, 21 FALL)</cx:pt>
          <cx:pt idx="412">Beatmung (SAP, 21 FALL)</cx:pt>
          <cx:pt idx="413">Beatmung (SAP, 21 FALL)</cx:pt>
          <cx:pt idx="414">Beatmung (SAP, 21 FALL)</cx:pt>
          <cx:pt idx="415">Beatmung (SAP, 21 FALL)</cx:pt>
          <cx:pt idx="416">Beatmung (SAP, 21 FALL)</cx:pt>
          <cx:pt idx="417">Beatmung (SAP, 21 FALL)</cx:pt>
          <cx:pt idx="418">Beatmung (SAP, 21 FALL)</cx:pt>
          <cx:pt idx="419">Beatmung (SAP, 21 FALL)</cx:pt>
          <cx:pt idx="420">Beatmung (SAP, 21 FALL)</cx:pt>
          <cx:pt idx="421">Beatmung (SAP, 21 FALL)</cx:pt>
          <cx:pt idx="422">Beatmung (SAP, 21 FALL)</cx:pt>
          <cx:pt idx="423">Beatmung (SAP, 21 FALL)</cx:pt>
          <cx:pt idx="424">Beatmung (SAP, 21 FALL)</cx:pt>
          <cx:pt idx="425">Beatmung (SAP, 21 FALL)</cx:pt>
          <cx:pt idx="426">Beatmung (SAP, 21 FALL)</cx:pt>
          <cx:pt idx="427">Beatmung (SAP, 21 FALL)</cx:pt>
          <cx:pt idx="428">Beatmung (SAP, 21 FALL)</cx:pt>
          <cx:pt idx="429">Beatmung (SAP, 21 FALL)</cx:pt>
          <cx:pt idx="430">Beatmung (SAP, 21 FALL)</cx:pt>
          <cx:pt idx="431">Beatmung (SAP, 21 FALL)</cx:pt>
          <cx:pt idx="432">Beatmung (SAP, 21 FALL)</cx:pt>
          <cx:pt idx="433">Beatmung (SAP, 21 FALL)</cx:pt>
          <cx:pt idx="434">Beatmung (SAP, 21 FALL)</cx:pt>
          <cx:pt idx="435">Beatmung (SAP, 21 FALL)</cx:pt>
          <cx:pt idx="436">Beatmung (SAP, 21 FALL)</cx:pt>
          <cx:pt idx="437">Beatmung (SAP, 21 FALL)</cx:pt>
          <cx:pt idx="438">Beatmung (SAP, 21 FALL)</cx:pt>
          <cx:pt idx="439">Beatmung (SAP, 21 FALL)</cx:pt>
          <cx:pt idx="440">Beatmung (SAP, 21 FALL)</cx:pt>
          <cx:pt idx="441">Beatmung (SAP, 21 FALL)</cx:pt>
          <cx:pt idx="442">Beatmung (SAP, 21 FALL)</cx:pt>
          <cx:pt idx="443">Beatmung (SAP, 21 FALL)</cx:pt>
          <cx:pt idx="444">Beatmung (SAP, 21 FALL)</cx:pt>
          <cx:pt idx="445">Beatmung (SAP, 21 FALL)</cx:pt>
          <cx:pt idx="446">Beatmung (SAP, 21 FALL)</cx:pt>
          <cx:pt idx="447">Beatmung (SAP, 21 FALL)</cx:pt>
          <cx:pt idx="448">Beatmung (SAP, 21 FALL)</cx:pt>
          <cx:pt idx="449">Beatmung (SAP, 21 FALL)</cx:pt>
          <cx:pt idx="450">Beatmung (SAP, 21 FALL)</cx:pt>
          <cx:pt idx="451">Beatmung (SAP, 21 FALL)</cx:pt>
          <cx:pt idx="452">Beatmung (SAP, 21 FALL)</cx:pt>
          <cx:pt idx="453">Beatmung (SAP, 21 FALL)</cx:pt>
          <cx:pt idx="454">Beatmung (SAP, 21 FALL)</cx:pt>
          <cx:pt idx="455">Beatmung (SAP, 21 FALL)</cx:pt>
          <cx:pt idx="456">Beatmung (SAP, 21 FALL)</cx:pt>
          <cx:pt idx="457">Beatmung (SAP, 21 FALL)</cx:pt>
          <cx:pt idx="458">Beatmung (SAP, 21 FALL)</cx:pt>
          <cx:pt idx="459">Beatmung (SAP, 21 FALL)</cx:pt>
          <cx:pt idx="460">Beatmung (SAP, 21 FALL)</cx:pt>
          <cx:pt idx="461">Beatmung (SAP, 21 FALL)</cx:pt>
          <cx:pt idx="462">Beatmung (SAP, 21 FALL)</cx:pt>
          <cx:pt idx="463">Beatmung (SAP, 21 FALL)</cx:pt>
          <cx:pt idx="464">Beatmung (SAP, 21 FALL)</cx:pt>
          <cx:pt idx="465">Beatmung (SAP, 21 FALL)</cx:pt>
          <cx:pt idx="466">Beatmung (SAP, 21 FALL)</cx:pt>
          <cx:pt idx="467">Beatmung (SAP, 21 FALL)</cx:pt>
          <cx:pt idx="468">Beatmung (SAP, 21 FALL)</cx:pt>
          <cx:pt idx="469">Beatmung (SAP, 21 FALL)</cx:pt>
          <cx:pt idx="470">Beatmung (SAP, 21 FALL)</cx:pt>
          <cx:pt idx="471">Beatmung (SAP, 21 FALL)</cx:pt>
          <cx:pt idx="472">Beatmung (SAP, 21 FALL)</cx:pt>
          <cx:pt idx="473">Beatmung (SAP, 21 FALL)</cx:pt>
          <cx:pt idx="474">Beatmung (SAP, 21 FALL)</cx:pt>
          <cx:pt idx="475">Beatmung (SAP, 21 FALL)</cx:pt>
          <cx:pt idx="476">Beatmung (SAP, 21 FALL)</cx:pt>
          <cx:pt idx="477">Beatmung (SAP, 21 FALL)</cx:pt>
          <cx:pt idx="478">Beatmung (SAP, 21 FALL)</cx:pt>
          <cx:pt idx="479">Beatmung (SAP, 21 FALL)</cx:pt>
          <cx:pt idx="480">Beatmung (SAP, 21 FALL)</cx:pt>
          <cx:pt idx="481">Beatmung (SAP, 21 FALL)</cx:pt>
          <cx:pt idx="482">Beatmung (SAP, 21 FALL)</cx:pt>
          <cx:pt idx="483">Beatmung (SAP, 21 FALL)</cx:pt>
          <cx:pt idx="484">Beatmung (SAP, 21 FALL)</cx:pt>
          <cx:pt idx="485">Beatmung (SAP, 21 FALL)</cx:pt>
          <cx:pt idx="486">Beatmung (SAP, 21 FALL)</cx:pt>
          <cx:pt idx="487">Beatmung (SAP, 21 FALL)</cx:pt>
          <cx:pt idx="488">Beatmung (SAP, 21 FALL)</cx:pt>
          <cx:pt idx="489">Beatmung (SAP, 21 FALL)</cx:pt>
          <cx:pt idx="490">Beatmung (SAP, 21 FALL)</cx:pt>
          <cx:pt idx="491">Beatmung (SAP, 21 FALL)</cx:pt>
          <cx:pt idx="492">Beatmung (SAP, 21 FALL)</cx:pt>
          <cx:pt idx="493">Beatmung (SAP, 21 FALL)</cx:pt>
          <cx:pt idx="494">Beatmung (SAP, 21 FALL)</cx:pt>
          <cx:pt idx="495">Beatmung (SAP, 21 FALL)</cx:pt>
          <cx:pt idx="496">Beatmung (SAP, 21 FALL)</cx:pt>
          <cx:pt idx="497">Beatmung (SAP, 21 FALL)</cx:pt>
          <cx:pt idx="498">Beatmung (SAP, 21 FALL)</cx:pt>
          <cx:pt idx="499">Beatmung (SAP, 21 FALL)</cx:pt>
          <cx:pt idx="500">Beatmung (SAP, 21 FALL)</cx:pt>
          <cx:pt idx="501">Beatmung (SAP, 21 FALL)</cx:pt>
          <cx:pt idx="502">Beatmung (SAP, 21 FALL)</cx:pt>
          <cx:pt idx="503">Beatmung (SAP, 21 FALL)</cx:pt>
          <cx:pt idx="504">Beatmung (SAP, 21 FALL)</cx:pt>
          <cx:pt idx="505">Beatmung (SAP, 21 FALL)</cx:pt>
          <cx:pt idx="506">Beatmung (SAP, 21 FALL)</cx:pt>
          <cx:pt idx="507">Beatmung (SAP, 21 FALL)</cx:pt>
          <cx:pt idx="508">Beatmung (SAP, 21 FALL)</cx:pt>
          <cx:pt idx="509">Beatmung (SAP, 21 FALL)</cx:pt>
          <cx:pt idx="510">Beatmung (SAP, 21 FALL)</cx:pt>
          <cx:pt idx="511">Beatmung (SAP, 21 FALL)</cx:pt>
          <cx:pt idx="512">Beatmung (SAP, 21 FALL)</cx:pt>
          <cx:pt idx="513">Beatmung (SAP, 21 FALL)</cx:pt>
          <cx:pt idx="514">Beatmung (SAP, 21 FALL)</cx:pt>
          <cx:pt idx="515">Beatmung (SAP, 21 FALL)</cx:pt>
          <cx:pt idx="516">Beatmung (SAP, 21 FALL)</cx:pt>
          <cx:pt idx="517">Beatmung (SAP, 21 FALL)</cx:pt>
          <cx:pt idx="518">Beatmung (SAP, 21 FALL)</cx:pt>
          <cx:pt idx="519">Beatmung (SAP, 21 FALL)</cx:pt>
        </cx:lvl>
      </cx:strDim>
      <cx:numDim type="val">
        <cx:lvl ptCount="520" formatCode="General">
          <cx:pt idx="0">0</cx:pt>
          <cx:pt idx="1">0</cx:pt>
          <cx:pt idx="2">0</cx:pt>
          <cx:pt idx="3">0</cx:pt>
          <cx:pt idx="4">0</cx:pt>
          <cx:pt idx="5">0</cx:pt>
          <cx:pt idx="6">0</cx:pt>
          <cx:pt idx="7">0</cx:pt>
          <cx:pt idx="8">0</cx:pt>
          <cx:pt idx="9">0</cx:pt>
          <cx:pt idx="10">0</cx:pt>
          <cx:pt idx="11">0</cx:pt>
          <cx:pt idx="12">0</cx:pt>
          <cx:pt idx="13">0</cx:pt>
          <cx:pt idx="14">0</cx:pt>
          <cx:pt idx="15">0</cx:pt>
          <cx:pt idx="16">0</cx:pt>
          <cx:pt idx="17">0</cx:pt>
          <cx:pt idx="18">0</cx:pt>
          <cx:pt idx="19">0</cx:pt>
          <cx:pt idx="20">0</cx:pt>
          <cx:pt idx="21">0</cx:pt>
          <cx:pt idx="22">0</cx:pt>
          <cx:pt idx="23">0</cx:pt>
          <cx:pt idx="24">0</cx:pt>
          <cx:pt idx="25">0</cx:pt>
          <cx:pt idx="26">0</cx:pt>
          <cx:pt idx="27">0</cx:pt>
          <cx:pt idx="28">0</cx:pt>
          <cx:pt idx="29">0</cx:pt>
          <cx:pt idx="30">0</cx:pt>
          <cx:pt idx="31">0</cx:pt>
          <cx:pt idx="32">0</cx:pt>
          <cx:pt idx="33">0</cx:pt>
          <cx:pt idx="34">0</cx:pt>
          <cx:pt idx="35">0</cx:pt>
          <cx:pt idx="36">0</cx:pt>
          <cx:pt idx="37">0</cx:pt>
          <cx:pt idx="38">0</cx:pt>
          <cx:pt idx="39">0</cx:pt>
          <cx:pt idx="40">0</cx:pt>
          <cx:pt idx="41">0</cx:pt>
          <cx:pt idx="42">0</cx:pt>
          <cx:pt idx="43">0</cx:pt>
          <cx:pt idx="44">0</cx:pt>
          <cx:pt idx="45">0</cx:pt>
          <cx:pt idx="46">0</cx:pt>
          <cx:pt idx="47">0</cx:pt>
          <cx:pt idx="48">0</cx:pt>
          <cx:pt idx="49">0</cx:pt>
          <cx:pt idx="50">0</cx:pt>
          <cx:pt idx="51">0</cx:pt>
          <cx:pt idx="52">0</cx:pt>
          <cx:pt idx="53">0</cx:pt>
          <cx:pt idx="54">0</cx:pt>
          <cx:pt idx="55">0</cx:pt>
          <cx:pt idx="56">0</cx:pt>
          <cx:pt idx="57">0</cx:pt>
          <cx:pt idx="58">0</cx:pt>
          <cx:pt idx="59">0</cx:pt>
          <cx:pt idx="60">0</cx:pt>
          <cx:pt idx="61">0</cx:pt>
          <cx:pt idx="62">0</cx:pt>
          <cx:pt idx="63">0</cx:pt>
          <cx:pt idx="64">0</cx:pt>
          <cx:pt idx="65">0</cx:pt>
          <cx:pt idx="66">0</cx:pt>
          <cx:pt idx="67">0</cx:pt>
          <cx:pt idx="68">0</cx:pt>
          <cx:pt idx="69">0</cx:pt>
          <cx:pt idx="70">0</cx:pt>
          <cx:pt idx="71">0</cx:pt>
          <cx:pt idx="72">0</cx:pt>
          <cx:pt idx="73">0</cx:pt>
          <cx:pt idx="74">0</cx:pt>
          <cx:pt idx="75">0</cx:pt>
          <cx:pt idx="76">0</cx:pt>
          <cx:pt idx="77">0</cx:pt>
          <cx:pt idx="78">0</cx:pt>
          <cx:pt idx="79">0</cx:pt>
          <cx:pt idx="80">0</cx:pt>
          <cx:pt idx="81">0</cx:pt>
          <cx:pt idx="82">0</cx:pt>
          <cx:pt idx="83">0</cx:pt>
          <cx:pt idx="84">0</cx:pt>
          <cx:pt idx="85">0</cx:pt>
          <cx:pt idx="86">0</cx:pt>
          <cx:pt idx="87">0</cx:pt>
          <cx:pt idx="88">0</cx:pt>
          <cx:pt idx="89">0</cx:pt>
          <cx:pt idx="90">0</cx:pt>
          <cx:pt idx="91">0</cx:pt>
          <cx:pt idx="92">0</cx:pt>
          <cx:pt idx="93">0</cx:pt>
          <cx:pt idx="94">0</cx:pt>
          <cx:pt idx="95">0</cx:pt>
          <cx:pt idx="96">0</cx:pt>
          <cx:pt idx="97">0</cx:pt>
          <cx:pt idx="98">0</cx:pt>
          <cx:pt idx="99">0</cx:pt>
          <cx:pt idx="100">0</cx:pt>
          <cx:pt idx="101">0</cx:pt>
          <cx:pt idx="102">0</cx:pt>
          <cx:pt idx="103">0</cx:pt>
          <cx:pt idx="104">0</cx:pt>
          <cx:pt idx="105">0</cx:pt>
          <cx:pt idx="106">0</cx:pt>
          <cx:pt idx="107">0</cx:pt>
          <cx:pt idx="108">0</cx:pt>
          <cx:pt idx="109">0</cx:pt>
          <cx:pt idx="110">0</cx:pt>
          <cx:pt idx="111">0</cx:pt>
          <cx:pt idx="112">0</cx:pt>
          <cx:pt idx="113">0</cx:pt>
          <cx:pt idx="114">0</cx:pt>
          <cx:pt idx="115">0</cx:pt>
          <cx:pt idx="116">0</cx:pt>
          <cx:pt idx="117">0</cx:pt>
          <cx:pt idx="118">0</cx:pt>
          <cx:pt idx="119">0</cx:pt>
          <cx:pt idx="120">0</cx:pt>
          <cx:pt idx="121">0</cx:pt>
          <cx:pt idx="122">0</cx:pt>
          <cx:pt idx="123">0</cx:pt>
          <cx:pt idx="124">0</cx:pt>
          <cx:pt idx="125">0</cx:pt>
          <cx:pt idx="126">0</cx:pt>
          <cx:pt idx="127">0</cx:pt>
          <cx:pt idx="128">0</cx:pt>
          <cx:pt idx="129">0</cx:pt>
          <cx:pt idx="130">0</cx:pt>
          <cx:pt idx="131">0</cx:pt>
          <cx:pt idx="132">0</cx:pt>
          <cx:pt idx="133">0</cx:pt>
          <cx:pt idx="134">0</cx:pt>
          <cx:pt idx="135">0</cx:pt>
          <cx:pt idx="136">0</cx:pt>
          <cx:pt idx="137">0</cx:pt>
          <cx:pt idx="138">0</cx:pt>
          <cx:pt idx="139">0</cx:pt>
          <cx:pt idx="140">0</cx:pt>
          <cx:pt idx="141">0</cx:pt>
          <cx:pt idx="142">0</cx:pt>
          <cx:pt idx="143">0</cx:pt>
          <cx:pt idx="144">0</cx:pt>
          <cx:pt idx="145">0</cx:pt>
          <cx:pt idx="146">0</cx:pt>
          <cx:pt idx="147">0</cx:pt>
          <cx:pt idx="148">0</cx:pt>
          <cx:pt idx="149">0</cx:pt>
          <cx:pt idx="150">0</cx:pt>
          <cx:pt idx="151">0</cx:pt>
          <cx:pt idx="152">0</cx:pt>
          <cx:pt idx="153">0</cx:pt>
          <cx:pt idx="154">0</cx:pt>
          <cx:pt idx="155">0</cx:pt>
          <cx:pt idx="156">0</cx:pt>
          <cx:pt idx="157">0</cx:pt>
          <cx:pt idx="158">0</cx:pt>
          <cx:pt idx="159">0</cx:pt>
          <cx:pt idx="160">0</cx:pt>
          <cx:pt idx="161">0</cx:pt>
          <cx:pt idx="162">0</cx:pt>
          <cx:pt idx="163">0</cx:pt>
          <cx:pt idx="164">0</cx:pt>
          <cx:pt idx="165">0</cx:pt>
          <cx:pt idx="166">0</cx:pt>
          <cx:pt idx="167">0</cx:pt>
          <cx:pt idx="168">0</cx:pt>
          <cx:pt idx="169">0</cx:pt>
          <cx:pt idx="170">0</cx:pt>
          <cx:pt idx="171">0</cx:pt>
          <cx:pt idx="172">0</cx:pt>
          <cx:pt idx="173">0</cx:pt>
          <cx:pt idx="174">0</cx:pt>
          <cx:pt idx="175">0</cx:pt>
          <cx:pt idx="176">0</cx:pt>
          <cx:pt idx="177">0</cx:pt>
          <cx:pt idx="178">0</cx:pt>
          <cx:pt idx="179">0</cx:pt>
          <cx:pt idx="180">0</cx:pt>
          <cx:pt idx="181">0</cx:pt>
          <cx:pt idx="182">0</cx:pt>
          <cx:pt idx="183">0</cx:pt>
          <cx:pt idx="184">0</cx:pt>
          <cx:pt idx="185">0</cx:pt>
          <cx:pt idx="186">0</cx:pt>
          <cx:pt idx="187">0</cx:pt>
          <cx:pt idx="188">0</cx:pt>
          <cx:pt idx="189">0</cx:pt>
          <cx:pt idx="190">0</cx:pt>
          <cx:pt idx="191">0</cx:pt>
          <cx:pt idx="192">0</cx:pt>
          <cx:pt idx="193">0</cx:pt>
          <cx:pt idx="194">0</cx:pt>
          <cx:pt idx="195">0</cx:pt>
          <cx:pt idx="196">0</cx:pt>
          <cx:pt idx="197">0</cx:pt>
          <cx:pt idx="198">0</cx:pt>
          <cx:pt idx="199">0</cx:pt>
          <cx:pt idx="200">0</cx:pt>
          <cx:pt idx="201">0</cx:pt>
          <cx:pt idx="202">0</cx:pt>
          <cx:pt idx="203">0</cx:pt>
          <cx:pt idx="204">0</cx:pt>
          <cx:pt idx="205">0</cx:pt>
          <cx:pt idx="206">0</cx:pt>
          <cx:pt idx="207">0</cx:pt>
          <cx:pt idx="208">0</cx:pt>
          <cx:pt idx="209">0</cx:pt>
          <cx:pt idx="210">0</cx:pt>
          <cx:pt idx="211">0</cx:pt>
          <cx:pt idx="212">0</cx:pt>
          <cx:pt idx="213">0</cx:pt>
          <cx:pt idx="214">0</cx:pt>
          <cx:pt idx="215">0</cx:pt>
          <cx:pt idx="216">0</cx:pt>
          <cx:pt idx="217">0</cx:pt>
          <cx:pt idx="218">0</cx:pt>
          <cx:pt idx="219">0</cx:pt>
          <cx:pt idx="220">0</cx:pt>
          <cx:pt idx="221">0</cx:pt>
          <cx:pt idx="222">0</cx:pt>
          <cx:pt idx="223">0</cx:pt>
          <cx:pt idx="224">0</cx:pt>
          <cx:pt idx="225">0</cx:pt>
          <cx:pt idx="226">0</cx:pt>
          <cx:pt idx="227">0</cx:pt>
          <cx:pt idx="228">0</cx:pt>
          <cx:pt idx="229">0</cx:pt>
          <cx:pt idx="230">0</cx:pt>
          <cx:pt idx="231">0</cx:pt>
          <cx:pt idx="232">0</cx:pt>
          <cx:pt idx="233">0</cx:pt>
          <cx:pt idx="234">0</cx:pt>
          <cx:pt idx="235">0</cx:pt>
          <cx:pt idx="236">0</cx:pt>
          <cx:pt idx="237">0</cx:pt>
          <cx:pt idx="238">0</cx:pt>
          <cx:pt idx="239">0</cx:pt>
          <cx:pt idx="240">0</cx:pt>
          <cx:pt idx="241">0</cx:pt>
          <cx:pt idx="242">0</cx:pt>
          <cx:pt idx="243">0</cx:pt>
          <cx:pt idx="244">0</cx:pt>
          <cx:pt idx="245">0</cx:pt>
          <cx:pt idx="246">0</cx:pt>
          <cx:pt idx="247">0</cx:pt>
          <cx:pt idx="248">0</cx:pt>
          <cx:pt idx="249">0</cx:pt>
          <cx:pt idx="250">0</cx:pt>
          <cx:pt idx="251">0</cx:pt>
          <cx:pt idx="252">0</cx:pt>
          <cx:pt idx="253">0</cx:pt>
          <cx:pt idx="254">0</cx:pt>
          <cx:pt idx="255">0</cx:pt>
          <cx:pt idx="256">0</cx:pt>
          <cx:pt idx="257">0</cx:pt>
          <cx:pt idx="258">0</cx:pt>
          <cx:pt idx="259">0</cx:pt>
          <cx:pt idx="260">0</cx:pt>
          <cx:pt idx="261">0</cx:pt>
          <cx:pt idx="262">0</cx:pt>
          <cx:pt idx="263">0</cx:pt>
          <cx:pt idx="264">0</cx:pt>
          <cx:pt idx="265">0</cx:pt>
          <cx:pt idx="266">0</cx:pt>
          <cx:pt idx="267">0</cx:pt>
          <cx:pt idx="268">0</cx:pt>
          <cx:pt idx="269">0</cx:pt>
          <cx:pt idx="270">0</cx:pt>
          <cx:pt idx="271">0</cx:pt>
          <cx:pt idx="272">0</cx:pt>
          <cx:pt idx="273">0</cx:pt>
          <cx:pt idx="274">0</cx:pt>
          <cx:pt idx="275">0</cx:pt>
          <cx:pt idx="276">0</cx:pt>
          <cx:pt idx="277">0</cx:pt>
          <cx:pt idx="278">0</cx:pt>
          <cx:pt idx="279">1</cx:pt>
          <cx:pt idx="280">1</cx:pt>
          <cx:pt idx="281">1</cx:pt>
          <cx:pt idx="282">1</cx:pt>
          <cx:pt idx="283">1</cx:pt>
          <cx:pt idx="284">4</cx:pt>
          <cx:pt idx="285">5</cx:pt>
          <cx:pt idx="286">5</cx:pt>
          <cx:pt idx="287">6</cx:pt>
          <cx:pt idx="288">7</cx:pt>
          <cx:pt idx="289">7</cx:pt>
          <cx:pt idx="290">7</cx:pt>
          <cx:pt idx="291">7</cx:pt>
          <cx:pt idx="292">7</cx:pt>
          <cx:pt idx="293">7</cx:pt>
          <cx:pt idx="294">7</cx:pt>
          <cx:pt idx="295">10</cx:pt>
          <cx:pt idx="296">11</cx:pt>
          <cx:pt idx="297">13</cx:pt>
          <cx:pt idx="298">15</cx:pt>
          <cx:pt idx="299">15</cx:pt>
          <cx:pt idx="300">15</cx:pt>
          <cx:pt idx="301">16</cx:pt>
          <cx:pt idx="302">16</cx:pt>
          <cx:pt idx="303">20</cx:pt>
          <cx:pt idx="304">21</cx:pt>
          <cx:pt idx="305">21</cx:pt>
          <cx:pt idx="306">21</cx:pt>
          <cx:pt idx="307">23</cx:pt>
          <cx:pt idx="308">24</cx:pt>
          <cx:pt idx="309">24</cx:pt>
          <cx:pt idx="310">24</cx:pt>
          <cx:pt idx="311">24</cx:pt>
          <cx:pt idx="312">25</cx:pt>
          <cx:pt idx="313">25</cx:pt>
          <cx:pt idx="314">25</cx:pt>
          <cx:pt idx="315">25</cx:pt>
          <cx:pt idx="316">25</cx:pt>
          <cx:pt idx="317">26</cx:pt>
          <cx:pt idx="318">26</cx:pt>
          <cx:pt idx="319">26</cx:pt>
          <cx:pt idx="320">26</cx:pt>
          <cx:pt idx="321">26</cx:pt>
          <cx:pt idx="322">27</cx:pt>
          <cx:pt idx="323">27</cx:pt>
          <cx:pt idx="324">27</cx:pt>
          <cx:pt idx="325">27</cx:pt>
          <cx:pt idx="326">27</cx:pt>
          <cx:pt idx="327">27</cx:pt>
          <cx:pt idx="328">28</cx:pt>
          <cx:pt idx="329">29</cx:pt>
          <cx:pt idx="330">29</cx:pt>
          <cx:pt idx="331">29</cx:pt>
          <cx:pt idx="332">29</cx:pt>
          <cx:pt idx="333">29</cx:pt>
          <cx:pt idx="334">29</cx:pt>
          <cx:pt idx="335">29</cx:pt>
          <cx:pt idx="336">30</cx:pt>
          <cx:pt idx="337">30</cx:pt>
          <cx:pt idx="338">30</cx:pt>
          <cx:pt idx="339">31</cx:pt>
          <cx:pt idx="340">32</cx:pt>
          <cx:pt idx="341">33</cx:pt>
          <cx:pt idx="342">33</cx:pt>
          <cx:pt idx="343">33</cx:pt>
          <cx:pt idx="344">34</cx:pt>
          <cx:pt idx="345">35</cx:pt>
          <cx:pt idx="346">35</cx:pt>
          <cx:pt idx="347">35</cx:pt>
          <cx:pt idx="348">35</cx:pt>
          <cx:pt idx="349">36</cx:pt>
          <cx:pt idx="350">36</cx:pt>
          <cx:pt idx="351">37</cx:pt>
          <cx:pt idx="352">38</cx:pt>
          <cx:pt idx="353">38</cx:pt>
          <cx:pt idx="354">39</cx:pt>
          <cx:pt idx="355">39</cx:pt>
          <cx:pt idx="356">40</cx:pt>
          <cx:pt idx="357">41</cx:pt>
          <cx:pt idx="358">41</cx:pt>
          <cx:pt idx="359">44</cx:pt>
          <cx:pt idx="360">44</cx:pt>
          <cx:pt idx="361">44</cx:pt>
          <cx:pt idx="362">45</cx:pt>
          <cx:pt idx="363">45</cx:pt>
          <cx:pt idx="364">45</cx:pt>
          <cx:pt idx="365">47</cx:pt>
          <cx:pt idx="366">47</cx:pt>
          <cx:pt idx="367">48</cx:pt>
          <cx:pt idx="368">49</cx:pt>
          <cx:pt idx="369">49</cx:pt>
          <cx:pt idx="370">49</cx:pt>
          <cx:pt idx="371">49</cx:pt>
          <cx:pt idx="372">49</cx:pt>
          <cx:pt idx="373">50</cx:pt>
          <cx:pt idx="374">50</cx:pt>
          <cx:pt idx="375">50</cx:pt>
          <cx:pt idx="376">50</cx:pt>
          <cx:pt idx="377">51</cx:pt>
          <cx:pt idx="378">51</cx:pt>
          <cx:pt idx="379">52</cx:pt>
          <cx:pt idx="380">52</cx:pt>
          <cx:pt idx="381">52</cx:pt>
          <cx:pt idx="382">52</cx:pt>
          <cx:pt idx="383">52</cx:pt>
          <cx:pt idx="384">53</cx:pt>
          <cx:pt idx="385">54</cx:pt>
          <cx:pt idx="386">54</cx:pt>
          <cx:pt idx="387">55</cx:pt>
          <cx:pt idx="388">55</cx:pt>
          <cx:pt idx="389">55</cx:pt>
          <cx:pt idx="390">56</cx:pt>
          <cx:pt idx="391">56</cx:pt>
          <cx:pt idx="392">56</cx:pt>
          <cx:pt idx="393">57</cx:pt>
          <cx:pt idx="394">58</cx:pt>
          <cx:pt idx="395">58</cx:pt>
          <cx:pt idx="396">58</cx:pt>
          <cx:pt idx="397">58</cx:pt>
          <cx:pt idx="398">59</cx:pt>
          <cx:pt idx="399">59</cx:pt>
          <cx:pt idx="400">60</cx:pt>
          <cx:pt idx="401">60</cx:pt>
          <cx:pt idx="402">60</cx:pt>
          <cx:pt idx="403">60</cx:pt>
          <cx:pt idx="404">60</cx:pt>
          <cx:pt idx="405">60</cx:pt>
          <cx:pt idx="406">61</cx:pt>
          <cx:pt idx="407">61</cx:pt>
          <cx:pt idx="408">61</cx:pt>
          <cx:pt idx="409">61</cx:pt>
          <cx:pt idx="410">62</cx:pt>
          <cx:pt idx="411">62</cx:pt>
          <cx:pt idx="412">62</cx:pt>
          <cx:pt idx="413">63</cx:pt>
          <cx:pt idx="414">63</cx:pt>
          <cx:pt idx="415">66</cx:pt>
          <cx:pt idx="416">67</cx:pt>
          <cx:pt idx="417">67</cx:pt>
          <cx:pt idx="418">68</cx:pt>
          <cx:pt idx="419">68</cx:pt>
          <cx:pt idx="420">69</cx:pt>
          <cx:pt idx="421">70</cx:pt>
          <cx:pt idx="422">70</cx:pt>
          <cx:pt idx="423">70</cx:pt>
          <cx:pt idx="424">71</cx:pt>
          <cx:pt idx="425">71</cx:pt>
          <cx:pt idx="426">71</cx:pt>
          <cx:pt idx="427">71</cx:pt>
          <cx:pt idx="428">71</cx:pt>
          <cx:pt idx="429">72</cx:pt>
          <cx:pt idx="430">73</cx:pt>
          <cx:pt idx="431">73</cx:pt>
          <cx:pt idx="432">73</cx:pt>
          <cx:pt idx="433">75</cx:pt>
          <cx:pt idx="434">75</cx:pt>
          <cx:pt idx="435">76</cx:pt>
          <cx:pt idx="436">76</cx:pt>
          <cx:pt idx="437">76</cx:pt>
          <cx:pt idx="438">76</cx:pt>
          <cx:pt idx="439">76</cx:pt>
          <cx:pt idx="440">76</cx:pt>
          <cx:pt idx="441">77</cx:pt>
          <cx:pt idx="442">78</cx:pt>
          <cx:pt idx="443">79</cx:pt>
          <cx:pt idx="444">81</cx:pt>
          <cx:pt idx="445">82</cx:pt>
          <cx:pt idx="446">82</cx:pt>
          <cx:pt idx="447">85</cx:pt>
          <cx:pt idx="448">86</cx:pt>
          <cx:pt idx="449">86</cx:pt>
          <cx:pt idx="450">86</cx:pt>
          <cx:pt idx="451">87</cx:pt>
          <cx:pt idx="452">89</cx:pt>
          <cx:pt idx="453">91</cx:pt>
          <cx:pt idx="454">92</cx:pt>
          <cx:pt idx="455">94</cx:pt>
          <cx:pt idx="456">94</cx:pt>
          <cx:pt idx="457">94</cx:pt>
          <cx:pt idx="458">95</cx:pt>
          <cx:pt idx="459">95</cx:pt>
          <cx:pt idx="460">95</cx:pt>
          <cx:pt idx="461">95</cx:pt>
          <cx:pt idx="462">96</cx:pt>
          <cx:pt idx="463">96</cx:pt>
          <cx:pt idx="464">98</cx:pt>
          <cx:pt idx="465">99</cx:pt>
          <cx:pt idx="466">100</cx:pt>
          <cx:pt idx="467">100</cx:pt>
          <cx:pt idx="468">103</cx:pt>
          <cx:pt idx="469">105</cx:pt>
          <cx:pt idx="470">105</cx:pt>
          <cx:pt idx="471">105</cx:pt>
          <cx:pt idx="472">106</cx:pt>
          <cx:pt idx="473">107</cx:pt>
          <cx:pt idx="474">109</cx:pt>
          <cx:pt idx="475">110</cx:pt>
          <cx:pt idx="476">110</cx:pt>
          <cx:pt idx="477">111</cx:pt>
          <cx:pt idx="478">119</cx:pt>
          <cx:pt idx="479">119</cx:pt>
          <cx:pt idx="480">126</cx:pt>
          <cx:pt idx="481">128</cx:pt>
          <cx:pt idx="482">128</cx:pt>
          <cx:pt idx="483">130</cx:pt>
          <cx:pt idx="484">131</cx:pt>
          <cx:pt idx="485">132</cx:pt>
          <cx:pt idx="486">133</cx:pt>
          <cx:pt idx="487">134</cx:pt>
          <cx:pt idx="488">135</cx:pt>
          <cx:pt idx="489">137</cx:pt>
          <cx:pt idx="490">138</cx:pt>
          <cx:pt idx="491">145</cx:pt>
          <cx:pt idx="492">147</cx:pt>
          <cx:pt idx="493">148</cx:pt>
          <cx:pt idx="494">148</cx:pt>
          <cx:pt idx="495">149</cx:pt>
          <cx:pt idx="496">149</cx:pt>
          <cx:pt idx="497">149</cx:pt>
          <cx:pt idx="498">150</cx:pt>
          <cx:pt idx="499">154</cx:pt>
          <cx:pt idx="500">155</cx:pt>
          <cx:pt idx="501">158</cx:pt>
          <cx:pt idx="502">169</cx:pt>
          <cx:pt idx="503">169</cx:pt>
          <cx:pt idx="504">171</cx:pt>
          <cx:pt idx="505">173</cx:pt>
          <cx:pt idx="506">174</cx:pt>
          <cx:pt idx="507">176</cx:pt>
          <cx:pt idx="508">180</cx:pt>
          <cx:pt idx="509">196</cx:pt>
          <cx:pt idx="510">204</cx:pt>
          <cx:pt idx="511">210</cx:pt>
          <cx:pt idx="512">222</cx:pt>
          <cx:pt idx="513">222</cx:pt>
          <cx:pt idx="514">223</cx:pt>
          <cx:pt idx="515">232</cx:pt>
          <cx:pt idx="516">243</cx:pt>
          <cx:pt idx="517">246</cx:pt>
          <cx:pt idx="518">283</cx:pt>
          <cx:pt idx="519">405</cx:pt>
        </cx:lvl>
      </cx:numDim>
    </cx:data>
  </cx:chartData>
  <cx:chart>
    <cx:title pos="t" align="ctr" overlay="0">
      <cx:tx>
        <cx:txData>
          <cx:v/>
        </cx:txData>
      </cx:tx>
      <cx:txPr>
        <a:bodyPr spcFirstLastPara="1" vertOverflow="ellipsis" wrap="square" lIns="0" tIns="0" rIns="0" bIns="0" anchor="ctr" anchorCtr="1"/>
        <a:lstStyle/>
        <a:p>
          <a:pPr algn="ctr">
            <a:defRPr/>
          </a:pPr>
          <a:endParaRPr/>
        </a:p>
      </cx:txPr>
    </cx:title>
    <cx:plotArea>
      <cx:plotAreaRegion>
        <cx:series layoutId="boxWhisker" uniqueId="{4182C088-BBF1-40C3-8A6B-46B290DE937D}">
          <cx:dataId val="0"/>
          <cx:layoutPr>
            <cx:visibility meanLine="0" meanMarker="1" nonoutliers="0" outliers="1"/>
            <cx:statistics quartileMethod="exclusive"/>
          </cx:layoutPr>
        </cx:series>
      </cx:plotAreaRegion>
      <cx:axis id="0">
        <cx:catScaling gapWidth="1"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tickLabels/>
      </cx:axis>
      <cx:axis id="1">
        <cx:valScaling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majorGridlines/>
        <cx:tickLabels/>
      </cx:axis>
    </cx:plotArea>
  </cx:chart>
</cx:chartSpace>
</file>

<file path=ppt/charts/chartEx4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lvl ptCount="520">
          <cx:pt idx="0">BWR pro Tag</cx:pt>
          <cx:pt idx="1">BWR pro Tag</cx:pt>
          <cx:pt idx="2">BWR pro Tag</cx:pt>
          <cx:pt idx="3">BWR pro Tag</cx:pt>
          <cx:pt idx="4">BWR pro Tag</cx:pt>
          <cx:pt idx="5">BWR pro Tag</cx:pt>
          <cx:pt idx="6">BWR pro Tag</cx:pt>
          <cx:pt idx="7">BWR pro Tag</cx:pt>
          <cx:pt idx="8">BWR pro Tag</cx:pt>
          <cx:pt idx="9">BWR pro Tag</cx:pt>
          <cx:pt idx="10">BWR pro Tag</cx:pt>
          <cx:pt idx="11">BWR pro Tag</cx:pt>
          <cx:pt idx="12">BWR pro Tag</cx:pt>
          <cx:pt idx="13">BWR pro Tag</cx:pt>
          <cx:pt idx="14">BWR pro Tag</cx:pt>
          <cx:pt idx="15">BWR pro Tag</cx:pt>
          <cx:pt idx="16">BWR pro Tag</cx:pt>
          <cx:pt idx="17">BWR pro Tag</cx:pt>
          <cx:pt idx="18">BWR pro Tag</cx:pt>
          <cx:pt idx="19">BWR pro Tag</cx:pt>
          <cx:pt idx="20">BWR pro Tag</cx:pt>
          <cx:pt idx="21">BWR pro Tag</cx:pt>
          <cx:pt idx="22">BWR pro Tag</cx:pt>
          <cx:pt idx="23">BWR pro Tag</cx:pt>
          <cx:pt idx="24">BWR pro Tag</cx:pt>
          <cx:pt idx="25">BWR pro Tag</cx:pt>
          <cx:pt idx="26">BWR pro Tag</cx:pt>
          <cx:pt idx="27">BWR pro Tag</cx:pt>
          <cx:pt idx="28">BWR pro Tag</cx:pt>
          <cx:pt idx="29">BWR pro Tag</cx:pt>
          <cx:pt idx="30">BWR pro Tag</cx:pt>
          <cx:pt idx="31">BWR pro Tag</cx:pt>
          <cx:pt idx="32">BWR pro Tag</cx:pt>
          <cx:pt idx="33">BWR pro Tag</cx:pt>
          <cx:pt idx="34">BWR pro Tag</cx:pt>
          <cx:pt idx="35">BWR pro Tag</cx:pt>
          <cx:pt idx="36">BWR pro Tag</cx:pt>
          <cx:pt idx="37">BWR pro Tag</cx:pt>
          <cx:pt idx="38">BWR pro Tag</cx:pt>
          <cx:pt idx="39">BWR pro Tag</cx:pt>
          <cx:pt idx="40">BWR pro Tag</cx:pt>
          <cx:pt idx="41">BWR pro Tag</cx:pt>
          <cx:pt idx="42">BWR pro Tag</cx:pt>
          <cx:pt idx="43">BWR pro Tag</cx:pt>
          <cx:pt idx="44">BWR pro Tag</cx:pt>
          <cx:pt idx="45">BWR pro Tag</cx:pt>
          <cx:pt idx="46">BWR pro Tag</cx:pt>
          <cx:pt idx="47">BWR pro Tag</cx:pt>
          <cx:pt idx="48">BWR pro Tag</cx:pt>
          <cx:pt idx="49">BWR pro Tag</cx:pt>
          <cx:pt idx="50">BWR pro Tag</cx:pt>
          <cx:pt idx="51">BWR pro Tag</cx:pt>
          <cx:pt idx="52">BWR pro Tag</cx:pt>
          <cx:pt idx="53">BWR pro Tag</cx:pt>
          <cx:pt idx="54">BWR pro Tag</cx:pt>
          <cx:pt idx="55">BWR pro Tag</cx:pt>
          <cx:pt idx="56">BWR pro Tag</cx:pt>
          <cx:pt idx="57">BWR pro Tag</cx:pt>
          <cx:pt idx="58">BWR pro Tag</cx:pt>
          <cx:pt idx="59">BWR pro Tag</cx:pt>
          <cx:pt idx="60">BWR pro Tag</cx:pt>
          <cx:pt idx="61">BWR pro Tag</cx:pt>
          <cx:pt idx="62">BWR pro Tag</cx:pt>
          <cx:pt idx="63">BWR pro Tag</cx:pt>
          <cx:pt idx="64">BWR pro Tag</cx:pt>
          <cx:pt idx="65">BWR pro Tag</cx:pt>
          <cx:pt idx="66">BWR pro Tag</cx:pt>
          <cx:pt idx="67">BWR pro Tag</cx:pt>
          <cx:pt idx="68">BWR pro Tag</cx:pt>
          <cx:pt idx="69">BWR pro Tag</cx:pt>
          <cx:pt idx="70">BWR pro Tag</cx:pt>
          <cx:pt idx="71">BWR pro Tag</cx:pt>
          <cx:pt idx="72">BWR pro Tag</cx:pt>
          <cx:pt idx="73">BWR pro Tag</cx:pt>
          <cx:pt idx="74">BWR pro Tag</cx:pt>
          <cx:pt idx="75">BWR pro Tag</cx:pt>
          <cx:pt idx="76">BWR pro Tag</cx:pt>
          <cx:pt idx="77">BWR pro Tag</cx:pt>
          <cx:pt idx="78">BWR pro Tag</cx:pt>
          <cx:pt idx="79">BWR pro Tag</cx:pt>
          <cx:pt idx="80">BWR pro Tag</cx:pt>
          <cx:pt idx="81">BWR pro Tag</cx:pt>
          <cx:pt idx="82">BWR pro Tag</cx:pt>
          <cx:pt idx="83">BWR pro Tag</cx:pt>
          <cx:pt idx="84">BWR pro Tag</cx:pt>
          <cx:pt idx="85">BWR pro Tag</cx:pt>
          <cx:pt idx="86">BWR pro Tag</cx:pt>
          <cx:pt idx="87">BWR pro Tag</cx:pt>
          <cx:pt idx="88">BWR pro Tag</cx:pt>
          <cx:pt idx="89">BWR pro Tag</cx:pt>
          <cx:pt idx="90">BWR pro Tag</cx:pt>
          <cx:pt idx="91">BWR pro Tag</cx:pt>
          <cx:pt idx="92">BWR pro Tag</cx:pt>
          <cx:pt idx="93">BWR pro Tag</cx:pt>
          <cx:pt idx="94">BWR pro Tag</cx:pt>
          <cx:pt idx="95">BWR pro Tag</cx:pt>
          <cx:pt idx="96">BWR pro Tag</cx:pt>
          <cx:pt idx="97">BWR pro Tag</cx:pt>
          <cx:pt idx="98">BWR pro Tag</cx:pt>
          <cx:pt idx="99">BWR pro Tag</cx:pt>
          <cx:pt idx="100">BWR pro Tag</cx:pt>
          <cx:pt idx="101">BWR pro Tag</cx:pt>
          <cx:pt idx="102">BWR pro Tag</cx:pt>
          <cx:pt idx="103">BWR pro Tag</cx:pt>
          <cx:pt idx="104">BWR pro Tag</cx:pt>
          <cx:pt idx="105">BWR pro Tag</cx:pt>
          <cx:pt idx="106">BWR pro Tag</cx:pt>
          <cx:pt idx="107">BWR pro Tag</cx:pt>
          <cx:pt idx="108">BWR pro Tag</cx:pt>
          <cx:pt idx="109">BWR pro Tag</cx:pt>
          <cx:pt idx="110">BWR pro Tag</cx:pt>
          <cx:pt idx="111">BWR pro Tag</cx:pt>
          <cx:pt idx="112">BWR pro Tag</cx:pt>
          <cx:pt idx="113">BWR pro Tag</cx:pt>
          <cx:pt idx="114">BWR pro Tag</cx:pt>
          <cx:pt idx="115">BWR pro Tag</cx:pt>
          <cx:pt idx="116">BWR pro Tag</cx:pt>
          <cx:pt idx="117">BWR pro Tag</cx:pt>
          <cx:pt idx="118">BWR pro Tag</cx:pt>
          <cx:pt idx="119">BWR pro Tag</cx:pt>
          <cx:pt idx="120">BWR pro Tag</cx:pt>
          <cx:pt idx="121">BWR pro Tag</cx:pt>
          <cx:pt idx="122">BWR pro Tag</cx:pt>
          <cx:pt idx="123">BWR pro Tag</cx:pt>
          <cx:pt idx="124">BWR pro Tag</cx:pt>
          <cx:pt idx="125">BWR pro Tag</cx:pt>
          <cx:pt idx="126">BWR pro Tag</cx:pt>
          <cx:pt idx="127">BWR pro Tag</cx:pt>
          <cx:pt idx="128">BWR pro Tag</cx:pt>
          <cx:pt idx="129">BWR pro Tag</cx:pt>
          <cx:pt idx="130">BWR pro Tag</cx:pt>
          <cx:pt idx="131">BWR pro Tag</cx:pt>
          <cx:pt idx="132">BWR pro Tag</cx:pt>
          <cx:pt idx="133">BWR pro Tag</cx:pt>
          <cx:pt idx="134">BWR pro Tag</cx:pt>
          <cx:pt idx="135">BWR pro Tag</cx:pt>
          <cx:pt idx="136">BWR pro Tag</cx:pt>
          <cx:pt idx="137">BWR pro Tag</cx:pt>
          <cx:pt idx="138">BWR pro Tag</cx:pt>
          <cx:pt idx="139">BWR pro Tag</cx:pt>
          <cx:pt idx="140">BWR pro Tag</cx:pt>
          <cx:pt idx="141">BWR pro Tag</cx:pt>
          <cx:pt idx="142">BWR pro Tag</cx:pt>
          <cx:pt idx="143">BWR pro Tag</cx:pt>
          <cx:pt idx="144">BWR pro Tag</cx:pt>
          <cx:pt idx="145">BWR pro Tag</cx:pt>
          <cx:pt idx="146">BWR pro Tag</cx:pt>
          <cx:pt idx="147">BWR pro Tag</cx:pt>
          <cx:pt idx="148">BWR pro Tag</cx:pt>
          <cx:pt idx="149">BWR pro Tag</cx:pt>
          <cx:pt idx="150">BWR pro Tag</cx:pt>
          <cx:pt idx="151">BWR pro Tag</cx:pt>
          <cx:pt idx="152">BWR pro Tag</cx:pt>
          <cx:pt idx="153">BWR pro Tag</cx:pt>
          <cx:pt idx="154">BWR pro Tag</cx:pt>
          <cx:pt idx="155">BWR pro Tag</cx:pt>
          <cx:pt idx="156">BWR pro Tag</cx:pt>
          <cx:pt idx="157">BWR pro Tag</cx:pt>
          <cx:pt idx="158">BWR pro Tag</cx:pt>
          <cx:pt idx="159">BWR pro Tag</cx:pt>
          <cx:pt idx="160">BWR pro Tag</cx:pt>
          <cx:pt idx="161">BWR pro Tag</cx:pt>
          <cx:pt idx="162">BWR pro Tag</cx:pt>
          <cx:pt idx="163">BWR pro Tag</cx:pt>
          <cx:pt idx="164">BWR pro Tag</cx:pt>
          <cx:pt idx="165">BWR pro Tag</cx:pt>
          <cx:pt idx="166">BWR pro Tag</cx:pt>
          <cx:pt idx="167">BWR pro Tag</cx:pt>
          <cx:pt idx="168">BWR pro Tag</cx:pt>
          <cx:pt idx="169">BWR pro Tag</cx:pt>
          <cx:pt idx="170">BWR pro Tag</cx:pt>
          <cx:pt idx="171">BWR pro Tag</cx:pt>
          <cx:pt idx="172">BWR pro Tag</cx:pt>
          <cx:pt idx="173">BWR pro Tag</cx:pt>
          <cx:pt idx="174">BWR pro Tag</cx:pt>
          <cx:pt idx="175">BWR pro Tag</cx:pt>
          <cx:pt idx="176">BWR pro Tag</cx:pt>
          <cx:pt idx="177">BWR pro Tag</cx:pt>
          <cx:pt idx="178">BWR pro Tag</cx:pt>
          <cx:pt idx="179">BWR pro Tag</cx:pt>
          <cx:pt idx="180">BWR pro Tag</cx:pt>
          <cx:pt idx="181">BWR pro Tag</cx:pt>
          <cx:pt idx="182">BWR pro Tag</cx:pt>
          <cx:pt idx="183">BWR pro Tag</cx:pt>
          <cx:pt idx="184">BWR pro Tag</cx:pt>
          <cx:pt idx="185">BWR pro Tag</cx:pt>
          <cx:pt idx="186">BWR pro Tag</cx:pt>
          <cx:pt idx="187">BWR pro Tag</cx:pt>
          <cx:pt idx="188">BWR pro Tag</cx:pt>
          <cx:pt idx="189">BWR pro Tag</cx:pt>
          <cx:pt idx="190">BWR pro Tag</cx:pt>
          <cx:pt idx="191">BWR pro Tag</cx:pt>
          <cx:pt idx="192">BWR pro Tag</cx:pt>
          <cx:pt idx="193">BWR pro Tag</cx:pt>
          <cx:pt idx="194">BWR pro Tag</cx:pt>
          <cx:pt idx="195">BWR pro Tag</cx:pt>
          <cx:pt idx="196">BWR pro Tag</cx:pt>
          <cx:pt idx="197">BWR pro Tag</cx:pt>
          <cx:pt idx="198">BWR pro Tag</cx:pt>
          <cx:pt idx="199">BWR pro Tag</cx:pt>
          <cx:pt idx="200">BWR pro Tag</cx:pt>
          <cx:pt idx="201">BWR pro Tag</cx:pt>
          <cx:pt idx="202">BWR pro Tag</cx:pt>
          <cx:pt idx="203">BWR pro Tag</cx:pt>
          <cx:pt idx="204">BWR pro Tag</cx:pt>
          <cx:pt idx="205">BWR pro Tag</cx:pt>
          <cx:pt idx="206">BWR pro Tag</cx:pt>
          <cx:pt idx="207">BWR pro Tag</cx:pt>
          <cx:pt idx="208">BWR pro Tag</cx:pt>
          <cx:pt idx="209">BWR pro Tag</cx:pt>
          <cx:pt idx="210">BWR pro Tag</cx:pt>
          <cx:pt idx="211">BWR pro Tag</cx:pt>
          <cx:pt idx="212">BWR pro Tag</cx:pt>
          <cx:pt idx="213">BWR pro Tag</cx:pt>
          <cx:pt idx="214">BWR pro Tag</cx:pt>
          <cx:pt idx="215">BWR pro Tag</cx:pt>
          <cx:pt idx="216">BWR pro Tag</cx:pt>
          <cx:pt idx="217">BWR pro Tag</cx:pt>
          <cx:pt idx="218">BWR pro Tag</cx:pt>
          <cx:pt idx="219">BWR pro Tag</cx:pt>
          <cx:pt idx="220">BWR pro Tag</cx:pt>
          <cx:pt idx="221">BWR pro Tag</cx:pt>
          <cx:pt idx="222">BWR pro Tag</cx:pt>
          <cx:pt idx="223">BWR pro Tag</cx:pt>
          <cx:pt idx="224">BWR pro Tag</cx:pt>
          <cx:pt idx="225">BWR pro Tag</cx:pt>
          <cx:pt idx="226">BWR pro Tag</cx:pt>
          <cx:pt idx="227">BWR pro Tag</cx:pt>
          <cx:pt idx="228">BWR pro Tag</cx:pt>
          <cx:pt idx="229">BWR pro Tag</cx:pt>
          <cx:pt idx="230">BWR pro Tag</cx:pt>
          <cx:pt idx="231">BWR pro Tag</cx:pt>
          <cx:pt idx="232">BWR pro Tag</cx:pt>
          <cx:pt idx="233">BWR pro Tag</cx:pt>
          <cx:pt idx="234">BWR pro Tag</cx:pt>
          <cx:pt idx="235">BWR pro Tag</cx:pt>
          <cx:pt idx="236">BWR pro Tag</cx:pt>
          <cx:pt idx="237">BWR pro Tag</cx:pt>
          <cx:pt idx="238">BWR pro Tag</cx:pt>
          <cx:pt idx="239">BWR pro Tag</cx:pt>
          <cx:pt idx="240">BWR pro Tag</cx:pt>
          <cx:pt idx="241">BWR pro Tag</cx:pt>
          <cx:pt idx="242">BWR pro Tag</cx:pt>
          <cx:pt idx="243">BWR pro Tag</cx:pt>
          <cx:pt idx="244">BWR pro Tag</cx:pt>
          <cx:pt idx="245">BWR pro Tag</cx:pt>
          <cx:pt idx="246">BWR pro Tag</cx:pt>
          <cx:pt idx="247">BWR pro Tag</cx:pt>
          <cx:pt idx="248">BWR pro Tag</cx:pt>
          <cx:pt idx="249">BWR pro Tag</cx:pt>
          <cx:pt idx="250">BWR pro Tag</cx:pt>
          <cx:pt idx="251">BWR pro Tag</cx:pt>
          <cx:pt idx="252">BWR pro Tag</cx:pt>
          <cx:pt idx="253">BWR pro Tag</cx:pt>
          <cx:pt idx="254">BWR pro Tag</cx:pt>
          <cx:pt idx="255">BWR pro Tag</cx:pt>
          <cx:pt idx="256">BWR pro Tag</cx:pt>
          <cx:pt idx="257">BWR pro Tag</cx:pt>
          <cx:pt idx="258">BWR pro Tag</cx:pt>
          <cx:pt idx="259">BWR pro Tag</cx:pt>
          <cx:pt idx="260">BWR pro Tag</cx:pt>
          <cx:pt idx="261">BWR pro Tag</cx:pt>
          <cx:pt idx="262">BWR pro Tag</cx:pt>
          <cx:pt idx="263">BWR pro Tag</cx:pt>
          <cx:pt idx="264">BWR pro Tag</cx:pt>
          <cx:pt idx="265">BWR pro Tag</cx:pt>
          <cx:pt idx="266">BWR pro Tag</cx:pt>
          <cx:pt idx="267">BWR pro Tag</cx:pt>
          <cx:pt idx="268">BWR pro Tag</cx:pt>
          <cx:pt idx="269">BWR pro Tag</cx:pt>
          <cx:pt idx="270">BWR pro Tag</cx:pt>
          <cx:pt idx="271">BWR pro Tag</cx:pt>
          <cx:pt idx="272">BWR pro Tag</cx:pt>
          <cx:pt idx="273">BWR pro Tag</cx:pt>
          <cx:pt idx="274">BWR pro Tag</cx:pt>
          <cx:pt idx="275">BWR pro Tag</cx:pt>
          <cx:pt idx="276">BWR pro Tag</cx:pt>
          <cx:pt idx="277">BWR pro Tag</cx:pt>
          <cx:pt idx="278">BWR pro Tag</cx:pt>
          <cx:pt idx="279">BWR pro Tag</cx:pt>
          <cx:pt idx="280">BWR pro Tag</cx:pt>
          <cx:pt idx="281">BWR pro Tag</cx:pt>
          <cx:pt idx="282">BWR pro Tag</cx:pt>
          <cx:pt idx="283">BWR pro Tag</cx:pt>
          <cx:pt idx="284">BWR pro Tag</cx:pt>
          <cx:pt idx="285">BWR pro Tag</cx:pt>
          <cx:pt idx="286">BWR pro Tag</cx:pt>
          <cx:pt idx="287">BWR pro Tag</cx:pt>
          <cx:pt idx="288">BWR pro Tag</cx:pt>
          <cx:pt idx="289">BWR pro Tag</cx:pt>
          <cx:pt idx="290">BWR pro Tag</cx:pt>
          <cx:pt idx="291">BWR pro Tag</cx:pt>
          <cx:pt idx="292">BWR pro Tag</cx:pt>
          <cx:pt idx="293">BWR pro Tag</cx:pt>
          <cx:pt idx="294">BWR pro Tag</cx:pt>
          <cx:pt idx="295">BWR pro Tag</cx:pt>
          <cx:pt idx="296">BWR pro Tag</cx:pt>
          <cx:pt idx="297">BWR pro Tag</cx:pt>
          <cx:pt idx="298">BWR pro Tag</cx:pt>
          <cx:pt idx="299">BWR pro Tag</cx:pt>
          <cx:pt idx="300">BWR pro Tag</cx:pt>
          <cx:pt idx="301">BWR pro Tag</cx:pt>
          <cx:pt idx="302">BWR pro Tag</cx:pt>
          <cx:pt idx="303">BWR pro Tag</cx:pt>
          <cx:pt idx="304">BWR pro Tag</cx:pt>
          <cx:pt idx="305">BWR pro Tag</cx:pt>
          <cx:pt idx="306">BWR pro Tag</cx:pt>
          <cx:pt idx="307">BWR pro Tag</cx:pt>
          <cx:pt idx="308">BWR pro Tag</cx:pt>
          <cx:pt idx="309">BWR pro Tag</cx:pt>
          <cx:pt idx="310">BWR pro Tag</cx:pt>
          <cx:pt idx="311">BWR pro Tag</cx:pt>
          <cx:pt idx="312">BWR pro Tag</cx:pt>
          <cx:pt idx="313">BWR pro Tag</cx:pt>
          <cx:pt idx="314">BWR pro Tag</cx:pt>
          <cx:pt idx="315">BWR pro Tag</cx:pt>
          <cx:pt idx="316">BWR pro Tag</cx:pt>
          <cx:pt idx="317">BWR pro Tag</cx:pt>
          <cx:pt idx="318">BWR pro Tag</cx:pt>
          <cx:pt idx="319">BWR pro Tag</cx:pt>
          <cx:pt idx="320">BWR pro Tag</cx:pt>
          <cx:pt idx="321">BWR pro Tag</cx:pt>
          <cx:pt idx="322">BWR pro Tag</cx:pt>
          <cx:pt idx="323">BWR pro Tag</cx:pt>
          <cx:pt idx="324">BWR pro Tag</cx:pt>
          <cx:pt idx="325">BWR pro Tag</cx:pt>
          <cx:pt idx="326">BWR pro Tag</cx:pt>
          <cx:pt idx="327">BWR pro Tag</cx:pt>
          <cx:pt idx="328">BWR pro Tag</cx:pt>
          <cx:pt idx="329">BWR pro Tag</cx:pt>
          <cx:pt idx="330">BWR pro Tag</cx:pt>
          <cx:pt idx="331">BWR pro Tag</cx:pt>
          <cx:pt idx="332">BWR pro Tag</cx:pt>
          <cx:pt idx="333">BWR pro Tag</cx:pt>
          <cx:pt idx="334">BWR pro Tag</cx:pt>
          <cx:pt idx="335">BWR pro Tag</cx:pt>
          <cx:pt idx="336">BWR pro Tag</cx:pt>
          <cx:pt idx="337">BWR pro Tag</cx:pt>
          <cx:pt idx="338">BWR pro Tag</cx:pt>
          <cx:pt idx="339">BWR pro Tag</cx:pt>
          <cx:pt idx="340">BWR pro Tag</cx:pt>
          <cx:pt idx="341">BWR pro Tag</cx:pt>
          <cx:pt idx="342">BWR pro Tag</cx:pt>
          <cx:pt idx="343">BWR pro Tag</cx:pt>
          <cx:pt idx="344">BWR pro Tag</cx:pt>
          <cx:pt idx="345">BWR pro Tag</cx:pt>
          <cx:pt idx="346">BWR pro Tag</cx:pt>
          <cx:pt idx="347">BWR pro Tag</cx:pt>
          <cx:pt idx="348">BWR pro Tag</cx:pt>
          <cx:pt idx="349">BWR pro Tag</cx:pt>
          <cx:pt idx="350">BWR pro Tag</cx:pt>
          <cx:pt idx="351">BWR pro Tag</cx:pt>
          <cx:pt idx="352">BWR pro Tag</cx:pt>
          <cx:pt idx="353">BWR pro Tag</cx:pt>
          <cx:pt idx="354">BWR pro Tag</cx:pt>
          <cx:pt idx="355">BWR pro Tag</cx:pt>
          <cx:pt idx="356">BWR pro Tag</cx:pt>
          <cx:pt idx="357">BWR pro Tag</cx:pt>
          <cx:pt idx="358">BWR pro Tag</cx:pt>
          <cx:pt idx="359">BWR pro Tag</cx:pt>
          <cx:pt idx="360">BWR pro Tag</cx:pt>
          <cx:pt idx="361">BWR pro Tag</cx:pt>
          <cx:pt idx="362">BWR pro Tag</cx:pt>
          <cx:pt idx="363">BWR pro Tag</cx:pt>
          <cx:pt idx="364">BWR pro Tag</cx:pt>
          <cx:pt idx="365">BWR pro Tag</cx:pt>
          <cx:pt idx="366">BWR pro Tag</cx:pt>
          <cx:pt idx="367">BWR pro Tag</cx:pt>
          <cx:pt idx="368">BWR pro Tag</cx:pt>
          <cx:pt idx="369">BWR pro Tag</cx:pt>
          <cx:pt idx="370">BWR pro Tag</cx:pt>
          <cx:pt idx="371">BWR pro Tag</cx:pt>
          <cx:pt idx="372">BWR pro Tag</cx:pt>
          <cx:pt idx="373">BWR pro Tag</cx:pt>
          <cx:pt idx="374">BWR pro Tag</cx:pt>
          <cx:pt idx="375">BWR pro Tag</cx:pt>
          <cx:pt idx="376">BWR pro Tag</cx:pt>
          <cx:pt idx="377">BWR pro Tag</cx:pt>
          <cx:pt idx="378">BWR pro Tag</cx:pt>
          <cx:pt idx="379">BWR pro Tag</cx:pt>
          <cx:pt idx="380">BWR pro Tag</cx:pt>
          <cx:pt idx="381">BWR pro Tag</cx:pt>
          <cx:pt idx="382">BWR pro Tag</cx:pt>
          <cx:pt idx="383">BWR pro Tag</cx:pt>
          <cx:pt idx="384">BWR pro Tag</cx:pt>
          <cx:pt idx="385">BWR pro Tag</cx:pt>
          <cx:pt idx="386">BWR pro Tag</cx:pt>
          <cx:pt idx="387">BWR pro Tag</cx:pt>
          <cx:pt idx="388">BWR pro Tag</cx:pt>
          <cx:pt idx="389">BWR pro Tag</cx:pt>
          <cx:pt idx="390">BWR pro Tag</cx:pt>
          <cx:pt idx="391">BWR pro Tag</cx:pt>
          <cx:pt idx="392">BWR pro Tag</cx:pt>
          <cx:pt idx="393">BWR pro Tag</cx:pt>
          <cx:pt idx="394">BWR pro Tag</cx:pt>
          <cx:pt idx="395">BWR pro Tag</cx:pt>
          <cx:pt idx="396">BWR pro Tag</cx:pt>
          <cx:pt idx="397">BWR pro Tag</cx:pt>
          <cx:pt idx="398">BWR pro Tag</cx:pt>
          <cx:pt idx="399">BWR pro Tag</cx:pt>
          <cx:pt idx="400">BWR pro Tag</cx:pt>
          <cx:pt idx="401">BWR pro Tag</cx:pt>
          <cx:pt idx="402">BWR pro Tag</cx:pt>
          <cx:pt idx="403">BWR pro Tag</cx:pt>
          <cx:pt idx="404">BWR pro Tag</cx:pt>
          <cx:pt idx="405">BWR pro Tag</cx:pt>
          <cx:pt idx="406">BWR pro Tag</cx:pt>
          <cx:pt idx="407">BWR pro Tag</cx:pt>
          <cx:pt idx="408">BWR pro Tag</cx:pt>
          <cx:pt idx="409">BWR pro Tag</cx:pt>
          <cx:pt idx="410">BWR pro Tag</cx:pt>
          <cx:pt idx="411">BWR pro Tag</cx:pt>
          <cx:pt idx="412">BWR pro Tag</cx:pt>
          <cx:pt idx="413">BWR pro Tag</cx:pt>
          <cx:pt idx="414">BWR pro Tag</cx:pt>
          <cx:pt idx="415">BWR pro Tag</cx:pt>
          <cx:pt idx="416">BWR pro Tag</cx:pt>
          <cx:pt idx="417">BWR pro Tag</cx:pt>
          <cx:pt idx="418">BWR pro Tag</cx:pt>
          <cx:pt idx="419">BWR pro Tag</cx:pt>
          <cx:pt idx="420">BWR pro Tag</cx:pt>
          <cx:pt idx="421">BWR pro Tag</cx:pt>
          <cx:pt idx="422">BWR pro Tag</cx:pt>
          <cx:pt idx="423">BWR pro Tag</cx:pt>
          <cx:pt idx="424">BWR pro Tag</cx:pt>
          <cx:pt idx="425">BWR pro Tag</cx:pt>
          <cx:pt idx="426">BWR pro Tag</cx:pt>
          <cx:pt idx="427">BWR pro Tag</cx:pt>
          <cx:pt idx="428">BWR pro Tag</cx:pt>
          <cx:pt idx="429">BWR pro Tag</cx:pt>
          <cx:pt idx="430">BWR pro Tag</cx:pt>
          <cx:pt idx="431">BWR pro Tag</cx:pt>
          <cx:pt idx="432">BWR pro Tag</cx:pt>
          <cx:pt idx="433">BWR pro Tag</cx:pt>
          <cx:pt idx="434">BWR pro Tag</cx:pt>
          <cx:pt idx="435">BWR pro Tag</cx:pt>
          <cx:pt idx="436">BWR pro Tag</cx:pt>
          <cx:pt idx="437">BWR pro Tag</cx:pt>
          <cx:pt idx="438">BWR pro Tag</cx:pt>
          <cx:pt idx="439">BWR pro Tag</cx:pt>
          <cx:pt idx="440">BWR pro Tag</cx:pt>
          <cx:pt idx="441">BWR pro Tag</cx:pt>
          <cx:pt idx="442">BWR pro Tag</cx:pt>
          <cx:pt idx="443">BWR pro Tag</cx:pt>
          <cx:pt idx="444">BWR pro Tag</cx:pt>
          <cx:pt idx="445">BWR pro Tag</cx:pt>
          <cx:pt idx="446">BWR pro Tag</cx:pt>
          <cx:pt idx="447">BWR pro Tag</cx:pt>
          <cx:pt idx="448">BWR pro Tag</cx:pt>
          <cx:pt idx="449">BWR pro Tag</cx:pt>
          <cx:pt idx="450">BWR pro Tag</cx:pt>
          <cx:pt idx="451">BWR pro Tag</cx:pt>
          <cx:pt idx="452">BWR pro Tag</cx:pt>
          <cx:pt idx="453">BWR pro Tag</cx:pt>
          <cx:pt idx="454">BWR pro Tag</cx:pt>
          <cx:pt idx="455">BWR pro Tag</cx:pt>
          <cx:pt idx="456">BWR pro Tag</cx:pt>
          <cx:pt idx="457">BWR pro Tag</cx:pt>
          <cx:pt idx="458">BWR pro Tag</cx:pt>
          <cx:pt idx="459">BWR pro Tag</cx:pt>
          <cx:pt idx="460">BWR pro Tag</cx:pt>
          <cx:pt idx="461">BWR pro Tag</cx:pt>
          <cx:pt idx="462">BWR pro Tag</cx:pt>
          <cx:pt idx="463">BWR pro Tag</cx:pt>
          <cx:pt idx="464">BWR pro Tag</cx:pt>
          <cx:pt idx="465">BWR pro Tag</cx:pt>
          <cx:pt idx="466">BWR pro Tag</cx:pt>
          <cx:pt idx="467">BWR pro Tag</cx:pt>
          <cx:pt idx="468">BWR pro Tag</cx:pt>
          <cx:pt idx="469">BWR pro Tag</cx:pt>
          <cx:pt idx="470">BWR pro Tag</cx:pt>
          <cx:pt idx="471">BWR pro Tag</cx:pt>
          <cx:pt idx="472">BWR pro Tag</cx:pt>
          <cx:pt idx="473">BWR pro Tag</cx:pt>
          <cx:pt idx="474">BWR pro Tag</cx:pt>
          <cx:pt idx="475">BWR pro Tag</cx:pt>
          <cx:pt idx="476">BWR pro Tag</cx:pt>
          <cx:pt idx="477">BWR pro Tag</cx:pt>
          <cx:pt idx="478">BWR pro Tag</cx:pt>
          <cx:pt idx="479">BWR pro Tag</cx:pt>
          <cx:pt idx="480">BWR pro Tag</cx:pt>
          <cx:pt idx="481">BWR pro Tag</cx:pt>
          <cx:pt idx="482">BWR pro Tag</cx:pt>
          <cx:pt idx="483">BWR pro Tag</cx:pt>
          <cx:pt idx="484">BWR pro Tag</cx:pt>
          <cx:pt idx="485">BWR pro Tag</cx:pt>
          <cx:pt idx="486">BWR pro Tag</cx:pt>
          <cx:pt idx="487">BWR pro Tag</cx:pt>
          <cx:pt idx="488">BWR pro Tag</cx:pt>
          <cx:pt idx="489">BWR pro Tag</cx:pt>
          <cx:pt idx="490">BWR pro Tag</cx:pt>
          <cx:pt idx="491">BWR pro Tag</cx:pt>
          <cx:pt idx="492">BWR pro Tag</cx:pt>
          <cx:pt idx="493">BWR pro Tag</cx:pt>
          <cx:pt idx="494">BWR pro Tag</cx:pt>
          <cx:pt idx="495">BWR pro Tag</cx:pt>
          <cx:pt idx="496">BWR pro Tag</cx:pt>
          <cx:pt idx="497">BWR pro Tag</cx:pt>
          <cx:pt idx="498">BWR pro Tag</cx:pt>
          <cx:pt idx="499">BWR pro Tag</cx:pt>
          <cx:pt idx="500">BWR pro Tag</cx:pt>
          <cx:pt idx="501">BWR pro Tag</cx:pt>
          <cx:pt idx="502">BWR pro Tag</cx:pt>
          <cx:pt idx="503">BWR pro Tag</cx:pt>
          <cx:pt idx="504">BWR pro Tag</cx:pt>
          <cx:pt idx="505">BWR pro Tag</cx:pt>
          <cx:pt idx="506">BWR pro Tag</cx:pt>
          <cx:pt idx="507">BWR pro Tag</cx:pt>
          <cx:pt idx="508">BWR pro Tag</cx:pt>
          <cx:pt idx="509">BWR pro Tag</cx:pt>
          <cx:pt idx="510">BWR pro Tag</cx:pt>
          <cx:pt idx="511">BWR pro Tag</cx:pt>
          <cx:pt idx="512">BWR pro Tag</cx:pt>
          <cx:pt idx="513">BWR pro Tag</cx:pt>
          <cx:pt idx="514">BWR pro Tag</cx:pt>
          <cx:pt idx="515">BWR pro Tag</cx:pt>
          <cx:pt idx="516">BWR pro Tag</cx:pt>
          <cx:pt idx="517">BWR pro Tag</cx:pt>
          <cx:pt idx="518">BWR pro Tag</cx:pt>
          <cx:pt idx="519">BWR pro Tag</cx:pt>
        </cx:lvl>
      </cx:strDim>
      <cx:numDim type="val">
        <cx:lvl ptCount="520" formatCode="General">
          <cx:pt idx="0">0.062055555555555558</cx:pt>
          <cx:pt idx="1">0.07011111111111111</cx:pt>
          <cx:pt idx="2">0.070250000000000007</cx:pt>
          <cx:pt idx="3">0.072352941176470592</cx:pt>
          <cx:pt idx="4">0.080285714285714294</cx:pt>
          <cx:pt idx="5">0.081299999999999997</cx:pt>
          <cx:pt idx="6">0.085777777777777786</cx:pt>
          <cx:pt idx="7">0.086535714285714285</cx:pt>
          <cx:pt idx="8">0.088058823529411773</cx:pt>
          <cx:pt idx="9">0.088269230769230766</cx:pt>
          <cx:pt idx="10">0.088555555555555554</cx:pt>
          <cx:pt idx="11">0.090999999999999998</cx:pt>
          <cx:pt idx="12">0.091333333333333336</cx:pt>
          <cx:pt idx="13">0.092000000000000012</cx:pt>
          <cx:pt idx="14">0.092090909090909084</cx:pt>
          <cx:pt idx="15">0.092666666666666675</cx:pt>
          <cx:pt idx="16">0.092714285714285721</cx:pt>
          <cx:pt idx="17">0.097333333333333327</cx:pt>
          <cx:pt idx="18">0.1032666666666667</cx:pt>
          <cx:pt idx="19">0.1035135135135135</cx:pt>
          <cx:pt idx="20">0.10425</cx:pt>
          <cx:pt idx="21">0.1044411764705883</cx:pt>
          <cx:pt idx="22">0.1076</cx:pt>
          <cx:pt idx="23">0.10904</cx:pt>
          <cx:pt idx="24">0.1115</cx:pt>
          <cx:pt idx="25">0.1147777777777778</cx:pt>
          <cx:pt idx="26">0.1149473684210527</cx:pt>
          <cx:pt idx="27">0.115</cx:pt>
          <cx:pt idx="28">0.1171875</cx:pt>
          <cx:pt idx="29">0.1188125</cx:pt>
          <cx:pt idx="30">0.1195</cx:pt>
          <cx:pt idx="31">0.1248888888888889</cx:pt>
          <cx:pt idx="32">0.1248888888888889</cx:pt>
          <cx:pt idx="33">0.12527272727272731</cx:pt>
          <cx:pt idx="34">0.12572727272727269</cx:pt>
          <cx:pt idx="35">0.12625</cx:pt>
          <cx:pt idx="36">0.1280857142857143</cx:pt>
          <cx:pt idx="37">0.12841509433962259</cx:pt>
          <cx:pt idx="38">0.12866666666666671</cx:pt>
          <cx:pt idx="39">0.1306285714285714</cx:pt>
          <cx:pt idx="40">0.13257142857142859</cx:pt>
          <cx:pt idx="41">0.135125</cx:pt>
          <cx:pt idx="42">0.1356</cx:pt>
          <cx:pt idx="43">0.13566666666666671</cx:pt>
          <cx:pt idx="44">0.13822222222222219</cx:pt>
          <cx:pt idx="45">0.13822222222222219</cx:pt>
          <cx:pt idx="46">0.1383571428571429</cx:pt>
          <cx:pt idx="47">0.13902500000000001</cx:pt>
          <cx:pt idx="48">0.13919999999999999</cx:pt>
          <cx:pt idx="49">0.1421</cx:pt>
          <cx:pt idx="50">0.14236363636363639</cx:pt>
          <cx:pt idx="51">0.14279310344827589</cx:pt>
          <cx:pt idx="52">0.14333333333333331</cx:pt>
          <cx:pt idx="53">0.14399999999999999</cx:pt>
          <cx:pt idx="54">0.14599999999999999</cx:pt>
          <cx:pt idx="55">0.14937500000000001</cx:pt>
          <cx:pt idx="56">0.15015000000000001</cx:pt>
          <cx:pt idx="57">0.15042857142857141</cx:pt>
          <cx:pt idx="58">0.152</cx:pt>
          <cx:pt idx="59">0.15244444444444449</cx:pt>
          <cx:pt idx="60">0.15477777777777779</cx:pt>
          <cx:pt idx="61">0.1555</cx:pt>
          <cx:pt idx="62">0.1571666666666667</cx:pt>
          <cx:pt idx="63">0.15751724137931031</cx:pt>
          <cx:pt idx="64">0.1593</cx:pt>
          <cx:pt idx="65">0.1598</cx:pt>
          <cx:pt idx="66">0.16553846153846161</cx:pt>
          <cx:pt idx="67">0.16603703703703701</cx:pt>
          <cx:pt idx="68">0.16745454545454549</cx:pt>
          <cx:pt idx="69">0.1684285714285714</cx:pt>
          <cx:pt idx="70">0.17028571428571429</cx:pt>
          <cx:pt idx="71">0.170875</cx:pt>
          <cx:pt idx="72">0.17100000000000001</cx:pt>
          <cx:pt idx="73">0.17249999999999999</cx:pt>
          <cx:pt idx="74">0.17366666666666669</cx:pt>
          <cx:pt idx="75">0.17480000000000001</cx:pt>
          <cx:pt idx="76">0.1770714285714286</cx:pt>
          <cx:pt idx="77">0.17771428571428571</cx:pt>
          <cx:pt idx="78">0.1779032258064516</cx:pt>
          <cx:pt idx="79">0.17958333333333329</cx:pt>
          <cx:pt idx="80">0.1796666666666667</cx:pt>
          <cx:pt idx="81">0.1802</cx:pt>
          <cx:pt idx="82">0.18021999999999999</cx:pt>
          <cx:pt idx="83">0.18170588235294119</cx:pt>
          <cx:pt idx="84">0.1825</cx:pt>
          <cx:pt idx="85">0.18253846153846159</cx:pt>
          <cx:pt idx="86">0.1868823529411765</cx:pt>
          <cx:pt idx="87">0.1875</cx:pt>
          <cx:pt idx="88">0.1875</cx:pt>
          <cx:pt idx="89">0.188</cx:pt>
          <cx:pt idx="90">0.18830434782608699</cx:pt>
          <cx:pt idx="91">0.19009999999999999</cx:pt>
          <cx:pt idx="92">0.19868749999999999</cx:pt>
          <cx:pt idx="93">0.19950000000000001</cx:pt>
          <cx:pt idx="94">0.2010689655172414</cx:pt>
          <cx:pt idx="95">0.2020769230769231</cx:pt>
          <cx:pt idx="96">0.2025384615384615</cx:pt>
          <cx:pt idx="97">0.20275000000000001</cx:pt>
          <cx:pt idx="98">0.2034</cx:pt>
          <cx:pt idx="99">0.20466666666666669</cx:pt>
          <cx:pt idx="100">0.20511111111111111</cx:pt>
          <cx:pt idx="101">0.205375</cx:pt>
          <cx:pt idx="102">0.206175</cx:pt>
          <cx:pt idx="103">0.2085714285714286</cx:pt>
          <cx:pt idx="104">0.20859259259259261</cx:pt>
          <cx:pt idx="105">0.20933333333333329</cx:pt>
          <cx:pt idx="106">0.2112222222222222</cx:pt>
          <cx:pt idx="107">0.21193333333333331</cx:pt>
          <cx:pt idx="108">0.21199999999999999</cx:pt>
          <cx:pt idx="109">0.2126666666666667</cx:pt>
          <cx:pt idx="110">0.21509090909090911</cx:pt>
          <cx:pt idx="111">0.21657894736842109</cx:pt>
          <cx:pt idx="112">0.217</cx:pt>
          <cx:pt idx="113">0.21829999999999999</cx:pt>
          <cx:pt idx="114">0.219</cx:pt>
          <cx:pt idx="115">0.2195</cx:pt>
          <cx:pt idx="116">0.2198333333333333</cx:pt>
          <cx:pt idx="117">0.22459999999999999</cx:pt>
          <cx:pt idx="118">0.22638461538461541</cx:pt>
          <cx:pt idx="119">0.22638461538461541</cx:pt>
          <cx:pt idx="120">0.2268148148148148</cx:pt>
          <cx:pt idx="121">0.2269285714285714</cx:pt>
          <cx:pt idx="122">0.2271428571428572</cx:pt>
          <cx:pt idx="123">0.22714814814814821</cx:pt>
          <cx:pt idx="124">0.2278333333333333</cx:pt>
          <cx:pt idx="125">0.22792307692307689</cx:pt>
          <cx:pt idx="126">0.22950000000000001</cx:pt>
          <cx:pt idx="127">0.22970370370370369</cx:pt>
          <cx:pt idx="128">0.23025000000000001</cx:pt>
          <cx:pt idx="129">0.2323478260869565</cx:pt>
          <cx:pt idx="130">0.23236363636363641</cx:pt>
          <cx:pt idx="131">0.2355384615384615</cx:pt>
          <cx:pt idx="132">0.23583333333333331</cx:pt>
          <cx:pt idx="133">0.23583333333333331</cx:pt>
          <cx:pt idx="134">0.23583333333333331</cx:pt>
          <cx:pt idx="135">0.23622222222222219</cx:pt>
          <cx:pt idx="136">0.23699999999999999</cx:pt>
          <cx:pt idx="137">0.23728571428571429</cx:pt>
          <cx:pt idx="138">0.237625</cx:pt>
          <cx:pt idx="139">0.2389473684210526</cx:pt>
          <cx:pt idx="140">0.23899999999999999</cx:pt>
          <cx:pt idx="141">0.2394615384615385</cx:pt>
          <cx:pt idx="142">0.2398461538461539</cx:pt>
          <cx:pt idx="143">0.24054545454545451</cx:pt>
          <cx:pt idx="144">0.24424999999999999</cx:pt>
          <cx:pt idx="145">0.24438461538461539</cx:pt>
          <cx:pt idx="146">0.24442857142857141</cx:pt>
          <cx:pt idx="147">0.24442857142857141</cx:pt>
          <cx:pt idx="148">0.24453846153846151</cx:pt>
          <cx:pt idx="149">0.24625</cx:pt>
          <cx:pt idx="150">0.2463823529411765</cx:pt>
          <cx:pt idx="151">0.24783333333333341</cx:pt>
          <cx:pt idx="152">0.24845454545454551</cx:pt>
          <cx:pt idx="153">0.24959999999999999</cx:pt>
          <cx:pt idx="154">0.25024999999999997</cx:pt>
          <cx:pt idx="155">0.25077142857142848</cx:pt>
          <cx:pt idx="156">0.2525</cx:pt>
          <cx:pt idx="157">0.25352941176470578</cx:pt>
          <cx:pt idx="158">0.25924999999999998</cx:pt>
          <cx:pt idx="159">0.25963636363636361</cx:pt>
          <cx:pt idx="160">0.26058823529411762</cx:pt>
          <cx:pt idx="161">0.26169999999999999</cx:pt>
          <cx:pt idx="162">0.26371428571428568</cx:pt>
          <cx:pt idx="163">0.26531250000000001</cx:pt>
          <cx:pt idx="164">0.26578571428571429</cx:pt>
          <cx:pt idx="165">0.26600000000000001</cx:pt>
          <cx:pt idx="166">0.26816666666666672</cx:pt>
          <cx:pt idx="167">0.26900000000000002</cx:pt>
          <cx:pt idx="168">0.26905263157894738</cx:pt>
          <cx:pt idx="169">0.27231818181818179</cx:pt>
          <cx:pt idx="170">0.27281818181818179</cx:pt>
          <cx:pt idx="171">0.27339999999999998</cx:pt>
          <cx:pt idx="172">0.27339999999999998</cx:pt>
          <cx:pt idx="173">0.27339999999999998</cx:pt>
          <cx:pt idx="174">0.27403571428571433</cx:pt>
          <cx:pt idx="175">0.27546153846153848</cx:pt>
          <cx:pt idx="176">0.2771153846153846</cx:pt>
          <cx:pt idx="177">0.2771153846153846</cx:pt>
          <cx:pt idx="178">0.27712500000000001</cx:pt>
          <cx:pt idx="179">0.27800000000000002</cx:pt>
          <cx:pt idx="180">0.28090909090909089</cx:pt>
          <cx:pt idx="181">0.28206249999999999</cx:pt>
          <cx:pt idx="182">0.28239999999999998</cx:pt>
          <cx:pt idx="183">0.28249999999999997</cx:pt>
          <cx:pt idx="184">0.28275</cx:pt>
          <cx:pt idx="185">0.28299999999999997</cx:pt>
          <cx:pt idx="186">0.28516666666666668</cx:pt>
          <cx:pt idx="187">0.28620000000000001</cx:pt>
          <cx:pt idx="188">0.2864666666666667</cx:pt>
          <cx:pt idx="189">0.28733333333333327</cx:pt>
          <cx:pt idx="190">0.28772727272727272</cx:pt>
          <cx:pt idx="191">0.2890833333333333</cx:pt>
          <cx:pt idx="192">0.29063636363636358</cx:pt>
          <cx:pt idx="193">0.29257142857142859</cx:pt>
          <cx:pt idx="194">0.29575000000000001</cx:pt>
          <cx:pt idx="195">0.29845454545454547</cx:pt>
          <cx:pt idx="196">0.30015384615384622</cx:pt>
          <cx:pt idx="197">0.3009230769230769</cx:pt>
          <cx:pt idx="198">0.30299999999999999</cx:pt>
          <cx:pt idx="199">0.30299999999999999</cx:pt>
          <cx:pt idx="200">0.30321428571428571</cx:pt>
          <cx:pt idx="201">0.30321428571428571</cx:pt>
          <cx:pt idx="202">0.30407692307692308</cx:pt>
          <cx:pt idx="203">0.30447619047619051</cx:pt>
          <cx:pt idx="204">0.30692857142857138</cx:pt>
          <cx:pt idx="205">0.30725000000000002</cx:pt>
          <cx:pt idx="206">0.30825000000000002</cx:pt>
          <cx:pt idx="207">0.31059999999999999</cx:pt>
          <cx:pt idx="208">0.3115</cx:pt>
          <cx:pt idx="209">0.31180000000000002</cx:pt>
          <cx:pt idx="210">0.31562499999999999</cx:pt>
          <cx:pt idx="211">0.31683333333333341</cx:pt>
          <cx:pt idx="212">0.31769999999999998</cx:pt>
          <cx:pt idx="213">0.31769999999999998</cx:pt>
          <cx:pt idx="214">0.318</cx:pt>
          <cx:pt idx="215">0.32350000000000001</cx:pt>
          <cx:pt idx="216">0.3237647058823529</cx:pt>
          <cx:pt idx="217">0.32444444444444442</cx:pt>
          <cx:pt idx="218">0.32444444444444442</cx:pt>
          <cx:pt idx="219">0.32558333333333328</cx:pt>
          <cx:pt idx="220">0.32611111111111107</cx:pt>
          <cx:pt idx="221">0.32653846153846161</cx:pt>
          <cx:pt idx="222">0.32653846153846161</cx:pt>
          <cx:pt idx="223">0.33074999999999999</cx:pt>
          <cx:pt idx="224">0.33114285714285713</cx:pt>
          <cx:pt idx="225">0.3331578947368421</cx:pt>
          <cx:pt idx="226">0.33329999999999999</cx:pt>
          <cx:pt idx="227">0.33329999999999999</cx:pt>
          <cx:pt idx="228">0.33644444444444438</cx:pt>
          <cx:pt idx="229">0.33657142857142858</cx:pt>
          <cx:pt idx="230">0.33666666666666673</cx:pt>
          <cx:pt idx="231">0.33766666666666662</cx:pt>
          <cx:pt idx="232">0.34175</cx:pt>
          <cx:pt idx="233">0.34322222222222221</cx:pt>
          <cx:pt idx="234">0.34383999999999998</cx:pt>
          <cx:pt idx="235">0.34644444444444439</cx:pt>
          <cx:pt idx="236">0.34644444444444439</cx:pt>
          <cx:pt idx="237">0.34733333333333333</cx:pt>
          <cx:pt idx="238">0.35133333333333328</cx:pt>
          <cx:pt idx="239">0.35246153846153838</cx:pt>
          <cx:pt idx="240">0.3528</cx:pt>
          <cx:pt idx="241">0.35522222222222222</cx:pt>
          <cx:pt idx="242">0.35661538461538461</cx:pt>
          <cx:pt idx="243">0.35916666666666658</cx:pt>
          <cx:pt idx="244">0.35999999999999999</cx:pt>
          <cx:pt idx="245">0.36421739130434788</cx:pt>
          <cx:pt idx="246">0.36425000000000002</cx:pt>
          <cx:pt idx="247">0.36506666666666671</cx:pt>
          <cx:pt idx="248">0.36515789473684213</cx:pt>
          <cx:pt idx="249">0.36538095238095242</cx:pt>
          <cx:pt idx="250">0.36568965517241381</cx:pt>
          <cx:pt idx="251">0.376</cx:pt>
          <cx:pt idx="252">0.37611764705882361</cx:pt>
          <cx:pt idx="253">0.378</cx:pt>
          <cx:pt idx="254">0.38019999999999998</cx:pt>
          <cx:pt idx="255">0.38019999999999998</cx:pt>
          <cx:pt idx="256">0.38150000000000001</cx:pt>
          <cx:pt idx="257">0.38446666666666668</cx:pt>
          <cx:pt idx="258">0.38590909090909092</cx:pt>
          <cx:pt idx="259">0.38590909090909092</cx:pt>
          <cx:pt idx="260">0.38590909090909092</cx:pt>
          <cx:pt idx="261">0.38590909090909092</cx:pt>
          <cx:pt idx="262">0.38833333333333342</cx:pt>
          <cx:pt idx="263">0.39019999999999999</cx:pt>
          <cx:pt idx="264">0.39019999999999999</cx:pt>
          <cx:pt idx="265">0.39069999999999999</cx:pt>
          <cx:pt idx="266">0.39119999999999999</cx:pt>
          <cx:pt idx="267">0.395625</cx:pt>
          <cx:pt idx="268">0.395625</cx:pt>
          <cx:pt idx="269">0.39712500000000001</cx:pt>
          <cx:pt idx="270">0.39712500000000001</cx:pt>
          <cx:pt idx="271">0.39890476190476187</cx:pt>
          <cx:pt idx="272">0.39890476190476187</cx:pt>
          <cx:pt idx="273">0.40342857142857141</cx:pt>
          <cx:pt idx="274">0.40707692307692311</cx:pt>
          <cx:pt idx="275">0.40707692307692311</cx:pt>
          <cx:pt idx="276">0.40707692307692311</cx:pt>
          <cx:pt idx="277">0.40718749999999998</cx:pt>
          <cx:pt idx="278">0.40916666666666668</cx:pt>
          <cx:pt idx="279">0.40999999999999998</cx:pt>
          <cx:pt idx="280">0.41107692307692312</cx:pt>
          <cx:pt idx="281">0.41607142857142859</cx:pt>
          <cx:pt idx="282">0.41885000000000011</cx:pt>
          <cx:pt idx="283">0.42199999999999999</cx:pt>
          <cx:pt idx="284">0.42199999999999999</cx:pt>
          <cx:pt idx="285">0.42382352941176471</cx:pt>
          <cx:pt idx="286">0.42449999999999999</cx:pt>
          <cx:pt idx="287">0.42449999999999999</cx:pt>
          <cx:pt idx="288">0.42449999999999999</cx:pt>
          <cx:pt idx="289">0.42599999999999999</cx:pt>
          <cx:pt idx="290">0.42775000000000002</cx:pt>
          <cx:pt idx="291">0.42775000000000002</cx:pt>
          <cx:pt idx="292">0.42775000000000002</cx:pt>
          <cx:pt idx="293">0.42792857142857138</cx:pt>
          <cx:pt idx="294">0.42890909090909091</cx:pt>
          <cx:pt idx="295">0.43016666666666659</cx:pt>
          <cx:pt idx="296">0.4325</cx:pt>
          <cx:pt idx="297">0.43371428571428572</cx:pt>
          <cx:pt idx="298">0.43446153846153851</cx:pt>
          <cx:pt idx="299">0.43754545454545452</cx:pt>
          <cx:pt idx="300">0.44089473684210528</cx:pt>
          <cx:pt idx="301">0.44450000000000001</cx:pt>
          <cx:pt idx="302">0.44524999999999998</cx:pt>
          <cx:pt idx="303">0.4517647058823529</cx:pt>
          <cx:pt idx="304">0.45214285714285712</cx:pt>
          <cx:pt idx="305">0.452421052631579</cx:pt>
          <cx:pt idx="306">0.45300000000000001</cx:pt>
          <cx:pt idx="307">0.45400000000000001</cx:pt>
          <cx:pt idx="308">0.45627272727272727</cx:pt>
          <cx:pt idx="309">0.4576818181818183</cx:pt>
          <cx:pt idx="310">0.45866666666666661</cx:pt>
          <cx:pt idx="311">0.46011111111111108</cx:pt>
          <cx:pt idx="312">0.46084615384615379</cx:pt>
          <cx:pt idx="313">0.46187499999999998</cx:pt>
          <cx:pt idx="314">0.46216666666666673</cx:pt>
          <cx:pt idx="315">0.46285714285714291</cx:pt>
          <cx:pt idx="316">0.46472727272727271</cx:pt>
          <cx:pt idx="317">0.46538888888888891</cx:pt>
          <cx:pt idx="318">0.47166666666666668</cx:pt>
          <cx:pt idx="319">0.47166666666666668</cx:pt>
          <cx:pt idx="320">0.4718</cx:pt>
          <cx:pt idx="321">0.47363636363636358</cx:pt>
          <cx:pt idx="322">0.47525000000000001</cx:pt>
          <cx:pt idx="323">0.47575000000000001</cx:pt>
          <cx:pt idx="324">0.4768</cx:pt>
          <cx:pt idx="325">0.4795625</cx:pt>
          <cx:pt idx="326">0.48828571428571432</cx:pt>
          <cx:pt idx="327">0.49276470588235299</cx:pt>
          <cx:pt idx="328">0.49276470588235299</cx:pt>
          <cx:pt idx="329">0.49580000000000002</cx:pt>
          <cx:pt idx="330">0.49925000000000003</cx:pt>
          <cx:pt idx="331">0.50724999999999998</cx:pt>
          <cx:pt idx="332">0.51269999999999993</cx:pt>
          <cx:pt idx="333">0.52356250000000004</cx:pt>
          <cx:pt idx="334">0.52356250000000004</cx:pt>
          <cx:pt idx="335">0.52422222222222226</cx:pt>
          <cx:pt idx="336">0.52749999999999997</cx:pt>
          <cx:pt idx="337">0.5278571428571428</cx:pt>
          <cx:pt idx="338">0.53009090909090917</cx:pt>
          <cx:pt idx="339">0.53062500000000001</cx:pt>
          <cx:pt idx="340">0.53062500000000001</cx:pt>
          <cx:pt idx="341">0.53062500000000001</cx:pt>
          <cx:pt idx="342">0.53062500000000001</cx:pt>
          <cx:pt idx="343">0.53062500000000001</cx:pt>
          <cx:pt idx="344">0.53062500000000001</cx:pt>
          <cx:pt idx="345">0.53062500000000001</cx:pt>
          <cx:pt idx="346">0.53968421052631577</cx:pt>
          <cx:pt idx="347">0.54137500000000005</cx:pt>
          <cx:pt idx="348">0.54807142857142854</cx:pt>
          <cx:pt idx="349">0.55074999999999996</cx:pt>
          <cx:pt idx="350">0.55374999999999996</cx:pt>
          <cx:pt idx="351">0.55549999999999999</cx:pt>
          <cx:pt idx="352">0.56479999999999997</cx:pt>
          <cx:pt idx="353">0.5675</cx:pt>
          <cx:pt idx="354">0.56966666666666665</cx:pt>
          <cx:pt idx="355">0.56966666666666665</cx:pt>
          <cx:pt idx="356">0.56966666666666665</cx:pt>
          <cx:pt idx="357">0.57545454545454544</cx:pt>
          <cx:pt idx="358">0.57872727272727265</cx:pt>
          <cx:pt idx="359">0.57950000000000002</cx:pt>
          <cx:pt idx="360">0.58542857142857141</cx:pt>
          <cx:pt idx="361">0.58566666666666667</cx:pt>
          <cx:pt idx="362">0.58799999999999997</cx:pt>
          <cx:pt idx="363">0.59157142857142853</cx:pt>
          <cx:pt idx="364">0.59835714285714292</cx:pt>
          <cx:pt idx="365">0.59835714285714292</cx:pt>
          <cx:pt idx="366">0.59835714285714292</cx:pt>
          <cx:pt idx="367">0.60041666666666671</cx:pt>
          <cx:pt idx="368">0.60317647058823531</cx:pt>
          <cx:pt idx="369">0.60453846153846158</cx:pt>
          <cx:pt idx="370">0.60642857142857143</cx:pt>
          <cx:pt idx="371">0.60642857142857143</cx:pt>
          <cx:pt idx="372">0.60642857142857143</cx:pt>
          <cx:pt idx="373">0.60642857142857143</cx:pt>
          <cx:pt idx="374">0.60642857142857143</cx:pt>
          <cx:pt idx="375">0.60642857142857143</cx:pt>
          <cx:pt idx="376">0.61399999999999999</cx:pt>
          <cx:pt idx="377">0.61399999999999999</cx:pt>
          <cx:pt idx="378">0.6186666666666667</cx:pt>
          <cx:pt idx="379">0.62755555555555553</cx:pt>
          <cx:pt idx="380">0.62755555555555553</cx:pt>
          <cx:pt idx="381">0.62849999999999995</cx:pt>
          <cx:pt idx="382">0.63300000000000001</cx:pt>
          <cx:pt idx="383">0.63539999999999996</cx:pt>
          <cx:pt idx="384">0.63539999999999996</cx:pt>
          <cx:pt idx="385">0.63941666666666663</cx:pt>
          <cx:pt idx="386">0.64022222222222214</cx:pt>
          <cx:pt idx="387">0.64438461538461544</cx:pt>
          <cx:pt idx="388">0.64438461538461544</cx:pt>
          <cx:pt idx="389">0.64438461538461544</cx:pt>
          <cx:pt idx="390">0.64438461538461544</cx:pt>
          <cx:pt idx="391">0.64438461538461544</cx:pt>
          <cx:pt idx="392">0.6549166666666667</cx:pt>
          <cx:pt idx="393">0.66660000000000008</cx:pt>
          <cx:pt idx="394">0.67413333333333336</cx:pt>
          <cx:pt idx="395">0.6818333333333334</cx:pt>
          <cx:pt idx="396">0.6818333333333334</cx:pt>
          <cx:pt idx="397">0.69228571428571428</cx:pt>
          <cx:pt idx="398">0.69808333333333339</cx:pt>
          <cx:pt idx="399">0.69808333333333339</cx:pt>
          <cx:pt idx="400">0.69808333333333339</cx:pt>
          <cx:pt idx="401">0.70750000000000002</cx:pt>
          <cx:pt idx="402">0.70750000000000002</cx:pt>
          <cx:pt idx="403">0.70750000000000002</cx:pt>
          <cx:pt idx="404">0.70750000000000002</cx:pt>
          <cx:pt idx="405">0.70750000000000002</cx:pt>
          <cx:pt idx="406">0.70750000000000002</cx:pt>
          <cx:pt idx="407">0.70750000000000002</cx:pt>
          <cx:pt idx="408">0.70750000000000002</cx:pt>
          <cx:pt idx="409">0.70750000000000002</cx:pt>
          <cx:pt idx="410">0.7082857142857143</cx:pt>
          <cx:pt idx="411">0.71260000000000001</cx:pt>
          <cx:pt idx="412">0.71260000000000001</cx:pt>
          <cx:pt idx="413">0.71542857142857141</cx:pt>
          <cx:pt idx="414">0.71633333333333338</cx:pt>
          <cx:pt idx="415">0.72183333333333344</cx:pt>
          <cx:pt idx="416">0.72183333333333344</cx:pt>
          <cx:pt idx="417">0.72228571428571431</cx:pt>
          <cx:pt idx="418">0.73242857142857143</cx:pt>
          <cx:pt idx="419">0.75600000000000001</cx:pt>
          <cx:pt idx="420">0.75600000000000001</cx:pt>
          <cx:pt idx="421">0.75600000000000001</cx:pt>
          <cx:pt idx="422">0.76154545454545464</cx:pt>
          <cx:pt idx="423">0.76154545454545464</cx:pt>
          <cx:pt idx="424">0.76154545454545464</cx:pt>
          <cx:pt idx="425">0.77649999999999997</cx:pt>
          <cx:pt idx="426">0.77676923076923088</cx:pt>
          <cx:pt idx="427">0.77676923076923088</cx:pt>
          <cx:pt idx="428">0.78360000000000007</cx:pt>
          <cx:pt idx="429">0.78500000000000003</cx:pt>
          <cx:pt idx="430">0.78876923076923078</cx:pt>
          <cx:pt idx="431">0.79425000000000001</cx:pt>
          <cx:pt idx="432">0.79574999999999996</cx:pt>
          <cx:pt idx="433">0.82805882352941174</cx:pt>
          <cx:pt idx="434">0.82913333333333328</cx:pt>
          <cx:pt idx="435">0.82913333333333328</cx:pt>
          <cx:pt idx="436">0.83770000000000011</cx:pt>
          <cx:pt idx="437">0.84266666666666667</cx:pt>
          <cx:pt idx="438">0.84899999999999998</cx:pt>
          <cx:pt idx="439">0.84899999999999998</cx:pt>
          <cx:pt idx="440">0.84899999999999998</cx:pt>
          <cx:pt idx="441">0.84899999999999998</cx:pt>
          <cx:pt idx="442">0.84899999999999998</cx:pt>
          <cx:pt idx="443">0.84950000000000003</cx:pt>
          <cx:pt idx="444">0.84950000000000003</cx:pt>
          <cx:pt idx="445">0.86657142857142855</cx:pt>
          <cx:pt idx="446">0.88200000000000001</cx:pt>
          <cx:pt idx="447">0.88200000000000001</cx:pt>
          <cx:pt idx="448">0.88200000000000001</cx:pt>
          <cx:pt idx="449">0.89061538461538459</cx:pt>
          <cx:pt idx="450">0.90062500000000001</cx:pt>
          <cx:pt idx="451">0.90062500000000001</cx:pt>
          <cx:pt idx="452">0.90942857142857136</cx:pt>
          <cx:pt idx="453">0.90942857142857136</cx:pt>
          <cx:pt idx="454">0.90942857142857136</cx:pt>
          <cx:pt idx="455">0.95511111111111113</cx:pt>
          <cx:pt idx="456">0.95511111111111113</cx:pt>
          <cx:pt idx="457">0.96300000000000008</cx:pt>
          <cx:pt idx="458">0.96300000000000008</cx:pt>
          <cx:pt idx="459">0.99299999999999999</cx:pt>
          <cx:pt idx="460">0.99680000000000002</cx:pt>
          <cx:pt idx="461">0.99680000000000002</cx:pt>
          <cx:pt idx="462">1.0112000000000001</cx:pt>
          <cx:pt idx="463">1.0254000000000001</cx:pt>
          <cx:pt idx="464">1.0471250000000001</cx:pt>
          <cx:pt idx="465">1.0471250000000001</cx:pt>
          <cx:pt idx="466">1.0471250000000001</cx:pt>
          <cx:pt idx="467">1.0471250000000001</cx:pt>
          <cx:pt idx="468">1.0526666666666671</cx:pt>
          <cx:pt idx="469">1.0584</cx:pt>
          <cx:pt idx="470">1.0609999999999999</cx:pt>
          <cx:pt idx="471">1.0609999999999999</cx:pt>
          <cx:pt idx="472">1.0609999999999999</cx:pt>
          <cx:pt idx="473">1.0609999999999999</cx:pt>
          <cx:pt idx="474">1.06125</cx:pt>
          <cx:pt idx="475">1.06125</cx:pt>
          <cx:pt idx="476">1.06125</cx:pt>
          <cx:pt idx="477">1.06125</cx:pt>
          <cx:pt idx="478">1.06125</cx:pt>
          <cx:pt idx="479">1.06125</cx:pt>
          <cx:pt idx="480">1.06125</cx:pt>
          <cx:pt idx="481">1.06125</cx:pt>
          <cx:pt idx="482">1.06125</cx:pt>
          <cx:pt idx="483">1.06125</cx:pt>
          <cx:pt idx="484">1.06125</cx:pt>
          <cx:pt idx="485">1.1085</cx:pt>
          <cx:pt idx="486">1.1120000000000001</cx:pt>
          <cx:pt idx="487">1.1306363636363641</cx:pt>
          <cx:pt idx="488">1.1393333333333331</cx:pt>
          <cx:pt idx="489">1.1393333333333331</cx:pt>
          <cx:pt idx="490">1.1393333333333331</cx:pt>
          <cx:pt idx="491">1.1393333333333331</cx:pt>
          <cx:pt idx="492">1.1393333333333331</cx:pt>
          <cx:pt idx="493">1.1393333333333331</cx:pt>
          <cx:pt idx="494">1.16475</cx:pt>
          <cx:pt idx="495">1.1967142857142861</cx:pt>
          <cx:pt idx="496">1.1967142857142861</cx:pt>
          <cx:pt idx="497">1.1967142857142861</cx:pt>
          <cx:pt idx="498">1.1967142857142861</cx:pt>
          <cx:pt idx="499">1.2450000000000001</cx:pt>
          <cx:pt idx="500">1.2450000000000001</cx:pt>
          <cx:pt idx="501">1.2450000000000001</cx:pt>
          <cx:pt idx="502">1.264</cx:pt>
          <cx:pt idx="503">1.2817499999999999</cx:pt>
          <cx:pt idx="504">1.2817499999999999</cx:pt>
          <cx:pt idx="505">1.3088571428571429</cx:pt>
          <cx:pt idx="506">1.3088571428571429</cx:pt>
          <cx:pt idx="507">1.3088571428571429</cx:pt>
          <cx:pt idx="508">1.3126</cx:pt>
          <cx:pt idx="509">1.3126</cx:pt>
          <cx:pt idx="510">1.4035</cx:pt>
          <cx:pt idx="511">1.4139999999999999</cx:pt>
          <cx:pt idx="512">1.4139999999999999</cx:pt>
          <cx:pt idx="513">1.430857142857143</cx:pt>
          <cx:pt idx="514">1.4648571428571431</cx:pt>
          <cx:pt idx="515">1.5546249999999999</cx:pt>
          <cx:pt idx="516">1.5985</cx:pt>
          <cx:pt idx="517">1.7090000000000001</cx:pt>
          <cx:pt idx="518">1.77</cx:pt>
          <cx:pt idx="519">2.0508000000000002</cx:pt>
        </cx:lvl>
      </cx:numDim>
    </cx:data>
  </cx:chartData>
  <cx:chart>
    <cx:title pos="t" align="ctr" overlay="0">
      <cx:tx>
        <cx:txData>
          <cx:v/>
        </cx:txData>
      </cx:tx>
      <cx:txPr>
        <a:bodyPr spcFirstLastPara="1" vertOverflow="ellipsis" wrap="square" lIns="0" tIns="0" rIns="0" bIns="0" anchor="ctr" anchorCtr="1"/>
        <a:lstStyle/>
        <a:p>
          <a:pPr algn="ctr">
            <a:defRPr/>
          </a:pPr>
          <a:endParaRPr/>
        </a:p>
      </cx:txPr>
    </cx:title>
    <cx:plotArea>
      <cx:plotAreaRegion>
        <cx:series layoutId="boxWhisker" uniqueId="{4182C088-BBF1-40C3-8A6B-46B290DE937D}">
          <cx:dataId val="0"/>
          <cx:layoutPr>
            <cx:visibility meanLine="0" meanMarker="1" nonoutliers="0" outliers="1"/>
            <cx:statistics quartileMethod="exclusive"/>
          </cx:layoutPr>
        </cx:series>
      </cx:plotAreaRegion>
      <cx:axis id="0">
        <cx:catScaling gapWidth="1"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tickLabels/>
      </cx:axis>
      <cx:axis id="1">
        <cx:valScaling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majorGridlines/>
        <cx:tickLabels/>
      </cx:axis>
    </cx:plotArea>
  </cx:chart>
</cx:chartSpace>
</file>

<file path=ppt/charts/chartEx5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lvl ptCount="520">
          <cx:pt idx="0">Gewinn UC pro Tag</cx:pt>
          <cx:pt idx="1">Gewinn UC pro Tag</cx:pt>
          <cx:pt idx="2">Gewinn UC pro Tag</cx:pt>
          <cx:pt idx="3">Gewinn UC pro Tag</cx:pt>
          <cx:pt idx="4">Gewinn UC pro Tag</cx:pt>
          <cx:pt idx="5">Gewinn UC pro Tag</cx:pt>
          <cx:pt idx="6">Gewinn UC pro Tag</cx:pt>
          <cx:pt idx="7">Gewinn UC pro Tag</cx:pt>
          <cx:pt idx="8">Gewinn UC pro Tag</cx:pt>
          <cx:pt idx="9">Gewinn UC pro Tag</cx:pt>
          <cx:pt idx="10">Gewinn UC pro Tag</cx:pt>
          <cx:pt idx="11">Gewinn UC pro Tag</cx:pt>
          <cx:pt idx="12">Gewinn UC pro Tag</cx:pt>
          <cx:pt idx="13">Gewinn UC pro Tag</cx:pt>
          <cx:pt idx="14">Gewinn UC pro Tag</cx:pt>
          <cx:pt idx="15">Gewinn UC pro Tag</cx:pt>
          <cx:pt idx="16">Gewinn UC pro Tag</cx:pt>
          <cx:pt idx="17">Gewinn UC pro Tag</cx:pt>
          <cx:pt idx="18">Gewinn UC pro Tag</cx:pt>
          <cx:pt idx="19">Gewinn UC pro Tag</cx:pt>
          <cx:pt idx="20">Gewinn UC pro Tag</cx:pt>
          <cx:pt idx="21">Gewinn UC pro Tag</cx:pt>
          <cx:pt idx="22">Gewinn UC pro Tag</cx:pt>
          <cx:pt idx="23">Gewinn UC pro Tag</cx:pt>
          <cx:pt idx="24">Gewinn UC pro Tag</cx:pt>
          <cx:pt idx="25">Gewinn UC pro Tag</cx:pt>
          <cx:pt idx="26">Gewinn UC pro Tag</cx:pt>
          <cx:pt idx="27">Gewinn UC pro Tag</cx:pt>
          <cx:pt idx="28">Gewinn UC pro Tag</cx:pt>
          <cx:pt idx="29">Gewinn UC pro Tag</cx:pt>
          <cx:pt idx="30">Gewinn UC pro Tag</cx:pt>
          <cx:pt idx="31">Gewinn UC pro Tag</cx:pt>
          <cx:pt idx="32">Gewinn UC pro Tag</cx:pt>
          <cx:pt idx="33">Gewinn UC pro Tag</cx:pt>
          <cx:pt idx="34">Gewinn UC pro Tag</cx:pt>
          <cx:pt idx="35">Gewinn UC pro Tag</cx:pt>
          <cx:pt idx="36">Gewinn UC pro Tag</cx:pt>
          <cx:pt idx="37">Gewinn UC pro Tag</cx:pt>
          <cx:pt idx="38">Gewinn UC pro Tag</cx:pt>
          <cx:pt idx="39">Gewinn UC pro Tag</cx:pt>
          <cx:pt idx="40">Gewinn UC pro Tag</cx:pt>
          <cx:pt idx="41">Gewinn UC pro Tag</cx:pt>
          <cx:pt idx="42">Gewinn UC pro Tag</cx:pt>
          <cx:pt idx="43">Gewinn UC pro Tag</cx:pt>
          <cx:pt idx="44">Gewinn UC pro Tag</cx:pt>
          <cx:pt idx="45">Gewinn UC pro Tag</cx:pt>
          <cx:pt idx="46">Gewinn UC pro Tag</cx:pt>
          <cx:pt idx="47">Gewinn UC pro Tag</cx:pt>
          <cx:pt idx="48">Gewinn UC pro Tag</cx:pt>
          <cx:pt idx="49">Gewinn UC pro Tag</cx:pt>
          <cx:pt idx="50">Gewinn UC pro Tag</cx:pt>
          <cx:pt idx="51">Gewinn UC pro Tag</cx:pt>
          <cx:pt idx="52">Gewinn UC pro Tag</cx:pt>
          <cx:pt idx="53">Gewinn UC pro Tag</cx:pt>
          <cx:pt idx="54">Gewinn UC pro Tag</cx:pt>
          <cx:pt idx="55">Gewinn UC pro Tag</cx:pt>
          <cx:pt idx="56">Gewinn UC pro Tag</cx:pt>
          <cx:pt idx="57">Gewinn UC pro Tag</cx:pt>
          <cx:pt idx="58">Gewinn UC pro Tag</cx:pt>
          <cx:pt idx="59">Gewinn UC pro Tag</cx:pt>
          <cx:pt idx="60">Gewinn UC pro Tag</cx:pt>
          <cx:pt idx="61">Gewinn UC pro Tag</cx:pt>
          <cx:pt idx="62">Gewinn UC pro Tag</cx:pt>
          <cx:pt idx="63">Gewinn UC pro Tag</cx:pt>
          <cx:pt idx="64">Gewinn UC pro Tag</cx:pt>
          <cx:pt idx="65">Gewinn UC pro Tag</cx:pt>
          <cx:pt idx="66">Gewinn UC pro Tag</cx:pt>
          <cx:pt idx="67">Gewinn UC pro Tag</cx:pt>
          <cx:pt idx="68">Gewinn UC pro Tag</cx:pt>
          <cx:pt idx="69">Gewinn UC pro Tag</cx:pt>
          <cx:pt idx="70">Gewinn UC pro Tag</cx:pt>
          <cx:pt idx="71">Gewinn UC pro Tag</cx:pt>
          <cx:pt idx="72">Gewinn UC pro Tag</cx:pt>
          <cx:pt idx="73">Gewinn UC pro Tag</cx:pt>
          <cx:pt idx="74">Gewinn UC pro Tag</cx:pt>
          <cx:pt idx="75">Gewinn UC pro Tag</cx:pt>
          <cx:pt idx="76">Gewinn UC pro Tag</cx:pt>
          <cx:pt idx="77">Gewinn UC pro Tag</cx:pt>
          <cx:pt idx="78">Gewinn UC pro Tag</cx:pt>
          <cx:pt idx="79">Gewinn UC pro Tag</cx:pt>
          <cx:pt idx="80">Gewinn UC pro Tag</cx:pt>
          <cx:pt idx="81">Gewinn UC pro Tag</cx:pt>
          <cx:pt idx="82">Gewinn UC pro Tag</cx:pt>
          <cx:pt idx="83">Gewinn UC pro Tag</cx:pt>
          <cx:pt idx="84">Gewinn UC pro Tag</cx:pt>
          <cx:pt idx="85">Gewinn UC pro Tag</cx:pt>
          <cx:pt idx="86">Gewinn UC pro Tag</cx:pt>
          <cx:pt idx="87">Gewinn UC pro Tag</cx:pt>
          <cx:pt idx="88">Gewinn UC pro Tag</cx:pt>
          <cx:pt idx="89">Gewinn UC pro Tag</cx:pt>
          <cx:pt idx="90">Gewinn UC pro Tag</cx:pt>
          <cx:pt idx="91">Gewinn UC pro Tag</cx:pt>
          <cx:pt idx="92">Gewinn UC pro Tag</cx:pt>
          <cx:pt idx="93">Gewinn UC pro Tag</cx:pt>
          <cx:pt idx="94">Gewinn UC pro Tag</cx:pt>
          <cx:pt idx="95">Gewinn UC pro Tag</cx:pt>
          <cx:pt idx="96">Gewinn UC pro Tag</cx:pt>
          <cx:pt idx="97">Gewinn UC pro Tag</cx:pt>
          <cx:pt idx="98">Gewinn UC pro Tag</cx:pt>
          <cx:pt idx="99">Gewinn UC pro Tag</cx:pt>
          <cx:pt idx="100">Gewinn UC pro Tag</cx:pt>
          <cx:pt idx="101">Gewinn UC pro Tag</cx:pt>
          <cx:pt idx="102">Gewinn UC pro Tag</cx:pt>
          <cx:pt idx="103">Gewinn UC pro Tag</cx:pt>
          <cx:pt idx="104">Gewinn UC pro Tag</cx:pt>
          <cx:pt idx="105">Gewinn UC pro Tag</cx:pt>
          <cx:pt idx="106">Gewinn UC pro Tag</cx:pt>
          <cx:pt idx="107">Gewinn UC pro Tag</cx:pt>
          <cx:pt idx="108">Gewinn UC pro Tag</cx:pt>
          <cx:pt idx="109">Gewinn UC pro Tag</cx:pt>
          <cx:pt idx="110">Gewinn UC pro Tag</cx:pt>
          <cx:pt idx="111">Gewinn UC pro Tag</cx:pt>
          <cx:pt idx="112">Gewinn UC pro Tag</cx:pt>
          <cx:pt idx="113">Gewinn UC pro Tag</cx:pt>
          <cx:pt idx="114">Gewinn UC pro Tag</cx:pt>
          <cx:pt idx="115">Gewinn UC pro Tag</cx:pt>
          <cx:pt idx="116">Gewinn UC pro Tag</cx:pt>
          <cx:pt idx="117">Gewinn UC pro Tag</cx:pt>
          <cx:pt idx="118">Gewinn UC pro Tag</cx:pt>
          <cx:pt idx="119">Gewinn UC pro Tag</cx:pt>
          <cx:pt idx="120">Gewinn UC pro Tag</cx:pt>
          <cx:pt idx="121">Gewinn UC pro Tag</cx:pt>
          <cx:pt idx="122">Gewinn UC pro Tag</cx:pt>
          <cx:pt idx="123">Gewinn UC pro Tag</cx:pt>
          <cx:pt idx="124">Gewinn UC pro Tag</cx:pt>
          <cx:pt idx="125">Gewinn UC pro Tag</cx:pt>
          <cx:pt idx="126">Gewinn UC pro Tag</cx:pt>
          <cx:pt idx="127">Gewinn UC pro Tag</cx:pt>
          <cx:pt idx="128">Gewinn UC pro Tag</cx:pt>
          <cx:pt idx="129">Gewinn UC pro Tag</cx:pt>
          <cx:pt idx="130">Gewinn UC pro Tag</cx:pt>
          <cx:pt idx="131">Gewinn UC pro Tag</cx:pt>
          <cx:pt idx="132">Gewinn UC pro Tag</cx:pt>
          <cx:pt idx="133">Gewinn UC pro Tag</cx:pt>
          <cx:pt idx="134">Gewinn UC pro Tag</cx:pt>
          <cx:pt idx="135">Gewinn UC pro Tag</cx:pt>
          <cx:pt idx="136">Gewinn UC pro Tag</cx:pt>
          <cx:pt idx="137">Gewinn UC pro Tag</cx:pt>
          <cx:pt idx="138">Gewinn UC pro Tag</cx:pt>
          <cx:pt idx="139">Gewinn UC pro Tag</cx:pt>
          <cx:pt idx="140">Gewinn UC pro Tag</cx:pt>
          <cx:pt idx="141">Gewinn UC pro Tag</cx:pt>
          <cx:pt idx="142">Gewinn UC pro Tag</cx:pt>
          <cx:pt idx="143">Gewinn UC pro Tag</cx:pt>
          <cx:pt idx="144">Gewinn UC pro Tag</cx:pt>
          <cx:pt idx="145">Gewinn UC pro Tag</cx:pt>
          <cx:pt idx="146">Gewinn UC pro Tag</cx:pt>
          <cx:pt idx="147">Gewinn UC pro Tag</cx:pt>
          <cx:pt idx="148">Gewinn UC pro Tag</cx:pt>
          <cx:pt idx="149">Gewinn UC pro Tag</cx:pt>
          <cx:pt idx="150">Gewinn UC pro Tag</cx:pt>
          <cx:pt idx="151">Gewinn UC pro Tag</cx:pt>
          <cx:pt idx="152">Gewinn UC pro Tag</cx:pt>
          <cx:pt idx="153">Gewinn UC pro Tag</cx:pt>
          <cx:pt idx="154">Gewinn UC pro Tag</cx:pt>
          <cx:pt idx="155">Gewinn UC pro Tag</cx:pt>
          <cx:pt idx="156">Gewinn UC pro Tag</cx:pt>
          <cx:pt idx="157">Gewinn UC pro Tag</cx:pt>
          <cx:pt idx="158">Gewinn UC pro Tag</cx:pt>
          <cx:pt idx="159">Gewinn UC pro Tag</cx:pt>
          <cx:pt idx="160">Gewinn UC pro Tag</cx:pt>
          <cx:pt idx="161">Gewinn UC pro Tag</cx:pt>
          <cx:pt idx="162">Gewinn UC pro Tag</cx:pt>
          <cx:pt idx="163">Gewinn UC pro Tag</cx:pt>
          <cx:pt idx="164">Gewinn UC pro Tag</cx:pt>
          <cx:pt idx="165">Gewinn UC pro Tag</cx:pt>
          <cx:pt idx="166">Gewinn UC pro Tag</cx:pt>
          <cx:pt idx="167">Gewinn UC pro Tag</cx:pt>
          <cx:pt idx="168">Gewinn UC pro Tag</cx:pt>
          <cx:pt idx="169">Gewinn UC pro Tag</cx:pt>
          <cx:pt idx="170">Gewinn UC pro Tag</cx:pt>
          <cx:pt idx="171">Gewinn UC pro Tag</cx:pt>
          <cx:pt idx="172">Gewinn UC pro Tag</cx:pt>
          <cx:pt idx="173">Gewinn UC pro Tag</cx:pt>
          <cx:pt idx="174">Gewinn UC pro Tag</cx:pt>
          <cx:pt idx="175">Gewinn UC pro Tag</cx:pt>
          <cx:pt idx="176">Gewinn UC pro Tag</cx:pt>
          <cx:pt idx="177">Gewinn UC pro Tag</cx:pt>
          <cx:pt idx="178">Gewinn UC pro Tag</cx:pt>
          <cx:pt idx="179">Gewinn UC pro Tag</cx:pt>
          <cx:pt idx="180">Gewinn UC pro Tag</cx:pt>
          <cx:pt idx="181">Gewinn UC pro Tag</cx:pt>
          <cx:pt idx="182">Gewinn UC pro Tag</cx:pt>
          <cx:pt idx="183">Gewinn UC pro Tag</cx:pt>
          <cx:pt idx="184">Gewinn UC pro Tag</cx:pt>
          <cx:pt idx="185">Gewinn UC pro Tag</cx:pt>
          <cx:pt idx="186">Gewinn UC pro Tag</cx:pt>
          <cx:pt idx="187">Gewinn UC pro Tag</cx:pt>
          <cx:pt idx="188">Gewinn UC pro Tag</cx:pt>
          <cx:pt idx="189">Gewinn UC pro Tag</cx:pt>
          <cx:pt idx="190">Gewinn UC pro Tag</cx:pt>
          <cx:pt idx="191">Gewinn UC pro Tag</cx:pt>
          <cx:pt idx="192">Gewinn UC pro Tag</cx:pt>
          <cx:pt idx="193">Gewinn UC pro Tag</cx:pt>
          <cx:pt idx="194">Gewinn UC pro Tag</cx:pt>
          <cx:pt idx="195">Gewinn UC pro Tag</cx:pt>
          <cx:pt idx="196">Gewinn UC pro Tag</cx:pt>
          <cx:pt idx="197">Gewinn UC pro Tag</cx:pt>
          <cx:pt idx="198">Gewinn UC pro Tag</cx:pt>
          <cx:pt idx="199">Gewinn UC pro Tag</cx:pt>
          <cx:pt idx="200">Gewinn UC pro Tag</cx:pt>
          <cx:pt idx="201">Gewinn UC pro Tag</cx:pt>
          <cx:pt idx="202">Gewinn UC pro Tag</cx:pt>
          <cx:pt idx="203">Gewinn UC pro Tag</cx:pt>
          <cx:pt idx="204">Gewinn UC pro Tag</cx:pt>
          <cx:pt idx="205">Gewinn UC pro Tag</cx:pt>
          <cx:pt idx="206">Gewinn UC pro Tag</cx:pt>
          <cx:pt idx="207">Gewinn UC pro Tag</cx:pt>
          <cx:pt idx="208">Gewinn UC pro Tag</cx:pt>
          <cx:pt idx="209">Gewinn UC pro Tag</cx:pt>
          <cx:pt idx="210">Gewinn UC pro Tag</cx:pt>
          <cx:pt idx="211">Gewinn UC pro Tag</cx:pt>
          <cx:pt idx="212">Gewinn UC pro Tag</cx:pt>
          <cx:pt idx="213">Gewinn UC pro Tag</cx:pt>
          <cx:pt idx="214">Gewinn UC pro Tag</cx:pt>
          <cx:pt idx="215">Gewinn UC pro Tag</cx:pt>
          <cx:pt idx="216">Gewinn UC pro Tag</cx:pt>
          <cx:pt idx="217">Gewinn UC pro Tag</cx:pt>
          <cx:pt idx="218">Gewinn UC pro Tag</cx:pt>
          <cx:pt idx="219">Gewinn UC pro Tag</cx:pt>
          <cx:pt idx="220">Gewinn UC pro Tag</cx:pt>
          <cx:pt idx="221">Gewinn UC pro Tag</cx:pt>
          <cx:pt idx="222">Gewinn UC pro Tag</cx:pt>
          <cx:pt idx="223">Gewinn UC pro Tag</cx:pt>
          <cx:pt idx="224">Gewinn UC pro Tag</cx:pt>
          <cx:pt idx="225">Gewinn UC pro Tag</cx:pt>
          <cx:pt idx="226">Gewinn UC pro Tag</cx:pt>
          <cx:pt idx="227">Gewinn UC pro Tag</cx:pt>
          <cx:pt idx="228">Gewinn UC pro Tag</cx:pt>
          <cx:pt idx="229">Gewinn UC pro Tag</cx:pt>
          <cx:pt idx="230">Gewinn UC pro Tag</cx:pt>
          <cx:pt idx="231">Gewinn UC pro Tag</cx:pt>
          <cx:pt idx="232">Gewinn UC pro Tag</cx:pt>
          <cx:pt idx="233">Gewinn UC pro Tag</cx:pt>
          <cx:pt idx="234">Gewinn UC pro Tag</cx:pt>
          <cx:pt idx="235">Gewinn UC pro Tag</cx:pt>
          <cx:pt idx="236">Gewinn UC pro Tag</cx:pt>
          <cx:pt idx="237">Gewinn UC pro Tag</cx:pt>
          <cx:pt idx="238">Gewinn UC pro Tag</cx:pt>
          <cx:pt idx="239">Gewinn UC pro Tag</cx:pt>
          <cx:pt idx="240">Gewinn UC pro Tag</cx:pt>
          <cx:pt idx="241">Gewinn UC pro Tag</cx:pt>
          <cx:pt idx="242">Gewinn UC pro Tag</cx:pt>
          <cx:pt idx="243">Gewinn UC pro Tag</cx:pt>
          <cx:pt idx="244">Gewinn UC pro Tag</cx:pt>
          <cx:pt idx="245">Gewinn UC pro Tag</cx:pt>
          <cx:pt idx="246">Gewinn UC pro Tag</cx:pt>
          <cx:pt idx="247">Gewinn UC pro Tag</cx:pt>
          <cx:pt idx="248">Gewinn UC pro Tag</cx:pt>
          <cx:pt idx="249">Gewinn UC pro Tag</cx:pt>
          <cx:pt idx="250">Gewinn UC pro Tag</cx:pt>
          <cx:pt idx="251">Gewinn UC pro Tag</cx:pt>
          <cx:pt idx="252">Gewinn UC pro Tag</cx:pt>
          <cx:pt idx="253">Gewinn UC pro Tag</cx:pt>
          <cx:pt idx="254">Gewinn UC pro Tag</cx:pt>
          <cx:pt idx="255">Gewinn UC pro Tag</cx:pt>
          <cx:pt idx="256">Gewinn UC pro Tag</cx:pt>
          <cx:pt idx="257">Gewinn UC pro Tag</cx:pt>
          <cx:pt idx="258">Gewinn UC pro Tag</cx:pt>
          <cx:pt idx="259">Gewinn UC pro Tag</cx:pt>
          <cx:pt idx="260">Gewinn UC pro Tag</cx:pt>
          <cx:pt idx="261">Gewinn UC pro Tag</cx:pt>
          <cx:pt idx="262">Gewinn UC pro Tag</cx:pt>
          <cx:pt idx="263">Gewinn UC pro Tag</cx:pt>
          <cx:pt idx="264">Gewinn UC pro Tag</cx:pt>
          <cx:pt idx="265">Gewinn UC pro Tag</cx:pt>
          <cx:pt idx="266">Gewinn UC pro Tag</cx:pt>
          <cx:pt idx="267">Gewinn UC pro Tag</cx:pt>
          <cx:pt idx="268">Gewinn UC pro Tag</cx:pt>
          <cx:pt idx="269">Gewinn UC pro Tag</cx:pt>
          <cx:pt idx="270">Gewinn UC pro Tag</cx:pt>
          <cx:pt idx="271">Gewinn UC pro Tag</cx:pt>
          <cx:pt idx="272">Gewinn UC pro Tag</cx:pt>
          <cx:pt idx="273">Gewinn UC pro Tag</cx:pt>
          <cx:pt idx="274">Gewinn UC pro Tag</cx:pt>
          <cx:pt idx="275">Gewinn UC pro Tag</cx:pt>
          <cx:pt idx="276">Gewinn UC pro Tag</cx:pt>
          <cx:pt idx="277">Gewinn UC pro Tag</cx:pt>
          <cx:pt idx="278">Gewinn UC pro Tag</cx:pt>
          <cx:pt idx="279">Gewinn UC pro Tag</cx:pt>
          <cx:pt idx="280">Gewinn UC pro Tag</cx:pt>
          <cx:pt idx="281">Gewinn UC pro Tag</cx:pt>
          <cx:pt idx="282">Gewinn UC pro Tag</cx:pt>
          <cx:pt idx="283">Gewinn UC pro Tag</cx:pt>
          <cx:pt idx="284">Gewinn UC pro Tag</cx:pt>
          <cx:pt idx="285">Gewinn UC pro Tag</cx:pt>
          <cx:pt idx="286">Gewinn UC pro Tag</cx:pt>
          <cx:pt idx="287">Gewinn UC pro Tag</cx:pt>
          <cx:pt idx="288">Gewinn UC pro Tag</cx:pt>
          <cx:pt idx="289">Gewinn UC pro Tag</cx:pt>
          <cx:pt idx="290">Gewinn UC pro Tag</cx:pt>
          <cx:pt idx="291">Gewinn UC pro Tag</cx:pt>
          <cx:pt idx="292">Gewinn UC pro Tag</cx:pt>
          <cx:pt idx="293">Gewinn UC pro Tag</cx:pt>
          <cx:pt idx="294">Gewinn UC pro Tag</cx:pt>
          <cx:pt idx="295">Gewinn UC pro Tag</cx:pt>
          <cx:pt idx="296">Gewinn UC pro Tag</cx:pt>
          <cx:pt idx="297">Gewinn UC pro Tag</cx:pt>
          <cx:pt idx="298">Gewinn UC pro Tag</cx:pt>
          <cx:pt idx="299">Gewinn UC pro Tag</cx:pt>
          <cx:pt idx="300">Gewinn UC pro Tag</cx:pt>
          <cx:pt idx="301">Gewinn UC pro Tag</cx:pt>
          <cx:pt idx="302">Gewinn UC pro Tag</cx:pt>
          <cx:pt idx="303">Gewinn UC pro Tag</cx:pt>
          <cx:pt idx="304">Gewinn UC pro Tag</cx:pt>
          <cx:pt idx="305">Gewinn UC pro Tag</cx:pt>
          <cx:pt idx="306">Gewinn UC pro Tag</cx:pt>
          <cx:pt idx="307">Gewinn UC pro Tag</cx:pt>
          <cx:pt idx="308">Gewinn UC pro Tag</cx:pt>
          <cx:pt idx="309">Gewinn UC pro Tag</cx:pt>
          <cx:pt idx="310">Gewinn UC pro Tag</cx:pt>
          <cx:pt idx="311">Gewinn UC pro Tag</cx:pt>
          <cx:pt idx="312">Gewinn UC pro Tag</cx:pt>
          <cx:pt idx="313">Gewinn UC pro Tag</cx:pt>
          <cx:pt idx="314">Gewinn UC pro Tag</cx:pt>
          <cx:pt idx="315">Gewinn UC pro Tag</cx:pt>
          <cx:pt idx="316">Gewinn UC pro Tag</cx:pt>
          <cx:pt idx="317">Gewinn UC pro Tag</cx:pt>
          <cx:pt idx="318">Gewinn UC pro Tag</cx:pt>
          <cx:pt idx="319">Gewinn UC pro Tag</cx:pt>
          <cx:pt idx="320">Gewinn UC pro Tag</cx:pt>
          <cx:pt idx="321">Gewinn UC pro Tag</cx:pt>
          <cx:pt idx="322">Gewinn UC pro Tag</cx:pt>
          <cx:pt idx="323">Gewinn UC pro Tag</cx:pt>
          <cx:pt idx="324">Gewinn UC pro Tag</cx:pt>
          <cx:pt idx="325">Gewinn UC pro Tag</cx:pt>
          <cx:pt idx="326">Gewinn UC pro Tag</cx:pt>
          <cx:pt idx="327">Gewinn UC pro Tag</cx:pt>
          <cx:pt idx="328">Gewinn UC pro Tag</cx:pt>
          <cx:pt idx="329">Gewinn UC pro Tag</cx:pt>
          <cx:pt idx="330">Gewinn UC pro Tag</cx:pt>
          <cx:pt idx="331">Gewinn UC pro Tag</cx:pt>
          <cx:pt idx="332">Gewinn UC pro Tag</cx:pt>
          <cx:pt idx="333">Gewinn UC pro Tag</cx:pt>
          <cx:pt idx="334">Gewinn UC pro Tag</cx:pt>
          <cx:pt idx="335">Gewinn UC pro Tag</cx:pt>
          <cx:pt idx="336">Gewinn UC pro Tag</cx:pt>
          <cx:pt idx="337">Gewinn UC pro Tag</cx:pt>
          <cx:pt idx="338">Gewinn UC pro Tag</cx:pt>
          <cx:pt idx="339">Gewinn UC pro Tag</cx:pt>
          <cx:pt idx="340">Gewinn UC pro Tag</cx:pt>
          <cx:pt idx="341">Gewinn UC pro Tag</cx:pt>
          <cx:pt idx="342">Gewinn UC pro Tag</cx:pt>
          <cx:pt idx="343">Gewinn UC pro Tag</cx:pt>
          <cx:pt idx="344">Gewinn UC pro Tag</cx:pt>
          <cx:pt idx="345">Gewinn UC pro Tag</cx:pt>
          <cx:pt idx="346">Gewinn UC pro Tag</cx:pt>
          <cx:pt idx="347">Gewinn UC pro Tag</cx:pt>
          <cx:pt idx="348">Gewinn UC pro Tag</cx:pt>
          <cx:pt idx="349">Gewinn UC pro Tag</cx:pt>
          <cx:pt idx="350">Gewinn UC pro Tag</cx:pt>
          <cx:pt idx="351">Gewinn UC pro Tag</cx:pt>
          <cx:pt idx="352">Gewinn UC pro Tag</cx:pt>
          <cx:pt idx="353">Gewinn UC pro Tag</cx:pt>
          <cx:pt idx="354">Gewinn UC pro Tag</cx:pt>
          <cx:pt idx="355">Gewinn UC pro Tag</cx:pt>
          <cx:pt idx="356">Gewinn UC pro Tag</cx:pt>
          <cx:pt idx="357">Gewinn UC pro Tag</cx:pt>
          <cx:pt idx="358">Gewinn UC pro Tag</cx:pt>
          <cx:pt idx="359">Gewinn UC pro Tag</cx:pt>
          <cx:pt idx="360">Gewinn UC pro Tag</cx:pt>
          <cx:pt idx="361">Gewinn UC pro Tag</cx:pt>
          <cx:pt idx="362">Gewinn UC pro Tag</cx:pt>
          <cx:pt idx="363">Gewinn UC pro Tag</cx:pt>
          <cx:pt idx="364">Gewinn UC pro Tag</cx:pt>
          <cx:pt idx="365">Gewinn UC pro Tag</cx:pt>
          <cx:pt idx="366">Gewinn UC pro Tag</cx:pt>
          <cx:pt idx="367">Gewinn UC pro Tag</cx:pt>
          <cx:pt idx="368">Gewinn UC pro Tag</cx:pt>
          <cx:pt idx="369">Gewinn UC pro Tag</cx:pt>
          <cx:pt idx="370">Gewinn UC pro Tag</cx:pt>
          <cx:pt idx="371">Gewinn UC pro Tag</cx:pt>
          <cx:pt idx="372">Gewinn UC pro Tag</cx:pt>
          <cx:pt idx="373">Gewinn UC pro Tag</cx:pt>
          <cx:pt idx="374">Gewinn UC pro Tag</cx:pt>
          <cx:pt idx="375">Gewinn UC pro Tag</cx:pt>
          <cx:pt idx="376">Gewinn UC pro Tag</cx:pt>
          <cx:pt idx="377">Gewinn UC pro Tag</cx:pt>
          <cx:pt idx="378">Gewinn UC pro Tag</cx:pt>
          <cx:pt idx="379">Gewinn UC pro Tag</cx:pt>
          <cx:pt idx="380">Gewinn UC pro Tag</cx:pt>
          <cx:pt idx="381">Gewinn UC pro Tag</cx:pt>
          <cx:pt idx="382">Gewinn UC pro Tag</cx:pt>
          <cx:pt idx="383">Gewinn UC pro Tag</cx:pt>
          <cx:pt idx="384">Gewinn UC pro Tag</cx:pt>
          <cx:pt idx="385">Gewinn UC pro Tag</cx:pt>
          <cx:pt idx="386">Gewinn UC pro Tag</cx:pt>
          <cx:pt idx="387">Gewinn UC pro Tag</cx:pt>
          <cx:pt idx="388">Gewinn UC pro Tag</cx:pt>
          <cx:pt idx="389">Gewinn UC pro Tag</cx:pt>
          <cx:pt idx="390">Gewinn UC pro Tag</cx:pt>
          <cx:pt idx="391">Gewinn UC pro Tag</cx:pt>
          <cx:pt idx="392">Gewinn UC pro Tag</cx:pt>
          <cx:pt idx="393">Gewinn UC pro Tag</cx:pt>
          <cx:pt idx="394">Gewinn UC pro Tag</cx:pt>
          <cx:pt idx="395">Gewinn UC pro Tag</cx:pt>
          <cx:pt idx="396">Gewinn UC pro Tag</cx:pt>
          <cx:pt idx="397">Gewinn UC pro Tag</cx:pt>
          <cx:pt idx="398">Gewinn UC pro Tag</cx:pt>
          <cx:pt idx="399">Gewinn UC pro Tag</cx:pt>
          <cx:pt idx="400">Gewinn UC pro Tag</cx:pt>
          <cx:pt idx="401">Gewinn UC pro Tag</cx:pt>
          <cx:pt idx="402">Gewinn UC pro Tag</cx:pt>
          <cx:pt idx="403">Gewinn UC pro Tag</cx:pt>
          <cx:pt idx="404">Gewinn UC pro Tag</cx:pt>
          <cx:pt idx="405">Gewinn UC pro Tag</cx:pt>
          <cx:pt idx="406">Gewinn UC pro Tag</cx:pt>
          <cx:pt idx="407">Gewinn UC pro Tag</cx:pt>
          <cx:pt idx="408">Gewinn UC pro Tag</cx:pt>
          <cx:pt idx="409">Gewinn UC pro Tag</cx:pt>
          <cx:pt idx="410">Gewinn UC pro Tag</cx:pt>
          <cx:pt idx="411">Gewinn UC pro Tag</cx:pt>
          <cx:pt idx="412">Gewinn UC pro Tag</cx:pt>
          <cx:pt idx="413">Gewinn UC pro Tag</cx:pt>
          <cx:pt idx="414">Gewinn UC pro Tag</cx:pt>
          <cx:pt idx="415">Gewinn UC pro Tag</cx:pt>
          <cx:pt idx="416">Gewinn UC pro Tag</cx:pt>
          <cx:pt idx="417">Gewinn UC pro Tag</cx:pt>
          <cx:pt idx="418">Gewinn UC pro Tag</cx:pt>
          <cx:pt idx="419">Gewinn UC pro Tag</cx:pt>
          <cx:pt idx="420">Gewinn UC pro Tag</cx:pt>
          <cx:pt idx="421">Gewinn UC pro Tag</cx:pt>
          <cx:pt idx="422">Gewinn UC pro Tag</cx:pt>
          <cx:pt idx="423">Gewinn UC pro Tag</cx:pt>
          <cx:pt idx="424">Gewinn UC pro Tag</cx:pt>
          <cx:pt idx="425">Gewinn UC pro Tag</cx:pt>
          <cx:pt idx="426">Gewinn UC pro Tag</cx:pt>
          <cx:pt idx="427">Gewinn UC pro Tag</cx:pt>
          <cx:pt idx="428">Gewinn UC pro Tag</cx:pt>
          <cx:pt idx="429">Gewinn UC pro Tag</cx:pt>
          <cx:pt idx="430">Gewinn UC pro Tag</cx:pt>
          <cx:pt idx="431">Gewinn UC pro Tag</cx:pt>
          <cx:pt idx="432">Gewinn UC pro Tag</cx:pt>
          <cx:pt idx="433">Gewinn UC pro Tag</cx:pt>
          <cx:pt idx="434">Gewinn UC pro Tag</cx:pt>
          <cx:pt idx="435">Gewinn UC pro Tag</cx:pt>
          <cx:pt idx="436">Gewinn UC pro Tag</cx:pt>
          <cx:pt idx="437">Gewinn UC pro Tag</cx:pt>
          <cx:pt idx="438">Gewinn UC pro Tag</cx:pt>
          <cx:pt idx="439">Gewinn UC pro Tag</cx:pt>
          <cx:pt idx="440">Gewinn UC pro Tag</cx:pt>
          <cx:pt idx="441">Gewinn UC pro Tag</cx:pt>
          <cx:pt idx="442">Gewinn UC pro Tag</cx:pt>
          <cx:pt idx="443">Gewinn UC pro Tag</cx:pt>
          <cx:pt idx="444">Gewinn UC pro Tag</cx:pt>
          <cx:pt idx="445">Gewinn UC pro Tag</cx:pt>
          <cx:pt idx="446">Gewinn UC pro Tag</cx:pt>
          <cx:pt idx="447">Gewinn UC pro Tag</cx:pt>
          <cx:pt idx="448">Gewinn UC pro Tag</cx:pt>
          <cx:pt idx="449">Gewinn UC pro Tag</cx:pt>
          <cx:pt idx="450">Gewinn UC pro Tag</cx:pt>
          <cx:pt idx="451">Gewinn UC pro Tag</cx:pt>
          <cx:pt idx="452">Gewinn UC pro Tag</cx:pt>
          <cx:pt idx="453">Gewinn UC pro Tag</cx:pt>
          <cx:pt idx="454">Gewinn UC pro Tag</cx:pt>
          <cx:pt idx="455">Gewinn UC pro Tag</cx:pt>
          <cx:pt idx="456">Gewinn UC pro Tag</cx:pt>
          <cx:pt idx="457">Gewinn UC pro Tag</cx:pt>
          <cx:pt idx="458">Gewinn UC pro Tag</cx:pt>
          <cx:pt idx="459">Gewinn UC pro Tag</cx:pt>
          <cx:pt idx="460">Gewinn UC pro Tag</cx:pt>
          <cx:pt idx="461">Gewinn UC pro Tag</cx:pt>
          <cx:pt idx="462">Gewinn UC pro Tag</cx:pt>
          <cx:pt idx="463">Gewinn UC pro Tag</cx:pt>
          <cx:pt idx="464">Gewinn UC pro Tag</cx:pt>
          <cx:pt idx="465">Gewinn UC pro Tag</cx:pt>
          <cx:pt idx="466">Gewinn UC pro Tag</cx:pt>
          <cx:pt idx="467">Gewinn UC pro Tag</cx:pt>
          <cx:pt idx="468">Gewinn UC pro Tag</cx:pt>
          <cx:pt idx="469">Gewinn UC pro Tag</cx:pt>
          <cx:pt idx="470">Gewinn UC pro Tag</cx:pt>
          <cx:pt idx="471">Gewinn UC pro Tag</cx:pt>
          <cx:pt idx="472">Gewinn UC pro Tag</cx:pt>
          <cx:pt idx="473">Gewinn UC pro Tag</cx:pt>
          <cx:pt idx="474">Gewinn UC pro Tag</cx:pt>
          <cx:pt idx="475">Gewinn UC pro Tag</cx:pt>
          <cx:pt idx="476">Gewinn UC pro Tag</cx:pt>
          <cx:pt idx="477">Gewinn UC pro Tag</cx:pt>
          <cx:pt idx="478">Gewinn UC pro Tag</cx:pt>
          <cx:pt idx="479">Gewinn UC pro Tag</cx:pt>
          <cx:pt idx="480">Gewinn UC pro Tag</cx:pt>
          <cx:pt idx="481">Gewinn UC pro Tag</cx:pt>
          <cx:pt idx="482">Gewinn UC pro Tag</cx:pt>
          <cx:pt idx="483">Gewinn UC pro Tag</cx:pt>
          <cx:pt idx="484">Gewinn UC pro Tag</cx:pt>
          <cx:pt idx="485">Gewinn UC pro Tag</cx:pt>
          <cx:pt idx="486">Gewinn UC pro Tag</cx:pt>
          <cx:pt idx="487">Gewinn UC pro Tag</cx:pt>
          <cx:pt idx="488">Gewinn UC pro Tag</cx:pt>
          <cx:pt idx="489">Gewinn UC pro Tag</cx:pt>
          <cx:pt idx="490">Gewinn UC pro Tag</cx:pt>
          <cx:pt idx="491">Gewinn UC pro Tag</cx:pt>
          <cx:pt idx="492">Gewinn UC pro Tag</cx:pt>
          <cx:pt idx="493">Gewinn UC pro Tag</cx:pt>
          <cx:pt idx="494">Gewinn UC pro Tag</cx:pt>
          <cx:pt idx="495">Gewinn UC pro Tag</cx:pt>
          <cx:pt idx="496">Gewinn UC pro Tag</cx:pt>
          <cx:pt idx="497">Gewinn UC pro Tag</cx:pt>
          <cx:pt idx="498">Gewinn UC pro Tag</cx:pt>
          <cx:pt idx="499">Gewinn UC pro Tag</cx:pt>
          <cx:pt idx="500">Gewinn UC pro Tag</cx:pt>
          <cx:pt idx="501">Gewinn UC pro Tag</cx:pt>
          <cx:pt idx="502">Gewinn UC pro Tag</cx:pt>
          <cx:pt idx="503">Gewinn UC pro Tag</cx:pt>
          <cx:pt idx="504">Gewinn UC pro Tag</cx:pt>
          <cx:pt idx="505">Gewinn UC pro Tag</cx:pt>
          <cx:pt idx="506">Gewinn UC pro Tag</cx:pt>
          <cx:pt idx="507">Gewinn UC pro Tag</cx:pt>
          <cx:pt idx="508">Gewinn UC pro Tag</cx:pt>
          <cx:pt idx="509">Gewinn UC pro Tag</cx:pt>
          <cx:pt idx="510">Gewinn UC pro Tag</cx:pt>
          <cx:pt idx="511">Gewinn UC pro Tag</cx:pt>
          <cx:pt idx="512">Gewinn UC pro Tag</cx:pt>
          <cx:pt idx="513">Gewinn UC pro Tag</cx:pt>
          <cx:pt idx="514">Gewinn UC pro Tag</cx:pt>
          <cx:pt idx="515">Gewinn UC pro Tag</cx:pt>
          <cx:pt idx="516">Gewinn UC pro Tag</cx:pt>
          <cx:pt idx="517">Gewinn UC pro Tag</cx:pt>
          <cx:pt idx="518">Gewinn UC pro Tag</cx:pt>
          <cx:pt idx="519">Gewinn UC pro Tag</cx:pt>
        </cx:lvl>
      </cx:strDim>
      <cx:numDim type="val">
        <cx:lvl ptCount="520" formatCode="General">
          <cx:pt idx="0">-1485.4866666666669</cx:pt>
          <cx:pt idx="1">-1460.136</cx:pt>
          <cx:pt idx="2">-1399.5025000000001</cx:pt>
          <cx:pt idx="3">-1261.1142857142861</cx:pt>
          <cx:pt idx="4">-1257.9549999999999</cx:pt>
          <cx:pt idx="5">-1159.3050000000001</cx:pt>
          <cx:pt idx="6">-1042.1675</cx:pt>
          <cx:pt idx="7">-1011.615</cx:pt>
          <cx:pt idx="8">-983.77499999999998</cx:pt>
          <cx:pt idx="9">-970.7600000000001</cx:pt>
          <cx:pt idx="10">-863.40750000000003</cx:pt>
          <cx:pt idx="11">-844.19928571428579</cx:pt>
          <cx:pt idx="12">-841.11764705882354</cx:pt>
          <cx:pt idx="13">-803.13999999999999</cx:pt>
          <cx:pt idx="14">-801.71299999999997</cx:pt>
          <cx:pt idx="15">-795.55214285714283</cx:pt>
          <cx:pt idx="16">-772.61000000000001</cx:pt>
          <cx:pt idx="17">-770.61400000000003</cx:pt>
          <cx:pt idx="18">-759.68499999999995</cx:pt>
          <cx:pt idx="19">-752.68999999999994</cx:pt>
          <cx:pt idx="20">-743.73500000000001</cx:pt>
          <cx:pt idx="21">-740.67666666666673</cx:pt>
          <cx:pt idx="22">-719.00374999999997</cx:pt>
          <cx:pt idx="23">-681.98000000000002</cx:pt>
          <cx:pt idx="24">-679.21833333333336</cx:pt>
          <cx:pt idx="25">-673.30230769230775</cx:pt>
          <cx:pt idx="26">-669.81928571428568</cx:pt>
          <cx:pt idx="27">-669.5911111111111</cx:pt>
          <cx:pt idx="28">-660.25599999999997</cx:pt>
          <cx:pt idx="29">-646.44600000000003</cx:pt>
          <cx:pt idx="30">-643.91999999999996</cx:pt>
          <cx:pt idx="31">-630.48800000000006</cx:pt>
          <cx:pt idx="32">-629.93642857142856</cx:pt>
          <cx:pt idx="33">-620.61714285714277</cx:pt>
          <cx:pt idx="34">-612.61800000000005</cx:pt>
          <cx:pt idx="35">-611.63166666666666</cx:pt>
          <cx:pt idx="36">-597.59500000000003</cx:pt>
          <cx:pt idx="37">-593.29899999999998</cx:pt>
          <cx:pt idx="38">-584.29535714285714</cx:pt>
          <cx:pt idx="39">-582.54399999999998</cx:pt>
          <cx:pt idx="40">-569.87857142857149</cx:pt>
          <cx:pt idx="41">-566.57749999999999</cx:pt>
          <cx:pt idx="42">-557.0723529411764</cx:pt>
          <cx:pt idx="43">-543.50200000000007</cx:pt>
          <cx:pt idx="44">-541.24923076923073</cx:pt>
          <cx:pt idx="45">-539.07399999999996</cx:pt>
          <cx:pt idx="46">-536.14833333333331</cx:pt>
          <cx:pt idx="47">-535.40949999999998</cx:pt>
          <cx:pt idx="48">-529.59333333333336</cx:pt>
          <cx:pt idx="49">-520.91499999999996</cx:pt>
          <cx:pt idx="50">-518.76499999999999</cx:pt>
          <cx:pt idx="51">-507.83571428571429</cx:pt>
          <cx:pt idx="52">-507.60705882352943</cx:pt>
          <cx:pt idx="53">-499.73142857142858</cx:pt>
          <cx:pt idx="54">-498.22222222222217</cx:pt>
          <cx:pt idx="55">-493.66666666666669</cx:pt>
          <cx:pt idx="56">-481.74400000000003</cx:pt>
          <cx:pt idx="57">-478.88799999999998</cx:pt>
          <cx:pt idx="58">-470.14428571428567</cx:pt>
          <cx:pt idx="59">-458.77600000000001</cx:pt>
          <cx:pt idx="60">-454.47513513513519</cx:pt>
          <cx:pt idx="61">-451.21133333333341</cx:pt>
          <cx:pt idx="62">-451.13166666666672</cx:pt>
          <cx:pt idx="63">-448.19400000000002</cx:pt>
          <cx:pt idx="64">-448.02384615384619</cx:pt>
          <cx:pt idx="65">-446.21176470588239</cx:pt>
          <cx:pt idx="66">-435.09500000000003</cx:pt>
          <cx:pt idx="67">-434.67099999999999</cx:pt>
          <cx:pt idx="68">-433.1731578947369</cx:pt>
          <cx:pt idx="69">-425.62666666666672</cx:pt>
          <cx:pt idx="70">-424.97666666666669</cx:pt>
          <cx:pt idx="71">-423.99000000000001</cx:pt>
          <cx:pt idx="72">-419.42137931034478</cx:pt>
          <cx:pt idx="73">-412.67000000000002</cx:pt>
          <cx:pt idx="74">-411.19277777777779</cx:pt>
          <cx:pt idx="75">-406.25647058823529</cx:pt>
          <cx:pt idx="76">-398.01999999999998</cx:pt>
          <cx:pt idx="77">-394.10300000000001</cx:pt>
          <cx:pt idx="78">-394.04333333333341</cx:pt>
          <cx:pt idx="79">-391.43333333333328</cx:pt>
          <cx:pt idx="80">-389.70894736842109</cx:pt>
          <cx:pt idx="81">-388.02222222222218</cx:pt>
          <cx:pt idx="82">-386.63875000000002</cx:pt>
          <cx:pt idx="83">-383.875</cx:pt>
          <cx:pt idx="84">-377.61571428571432</cx:pt>
          <cx:pt idx="85">-377.31666666666672</cx:pt>
          <cx:pt idx="86">-366.85111111111109</cx:pt>
          <cx:pt idx="87">-366.53666666666658</cx:pt>
          <cx:pt idx="88">-363.935</cx:pt>
          <cx:pt idx="89">-358.089</cx:pt>
          <cx:pt idx="90">-357.89299999999997</cx:pt>
          <cx:pt idx="91">-355.19043478260869</cx:pt>
          <cx:pt idx="92">-353.62400000000002</cx:pt>
          <cx:pt idx="93">-353.29647058823531</cx:pt>
          <cx:pt idx="94">-349.3152380952381</cx:pt>
          <cx:pt idx="95">-342.64222222222219</cx:pt>
          <cx:pt idx="96">-336.45666666666671</cx:pt>
          <cx:pt idx="97">-334.89228571428572</cx:pt>
          <cx:pt idx="98">-333.88125000000002</cx:pt>
          <cx:pt idx="99">-331.69636363636363</cx:pt>
          <cx:pt idx="100">-331.50943396226421</cx:pt>
          <cx:pt idx="101">-327.28333333333342</cx:pt>
          <cx:pt idx="102">-325.69323529411758</cx:pt>
          <cx:pt idx="103">-323.59500000000003</cx:pt>
          <cx:pt idx="104">-323.17090909090911</cx:pt>
          <cx:pt idx="105">-318.71642857142848</cx:pt>
          <cx:pt idx="106">-317.09125</cx:pt>
          <cx:pt idx="107">-315.71499999999997</cx:pt>
          <cx:pt idx="108">-315.22624999999999</cx:pt>
          <cx:pt idx="109">-315.00999999999999</cx:pt>
          <cx:pt idx="110">-314.69363636363641</cx:pt>
          <cx:pt idx="111">-313.58333333333331</cx:pt>
          <cx:pt idx="112">-309.79000000000002</cx:pt>
          <cx:pt idx="113">-308.45625000000001</cx:pt>
          <cx:pt idx="114">-308.30900000000003</cx:pt>
          <cx:pt idx="115">-301.54666666666668</cx:pt>
          <cx:pt idx="116">-301.24124999999998</cx:pt>
          <cx:pt idx="117">-284.24000000000001</cx:pt>
          <cx:pt idx="118">-282.6990909090909</cx:pt>
          <cx:pt idx="119">-281.28571428571428</cx:pt>
          <cx:pt idx="120">-280.24052631578951</cx:pt>
          <cx:pt idx="121">-279.23750000000001</cx:pt>
          <cx:pt idx="122">-276.46375</cx:pt>
          <cx:pt idx="123">-276.36857142857139</cx:pt>
          <cx:pt idx="124">-275.28357142857141</cx:pt>
          <cx:pt idx="125">-273.06599999999997</cx:pt>
          <cx:pt idx="126">-272.75999999999999</cx:pt>
          <cx:pt idx="127">-271.90047619047618</cx:pt>
          <cx:pt idx="128">-271.503076923077</cx:pt>
          <cx:pt idx="129">-271.29388888888889</cx:pt>
          <cx:pt idx="130">-267.89999999999998</cx:pt>
          <cx:pt idx="131">-267.74562500000002</cx:pt>
          <cx:pt idx="132">-263.92500000000001</cx:pt>
          <cx:pt idx="133">-259.65222222222218</cx:pt>
          <cx:pt idx="134">-258.20206896551719</cx:pt>
          <cx:pt idx="135">-258.176875</cx:pt>
          <cx:pt idx="136">-257.92124999999999</cx:pt>
          <cx:pt idx="137">-251.69399999999999</cx:pt>
          <cx:pt idx="138">-248.87666666666669</cx:pt>
          <cx:pt idx="139">-244.6028571428572</cx:pt>
          <cx:pt idx="140">-241.80333333333331</cx:pt>
          <cx:pt idx="141">-240.56461538461539</cx:pt>
          <cx:pt idx="142">-239.7307142857143</cx:pt>
          <cx:pt idx="143">-237.84899999999999</cx:pt>
          <cx:pt idx="144">-235.83150000000001</cx:pt>
          <cx:pt idx="145">-234.82050000000001</cx:pt>
          <cx:pt idx="146">-232.87777777777779</cx:pt>
          <cx:pt idx="147">-232.72</cx:pt>
          <cx:pt idx="148">-230.45777777777781</cx:pt>
          <cx:pt idx="149">-229.92357142857139</cx:pt>
          <cx:pt idx="150">-229.12467741935481</cx:pt>
          <cx:pt idx="151">-228.42642857142849</cx:pt>
          <cx:pt idx="152">-223.495</cx:pt>
          <cx:pt idx="153">-223.17615384615391</cx:pt>
          <cx:pt idx="154">-221.41749999999999</cx:pt>
          <cx:pt idx="155">-219.65857142857141</cx:pt>
          <cx:pt idx="156">-217.45666666666671</cx:pt>
          <cx:pt idx="157">-214.25749999999999</cx:pt>
          <cx:pt idx="158">-214.00952380952381</cx:pt>
          <cx:pt idx="159">-212.74181818181819</cx:pt>
          <cx:pt idx="160">-212.40125</cx:pt>
          <cx:pt idx="161">-210.98090909090911</cx:pt>
          <cx:pt idx="162">-208.66399999999999</cx:pt>
          <cx:pt idx="163">-207.41499999999999</cx:pt>
          <cx:pt idx="164">-207.2891379310345</cx:pt>
          <cx:pt idx="165">-205.07846153846151</cx:pt>
          <cx:pt idx="166">-204.65333333333331</cx:pt>
          <cx:pt idx="167">-203.49600000000001</cx:pt>
          <cx:pt idx="168">-199.38055555555559</cx:pt>
          <cx:pt idx="169">-198.6792857142857</cx:pt>
          <cx:pt idx="170">-197.71111111111111</cx:pt>
          <cx:pt idx="171">-196.5542857142857</cx:pt>
          <cx:pt idx="172">-193.18333333333331</cx:pt>
          <cx:pt idx="173">-192.5675</cx:pt>
          <cx:pt idx="174">-191.6509090909091</cx:pt>
          <cx:pt idx="175">-191.59999999999999</cx:pt>
          <cx:pt idx="176">-191.04166666666671</cx:pt>
          <cx:pt idx="177">-190.39409090909089</cx:pt>
          <cx:pt idx="178">-188.55347826086961</cx:pt>
          <cx:pt idx="179">-187.55000000000001</cx:pt>
          <cx:pt idx="180">-186.15000000000001</cx:pt>
          <cx:pt idx="181">-185.6828571428571</cx:pt>
          <cx:pt idx="182">-185.50800000000001</cx:pt>
          <cx:pt idx="183">-185.14250000000001</cx:pt>
          <cx:pt idx="184">-184.08435897435899</cx:pt>
          <cx:pt idx="185">-183.25545454545451</cx:pt>
          <cx:pt idx="186">-181.3305882352941</cx:pt>
          <cx:pt idx="187">-181.3276923076923</cx:pt>
          <cx:pt idx="188">-180.85874999999999</cx:pt>
          <cx:pt idx="189">-180.54249999999999</cx:pt>
          <cx:pt idx="190">-179.65076923076921</cx:pt>
          <cx:pt idx="191">-178.81999999999999</cx:pt>
          <cx:pt idx="192">-175.88999999999999</cx:pt>
          <cx:pt idx="193">-175.48333333333341</cx:pt>
          <cx:pt idx="194">-169.53299999999999</cx:pt>
          <cx:pt idx="195">-168.57875000000001</cx:pt>
          <cx:pt idx="196">-167.7641379310345</cx:pt>
          <cx:pt idx="197">-165.19499999999999</cx:pt>
          <cx:pt idx="198">-163.84049999999999</cx:pt>
          <cx:pt idx="199">-163.83375000000001</cx:pt>
          <cx:pt idx="200">-162.80555555555549</cx:pt>
          <cx:pt idx="201">-160.96812499999999</cx:pt>
          <cx:pt idx="202">-157.69181818181821</cx:pt>
          <cx:pt idx="203">-155.3422222222222</cx:pt>
          <cx:pt idx="204">-150.31399999999999</cx:pt>
          <cx:pt idx="205">-150.07222222222219</cx:pt>
          <cx:pt idx="206">-149.90333333333331</cx:pt>
          <cx:pt idx="207">-148.17750000000001</cx:pt>
          <cx:pt idx="208">-147.59076923076921</cx:pt>
          <cx:pt idx="209">-145.684</cx:pt>
          <cx:pt idx="210">-144.3088888888889</cx:pt>
          <cx:pt idx="211">-143.27571428571429</cx:pt>
          <cx:pt idx="212">-142.71642857142859</cx:pt>
          <cx:pt idx="213">-142.46545454545461</cx:pt>
          <cx:pt idx="214">-141.40333333333331</cx:pt>
          <cx:pt idx="215">-129.95500000000001</cx:pt>
          <cx:pt idx="216">-120.2383333333333</cx:pt>
          <cx:pt idx="217">-120.05</cx:pt>
          <cx:pt idx="218">-119.9657142857143</cx:pt>
          <cx:pt idx="219">-119.7227272727273</cx:pt>
          <cx:pt idx="220">-118.5477777777778</cx:pt>
          <cx:pt idx="221">-116.57250000000001</cx:pt>
          <cx:pt idx="222">-113.2230769230769</cx:pt>
          <cx:pt idx="223">-108.8725</cx:pt>
          <cx:pt idx="224">-104.33925925925929</cx:pt>
          <cx:pt idx="225">-103.53</cx:pt>
          <cx:pt idx="226">-98.689999999999998</cx:pt>
          <cx:pt idx="227">-97.796000000000006</cx:pt>
          <cx:pt idx="228">-92.599999999999994</cx:pt>
          <cx:pt idx="229">-88.701333333333338</cx:pt>
          <cx:pt idx="230">-87.678333333333342</cx:pt>
          <cx:pt idx="231">-85.714736842105253</cx:pt>
          <cx:pt idx="232">-83.583571428571432</cx:pt>
          <cx:pt idx="233">-81.49199999999999</cx:pt>
          <cx:pt idx="234">-80.879999999999995</cx:pt>
          <cx:pt idx="235">-80.857692307692318</cx:pt>
          <cx:pt idx="236">-77.484999999999999</cx:pt>
          <cx:pt idx="237">-77.118333333333339</cx:pt>
          <cx:pt idx="238">-74.260000000000005</cx:pt>
          <cx:pt idx="239">-73.935999999999993</cx:pt>
          <cx:pt idx="240">-71.387</cx:pt>
          <cx:pt idx="241">-70.510000000000005</cx:pt>
          <cx:pt idx="242">-69.36666666666666</cx:pt>
          <cx:pt idx="243">-68.826666666666668</cx:pt>
          <cx:pt idx="244">-67.514705882352942</cx:pt>
          <cx:pt idx="245">-66.240833333333327</cx:pt>
          <cx:pt idx="246">-64.580588235294115</cx:pt>
          <cx:pt idx="247">-58.257272727272728</cx:pt>
          <cx:pt idx="248">-57.958846153846153</cx:pt>
          <cx:pt idx="249">-54.240769230769232</cx:pt>
          <cx:pt idx="250">-50.334090909090897</cx:pt>
          <cx:pt idx="251">-49.332142857142863</cx:pt>
          <cx:pt idx="252">-48.645909090909093</cx:pt>
          <cx:pt idx="253">-45.372250000000001</cx:pt>
          <cx:pt idx="254">-44.660740740740742</cx:pt>
          <cx:pt idx="255">-40.603846153846163</cx:pt>
          <cx:pt idx="256">-40.263636363636358</cx:pt>
          <cx:pt idx="257">-39.360769230769229</cx:pt>
          <cx:pt idx="258">-38.912500000000001</cx:pt>
          <cx:pt idx="259">-34.387999999999998</cx:pt>
          <cx:pt idx="260">-31.78025641025641</cx:pt>
          <cx:pt idx="261">-29.9025</cx:pt>
          <cx:pt idx="262">-24.832777777777778</cx:pt>
          <cx:pt idx="263">-22.715</cx:pt>
          <cx:pt idx="264">-20.31625</cx:pt>
          <cx:pt idx="265">-18.050666666666672</cx:pt>
          <cx:pt idx="266">-14.1195</cx:pt>
          <cx:pt idx="267">-11.91</cx:pt>
          <cx:pt idx="268">-7.9187500000000002</cx:pt>
          <cx:pt idx="269">-3.2618749999999999</cx:pt>
          <cx:pt idx="270">0.79769230769230759</cx:pt>
          <cx:pt idx="271">3.4159999999999999</cx:pt>
          <cx:pt idx="272">6.2374999999999998</cx:pt>
          <cx:pt idx="273">8.7246666666666677</cx:pt>
          <cx:pt idx="274">12.99071428571429</cx:pt>
          <cx:pt idx="275">14.07</cx:pt>
          <cx:pt idx="276">18.556000000000001</cx:pt>
          <cx:pt idx="277">19.113461538461539</cx:pt>
          <cx:pt idx="278">19.577999999999999</cx:pt>
          <cx:pt idx="279">21.699999999999999</cx:pt>
          <cx:pt idx="280">23.785625</cx:pt>
          <cx:pt idx="281">27.483333333333331</cx:pt>
          <cx:pt idx="282">27.583636363636369</cx:pt>
          <cx:pt idx="283">31.613846153846151</cx:pt>
          <cx:pt idx="284">31.63666666666667</cx:pt>
          <cx:pt idx="285">35.664999999999999</cx:pt>
          <cx:pt idx="286">38.8125</cx:pt>
          <cx:pt idx="287">41.650399999999998</cx:pt>
          <cx:pt idx="288">43.832777777777778</cx:pt>
          <cx:pt idx="289">44.252857142857138</cx:pt>
          <cx:pt idx="290">45.471538461538458</cx:pt>
          <cx:pt idx="291">47.993333333333332</cx:pt>
          <cx:pt idx="292">49.542857142857137</cx:pt>
          <cx:pt idx="293">50.251428571428569</cx:pt>
          <cx:pt idx="294">52.225000000000001</cx:pt>
          <cx:pt idx="295">52.763181818181813</cx:pt>
          <cx:pt idx="296">55.222499999999997</cx:pt>
          <cx:pt idx="297">62.179999999999993</cx:pt>
          <cx:pt idx="298">64.748888888888885</cx:pt>
          <cx:pt idx="299">67.301999999999992</cx:pt>
          <cx:pt idx="300">68.361000000000004</cx:pt>
          <cx:pt idx="301">71.089166666666671</cx:pt>
          <cx:pt idx="302">71.769500000000008</cx:pt>
          <cx:pt idx="303">79.944999999999993</cx:pt>
          <cx:pt idx="304">82.405000000000001</cx:pt>
          <cx:pt idx="305">83.73571428571428</cx:pt>
          <cx:pt idx="306">84.246250000000003</cx:pt>
          <cx:pt idx="307">87.8690909090909</cx:pt>
          <cx:pt idx="308">92.900666666666666</cx:pt>
          <cx:pt idx="309">93.634761904761902</cx:pt>
          <cx:pt idx="310">93.651875000000004</cx:pt>
          <cx:pt idx="311">96.193636363636372</cx:pt>
          <cx:pt idx="312">104.9671428571429</cx:pt>
          <cx:pt idx="313">105.39888888888891</cx:pt>
          <cx:pt idx="314">107.639</cx:pt>
          <cx:pt idx="315">107.828</cx:pt>
          <cx:pt idx="316">109.40428571428571</cx:pt>
          <cx:pt idx="317">110.0338461538462</cx:pt>
          <cx:pt idx="318">116.30500000000001</cx:pt>
          <cx:pt idx="319">116.405</cx:pt>
          <cx:pt idx="320">117.7485714285714</cx:pt>
          <cx:pt idx="321">118.1825</cx:pt>
          <cx:pt idx="322">121.00291666666671</cx:pt>
          <cx:pt idx="323">124.0457142857143</cx:pt>
          <cx:pt idx="324">129.57666666666671</cx:pt>
          <cx:pt idx="325">131.08846153846159</cx:pt>
          <cx:pt idx="326">131.51866666666669</cx:pt>
          <cx:pt idx="327">133.35882352941181</cx:pt>
          <cx:pt idx="328">136.1444444444445</cx:pt>
          <cx:pt idx="329">136.95285714285711</cx:pt>
          <cx:pt idx="330">137.7253846153846</cx:pt>
          <cx:pt idx="331">139.5473684210526</cx:pt>
          <cx:pt idx="332">140.82785714285711</cx:pt>
          <cx:pt idx="333">142.84130434782611</cx:pt>
          <cx:pt idx="334">149.50666666666669</cx:pt>
          <cx:pt idx="335">151.56916666666669</cx:pt>
          <cx:pt idx="336">154.12799999999999</cx:pt>
          <cx:pt idx="337">154.44999999999999</cx:pt>
          <cx:pt idx="338">156.43000000000001</cx:pt>
          <cx:pt idx="339">168.0794117647059</cx:pt>
          <cx:pt idx="340">169.322</cx:pt>
          <cx:pt idx="341">169.995</cx:pt>
          <cx:pt idx="342">170.47800000000001</cx:pt>
          <cx:pt idx="343">172.5572727272727</cx:pt>
          <cx:pt idx="344">172.61199999999999</cx:pt>
          <cx:pt idx="345">175.76833333333329</cx:pt>
          <cx:pt idx="346">178.03874999999999</cx:pt>
          <cx:pt idx="347">183.78749999999999</cx:pt>
          <cx:pt idx="348">187.47999999999999</cx:pt>
          <cx:pt idx="349">190.8725</cx:pt>
          <cx:pt idx="350">198.85666666666671</cx:pt>
          <cx:pt idx="351">202.87571428571431</cx:pt>
          <cx:pt idx="352">204.17400000000001</cx:pt>
          <cx:pt idx="353">204.22999999999999</cx:pt>
          <cx:pt idx="354">205.56916666666669</cx:pt>
          <cx:pt idx="355">211.59555555555551</cx:pt>
          <cx:pt idx="356">219.56736842105261</cx:pt>
          <cx:pt idx="357">220.435</cx:pt>
          <cx:pt idx="358">238.8533333333333</cx:pt>
          <cx:pt idx="359">240.226</cx:pt>
          <cx:pt idx="360">242.69714285714289</cx:pt>
          <cx:pt idx="361">243.35666666666671</cx:pt>
          <cx:pt idx="362">243.81999999999999</cx:pt>
          <cx:pt idx="363">254.1525</cx:pt>
          <cx:pt idx="364">260.63857142857142</cx:pt>
          <cx:pt idx="365">264.19619047619051</cx:pt>
          <cx:pt idx="366">265.59722222222217</cx:pt>
          <cx:pt idx="367">278.29416666666668</cx:pt>
          <cx:pt idx="368">279.91444444444443</cx:pt>
          <cx:pt idx="369">281.16571428571427</cx:pt>
          <cx:pt idx="370">281.57833333333332</cx:pt>
          <cx:pt idx="371">283.34857142857152</cx:pt>
          <cx:pt idx="372">283.67888888888888</cx:pt>
          <cx:pt idx="373">287.92571428571432</cx:pt>
          <cx:pt idx="374">288.23818181818177</cx:pt>
          <cx:pt idx="375">289.63666666666671</cx:pt>
          <cx:pt idx="376">293.38416666666672</cx:pt>
          <cx:pt idx="377">310.81999999999999</cx:pt>
          <cx:pt idx="378">311.28699999999998</cx:pt>
          <cx:pt idx="379">318.48117647058831</cx:pt>
          <cx:pt idx="380">319.08214285714291</cx:pt>
          <cx:pt idx="381">320.70499999999998</cx:pt>
          <cx:pt idx="382">321.35750000000002</cx:pt>
          <cx:pt idx="383">324.87625000000003</cx:pt>
          <cx:pt idx="384">325.5025</cx:pt>
          <cx:pt idx="385">333.74153846153848</cx:pt>
          <cx:pt idx="386">342.52699999999999</cx:pt>
          <cx:pt idx="387">344.01833333333337</cx:pt>
          <cx:pt idx="388">347.64800000000002</cx:pt>
          <cx:pt idx="389">364.20238095238102</cx:pt>
          <cx:pt idx="390">372.75555555555559</cx:pt>
          <cx:pt idx="391">379.80428571428581</cx:pt>
          <cx:pt idx="392">396.12636363636369</cx:pt>
          <cx:pt idx="393">400.80200000000002</cx:pt>
          <cx:pt idx="394">410.48473684210529</cx:pt>
          <cx:pt idx="395">414.61500000000001</cx:pt>
          <cx:pt idx="396">429.13111111111112</cx:pt>
          <cx:pt idx="397">429.154</cx:pt>
          <cx:pt idx="398">431.85399999999998</cx:pt>
          <cx:pt idx="399">433.24052631578951</cx:pt>
          <cx:pt idx="400">435.67000000000002</cx:pt>
          <cx:pt idx="401">443.94</cx:pt>
          <cx:pt idx="402">449.78500000000003</cx:pt>
          <cx:pt idx="403">451.80857142857138</cx:pt>
          <cx:pt idx="404">459.12400000000002</cx:pt>
          <cx:pt idx="405">472.6718181818182</cx:pt>
          <cx:pt idx="406">473.23500000000001</cx:pt>
          <cx:pt idx="407">474.39384615384608</cx:pt>
          <cx:pt idx="408">475.04000000000002</cx:pt>
          <cx:pt idx="409">478.79333333333341</cx:pt>
          <cx:pt idx="410">480.80083333333329</cx:pt>
          <cx:pt idx="411">481.17000000000002</cx:pt>
          <cx:pt idx="412">486.98624999999998</cx:pt>
          <cx:pt idx="413">502.06727272727272</cx:pt>
          <cx:pt idx="414">513.54000000000008</cx:pt>
          <cx:pt idx="415">514.20333333333338</cx:pt>
          <cx:pt idx="416">515.54999999999995</cx:pt>
          <cx:pt idx="417">517.13</cx:pt>
          <cx:pt idx="418">525.22500000000002</cx:pt>
          <cx:pt idx="419">531.52846153846156</cx:pt>
          <cx:pt idx="420">532.0916666666667</cx:pt>
          <cx:pt idx="421">532.73599999999999</cx:pt>
          <cx:pt idx="422">540.35874999999999</cx:pt>
          <cx:pt idx="423">544.41571428571422</cx:pt>
          <cx:pt idx="424">545.18624999999997</cx:pt>
          <cx:pt idx="425">545.37642857142862</cx:pt>
          <cx:pt idx="426">545.53785714285709</cx:pt>
          <cx:pt idx="427">556.63111111111118</cx:pt>
          <cx:pt idx="428">563.34000000000003</cx:pt>
          <cx:pt idx="429">566.16733333333332</cx:pt>
          <cx:pt idx="430">580.5958333333333</cx:pt>
          <cx:pt idx="431">582.61333333333334</cx:pt>
          <cx:pt idx="432">594.12352941176471</cx:pt>
          <cx:pt idx="433">602.48400000000004</cx:pt>
          <cx:pt idx="434">603.99615384615379</cx:pt>
          <cx:pt idx="435">607.43263157894728</cx:pt>
          <cx:pt idx="436">615.5383333333333</cx:pt>
          <cx:pt idx="437">617.31923076923078</cx:pt>
          <cx:pt idx="438">619.1123076923077</cx:pt>
          <cx:pt idx="439">637.34923076923087</cx:pt>
          <cx:pt idx="440">642.46000000000004</cx:pt>
          <cx:pt idx="441">647.03000000000009</cx:pt>
          <cx:pt idx="442">648.14176470588234</cx:pt>
          <cx:pt idx="443">648.76999999999998</cx:pt>
          <cx:pt idx="444">650.31000000000006</cx:pt>
          <cx:pt idx="445">671.90300000000002</cx:pt>
          <cx:pt idx="446">676.35588235294108</cx:pt>
          <cx:pt idx="447">678.83833333333337</cx:pt>
          <cx:pt idx="448">700.58583333333343</cx:pt>
          <cx:pt idx="449">705.60928571428576</cx:pt>
          <cx:pt idx="450">713.89571428571435</cx:pt>
          <cx:pt idx="451">737.40374999999995</cx:pt>
          <cx:pt idx="452">758.63230769230768</cx:pt>
          <cx:pt idx="453">765.81499999999994</cx:pt>
          <cx:pt idx="454">780.46538461538455</cx:pt>
          <cx:pt idx="455">783.0971428571429</cx:pt>
          <cx:pt idx="456">789.51909090909078</cx:pt>
          <cx:pt idx="457">795.09500000000003</cx:pt>
          <cx:pt idx="458">797.31000000000006</cx:pt>
          <cx:pt idx="459">811.09249999999997</cx:pt>
          <cx:pt idx="460">828.24333333333334</cx:pt>
          <cx:pt idx="461">858.89888888888891</cx:pt>
          <cx:pt idx="462">912.61800000000005</cx:pt>
          <cx:pt idx="463">915.53777777777782</cx:pt>
          <cx:pt idx="464">915.87333333333345</cx:pt>
          <cx:pt idx="465">920.94899999999996</cx:pt>
          <cx:pt idx="466">923.40250000000003</cx:pt>
          <cx:pt idx="467">925.45444444444445</cx:pt>
          <cx:pt idx="468">934.91000000000008</cx:pt>
          <cx:pt idx="469">961.01800000000003</cx:pt>
          <cx:pt idx="470">972.90750000000003</cx:pt>
          <cx:pt idx="471">1013.442857142857</cx:pt>
          <cx:pt idx="472">1028.5999999999999</cx:pt>
          <cx:pt idx="473">1039.6554545454539</cx:pt>
          <cx:pt idx="474">1040.0366666666671</cx:pt>
          <cx:pt idx="475">1043.4512500000001</cx:pt>
          <cx:pt idx="476">1051.25125</cx:pt>
          <cx:pt idx="477">1061.537142857143</cx:pt>
          <cx:pt idx="478">1083.5525</cx:pt>
          <cx:pt idx="479">1092.9275</cx:pt>
          <cx:pt idx="480">1094.8757142857139</cx:pt>
          <cx:pt idx="481">1110.2016666666671</cx:pt>
          <cx:pt idx="482">1153.0525</cx:pt>
          <cx:pt idx="483">1198.3579999999999</cx:pt>
          <cx:pt idx="484">1205.155</cx:pt>
          <cx:pt idx="485">1207.207142857143</cx:pt>
          <cx:pt idx="486">1214.48</cx:pt>
          <cx:pt idx="487">1221.0920000000001</cx:pt>
          <cx:pt idx="488">1230.2336363636359</cx:pt>
          <cx:pt idx="489">1241.5522222222221</cx:pt>
          <cx:pt idx="490">1261.0250000000001</cx:pt>
          <cx:pt idx="491">1279.95</cx:pt>
          <cx:pt idx="492">1283.268571428571</cx:pt>
          <cx:pt idx="493">1291.5799999999999</cx:pt>
          <cx:pt idx="494">1355.2</cx:pt>
          <cx:pt idx="495">1355.9000000000001</cx:pt>
          <cx:pt idx="496">1420.175</cx:pt>
          <cx:pt idx="497">1433.4966666666669</cx:pt>
          <cx:pt idx="498">1470.5487499999999</cx:pt>
          <cx:pt idx="499">1473.0233333333331</cx:pt>
          <cx:pt idx="500">1500.6483333333331</cx:pt>
          <cx:pt idx="501">1519.906666666667</cx:pt>
          <cx:pt idx="502">1525.0825</cx:pt>
          <cx:pt idx="503">1660.261666666667</cx:pt>
          <cx:pt idx="504">1690.434285714286</cx:pt>
          <cx:pt idx="505">1830.25125</cx:pt>
          <cx:pt idx="506">1833.06375</cx:pt>
          <cx:pt idx="507">1857.4385714285711</cx:pt>
          <cx:pt idx="508">1882.076</cx:pt>
          <cx:pt idx="509">1905.4100000000001</cx:pt>
          <cx:pt idx="510">1918.3845454545451</cx:pt>
          <cx:pt idx="511">1941.416666666667</cx:pt>
          <cx:pt idx="512">1964.408571428572</cx:pt>
          <cx:pt idx="513">2068.8866666666672</cx:pt>
          <cx:pt idx="514">2109.9924999999998</cx:pt>
          <cx:pt idx="515">2243.8883333333329</cx:pt>
          <cx:pt idx="516">2320.8125</cx:pt>
          <cx:pt idx="517">2460.5075000000002</cx:pt>
          <cx:pt idx="518">2629.7440000000001</cx:pt>
          <cx:pt idx="519">3198.01125</cx:pt>
        </cx:lvl>
      </cx:numDim>
    </cx:data>
  </cx:chartData>
  <cx:chart>
    <cx:title pos="t" align="ctr" overlay="0">
      <cx:tx>
        <cx:txData>
          <cx:v/>
        </cx:txData>
      </cx:tx>
      <cx:txPr>
        <a:bodyPr spcFirstLastPara="1" vertOverflow="ellipsis" wrap="square" lIns="0" tIns="0" rIns="0" bIns="0" anchor="ctr" anchorCtr="1"/>
        <a:lstStyle/>
        <a:p>
          <a:pPr algn="ctr">
            <a:defRPr/>
          </a:pPr>
          <a:endParaRPr/>
        </a:p>
      </cx:txPr>
    </cx:title>
    <cx:plotArea>
      <cx:plotAreaRegion>
        <cx:series layoutId="boxWhisker" uniqueId="{4182C088-BBF1-40C3-8A6B-46B290DE937D}">
          <cx:dataId val="0"/>
          <cx:layoutPr>
            <cx:visibility meanLine="0" meanMarker="1" nonoutliers="0" outliers="1"/>
            <cx:statistics quartileMethod="exclusive"/>
          </cx:layoutPr>
        </cx:series>
      </cx:plotAreaRegion>
      <cx:axis id="0">
        <cx:catScaling gapWidth="1"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tickLabels/>
      </cx:axis>
      <cx:axis id="1">
        <cx:valScaling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majorGridlines/>
        <cx:tickLabels/>
      </cx:axis>
    </cx:plotArea>
  </cx:chart>
</cx:chartSpace>
</file>

<file path=ppt/charts/chartEx6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lvl ptCount="803">
          <cx:pt idx="0">KH VWD (SAP, 21 FALL)</cx:pt>
          <cx:pt idx="1">KH VWD (SAP, 21 FALL)</cx:pt>
          <cx:pt idx="2">KH VWD (SAP, 21 FALL)</cx:pt>
          <cx:pt idx="3">KH VWD (SAP, 21 FALL)</cx:pt>
          <cx:pt idx="4">KH VWD (SAP, 21 FALL)</cx:pt>
          <cx:pt idx="5">KH VWD (SAP, 21 FALL)</cx:pt>
          <cx:pt idx="6">KH VWD (SAP, 21 FALL)</cx:pt>
          <cx:pt idx="7">KH VWD (SAP, 21 FALL)</cx:pt>
          <cx:pt idx="8">KH VWD (SAP, 21 FALL)</cx:pt>
          <cx:pt idx="9">KH VWD (SAP, 21 FALL)</cx:pt>
          <cx:pt idx="10">KH VWD (SAP, 21 FALL)</cx:pt>
          <cx:pt idx="11">KH VWD (SAP, 21 FALL)</cx:pt>
          <cx:pt idx="12">KH VWD (SAP, 21 FALL)</cx:pt>
          <cx:pt idx="13">KH VWD (SAP, 21 FALL)</cx:pt>
          <cx:pt idx="14">KH VWD (SAP, 21 FALL)</cx:pt>
          <cx:pt idx="15">KH VWD (SAP, 21 FALL)</cx:pt>
          <cx:pt idx="16">KH VWD (SAP, 21 FALL)</cx:pt>
          <cx:pt idx="17">KH VWD (SAP, 21 FALL)</cx:pt>
          <cx:pt idx="18">KH VWD (SAP, 21 FALL)</cx:pt>
          <cx:pt idx="19">KH VWD (SAP, 21 FALL)</cx:pt>
          <cx:pt idx="20">KH VWD (SAP, 21 FALL)</cx:pt>
          <cx:pt idx="21">KH VWD (SAP, 21 FALL)</cx:pt>
          <cx:pt idx="22">KH VWD (SAP, 21 FALL)</cx:pt>
          <cx:pt idx="23">KH VWD (SAP, 21 FALL)</cx:pt>
          <cx:pt idx="24">KH VWD (SAP, 21 FALL)</cx:pt>
          <cx:pt idx="25">KH VWD (SAP, 21 FALL)</cx:pt>
          <cx:pt idx="26">KH VWD (SAP, 21 FALL)</cx:pt>
          <cx:pt idx="27">KH VWD (SAP, 21 FALL)</cx:pt>
          <cx:pt idx="28">KH VWD (SAP, 21 FALL)</cx:pt>
          <cx:pt idx="29">KH VWD (SAP, 21 FALL)</cx:pt>
          <cx:pt idx="30">KH VWD (SAP, 21 FALL)</cx:pt>
          <cx:pt idx="31">KH VWD (SAP, 21 FALL)</cx:pt>
          <cx:pt idx="32">KH VWD (SAP, 21 FALL)</cx:pt>
          <cx:pt idx="33">KH VWD (SAP, 21 FALL)</cx:pt>
          <cx:pt idx="34">KH VWD (SAP, 21 FALL)</cx:pt>
          <cx:pt idx="35">KH VWD (SAP, 21 FALL)</cx:pt>
          <cx:pt idx="36">KH VWD (SAP, 21 FALL)</cx:pt>
          <cx:pt idx="37">KH VWD (SAP, 21 FALL)</cx:pt>
          <cx:pt idx="38">KH VWD (SAP, 21 FALL)</cx:pt>
          <cx:pt idx="39">KH VWD (SAP, 21 FALL)</cx:pt>
          <cx:pt idx="40">KH VWD (SAP, 21 FALL)</cx:pt>
          <cx:pt idx="41">KH VWD (SAP, 21 FALL)</cx:pt>
          <cx:pt idx="42">KH VWD (SAP, 21 FALL)</cx:pt>
          <cx:pt idx="43">KH VWD (SAP, 21 FALL)</cx:pt>
          <cx:pt idx="44">KH VWD (SAP, 21 FALL)</cx:pt>
          <cx:pt idx="45">KH VWD (SAP, 21 FALL)</cx:pt>
          <cx:pt idx="46">KH VWD (SAP, 21 FALL)</cx:pt>
          <cx:pt idx="47">KH VWD (SAP, 21 FALL)</cx:pt>
          <cx:pt idx="48">KH VWD (SAP, 21 FALL)</cx:pt>
          <cx:pt idx="49">KH VWD (SAP, 21 FALL)</cx:pt>
          <cx:pt idx="50">KH VWD (SAP, 21 FALL)</cx:pt>
          <cx:pt idx="51">KH VWD (SAP, 21 FALL)</cx:pt>
          <cx:pt idx="52">KH VWD (SAP, 21 FALL)</cx:pt>
          <cx:pt idx="53">KH VWD (SAP, 21 FALL)</cx:pt>
          <cx:pt idx="54">KH VWD (SAP, 21 FALL)</cx:pt>
          <cx:pt idx="55">KH VWD (SAP, 21 FALL)</cx:pt>
          <cx:pt idx="56">KH VWD (SAP, 21 FALL)</cx:pt>
          <cx:pt idx="57">KH VWD (SAP, 21 FALL)</cx:pt>
          <cx:pt idx="58">KH VWD (SAP, 21 FALL)</cx:pt>
          <cx:pt idx="59">KH VWD (SAP, 21 FALL)</cx:pt>
          <cx:pt idx="60">KH VWD (SAP, 21 FALL)</cx:pt>
          <cx:pt idx="61">KH VWD (SAP, 21 FALL)</cx:pt>
          <cx:pt idx="62">KH VWD (SAP, 21 FALL)</cx:pt>
          <cx:pt idx="63">KH VWD (SAP, 21 FALL)</cx:pt>
          <cx:pt idx="64">KH VWD (SAP, 21 FALL)</cx:pt>
          <cx:pt idx="65">KH VWD (SAP, 21 FALL)</cx:pt>
          <cx:pt idx="66">KH VWD (SAP, 21 FALL)</cx:pt>
          <cx:pt idx="67">KH VWD (SAP, 21 FALL)</cx:pt>
          <cx:pt idx="68">KH VWD (SAP, 21 FALL)</cx:pt>
          <cx:pt idx="69">KH VWD (SAP, 21 FALL)</cx:pt>
          <cx:pt idx="70">KH VWD (SAP, 21 FALL)</cx:pt>
          <cx:pt idx="71">KH VWD (SAP, 21 FALL)</cx:pt>
          <cx:pt idx="72">KH VWD (SAP, 21 FALL)</cx:pt>
          <cx:pt idx="73">KH VWD (SAP, 21 FALL)</cx:pt>
          <cx:pt idx="74">KH VWD (SAP, 21 FALL)</cx:pt>
          <cx:pt idx="75">KH VWD (SAP, 21 FALL)</cx:pt>
          <cx:pt idx="76">KH VWD (SAP, 21 FALL)</cx:pt>
          <cx:pt idx="77">KH VWD (SAP, 21 FALL)</cx:pt>
          <cx:pt idx="78">KH VWD (SAP, 21 FALL)</cx:pt>
          <cx:pt idx="79">KH VWD (SAP, 21 FALL)</cx:pt>
          <cx:pt idx="80">KH VWD (SAP, 21 FALL)</cx:pt>
          <cx:pt idx="81">KH VWD (SAP, 21 FALL)</cx:pt>
          <cx:pt idx="82">KH VWD (SAP, 21 FALL)</cx:pt>
          <cx:pt idx="83">KH VWD (SAP, 21 FALL)</cx:pt>
          <cx:pt idx="84">KH VWD (SAP, 21 FALL)</cx:pt>
          <cx:pt idx="85">KH VWD (SAP, 21 FALL)</cx:pt>
          <cx:pt idx="86">KH VWD (SAP, 21 FALL)</cx:pt>
          <cx:pt idx="87">KH VWD (SAP, 21 FALL)</cx:pt>
          <cx:pt idx="88">KH VWD (SAP, 21 FALL)</cx:pt>
          <cx:pt idx="89">KH VWD (SAP, 21 FALL)</cx:pt>
          <cx:pt idx="90">KH VWD (SAP, 21 FALL)</cx:pt>
          <cx:pt idx="91">KH VWD (SAP, 21 FALL)</cx:pt>
          <cx:pt idx="92">KH VWD (SAP, 21 FALL)</cx:pt>
          <cx:pt idx="93">KH VWD (SAP, 21 FALL)</cx:pt>
          <cx:pt idx="94">KH VWD (SAP, 21 FALL)</cx:pt>
          <cx:pt idx="95">KH VWD (SAP, 21 FALL)</cx:pt>
          <cx:pt idx="96">KH VWD (SAP, 21 FALL)</cx:pt>
          <cx:pt idx="97">KH VWD (SAP, 21 FALL)</cx:pt>
          <cx:pt idx="98">KH VWD (SAP, 21 FALL)</cx:pt>
          <cx:pt idx="99">KH VWD (SAP, 21 FALL)</cx:pt>
          <cx:pt idx="100">KH VWD (SAP, 21 FALL)</cx:pt>
          <cx:pt idx="101">KH VWD (SAP, 21 FALL)</cx:pt>
          <cx:pt idx="102">KH VWD (SAP, 21 FALL)</cx:pt>
          <cx:pt idx="103">KH VWD (SAP, 21 FALL)</cx:pt>
          <cx:pt idx="104">KH VWD (SAP, 21 FALL)</cx:pt>
          <cx:pt idx="105">KH VWD (SAP, 21 FALL)</cx:pt>
          <cx:pt idx="106">KH VWD (SAP, 21 FALL)</cx:pt>
          <cx:pt idx="107">KH VWD (SAP, 21 FALL)</cx:pt>
          <cx:pt idx="108">KH VWD (SAP, 21 FALL)</cx:pt>
          <cx:pt idx="109">KH VWD (SAP, 21 FALL)</cx:pt>
          <cx:pt idx="110">KH VWD (SAP, 21 FALL)</cx:pt>
          <cx:pt idx="111">KH VWD (SAP, 21 FALL)</cx:pt>
          <cx:pt idx="112">KH VWD (SAP, 21 FALL)</cx:pt>
          <cx:pt idx="113">KH VWD (SAP, 21 FALL)</cx:pt>
          <cx:pt idx="114">KH VWD (SAP, 21 FALL)</cx:pt>
          <cx:pt idx="115">KH VWD (SAP, 21 FALL)</cx:pt>
          <cx:pt idx="116">KH VWD (SAP, 21 FALL)</cx:pt>
          <cx:pt idx="117">KH VWD (SAP, 21 FALL)</cx:pt>
          <cx:pt idx="118">KH VWD (SAP, 21 FALL)</cx:pt>
          <cx:pt idx="119">KH VWD (SAP, 21 FALL)</cx:pt>
          <cx:pt idx="120">KH VWD (SAP, 21 FALL)</cx:pt>
          <cx:pt idx="121">KH VWD (SAP, 21 FALL)</cx:pt>
          <cx:pt idx="122">KH VWD (SAP, 21 FALL)</cx:pt>
          <cx:pt idx="123">KH VWD (SAP, 21 FALL)</cx:pt>
          <cx:pt idx="124">KH VWD (SAP, 21 FALL)</cx:pt>
          <cx:pt idx="125">KH VWD (SAP, 21 FALL)</cx:pt>
          <cx:pt idx="126">KH VWD (SAP, 21 FALL)</cx:pt>
          <cx:pt idx="127">KH VWD (SAP, 21 FALL)</cx:pt>
          <cx:pt idx="128">KH VWD (SAP, 21 FALL)</cx:pt>
          <cx:pt idx="129">KH VWD (SAP, 21 FALL)</cx:pt>
          <cx:pt idx="130">KH VWD (SAP, 21 FALL)</cx:pt>
          <cx:pt idx="131">KH VWD (SAP, 21 FALL)</cx:pt>
          <cx:pt idx="132">KH VWD (SAP, 21 FALL)</cx:pt>
          <cx:pt idx="133">KH VWD (SAP, 21 FALL)</cx:pt>
          <cx:pt idx="134">KH VWD (SAP, 21 FALL)</cx:pt>
          <cx:pt idx="135">KH VWD (SAP, 21 FALL)</cx:pt>
          <cx:pt idx="136">KH VWD (SAP, 21 FALL)</cx:pt>
          <cx:pt idx="137">KH VWD (SAP, 21 FALL)</cx:pt>
          <cx:pt idx="138">KH VWD (SAP, 21 FALL)</cx:pt>
          <cx:pt idx="139">KH VWD (SAP, 21 FALL)</cx:pt>
          <cx:pt idx="140">KH VWD (SAP, 21 FALL)</cx:pt>
          <cx:pt idx="141">KH VWD (SAP, 21 FALL)</cx:pt>
          <cx:pt idx="142">KH VWD (SAP, 21 FALL)</cx:pt>
          <cx:pt idx="143">KH VWD (SAP, 21 FALL)</cx:pt>
          <cx:pt idx="144">KH VWD (SAP, 21 FALL)</cx:pt>
          <cx:pt idx="145">KH VWD (SAP, 21 FALL)</cx:pt>
          <cx:pt idx="146">KH VWD (SAP, 21 FALL)</cx:pt>
          <cx:pt idx="147">KH VWD (SAP, 21 FALL)</cx:pt>
          <cx:pt idx="148">KH VWD (SAP, 21 FALL)</cx:pt>
          <cx:pt idx="149">KH VWD (SAP, 21 FALL)</cx:pt>
          <cx:pt idx="150">KH VWD (SAP, 21 FALL)</cx:pt>
          <cx:pt idx="151">KH VWD (SAP, 21 FALL)</cx:pt>
          <cx:pt idx="152">KH VWD (SAP, 21 FALL)</cx:pt>
          <cx:pt idx="153">KH VWD (SAP, 21 FALL)</cx:pt>
          <cx:pt idx="154">KH VWD (SAP, 21 FALL)</cx:pt>
          <cx:pt idx="155">KH VWD (SAP, 21 FALL)</cx:pt>
          <cx:pt idx="156">KH VWD (SAP, 21 FALL)</cx:pt>
          <cx:pt idx="157">KH VWD (SAP, 21 FALL)</cx:pt>
          <cx:pt idx="158">KH VWD (SAP, 21 FALL)</cx:pt>
          <cx:pt idx="159">KH VWD (SAP, 21 FALL)</cx:pt>
          <cx:pt idx="160">KH VWD (SAP, 21 FALL)</cx:pt>
          <cx:pt idx="161">KH VWD (SAP, 21 FALL)</cx:pt>
          <cx:pt idx="162">KH VWD (SAP, 21 FALL)</cx:pt>
          <cx:pt idx="163">KH VWD (SAP, 21 FALL)</cx:pt>
          <cx:pt idx="164">KH VWD (SAP, 21 FALL)</cx:pt>
          <cx:pt idx="165">KH VWD (SAP, 21 FALL)</cx:pt>
          <cx:pt idx="166">KH VWD (SAP, 21 FALL)</cx:pt>
          <cx:pt idx="167">KH VWD (SAP, 21 FALL)</cx:pt>
          <cx:pt idx="168">KH VWD (SAP, 21 FALL)</cx:pt>
          <cx:pt idx="169">KH VWD (SAP, 21 FALL)</cx:pt>
          <cx:pt idx="170">KH VWD (SAP, 21 FALL)</cx:pt>
          <cx:pt idx="171">KH VWD (SAP, 21 FALL)</cx:pt>
          <cx:pt idx="172">KH VWD (SAP, 21 FALL)</cx:pt>
          <cx:pt idx="173">KH VWD (SAP, 21 FALL)</cx:pt>
          <cx:pt idx="174">KH VWD (SAP, 21 FALL)</cx:pt>
          <cx:pt idx="175">KH VWD (SAP, 21 FALL)</cx:pt>
          <cx:pt idx="176">KH VWD (SAP, 21 FALL)</cx:pt>
          <cx:pt idx="177">KH VWD (SAP, 21 FALL)</cx:pt>
          <cx:pt idx="178">KH VWD (SAP, 21 FALL)</cx:pt>
          <cx:pt idx="179">KH VWD (SAP, 21 FALL)</cx:pt>
          <cx:pt idx="180">KH VWD (SAP, 21 FALL)</cx:pt>
          <cx:pt idx="181">KH VWD (SAP, 21 FALL)</cx:pt>
          <cx:pt idx="182">KH VWD (SAP, 21 FALL)</cx:pt>
          <cx:pt idx="183">KH VWD (SAP, 21 FALL)</cx:pt>
          <cx:pt idx="184">KH VWD (SAP, 21 FALL)</cx:pt>
          <cx:pt idx="185">KH VWD (SAP, 21 FALL)</cx:pt>
          <cx:pt idx="186">KH VWD (SAP, 21 FALL)</cx:pt>
          <cx:pt idx="187">KH VWD (SAP, 21 FALL)</cx:pt>
          <cx:pt idx="188">KH VWD (SAP, 21 FALL)</cx:pt>
          <cx:pt idx="189">KH VWD (SAP, 21 FALL)</cx:pt>
          <cx:pt idx="190">KH VWD (SAP, 21 FALL)</cx:pt>
          <cx:pt idx="191">KH VWD (SAP, 21 FALL)</cx:pt>
          <cx:pt idx="192">KH VWD (SAP, 21 FALL)</cx:pt>
          <cx:pt idx="193">KH VWD (SAP, 21 FALL)</cx:pt>
          <cx:pt idx="194">KH VWD (SAP, 21 FALL)</cx:pt>
          <cx:pt idx="195">KH VWD (SAP, 21 FALL)</cx:pt>
          <cx:pt idx="196">KH VWD (SAP, 21 FALL)</cx:pt>
          <cx:pt idx="197">KH VWD (SAP, 21 FALL)</cx:pt>
          <cx:pt idx="198">KH VWD (SAP, 21 FALL)</cx:pt>
          <cx:pt idx="199">KH VWD (SAP, 21 FALL)</cx:pt>
          <cx:pt idx="200">KH VWD (SAP, 21 FALL)</cx:pt>
          <cx:pt idx="201">KH VWD (SAP, 21 FALL)</cx:pt>
          <cx:pt idx="202">KH VWD (SAP, 21 FALL)</cx:pt>
          <cx:pt idx="203">KH VWD (SAP, 21 FALL)</cx:pt>
          <cx:pt idx="204">KH VWD (SAP, 21 FALL)</cx:pt>
          <cx:pt idx="205">KH VWD (SAP, 21 FALL)</cx:pt>
          <cx:pt idx="206">KH VWD (SAP, 21 FALL)</cx:pt>
          <cx:pt idx="207">KH VWD (SAP, 21 FALL)</cx:pt>
          <cx:pt idx="208">KH VWD (SAP, 21 FALL)</cx:pt>
          <cx:pt idx="209">KH VWD (SAP, 21 FALL)</cx:pt>
          <cx:pt idx="210">KH VWD (SAP, 21 FALL)</cx:pt>
          <cx:pt idx="211">KH VWD (SAP, 21 FALL)</cx:pt>
          <cx:pt idx="212">KH VWD (SAP, 21 FALL)</cx:pt>
          <cx:pt idx="213">KH VWD (SAP, 21 FALL)</cx:pt>
          <cx:pt idx="214">KH VWD (SAP, 21 FALL)</cx:pt>
          <cx:pt idx="215">KH VWD (SAP, 21 FALL)</cx:pt>
          <cx:pt idx="216">KH VWD (SAP, 21 FALL)</cx:pt>
          <cx:pt idx="217">KH VWD (SAP, 21 FALL)</cx:pt>
          <cx:pt idx="218">KH VWD (SAP, 21 FALL)</cx:pt>
          <cx:pt idx="219">KH VWD (SAP, 21 FALL)</cx:pt>
          <cx:pt idx="220">KH VWD (SAP, 21 FALL)</cx:pt>
          <cx:pt idx="221">KH VWD (SAP, 21 FALL)</cx:pt>
          <cx:pt idx="222">KH VWD (SAP, 21 FALL)</cx:pt>
          <cx:pt idx="223">KH VWD (SAP, 21 FALL)</cx:pt>
          <cx:pt idx="224">KH VWD (SAP, 21 FALL)</cx:pt>
          <cx:pt idx="225">KH VWD (SAP, 21 FALL)</cx:pt>
          <cx:pt idx="226">KH VWD (SAP, 21 FALL)</cx:pt>
          <cx:pt idx="227">KH VWD (SAP, 21 FALL)</cx:pt>
          <cx:pt idx="228">KH VWD (SAP, 21 FALL)</cx:pt>
          <cx:pt idx="229">KH VWD (SAP, 21 FALL)</cx:pt>
          <cx:pt idx="230">KH VWD (SAP, 21 FALL)</cx:pt>
          <cx:pt idx="231">KH VWD (SAP, 21 FALL)</cx:pt>
          <cx:pt idx="232">KH VWD (SAP, 21 FALL)</cx:pt>
          <cx:pt idx="233">KH VWD (SAP, 21 FALL)</cx:pt>
          <cx:pt idx="234">KH VWD (SAP, 21 FALL)</cx:pt>
          <cx:pt idx="235">KH VWD (SAP, 21 FALL)</cx:pt>
          <cx:pt idx="236">KH VWD (SAP, 21 FALL)</cx:pt>
          <cx:pt idx="237">KH VWD (SAP, 21 FALL)</cx:pt>
          <cx:pt idx="238">KH VWD (SAP, 21 FALL)</cx:pt>
          <cx:pt idx="239">KH VWD (SAP, 21 FALL)</cx:pt>
          <cx:pt idx="240">KH VWD (SAP, 21 FALL)</cx:pt>
          <cx:pt idx="241">KH VWD (SAP, 21 FALL)</cx:pt>
          <cx:pt idx="242">KH VWD (SAP, 21 FALL)</cx:pt>
          <cx:pt idx="243">KH VWD (SAP, 21 FALL)</cx:pt>
          <cx:pt idx="244">KH VWD (SAP, 21 FALL)</cx:pt>
          <cx:pt idx="245">KH VWD (SAP, 21 FALL)</cx:pt>
          <cx:pt idx="246">KH VWD (SAP, 21 FALL)</cx:pt>
          <cx:pt idx="247">KH VWD (SAP, 21 FALL)</cx:pt>
          <cx:pt idx="248">KH VWD (SAP, 21 FALL)</cx:pt>
          <cx:pt idx="249">KH VWD (SAP, 21 FALL)</cx:pt>
          <cx:pt idx="250">KH VWD (SAP, 21 FALL)</cx:pt>
          <cx:pt idx="251">KH VWD (SAP, 21 FALL)</cx:pt>
          <cx:pt idx="252">KH VWD (SAP, 21 FALL)</cx:pt>
          <cx:pt idx="253">KH VWD (SAP, 21 FALL)</cx:pt>
          <cx:pt idx="254">KH VWD (SAP, 21 FALL)</cx:pt>
          <cx:pt idx="255">KH VWD (SAP, 21 FALL)</cx:pt>
          <cx:pt idx="256">KH VWD (SAP, 21 FALL)</cx:pt>
          <cx:pt idx="257">KH VWD (SAP, 21 FALL)</cx:pt>
          <cx:pt idx="258">KH VWD (SAP, 21 FALL)</cx:pt>
          <cx:pt idx="259">KH VWD (SAP, 21 FALL)</cx:pt>
          <cx:pt idx="260">KH VWD (SAP, 21 FALL)</cx:pt>
          <cx:pt idx="261">KH VWD (SAP, 21 FALL)</cx:pt>
          <cx:pt idx="262">KH VWD (SAP, 21 FALL)</cx:pt>
          <cx:pt idx="263">KH VWD (SAP, 21 FALL)</cx:pt>
          <cx:pt idx="264">KH VWD (SAP, 21 FALL)</cx:pt>
          <cx:pt idx="265">KH VWD (SAP, 21 FALL)</cx:pt>
          <cx:pt idx="266">KH VWD (SAP, 21 FALL)</cx:pt>
          <cx:pt idx="267">KH VWD (SAP, 21 FALL)</cx:pt>
          <cx:pt idx="268">KH VWD (SAP, 21 FALL)</cx:pt>
          <cx:pt idx="269">KH VWD (SAP, 21 FALL)</cx:pt>
          <cx:pt idx="270">KH VWD (SAP, 21 FALL)</cx:pt>
          <cx:pt idx="271">KH VWD (SAP, 21 FALL)</cx:pt>
          <cx:pt idx="272">KH VWD (SAP, 21 FALL)</cx:pt>
          <cx:pt idx="273">KH VWD (SAP, 21 FALL)</cx:pt>
          <cx:pt idx="274">KH VWD (SAP, 21 FALL)</cx:pt>
          <cx:pt idx="275">KH VWD (SAP, 21 FALL)</cx:pt>
          <cx:pt idx="276">KH VWD (SAP, 21 FALL)</cx:pt>
          <cx:pt idx="277">KH VWD (SAP, 21 FALL)</cx:pt>
          <cx:pt idx="278">KH VWD (SAP, 21 FALL)</cx:pt>
          <cx:pt idx="279">KH VWD (SAP, 21 FALL)</cx:pt>
          <cx:pt idx="280">KH VWD (SAP, 21 FALL)</cx:pt>
          <cx:pt idx="281">KH VWD (SAP, 21 FALL)</cx:pt>
          <cx:pt idx="282">KH VWD (SAP, 21 FALL)</cx:pt>
          <cx:pt idx="283">KH VWD (SAP, 21 FALL)</cx:pt>
          <cx:pt idx="284">KH VWD (SAP, 21 FALL)</cx:pt>
          <cx:pt idx="285">KH VWD (SAP, 21 FALL)</cx:pt>
          <cx:pt idx="286">KH VWD (SAP, 21 FALL)</cx:pt>
          <cx:pt idx="287">KH VWD (SAP, 21 FALL)</cx:pt>
          <cx:pt idx="288">KH VWD (SAP, 21 FALL)</cx:pt>
          <cx:pt idx="289">KH VWD (SAP, 21 FALL)</cx:pt>
          <cx:pt idx="290">KH VWD (SAP, 21 FALL)</cx:pt>
          <cx:pt idx="291">KH VWD (SAP, 21 FALL)</cx:pt>
          <cx:pt idx="292">KH VWD (SAP, 21 FALL)</cx:pt>
          <cx:pt idx="293">KH VWD (SAP, 21 FALL)</cx:pt>
          <cx:pt idx="294">KH VWD (SAP, 21 FALL)</cx:pt>
          <cx:pt idx="295">KH VWD (SAP, 21 FALL)</cx:pt>
          <cx:pt idx="296">KH VWD (SAP, 21 FALL)</cx:pt>
          <cx:pt idx="297">KH VWD (SAP, 21 FALL)</cx:pt>
          <cx:pt idx="298">KH VWD (SAP, 21 FALL)</cx:pt>
          <cx:pt idx="299">KH VWD (SAP, 21 FALL)</cx:pt>
          <cx:pt idx="300">KH VWD (SAP, 21 FALL)</cx:pt>
          <cx:pt idx="301">KH VWD (SAP, 21 FALL)</cx:pt>
          <cx:pt idx="302">KH VWD (SAP, 21 FALL)</cx:pt>
          <cx:pt idx="303">KH VWD (SAP, 21 FALL)</cx:pt>
          <cx:pt idx="304">KH VWD (SAP, 21 FALL)</cx:pt>
          <cx:pt idx="305">KH VWD (SAP, 21 FALL)</cx:pt>
          <cx:pt idx="306">KH VWD (SAP, 21 FALL)</cx:pt>
          <cx:pt idx="307">KH VWD (SAP, 21 FALL)</cx:pt>
          <cx:pt idx="308">KH VWD (SAP, 21 FALL)</cx:pt>
          <cx:pt idx="309">KH VWD (SAP, 21 FALL)</cx:pt>
          <cx:pt idx="310">KH VWD (SAP, 21 FALL)</cx:pt>
          <cx:pt idx="311">KH VWD (SAP, 21 FALL)</cx:pt>
          <cx:pt idx="312">KH VWD (SAP, 21 FALL)</cx:pt>
          <cx:pt idx="313">KH VWD (SAP, 21 FALL)</cx:pt>
          <cx:pt idx="314">KH VWD (SAP, 21 FALL)</cx:pt>
          <cx:pt idx="315">KH VWD (SAP, 21 FALL)</cx:pt>
          <cx:pt idx="316">KH VWD (SAP, 21 FALL)</cx:pt>
          <cx:pt idx="317">KH VWD (SAP, 21 FALL)</cx:pt>
          <cx:pt idx="318">KH VWD (SAP, 21 FALL)</cx:pt>
          <cx:pt idx="319">KH VWD (SAP, 21 FALL)</cx:pt>
          <cx:pt idx="320">KH VWD (SAP, 21 FALL)</cx:pt>
          <cx:pt idx="321">KH VWD (SAP, 21 FALL)</cx:pt>
          <cx:pt idx="322">KH VWD (SAP, 21 FALL)</cx:pt>
          <cx:pt idx="323">KH VWD (SAP, 21 FALL)</cx:pt>
          <cx:pt idx="324">KH VWD (SAP, 21 FALL)</cx:pt>
          <cx:pt idx="325">KH VWD (SAP, 21 FALL)</cx:pt>
          <cx:pt idx="326">KH VWD (SAP, 21 FALL)</cx:pt>
          <cx:pt idx="327">KH VWD (SAP, 21 FALL)</cx:pt>
          <cx:pt idx="328">KH VWD (SAP, 21 FALL)</cx:pt>
          <cx:pt idx="329">KH VWD (SAP, 21 FALL)</cx:pt>
          <cx:pt idx="330">KH VWD (SAP, 21 FALL)</cx:pt>
          <cx:pt idx="331">KH VWD (SAP, 21 FALL)</cx:pt>
          <cx:pt idx="332">KH VWD (SAP, 21 FALL)</cx:pt>
          <cx:pt idx="333">KH VWD (SAP, 21 FALL)</cx:pt>
          <cx:pt idx="334">KH VWD (SAP, 21 FALL)</cx:pt>
          <cx:pt idx="335">KH VWD (SAP, 21 FALL)</cx:pt>
          <cx:pt idx="336">KH VWD (SAP, 21 FALL)</cx:pt>
          <cx:pt idx="337">KH VWD (SAP, 21 FALL)</cx:pt>
          <cx:pt idx="338">KH VWD (SAP, 21 FALL)</cx:pt>
          <cx:pt idx="339">KH VWD (SAP, 21 FALL)</cx:pt>
          <cx:pt idx="340">KH VWD (SAP, 21 FALL)</cx:pt>
          <cx:pt idx="341">KH VWD (SAP, 21 FALL)</cx:pt>
          <cx:pt idx="342">KH VWD (SAP, 21 FALL)</cx:pt>
          <cx:pt idx="343">KH VWD (SAP, 21 FALL)</cx:pt>
          <cx:pt idx="344">KH VWD (SAP, 21 FALL)</cx:pt>
          <cx:pt idx="345">KH VWD (SAP, 21 FALL)</cx:pt>
          <cx:pt idx="346">KH VWD (SAP, 21 FALL)</cx:pt>
          <cx:pt idx="347">KH VWD (SAP, 21 FALL)</cx:pt>
          <cx:pt idx="348">KH VWD (SAP, 21 FALL)</cx:pt>
          <cx:pt idx="349">KH VWD (SAP, 21 FALL)</cx:pt>
          <cx:pt idx="350">KH VWD (SAP, 21 FALL)</cx:pt>
          <cx:pt idx="351">KH VWD (SAP, 21 FALL)</cx:pt>
          <cx:pt idx="352">KH VWD (SAP, 21 FALL)</cx:pt>
          <cx:pt idx="353">KH VWD (SAP, 21 FALL)</cx:pt>
          <cx:pt idx="354">KH VWD (SAP, 21 FALL)</cx:pt>
          <cx:pt idx="355">KH VWD (SAP, 21 FALL)</cx:pt>
          <cx:pt idx="356">KH VWD (SAP, 21 FALL)</cx:pt>
          <cx:pt idx="357">KH VWD (SAP, 21 FALL)</cx:pt>
          <cx:pt idx="358">KH VWD (SAP, 21 FALL)</cx:pt>
          <cx:pt idx="359">KH VWD (SAP, 21 FALL)</cx:pt>
          <cx:pt idx="360">KH VWD (SAP, 21 FALL)</cx:pt>
          <cx:pt idx="361">KH VWD (SAP, 21 FALL)</cx:pt>
          <cx:pt idx="362">KH VWD (SAP, 21 FALL)</cx:pt>
          <cx:pt idx="363">KH VWD (SAP, 21 FALL)</cx:pt>
          <cx:pt idx="364">KH VWD (SAP, 21 FALL)</cx:pt>
          <cx:pt idx="365">KH VWD (SAP, 21 FALL)</cx:pt>
          <cx:pt idx="366">KH VWD (SAP, 21 FALL)</cx:pt>
          <cx:pt idx="367">KH VWD (SAP, 21 FALL)</cx:pt>
          <cx:pt idx="368">KH VWD (SAP, 21 FALL)</cx:pt>
          <cx:pt idx="369">KH VWD (SAP, 21 FALL)</cx:pt>
          <cx:pt idx="370">KH VWD (SAP, 21 FALL)</cx:pt>
          <cx:pt idx="371">KH VWD (SAP, 21 FALL)</cx:pt>
          <cx:pt idx="372">KH VWD (SAP, 21 FALL)</cx:pt>
          <cx:pt idx="373">KH VWD (SAP, 21 FALL)</cx:pt>
          <cx:pt idx="374">KH VWD (SAP, 21 FALL)</cx:pt>
          <cx:pt idx="375">KH VWD (SAP, 21 FALL)</cx:pt>
          <cx:pt idx="376">KH VWD (SAP, 21 FALL)</cx:pt>
          <cx:pt idx="377">KH VWD (SAP, 21 FALL)</cx:pt>
          <cx:pt idx="378">KH VWD (SAP, 21 FALL)</cx:pt>
          <cx:pt idx="379">KH VWD (SAP, 21 FALL)</cx:pt>
          <cx:pt idx="380">KH VWD (SAP, 21 FALL)</cx:pt>
          <cx:pt idx="381">KH VWD (SAP, 21 FALL)</cx:pt>
          <cx:pt idx="382">KH VWD (SAP, 21 FALL)</cx:pt>
          <cx:pt idx="383">KH VWD (SAP, 21 FALL)</cx:pt>
          <cx:pt idx="384">KH VWD (SAP, 21 FALL)</cx:pt>
          <cx:pt idx="385">KH VWD (SAP, 21 FALL)</cx:pt>
          <cx:pt idx="386">KH VWD (SAP, 21 FALL)</cx:pt>
          <cx:pt idx="387">KH VWD (SAP, 21 FALL)</cx:pt>
          <cx:pt idx="388">KH VWD (SAP, 21 FALL)</cx:pt>
          <cx:pt idx="389">KH VWD (SAP, 21 FALL)</cx:pt>
          <cx:pt idx="390">KH VWD (SAP, 21 FALL)</cx:pt>
          <cx:pt idx="391">KH VWD (SAP, 21 FALL)</cx:pt>
          <cx:pt idx="392">KH VWD (SAP, 21 FALL)</cx:pt>
          <cx:pt idx="393">KH VWD (SAP, 21 FALL)</cx:pt>
          <cx:pt idx="394">KH VWD (SAP, 21 FALL)</cx:pt>
          <cx:pt idx="395">KH VWD (SAP, 21 FALL)</cx:pt>
          <cx:pt idx="396">KH VWD (SAP, 21 FALL)</cx:pt>
          <cx:pt idx="397">KH VWD (SAP, 21 FALL)</cx:pt>
          <cx:pt idx="398">KH VWD (SAP, 21 FALL)</cx:pt>
          <cx:pt idx="399">KH VWD (SAP, 21 FALL)</cx:pt>
          <cx:pt idx="400">KH VWD (SAP, 21 FALL)</cx:pt>
          <cx:pt idx="401">KH VWD (SAP, 21 FALL)</cx:pt>
          <cx:pt idx="402">KH VWD (SAP, 21 FALL)</cx:pt>
          <cx:pt idx="403">KH VWD (SAP, 21 FALL)</cx:pt>
          <cx:pt idx="404">KH VWD (SAP, 21 FALL)</cx:pt>
          <cx:pt idx="405">KH VWD (SAP, 21 FALL)</cx:pt>
          <cx:pt idx="406">KH VWD (SAP, 21 FALL)</cx:pt>
          <cx:pt idx="407">KH VWD (SAP, 21 FALL)</cx:pt>
          <cx:pt idx="408">KH VWD (SAP, 21 FALL)</cx:pt>
          <cx:pt idx="409">KH VWD (SAP, 21 FALL)</cx:pt>
          <cx:pt idx="410">KH VWD (SAP, 21 FALL)</cx:pt>
          <cx:pt idx="411">KH VWD (SAP, 21 FALL)</cx:pt>
          <cx:pt idx="412">KH VWD (SAP, 21 FALL)</cx:pt>
          <cx:pt idx="413">KH VWD (SAP, 21 FALL)</cx:pt>
          <cx:pt idx="414">KH VWD (SAP, 21 FALL)</cx:pt>
          <cx:pt idx="415">KH VWD (SAP, 21 FALL)</cx:pt>
          <cx:pt idx="416">KH VWD (SAP, 21 FALL)</cx:pt>
          <cx:pt idx="417">KH VWD (SAP, 21 FALL)</cx:pt>
          <cx:pt idx="418">KH VWD (SAP, 21 FALL)</cx:pt>
          <cx:pt idx="419">KH VWD (SAP, 21 FALL)</cx:pt>
          <cx:pt idx="420">KH VWD (SAP, 21 FALL)</cx:pt>
          <cx:pt idx="421">KH VWD (SAP, 21 FALL)</cx:pt>
          <cx:pt idx="422">KH VWD (SAP, 21 FALL)</cx:pt>
          <cx:pt idx="423">KH VWD (SAP, 21 FALL)</cx:pt>
          <cx:pt idx="424">KH VWD (SAP, 21 FALL)</cx:pt>
          <cx:pt idx="425">KH VWD (SAP, 21 FALL)</cx:pt>
          <cx:pt idx="426">KH VWD (SAP, 21 FALL)</cx:pt>
          <cx:pt idx="427">KH VWD (SAP, 21 FALL)</cx:pt>
          <cx:pt idx="428">KH VWD (SAP, 21 FALL)</cx:pt>
          <cx:pt idx="429">KH VWD (SAP, 21 FALL)</cx:pt>
          <cx:pt idx="430">KH VWD (SAP, 21 FALL)</cx:pt>
          <cx:pt idx="431">KH VWD (SAP, 21 FALL)</cx:pt>
          <cx:pt idx="432">KH VWD (SAP, 21 FALL)</cx:pt>
          <cx:pt idx="433">KH VWD (SAP, 21 FALL)</cx:pt>
          <cx:pt idx="434">KH VWD (SAP, 21 FALL)</cx:pt>
          <cx:pt idx="435">KH VWD (SAP, 21 FALL)</cx:pt>
          <cx:pt idx="436">KH VWD (SAP, 21 FALL)</cx:pt>
          <cx:pt idx="437">KH VWD (SAP, 21 FALL)</cx:pt>
          <cx:pt idx="438">KH VWD (SAP, 21 FALL)</cx:pt>
          <cx:pt idx="439">KH VWD (SAP, 21 FALL)</cx:pt>
          <cx:pt idx="440">KH VWD (SAP, 21 FALL)</cx:pt>
          <cx:pt idx="441">KH VWD (SAP, 21 FALL)</cx:pt>
          <cx:pt idx="442">KH VWD (SAP, 21 FALL)</cx:pt>
          <cx:pt idx="443">KH VWD (SAP, 21 FALL)</cx:pt>
          <cx:pt idx="444">KH VWD (SAP, 21 FALL)</cx:pt>
          <cx:pt idx="445">KH VWD (SAP, 21 FALL)</cx:pt>
          <cx:pt idx="446">KH VWD (SAP, 21 FALL)</cx:pt>
          <cx:pt idx="447">KH VWD (SAP, 21 FALL)</cx:pt>
          <cx:pt idx="448">KH VWD (SAP, 21 FALL)</cx:pt>
          <cx:pt idx="449">KH VWD (SAP, 21 FALL)</cx:pt>
          <cx:pt idx="450">KH VWD (SAP, 21 FALL)</cx:pt>
          <cx:pt idx="451">KH VWD (SAP, 21 FALL)</cx:pt>
          <cx:pt idx="452">KH VWD (SAP, 21 FALL)</cx:pt>
          <cx:pt idx="453">KH VWD (SAP, 21 FALL)</cx:pt>
          <cx:pt idx="454">KH VWD (SAP, 21 FALL)</cx:pt>
          <cx:pt idx="455">KH VWD (SAP, 21 FALL)</cx:pt>
          <cx:pt idx="456">KH VWD (SAP, 21 FALL)</cx:pt>
          <cx:pt idx="457">KH VWD (SAP, 21 FALL)</cx:pt>
          <cx:pt idx="458">KH VWD (SAP, 21 FALL)</cx:pt>
          <cx:pt idx="459">KH VWD (SAP, 21 FALL)</cx:pt>
          <cx:pt idx="460">KH VWD (SAP, 21 FALL)</cx:pt>
          <cx:pt idx="461">KH VWD (SAP, 21 FALL)</cx:pt>
          <cx:pt idx="462">KH VWD (SAP, 21 FALL)</cx:pt>
          <cx:pt idx="463">KH VWD (SAP, 21 FALL)</cx:pt>
          <cx:pt idx="464">KH VWD (SAP, 21 FALL)</cx:pt>
          <cx:pt idx="465">KH VWD (SAP, 21 FALL)</cx:pt>
          <cx:pt idx="466">KH VWD (SAP, 21 FALL)</cx:pt>
          <cx:pt idx="467">KH VWD (SAP, 21 FALL)</cx:pt>
          <cx:pt idx="468">KH VWD (SAP, 21 FALL)</cx:pt>
          <cx:pt idx="469">KH VWD (SAP, 21 FALL)</cx:pt>
          <cx:pt idx="470">KH VWD (SAP, 21 FALL)</cx:pt>
          <cx:pt idx="471">KH VWD (SAP, 21 FALL)</cx:pt>
          <cx:pt idx="472">KH VWD (SAP, 21 FALL)</cx:pt>
          <cx:pt idx="473">KH VWD (SAP, 21 FALL)</cx:pt>
          <cx:pt idx="474">KH VWD (SAP, 21 FALL)</cx:pt>
          <cx:pt idx="475">KH VWD (SAP, 21 FALL)</cx:pt>
          <cx:pt idx="476">KH VWD (SAP, 21 FALL)</cx:pt>
          <cx:pt idx="477">KH VWD (SAP, 21 FALL)</cx:pt>
          <cx:pt idx="478">KH VWD (SAP, 21 FALL)</cx:pt>
          <cx:pt idx="479">KH VWD (SAP, 21 FALL)</cx:pt>
          <cx:pt idx="480">KH VWD (SAP, 21 FALL)</cx:pt>
          <cx:pt idx="481">KH VWD (SAP, 21 FALL)</cx:pt>
          <cx:pt idx="482">KH VWD (SAP, 21 FALL)</cx:pt>
          <cx:pt idx="483">KH VWD (SAP, 21 FALL)</cx:pt>
          <cx:pt idx="484">KH VWD (SAP, 21 FALL)</cx:pt>
          <cx:pt idx="485">KH VWD (SAP, 21 FALL)</cx:pt>
          <cx:pt idx="486">KH VWD (SAP, 21 FALL)</cx:pt>
          <cx:pt idx="487">KH VWD (SAP, 21 FALL)</cx:pt>
          <cx:pt idx="488">KH VWD (SAP, 21 FALL)</cx:pt>
          <cx:pt idx="489">KH VWD (SAP, 21 FALL)</cx:pt>
          <cx:pt idx="490">KH VWD (SAP, 21 FALL)</cx:pt>
          <cx:pt idx="491">KH VWD (SAP, 21 FALL)</cx:pt>
          <cx:pt idx="492">KH VWD (SAP, 21 FALL)</cx:pt>
          <cx:pt idx="493">KH VWD (SAP, 21 FALL)</cx:pt>
          <cx:pt idx="494">KH VWD (SAP, 21 FALL)</cx:pt>
          <cx:pt idx="495">KH VWD (SAP, 21 FALL)</cx:pt>
          <cx:pt idx="496">KH VWD (SAP, 21 FALL)</cx:pt>
          <cx:pt idx="497">KH VWD (SAP, 21 FALL)</cx:pt>
          <cx:pt idx="498">KH VWD (SAP, 21 FALL)</cx:pt>
          <cx:pt idx="499">KH VWD (SAP, 21 FALL)</cx:pt>
          <cx:pt idx="500">KH VWD (SAP, 21 FALL)</cx:pt>
          <cx:pt idx="501">KH VWD (SAP, 21 FALL)</cx:pt>
          <cx:pt idx="502">KH VWD (SAP, 21 FALL)</cx:pt>
          <cx:pt idx="503">KH VWD (SAP, 21 FALL)</cx:pt>
          <cx:pt idx="504">KH VWD (SAP, 21 FALL)</cx:pt>
          <cx:pt idx="505">KH VWD (SAP, 21 FALL)</cx:pt>
          <cx:pt idx="506">KH VWD (SAP, 21 FALL)</cx:pt>
          <cx:pt idx="507">KH VWD (SAP, 21 FALL)</cx:pt>
          <cx:pt idx="508">KH VWD (SAP, 21 FALL)</cx:pt>
          <cx:pt idx="509">KH VWD (SAP, 21 FALL)</cx:pt>
          <cx:pt idx="510">KH VWD (SAP, 21 FALL)</cx:pt>
          <cx:pt idx="511">KH VWD (SAP, 21 FALL)</cx:pt>
          <cx:pt idx="512">KH VWD (SAP, 21 FALL)</cx:pt>
          <cx:pt idx="513">KH VWD (SAP, 21 FALL)</cx:pt>
          <cx:pt idx="514">KH VWD (SAP, 21 FALL)</cx:pt>
          <cx:pt idx="515">KH VWD (SAP, 21 FALL)</cx:pt>
          <cx:pt idx="516">KH VWD (SAP, 21 FALL)</cx:pt>
          <cx:pt idx="517">KH VWD (SAP, 21 FALL)</cx:pt>
          <cx:pt idx="518">KH VWD (SAP, 21 FALL)</cx:pt>
          <cx:pt idx="519">KH VWD (SAP, 21 FALL)</cx:pt>
          <cx:pt idx="520">KH VWD (SAP, 21 FALL)</cx:pt>
          <cx:pt idx="521">KH VWD (SAP, 21 FALL)</cx:pt>
          <cx:pt idx="522">KH VWD (SAP, 21 FALL)</cx:pt>
          <cx:pt idx="523">KH VWD (SAP, 21 FALL)</cx:pt>
          <cx:pt idx="524">KH VWD (SAP, 21 FALL)</cx:pt>
          <cx:pt idx="525">KH VWD (SAP, 21 FALL)</cx:pt>
          <cx:pt idx="526">KH VWD (SAP, 21 FALL)</cx:pt>
          <cx:pt idx="527">KH VWD (SAP, 21 FALL)</cx:pt>
          <cx:pt idx="528">KH VWD (SAP, 21 FALL)</cx:pt>
          <cx:pt idx="529">KH VWD (SAP, 21 FALL)</cx:pt>
          <cx:pt idx="530">KH VWD (SAP, 21 FALL)</cx:pt>
          <cx:pt idx="531">KH VWD (SAP, 21 FALL)</cx:pt>
          <cx:pt idx="532">KH VWD (SAP, 21 FALL)</cx:pt>
          <cx:pt idx="533">KH VWD (SAP, 21 FALL)</cx:pt>
          <cx:pt idx="534">KH VWD (SAP, 21 FALL)</cx:pt>
          <cx:pt idx="535">KH VWD (SAP, 21 FALL)</cx:pt>
          <cx:pt idx="536">KH VWD (SAP, 21 FALL)</cx:pt>
          <cx:pt idx="537">KH VWD (SAP, 21 FALL)</cx:pt>
          <cx:pt idx="538">KH VWD (SAP, 21 FALL)</cx:pt>
          <cx:pt idx="539">KH VWD (SAP, 21 FALL)</cx:pt>
          <cx:pt idx="540">KH VWD (SAP, 21 FALL)</cx:pt>
          <cx:pt idx="541">KH VWD (SAP, 21 FALL)</cx:pt>
          <cx:pt idx="542">KH VWD (SAP, 21 FALL)</cx:pt>
          <cx:pt idx="543">KH VWD (SAP, 21 FALL)</cx:pt>
          <cx:pt idx="544">KH VWD (SAP, 21 FALL)</cx:pt>
          <cx:pt idx="545">KH VWD (SAP, 21 FALL)</cx:pt>
          <cx:pt idx="546">KH VWD (SAP, 21 FALL)</cx:pt>
          <cx:pt idx="547">KH VWD (SAP, 21 FALL)</cx:pt>
          <cx:pt idx="548">KH VWD (SAP, 21 FALL)</cx:pt>
          <cx:pt idx="549">KH VWD (SAP, 21 FALL)</cx:pt>
          <cx:pt idx="550">KH VWD (SAP, 21 FALL)</cx:pt>
          <cx:pt idx="551">KH VWD (SAP, 21 FALL)</cx:pt>
          <cx:pt idx="552">KH VWD (SAP, 21 FALL)</cx:pt>
          <cx:pt idx="553">KH VWD (SAP, 21 FALL)</cx:pt>
          <cx:pt idx="554">KH VWD (SAP, 21 FALL)</cx:pt>
          <cx:pt idx="555">KH VWD (SAP, 21 FALL)</cx:pt>
          <cx:pt idx="556">KH VWD (SAP, 21 FALL)</cx:pt>
          <cx:pt idx="557">KH VWD (SAP, 21 FALL)</cx:pt>
          <cx:pt idx="558">KH VWD (SAP, 21 FALL)</cx:pt>
          <cx:pt idx="559">KH VWD (SAP, 21 FALL)</cx:pt>
          <cx:pt idx="560">KH VWD (SAP, 21 FALL)</cx:pt>
          <cx:pt idx="561">KH VWD (SAP, 21 FALL)</cx:pt>
          <cx:pt idx="562">KH VWD (SAP, 21 FALL)</cx:pt>
          <cx:pt idx="563">KH VWD (SAP, 21 FALL)</cx:pt>
          <cx:pt idx="564">KH VWD (SAP, 21 FALL)</cx:pt>
          <cx:pt idx="565">KH VWD (SAP, 21 FALL)</cx:pt>
          <cx:pt idx="566">KH VWD (SAP, 21 FALL)</cx:pt>
          <cx:pt idx="567">KH VWD (SAP, 21 FALL)</cx:pt>
          <cx:pt idx="568">KH VWD (SAP, 21 FALL)</cx:pt>
          <cx:pt idx="569">KH VWD (SAP, 21 FALL)</cx:pt>
          <cx:pt idx="570">KH VWD (SAP, 21 FALL)</cx:pt>
          <cx:pt idx="571">KH VWD (SAP, 21 FALL)</cx:pt>
          <cx:pt idx="572">KH VWD (SAP, 21 FALL)</cx:pt>
          <cx:pt idx="573">KH VWD (SAP, 21 FALL)</cx:pt>
          <cx:pt idx="574">KH VWD (SAP, 21 FALL)</cx:pt>
          <cx:pt idx="575">KH VWD (SAP, 21 FALL)</cx:pt>
          <cx:pt idx="576">KH VWD (SAP, 21 FALL)</cx:pt>
          <cx:pt idx="577">KH VWD (SAP, 21 FALL)</cx:pt>
          <cx:pt idx="578">KH VWD (SAP, 21 FALL)</cx:pt>
          <cx:pt idx="579">KH VWD (SAP, 21 FALL)</cx:pt>
          <cx:pt idx="580">KH VWD (SAP, 21 FALL)</cx:pt>
          <cx:pt idx="581">KH VWD (SAP, 21 FALL)</cx:pt>
          <cx:pt idx="582">KH VWD (SAP, 21 FALL)</cx:pt>
          <cx:pt idx="583">KH VWD (SAP, 21 FALL)</cx:pt>
          <cx:pt idx="584">KH VWD (SAP, 21 FALL)</cx:pt>
          <cx:pt idx="585">KH VWD (SAP, 21 FALL)</cx:pt>
          <cx:pt idx="586">KH VWD (SAP, 21 FALL)</cx:pt>
          <cx:pt idx="587">KH VWD (SAP, 21 FALL)</cx:pt>
          <cx:pt idx="588">KH VWD (SAP, 21 FALL)</cx:pt>
          <cx:pt idx="589">KH VWD (SAP, 21 FALL)</cx:pt>
          <cx:pt idx="590">KH VWD (SAP, 21 FALL)</cx:pt>
          <cx:pt idx="591">KH VWD (SAP, 21 FALL)</cx:pt>
          <cx:pt idx="592">KH VWD (SAP, 21 FALL)</cx:pt>
          <cx:pt idx="593">KH VWD (SAP, 21 FALL)</cx:pt>
          <cx:pt idx="594">KH VWD (SAP, 21 FALL)</cx:pt>
          <cx:pt idx="595">KH VWD (SAP, 21 FALL)</cx:pt>
          <cx:pt idx="596">KH VWD (SAP, 21 FALL)</cx:pt>
          <cx:pt idx="597">KH VWD (SAP, 21 FALL)</cx:pt>
          <cx:pt idx="598">KH VWD (SAP, 21 FALL)</cx:pt>
          <cx:pt idx="599">KH VWD (SAP, 21 FALL)</cx:pt>
          <cx:pt idx="600">KH VWD (SAP, 21 FALL)</cx:pt>
          <cx:pt idx="601">KH VWD (SAP, 21 FALL)</cx:pt>
          <cx:pt idx="602">KH VWD (SAP, 21 FALL)</cx:pt>
          <cx:pt idx="603">KH VWD (SAP, 21 FALL)</cx:pt>
          <cx:pt idx="604">KH VWD (SAP, 21 FALL)</cx:pt>
          <cx:pt idx="605">KH VWD (SAP, 21 FALL)</cx:pt>
          <cx:pt idx="606">KH VWD (SAP, 21 FALL)</cx:pt>
          <cx:pt idx="607">KH VWD (SAP, 21 FALL)</cx:pt>
          <cx:pt idx="608">KH VWD (SAP, 21 FALL)</cx:pt>
          <cx:pt idx="609">KH VWD (SAP, 21 FALL)</cx:pt>
          <cx:pt idx="610">KH VWD (SAP, 21 FALL)</cx:pt>
          <cx:pt idx="611">KH VWD (SAP, 21 FALL)</cx:pt>
          <cx:pt idx="612">KH VWD (SAP, 21 FALL)</cx:pt>
          <cx:pt idx="613">KH VWD (SAP, 21 FALL)</cx:pt>
          <cx:pt idx="614">KH VWD (SAP, 21 FALL)</cx:pt>
          <cx:pt idx="615">KH VWD (SAP, 21 FALL)</cx:pt>
          <cx:pt idx="616">KH VWD (SAP, 21 FALL)</cx:pt>
          <cx:pt idx="617">KH VWD (SAP, 21 FALL)</cx:pt>
          <cx:pt idx="618">KH VWD (SAP, 21 FALL)</cx:pt>
          <cx:pt idx="619">KH VWD (SAP, 21 FALL)</cx:pt>
          <cx:pt idx="620">KH VWD (SAP, 21 FALL)</cx:pt>
          <cx:pt idx="621">KH VWD (SAP, 21 FALL)</cx:pt>
          <cx:pt idx="622">KH VWD (SAP, 21 FALL)</cx:pt>
          <cx:pt idx="623">KH VWD (SAP, 21 FALL)</cx:pt>
          <cx:pt idx="624">KH VWD (SAP, 21 FALL)</cx:pt>
          <cx:pt idx="625">KH VWD (SAP, 21 FALL)</cx:pt>
          <cx:pt idx="626">KH VWD (SAP, 21 FALL)</cx:pt>
          <cx:pt idx="627">KH VWD (SAP, 21 FALL)</cx:pt>
          <cx:pt idx="628">KH VWD (SAP, 21 FALL)</cx:pt>
          <cx:pt idx="629">KH VWD (SAP, 21 FALL)</cx:pt>
          <cx:pt idx="630">KH VWD (SAP, 21 FALL)</cx:pt>
          <cx:pt idx="631">KH VWD (SAP, 21 FALL)</cx:pt>
          <cx:pt idx="632">KH VWD (SAP, 21 FALL)</cx:pt>
          <cx:pt idx="633">KH VWD (SAP, 21 FALL)</cx:pt>
          <cx:pt idx="634">KH VWD (SAP, 21 FALL)</cx:pt>
          <cx:pt idx="635">KH VWD (SAP, 21 FALL)</cx:pt>
          <cx:pt idx="636">KH VWD (SAP, 21 FALL)</cx:pt>
          <cx:pt idx="637">KH VWD (SAP, 21 FALL)</cx:pt>
          <cx:pt idx="638">KH VWD (SAP, 21 FALL)</cx:pt>
          <cx:pt idx="639">KH VWD (SAP, 21 FALL)</cx:pt>
          <cx:pt idx="640">KH VWD (SAP, 21 FALL)</cx:pt>
          <cx:pt idx="641">KH VWD (SAP, 21 FALL)</cx:pt>
          <cx:pt idx="642">KH VWD (SAP, 21 FALL)</cx:pt>
          <cx:pt idx="643">KH VWD (SAP, 21 FALL)</cx:pt>
          <cx:pt idx="644">KH VWD (SAP, 21 FALL)</cx:pt>
          <cx:pt idx="645">KH VWD (SAP, 21 FALL)</cx:pt>
          <cx:pt idx="646">KH VWD (SAP, 21 FALL)</cx:pt>
          <cx:pt idx="647">KH VWD (SAP, 21 FALL)</cx:pt>
          <cx:pt idx="648">KH VWD (SAP, 21 FALL)</cx:pt>
          <cx:pt idx="649">KH VWD (SAP, 21 FALL)</cx:pt>
          <cx:pt idx="650">KH VWD (SAP, 21 FALL)</cx:pt>
          <cx:pt idx="651">KH VWD (SAP, 21 FALL)</cx:pt>
          <cx:pt idx="652">KH VWD (SAP, 21 FALL)</cx:pt>
          <cx:pt idx="653">KH VWD (SAP, 21 FALL)</cx:pt>
          <cx:pt idx="654">KH VWD (SAP, 21 FALL)</cx:pt>
          <cx:pt idx="655">KH VWD (SAP, 21 FALL)</cx:pt>
          <cx:pt idx="656">KH VWD (SAP, 21 FALL)</cx:pt>
          <cx:pt idx="657">KH VWD (SAP, 21 FALL)</cx:pt>
          <cx:pt idx="658">KH VWD (SAP, 21 FALL)</cx:pt>
          <cx:pt idx="659">KH VWD (SAP, 21 FALL)</cx:pt>
          <cx:pt idx="660">KH VWD (SAP, 21 FALL)</cx:pt>
          <cx:pt idx="661">KH VWD (SAP, 21 FALL)</cx:pt>
          <cx:pt idx="662">KH VWD (SAP, 21 FALL)</cx:pt>
          <cx:pt idx="663">KH VWD (SAP, 21 FALL)</cx:pt>
          <cx:pt idx="664">KH VWD (SAP, 21 FALL)</cx:pt>
          <cx:pt idx="665">KH VWD (SAP, 21 FALL)</cx:pt>
          <cx:pt idx="666">KH VWD (SAP, 21 FALL)</cx:pt>
          <cx:pt idx="667">KH VWD (SAP, 21 FALL)</cx:pt>
          <cx:pt idx="668">KH VWD (SAP, 21 FALL)</cx:pt>
          <cx:pt idx="669">KH VWD (SAP, 21 FALL)</cx:pt>
          <cx:pt idx="670">KH VWD (SAP, 21 FALL)</cx:pt>
          <cx:pt idx="671">KH VWD (SAP, 21 FALL)</cx:pt>
          <cx:pt idx="672">KH VWD (SAP, 21 FALL)</cx:pt>
          <cx:pt idx="673">KH VWD (SAP, 21 FALL)</cx:pt>
          <cx:pt idx="674">KH VWD (SAP, 21 FALL)</cx:pt>
          <cx:pt idx="675">KH VWD (SAP, 21 FALL)</cx:pt>
          <cx:pt idx="676">KH VWD (SAP, 21 FALL)</cx:pt>
          <cx:pt idx="677">KH VWD (SAP, 21 FALL)</cx:pt>
          <cx:pt idx="678">KH VWD (SAP, 21 FALL)</cx:pt>
          <cx:pt idx="679">KH VWD (SAP, 21 FALL)</cx:pt>
          <cx:pt idx="680">KH VWD (SAP, 21 FALL)</cx:pt>
          <cx:pt idx="681">KH VWD (SAP, 21 FALL)</cx:pt>
          <cx:pt idx="682">KH VWD (SAP, 21 FALL)</cx:pt>
          <cx:pt idx="683">KH VWD (SAP, 21 FALL)</cx:pt>
          <cx:pt idx="684">KH VWD (SAP, 21 FALL)</cx:pt>
          <cx:pt idx="685">KH VWD (SAP, 21 FALL)</cx:pt>
          <cx:pt idx="686">KH VWD (SAP, 21 FALL)</cx:pt>
          <cx:pt idx="687">KH VWD (SAP, 21 FALL)</cx:pt>
          <cx:pt idx="688">KH VWD (SAP, 21 FALL)</cx:pt>
          <cx:pt idx="689">KH VWD (SAP, 21 FALL)</cx:pt>
          <cx:pt idx="690">KH VWD (SAP, 21 FALL)</cx:pt>
          <cx:pt idx="691">KH VWD (SAP, 21 FALL)</cx:pt>
          <cx:pt idx="692">KH VWD (SAP, 21 FALL)</cx:pt>
          <cx:pt idx="693">KH VWD (SAP, 21 FALL)</cx:pt>
          <cx:pt idx="694">KH VWD (SAP, 21 FALL)</cx:pt>
          <cx:pt idx="695">KH VWD (SAP, 21 FALL)</cx:pt>
          <cx:pt idx="696">KH VWD (SAP, 21 FALL)</cx:pt>
          <cx:pt idx="697">KH VWD (SAP, 21 FALL)</cx:pt>
          <cx:pt idx="698">KH VWD (SAP, 21 FALL)</cx:pt>
          <cx:pt idx="699">KH VWD (SAP, 21 FALL)</cx:pt>
          <cx:pt idx="700">KH VWD (SAP, 21 FALL)</cx:pt>
          <cx:pt idx="701">KH VWD (SAP, 21 FALL)</cx:pt>
          <cx:pt idx="702">KH VWD (SAP, 21 FALL)</cx:pt>
          <cx:pt idx="703">KH VWD (SAP, 21 FALL)</cx:pt>
          <cx:pt idx="704">KH VWD (SAP, 21 FALL)</cx:pt>
          <cx:pt idx="705">KH VWD (SAP, 21 FALL)</cx:pt>
          <cx:pt idx="706">KH VWD (SAP, 21 FALL)</cx:pt>
          <cx:pt idx="707">KH VWD (SAP, 21 FALL)</cx:pt>
          <cx:pt idx="708">KH VWD (SAP, 21 FALL)</cx:pt>
          <cx:pt idx="709">KH VWD (SAP, 21 FALL)</cx:pt>
          <cx:pt idx="710">KH VWD (SAP, 21 FALL)</cx:pt>
          <cx:pt idx="711">KH VWD (SAP, 21 FALL)</cx:pt>
          <cx:pt idx="712">KH VWD (SAP, 21 FALL)</cx:pt>
          <cx:pt idx="713">KH VWD (SAP, 21 FALL)</cx:pt>
          <cx:pt idx="714">KH VWD (SAP, 21 FALL)</cx:pt>
          <cx:pt idx="715">KH VWD (SAP, 21 FALL)</cx:pt>
          <cx:pt idx="716">KH VWD (SAP, 21 FALL)</cx:pt>
          <cx:pt idx="717">KH VWD (SAP, 21 FALL)</cx:pt>
          <cx:pt idx="718">KH VWD (SAP, 21 FALL)</cx:pt>
          <cx:pt idx="719">KH VWD (SAP, 21 FALL)</cx:pt>
          <cx:pt idx="720">KH VWD (SAP, 21 FALL)</cx:pt>
          <cx:pt idx="721">KH VWD (SAP, 21 FALL)</cx:pt>
          <cx:pt idx="722">KH VWD (SAP, 21 FALL)</cx:pt>
          <cx:pt idx="723">KH VWD (SAP, 21 FALL)</cx:pt>
          <cx:pt idx="724">KH VWD (SAP, 21 FALL)</cx:pt>
          <cx:pt idx="725">KH VWD (SAP, 21 FALL)</cx:pt>
          <cx:pt idx="726">KH VWD (SAP, 21 FALL)</cx:pt>
          <cx:pt idx="727">KH VWD (SAP, 21 FALL)</cx:pt>
          <cx:pt idx="728">KH VWD (SAP, 21 FALL)</cx:pt>
          <cx:pt idx="729">KH VWD (SAP, 21 FALL)</cx:pt>
          <cx:pt idx="730">KH VWD (SAP, 21 FALL)</cx:pt>
          <cx:pt idx="731">KH VWD (SAP, 21 FALL)</cx:pt>
          <cx:pt idx="732">KH VWD (SAP, 21 FALL)</cx:pt>
          <cx:pt idx="733">KH VWD (SAP, 21 FALL)</cx:pt>
          <cx:pt idx="734">KH VWD (SAP, 21 FALL)</cx:pt>
          <cx:pt idx="735">KH VWD (SAP, 21 FALL)</cx:pt>
          <cx:pt idx="736">KH VWD (SAP, 21 FALL)</cx:pt>
          <cx:pt idx="737">KH VWD (SAP, 21 FALL)</cx:pt>
          <cx:pt idx="738">KH VWD (SAP, 21 FALL)</cx:pt>
          <cx:pt idx="739">KH VWD (SAP, 21 FALL)</cx:pt>
          <cx:pt idx="740">KH VWD (SAP, 21 FALL)</cx:pt>
          <cx:pt idx="741">KH VWD (SAP, 21 FALL)</cx:pt>
          <cx:pt idx="742">KH VWD (SAP, 21 FALL)</cx:pt>
          <cx:pt idx="743">KH VWD (SAP, 21 FALL)</cx:pt>
          <cx:pt idx="744">KH VWD (SAP, 21 FALL)</cx:pt>
          <cx:pt idx="745">KH VWD (SAP, 21 FALL)</cx:pt>
          <cx:pt idx="746">KH VWD (SAP, 21 FALL)</cx:pt>
          <cx:pt idx="747">KH VWD (SAP, 21 FALL)</cx:pt>
          <cx:pt idx="748">KH VWD (SAP, 21 FALL)</cx:pt>
          <cx:pt idx="749">KH VWD (SAP, 21 FALL)</cx:pt>
          <cx:pt idx="750">KH VWD (SAP, 21 FALL)</cx:pt>
          <cx:pt idx="751">KH VWD (SAP, 21 FALL)</cx:pt>
          <cx:pt idx="752">KH VWD (SAP, 21 FALL)</cx:pt>
          <cx:pt idx="753">KH VWD (SAP, 21 FALL)</cx:pt>
          <cx:pt idx="754">KH VWD (SAP, 21 FALL)</cx:pt>
          <cx:pt idx="755">KH VWD (SAP, 21 FALL)</cx:pt>
          <cx:pt idx="756">KH VWD (SAP, 21 FALL)</cx:pt>
          <cx:pt idx="757">KH VWD (SAP, 21 FALL)</cx:pt>
          <cx:pt idx="758">KH VWD (SAP, 21 FALL)</cx:pt>
          <cx:pt idx="759">KH VWD (SAP, 21 FALL)</cx:pt>
          <cx:pt idx="760">KH VWD (SAP, 21 FALL)</cx:pt>
          <cx:pt idx="761">KH VWD (SAP, 21 FALL)</cx:pt>
          <cx:pt idx="762">KH VWD (SAP, 21 FALL)</cx:pt>
          <cx:pt idx="763">KH VWD (SAP, 21 FALL)</cx:pt>
          <cx:pt idx="764">KH VWD (SAP, 21 FALL)</cx:pt>
          <cx:pt idx="765">KH VWD (SAP, 21 FALL)</cx:pt>
          <cx:pt idx="766">KH VWD (SAP, 21 FALL)</cx:pt>
          <cx:pt idx="767">KH VWD (SAP, 21 FALL)</cx:pt>
          <cx:pt idx="768">KH VWD (SAP, 21 FALL)</cx:pt>
          <cx:pt idx="769">KH VWD (SAP, 21 FALL)</cx:pt>
          <cx:pt idx="770">KH VWD (SAP, 21 FALL)</cx:pt>
          <cx:pt idx="771">KH VWD (SAP, 21 FALL)</cx:pt>
          <cx:pt idx="772">KH VWD (SAP, 21 FALL)</cx:pt>
          <cx:pt idx="773">KH VWD (SAP, 21 FALL)</cx:pt>
          <cx:pt idx="774">KH VWD (SAP, 21 FALL)</cx:pt>
          <cx:pt idx="775">KH VWD (SAP, 21 FALL)</cx:pt>
          <cx:pt idx="776">KH VWD (SAP, 21 FALL)</cx:pt>
          <cx:pt idx="777">KH VWD (SAP, 21 FALL)</cx:pt>
          <cx:pt idx="778">KH VWD (SAP, 21 FALL)</cx:pt>
          <cx:pt idx="779">KH VWD (SAP, 21 FALL)</cx:pt>
          <cx:pt idx="780">KH VWD (SAP, 21 FALL)</cx:pt>
          <cx:pt idx="781">KH VWD (SAP, 21 FALL)</cx:pt>
          <cx:pt idx="782">KH VWD (SAP, 21 FALL)</cx:pt>
          <cx:pt idx="783">KH VWD (SAP, 21 FALL)</cx:pt>
          <cx:pt idx="784">KH VWD (SAP, 21 FALL)</cx:pt>
          <cx:pt idx="785">KH VWD (SAP, 21 FALL)</cx:pt>
          <cx:pt idx="786">KH VWD (SAP, 21 FALL)</cx:pt>
          <cx:pt idx="787">KH VWD (SAP, 21 FALL)</cx:pt>
          <cx:pt idx="788">KH VWD (SAP, 21 FALL)</cx:pt>
          <cx:pt idx="789">KH VWD (SAP, 21 FALL)</cx:pt>
          <cx:pt idx="790">KH VWD (SAP, 21 FALL)</cx:pt>
          <cx:pt idx="791">KH VWD (SAP, 21 FALL)</cx:pt>
          <cx:pt idx="792">KH VWD (SAP, 21 FALL)</cx:pt>
          <cx:pt idx="793">KH VWD (SAP, 21 FALL)</cx:pt>
          <cx:pt idx="794">KH VWD (SAP, 21 FALL)</cx:pt>
          <cx:pt idx="795">KH VWD (SAP, 21 FALL)</cx:pt>
          <cx:pt idx="796">KH VWD (SAP, 21 FALL)</cx:pt>
          <cx:pt idx="797">KH VWD (SAP, 21 FALL)</cx:pt>
          <cx:pt idx="798">KH VWD (SAP, 21 FALL)</cx:pt>
          <cx:pt idx="799">KH VWD (SAP, 21 FALL)</cx:pt>
          <cx:pt idx="800">KH VWD (SAP, 21 FALL)</cx:pt>
          <cx:pt idx="801">KH VWD (SAP, 21 FALL)</cx:pt>
          <cx:pt idx="802">KH VWD (SAP, 21 FALL)</cx:pt>
        </cx:lvl>
      </cx:strDim>
      <cx:numDim type="val">
        <cx:lvl ptCount="803" formatCode="General">
          <cx:pt idx="0">2</cx:pt>
          <cx:pt idx="1">2</cx:pt>
          <cx:pt idx="2">2</cx:pt>
          <cx:pt idx="3">2</cx:pt>
          <cx:pt idx="4">2</cx:pt>
          <cx:pt idx="5">2</cx:pt>
          <cx:pt idx="6">2</cx:pt>
          <cx:pt idx="7">3</cx:pt>
          <cx:pt idx="8">3</cx:pt>
          <cx:pt idx="9">3</cx:pt>
          <cx:pt idx="10">3</cx:pt>
          <cx:pt idx="11">3</cx:pt>
          <cx:pt idx="12">3</cx:pt>
          <cx:pt idx="13">3</cx:pt>
          <cx:pt idx="14">3</cx:pt>
          <cx:pt idx="15">3</cx:pt>
          <cx:pt idx="16">3</cx:pt>
          <cx:pt idx="17">3</cx:pt>
          <cx:pt idx="18">3</cx:pt>
          <cx:pt idx="19">3</cx:pt>
          <cx:pt idx="20">3</cx:pt>
          <cx:pt idx="21">4</cx:pt>
          <cx:pt idx="22">4</cx:pt>
          <cx:pt idx="23">4</cx:pt>
          <cx:pt idx="24">4</cx:pt>
          <cx:pt idx="25">4</cx:pt>
          <cx:pt idx="26">4</cx:pt>
          <cx:pt idx="27">4</cx:pt>
          <cx:pt idx="28">4</cx:pt>
          <cx:pt idx="29">4</cx:pt>
          <cx:pt idx="30">4</cx:pt>
          <cx:pt idx="31">4</cx:pt>
          <cx:pt idx="32">4</cx:pt>
          <cx:pt idx="33">4</cx:pt>
          <cx:pt idx="34">4</cx:pt>
          <cx:pt idx="35">4</cx:pt>
          <cx:pt idx="36">4</cx:pt>
          <cx:pt idx="37">4</cx:pt>
          <cx:pt idx="38">4</cx:pt>
          <cx:pt idx="39">4</cx:pt>
          <cx:pt idx="40">4</cx:pt>
          <cx:pt idx="41">4</cx:pt>
          <cx:pt idx="42">4</cx:pt>
          <cx:pt idx="43">4</cx:pt>
          <cx:pt idx="44">4</cx:pt>
          <cx:pt idx="45">4</cx:pt>
          <cx:pt idx="46">4</cx:pt>
          <cx:pt idx="47">4</cx:pt>
          <cx:pt idx="48">4</cx:pt>
          <cx:pt idx="49">5</cx:pt>
          <cx:pt idx="50">5</cx:pt>
          <cx:pt idx="51">5</cx:pt>
          <cx:pt idx="52">5</cx:pt>
          <cx:pt idx="53">5</cx:pt>
          <cx:pt idx="54">5</cx:pt>
          <cx:pt idx="55">5</cx:pt>
          <cx:pt idx="56">5</cx:pt>
          <cx:pt idx="57">5</cx:pt>
          <cx:pt idx="58">5</cx:pt>
          <cx:pt idx="59">5</cx:pt>
          <cx:pt idx="60">5</cx:pt>
          <cx:pt idx="61">5</cx:pt>
          <cx:pt idx="62">5</cx:pt>
          <cx:pt idx="63">5</cx:pt>
          <cx:pt idx="64">5</cx:pt>
          <cx:pt idx="65">5</cx:pt>
          <cx:pt idx="66">5</cx:pt>
          <cx:pt idx="67">5</cx:pt>
          <cx:pt idx="68">5</cx:pt>
          <cx:pt idx="69">5</cx:pt>
          <cx:pt idx="70">5</cx:pt>
          <cx:pt idx="71">5</cx:pt>
          <cx:pt idx="72">5</cx:pt>
          <cx:pt idx="73">5</cx:pt>
          <cx:pt idx="74">5</cx:pt>
          <cx:pt idx="75">5</cx:pt>
          <cx:pt idx="76">5</cx:pt>
          <cx:pt idx="77">5</cx:pt>
          <cx:pt idx="78">5</cx:pt>
          <cx:pt idx="79">5</cx:pt>
          <cx:pt idx="80">6</cx:pt>
          <cx:pt idx="81">6</cx:pt>
          <cx:pt idx="82">6</cx:pt>
          <cx:pt idx="83">6</cx:pt>
          <cx:pt idx="84">6</cx:pt>
          <cx:pt idx="85">6</cx:pt>
          <cx:pt idx="86">6</cx:pt>
          <cx:pt idx="87">6</cx:pt>
          <cx:pt idx="88">6</cx:pt>
          <cx:pt idx="89">6</cx:pt>
          <cx:pt idx="90">6</cx:pt>
          <cx:pt idx="91">6</cx:pt>
          <cx:pt idx="92">6</cx:pt>
          <cx:pt idx="93">6</cx:pt>
          <cx:pt idx="94">6</cx:pt>
          <cx:pt idx="95">6</cx:pt>
          <cx:pt idx="96">6</cx:pt>
          <cx:pt idx="97">6</cx:pt>
          <cx:pt idx="98">6</cx:pt>
          <cx:pt idx="99">6</cx:pt>
          <cx:pt idx="100">6</cx:pt>
          <cx:pt idx="101">6</cx:pt>
          <cx:pt idx="102">6</cx:pt>
          <cx:pt idx="103">6</cx:pt>
          <cx:pt idx="104">6</cx:pt>
          <cx:pt idx="105">6</cx:pt>
          <cx:pt idx="106">6</cx:pt>
          <cx:pt idx="107">6</cx:pt>
          <cx:pt idx="108">6</cx:pt>
          <cx:pt idx="109">6</cx:pt>
          <cx:pt idx="110">6</cx:pt>
          <cx:pt idx="111">6</cx:pt>
          <cx:pt idx="112">6</cx:pt>
          <cx:pt idx="113">6</cx:pt>
          <cx:pt idx="114">6</cx:pt>
          <cx:pt idx="115">6</cx:pt>
          <cx:pt idx="116">6</cx:pt>
          <cx:pt idx="117">6</cx:pt>
          <cx:pt idx="118">6</cx:pt>
          <cx:pt idx="119">6</cx:pt>
          <cx:pt idx="120">6</cx:pt>
          <cx:pt idx="121">6</cx:pt>
          <cx:pt idx="122">6</cx:pt>
          <cx:pt idx="123">6</cx:pt>
          <cx:pt idx="124">7</cx:pt>
          <cx:pt idx="125">7</cx:pt>
          <cx:pt idx="126">7</cx:pt>
          <cx:pt idx="127">7</cx:pt>
          <cx:pt idx="128">7</cx:pt>
          <cx:pt idx="129">7</cx:pt>
          <cx:pt idx="130">7</cx:pt>
          <cx:pt idx="131">7</cx:pt>
          <cx:pt idx="132">7</cx:pt>
          <cx:pt idx="133">7</cx:pt>
          <cx:pt idx="134">7</cx:pt>
          <cx:pt idx="135">7</cx:pt>
          <cx:pt idx="136">7</cx:pt>
          <cx:pt idx="137">7</cx:pt>
          <cx:pt idx="138">7</cx:pt>
          <cx:pt idx="139">7</cx:pt>
          <cx:pt idx="140">7</cx:pt>
          <cx:pt idx="141">7</cx:pt>
          <cx:pt idx="142">7</cx:pt>
          <cx:pt idx="143">7</cx:pt>
          <cx:pt idx="144">7</cx:pt>
          <cx:pt idx="145">7</cx:pt>
          <cx:pt idx="146">7</cx:pt>
          <cx:pt idx="147">7</cx:pt>
          <cx:pt idx="148">7</cx:pt>
          <cx:pt idx="149">7</cx:pt>
          <cx:pt idx="150">7</cx:pt>
          <cx:pt idx="151">7</cx:pt>
          <cx:pt idx="152">7</cx:pt>
          <cx:pt idx="153">7</cx:pt>
          <cx:pt idx="154">7</cx:pt>
          <cx:pt idx="155">7</cx:pt>
          <cx:pt idx="156">7</cx:pt>
          <cx:pt idx="157">7</cx:pt>
          <cx:pt idx="158">7</cx:pt>
          <cx:pt idx="159">7</cx:pt>
          <cx:pt idx="160">7</cx:pt>
          <cx:pt idx="161">7</cx:pt>
          <cx:pt idx="162">7</cx:pt>
          <cx:pt idx="163">7</cx:pt>
          <cx:pt idx="164">7</cx:pt>
          <cx:pt idx="165">7</cx:pt>
          <cx:pt idx="166">7</cx:pt>
          <cx:pt idx="167">7</cx:pt>
          <cx:pt idx="168">7</cx:pt>
          <cx:pt idx="169">7</cx:pt>
          <cx:pt idx="170">7</cx:pt>
          <cx:pt idx="171">7</cx:pt>
          <cx:pt idx="172">7</cx:pt>
          <cx:pt idx="173">7</cx:pt>
          <cx:pt idx="174">8</cx:pt>
          <cx:pt idx="175">8</cx:pt>
          <cx:pt idx="176">8</cx:pt>
          <cx:pt idx="177">8</cx:pt>
          <cx:pt idx="178">8</cx:pt>
          <cx:pt idx="179">8</cx:pt>
          <cx:pt idx="180">8</cx:pt>
          <cx:pt idx="181">8</cx:pt>
          <cx:pt idx="182">8</cx:pt>
          <cx:pt idx="183">8</cx:pt>
          <cx:pt idx="184">8</cx:pt>
          <cx:pt idx="185">8</cx:pt>
          <cx:pt idx="186">8</cx:pt>
          <cx:pt idx="187">8</cx:pt>
          <cx:pt idx="188">8</cx:pt>
          <cx:pt idx="189">8</cx:pt>
          <cx:pt idx="190">8</cx:pt>
          <cx:pt idx="191">8</cx:pt>
          <cx:pt idx="192">8</cx:pt>
          <cx:pt idx="193">8</cx:pt>
          <cx:pt idx="194">8</cx:pt>
          <cx:pt idx="195">8</cx:pt>
          <cx:pt idx="196">8</cx:pt>
          <cx:pt idx="197">8</cx:pt>
          <cx:pt idx="198">8</cx:pt>
          <cx:pt idx="199">8</cx:pt>
          <cx:pt idx="200">8</cx:pt>
          <cx:pt idx="201">8</cx:pt>
          <cx:pt idx="202">8</cx:pt>
          <cx:pt idx="203">8</cx:pt>
          <cx:pt idx="204">8</cx:pt>
          <cx:pt idx="205">8</cx:pt>
          <cx:pt idx="206">8</cx:pt>
          <cx:pt idx="207">8</cx:pt>
          <cx:pt idx="208">8</cx:pt>
          <cx:pt idx="209">8</cx:pt>
          <cx:pt idx="210">8</cx:pt>
          <cx:pt idx="211">8</cx:pt>
          <cx:pt idx="212">8</cx:pt>
          <cx:pt idx="213">8</cx:pt>
          <cx:pt idx="214">8</cx:pt>
          <cx:pt idx="215">8</cx:pt>
          <cx:pt idx="216">8</cx:pt>
          <cx:pt idx="217">8</cx:pt>
          <cx:pt idx="218">8</cx:pt>
          <cx:pt idx="219">8</cx:pt>
          <cx:pt idx="220">8</cx:pt>
          <cx:pt idx="221">8</cx:pt>
          <cx:pt idx="222">8</cx:pt>
          <cx:pt idx="223">8</cx:pt>
          <cx:pt idx="224">8</cx:pt>
          <cx:pt idx="225">8</cx:pt>
          <cx:pt idx="226">8</cx:pt>
          <cx:pt idx="227">8</cx:pt>
          <cx:pt idx="228">9</cx:pt>
          <cx:pt idx="229">9</cx:pt>
          <cx:pt idx="230">9</cx:pt>
          <cx:pt idx="231">9</cx:pt>
          <cx:pt idx="232">9</cx:pt>
          <cx:pt idx="233">9</cx:pt>
          <cx:pt idx="234">9</cx:pt>
          <cx:pt idx="235">9</cx:pt>
          <cx:pt idx="236">9</cx:pt>
          <cx:pt idx="237">9</cx:pt>
          <cx:pt idx="238">9</cx:pt>
          <cx:pt idx="239">9</cx:pt>
          <cx:pt idx="240">9</cx:pt>
          <cx:pt idx="241">9</cx:pt>
          <cx:pt idx="242">9</cx:pt>
          <cx:pt idx="243">9</cx:pt>
          <cx:pt idx="244">9</cx:pt>
          <cx:pt idx="245">9</cx:pt>
          <cx:pt idx="246">9</cx:pt>
          <cx:pt idx="247">9</cx:pt>
          <cx:pt idx="248">9</cx:pt>
          <cx:pt idx="249">9</cx:pt>
          <cx:pt idx="250">9</cx:pt>
          <cx:pt idx="251">9</cx:pt>
          <cx:pt idx="252">9</cx:pt>
          <cx:pt idx="253">9</cx:pt>
          <cx:pt idx="254">9</cx:pt>
          <cx:pt idx="255">9</cx:pt>
          <cx:pt idx="256">9</cx:pt>
          <cx:pt idx="257">9</cx:pt>
          <cx:pt idx="258">9</cx:pt>
          <cx:pt idx="259">9</cx:pt>
          <cx:pt idx="260">9</cx:pt>
          <cx:pt idx="261">9</cx:pt>
          <cx:pt idx="262">9</cx:pt>
          <cx:pt idx="263">9</cx:pt>
          <cx:pt idx="264">9</cx:pt>
          <cx:pt idx="265">9</cx:pt>
          <cx:pt idx="266">9</cx:pt>
          <cx:pt idx="267">9</cx:pt>
          <cx:pt idx="268">9</cx:pt>
          <cx:pt idx="269">9</cx:pt>
          <cx:pt idx="270">9</cx:pt>
          <cx:pt idx="271">10</cx:pt>
          <cx:pt idx="272">10</cx:pt>
          <cx:pt idx="273">10</cx:pt>
          <cx:pt idx="274">10</cx:pt>
          <cx:pt idx="275">10</cx:pt>
          <cx:pt idx="276">10</cx:pt>
          <cx:pt idx="277">10</cx:pt>
          <cx:pt idx="278">10</cx:pt>
          <cx:pt idx="279">10</cx:pt>
          <cx:pt idx="280">10</cx:pt>
          <cx:pt idx="281">10</cx:pt>
          <cx:pt idx="282">10</cx:pt>
          <cx:pt idx="283">10</cx:pt>
          <cx:pt idx="284">10</cx:pt>
          <cx:pt idx="285">10</cx:pt>
          <cx:pt idx="286">10</cx:pt>
          <cx:pt idx="287">10</cx:pt>
          <cx:pt idx="288">10</cx:pt>
          <cx:pt idx="289">10</cx:pt>
          <cx:pt idx="290">10</cx:pt>
          <cx:pt idx="291">10</cx:pt>
          <cx:pt idx="292">10</cx:pt>
          <cx:pt idx="293">10</cx:pt>
          <cx:pt idx="294">10</cx:pt>
          <cx:pt idx="295">10</cx:pt>
          <cx:pt idx="296">10</cx:pt>
          <cx:pt idx="297">10</cx:pt>
          <cx:pt idx="298">10</cx:pt>
          <cx:pt idx="299">10</cx:pt>
          <cx:pt idx="300">11</cx:pt>
          <cx:pt idx="301">11</cx:pt>
          <cx:pt idx="302">11</cx:pt>
          <cx:pt idx="303">11</cx:pt>
          <cx:pt idx="304">11</cx:pt>
          <cx:pt idx="305">11</cx:pt>
          <cx:pt idx="306">11</cx:pt>
          <cx:pt idx="307">11</cx:pt>
          <cx:pt idx="308">11</cx:pt>
          <cx:pt idx="309">11</cx:pt>
          <cx:pt idx="310">11</cx:pt>
          <cx:pt idx="311">11</cx:pt>
          <cx:pt idx="312">11</cx:pt>
          <cx:pt idx="313">11</cx:pt>
          <cx:pt idx="314">11</cx:pt>
          <cx:pt idx="315">11</cx:pt>
          <cx:pt idx="316">11</cx:pt>
          <cx:pt idx="317">11</cx:pt>
          <cx:pt idx="318">11</cx:pt>
          <cx:pt idx="319">11</cx:pt>
          <cx:pt idx="320">11</cx:pt>
          <cx:pt idx="321">11</cx:pt>
          <cx:pt idx="322">11</cx:pt>
          <cx:pt idx="323">11</cx:pt>
          <cx:pt idx="324">11</cx:pt>
          <cx:pt idx="325">11</cx:pt>
          <cx:pt idx="326">11</cx:pt>
          <cx:pt idx="327">11</cx:pt>
          <cx:pt idx="328">11</cx:pt>
          <cx:pt idx="329">11</cx:pt>
          <cx:pt idx="330">11</cx:pt>
          <cx:pt idx="331">11</cx:pt>
          <cx:pt idx="332">11</cx:pt>
          <cx:pt idx="333">11</cx:pt>
          <cx:pt idx="334">12</cx:pt>
          <cx:pt idx="335">12</cx:pt>
          <cx:pt idx="336">12</cx:pt>
          <cx:pt idx="337">12</cx:pt>
          <cx:pt idx="338">12</cx:pt>
          <cx:pt idx="339">12</cx:pt>
          <cx:pt idx="340">12</cx:pt>
          <cx:pt idx="341">12</cx:pt>
          <cx:pt idx="342">12</cx:pt>
          <cx:pt idx="343">12</cx:pt>
          <cx:pt idx="344">12</cx:pt>
          <cx:pt idx="345">12</cx:pt>
          <cx:pt idx="346">12</cx:pt>
          <cx:pt idx="347">12</cx:pt>
          <cx:pt idx="348">12</cx:pt>
          <cx:pt idx="349">12</cx:pt>
          <cx:pt idx="350">12</cx:pt>
          <cx:pt idx="351">12</cx:pt>
          <cx:pt idx="352">12</cx:pt>
          <cx:pt idx="353">12</cx:pt>
          <cx:pt idx="354">12</cx:pt>
          <cx:pt idx="355">12</cx:pt>
          <cx:pt idx="356">12</cx:pt>
          <cx:pt idx="357">12</cx:pt>
          <cx:pt idx="358">12</cx:pt>
          <cx:pt idx="359">12</cx:pt>
          <cx:pt idx="360">12</cx:pt>
          <cx:pt idx="361">12</cx:pt>
          <cx:pt idx="362">12</cx:pt>
          <cx:pt idx="363">12</cx:pt>
          <cx:pt idx="364">12</cx:pt>
          <cx:pt idx="365">12</cx:pt>
          <cx:pt idx="366">12</cx:pt>
          <cx:pt idx="367">12</cx:pt>
          <cx:pt idx="368">12</cx:pt>
          <cx:pt idx="369">13</cx:pt>
          <cx:pt idx="370">13</cx:pt>
          <cx:pt idx="371">13</cx:pt>
          <cx:pt idx="372">13</cx:pt>
          <cx:pt idx="373">13</cx:pt>
          <cx:pt idx="374">13</cx:pt>
          <cx:pt idx="375">13</cx:pt>
          <cx:pt idx="376">13</cx:pt>
          <cx:pt idx="377">13</cx:pt>
          <cx:pt idx="378">13</cx:pt>
          <cx:pt idx="379">13</cx:pt>
          <cx:pt idx="380">13</cx:pt>
          <cx:pt idx="381">13</cx:pt>
          <cx:pt idx="382">13</cx:pt>
          <cx:pt idx="383">13</cx:pt>
          <cx:pt idx="384">13</cx:pt>
          <cx:pt idx="385">13</cx:pt>
          <cx:pt idx="386">13</cx:pt>
          <cx:pt idx="387">13</cx:pt>
          <cx:pt idx="388">13</cx:pt>
          <cx:pt idx="389">13</cx:pt>
          <cx:pt idx="390">13</cx:pt>
          <cx:pt idx="391">13</cx:pt>
          <cx:pt idx="392">13</cx:pt>
          <cx:pt idx="393">13</cx:pt>
          <cx:pt idx="394">13</cx:pt>
          <cx:pt idx="395">13</cx:pt>
          <cx:pt idx="396">13</cx:pt>
          <cx:pt idx="397">13</cx:pt>
          <cx:pt idx="398">13</cx:pt>
          <cx:pt idx="399">13</cx:pt>
          <cx:pt idx="400">13</cx:pt>
          <cx:pt idx="401">13</cx:pt>
          <cx:pt idx="402">13</cx:pt>
          <cx:pt idx="403">13</cx:pt>
          <cx:pt idx="404">13</cx:pt>
          <cx:pt idx="405">14</cx:pt>
          <cx:pt idx="406">14</cx:pt>
          <cx:pt idx="407">14</cx:pt>
          <cx:pt idx="408">14</cx:pt>
          <cx:pt idx="409">14</cx:pt>
          <cx:pt idx="410">14</cx:pt>
          <cx:pt idx="411">14</cx:pt>
          <cx:pt idx="412">14</cx:pt>
          <cx:pt idx="413">14</cx:pt>
          <cx:pt idx="414">14</cx:pt>
          <cx:pt idx="415">14</cx:pt>
          <cx:pt idx="416">14</cx:pt>
          <cx:pt idx="417">14</cx:pt>
          <cx:pt idx="418">14</cx:pt>
          <cx:pt idx="419">14</cx:pt>
          <cx:pt idx="420">14</cx:pt>
          <cx:pt idx="421">14</cx:pt>
          <cx:pt idx="422">14</cx:pt>
          <cx:pt idx="423">14</cx:pt>
          <cx:pt idx="424">14</cx:pt>
          <cx:pt idx="425">14</cx:pt>
          <cx:pt idx="426">14</cx:pt>
          <cx:pt idx="427">14</cx:pt>
          <cx:pt idx="428">14</cx:pt>
          <cx:pt idx="429">14</cx:pt>
          <cx:pt idx="430">14</cx:pt>
          <cx:pt idx="431">14</cx:pt>
          <cx:pt idx="432">14</cx:pt>
          <cx:pt idx="433">14</cx:pt>
          <cx:pt idx="434">15</cx:pt>
          <cx:pt idx="435">15</cx:pt>
          <cx:pt idx="436">15</cx:pt>
          <cx:pt idx="437">15</cx:pt>
          <cx:pt idx="438">15</cx:pt>
          <cx:pt idx="439">15</cx:pt>
          <cx:pt idx="440">15</cx:pt>
          <cx:pt idx="441">15</cx:pt>
          <cx:pt idx="442">15</cx:pt>
          <cx:pt idx="443">15</cx:pt>
          <cx:pt idx="444">15</cx:pt>
          <cx:pt idx="445">15</cx:pt>
          <cx:pt idx="446">15</cx:pt>
          <cx:pt idx="447">15</cx:pt>
          <cx:pt idx="448">15</cx:pt>
          <cx:pt idx="449">15</cx:pt>
          <cx:pt idx="450">15</cx:pt>
          <cx:pt idx="451">15</cx:pt>
          <cx:pt idx="452">15</cx:pt>
          <cx:pt idx="453">15</cx:pt>
          <cx:pt idx="454">15</cx:pt>
          <cx:pt idx="455">15</cx:pt>
          <cx:pt idx="456">15</cx:pt>
          <cx:pt idx="457">16</cx:pt>
          <cx:pt idx="458">16</cx:pt>
          <cx:pt idx="459">16</cx:pt>
          <cx:pt idx="460">16</cx:pt>
          <cx:pt idx="461">16</cx:pt>
          <cx:pt idx="462">16</cx:pt>
          <cx:pt idx="463">16</cx:pt>
          <cx:pt idx="464">16</cx:pt>
          <cx:pt idx="465">16</cx:pt>
          <cx:pt idx="466">16</cx:pt>
          <cx:pt idx="467">16</cx:pt>
          <cx:pt idx="468">16</cx:pt>
          <cx:pt idx="469">16</cx:pt>
          <cx:pt idx="470">16</cx:pt>
          <cx:pt idx="471">16</cx:pt>
          <cx:pt idx="472">16</cx:pt>
          <cx:pt idx="473">16</cx:pt>
          <cx:pt idx="474">16</cx:pt>
          <cx:pt idx="475">16</cx:pt>
          <cx:pt idx="476">16</cx:pt>
          <cx:pt idx="477">16</cx:pt>
          <cx:pt idx="478">16</cx:pt>
          <cx:pt idx="479">16</cx:pt>
          <cx:pt idx="480">16</cx:pt>
          <cx:pt idx="481">16</cx:pt>
          <cx:pt idx="482">16</cx:pt>
          <cx:pt idx="483">16</cx:pt>
          <cx:pt idx="484">16</cx:pt>
          <cx:pt idx="485">17</cx:pt>
          <cx:pt idx="486">17</cx:pt>
          <cx:pt idx="487">17</cx:pt>
          <cx:pt idx="488">17</cx:pt>
          <cx:pt idx="489">17</cx:pt>
          <cx:pt idx="490">17</cx:pt>
          <cx:pt idx="491">17</cx:pt>
          <cx:pt idx="492">17</cx:pt>
          <cx:pt idx="493">17</cx:pt>
          <cx:pt idx="494">17</cx:pt>
          <cx:pt idx="495">17</cx:pt>
          <cx:pt idx="496">17</cx:pt>
          <cx:pt idx="497">17</cx:pt>
          <cx:pt idx="498">17</cx:pt>
          <cx:pt idx="499">17</cx:pt>
          <cx:pt idx="500">17</cx:pt>
          <cx:pt idx="501">17</cx:pt>
          <cx:pt idx="502">17</cx:pt>
          <cx:pt idx="503">17</cx:pt>
          <cx:pt idx="504">17</cx:pt>
          <cx:pt idx="505">17</cx:pt>
          <cx:pt idx="506">17</cx:pt>
          <cx:pt idx="507">17</cx:pt>
          <cx:pt idx="508">17</cx:pt>
          <cx:pt idx="509">17</cx:pt>
          <cx:pt idx="510">17</cx:pt>
          <cx:pt idx="511">17</cx:pt>
          <cx:pt idx="512">17</cx:pt>
          <cx:pt idx="513">18</cx:pt>
          <cx:pt idx="514">18</cx:pt>
          <cx:pt idx="515">18</cx:pt>
          <cx:pt idx="516">18</cx:pt>
          <cx:pt idx="517">18</cx:pt>
          <cx:pt idx="518">18</cx:pt>
          <cx:pt idx="519">18</cx:pt>
          <cx:pt idx="520">18</cx:pt>
          <cx:pt idx="521">18</cx:pt>
          <cx:pt idx="522">18</cx:pt>
          <cx:pt idx="523">18</cx:pt>
          <cx:pt idx="524">18</cx:pt>
          <cx:pt idx="525">18</cx:pt>
          <cx:pt idx="526">18</cx:pt>
          <cx:pt idx="527">18</cx:pt>
          <cx:pt idx="528">18</cx:pt>
          <cx:pt idx="529">19</cx:pt>
          <cx:pt idx="530">19</cx:pt>
          <cx:pt idx="531">19</cx:pt>
          <cx:pt idx="532">19</cx:pt>
          <cx:pt idx="533">19</cx:pt>
          <cx:pt idx="534">19</cx:pt>
          <cx:pt idx="535">19</cx:pt>
          <cx:pt idx="536">19</cx:pt>
          <cx:pt idx="537">19</cx:pt>
          <cx:pt idx="538">19</cx:pt>
          <cx:pt idx="539">19</cx:pt>
          <cx:pt idx="540">19</cx:pt>
          <cx:pt idx="541">19</cx:pt>
          <cx:pt idx="542">19</cx:pt>
          <cx:pt idx="543">19</cx:pt>
          <cx:pt idx="544">19</cx:pt>
          <cx:pt idx="545">19</cx:pt>
          <cx:pt idx="546">19</cx:pt>
          <cx:pt idx="547">20</cx:pt>
          <cx:pt idx="548">20</cx:pt>
          <cx:pt idx="549">20</cx:pt>
          <cx:pt idx="550">20</cx:pt>
          <cx:pt idx="551">20</cx:pt>
          <cx:pt idx="552">20</cx:pt>
          <cx:pt idx="553">20</cx:pt>
          <cx:pt idx="554">20</cx:pt>
          <cx:pt idx="555">20</cx:pt>
          <cx:pt idx="556">20</cx:pt>
          <cx:pt idx="557">20</cx:pt>
          <cx:pt idx="558">20</cx:pt>
          <cx:pt idx="559">20</cx:pt>
          <cx:pt idx="560">20</cx:pt>
          <cx:pt idx="561">20</cx:pt>
          <cx:pt idx="562">20</cx:pt>
          <cx:pt idx="563">20</cx:pt>
          <cx:pt idx="564">20</cx:pt>
          <cx:pt idx="565">20</cx:pt>
          <cx:pt idx="566">20</cx:pt>
          <cx:pt idx="567">21</cx:pt>
          <cx:pt idx="568">21</cx:pt>
          <cx:pt idx="569">21</cx:pt>
          <cx:pt idx="570">21</cx:pt>
          <cx:pt idx="571">21</cx:pt>
          <cx:pt idx="572">21</cx:pt>
          <cx:pt idx="573">21</cx:pt>
          <cx:pt idx="574">21</cx:pt>
          <cx:pt idx="575">21</cx:pt>
          <cx:pt idx="576">21</cx:pt>
          <cx:pt idx="577">21</cx:pt>
          <cx:pt idx="578">21</cx:pt>
          <cx:pt idx="579">21</cx:pt>
          <cx:pt idx="580">21</cx:pt>
          <cx:pt idx="581">21</cx:pt>
          <cx:pt idx="582">21</cx:pt>
          <cx:pt idx="583">22</cx:pt>
          <cx:pt idx="584">22</cx:pt>
          <cx:pt idx="585">22</cx:pt>
          <cx:pt idx="586">22</cx:pt>
          <cx:pt idx="587">22</cx:pt>
          <cx:pt idx="588">22</cx:pt>
          <cx:pt idx="589">22</cx:pt>
          <cx:pt idx="590">22</cx:pt>
          <cx:pt idx="591">22</cx:pt>
          <cx:pt idx="592">22</cx:pt>
          <cx:pt idx="593">22</cx:pt>
          <cx:pt idx="594">22</cx:pt>
          <cx:pt idx="595">22</cx:pt>
          <cx:pt idx="596">22</cx:pt>
          <cx:pt idx="597">22</cx:pt>
          <cx:pt idx="598">22</cx:pt>
          <cx:pt idx="599">22</cx:pt>
          <cx:pt idx="600">22</cx:pt>
          <cx:pt idx="601">22</cx:pt>
          <cx:pt idx="602">22</cx:pt>
          <cx:pt idx="603">22</cx:pt>
          <cx:pt idx="604">22</cx:pt>
          <cx:pt idx="605">22</cx:pt>
          <cx:pt idx="606">22</cx:pt>
          <cx:pt idx="607">22</cx:pt>
          <cx:pt idx="608">22</cx:pt>
          <cx:pt idx="609">22</cx:pt>
          <cx:pt idx="610">22</cx:pt>
          <cx:pt idx="611">22</cx:pt>
          <cx:pt idx="612">22</cx:pt>
          <cx:pt idx="613">22</cx:pt>
          <cx:pt idx="614">23</cx:pt>
          <cx:pt idx="615">23</cx:pt>
          <cx:pt idx="616">23</cx:pt>
          <cx:pt idx="617">23</cx:pt>
          <cx:pt idx="618">23</cx:pt>
          <cx:pt idx="619">23</cx:pt>
          <cx:pt idx="620">23</cx:pt>
          <cx:pt idx="621">23</cx:pt>
          <cx:pt idx="622">23</cx:pt>
          <cx:pt idx="623">23</cx:pt>
          <cx:pt idx="624">23</cx:pt>
          <cx:pt idx="625">23</cx:pt>
          <cx:pt idx="626">23</cx:pt>
          <cx:pt idx="627">23</cx:pt>
          <cx:pt idx="628">24</cx:pt>
          <cx:pt idx="629">24</cx:pt>
          <cx:pt idx="630">24</cx:pt>
          <cx:pt idx="631">24</cx:pt>
          <cx:pt idx="632">24</cx:pt>
          <cx:pt idx="633">24</cx:pt>
          <cx:pt idx="634">24</cx:pt>
          <cx:pt idx="635">24</cx:pt>
          <cx:pt idx="636">24</cx:pt>
          <cx:pt idx="637">24</cx:pt>
          <cx:pt idx="638">24</cx:pt>
          <cx:pt idx="639">24</cx:pt>
          <cx:pt idx="640">24</cx:pt>
          <cx:pt idx="641">24</cx:pt>
          <cx:pt idx="642">24</cx:pt>
          <cx:pt idx="643">24</cx:pt>
          <cx:pt idx="644">24</cx:pt>
          <cx:pt idx="645">25</cx:pt>
          <cx:pt idx="646">25</cx:pt>
          <cx:pt idx="647">25</cx:pt>
          <cx:pt idx="648">25</cx:pt>
          <cx:pt idx="649">25</cx:pt>
          <cx:pt idx="650">25</cx:pt>
          <cx:pt idx="651">25</cx:pt>
          <cx:pt idx="652">25</cx:pt>
          <cx:pt idx="653">25</cx:pt>
          <cx:pt idx="654">25</cx:pt>
          <cx:pt idx="655">25</cx:pt>
          <cx:pt idx="656">25</cx:pt>
          <cx:pt idx="657">25</cx:pt>
          <cx:pt idx="658">25</cx:pt>
          <cx:pt idx="659">25</cx:pt>
          <cx:pt idx="660">25</cx:pt>
          <cx:pt idx="661">26</cx:pt>
          <cx:pt idx="662">26</cx:pt>
          <cx:pt idx="663">26</cx:pt>
          <cx:pt idx="664">26</cx:pt>
          <cx:pt idx="665">26</cx:pt>
          <cx:pt idx="666">26</cx:pt>
          <cx:pt idx="667">26</cx:pt>
          <cx:pt idx="668">26</cx:pt>
          <cx:pt idx="669">26</cx:pt>
          <cx:pt idx="670">26</cx:pt>
          <cx:pt idx="671">26</cx:pt>
          <cx:pt idx="672">26</cx:pt>
          <cx:pt idx="673">26</cx:pt>
          <cx:pt idx="674">27</cx:pt>
          <cx:pt idx="675">27</cx:pt>
          <cx:pt idx="676">27</cx:pt>
          <cx:pt idx="677">27</cx:pt>
          <cx:pt idx="678">27</cx:pt>
          <cx:pt idx="679">27</cx:pt>
          <cx:pt idx="680">27</cx:pt>
          <cx:pt idx="681">27</cx:pt>
          <cx:pt idx="682">28</cx:pt>
          <cx:pt idx="683">28</cx:pt>
          <cx:pt idx="684">28</cx:pt>
          <cx:pt idx="685">28</cx:pt>
          <cx:pt idx="686">28</cx:pt>
          <cx:pt idx="687">28</cx:pt>
          <cx:pt idx="688">28</cx:pt>
          <cx:pt idx="689">28</cx:pt>
          <cx:pt idx="690">28</cx:pt>
          <cx:pt idx="691">28</cx:pt>
          <cx:pt idx="692">28</cx:pt>
          <cx:pt idx="693">28</cx:pt>
          <cx:pt idx="694">29</cx:pt>
          <cx:pt idx="695">29</cx:pt>
          <cx:pt idx="696">29</cx:pt>
          <cx:pt idx="697">29</cx:pt>
          <cx:pt idx="698">29</cx:pt>
          <cx:pt idx="699">29</cx:pt>
          <cx:pt idx="700">29</cx:pt>
          <cx:pt idx="701">29</cx:pt>
          <cx:pt idx="702">29</cx:pt>
          <cx:pt idx="703">30</cx:pt>
          <cx:pt idx="704">30</cx:pt>
          <cx:pt idx="705">30</cx:pt>
          <cx:pt idx="706">30</cx:pt>
          <cx:pt idx="707">30</cx:pt>
          <cx:pt idx="708">30</cx:pt>
          <cx:pt idx="709">30</cx:pt>
          <cx:pt idx="710">30</cx:pt>
          <cx:pt idx="711">30</cx:pt>
          <cx:pt idx="712">30</cx:pt>
          <cx:pt idx="713">30</cx:pt>
          <cx:pt idx="714">30</cx:pt>
          <cx:pt idx="715">31</cx:pt>
          <cx:pt idx="716">31</cx:pt>
          <cx:pt idx="717">32</cx:pt>
          <cx:pt idx="718">32</cx:pt>
          <cx:pt idx="719">32</cx:pt>
          <cx:pt idx="720">32</cx:pt>
          <cx:pt idx="721">33</cx:pt>
          <cx:pt idx="722">33</cx:pt>
          <cx:pt idx="723">33</cx:pt>
          <cx:pt idx="724">33</cx:pt>
          <cx:pt idx="725">33</cx:pt>
          <cx:pt idx="726">33</cx:pt>
          <cx:pt idx="727">34</cx:pt>
          <cx:pt idx="728">34</cx:pt>
          <cx:pt idx="729">34</cx:pt>
          <cx:pt idx="730">34</cx:pt>
          <cx:pt idx="731">34</cx:pt>
          <cx:pt idx="732">34</cx:pt>
          <cx:pt idx="733">34</cx:pt>
          <cx:pt idx="734">34</cx:pt>
          <cx:pt idx="735">35</cx:pt>
          <cx:pt idx="736">35</cx:pt>
          <cx:pt idx="737">35</cx:pt>
          <cx:pt idx="738">36</cx:pt>
          <cx:pt idx="739">36</cx:pt>
          <cx:pt idx="740">36</cx:pt>
          <cx:pt idx="741">36</cx:pt>
          <cx:pt idx="742">36</cx:pt>
          <cx:pt idx="743">38</cx:pt>
          <cx:pt idx="744">38</cx:pt>
          <cx:pt idx="745">38</cx:pt>
          <cx:pt idx="746">38</cx:pt>
          <cx:pt idx="747">39</cx:pt>
          <cx:pt idx="748">39</cx:pt>
          <cx:pt idx="749">40</cx:pt>
          <cx:pt idx="750">40</cx:pt>
          <cx:pt idx="751">40</cx:pt>
          <cx:pt idx="752">40</cx:pt>
          <cx:pt idx="753">40</cx:pt>
          <cx:pt idx="754">40</cx:pt>
          <cx:pt idx="755">41</cx:pt>
          <cx:pt idx="756">41</cx:pt>
          <cx:pt idx="757">42</cx:pt>
          <cx:pt idx="758">42</cx:pt>
          <cx:pt idx="759">42</cx:pt>
          <cx:pt idx="760">42</cx:pt>
          <cx:pt idx="761">42</cx:pt>
          <cx:pt idx="762">43</cx:pt>
          <cx:pt idx="763">44</cx:pt>
          <cx:pt idx="764">44</cx:pt>
          <cx:pt idx="765">45</cx:pt>
          <cx:pt idx="766">46</cx:pt>
          <cx:pt idx="767">46</cx:pt>
          <cx:pt idx="768">47</cx:pt>
          <cx:pt idx="769">48</cx:pt>
          <cx:pt idx="770">48</cx:pt>
          <cx:pt idx="771">48</cx:pt>
          <cx:pt idx="772">49</cx:pt>
          <cx:pt idx="773">50</cx:pt>
          <cx:pt idx="774">51</cx:pt>
          <cx:pt idx="775">51</cx:pt>
          <cx:pt idx="776">52</cx:pt>
          <cx:pt idx="777">52</cx:pt>
          <cx:pt idx="778">53</cx:pt>
          <cx:pt idx="779">53</cx:pt>
          <cx:pt idx="780">54</cx:pt>
          <cx:pt idx="781">54</cx:pt>
          <cx:pt idx="782">55</cx:pt>
          <cx:pt idx="783">56</cx:pt>
          <cx:pt idx="784">57</cx:pt>
          <cx:pt idx="785">57</cx:pt>
          <cx:pt idx="786">58</cx:pt>
          <cx:pt idx="787">58</cx:pt>
          <cx:pt idx="788">59</cx:pt>
          <cx:pt idx="789">60</cx:pt>
          <cx:pt idx="790">61</cx:pt>
          <cx:pt idx="791">61</cx:pt>
          <cx:pt idx="792">61</cx:pt>
          <cx:pt idx="793">63</cx:pt>
          <cx:pt idx="794">63</cx:pt>
          <cx:pt idx="795">63</cx:pt>
          <cx:pt idx="796">65</cx:pt>
          <cx:pt idx="797">66</cx:pt>
          <cx:pt idx="798">71</cx:pt>
          <cx:pt idx="799">79</cx:pt>
          <cx:pt idx="800">79</cx:pt>
          <cx:pt idx="801">109</cx:pt>
          <cx:pt idx="802">114</cx:pt>
        </cx:lvl>
      </cx:numDim>
    </cx:data>
  </cx:chartData>
  <cx:chart>
    <cx:title pos="t" align="ctr" overlay="0">
      <cx:tx>
        <cx:txData>
          <cx:v/>
        </cx:txData>
      </cx:tx>
      <cx:txPr>
        <a:bodyPr spcFirstLastPara="1" vertOverflow="ellipsis" wrap="square" lIns="0" tIns="0" rIns="0" bIns="0" anchor="ctr" anchorCtr="1"/>
        <a:lstStyle/>
        <a:p>
          <a:pPr algn="ctr">
            <a:defRPr/>
          </a:pPr>
          <a:endParaRPr/>
        </a:p>
      </cx:txPr>
    </cx:title>
    <cx:plotArea>
      <cx:plotAreaRegion>
        <cx:series layoutId="boxWhisker" uniqueId="{4182C088-BBF1-40C3-8A6B-46B290DE937D}">
          <cx:dataId val="0"/>
          <cx:layoutPr>
            <cx:visibility meanLine="0" meanMarker="1" nonoutliers="0" outliers="1"/>
            <cx:statistics quartileMethod="exclusive"/>
          </cx:layoutPr>
        </cx:series>
      </cx:plotAreaRegion>
      <cx:axis id="0">
        <cx:catScaling gapWidth="1"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tickLabels/>
      </cx:axis>
      <cx:axis id="1">
        <cx:valScaling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majorGridlines/>
        <cx:tickLabels/>
      </cx:axis>
    </cx:plotArea>
  </cx:chart>
</cx:chartSpace>
</file>

<file path=ppt/charts/chartEx7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lvl ptCount="803">
          <cx:pt idx="0">Copra, ITS-VWD, Plisten</cx:pt>
          <cx:pt idx="1">Copra, ITS-VWD, Plisten</cx:pt>
          <cx:pt idx="2">Copra, ITS-VWD, Plisten</cx:pt>
          <cx:pt idx="3">Copra, ITS-VWD, Plisten</cx:pt>
          <cx:pt idx="4">Copra, ITS-VWD, Plisten</cx:pt>
          <cx:pt idx="5">Copra, ITS-VWD, Plisten</cx:pt>
          <cx:pt idx="6">Copra, ITS-VWD, Plisten</cx:pt>
          <cx:pt idx="7">Copra, ITS-VWD, Plisten</cx:pt>
          <cx:pt idx="8">Copra, ITS-VWD, Plisten</cx:pt>
          <cx:pt idx="9">Copra, ITS-VWD, Plisten</cx:pt>
          <cx:pt idx="10">Copra, ITS-VWD, Plisten</cx:pt>
          <cx:pt idx="11">Copra, ITS-VWD, Plisten</cx:pt>
          <cx:pt idx="12">Copra, ITS-VWD, Plisten</cx:pt>
          <cx:pt idx="13">Copra, ITS-VWD, Plisten</cx:pt>
          <cx:pt idx="14">Copra, ITS-VWD, Plisten</cx:pt>
          <cx:pt idx="15">Copra, ITS-VWD, Plisten</cx:pt>
          <cx:pt idx="16">Copra, ITS-VWD, Plisten</cx:pt>
          <cx:pt idx="17">Copra, ITS-VWD, Plisten</cx:pt>
          <cx:pt idx="18">Copra, ITS-VWD, Plisten</cx:pt>
          <cx:pt idx="19">Copra, ITS-VWD, Plisten</cx:pt>
          <cx:pt idx="20">Copra, ITS-VWD, Plisten</cx:pt>
          <cx:pt idx="21">Copra, ITS-VWD, Plisten</cx:pt>
          <cx:pt idx="22">Copra, ITS-VWD, Plisten</cx:pt>
          <cx:pt idx="23">Copra, ITS-VWD, Plisten</cx:pt>
          <cx:pt idx="24">Copra, ITS-VWD, Plisten</cx:pt>
          <cx:pt idx="25">Copra, ITS-VWD, Plisten</cx:pt>
          <cx:pt idx="26">Copra, ITS-VWD, Plisten</cx:pt>
          <cx:pt idx="27">Copra, ITS-VWD, Plisten</cx:pt>
          <cx:pt idx="28">Copra, ITS-VWD, Plisten</cx:pt>
          <cx:pt idx="29">Copra, ITS-VWD, Plisten</cx:pt>
          <cx:pt idx="30">Copra, ITS-VWD, Plisten</cx:pt>
          <cx:pt idx="31">Copra, ITS-VWD, Plisten</cx:pt>
          <cx:pt idx="32">Copra, ITS-VWD, Plisten</cx:pt>
          <cx:pt idx="33">Copra, ITS-VWD, Plisten</cx:pt>
          <cx:pt idx="34">Copra, ITS-VWD, Plisten</cx:pt>
          <cx:pt idx="35">Copra, ITS-VWD, Plisten</cx:pt>
          <cx:pt idx="36">Copra, ITS-VWD, Plisten</cx:pt>
          <cx:pt idx="37">Copra, ITS-VWD, Plisten</cx:pt>
          <cx:pt idx="38">Copra, ITS-VWD, Plisten</cx:pt>
          <cx:pt idx="39">Copra, ITS-VWD, Plisten</cx:pt>
          <cx:pt idx="40">Copra, ITS-VWD, Plisten</cx:pt>
          <cx:pt idx="41">Copra, ITS-VWD, Plisten</cx:pt>
          <cx:pt idx="42">Copra, ITS-VWD, Plisten</cx:pt>
          <cx:pt idx="43">Copra, ITS-VWD, Plisten</cx:pt>
          <cx:pt idx="44">Copra, ITS-VWD, Plisten</cx:pt>
          <cx:pt idx="45">Copra, ITS-VWD, Plisten</cx:pt>
          <cx:pt idx="46">Copra, ITS-VWD, Plisten</cx:pt>
          <cx:pt idx="47">Copra, ITS-VWD, Plisten</cx:pt>
          <cx:pt idx="48">Copra, ITS-VWD, Plisten</cx:pt>
          <cx:pt idx="49">Copra, ITS-VWD, Plisten</cx:pt>
          <cx:pt idx="50">Copra, ITS-VWD, Plisten</cx:pt>
          <cx:pt idx="51">Copra, ITS-VWD, Plisten</cx:pt>
          <cx:pt idx="52">Copra, ITS-VWD, Plisten</cx:pt>
          <cx:pt idx="53">Copra, ITS-VWD, Plisten</cx:pt>
          <cx:pt idx="54">Copra, ITS-VWD, Plisten</cx:pt>
          <cx:pt idx="55">Copra, ITS-VWD, Plisten</cx:pt>
          <cx:pt idx="56">Copra, ITS-VWD, Plisten</cx:pt>
          <cx:pt idx="57">Copra, ITS-VWD, Plisten</cx:pt>
          <cx:pt idx="58">Copra, ITS-VWD, Plisten</cx:pt>
          <cx:pt idx="59">Copra, ITS-VWD, Plisten</cx:pt>
          <cx:pt idx="60">Copra, ITS-VWD, Plisten</cx:pt>
          <cx:pt idx="61">Copra, ITS-VWD, Plisten</cx:pt>
          <cx:pt idx="62">Copra, ITS-VWD, Plisten</cx:pt>
          <cx:pt idx="63">Copra, ITS-VWD, Plisten</cx:pt>
          <cx:pt idx="64">Copra, ITS-VWD, Plisten</cx:pt>
          <cx:pt idx="65">Copra, ITS-VWD, Plisten</cx:pt>
          <cx:pt idx="66">Copra, ITS-VWD, Plisten</cx:pt>
          <cx:pt idx="67">Copra, ITS-VWD, Plisten</cx:pt>
          <cx:pt idx="68">Copra, ITS-VWD, Plisten</cx:pt>
          <cx:pt idx="69">Copra, ITS-VWD, Plisten</cx:pt>
          <cx:pt idx="70">Copra, ITS-VWD, Plisten</cx:pt>
          <cx:pt idx="71">Copra, ITS-VWD, Plisten</cx:pt>
          <cx:pt idx="72">Copra, ITS-VWD, Plisten</cx:pt>
          <cx:pt idx="73">Copra, ITS-VWD, Plisten</cx:pt>
          <cx:pt idx="74">Copra, ITS-VWD, Plisten</cx:pt>
          <cx:pt idx="75">Copra, ITS-VWD, Plisten</cx:pt>
          <cx:pt idx="76">Copra, ITS-VWD, Plisten</cx:pt>
          <cx:pt idx="77">Copra, ITS-VWD, Plisten</cx:pt>
          <cx:pt idx="78">Copra, ITS-VWD, Plisten</cx:pt>
          <cx:pt idx="79">Copra, ITS-VWD, Plisten</cx:pt>
          <cx:pt idx="80">Copra, ITS-VWD, Plisten</cx:pt>
          <cx:pt idx="81">Copra, ITS-VWD, Plisten</cx:pt>
          <cx:pt idx="82">Copra, ITS-VWD, Plisten</cx:pt>
          <cx:pt idx="83">Copra, ITS-VWD, Plisten</cx:pt>
          <cx:pt idx="84">Copra, ITS-VWD, Plisten</cx:pt>
          <cx:pt idx="85">Copra, ITS-VWD, Plisten</cx:pt>
          <cx:pt idx="86">Copra, ITS-VWD, Plisten</cx:pt>
          <cx:pt idx="87">Copra, ITS-VWD, Plisten</cx:pt>
          <cx:pt idx="88">Copra, ITS-VWD, Plisten</cx:pt>
          <cx:pt idx="89">Copra, ITS-VWD, Plisten</cx:pt>
          <cx:pt idx="90">Copra, ITS-VWD, Plisten</cx:pt>
          <cx:pt idx="91">Copra, ITS-VWD, Plisten</cx:pt>
          <cx:pt idx="92">Copra, ITS-VWD, Plisten</cx:pt>
          <cx:pt idx="93">Copra, ITS-VWD, Plisten</cx:pt>
          <cx:pt idx="94">Copra, ITS-VWD, Plisten</cx:pt>
          <cx:pt idx="95">Copra, ITS-VWD, Plisten</cx:pt>
          <cx:pt idx="96">Copra, ITS-VWD, Plisten</cx:pt>
          <cx:pt idx="97">Copra, ITS-VWD, Plisten</cx:pt>
          <cx:pt idx="98">Copra, ITS-VWD, Plisten</cx:pt>
          <cx:pt idx="99">Copra, ITS-VWD, Plisten</cx:pt>
          <cx:pt idx="100">Copra, ITS-VWD, Plisten</cx:pt>
          <cx:pt idx="101">Copra, ITS-VWD, Plisten</cx:pt>
          <cx:pt idx="102">Copra, ITS-VWD, Plisten</cx:pt>
          <cx:pt idx="103">Copra, ITS-VWD, Plisten</cx:pt>
          <cx:pt idx="104">Copra, ITS-VWD, Plisten</cx:pt>
          <cx:pt idx="105">Copra, ITS-VWD, Plisten</cx:pt>
          <cx:pt idx="106">Copra, ITS-VWD, Plisten</cx:pt>
          <cx:pt idx="107">Copra, ITS-VWD, Plisten</cx:pt>
          <cx:pt idx="108">Copra, ITS-VWD, Plisten</cx:pt>
          <cx:pt idx="109">Copra, ITS-VWD, Plisten</cx:pt>
          <cx:pt idx="110">Copra, ITS-VWD, Plisten</cx:pt>
          <cx:pt idx="111">Copra, ITS-VWD, Plisten</cx:pt>
          <cx:pt idx="112">Copra, ITS-VWD, Plisten</cx:pt>
          <cx:pt idx="113">Copra, ITS-VWD, Plisten</cx:pt>
          <cx:pt idx="114">Copra, ITS-VWD, Plisten</cx:pt>
          <cx:pt idx="115">Copra, ITS-VWD, Plisten</cx:pt>
          <cx:pt idx="116">Copra, ITS-VWD, Plisten</cx:pt>
          <cx:pt idx="117">Copra, ITS-VWD, Plisten</cx:pt>
          <cx:pt idx="118">Copra, ITS-VWD, Plisten</cx:pt>
          <cx:pt idx="119">Copra, ITS-VWD, Plisten</cx:pt>
          <cx:pt idx="120">Copra, ITS-VWD, Plisten</cx:pt>
          <cx:pt idx="121">Copra, ITS-VWD, Plisten</cx:pt>
          <cx:pt idx="122">Copra, ITS-VWD, Plisten</cx:pt>
          <cx:pt idx="123">Copra, ITS-VWD, Plisten</cx:pt>
          <cx:pt idx="124">Copra, ITS-VWD, Plisten</cx:pt>
          <cx:pt idx="125">Copra, ITS-VWD, Plisten</cx:pt>
          <cx:pt idx="126">Copra, ITS-VWD, Plisten</cx:pt>
          <cx:pt idx="127">Copra, ITS-VWD, Plisten</cx:pt>
          <cx:pt idx="128">Copra, ITS-VWD, Plisten</cx:pt>
          <cx:pt idx="129">Copra, ITS-VWD, Plisten</cx:pt>
          <cx:pt idx="130">Copra, ITS-VWD, Plisten</cx:pt>
          <cx:pt idx="131">Copra, ITS-VWD, Plisten</cx:pt>
          <cx:pt idx="132">Copra, ITS-VWD, Plisten</cx:pt>
          <cx:pt idx="133">Copra, ITS-VWD, Plisten</cx:pt>
          <cx:pt idx="134">Copra, ITS-VWD, Plisten</cx:pt>
          <cx:pt idx="135">Copra, ITS-VWD, Plisten</cx:pt>
          <cx:pt idx="136">Copra, ITS-VWD, Plisten</cx:pt>
          <cx:pt idx="137">Copra, ITS-VWD, Plisten</cx:pt>
          <cx:pt idx="138">Copra, ITS-VWD, Plisten</cx:pt>
          <cx:pt idx="139">Copra, ITS-VWD, Plisten</cx:pt>
          <cx:pt idx="140">Copra, ITS-VWD, Plisten</cx:pt>
          <cx:pt idx="141">Copra, ITS-VWD, Plisten</cx:pt>
          <cx:pt idx="142">Copra, ITS-VWD, Plisten</cx:pt>
          <cx:pt idx="143">Copra, ITS-VWD, Plisten</cx:pt>
          <cx:pt idx="144">Copra, ITS-VWD, Plisten</cx:pt>
          <cx:pt idx="145">Copra, ITS-VWD, Plisten</cx:pt>
          <cx:pt idx="146">Copra, ITS-VWD, Plisten</cx:pt>
          <cx:pt idx="147">Copra, ITS-VWD, Plisten</cx:pt>
          <cx:pt idx="148">Copra, ITS-VWD, Plisten</cx:pt>
          <cx:pt idx="149">Copra, ITS-VWD, Plisten</cx:pt>
          <cx:pt idx="150">Copra, ITS-VWD, Plisten</cx:pt>
          <cx:pt idx="151">Copra, ITS-VWD, Plisten</cx:pt>
          <cx:pt idx="152">Copra, ITS-VWD, Plisten</cx:pt>
          <cx:pt idx="153">Copra, ITS-VWD, Plisten</cx:pt>
          <cx:pt idx="154">Copra, ITS-VWD, Plisten</cx:pt>
          <cx:pt idx="155">Copra, ITS-VWD, Plisten</cx:pt>
          <cx:pt idx="156">Copra, ITS-VWD, Plisten</cx:pt>
          <cx:pt idx="157">Copra, ITS-VWD, Plisten</cx:pt>
          <cx:pt idx="158">Copra, ITS-VWD, Plisten</cx:pt>
          <cx:pt idx="159">Copra, ITS-VWD, Plisten</cx:pt>
          <cx:pt idx="160">Copra, ITS-VWD, Plisten</cx:pt>
          <cx:pt idx="161">Copra, ITS-VWD, Plisten</cx:pt>
          <cx:pt idx="162">Copra, ITS-VWD, Plisten</cx:pt>
          <cx:pt idx="163">Copra, ITS-VWD, Plisten</cx:pt>
          <cx:pt idx="164">Copra, ITS-VWD, Plisten</cx:pt>
          <cx:pt idx="165">Copra, ITS-VWD, Plisten</cx:pt>
          <cx:pt idx="166">Copra, ITS-VWD, Plisten</cx:pt>
          <cx:pt idx="167">Copra, ITS-VWD, Plisten</cx:pt>
          <cx:pt idx="168">Copra, ITS-VWD, Plisten</cx:pt>
          <cx:pt idx="169">Copra, ITS-VWD, Plisten</cx:pt>
          <cx:pt idx="170">Copra, ITS-VWD, Plisten</cx:pt>
          <cx:pt idx="171">Copra, ITS-VWD, Plisten</cx:pt>
          <cx:pt idx="172">Copra, ITS-VWD, Plisten</cx:pt>
          <cx:pt idx="173">Copra, ITS-VWD, Plisten</cx:pt>
          <cx:pt idx="174">Copra, ITS-VWD, Plisten</cx:pt>
          <cx:pt idx="175">Copra, ITS-VWD, Plisten</cx:pt>
          <cx:pt idx="176">Copra, ITS-VWD, Plisten</cx:pt>
          <cx:pt idx="177">Copra, ITS-VWD, Plisten</cx:pt>
          <cx:pt idx="178">Copra, ITS-VWD, Plisten</cx:pt>
          <cx:pt idx="179">Copra, ITS-VWD, Plisten</cx:pt>
          <cx:pt idx="180">Copra, ITS-VWD, Plisten</cx:pt>
          <cx:pt idx="181">Copra, ITS-VWD, Plisten</cx:pt>
          <cx:pt idx="182">Copra, ITS-VWD, Plisten</cx:pt>
          <cx:pt idx="183">Copra, ITS-VWD, Plisten</cx:pt>
          <cx:pt idx="184">Copra, ITS-VWD, Plisten</cx:pt>
          <cx:pt idx="185">Copra, ITS-VWD, Plisten</cx:pt>
          <cx:pt idx="186">Copra, ITS-VWD, Plisten</cx:pt>
          <cx:pt idx="187">Copra, ITS-VWD, Plisten</cx:pt>
          <cx:pt idx="188">Copra, ITS-VWD, Plisten</cx:pt>
          <cx:pt idx="189">Copra, ITS-VWD, Plisten</cx:pt>
          <cx:pt idx="190">Copra, ITS-VWD, Plisten</cx:pt>
          <cx:pt idx="191">Copra, ITS-VWD, Plisten</cx:pt>
          <cx:pt idx="192">Copra, ITS-VWD, Plisten</cx:pt>
          <cx:pt idx="193">Copra, ITS-VWD, Plisten</cx:pt>
          <cx:pt idx="194">Copra, ITS-VWD, Plisten</cx:pt>
          <cx:pt idx="195">Copra, ITS-VWD, Plisten</cx:pt>
          <cx:pt idx="196">Copra, ITS-VWD, Plisten</cx:pt>
          <cx:pt idx="197">Copra, ITS-VWD, Plisten</cx:pt>
          <cx:pt idx="198">Copra, ITS-VWD, Plisten</cx:pt>
          <cx:pt idx="199">Copra, ITS-VWD, Plisten</cx:pt>
          <cx:pt idx="200">Copra, ITS-VWD, Plisten</cx:pt>
          <cx:pt idx="201">Copra, ITS-VWD, Plisten</cx:pt>
          <cx:pt idx="202">Copra, ITS-VWD, Plisten</cx:pt>
          <cx:pt idx="203">Copra, ITS-VWD, Plisten</cx:pt>
          <cx:pt idx="204">Copra, ITS-VWD, Plisten</cx:pt>
          <cx:pt idx="205">Copra, ITS-VWD, Plisten</cx:pt>
          <cx:pt idx="206">Copra, ITS-VWD, Plisten</cx:pt>
          <cx:pt idx="207">Copra, ITS-VWD, Plisten</cx:pt>
          <cx:pt idx="208">Copra, ITS-VWD, Plisten</cx:pt>
          <cx:pt idx="209">Copra, ITS-VWD, Plisten</cx:pt>
          <cx:pt idx="210">Copra, ITS-VWD, Plisten</cx:pt>
          <cx:pt idx="211">Copra, ITS-VWD, Plisten</cx:pt>
          <cx:pt idx="212">Copra, ITS-VWD, Plisten</cx:pt>
          <cx:pt idx="213">Copra, ITS-VWD, Plisten</cx:pt>
          <cx:pt idx="214">Copra, ITS-VWD, Plisten</cx:pt>
          <cx:pt idx="215">Copra, ITS-VWD, Plisten</cx:pt>
          <cx:pt idx="216">Copra, ITS-VWD, Plisten</cx:pt>
          <cx:pt idx="217">Copra, ITS-VWD, Plisten</cx:pt>
          <cx:pt idx="218">Copra, ITS-VWD, Plisten</cx:pt>
          <cx:pt idx="219">Copra, ITS-VWD, Plisten</cx:pt>
          <cx:pt idx="220">Copra, ITS-VWD, Plisten</cx:pt>
          <cx:pt idx="221">Copra, ITS-VWD, Plisten</cx:pt>
          <cx:pt idx="222">Copra, ITS-VWD, Plisten</cx:pt>
          <cx:pt idx="223">Copra, ITS-VWD, Plisten</cx:pt>
          <cx:pt idx="224">Copra, ITS-VWD, Plisten</cx:pt>
          <cx:pt idx="225">Copra, ITS-VWD, Plisten</cx:pt>
          <cx:pt idx="226">Copra, ITS-VWD, Plisten</cx:pt>
          <cx:pt idx="227">Copra, ITS-VWD, Plisten</cx:pt>
          <cx:pt idx="228">Copra, ITS-VWD, Plisten</cx:pt>
          <cx:pt idx="229">Copra, ITS-VWD, Plisten</cx:pt>
          <cx:pt idx="230">Copra, ITS-VWD, Plisten</cx:pt>
          <cx:pt idx="231">Copra, ITS-VWD, Plisten</cx:pt>
          <cx:pt idx="232">Copra, ITS-VWD, Plisten</cx:pt>
          <cx:pt idx="233">Copra, ITS-VWD, Plisten</cx:pt>
          <cx:pt idx="234">Copra, ITS-VWD, Plisten</cx:pt>
          <cx:pt idx="235">Copra, ITS-VWD, Plisten</cx:pt>
          <cx:pt idx="236">Copra, ITS-VWD, Plisten</cx:pt>
          <cx:pt idx="237">Copra, ITS-VWD, Plisten</cx:pt>
          <cx:pt idx="238">Copra, ITS-VWD, Plisten</cx:pt>
          <cx:pt idx="239">Copra, ITS-VWD, Plisten</cx:pt>
          <cx:pt idx="240">Copra, ITS-VWD, Plisten</cx:pt>
          <cx:pt idx="241">Copra, ITS-VWD, Plisten</cx:pt>
          <cx:pt idx="242">Copra, ITS-VWD, Plisten</cx:pt>
          <cx:pt idx="243">Copra, ITS-VWD, Plisten</cx:pt>
          <cx:pt idx="244">Copra, ITS-VWD, Plisten</cx:pt>
          <cx:pt idx="245">Copra, ITS-VWD, Plisten</cx:pt>
          <cx:pt idx="246">Copra, ITS-VWD, Plisten</cx:pt>
          <cx:pt idx="247">Copra, ITS-VWD, Plisten</cx:pt>
          <cx:pt idx="248">Copra, ITS-VWD, Plisten</cx:pt>
          <cx:pt idx="249">Copra, ITS-VWD, Plisten</cx:pt>
          <cx:pt idx="250">Copra, ITS-VWD, Plisten</cx:pt>
          <cx:pt idx="251">Copra, ITS-VWD, Plisten</cx:pt>
          <cx:pt idx="252">Copra, ITS-VWD, Plisten</cx:pt>
          <cx:pt idx="253">Copra, ITS-VWD, Plisten</cx:pt>
          <cx:pt idx="254">Copra, ITS-VWD, Plisten</cx:pt>
          <cx:pt idx="255">Copra, ITS-VWD, Plisten</cx:pt>
          <cx:pt idx="256">Copra, ITS-VWD, Plisten</cx:pt>
          <cx:pt idx="257">Copra, ITS-VWD, Plisten</cx:pt>
          <cx:pt idx="258">Copra, ITS-VWD, Plisten</cx:pt>
          <cx:pt idx="259">Copra, ITS-VWD, Plisten</cx:pt>
          <cx:pt idx="260">Copra, ITS-VWD, Plisten</cx:pt>
          <cx:pt idx="261">Copra, ITS-VWD, Plisten</cx:pt>
          <cx:pt idx="262">Copra, ITS-VWD, Plisten</cx:pt>
          <cx:pt idx="263">Copra, ITS-VWD, Plisten</cx:pt>
          <cx:pt idx="264">Copra, ITS-VWD, Plisten</cx:pt>
          <cx:pt idx="265">Copra, ITS-VWD, Plisten</cx:pt>
          <cx:pt idx="266">Copra, ITS-VWD, Plisten</cx:pt>
          <cx:pt idx="267">Copra, ITS-VWD, Plisten</cx:pt>
          <cx:pt idx="268">Copra, ITS-VWD, Plisten</cx:pt>
          <cx:pt idx="269">Copra, ITS-VWD, Plisten</cx:pt>
          <cx:pt idx="270">Copra, ITS-VWD, Plisten</cx:pt>
          <cx:pt idx="271">Copra, ITS-VWD, Plisten</cx:pt>
          <cx:pt idx="272">Copra, ITS-VWD, Plisten</cx:pt>
          <cx:pt idx="273">Copra, ITS-VWD, Plisten</cx:pt>
          <cx:pt idx="274">Copra, ITS-VWD, Plisten</cx:pt>
          <cx:pt idx="275">Copra, ITS-VWD, Plisten</cx:pt>
          <cx:pt idx="276">Copra, ITS-VWD, Plisten</cx:pt>
          <cx:pt idx="277">Copra, ITS-VWD, Plisten</cx:pt>
          <cx:pt idx="278">Copra, ITS-VWD, Plisten</cx:pt>
          <cx:pt idx="279">Copra, ITS-VWD, Plisten</cx:pt>
          <cx:pt idx="280">Copra, ITS-VWD, Plisten</cx:pt>
          <cx:pt idx="281">Copra, ITS-VWD, Plisten</cx:pt>
          <cx:pt idx="282">Copra, ITS-VWD, Plisten</cx:pt>
          <cx:pt idx="283">Copra, ITS-VWD, Plisten</cx:pt>
          <cx:pt idx="284">Copra, ITS-VWD, Plisten</cx:pt>
          <cx:pt idx="285">Copra, ITS-VWD, Plisten</cx:pt>
          <cx:pt idx="286">Copra, ITS-VWD, Plisten</cx:pt>
          <cx:pt idx="287">Copra, ITS-VWD, Plisten</cx:pt>
          <cx:pt idx="288">Copra, ITS-VWD, Plisten</cx:pt>
          <cx:pt idx="289">Copra, ITS-VWD, Plisten</cx:pt>
          <cx:pt idx="290">Copra, ITS-VWD, Plisten</cx:pt>
          <cx:pt idx="291">Copra, ITS-VWD, Plisten</cx:pt>
          <cx:pt idx="292">Copra, ITS-VWD, Plisten</cx:pt>
          <cx:pt idx="293">Copra, ITS-VWD, Plisten</cx:pt>
          <cx:pt idx="294">Copra, ITS-VWD, Plisten</cx:pt>
          <cx:pt idx="295">Copra, ITS-VWD, Plisten</cx:pt>
          <cx:pt idx="296">Copra, ITS-VWD, Plisten</cx:pt>
          <cx:pt idx="297">Copra, ITS-VWD, Plisten</cx:pt>
          <cx:pt idx="298">Copra, ITS-VWD, Plisten</cx:pt>
          <cx:pt idx="299">Copra, ITS-VWD, Plisten</cx:pt>
          <cx:pt idx="300">Copra, ITS-VWD, Plisten</cx:pt>
          <cx:pt idx="301">Copra, ITS-VWD, Plisten</cx:pt>
          <cx:pt idx="302">Copra, ITS-VWD, Plisten</cx:pt>
          <cx:pt idx="303">Copra, ITS-VWD, Plisten</cx:pt>
          <cx:pt idx="304">Copra, ITS-VWD, Plisten</cx:pt>
          <cx:pt idx="305">Copra, ITS-VWD, Plisten</cx:pt>
          <cx:pt idx="306">Copra, ITS-VWD, Plisten</cx:pt>
          <cx:pt idx="307">Copra, ITS-VWD, Plisten</cx:pt>
          <cx:pt idx="308">Copra, ITS-VWD, Plisten</cx:pt>
          <cx:pt idx="309">Copra, ITS-VWD, Plisten</cx:pt>
          <cx:pt idx="310">Copra, ITS-VWD, Plisten</cx:pt>
          <cx:pt idx="311">Copra, ITS-VWD, Plisten</cx:pt>
          <cx:pt idx="312">Copra, ITS-VWD, Plisten</cx:pt>
          <cx:pt idx="313">Copra, ITS-VWD, Plisten</cx:pt>
          <cx:pt idx="314">Copra, ITS-VWD, Plisten</cx:pt>
          <cx:pt idx="315">Copra, ITS-VWD, Plisten</cx:pt>
          <cx:pt idx="316">Copra, ITS-VWD, Plisten</cx:pt>
          <cx:pt idx="317">Copra, ITS-VWD, Plisten</cx:pt>
          <cx:pt idx="318">Copra, ITS-VWD, Plisten</cx:pt>
          <cx:pt idx="319">Copra, ITS-VWD, Plisten</cx:pt>
          <cx:pt idx="320">Copra, ITS-VWD, Plisten</cx:pt>
          <cx:pt idx="321">Copra, ITS-VWD, Plisten</cx:pt>
          <cx:pt idx="322">Copra, ITS-VWD, Plisten</cx:pt>
          <cx:pt idx="323">Copra, ITS-VWD, Plisten</cx:pt>
          <cx:pt idx="324">Copra, ITS-VWD, Plisten</cx:pt>
          <cx:pt idx="325">Copra, ITS-VWD, Plisten</cx:pt>
          <cx:pt idx="326">Copra, ITS-VWD, Plisten</cx:pt>
          <cx:pt idx="327">Copra, ITS-VWD, Plisten</cx:pt>
          <cx:pt idx="328">Copra, ITS-VWD, Plisten</cx:pt>
          <cx:pt idx="329">Copra, ITS-VWD, Plisten</cx:pt>
          <cx:pt idx="330">Copra, ITS-VWD, Plisten</cx:pt>
          <cx:pt idx="331">Copra, ITS-VWD, Plisten</cx:pt>
          <cx:pt idx="332">Copra, ITS-VWD, Plisten</cx:pt>
          <cx:pt idx="333">Copra, ITS-VWD, Plisten</cx:pt>
          <cx:pt idx="334">Copra, ITS-VWD, Plisten</cx:pt>
          <cx:pt idx="335">Copra, ITS-VWD, Plisten</cx:pt>
          <cx:pt idx="336">Copra, ITS-VWD, Plisten</cx:pt>
          <cx:pt idx="337">Copra, ITS-VWD, Plisten</cx:pt>
          <cx:pt idx="338">Copra, ITS-VWD, Plisten</cx:pt>
          <cx:pt idx="339">Copra, ITS-VWD, Plisten</cx:pt>
          <cx:pt idx="340">Copra, ITS-VWD, Plisten</cx:pt>
          <cx:pt idx="341">Copra, ITS-VWD, Plisten</cx:pt>
          <cx:pt idx="342">Copra, ITS-VWD, Plisten</cx:pt>
          <cx:pt idx="343">Copra, ITS-VWD, Plisten</cx:pt>
          <cx:pt idx="344">Copra, ITS-VWD, Plisten</cx:pt>
          <cx:pt idx="345">Copra, ITS-VWD, Plisten</cx:pt>
          <cx:pt idx="346">Copra, ITS-VWD, Plisten</cx:pt>
          <cx:pt idx="347">Copra, ITS-VWD, Plisten</cx:pt>
          <cx:pt idx="348">Copra, ITS-VWD, Plisten</cx:pt>
          <cx:pt idx="349">Copra, ITS-VWD, Plisten</cx:pt>
          <cx:pt idx="350">Copra, ITS-VWD, Plisten</cx:pt>
          <cx:pt idx="351">Copra, ITS-VWD, Plisten</cx:pt>
          <cx:pt idx="352">Copra, ITS-VWD, Plisten</cx:pt>
          <cx:pt idx="353">Copra, ITS-VWD, Plisten</cx:pt>
          <cx:pt idx="354">Copra, ITS-VWD, Plisten</cx:pt>
          <cx:pt idx="355">Copra, ITS-VWD, Plisten</cx:pt>
          <cx:pt idx="356">Copra, ITS-VWD, Plisten</cx:pt>
          <cx:pt idx="357">Copra, ITS-VWD, Plisten</cx:pt>
          <cx:pt idx="358">Copra, ITS-VWD, Plisten</cx:pt>
          <cx:pt idx="359">Copra, ITS-VWD, Plisten</cx:pt>
          <cx:pt idx="360">Copra, ITS-VWD, Plisten</cx:pt>
          <cx:pt idx="361">Copra, ITS-VWD, Plisten</cx:pt>
          <cx:pt idx="362">Copra, ITS-VWD, Plisten</cx:pt>
          <cx:pt idx="363">Copra, ITS-VWD, Plisten</cx:pt>
          <cx:pt idx="364">Copra, ITS-VWD, Plisten</cx:pt>
          <cx:pt idx="365">Copra, ITS-VWD, Plisten</cx:pt>
          <cx:pt idx="366">Copra, ITS-VWD, Plisten</cx:pt>
          <cx:pt idx="367">Copra, ITS-VWD, Plisten</cx:pt>
          <cx:pt idx="368">Copra, ITS-VWD, Plisten</cx:pt>
          <cx:pt idx="369">Copra, ITS-VWD, Plisten</cx:pt>
          <cx:pt idx="370">Copra, ITS-VWD, Plisten</cx:pt>
          <cx:pt idx="371">Copra, ITS-VWD, Plisten</cx:pt>
          <cx:pt idx="372">Copra, ITS-VWD, Plisten</cx:pt>
          <cx:pt idx="373">Copra, ITS-VWD, Plisten</cx:pt>
          <cx:pt idx="374">Copra, ITS-VWD, Plisten</cx:pt>
          <cx:pt idx="375">Copra, ITS-VWD, Plisten</cx:pt>
          <cx:pt idx="376">Copra, ITS-VWD, Plisten</cx:pt>
          <cx:pt idx="377">Copra, ITS-VWD, Plisten</cx:pt>
          <cx:pt idx="378">Copra, ITS-VWD, Plisten</cx:pt>
          <cx:pt idx="379">Copra, ITS-VWD, Plisten</cx:pt>
          <cx:pt idx="380">Copra, ITS-VWD, Plisten</cx:pt>
          <cx:pt idx="381">Copra, ITS-VWD, Plisten</cx:pt>
          <cx:pt idx="382">Copra, ITS-VWD, Plisten</cx:pt>
          <cx:pt idx="383">Copra, ITS-VWD, Plisten</cx:pt>
          <cx:pt idx="384">Copra, ITS-VWD, Plisten</cx:pt>
          <cx:pt idx="385">Copra, ITS-VWD, Plisten</cx:pt>
          <cx:pt idx="386">Copra, ITS-VWD, Plisten</cx:pt>
          <cx:pt idx="387">Copra, ITS-VWD, Plisten</cx:pt>
          <cx:pt idx="388">Copra, ITS-VWD, Plisten</cx:pt>
          <cx:pt idx="389">Copra, ITS-VWD, Plisten</cx:pt>
          <cx:pt idx="390">Copra, ITS-VWD, Plisten</cx:pt>
          <cx:pt idx="391">Copra, ITS-VWD, Plisten</cx:pt>
          <cx:pt idx="392">Copra, ITS-VWD, Plisten</cx:pt>
          <cx:pt idx="393">Copra, ITS-VWD, Plisten</cx:pt>
          <cx:pt idx="394">Copra, ITS-VWD, Plisten</cx:pt>
          <cx:pt idx="395">Copra, ITS-VWD, Plisten</cx:pt>
          <cx:pt idx="396">Copra, ITS-VWD, Plisten</cx:pt>
          <cx:pt idx="397">Copra, ITS-VWD, Plisten</cx:pt>
          <cx:pt idx="398">Copra, ITS-VWD, Plisten</cx:pt>
          <cx:pt idx="399">Copra, ITS-VWD, Plisten</cx:pt>
          <cx:pt idx="400">Copra, ITS-VWD, Plisten</cx:pt>
          <cx:pt idx="401">Copra, ITS-VWD, Plisten</cx:pt>
          <cx:pt idx="402">Copra, ITS-VWD, Plisten</cx:pt>
          <cx:pt idx="403">Copra, ITS-VWD, Plisten</cx:pt>
          <cx:pt idx="404">Copra, ITS-VWD, Plisten</cx:pt>
          <cx:pt idx="405">Copra, ITS-VWD, Plisten</cx:pt>
          <cx:pt idx="406">Copra, ITS-VWD, Plisten</cx:pt>
          <cx:pt idx="407">Copra, ITS-VWD, Plisten</cx:pt>
          <cx:pt idx="408">Copra, ITS-VWD, Plisten</cx:pt>
          <cx:pt idx="409">Copra, ITS-VWD, Plisten</cx:pt>
          <cx:pt idx="410">Copra, ITS-VWD, Plisten</cx:pt>
          <cx:pt idx="411">Copra, ITS-VWD, Plisten</cx:pt>
          <cx:pt idx="412">Copra, ITS-VWD, Plisten</cx:pt>
          <cx:pt idx="413">Copra, ITS-VWD, Plisten</cx:pt>
          <cx:pt idx="414">Copra, ITS-VWD, Plisten</cx:pt>
          <cx:pt idx="415">Copra, ITS-VWD, Plisten</cx:pt>
          <cx:pt idx="416">Copra, ITS-VWD, Plisten</cx:pt>
          <cx:pt idx="417">Copra, ITS-VWD, Plisten</cx:pt>
          <cx:pt idx="418">Copra, ITS-VWD, Plisten</cx:pt>
          <cx:pt idx="419">Copra, ITS-VWD, Plisten</cx:pt>
          <cx:pt idx="420">Copra, ITS-VWD, Plisten</cx:pt>
          <cx:pt idx="421">Copra, ITS-VWD, Plisten</cx:pt>
          <cx:pt idx="422">Copra, ITS-VWD, Plisten</cx:pt>
          <cx:pt idx="423">Copra, ITS-VWD, Plisten</cx:pt>
          <cx:pt idx="424">Copra, ITS-VWD, Plisten</cx:pt>
          <cx:pt idx="425">Copra, ITS-VWD, Plisten</cx:pt>
          <cx:pt idx="426">Copra, ITS-VWD, Plisten</cx:pt>
          <cx:pt idx="427">Copra, ITS-VWD, Plisten</cx:pt>
          <cx:pt idx="428">Copra, ITS-VWD, Plisten</cx:pt>
          <cx:pt idx="429">Copra, ITS-VWD, Plisten</cx:pt>
          <cx:pt idx="430">Copra, ITS-VWD, Plisten</cx:pt>
          <cx:pt idx="431">Copra, ITS-VWD, Plisten</cx:pt>
          <cx:pt idx="432">Copra, ITS-VWD, Plisten</cx:pt>
          <cx:pt idx="433">Copra, ITS-VWD, Plisten</cx:pt>
          <cx:pt idx="434">Copra, ITS-VWD, Plisten</cx:pt>
          <cx:pt idx="435">Copra, ITS-VWD, Plisten</cx:pt>
          <cx:pt idx="436">Copra, ITS-VWD, Plisten</cx:pt>
          <cx:pt idx="437">Copra, ITS-VWD, Plisten</cx:pt>
          <cx:pt idx="438">Copra, ITS-VWD, Plisten</cx:pt>
          <cx:pt idx="439">Copra, ITS-VWD, Plisten</cx:pt>
          <cx:pt idx="440">Copra, ITS-VWD, Plisten</cx:pt>
          <cx:pt idx="441">Copra, ITS-VWD, Plisten</cx:pt>
          <cx:pt idx="442">Copra, ITS-VWD, Plisten</cx:pt>
          <cx:pt idx="443">Copra, ITS-VWD, Plisten</cx:pt>
          <cx:pt idx="444">Copra, ITS-VWD, Plisten</cx:pt>
          <cx:pt idx="445">Copra, ITS-VWD, Plisten</cx:pt>
          <cx:pt idx="446">Copra, ITS-VWD, Plisten</cx:pt>
          <cx:pt idx="447">Copra, ITS-VWD, Plisten</cx:pt>
          <cx:pt idx="448">Copra, ITS-VWD, Plisten</cx:pt>
          <cx:pt idx="449">Copra, ITS-VWD, Plisten</cx:pt>
          <cx:pt idx="450">Copra, ITS-VWD, Plisten</cx:pt>
          <cx:pt idx="451">Copra, ITS-VWD, Plisten</cx:pt>
          <cx:pt idx="452">Copra, ITS-VWD, Plisten</cx:pt>
          <cx:pt idx="453">Copra, ITS-VWD, Plisten</cx:pt>
          <cx:pt idx="454">Copra, ITS-VWD, Plisten</cx:pt>
          <cx:pt idx="455">Copra, ITS-VWD, Plisten</cx:pt>
          <cx:pt idx="456">Copra, ITS-VWD, Plisten</cx:pt>
          <cx:pt idx="457">Copra, ITS-VWD, Plisten</cx:pt>
          <cx:pt idx="458">Copra, ITS-VWD, Plisten</cx:pt>
          <cx:pt idx="459">Copra, ITS-VWD, Plisten</cx:pt>
          <cx:pt idx="460">Copra, ITS-VWD, Plisten</cx:pt>
          <cx:pt idx="461">Copra, ITS-VWD, Plisten</cx:pt>
          <cx:pt idx="462">Copra, ITS-VWD, Plisten</cx:pt>
          <cx:pt idx="463">Copra, ITS-VWD, Plisten</cx:pt>
          <cx:pt idx="464">Copra, ITS-VWD, Plisten</cx:pt>
          <cx:pt idx="465">Copra, ITS-VWD, Plisten</cx:pt>
          <cx:pt idx="466">Copra, ITS-VWD, Plisten</cx:pt>
          <cx:pt idx="467">Copra, ITS-VWD, Plisten</cx:pt>
          <cx:pt idx="468">Copra, ITS-VWD, Plisten</cx:pt>
          <cx:pt idx="469">Copra, ITS-VWD, Plisten</cx:pt>
          <cx:pt idx="470">Copra, ITS-VWD, Plisten</cx:pt>
          <cx:pt idx="471">Copra, ITS-VWD, Plisten</cx:pt>
          <cx:pt idx="472">Copra, ITS-VWD, Plisten</cx:pt>
          <cx:pt idx="473">Copra, ITS-VWD, Plisten</cx:pt>
          <cx:pt idx="474">Copra, ITS-VWD, Plisten</cx:pt>
          <cx:pt idx="475">Copra, ITS-VWD, Plisten</cx:pt>
          <cx:pt idx="476">Copra, ITS-VWD, Plisten</cx:pt>
          <cx:pt idx="477">Copra, ITS-VWD, Plisten</cx:pt>
          <cx:pt idx="478">Copra, ITS-VWD, Plisten</cx:pt>
          <cx:pt idx="479">Copra, ITS-VWD, Plisten</cx:pt>
          <cx:pt idx="480">Copra, ITS-VWD, Plisten</cx:pt>
          <cx:pt idx="481">Copra, ITS-VWD, Plisten</cx:pt>
          <cx:pt idx="482">Copra, ITS-VWD, Plisten</cx:pt>
          <cx:pt idx="483">Copra, ITS-VWD, Plisten</cx:pt>
          <cx:pt idx="484">Copra, ITS-VWD, Plisten</cx:pt>
          <cx:pt idx="485">Copra, ITS-VWD, Plisten</cx:pt>
          <cx:pt idx="486">Copra, ITS-VWD, Plisten</cx:pt>
          <cx:pt idx="487">Copra, ITS-VWD, Plisten</cx:pt>
          <cx:pt idx="488">Copra, ITS-VWD, Plisten</cx:pt>
          <cx:pt idx="489">Copra, ITS-VWD, Plisten</cx:pt>
          <cx:pt idx="490">Copra, ITS-VWD, Plisten</cx:pt>
          <cx:pt idx="491">Copra, ITS-VWD, Plisten</cx:pt>
          <cx:pt idx="492">Copra, ITS-VWD, Plisten</cx:pt>
          <cx:pt idx="493">Copra, ITS-VWD, Plisten</cx:pt>
          <cx:pt idx="494">Copra, ITS-VWD, Plisten</cx:pt>
          <cx:pt idx="495">Copra, ITS-VWD, Plisten</cx:pt>
          <cx:pt idx="496">Copra, ITS-VWD, Plisten</cx:pt>
          <cx:pt idx="497">Copra, ITS-VWD, Plisten</cx:pt>
          <cx:pt idx="498">Copra, ITS-VWD, Plisten</cx:pt>
          <cx:pt idx="499">Copra, ITS-VWD, Plisten</cx:pt>
          <cx:pt idx="500">Copra, ITS-VWD, Plisten</cx:pt>
          <cx:pt idx="501">Copra, ITS-VWD, Plisten</cx:pt>
          <cx:pt idx="502">Copra, ITS-VWD, Plisten</cx:pt>
          <cx:pt idx="503">Copra, ITS-VWD, Plisten</cx:pt>
          <cx:pt idx="504">Copra, ITS-VWD, Plisten</cx:pt>
          <cx:pt idx="505">Copra, ITS-VWD, Plisten</cx:pt>
          <cx:pt idx="506">Copra, ITS-VWD, Plisten</cx:pt>
          <cx:pt idx="507">Copra, ITS-VWD, Plisten</cx:pt>
          <cx:pt idx="508">Copra, ITS-VWD, Plisten</cx:pt>
          <cx:pt idx="509">Copra, ITS-VWD, Plisten</cx:pt>
          <cx:pt idx="510">Copra, ITS-VWD, Plisten</cx:pt>
          <cx:pt idx="511">Copra, ITS-VWD, Plisten</cx:pt>
          <cx:pt idx="512">Copra, ITS-VWD, Plisten</cx:pt>
          <cx:pt idx="513">Copra, ITS-VWD, Plisten</cx:pt>
          <cx:pt idx="514">Copra, ITS-VWD, Plisten</cx:pt>
          <cx:pt idx="515">Copra, ITS-VWD, Plisten</cx:pt>
          <cx:pt idx="516">Copra, ITS-VWD, Plisten</cx:pt>
          <cx:pt idx="517">Copra, ITS-VWD, Plisten</cx:pt>
          <cx:pt idx="518">Copra, ITS-VWD, Plisten</cx:pt>
          <cx:pt idx="519">Copra, ITS-VWD, Plisten</cx:pt>
          <cx:pt idx="520">Copra, ITS-VWD, Plisten</cx:pt>
          <cx:pt idx="521">Copra, ITS-VWD, Plisten</cx:pt>
          <cx:pt idx="522">Copra, ITS-VWD, Plisten</cx:pt>
          <cx:pt idx="523">Copra, ITS-VWD, Plisten</cx:pt>
          <cx:pt idx="524">Copra, ITS-VWD, Plisten</cx:pt>
          <cx:pt idx="525">Copra, ITS-VWD, Plisten</cx:pt>
          <cx:pt idx="526">Copra, ITS-VWD, Plisten</cx:pt>
          <cx:pt idx="527">Copra, ITS-VWD, Plisten</cx:pt>
          <cx:pt idx="528">Copra, ITS-VWD, Plisten</cx:pt>
          <cx:pt idx="529">Copra, ITS-VWD, Plisten</cx:pt>
          <cx:pt idx="530">Copra, ITS-VWD, Plisten</cx:pt>
          <cx:pt idx="531">Copra, ITS-VWD, Plisten</cx:pt>
          <cx:pt idx="532">Copra, ITS-VWD, Plisten</cx:pt>
          <cx:pt idx="533">Copra, ITS-VWD, Plisten</cx:pt>
          <cx:pt idx="534">Copra, ITS-VWD, Plisten</cx:pt>
          <cx:pt idx="535">Copra, ITS-VWD, Plisten</cx:pt>
          <cx:pt idx="536">Copra, ITS-VWD, Plisten</cx:pt>
          <cx:pt idx="537">Copra, ITS-VWD, Plisten</cx:pt>
          <cx:pt idx="538">Copra, ITS-VWD, Plisten</cx:pt>
          <cx:pt idx="539">Copra, ITS-VWD, Plisten</cx:pt>
          <cx:pt idx="540">Copra, ITS-VWD, Plisten</cx:pt>
          <cx:pt idx="541">Copra, ITS-VWD, Plisten</cx:pt>
          <cx:pt idx="542">Copra, ITS-VWD, Plisten</cx:pt>
          <cx:pt idx="543">Copra, ITS-VWD, Plisten</cx:pt>
          <cx:pt idx="544">Copra, ITS-VWD, Plisten</cx:pt>
          <cx:pt idx="545">Copra, ITS-VWD, Plisten</cx:pt>
          <cx:pt idx="546">Copra, ITS-VWD, Plisten</cx:pt>
          <cx:pt idx="547">Copra, ITS-VWD, Plisten</cx:pt>
          <cx:pt idx="548">Copra, ITS-VWD, Plisten</cx:pt>
          <cx:pt idx="549">Copra, ITS-VWD, Plisten</cx:pt>
          <cx:pt idx="550">Copra, ITS-VWD, Plisten</cx:pt>
          <cx:pt idx="551">Copra, ITS-VWD, Plisten</cx:pt>
          <cx:pt idx="552">Copra, ITS-VWD, Plisten</cx:pt>
          <cx:pt idx="553">Copra, ITS-VWD, Plisten</cx:pt>
          <cx:pt idx="554">Copra, ITS-VWD, Plisten</cx:pt>
          <cx:pt idx="555">Copra, ITS-VWD, Plisten</cx:pt>
          <cx:pt idx="556">Copra, ITS-VWD, Plisten</cx:pt>
          <cx:pt idx="557">Copra, ITS-VWD, Plisten</cx:pt>
          <cx:pt idx="558">Copra, ITS-VWD, Plisten</cx:pt>
          <cx:pt idx="559">Copra, ITS-VWD, Plisten</cx:pt>
          <cx:pt idx="560">Copra, ITS-VWD, Plisten</cx:pt>
          <cx:pt idx="561">Copra, ITS-VWD, Plisten</cx:pt>
          <cx:pt idx="562">Copra, ITS-VWD, Plisten</cx:pt>
          <cx:pt idx="563">Copra, ITS-VWD, Plisten</cx:pt>
          <cx:pt idx="564">Copra, ITS-VWD, Plisten</cx:pt>
          <cx:pt idx="565">Copra, ITS-VWD, Plisten</cx:pt>
          <cx:pt idx="566">Copra, ITS-VWD, Plisten</cx:pt>
          <cx:pt idx="567">Copra, ITS-VWD, Plisten</cx:pt>
          <cx:pt idx="568">Copra, ITS-VWD, Plisten</cx:pt>
          <cx:pt idx="569">Copra, ITS-VWD, Plisten</cx:pt>
          <cx:pt idx="570">Copra, ITS-VWD, Plisten</cx:pt>
          <cx:pt idx="571">Copra, ITS-VWD, Plisten</cx:pt>
          <cx:pt idx="572">Copra, ITS-VWD, Plisten</cx:pt>
          <cx:pt idx="573">Copra, ITS-VWD, Plisten</cx:pt>
          <cx:pt idx="574">Copra, ITS-VWD, Plisten</cx:pt>
          <cx:pt idx="575">Copra, ITS-VWD, Plisten</cx:pt>
          <cx:pt idx="576">Copra, ITS-VWD, Plisten</cx:pt>
          <cx:pt idx="577">Copra, ITS-VWD, Plisten</cx:pt>
          <cx:pt idx="578">Copra, ITS-VWD, Plisten</cx:pt>
          <cx:pt idx="579">Copra, ITS-VWD, Plisten</cx:pt>
          <cx:pt idx="580">Copra, ITS-VWD, Plisten</cx:pt>
          <cx:pt idx="581">Copra, ITS-VWD, Plisten</cx:pt>
          <cx:pt idx="582">Copra, ITS-VWD, Plisten</cx:pt>
          <cx:pt idx="583">Copra, ITS-VWD, Plisten</cx:pt>
          <cx:pt idx="584">Copra, ITS-VWD, Plisten</cx:pt>
          <cx:pt idx="585">Copra, ITS-VWD, Plisten</cx:pt>
          <cx:pt idx="586">Copra, ITS-VWD, Plisten</cx:pt>
          <cx:pt idx="587">Copra, ITS-VWD, Plisten</cx:pt>
          <cx:pt idx="588">Copra, ITS-VWD, Plisten</cx:pt>
          <cx:pt idx="589">Copra, ITS-VWD, Plisten</cx:pt>
          <cx:pt idx="590">Copra, ITS-VWD, Plisten</cx:pt>
          <cx:pt idx="591">Copra, ITS-VWD, Plisten</cx:pt>
          <cx:pt idx="592">Copra, ITS-VWD, Plisten</cx:pt>
          <cx:pt idx="593">Copra, ITS-VWD, Plisten</cx:pt>
          <cx:pt idx="594">Copra, ITS-VWD, Plisten</cx:pt>
          <cx:pt idx="595">Copra, ITS-VWD, Plisten</cx:pt>
          <cx:pt idx="596">Copra, ITS-VWD, Plisten</cx:pt>
          <cx:pt idx="597">Copra, ITS-VWD, Plisten</cx:pt>
          <cx:pt idx="598">Copra, ITS-VWD, Plisten</cx:pt>
          <cx:pt idx="599">Copra, ITS-VWD, Plisten</cx:pt>
          <cx:pt idx="600">Copra, ITS-VWD, Plisten</cx:pt>
          <cx:pt idx="601">Copra, ITS-VWD, Plisten</cx:pt>
          <cx:pt idx="602">Copra, ITS-VWD, Plisten</cx:pt>
          <cx:pt idx="603">Copra, ITS-VWD, Plisten</cx:pt>
          <cx:pt idx="604">Copra, ITS-VWD, Plisten</cx:pt>
          <cx:pt idx="605">Copra, ITS-VWD, Plisten</cx:pt>
          <cx:pt idx="606">Copra, ITS-VWD, Plisten</cx:pt>
          <cx:pt idx="607">Copra, ITS-VWD, Plisten</cx:pt>
          <cx:pt idx="608">Copra, ITS-VWD, Plisten</cx:pt>
          <cx:pt idx="609">Copra, ITS-VWD, Plisten</cx:pt>
          <cx:pt idx="610">Copra, ITS-VWD, Plisten</cx:pt>
          <cx:pt idx="611">Copra, ITS-VWD, Plisten</cx:pt>
          <cx:pt idx="612">Copra, ITS-VWD, Plisten</cx:pt>
          <cx:pt idx="613">Copra, ITS-VWD, Plisten</cx:pt>
          <cx:pt idx="614">Copra, ITS-VWD, Plisten</cx:pt>
          <cx:pt idx="615">Copra, ITS-VWD, Plisten</cx:pt>
          <cx:pt idx="616">Copra, ITS-VWD, Plisten</cx:pt>
          <cx:pt idx="617">Copra, ITS-VWD, Plisten</cx:pt>
          <cx:pt idx="618">Copra, ITS-VWD, Plisten</cx:pt>
          <cx:pt idx="619">Copra, ITS-VWD, Plisten</cx:pt>
          <cx:pt idx="620">Copra, ITS-VWD, Plisten</cx:pt>
          <cx:pt idx="621">Copra, ITS-VWD, Plisten</cx:pt>
          <cx:pt idx="622">Copra, ITS-VWD, Plisten</cx:pt>
          <cx:pt idx="623">Copra, ITS-VWD, Plisten</cx:pt>
          <cx:pt idx="624">Copra, ITS-VWD, Plisten</cx:pt>
          <cx:pt idx="625">Copra, ITS-VWD, Plisten</cx:pt>
          <cx:pt idx="626">Copra, ITS-VWD, Plisten</cx:pt>
          <cx:pt idx="627">Copra, ITS-VWD, Plisten</cx:pt>
          <cx:pt idx="628">Copra, ITS-VWD, Plisten</cx:pt>
          <cx:pt idx="629">Copra, ITS-VWD, Plisten</cx:pt>
          <cx:pt idx="630">Copra, ITS-VWD, Plisten</cx:pt>
          <cx:pt idx="631">Copra, ITS-VWD, Plisten</cx:pt>
          <cx:pt idx="632">Copra, ITS-VWD, Plisten</cx:pt>
          <cx:pt idx="633">Copra, ITS-VWD, Plisten</cx:pt>
          <cx:pt idx="634">Copra, ITS-VWD, Plisten</cx:pt>
          <cx:pt idx="635">Copra, ITS-VWD, Plisten</cx:pt>
          <cx:pt idx="636">Copra, ITS-VWD, Plisten</cx:pt>
          <cx:pt idx="637">Copra, ITS-VWD, Plisten</cx:pt>
          <cx:pt idx="638">Copra, ITS-VWD, Plisten</cx:pt>
          <cx:pt idx="639">Copra, ITS-VWD, Plisten</cx:pt>
          <cx:pt idx="640">Copra, ITS-VWD, Plisten</cx:pt>
          <cx:pt idx="641">Copra, ITS-VWD, Plisten</cx:pt>
          <cx:pt idx="642">Copra, ITS-VWD, Plisten</cx:pt>
          <cx:pt idx="643">Copra, ITS-VWD, Plisten</cx:pt>
          <cx:pt idx="644">Copra, ITS-VWD, Plisten</cx:pt>
          <cx:pt idx="645">Copra, ITS-VWD, Plisten</cx:pt>
          <cx:pt idx="646">Copra, ITS-VWD, Plisten</cx:pt>
          <cx:pt idx="647">Copra, ITS-VWD, Plisten</cx:pt>
          <cx:pt idx="648">Copra, ITS-VWD, Plisten</cx:pt>
          <cx:pt idx="649">Copra, ITS-VWD, Plisten</cx:pt>
          <cx:pt idx="650">Copra, ITS-VWD, Plisten</cx:pt>
          <cx:pt idx="651">Copra, ITS-VWD, Plisten</cx:pt>
          <cx:pt idx="652">Copra, ITS-VWD, Plisten</cx:pt>
          <cx:pt idx="653">Copra, ITS-VWD, Plisten</cx:pt>
          <cx:pt idx="654">Copra, ITS-VWD, Plisten</cx:pt>
          <cx:pt idx="655">Copra, ITS-VWD, Plisten</cx:pt>
          <cx:pt idx="656">Copra, ITS-VWD, Plisten</cx:pt>
          <cx:pt idx="657">Copra, ITS-VWD, Plisten</cx:pt>
          <cx:pt idx="658">Copra, ITS-VWD, Plisten</cx:pt>
          <cx:pt idx="659">Copra, ITS-VWD, Plisten</cx:pt>
          <cx:pt idx="660">Copra, ITS-VWD, Plisten</cx:pt>
          <cx:pt idx="661">Copra, ITS-VWD, Plisten</cx:pt>
          <cx:pt idx="662">Copra, ITS-VWD, Plisten</cx:pt>
          <cx:pt idx="663">Copra, ITS-VWD, Plisten</cx:pt>
          <cx:pt idx="664">Copra, ITS-VWD, Plisten</cx:pt>
          <cx:pt idx="665">Copra, ITS-VWD, Plisten</cx:pt>
          <cx:pt idx="666">Copra, ITS-VWD, Plisten</cx:pt>
          <cx:pt idx="667">Copra, ITS-VWD, Plisten</cx:pt>
          <cx:pt idx="668">Copra, ITS-VWD, Plisten</cx:pt>
          <cx:pt idx="669">Copra, ITS-VWD, Plisten</cx:pt>
          <cx:pt idx="670">Copra, ITS-VWD, Plisten</cx:pt>
          <cx:pt idx="671">Copra, ITS-VWD, Plisten</cx:pt>
          <cx:pt idx="672">Copra, ITS-VWD, Plisten</cx:pt>
          <cx:pt idx="673">Copra, ITS-VWD, Plisten</cx:pt>
          <cx:pt idx="674">Copra, ITS-VWD, Plisten</cx:pt>
          <cx:pt idx="675">Copra, ITS-VWD, Plisten</cx:pt>
          <cx:pt idx="676">Copra, ITS-VWD, Plisten</cx:pt>
          <cx:pt idx="677">Copra, ITS-VWD, Plisten</cx:pt>
          <cx:pt idx="678">Copra, ITS-VWD, Plisten</cx:pt>
          <cx:pt idx="679">Copra, ITS-VWD, Plisten</cx:pt>
          <cx:pt idx="680">Copra, ITS-VWD, Plisten</cx:pt>
          <cx:pt idx="681">Copra, ITS-VWD, Plisten</cx:pt>
          <cx:pt idx="682">Copra, ITS-VWD, Plisten</cx:pt>
          <cx:pt idx="683">Copra, ITS-VWD, Plisten</cx:pt>
          <cx:pt idx="684">Copra, ITS-VWD, Plisten</cx:pt>
          <cx:pt idx="685">Copra, ITS-VWD, Plisten</cx:pt>
          <cx:pt idx="686">Copra, ITS-VWD, Plisten</cx:pt>
          <cx:pt idx="687">Copra, ITS-VWD, Plisten</cx:pt>
          <cx:pt idx="688">Copra, ITS-VWD, Plisten</cx:pt>
          <cx:pt idx="689">Copra, ITS-VWD, Plisten</cx:pt>
          <cx:pt idx="690">Copra, ITS-VWD, Plisten</cx:pt>
          <cx:pt idx="691">Copra, ITS-VWD, Plisten</cx:pt>
          <cx:pt idx="692">Copra, ITS-VWD, Plisten</cx:pt>
          <cx:pt idx="693">Copra, ITS-VWD, Plisten</cx:pt>
          <cx:pt idx="694">Copra, ITS-VWD, Plisten</cx:pt>
          <cx:pt idx="695">Copra, ITS-VWD, Plisten</cx:pt>
          <cx:pt idx="696">Copra, ITS-VWD, Plisten</cx:pt>
          <cx:pt idx="697">Copra, ITS-VWD, Plisten</cx:pt>
          <cx:pt idx="698">Copra, ITS-VWD, Plisten</cx:pt>
          <cx:pt idx="699">Copra, ITS-VWD, Plisten</cx:pt>
          <cx:pt idx="700">Copra, ITS-VWD, Plisten</cx:pt>
          <cx:pt idx="701">Copra, ITS-VWD, Plisten</cx:pt>
          <cx:pt idx="702">Copra, ITS-VWD, Plisten</cx:pt>
          <cx:pt idx="703">Copra, ITS-VWD, Plisten</cx:pt>
          <cx:pt idx="704">Copra, ITS-VWD, Plisten</cx:pt>
          <cx:pt idx="705">Copra, ITS-VWD, Plisten</cx:pt>
          <cx:pt idx="706">Copra, ITS-VWD, Plisten</cx:pt>
          <cx:pt idx="707">Copra, ITS-VWD, Plisten</cx:pt>
          <cx:pt idx="708">Copra, ITS-VWD, Plisten</cx:pt>
          <cx:pt idx="709">Copra, ITS-VWD, Plisten</cx:pt>
          <cx:pt idx="710">Copra, ITS-VWD, Plisten</cx:pt>
          <cx:pt idx="711">Copra, ITS-VWD, Plisten</cx:pt>
          <cx:pt idx="712">Copra, ITS-VWD, Plisten</cx:pt>
          <cx:pt idx="713">Copra, ITS-VWD, Plisten</cx:pt>
          <cx:pt idx="714">Copra, ITS-VWD, Plisten</cx:pt>
          <cx:pt idx="715">Copra, ITS-VWD, Plisten</cx:pt>
          <cx:pt idx="716">Copra, ITS-VWD, Plisten</cx:pt>
          <cx:pt idx="717">Copra, ITS-VWD, Plisten</cx:pt>
          <cx:pt idx="718">Copra, ITS-VWD, Plisten</cx:pt>
          <cx:pt idx="719">Copra, ITS-VWD, Plisten</cx:pt>
          <cx:pt idx="720">Copra, ITS-VWD, Plisten</cx:pt>
          <cx:pt idx="721">Copra, ITS-VWD, Plisten</cx:pt>
          <cx:pt idx="722">Copra, ITS-VWD, Plisten</cx:pt>
          <cx:pt idx="723">Copra, ITS-VWD, Plisten</cx:pt>
          <cx:pt idx="724">Copra, ITS-VWD, Plisten</cx:pt>
          <cx:pt idx="725">Copra, ITS-VWD, Plisten</cx:pt>
          <cx:pt idx="726">Copra, ITS-VWD, Plisten</cx:pt>
          <cx:pt idx="727">Copra, ITS-VWD, Plisten</cx:pt>
          <cx:pt idx="728">Copra, ITS-VWD, Plisten</cx:pt>
          <cx:pt idx="729">Copra, ITS-VWD, Plisten</cx:pt>
          <cx:pt idx="730">Copra, ITS-VWD, Plisten</cx:pt>
          <cx:pt idx="731">Copra, ITS-VWD, Plisten</cx:pt>
          <cx:pt idx="732">Copra, ITS-VWD, Plisten</cx:pt>
          <cx:pt idx="733">Copra, ITS-VWD, Plisten</cx:pt>
          <cx:pt idx="734">Copra, ITS-VWD, Plisten</cx:pt>
          <cx:pt idx="735">Copra, ITS-VWD, Plisten</cx:pt>
          <cx:pt idx="736">Copra, ITS-VWD, Plisten</cx:pt>
          <cx:pt idx="737">Copra, ITS-VWD, Plisten</cx:pt>
          <cx:pt idx="738">Copra, ITS-VWD, Plisten</cx:pt>
          <cx:pt idx="739">Copra, ITS-VWD, Plisten</cx:pt>
          <cx:pt idx="740">Copra, ITS-VWD, Plisten</cx:pt>
          <cx:pt idx="741">Copra, ITS-VWD, Plisten</cx:pt>
          <cx:pt idx="742">Copra, ITS-VWD, Plisten</cx:pt>
          <cx:pt idx="743">Copra, ITS-VWD, Plisten</cx:pt>
          <cx:pt idx="744">Copra, ITS-VWD, Plisten</cx:pt>
          <cx:pt idx="745">Copra, ITS-VWD, Plisten</cx:pt>
          <cx:pt idx="746">Copra, ITS-VWD, Plisten</cx:pt>
          <cx:pt idx="747">Copra, ITS-VWD, Plisten</cx:pt>
          <cx:pt idx="748">Copra, ITS-VWD, Plisten</cx:pt>
          <cx:pt idx="749">Copra, ITS-VWD, Plisten</cx:pt>
          <cx:pt idx="750">Copra, ITS-VWD, Plisten</cx:pt>
          <cx:pt idx="751">Copra, ITS-VWD, Plisten</cx:pt>
          <cx:pt idx="752">Copra, ITS-VWD, Plisten</cx:pt>
          <cx:pt idx="753">Copra, ITS-VWD, Plisten</cx:pt>
          <cx:pt idx="754">Copra, ITS-VWD, Plisten</cx:pt>
          <cx:pt idx="755">Copra, ITS-VWD, Plisten</cx:pt>
          <cx:pt idx="756">Copra, ITS-VWD, Plisten</cx:pt>
          <cx:pt idx="757">Copra, ITS-VWD, Plisten</cx:pt>
          <cx:pt idx="758">Copra, ITS-VWD, Plisten</cx:pt>
          <cx:pt idx="759">Copra, ITS-VWD, Plisten</cx:pt>
          <cx:pt idx="760">Copra, ITS-VWD, Plisten</cx:pt>
          <cx:pt idx="761">Copra, ITS-VWD, Plisten</cx:pt>
          <cx:pt idx="762">Copra, ITS-VWD, Plisten</cx:pt>
          <cx:pt idx="763">Copra, ITS-VWD, Plisten</cx:pt>
          <cx:pt idx="764">Copra, ITS-VWD, Plisten</cx:pt>
          <cx:pt idx="765">Copra, ITS-VWD, Plisten</cx:pt>
          <cx:pt idx="766">Copra, ITS-VWD, Plisten</cx:pt>
          <cx:pt idx="767">Copra, ITS-VWD, Plisten</cx:pt>
          <cx:pt idx="768">Copra, ITS-VWD, Plisten</cx:pt>
          <cx:pt idx="769">Copra, ITS-VWD, Plisten</cx:pt>
          <cx:pt idx="770">Copra, ITS-VWD, Plisten</cx:pt>
          <cx:pt idx="771">Copra, ITS-VWD, Plisten</cx:pt>
          <cx:pt idx="772">Copra, ITS-VWD, Plisten</cx:pt>
          <cx:pt idx="773">Copra, ITS-VWD, Plisten</cx:pt>
          <cx:pt idx="774">Copra, ITS-VWD, Plisten</cx:pt>
          <cx:pt idx="775">Copra, ITS-VWD, Plisten</cx:pt>
          <cx:pt idx="776">Copra, ITS-VWD, Plisten</cx:pt>
          <cx:pt idx="777">Copra, ITS-VWD, Plisten</cx:pt>
          <cx:pt idx="778">Copra, ITS-VWD, Plisten</cx:pt>
          <cx:pt idx="779">Copra, ITS-VWD, Plisten</cx:pt>
          <cx:pt idx="780">Copra, ITS-VWD, Plisten</cx:pt>
          <cx:pt idx="781">Copra, ITS-VWD, Plisten</cx:pt>
          <cx:pt idx="782">Copra, ITS-VWD, Plisten</cx:pt>
          <cx:pt idx="783">Copra, ITS-VWD, Plisten</cx:pt>
          <cx:pt idx="784">Copra, ITS-VWD, Plisten</cx:pt>
          <cx:pt idx="785">Copra, ITS-VWD, Plisten</cx:pt>
          <cx:pt idx="786">Copra, ITS-VWD, Plisten</cx:pt>
          <cx:pt idx="787">Copra, ITS-VWD, Plisten</cx:pt>
          <cx:pt idx="788">Copra, ITS-VWD, Plisten</cx:pt>
          <cx:pt idx="789">Copra, ITS-VWD, Plisten</cx:pt>
          <cx:pt idx="790">Copra, ITS-VWD, Plisten</cx:pt>
          <cx:pt idx="791">Copra, ITS-VWD, Plisten</cx:pt>
          <cx:pt idx="792">Copra, ITS-VWD, Plisten</cx:pt>
          <cx:pt idx="793">Copra, ITS-VWD, Plisten</cx:pt>
          <cx:pt idx="794">Copra, ITS-VWD, Plisten</cx:pt>
          <cx:pt idx="795">Copra, ITS-VWD, Plisten</cx:pt>
          <cx:pt idx="796">Copra, ITS-VWD, Plisten</cx:pt>
          <cx:pt idx="797">Copra, ITS-VWD, Plisten</cx:pt>
          <cx:pt idx="798">Copra, ITS-VWD, Plisten</cx:pt>
          <cx:pt idx="799">Copra, ITS-VWD, Plisten</cx:pt>
          <cx:pt idx="800">Copra, ITS-VWD, Plisten</cx:pt>
          <cx:pt idx="801">Copra, ITS-VWD, Plisten</cx:pt>
          <cx:pt idx="802">Copra, ITS-VWD, Plisten</cx:pt>
        </cx:lvl>
      </cx:strDim>
      <cx:numDim type="val">
        <cx:lvl ptCount="803" formatCode="General">
          <cx:pt idx="0">2</cx:pt>
          <cx:pt idx="1">2</cx:pt>
          <cx:pt idx="2">2</cx:pt>
          <cx:pt idx="3">2</cx:pt>
          <cx:pt idx="4">2</cx:pt>
          <cx:pt idx="5">2</cx:pt>
          <cx:pt idx="6">2</cx:pt>
          <cx:pt idx="7">2</cx:pt>
          <cx:pt idx="8">2</cx:pt>
          <cx:pt idx="9">2</cx:pt>
          <cx:pt idx="10">2</cx:pt>
          <cx:pt idx="11">2</cx:pt>
          <cx:pt idx="12">2</cx:pt>
          <cx:pt idx="13">2</cx:pt>
          <cx:pt idx="14">2</cx:pt>
          <cx:pt idx="15">2</cx:pt>
          <cx:pt idx="16">2</cx:pt>
          <cx:pt idx="17">2</cx:pt>
          <cx:pt idx="18">2</cx:pt>
          <cx:pt idx="19">2</cx:pt>
          <cx:pt idx="20">2</cx:pt>
          <cx:pt idx="21">2</cx:pt>
          <cx:pt idx="22">2</cx:pt>
          <cx:pt idx="23">2</cx:pt>
          <cx:pt idx="24">2</cx:pt>
          <cx:pt idx="25">2</cx:pt>
          <cx:pt idx="26">2</cx:pt>
          <cx:pt idx="27">2</cx:pt>
          <cx:pt idx="28">2</cx:pt>
          <cx:pt idx="29">2</cx:pt>
          <cx:pt idx="30">2</cx:pt>
          <cx:pt idx="31">2</cx:pt>
          <cx:pt idx="32">2</cx:pt>
          <cx:pt idx="33">2</cx:pt>
          <cx:pt idx="34">2</cx:pt>
          <cx:pt idx="35">2</cx:pt>
          <cx:pt idx="36">2</cx:pt>
          <cx:pt idx="37">2</cx:pt>
          <cx:pt idx="38">2</cx:pt>
          <cx:pt idx="39">2</cx:pt>
          <cx:pt idx="40">2</cx:pt>
          <cx:pt idx="41">2</cx:pt>
          <cx:pt idx="42">2</cx:pt>
          <cx:pt idx="43">2</cx:pt>
          <cx:pt idx="44">2</cx:pt>
          <cx:pt idx="45">2</cx:pt>
          <cx:pt idx="46">2</cx:pt>
          <cx:pt idx="47">2</cx:pt>
          <cx:pt idx="48">2</cx:pt>
          <cx:pt idx="49">2</cx:pt>
          <cx:pt idx="50">2</cx:pt>
          <cx:pt idx="51">2</cx:pt>
          <cx:pt idx="52">2</cx:pt>
          <cx:pt idx="53">2</cx:pt>
          <cx:pt idx="54">2</cx:pt>
          <cx:pt idx="55">2</cx:pt>
          <cx:pt idx="56">2</cx:pt>
          <cx:pt idx="57">2</cx:pt>
          <cx:pt idx="58">2</cx:pt>
          <cx:pt idx="59">2</cx:pt>
          <cx:pt idx="60">2</cx:pt>
          <cx:pt idx="61">2</cx:pt>
          <cx:pt idx="62">2</cx:pt>
          <cx:pt idx="63">2</cx:pt>
          <cx:pt idx="64">2</cx:pt>
          <cx:pt idx="65">2</cx:pt>
          <cx:pt idx="66">2</cx:pt>
          <cx:pt idx="67">2</cx:pt>
          <cx:pt idx="68">2</cx:pt>
          <cx:pt idx="69">2</cx:pt>
          <cx:pt idx="70">2</cx:pt>
          <cx:pt idx="71">2</cx:pt>
          <cx:pt idx="72">2</cx:pt>
          <cx:pt idx="73">2</cx:pt>
          <cx:pt idx="74">2</cx:pt>
          <cx:pt idx="75">2</cx:pt>
          <cx:pt idx="76">2</cx:pt>
          <cx:pt idx="77">2</cx:pt>
          <cx:pt idx="78">2</cx:pt>
          <cx:pt idx="79">2</cx:pt>
          <cx:pt idx="80">2</cx:pt>
          <cx:pt idx="81">2</cx:pt>
          <cx:pt idx="82">2</cx:pt>
          <cx:pt idx="83">2</cx:pt>
          <cx:pt idx="84">2</cx:pt>
          <cx:pt idx="85">2</cx:pt>
          <cx:pt idx="86">2</cx:pt>
          <cx:pt idx="87">2</cx:pt>
          <cx:pt idx="88">2</cx:pt>
          <cx:pt idx="89">2</cx:pt>
          <cx:pt idx="90">2</cx:pt>
          <cx:pt idx="91">2</cx:pt>
          <cx:pt idx="92">2</cx:pt>
          <cx:pt idx="93">2</cx:pt>
          <cx:pt idx="94">2</cx:pt>
          <cx:pt idx="95">2</cx:pt>
          <cx:pt idx="96">2</cx:pt>
          <cx:pt idx="97">2</cx:pt>
          <cx:pt idx="98">2</cx:pt>
          <cx:pt idx="99">2</cx:pt>
          <cx:pt idx="100">2</cx:pt>
          <cx:pt idx="101">2</cx:pt>
          <cx:pt idx="102">2</cx:pt>
          <cx:pt idx="103">2</cx:pt>
          <cx:pt idx="104">2</cx:pt>
          <cx:pt idx="105">3</cx:pt>
          <cx:pt idx="106">3</cx:pt>
          <cx:pt idx="107">3</cx:pt>
          <cx:pt idx="108">3</cx:pt>
          <cx:pt idx="109">3</cx:pt>
          <cx:pt idx="110">3</cx:pt>
          <cx:pt idx="111">3</cx:pt>
          <cx:pt idx="112">3</cx:pt>
          <cx:pt idx="113">3</cx:pt>
          <cx:pt idx="114">3</cx:pt>
          <cx:pt idx="115">3</cx:pt>
          <cx:pt idx="116">3</cx:pt>
          <cx:pt idx="117">3</cx:pt>
          <cx:pt idx="118">3</cx:pt>
          <cx:pt idx="119">3</cx:pt>
          <cx:pt idx="120">3</cx:pt>
          <cx:pt idx="121">3</cx:pt>
          <cx:pt idx="122">3</cx:pt>
          <cx:pt idx="123">3</cx:pt>
          <cx:pt idx="124">3</cx:pt>
          <cx:pt idx="125">3</cx:pt>
          <cx:pt idx="126">3</cx:pt>
          <cx:pt idx="127">3</cx:pt>
          <cx:pt idx="128">3</cx:pt>
          <cx:pt idx="129">3</cx:pt>
          <cx:pt idx="130">3</cx:pt>
          <cx:pt idx="131">3</cx:pt>
          <cx:pt idx="132">3</cx:pt>
          <cx:pt idx="133">3</cx:pt>
          <cx:pt idx="134">3</cx:pt>
          <cx:pt idx="135">3</cx:pt>
          <cx:pt idx="136">3</cx:pt>
          <cx:pt idx="137">3</cx:pt>
          <cx:pt idx="138">3</cx:pt>
          <cx:pt idx="139">3</cx:pt>
          <cx:pt idx="140">3</cx:pt>
          <cx:pt idx="141">3</cx:pt>
          <cx:pt idx="142">3</cx:pt>
          <cx:pt idx="143">3</cx:pt>
          <cx:pt idx="144">3</cx:pt>
          <cx:pt idx="145">3</cx:pt>
          <cx:pt idx="146">3</cx:pt>
          <cx:pt idx="147">3</cx:pt>
          <cx:pt idx="148">3</cx:pt>
          <cx:pt idx="149">3</cx:pt>
          <cx:pt idx="150">3</cx:pt>
          <cx:pt idx="151">3</cx:pt>
          <cx:pt idx="152">3</cx:pt>
          <cx:pt idx="153">3</cx:pt>
          <cx:pt idx="154">3</cx:pt>
          <cx:pt idx="155">3</cx:pt>
          <cx:pt idx="156">3</cx:pt>
          <cx:pt idx="157">3</cx:pt>
          <cx:pt idx="158">3</cx:pt>
          <cx:pt idx="159">3</cx:pt>
          <cx:pt idx="160">3</cx:pt>
          <cx:pt idx="161">3</cx:pt>
          <cx:pt idx="162">3</cx:pt>
          <cx:pt idx="163">3</cx:pt>
          <cx:pt idx="164">3</cx:pt>
          <cx:pt idx="165">3</cx:pt>
          <cx:pt idx="166">3</cx:pt>
          <cx:pt idx="167">3</cx:pt>
          <cx:pt idx="168">3</cx:pt>
          <cx:pt idx="169">3</cx:pt>
          <cx:pt idx="170">3</cx:pt>
          <cx:pt idx="171">3</cx:pt>
          <cx:pt idx="172">3</cx:pt>
          <cx:pt idx="173">3</cx:pt>
          <cx:pt idx="174">3</cx:pt>
          <cx:pt idx="175">3</cx:pt>
          <cx:pt idx="176">3</cx:pt>
          <cx:pt idx="177">3</cx:pt>
          <cx:pt idx="178">3</cx:pt>
          <cx:pt idx="179">3</cx:pt>
          <cx:pt idx="180">3</cx:pt>
          <cx:pt idx="181">3</cx:pt>
          <cx:pt idx="182">3</cx:pt>
          <cx:pt idx="183">3</cx:pt>
          <cx:pt idx="184">3</cx:pt>
          <cx:pt idx="185">3</cx:pt>
          <cx:pt idx="186">3</cx:pt>
          <cx:pt idx="187">3</cx:pt>
          <cx:pt idx="188">3</cx:pt>
          <cx:pt idx="189">3</cx:pt>
          <cx:pt idx="190">3</cx:pt>
          <cx:pt idx="191">3</cx:pt>
          <cx:pt idx="192">4</cx:pt>
          <cx:pt idx="193">4</cx:pt>
          <cx:pt idx="194">4</cx:pt>
          <cx:pt idx="195">4</cx:pt>
          <cx:pt idx="196">4</cx:pt>
          <cx:pt idx="197">4</cx:pt>
          <cx:pt idx="198">4</cx:pt>
          <cx:pt idx="199">4</cx:pt>
          <cx:pt idx="200">4</cx:pt>
          <cx:pt idx="201">4</cx:pt>
          <cx:pt idx="202">4</cx:pt>
          <cx:pt idx="203">4</cx:pt>
          <cx:pt idx="204">4</cx:pt>
          <cx:pt idx="205">4</cx:pt>
          <cx:pt idx="206">4</cx:pt>
          <cx:pt idx="207">4</cx:pt>
          <cx:pt idx="208">4</cx:pt>
          <cx:pt idx="209">4</cx:pt>
          <cx:pt idx="210">4</cx:pt>
          <cx:pt idx="211">4</cx:pt>
          <cx:pt idx="212">4</cx:pt>
          <cx:pt idx="213">4</cx:pt>
          <cx:pt idx="214">4</cx:pt>
          <cx:pt idx="215">4</cx:pt>
          <cx:pt idx="216">4</cx:pt>
          <cx:pt idx="217">4</cx:pt>
          <cx:pt idx="218">4</cx:pt>
          <cx:pt idx="219">4</cx:pt>
          <cx:pt idx="220">4</cx:pt>
          <cx:pt idx="221">4</cx:pt>
          <cx:pt idx="222">4</cx:pt>
          <cx:pt idx="223">4</cx:pt>
          <cx:pt idx="224">4</cx:pt>
          <cx:pt idx="225">4</cx:pt>
          <cx:pt idx="226">4</cx:pt>
          <cx:pt idx="227">4</cx:pt>
          <cx:pt idx="228">4</cx:pt>
          <cx:pt idx="229">4</cx:pt>
          <cx:pt idx="230">4</cx:pt>
          <cx:pt idx="231">4</cx:pt>
          <cx:pt idx="232">4</cx:pt>
          <cx:pt idx="233">4</cx:pt>
          <cx:pt idx="234">4</cx:pt>
          <cx:pt idx="235">4</cx:pt>
          <cx:pt idx="236">4</cx:pt>
          <cx:pt idx="237">4</cx:pt>
          <cx:pt idx="238">4</cx:pt>
          <cx:pt idx="239">4</cx:pt>
          <cx:pt idx="240">4</cx:pt>
          <cx:pt idx="241">4</cx:pt>
          <cx:pt idx="242">4</cx:pt>
          <cx:pt idx="243">4</cx:pt>
          <cx:pt idx="244">4</cx:pt>
          <cx:pt idx="245">4</cx:pt>
          <cx:pt idx="246">4</cx:pt>
          <cx:pt idx="247">4</cx:pt>
          <cx:pt idx="248">4</cx:pt>
          <cx:pt idx="249">4</cx:pt>
          <cx:pt idx="250">4</cx:pt>
          <cx:pt idx="251">4</cx:pt>
          <cx:pt idx="252">4</cx:pt>
          <cx:pt idx="253">4</cx:pt>
          <cx:pt idx="254">4</cx:pt>
          <cx:pt idx="255">4</cx:pt>
          <cx:pt idx="256">4</cx:pt>
          <cx:pt idx="257">4</cx:pt>
          <cx:pt idx="258">4</cx:pt>
          <cx:pt idx="259">4</cx:pt>
          <cx:pt idx="260">4</cx:pt>
          <cx:pt idx="261">4</cx:pt>
          <cx:pt idx="262">4</cx:pt>
          <cx:pt idx="263">4</cx:pt>
          <cx:pt idx="264">4</cx:pt>
          <cx:pt idx="265">4</cx:pt>
          <cx:pt idx="266">4</cx:pt>
          <cx:pt idx="267">4</cx:pt>
          <cx:pt idx="268">4</cx:pt>
          <cx:pt idx="269">4</cx:pt>
          <cx:pt idx="270">4</cx:pt>
          <cx:pt idx="271">4</cx:pt>
          <cx:pt idx="272">4</cx:pt>
          <cx:pt idx="273">4</cx:pt>
          <cx:pt idx="274">4</cx:pt>
          <cx:pt idx="275">4</cx:pt>
          <cx:pt idx="276">4</cx:pt>
          <cx:pt idx="277">5</cx:pt>
          <cx:pt idx="278">5</cx:pt>
          <cx:pt idx="279">5</cx:pt>
          <cx:pt idx="280">5</cx:pt>
          <cx:pt idx="281">5</cx:pt>
          <cx:pt idx="282">5</cx:pt>
          <cx:pt idx="283">5</cx:pt>
          <cx:pt idx="284">5</cx:pt>
          <cx:pt idx="285">5</cx:pt>
          <cx:pt idx="286">5</cx:pt>
          <cx:pt idx="287">5</cx:pt>
          <cx:pt idx="288">5</cx:pt>
          <cx:pt idx="289">5</cx:pt>
          <cx:pt idx="290">5</cx:pt>
          <cx:pt idx="291">5</cx:pt>
          <cx:pt idx="292">5</cx:pt>
          <cx:pt idx="293">5</cx:pt>
          <cx:pt idx="294">5</cx:pt>
          <cx:pt idx="295">5</cx:pt>
          <cx:pt idx="296">5</cx:pt>
          <cx:pt idx="297">5</cx:pt>
          <cx:pt idx="298">5</cx:pt>
          <cx:pt idx="299">5</cx:pt>
          <cx:pt idx="300">5</cx:pt>
          <cx:pt idx="301">5</cx:pt>
          <cx:pt idx="302">5</cx:pt>
          <cx:pt idx="303">5</cx:pt>
          <cx:pt idx="304">5</cx:pt>
          <cx:pt idx="305">5</cx:pt>
          <cx:pt idx="306">5</cx:pt>
          <cx:pt idx="307">5</cx:pt>
          <cx:pt idx="308">5</cx:pt>
          <cx:pt idx="309">5</cx:pt>
          <cx:pt idx="310">5</cx:pt>
          <cx:pt idx="311">5</cx:pt>
          <cx:pt idx="312">5</cx:pt>
          <cx:pt idx="313">5</cx:pt>
          <cx:pt idx="314">5</cx:pt>
          <cx:pt idx="315">5</cx:pt>
          <cx:pt idx="316">5</cx:pt>
          <cx:pt idx="317">5</cx:pt>
          <cx:pt idx="318">5</cx:pt>
          <cx:pt idx="319">5</cx:pt>
          <cx:pt idx="320">5</cx:pt>
          <cx:pt idx="321">5</cx:pt>
          <cx:pt idx="322">5</cx:pt>
          <cx:pt idx="323">5</cx:pt>
          <cx:pt idx="324">5</cx:pt>
          <cx:pt idx="325">5</cx:pt>
          <cx:pt idx="326">5</cx:pt>
          <cx:pt idx="327">5</cx:pt>
          <cx:pt idx="328">5</cx:pt>
          <cx:pt idx="329">5</cx:pt>
          <cx:pt idx="330">5</cx:pt>
          <cx:pt idx="331">5</cx:pt>
          <cx:pt idx="332">5</cx:pt>
          <cx:pt idx="333">5</cx:pt>
          <cx:pt idx="334">5</cx:pt>
          <cx:pt idx="335">5</cx:pt>
          <cx:pt idx="336">5</cx:pt>
          <cx:pt idx="337">5</cx:pt>
          <cx:pt idx="338">5</cx:pt>
          <cx:pt idx="339">5</cx:pt>
          <cx:pt idx="340">5</cx:pt>
          <cx:pt idx="341">5</cx:pt>
          <cx:pt idx="342">5</cx:pt>
          <cx:pt idx="343">5</cx:pt>
          <cx:pt idx="344">5</cx:pt>
          <cx:pt idx="345">5</cx:pt>
          <cx:pt idx="346">5</cx:pt>
          <cx:pt idx="347">5</cx:pt>
          <cx:pt idx="348">5</cx:pt>
          <cx:pt idx="349">5</cx:pt>
          <cx:pt idx="350">5</cx:pt>
          <cx:pt idx="351">5</cx:pt>
          <cx:pt idx="352">5</cx:pt>
          <cx:pt idx="353">5</cx:pt>
          <cx:pt idx="354">5</cx:pt>
          <cx:pt idx="355">5</cx:pt>
          <cx:pt idx="356">5</cx:pt>
          <cx:pt idx="357">5</cx:pt>
          <cx:pt idx="358">5</cx:pt>
          <cx:pt idx="359">6</cx:pt>
          <cx:pt idx="360">6</cx:pt>
          <cx:pt idx="361">6</cx:pt>
          <cx:pt idx="362">6</cx:pt>
          <cx:pt idx="363">6</cx:pt>
          <cx:pt idx="364">6</cx:pt>
          <cx:pt idx="365">6</cx:pt>
          <cx:pt idx="366">6</cx:pt>
          <cx:pt idx="367">6</cx:pt>
          <cx:pt idx="368">6</cx:pt>
          <cx:pt idx="369">6</cx:pt>
          <cx:pt idx="370">6</cx:pt>
          <cx:pt idx="371">6</cx:pt>
          <cx:pt idx="372">6</cx:pt>
          <cx:pt idx="373">6</cx:pt>
          <cx:pt idx="374">6</cx:pt>
          <cx:pt idx="375">6</cx:pt>
          <cx:pt idx="376">6</cx:pt>
          <cx:pt idx="377">6</cx:pt>
          <cx:pt idx="378">6</cx:pt>
          <cx:pt idx="379">6</cx:pt>
          <cx:pt idx="380">6</cx:pt>
          <cx:pt idx="381">6</cx:pt>
          <cx:pt idx="382">6</cx:pt>
          <cx:pt idx="383">6</cx:pt>
          <cx:pt idx="384">6</cx:pt>
          <cx:pt idx="385">6</cx:pt>
          <cx:pt idx="386">6</cx:pt>
          <cx:pt idx="387">6</cx:pt>
          <cx:pt idx="388">6</cx:pt>
          <cx:pt idx="389">6</cx:pt>
          <cx:pt idx="390">6</cx:pt>
          <cx:pt idx="391">6</cx:pt>
          <cx:pt idx="392">6</cx:pt>
          <cx:pt idx="393">6</cx:pt>
          <cx:pt idx="394">6</cx:pt>
          <cx:pt idx="395">6</cx:pt>
          <cx:pt idx="396">6</cx:pt>
          <cx:pt idx="397">6</cx:pt>
          <cx:pt idx="398">6</cx:pt>
          <cx:pt idx="399">6</cx:pt>
          <cx:pt idx="400">6</cx:pt>
          <cx:pt idx="401">6</cx:pt>
          <cx:pt idx="402">6</cx:pt>
          <cx:pt idx="403">6</cx:pt>
          <cx:pt idx="404">6</cx:pt>
          <cx:pt idx="405">6</cx:pt>
          <cx:pt idx="406">6</cx:pt>
          <cx:pt idx="407">6</cx:pt>
          <cx:pt idx="408">6</cx:pt>
          <cx:pt idx="409">6</cx:pt>
          <cx:pt idx="410">6</cx:pt>
          <cx:pt idx="411">6</cx:pt>
          <cx:pt idx="412">6</cx:pt>
          <cx:pt idx="413">6</cx:pt>
          <cx:pt idx="414">6</cx:pt>
          <cx:pt idx="415">6</cx:pt>
          <cx:pt idx="416">6</cx:pt>
          <cx:pt idx="417">6</cx:pt>
          <cx:pt idx="418">6</cx:pt>
          <cx:pt idx="419">6</cx:pt>
          <cx:pt idx="420">6</cx:pt>
          <cx:pt idx="421">6</cx:pt>
          <cx:pt idx="422">6</cx:pt>
          <cx:pt idx="423">6</cx:pt>
          <cx:pt idx="424">6</cx:pt>
          <cx:pt idx="425">6</cx:pt>
          <cx:pt idx="426">6</cx:pt>
          <cx:pt idx="427">6</cx:pt>
          <cx:pt idx="428">6</cx:pt>
          <cx:pt idx="429">6</cx:pt>
          <cx:pt idx="430">6</cx:pt>
          <cx:pt idx="431">6</cx:pt>
          <cx:pt idx="432">6</cx:pt>
          <cx:pt idx="433">6</cx:pt>
          <cx:pt idx="434">7</cx:pt>
          <cx:pt idx="435">7</cx:pt>
          <cx:pt idx="436">7</cx:pt>
          <cx:pt idx="437">7</cx:pt>
          <cx:pt idx="438">7</cx:pt>
          <cx:pt idx="439">7</cx:pt>
          <cx:pt idx="440">7</cx:pt>
          <cx:pt idx="441">7</cx:pt>
          <cx:pt idx="442">7</cx:pt>
          <cx:pt idx="443">7</cx:pt>
          <cx:pt idx="444">7</cx:pt>
          <cx:pt idx="445">7</cx:pt>
          <cx:pt idx="446">7</cx:pt>
          <cx:pt idx="447">7</cx:pt>
          <cx:pt idx="448">7</cx:pt>
          <cx:pt idx="449">7</cx:pt>
          <cx:pt idx="450">7</cx:pt>
          <cx:pt idx="451">7</cx:pt>
          <cx:pt idx="452">7</cx:pt>
          <cx:pt idx="453">7</cx:pt>
          <cx:pt idx="454">7</cx:pt>
          <cx:pt idx="455">7</cx:pt>
          <cx:pt idx="456">7</cx:pt>
          <cx:pt idx="457">7</cx:pt>
          <cx:pt idx="458">7</cx:pt>
          <cx:pt idx="459">7</cx:pt>
          <cx:pt idx="460">7</cx:pt>
          <cx:pt idx="461">7</cx:pt>
          <cx:pt idx="462">7</cx:pt>
          <cx:pt idx="463">7</cx:pt>
          <cx:pt idx="464">7</cx:pt>
          <cx:pt idx="465">7</cx:pt>
          <cx:pt idx="466">7</cx:pt>
          <cx:pt idx="467">7</cx:pt>
          <cx:pt idx="468">7</cx:pt>
          <cx:pt idx="469">7</cx:pt>
          <cx:pt idx="470">7</cx:pt>
          <cx:pt idx="471">7</cx:pt>
          <cx:pt idx="472">7</cx:pt>
          <cx:pt idx="473">7</cx:pt>
          <cx:pt idx="474">7</cx:pt>
          <cx:pt idx="475">7</cx:pt>
          <cx:pt idx="476">7</cx:pt>
          <cx:pt idx="477">7</cx:pt>
          <cx:pt idx="478">7</cx:pt>
          <cx:pt idx="479">7</cx:pt>
          <cx:pt idx="480">7</cx:pt>
          <cx:pt idx="481">7</cx:pt>
          <cx:pt idx="482">7</cx:pt>
          <cx:pt idx="483">7</cx:pt>
          <cx:pt idx="484">7</cx:pt>
          <cx:pt idx="485">7</cx:pt>
          <cx:pt idx="486">7</cx:pt>
          <cx:pt idx="487">7</cx:pt>
          <cx:pt idx="488">7</cx:pt>
          <cx:pt idx="489">7</cx:pt>
          <cx:pt idx="490">7</cx:pt>
          <cx:pt idx="491">7</cx:pt>
          <cx:pt idx="492">7</cx:pt>
          <cx:pt idx="493">7</cx:pt>
          <cx:pt idx="494">7</cx:pt>
          <cx:pt idx="495">7</cx:pt>
          <cx:pt idx="496">7</cx:pt>
          <cx:pt idx="497">8</cx:pt>
          <cx:pt idx="498">8</cx:pt>
          <cx:pt idx="499">8</cx:pt>
          <cx:pt idx="500">8</cx:pt>
          <cx:pt idx="501">8</cx:pt>
          <cx:pt idx="502">8</cx:pt>
          <cx:pt idx="503">8</cx:pt>
          <cx:pt idx="504">8</cx:pt>
          <cx:pt idx="505">8</cx:pt>
          <cx:pt idx="506">8</cx:pt>
          <cx:pt idx="507">8</cx:pt>
          <cx:pt idx="508">8</cx:pt>
          <cx:pt idx="509">8</cx:pt>
          <cx:pt idx="510">8</cx:pt>
          <cx:pt idx="511">8</cx:pt>
          <cx:pt idx="512">8</cx:pt>
          <cx:pt idx="513">8</cx:pt>
          <cx:pt idx="514">8</cx:pt>
          <cx:pt idx="515">8</cx:pt>
          <cx:pt idx="516">8</cx:pt>
          <cx:pt idx="517">8</cx:pt>
          <cx:pt idx="518">8</cx:pt>
          <cx:pt idx="519">8</cx:pt>
          <cx:pt idx="520">8</cx:pt>
          <cx:pt idx="521">8</cx:pt>
          <cx:pt idx="522">8</cx:pt>
          <cx:pt idx="523">8</cx:pt>
          <cx:pt idx="524">8</cx:pt>
          <cx:pt idx="525">8</cx:pt>
          <cx:pt idx="526">8</cx:pt>
          <cx:pt idx="527">8</cx:pt>
          <cx:pt idx="528">8</cx:pt>
          <cx:pt idx="529">8</cx:pt>
          <cx:pt idx="530">8</cx:pt>
          <cx:pt idx="531">8</cx:pt>
          <cx:pt idx="532">8</cx:pt>
          <cx:pt idx="533">8</cx:pt>
          <cx:pt idx="534">8</cx:pt>
          <cx:pt idx="535">8</cx:pt>
          <cx:pt idx="536">8</cx:pt>
          <cx:pt idx="537">8</cx:pt>
          <cx:pt idx="538">8</cx:pt>
          <cx:pt idx="539">8</cx:pt>
          <cx:pt idx="540">8</cx:pt>
          <cx:pt idx="541">8</cx:pt>
          <cx:pt idx="542">9</cx:pt>
          <cx:pt idx="543">9</cx:pt>
          <cx:pt idx="544">9</cx:pt>
          <cx:pt idx="545">9</cx:pt>
          <cx:pt idx="546">9</cx:pt>
          <cx:pt idx="547">9</cx:pt>
          <cx:pt idx="548">9</cx:pt>
          <cx:pt idx="549">9</cx:pt>
          <cx:pt idx="550">9</cx:pt>
          <cx:pt idx="551">9</cx:pt>
          <cx:pt idx="552">9</cx:pt>
          <cx:pt idx="553">9</cx:pt>
          <cx:pt idx="554">9</cx:pt>
          <cx:pt idx="555">9</cx:pt>
          <cx:pt idx="556">9</cx:pt>
          <cx:pt idx="557">9</cx:pt>
          <cx:pt idx="558">9</cx:pt>
          <cx:pt idx="559">9</cx:pt>
          <cx:pt idx="560">9</cx:pt>
          <cx:pt idx="561">9</cx:pt>
          <cx:pt idx="562">9</cx:pt>
          <cx:pt idx="563">9</cx:pt>
          <cx:pt idx="564">9</cx:pt>
          <cx:pt idx="565">9</cx:pt>
          <cx:pt idx="566">9</cx:pt>
          <cx:pt idx="567">9</cx:pt>
          <cx:pt idx="568">9</cx:pt>
          <cx:pt idx="569">9</cx:pt>
          <cx:pt idx="570">9</cx:pt>
          <cx:pt idx="571">9</cx:pt>
          <cx:pt idx="572">9</cx:pt>
          <cx:pt idx="573">10</cx:pt>
          <cx:pt idx="574">10</cx:pt>
          <cx:pt idx="575">10</cx:pt>
          <cx:pt idx="576">10</cx:pt>
          <cx:pt idx="577">10</cx:pt>
          <cx:pt idx="578">10</cx:pt>
          <cx:pt idx="579">10</cx:pt>
          <cx:pt idx="580">10</cx:pt>
          <cx:pt idx="581">10</cx:pt>
          <cx:pt idx="582">10</cx:pt>
          <cx:pt idx="583">10</cx:pt>
          <cx:pt idx="584">10</cx:pt>
          <cx:pt idx="585">10</cx:pt>
          <cx:pt idx="586">10</cx:pt>
          <cx:pt idx="587">10</cx:pt>
          <cx:pt idx="588">10</cx:pt>
          <cx:pt idx="589">10</cx:pt>
          <cx:pt idx="590">10</cx:pt>
          <cx:pt idx="591">10</cx:pt>
          <cx:pt idx="592">10</cx:pt>
          <cx:pt idx="593">10</cx:pt>
          <cx:pt idx="594">10</cx:pt>
          <cx:pt idx="595">10</cx:pt>
          <cx:pt idx="596">11</cx:pt>
          <cx:pt idx="597">11</cx:pt>
          <cx:pt idx="598">11</cx:pt>
          <cx:pt idx="599">11</cx:pt>
          <cx:pt idx="600">11</cx:pt>
          <cx:pt idx="601">11</cx:pt>
          <cx:pt idx="602">11</cx:pt>
          <cx:pt idx="603">11</cx:pt>
          <cx:pt idx="604">11</cx:pt>
          <cx:pt idx="605">11</cx:pt>
          <cx:pt idx="606">11</cx:pt>
          <cx:pt idx="607">11</cx:pt>
          <cx:pt idx="608">11</cx:pt>
          <cx:pt idx="609">11</cx:pt>
          <cx:pt idx="610">11</cx:pt>
          <cx:pt idx="611">11</cx:pt>
          <cx:pt idx="612">11</cx:pt>
          <cx:pt idx="613">12</cx:pt>
          <cx:pt idx="614">12</cx:pt>
          <cx:pt idx="615">12</cx:pt>
          <cx:pt idx="616">12</cx:pt>
          <cx:pt idx="617">12</cx:pt>
          <cx:pt idx="618">12</cx:pt>
          <cx:pt idx="619">12</cx:pt>
          <cx:pt idx="620">12</cx:pt>
          <cx:pt idx="621">12</cx:pt>
          <cx:pt idx="622">12</cx:pt>
          <cx:pt idx="623">12</cx:pt>
          <cx:pt idx="624">12</cx:pt>
          <cx:pt idx="625">12</cx:pt>
          <cx:pt idx="626">12</cx:pt>
          <cx:pt idx="627">12</cx:pt>
          <cx:pt idx="628">12</cx:pt>
          <cx:pt idx="629">12</cx:pt>
          <cx:pt idx="630">12</cx:pt>
          <cx:pt idx="631">12</cx:pt>
          <cx:pt idx="632">12</cx:pt>
          <cx:pt idx="633">12</cx:pt>
          <cx:pt idx="634">12</cx:pt>
          <cx:pt idx="635">13</cx:pt>
          <cx:pt idx="636">13</cx:pt>
          <cx:pt idx="637">13</cx:pt>
          <cx:pt idx="638">13</cx:pt>
          <cx:pt idx="639">13</cx:pt>
          <cx:pt idx="640">13</cx:pt>
          <cx:pt idx="641">13</cx:pt>
          <cx:pt idx="642">13</cx:pt>
          <cx:pt idx="643">13</cx:pt>
          <cx:pt idx="644">13</cx:pt>
          <cx:pt idx="645">13</cx:pt>
          <cx:pt idx="646">13</cx:pt>
          <cx:pt idx="647">13</cx:pt>
          <cx:pt idx="648">13</cx:pt>
          <cx:pt idx="649">13</cx:pt>
          <cx:pt idx="650">13</cx:pt>
          <cx:pt idx="651">14</cx:pt>
          <cx:pt idx="652">14</cx:pt>
          <cx:pt idx="653">14</cx:pt>
          <cx:pt idx="654">14</cx:pt>
          <cx:pt idx="655">14</cx:pt>
          <cx:pt idx="656">14</cx:pt>
          <cx:pt idx="657">14</cx:pt>
          <cx:pt idx="658">14</cx:pt>
          <cx:pt idx="659">14</cx:pt>
          <cx:pt idx="660">15</cx:pt>
          <cx:pt idx="661">15</cx:pt>
          <cx:pt idx="662">15</cx:pt>
          <cx:pt idx="663">15</cx:pt>
          <cx:pt idx="664">15</cx:pt>
          <cx:pt idx="665">15</cx:pt>
          <cx:pt idx="666">16</cx:pt>
          <cx:pt idx="667">16</cx:pt>
          <cx:pt idx="668">16</cx:pt>
          <cx:pt idx="669">16</cx:pt>
          <cx:pt idx="670">16</cx:pt>
          <cx:pt idx="671">16</cx:pt>
          <cx:pt idx="672">16</cx:pt>
          <cx:pt idx="673">16</cx:pt>
          <cx:pt idx="674">16</cx:pt>
          <cx:pt idx="675">17</cx:pt>
          <cx:pt idx="676">17</cx:pt>
          <cx:pt idx="677">17</cx:pt>
          <cx:pt idx="678">17</cx:pt>
          <cx:pt idx="679">17</cx:pt>
          <cx:pt idx="680">17</cx:pt>
          <cx:pt idx="681">17</cx:pt>
          <cx:pt idx="682">17</cx:pt>
          <cx:pt idx="683">17</cx:pt>
          <cx:pt idx="684">17</cx:pt>
          <cx:pt idx="685">18</cx:pt>
          <cx:pt idx="686">18</cx:pt>
          <cx:pt idx="687">18</cx:pt>
          <cx:pt idx="688">19</cx:pt>
          <cx:pt idx="689">19</cx:pt>
          <cx:pt idx="690">19</cx:pt>
          <cx:pt idx="691">19</cx:pt>
          <cx:pt idx="692">19</cx:pt>
          <cx:pt idx="693">19</cx:pt>
          <cx:pt idx="694">19</cx:pt>
          <cx:pt idx="695">20</cx:pt>
          <cx:pt idx="696">20</cx:pt>
          <cx:pt idx="697">20</cx:pt>
          <cx:pt idx="698">20</cx:pt>
          <cx:pt idx="699">20</cx:pt>
          <cx:pt idx="700">20</cx:pt>
          <cx:pt idx="701">20</cx:pt>
          <cx:pt idx="702">20</cx:pt>
          <cx:pt idx="703">20</cx:pt>
          <cx:pt idx="704">20</cx:pt>
          <cx:pt idx="705">20</cx:pt>
          <cx:pt idx="706">20</cx:pt>
          <cx:pt idx="707">20</cx:pt>
          <cx:pt idx="708">20</cx:pt>
          <cx:pt idx="709">20</cx:pt>
          <cx:pt idx="710">20</cx:pt>
          <cx:pt idx="711">20</cx:pt>
          <cx:pt idx="712">21</cx:pt>
          <cx:pt idx="713">21</cx:pt>
          <cx:pt idx="714">21</cx:pt>
          <cx:pt idx="715">21</cx:pt>
          <cx:pt idx="716">21</cx:pt>
          <cx:pt idx="717">22</cx:pt>
          <cx:pt idx="718">22</cx:pt>
          <cx:pt idx="719">22</cx:pt>
          <cx:pt idx="720">22</cx:pt>
          <cx:pt idx="721">22</cx:pt>
          <cx:pt idx="722">22</cx:pt>
          <cx:pt idx="723">22</cx:pt>
          <cx:pt idx="724">22</cx:pt>
          <cx:pt idx="725">22</cx:pt>
          <cx:pt idx="726">22</cx:pt>
          <cx:pt idx="727">23</cx:pt>
          <cx:pt idx="728">23</cx:pt>
          <cx:pt idx="729">23</cx:pt>
          <cx:pt idx="730">23</cx:pt>
          <cx:pt idx="731">23</cx:pt>
          <cx:pt idx="732">23</cx:pt>
          <cx:pt idx="733">23</cx:pt>
          <cx:pt idx="734">23</cx:pt>
          <cx:pt idx="735">24</cx:pt>
          <cx:pt idx="736">24</cx:pt>
          <cx:pt idx="737">24</cx:pt>
          <cx:pt idx="738">24</cx:pt>
          <cx:pt idx="739">25</cx:pt>
          <cx:pt idx="740">25</cx:pt>
          <cx:pt idx="741">25</cx:pt>
          <cx:pt idx="742">25</cx:pt>
          <cx:pt idx="743">26</cx:pt>
          <cx:pt idx="744">26</cx:pt>
          <cx:pt idx="745">26</cx:pt>
          <cx:pt idx="746">26</cx:pt>
          <cx:pt idx="747">26</cx:pt>
          <cx:pt idx="748">26</cx:pt>
          <cx:pt idx="749">27</cx:pt>
          <cx:pt idx="750">27</cx:pt>
          <cx:pt idx="751">28</cx:pt>
          <cx:pt idx="752">28</cx:pt>
          <cx:pt idx="753">28</cx:pt>
          <cx:pt idx="754">28</cx:pt>
          <cx:pt idx="755">29</cx:pt>
          <cx:pt idx="756">29</cx:pt>
          <cx:pt idx="757">29</cx:pt>
          <cx:pt idx="758">30</cx:pt>
          <cx:pt idx="759">30</cx:pt>
          <cx:pt idx="760">30</cx:pt>
          <cx:pt idx="761">30</cx:pt>
          <cx:pt idx="762">31</cx:pt>
          <cx:pt idx="763">31</cx:pt>
          <cx:pt idx="764">32</cx:pt>
          <cx:pt idx="765">33</cx:pt>
          <cx:pt idx="766">33</cx:pt>
          <cx:pt idx="767">34</cx:pt>
          <cx:pt idx="768">34</cx:pt>
          <cx:pt idx="769">34</cx:pt>
          <cx:pt idx="770">34</cx:pt>
          <cx:pt idx="771">34</cx:pt>
          <cx:pt idx="772">35</cx:pt>
          <cx:pt idx="773">36</cx:pt>
          <cx:pt idx="774">37</cx:pt>
          <cx:pt idx="775">37</cx:pt>
          <cx:pt idx="776">38</cx:pt>
          <cx:pt idx="777">39</cx:pt>
          <cx:pt idx="778">41</cx:pt>
          <cx:pt idx="779">42</cx:pt>
          <cx:pt idx="780">42</cx:pt>
          <cx:pt idx="781">42</cx:pt>
          <cx:pt idx="782">42</cx:pt>
          <cx:pt idx="783">42</cx:pt>
          <cx:pt idx="784">43</cx:pt>
          <cx:pt idx="785">45</cx:pt>
          <cx:pt idx="786">45</cx:pt>
          <cx:pt idx="787">49</cx:pt>
          <cx:pt idx="788">51</cx:pt>
          <cx:pt idx="789">52</cx:pt>
          <cx:pt idx="790">53</cx:pt>
          <cx:pt idx="791">54</cx:pt>
          <cx:pt idx="792">55</cx:pt>
          <cx:pt idx="793">56</cx:pt>
          <cx:pt idx="794">56</cx:pt>
          <cx:pt idx="795">57</cx:pt>
          <cx:pt idx="796">61</cx:pt>
          <cx:pt idx="797">63</cx:pt>
          <cx:pt idx="798">63</cx:pt>
          <cx:pt idx="799">63</cx:pt>
          <cx:pt idx="800">79</cx:pt>
          <cx:pt idx="801">109</cx:pt>
          <cx:pt idx="802">111</cx:pt>
        </cx:lvl>
      </cx:numDim>
    </cx:data>
  </cx:chartData>
  <cx:chart>
    <cx:title pos="t" align="ctr" overlay="0">
      <cx:tx>
        <cx:txData>
          <cx:v/>
        </cx:txData>
      </cx:tx>
      <cx:txPr>
        <a:bodyPr spcFirstLastPara="1" vertOverflow="ellipsis" wrap="square" lIns="0" tIns="0" rIns="0" bIns="0" anchor="ctr" anchorCtr="1"/>
        <a:lstStyle/>
        <a:p>
          <a:pPr algn="ctr">
            <a:defRPr/>
          </a:pPr>
          <a:endParaRPr/>
        </a:p>
      </cx:txPr>
    </cx:title>
    <cx:plotArea>
      <cx:plotAreaRegion>
        <cx:series layoutId="boxWhisker" uniqueId="{4182C088-BBF1-40C3-8A6B-46B290DE937D}">
          <cx:dataId val="0"/>
          <cx:layoutPr>
            <cx:visibility meanLine="0" meanMarker="1" nonoutliers="0" outliers="1"/>
            <cx:statistics quartileMethod="exclusive"/>
          </cx:layoutPr>
        </cx:series>
      </cx:plotAreaRegion>
      <cx:axis id="0">
        <cx:catScaling gapWidth="1"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tickLabels/>
      </cx:axis>
      <cx:axis id="1">
        <cx:valScaling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majorGridlines/>
        <cx:tickLabels/>
      </cx:axis>
    </cx:plotArea>
  </cx:chart>
</cx:chartSpace>
</file>

<file path=ppt/charts/chartEx8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lvl ptCount="803">
          <cx:pt idx="0">Beatmung (SAP, 21 FALL)</cx:pt>
          <cx:pt idx="1">Beatmung (SAP, 21 FALL)</cx:pt>
          <cx:pt idx="2">Beatmung (SAP, 21 FALL)</cx:pt>
          <cx:pt idx="3">Beatmung (SAP, 21 FALL)</cx:pt>
          <cx:pt idx="4">Beatmung (SAP, 21 FALL)</cx:pt>
          <cx:pt idx="5">Beatmung (SAP, 21 FALL)</cx:pt>
          <cx:pt idx="6">Beatmung (SAP, 21 FALL)</cx:pt>
          <cx:pt idx="7">Beatmung (SAP, 21 FALL)</cx:pt>
          <cx:pt idx="8">Beatmung (SAP, 21 FALL)</cx:pt>
          <cx:pt idx="9">Beatmung (SAP, 21 FALL)</cx:pt>
          <cx:pt idx="10">Beatmung (SAP, 21 FALL)</cx:pt>
          <cx:pt idx="11">Beatmung (SAP, 21 FALL)</cx:pt>
          <cx:pt idx="12">Beatmung (SAP, 21 FALL)</cx:pt>
          <cx:pt idx="13">Beatmung (SAP, 21 FALL)</cx:pt>
          <cx:pt idx="14">Beatmung (SAP, 21 FALL)</cx:pt>
          <cx:pt idx="15">Beatmung (SAP, 21 FALL)</cx:pt>
          <cx:pt idx="16">Beatmung (SAP, 21 FALL)</cx:pt>
          <cx:pt idx="17">Beatmung (SAP, 21 FALL)</cx:pt>
          <cx:pt idx="18">Beatmung (SAP, 21 FALL)</cx:pt>
          <cx:pt idx="19">Beatmung (SAP, 21 FALL)</cx:pt>
          <cx:pt idx="20">Beatmung (SAP, 21 FALL)</cx:pt>
          <cx:pt idx="21">Beatmung (SAP, 21 FALL)</cx:pt>
          <cx:pt idx="22">Beatmung (SAP, 21 FALL)</cx:pt>
          <cx:pt idx="23">Beatmung (SAP, 21 FALL)</cx:pt>
          <cx:pt idx="24">Beatmung (SAP, 21 FALL)</cx:pt>
          <cx:pt idx="25">Beatmung (SAP, 21 FALL)</cx:pt>
          <cx:pt idx="26">Beatmung (SAP, 21 FALL)</cx:pt>
          <cx:pt idx="27">Beatmung (SAP, 21 FALL)</cx:pt>
          <cx:pt idx="28">Beatmung (SAP, 21 FALL)</cx:pt>
          <cx:pt idx="29">Beatmung (SAP, 21 FALL)</cx:pt>
          <cx:pt idx="30">Beatmung (SAP, 21 FALL)</cx:pt>
          <cx:pt idx="31">Beatmung (SAP, 21 FALL)</cx:pt>
          <cx:pt idx="32">Beatmung (SAP, 21 FALL)</cx:pt>
          <cx:pt idx="33">Beatmung (SAP, 21 FALL)</cx:pt>
          <cx:pt idx="34">Beatmung (SAP, 21 FALL)</cx:pt>
          <cx:pt idx="35">Beatmung (SAP, 21 FALL)</cx:pt>
          <cx:pt idx="36">Beatmung (SAP, 21 FALL)</cx:pt>
          <cx:pt idx="37">Beatmung (SAP, 21 FALL)</cx:pt>
          <cx:pt idx="38">Beatmung (SAP, 21 FALL)</cx:pt>
          <cx:pt idx="39">Beatmung (SAP, 21 FALL)</cx:pt>
          <cx:pt idx="40">Beatmung (SAP, 21 FALL)</cx:pt>
          <cx:pt idx="41">Beatmung (SAP, 21 FALL)</cx:pt>
          <cx:pt idx="42">Beatmung (SAP, 21 FALL)</cx:pt>
          <cx:pt idx="43">Beatmung (SAP, 21 FALL)</cx:pt>
          <cx:pt idx="44">Beatmung (SAP, 21 FALL)</cx:pt>
          <cx:pt idx="45">Beatmung (SAP, 21 FALL)</cx:pt>
          <cx:pt idx="46">Beatmung (SAP, 21 FALL)</cx:pt>
          <cx:pt idx="47">Beatmung (SAP, 21 FALL)</cx:pt>
          <cx:pt idx="48">Beatmung (SAP, 21 FALL)</cx:pt>
          <cx:pt idx="49">Beatmung (SAP, 21 FALL)</cx:pt>
          <cx:pt idx="50">Beatmung (SAP, 21 FALL)</cx:pt>
          <cx:pt idx="51">Beatmung (SAP, 21 FALL)</cx:pt>
          <cx:pt idx="52">Beatmung (SAP, 21 FALL)</cx:pt>
          <cx:pt idx="53">Beatmung (SAP, 21 FALL)</cx:pt>
          <cx:pt idx="54">Beatmung (SAP, 21 FALL)</cx:pt>
          <cx:pt idx="55">Beatmung (SAP, 21 FALL)</cx:pt>
          <cx:pt idx="56">Beatmung (SAP, 21 FALL)</cx:pt>
          <cx:pt idx="57">Beatmung (SAP, 21 FALL)</cx:pt>
          <cx:pt idx="58">Beatmung (SAP, 21 FALL)</cx:pt>
          <cx:pt idx="59">Beatmung (SAP, 21 FALL)</cx:pt>
          <cx:pt idx="60">Beatmung (SAP, 21 FALL)</cx:pt>
          <cx:pt idx="61">Beatmung (SAP, 21 FALL)</cx:pt>
          <cx:pt idx="62">Beatmung (SAP, 21 FALL)</cx:pt>
          <cx:pt idx="63">Beatmung (SAP, 21 FALL)</cx:pt>
          <cx:pt idx="64">Beatmung (SAP, 21 FALL)</cx:pt>
          <cx:pt idx="65">Beatmung (SAP, 21 FALL)</cx:pt>
          <cx:pt idx="66">Beatmung (SAP, 21 FALL)</cx:pt>
          <cx:pt idx="67">Beatmung (SAP, 21 FALL)</cx:pt>
          <cx:pt idx="68">Beatmung (SAP, 21 FALL)</cx:pt>
          <cx:pt idx="69">Beatmung (SAP, 21 FALL)</cx:pt>
          <cx:pt idx="70">Beatmung (SAP, 21 FALL)</cx:pt>
          <cx:pt idx="71">Beatmung (SAP, 21 FALL)</cx:pt>
          <cx:pt idx="72">Beatmung (SAP, 21 FALL)</cx:pt>
          <cx:pt idx="73">Beatmung (SAP, 21 FALL)</cx:pt>
          <cx:pt idx="74">Beatmung (SAP, 21 FALL)</cx:pt>
          <cx:pt idx="75">Beatmung (SAP, 21 FALL)</cx:pt>
          <cx:pt idx="76">Beatmung (SAP, 21 FALL)</cx:pt>
          <cx:pt idx="77">Beatmung (SAP, 21 FALL)</cx:pt>
          <cx:pt idx="78">Beatmung (SAP, 21 FALL)</cx:pt>
          <cx:pt idx="79">Beatmung (SAP, 21 FALL)</cx:pt>
          <cx:pt idx="80">Beatmung (SAP, 21 FALL)</cx:pt>
          <cx:pt idx="81">Beatmung (SAP, 21 FALL)</cx:pt>
          <cx:pt idx="82">Beatmung (SAP, 21 FALL)</cx:pt>
          <cx:pt idx="83">Beatmung (SAP, 21 FALL)</cx:pt>
          <cx:pt idx="84">Beatmung (SAP, 21 FALL)</cx:pt>
          <cx:pt idx="85">Beatmung (SAP, 21 FALL)</cx:pt>
          <cx:pt idx="86">Beatmung (SAP, 21 FALL)</cx:pt>
          <cx:pt idx="87">Beatmung (SAP, 21 FALL)</cx:pt>
          <cx:pt idx="88">Beatmung (SAP, 21 FALL)</cx:pt>
          <cx:pt idx="89">Beatmung (SAP, 21 FALL)</cx:pt>
          <cx:pt idx="90">Beatmung (SAP, 21 FALL)</cx:pt>
          <cx:pt idx="91">Beatmung (SAP, 21 FALL)</cx:pt>
          <cx:pt idx="92">Beatmung (SAP, 21 FALL)</cx:pt>
          <cx:pt idx="93">Beatmung (SAP, 21 FALL)</cx:pt>
          <cx:pt idx="94">Beatmung (SAP, 21 FALL)</cx:pt>
          <cx:pt idx="95">Beatmung (SAP, 21 FALL)</cx:pt>
          <cx:pt idx="96">Beatmung (SAP, 21 FALL)</cx:pt>
          <cx:pt idx="97">Beatmung (SAP, 21 FALL)</cx:pt>
          <cx:pt idx="98">Beatmung (SAP, 21 FALL)</cx:pt>
          <cx:pt idx="99">Beatmung (SAP, 21 FALL)</cx:pt>
          <cx:pt idx="100">Beatmung (SAP, 21 FALL)</cx:pt>
          <cx:pt idx="101">Beatmung (SAP, 21 FALL)</cx:pt>
          <cx:pt idx="102">Beatmung (SAP, 21 FALL)</cx:pt>
          <cx:pt idx="103">Beatmung (SAP, 21 FALL)</cx:pt>
          <cx:pt idx="104">Beatmung (SAP, 21 FALL)</cx:pt>
          <cx:pt idx="105">Beatmung (SAP, 21 FALL)</cx:pt>
          <cx:pt idx="106">Beatmung (SAP, 21 FALL)</cx:pt>
          <cx:pt idx="107">Beatmung (SAP, 21 FALL)</cx:pt>
          <cx:pt idx="108">Beatmung (SAP, 21 FALL)</cx:pt>
          <cx:pt idx="109">Beatmung (SAP, 21 FALL)</cx:pt>
          <cx:pt idx="110">Beatmung (SAP, 21 FALL)</cx:pt>
          <cx:pt idx="111">Beatmung (SAP, 21 FALL)</cx:pt>
          <cx:pt idx="112">Beatmung (SAP, 21 FALL)</cx:pt>
          <cx:pt idx="113">Beatmung (SAP, 21 FALL)</cx:pt>
          <cx:pt idx="114">Beatmung (SAP, 21 FALL)</cx:pt>
          <cx:pt idx="115">Beatmung (SAP, 21 FALL)</cx:pt>
          <cx:pt idx="116">Beatmung (SAP, 21 FALL)</cx:pt>
          <cx:pt idx="117">Beatmung (SAP, 21 FALL)</cx:pt>
          <cx:pt idx="118">Beatmung (SAP, 21 FALL)</cx:pt>
          <cx:pt idx="119">Beatmung (SAP, 21 FALL)</cx:pt>
          <cx:pt idx="120">Beatmung (SAP, 21 FALL)</cx:pt>
          <cx:pt idx="121">Beatmung (SAP, 21 FALL)</cx:pt>
          <cx:pt idx="122">Beatmung (SAP, 21 FALL)</cx:pt>
          <cx:pt idx="123">Beatmung (SAP, 21 FALL)</cx:pt>
          <cx:pt idx="124">Beatmung (SAP, 21 FALL)</cx:pt>
          <cx:pt idx="125">Beatmung (SAP, 21 FALL)</cx:pt>
          <cx:pt idx="126">Beatmung (SAP, 21 FALL)</cx:pt>
          <cx:pt idx="127">Beatmung (SAP, 21 FALL)</cx:pt>
          <cx:pt idx="128">Beatmung (SAP, 21 FALL)</cx:pt>
          <cx:pt idx="129">Beatmung (SAP, 21 FALL)</cx:pt>
          <cx:pt idx="130">Beatmung (SAP, 21 FALL)</cx:pt>
          <cx:pt idx="131">Beatmung (SAP, 21 FALL)</cx:pt>
          <cx:pt idx="132">Beatmung (SAP, 21 FALL)</cx:pt>
          <cx:pt idx="133">Beatmung (SAP, 21 FALL)</cx:pt>
          <cx:pt idx="134">Beatmung (SAP, 21 FALL)</cx:pt>
          <cx:pt idx="135">Beatmung (SAP, 21 FALL)</cx:pt>
          <cx:pt idx="136">Beatmung (SAP, 21 FALL)</cx:pt>
          <cx:pt idx="137">Beatmung (SAP, 21 FALL)</cx:pt>
          <cx:pt idx="138">Beatmung (SAP, 21 FALL)</cx:pt>
          <cx:pt idx="139">Beatmung (SAP, 21 FALL)</cx:pt>
          <cx:pt idx="140">Beatmung (SAP, 21 FALL)</cx:pt>
          <cx:pt idx="141">Beatmung (SAP, 21 FALL)</cx:pt>
          <cx:pt idx="142">Beatmung (SAP, 21 FALL)</cx:pt>
          <cx:pt idx="143">Beatmung (SAP, 21 FALL)</cx:pt>
          <cx:pt idx="144">Beatmung (SAP, 21 FALL)</cx:pt>
          <cx:pt idx="145">Beatmung (SAP, 21 FALL)</cx:pt>
          <cx:pt idx="146">Beatmung (SAP, 21 FALL)</cx:pt>
          <cx:pt idx="147">Beatmung (SAP, 21 FALL)</cx:pt>
          <cx:pt idx="148">Beatmung (SAP, 21 FALL)</cx:pt>
          <cx:pt idx="149">Beatmung (SAP, 21 FALL)</cx:pt>
          <cx:pt idx="150">Beatmung (SAP, 21 FALL)</cx:pt>
          <cx:pt idx="151">Beatmung (SAP, 21 FALL)</cx:pt>
          <cx:pt idx="152">Beatmung (SAP, 21 FALL)</cx:pt>
          <cx:pt idx="153">Beatmung (SAP, 21 FALL)</cx:pt>
          <cx:pt idx="154">Beatmung (SAP, 21 FALL)</cx:pt>
          <cx:pt idx="155">Beatmung (SAP, 21 FALL)</cx:pt>
          <cx:pt idx="156">Beatmung (SAP, 21 FALL)</cx:pt>
          <cx:pt idx="157">Beatmung (SAP, 21 FALL)</cx:pt>
          <cx:pt idx="158">Beatmung (SAP, 21 FALL)</cx:pt>
          <cx:pt idx="159">Beatmung (SAP, 21 FALL)</cx:pt>
          <cx:pt idx="160">Beatmung (SAP, 21 FALL)</cx:pt>
          <cx:pt idx="161">Beatmung (SAP, 21 FALL)</cx:pt>
          <cx:pt idx="162">Beatmung (SAP, 21 FALL)</cx:pt>
          <cx:pt idx="163">Beatmung (SAP, 21 FALL)</cx:pt>
          <cx:pt idx="164">Beatmung (SAP, 21 FALL)</cx:pt>
          <cx:pt idx="165">Beatmung (SAP, 21 FALL)</cx:pt>
          <cx:pt idx="166">Beatmung (SAP, 21 FALL)</cx:pt>
          <cx:pt idx="167">Beatmung (SAP, 21 FALL)</cx:pt>
          <cx:pt idx="168">Beatmung (SAP, 21 FALL)</cx:pt>
          <cx:pt idx="169">Beatmung (SAP, 21 FALL)</cx:pt>
          <cx:pt idx="170">Beatmung (SAP, 21 FALL)</cx:pt>
          <cx:pt idx="171">Beatmung (SAP, 21 FALL)</cx:pt>
          <cx:pt idx="172">Beatmung (SAP, 21 FALL)</cx:pt>
          <cx:pt idx="173">Beatmung (SAP, 21 FALL)</cx:pt>
          <cx:pt idx="174">Beatmung (SAP, 21 FALL)</cx:pt>
          <cx:pt idx="175">Beatmung (SAP, 21 FALL)</cx:pt>
          <cx:pt idx="176">Beatmung (SAP, 21 FALL)</cx:pt>
          <cx:pt idx="177">Beatmung (SAP, 21 FALL)</cx:pt>
          <cx:pt idx="178">Beatmung (SAP, 21 FALL)</cx:pt>
          <cx:pt idx="179">Beatmung (SAP, 21 FALL)</cx:pt>
          <cx:pt idx="180">Beatmung (SAP, 21 FALL)</cx:pt>
          <cx:pt idx="181">Beatmung (SAP, 21 FALL)</cx:pt>
          <cx:pt idx="182">Beatmung (SAP, 21 FALL)</cx:pt>
          <cx:pt idx="183">Beatmung (SAP, 21 FALL)</cx:pt>
          <cx:pt idx="184">Beatmung (SAP, 21 FALL)</cx:pt>
          <cx:pt idx="185">Beatmung (SAP, 21 FALL)</cx:pt>
          <cx:pt idx="186">Beatmung (SAP, 21 FALL)</cx:pt>
          <cx:pt idx="187">Beatmung (SAP, 21 FALL)</cx:pt>
          <cx:pt idx="188">Beatmung (SAP, 21 FALL)</cx:pt>
          <cx:pt idx="189">Beatmung (SAP, 21 FALL)</cx:pt>
          <cx:pt idx="190">Beatmung (SAP, 21 FALL)</cx:pt>
          <cx:pt idx="191">Beatmung (SAP, 21 FALL)</cx:pt>
          <cx:pt idx="192">Beatmung (SAP, 21 FALL)</cx:pt>
          <cx:pt idx="193">Beatmung (SAP, 21 FALL)</cx:pt>
          <cx:pt idx="194">Beatmung (SAP, 21 FALL)</cx:pt>
          <cx:pt idx="195">Beatmung (SAP, 21 FALL)</cx:pt>
          <cx:pt idx="196">Beatmung (SAP, 21 FALL)</cx:pt>
          <cx:pt idx="197">Beatmung (SAP, 21 FALL)</cx:pt>
          <cx:pt idx="198">Beatmung (SAP, 21 FALL)</cx:pt>
          <cx:pt idx="199">Beatmung (SAP, 21 FALL)</cx:pt>
          <cx:pt idx="200">Beatmung (SAP, 21 FALL)</cx:pt>
          <cx:pt idx="201">Beatmung (SAP, 21 FALL)</cx:pt>
          <cx:pt idx="202">Beatmung (SAP, 21 FALL)</cx:pt>
          <cx:pt idx="203">Beatmung (SAP, 21 FALL)</cx:pt>
          <cx:pt idx="204">Beatmung (SAP, 21 FALL)</cx:pt>
          <cx:pt idx="205">Beatmung (SAP, 21 FALL)</cx:pt>
          <cx:pt idx="206">Beatmung (SAP, 21 FALL)</cx:pt>
          <cx:pt idx="207">Beatmung (SAP, 21 FALL)</cx:pt>
          <cx:pt idx="208">Beatmung (SAP, 21 FALL)</cx:pt>
          <cx:pt idx="209">Beatmung (SAP, 21 FALL)</cx:pt>
          <cx:pt idx="210">Beatmung (SAP, 21 FALL)</cx:pt>
          <cx:pt idx="211">Beatmung (SAP, 21 FALL)</cx:pt>
          <cx:pt idx="212">Beatmung (SAP, 21 FALL)</cx:pt>
          <cx:pt idx="213">Beatmung (SAP, 21 FALL)</cx:pt>
          <cx:pt idx="214">Beatmung (SAP, 21 FALL)</cx:pt>
          <cx:pt idx="215">Beatmung (SAP, 21 FALL)</cx:pt>
          <cx:pt idx="216">Beatmung (SAP, 21 FALL)</cx:pt>
          <cx:pt idx="217">Beatmung (SAP, 21 FALL)</cx:pt>
          <cx:pt idx="218">Beatmung (SAP, 21 FALL)</cx:pt>
          <cx:pt idx="219">Beatmung (SAP, 21 FALL)</cx:pt>
          <cx:pt idx="220">Beatmung (SAP, 21 FALL)</cx:pt>
          <cx:pt idx="221">Beatmung (SAP, 21 FALL)</cx:pt>
          <cx:pt idx="222">Beatmung (SAP, 21 FALL)</cx:pt>
          <cx:pt idx="223">Beatmung (SAP, 21 FALL)</cx:pt>
          <cx:pt idx="224">Beatmung (SAP, 21 FALL)</cx:pt>
          <cx:pt idx="225">Beatmung (SAP, 21 FALL)</cx:pt>
          <cx:pt idx="226">Beatmung (SAP, 21 FALL)</cx:pt>
          <cx:pt idx="227">Beatmung (SAP, 21 FALL)</cx:pt>
          <cx:pt idx="228">Beatmung (SAP, 21 FALL)</cx:pt>
          <cx:pt idx="229">Beatmung (SAP, 21 FALL)</cx:pt>
          <cx:pt idx="230">Beatmung (SAP, 21 FALL)</cx:pt>
          <cx:pt idx="231">Beatmung (SAP, 21 FALL)</cx:pt>
          <cx:pt idx="232">Beatmung (SAP, 21 FALL)</cx:pt>
          <cx:pt idx="233">Beatmung (SAP, 21 FALL)</cx:pt>
          <cx:pt idx="234">Beatmung (SAP, 21 FALL)</cx:pt>
          <cx:pt idx="235">Beatmung (SAP, 21 FALL)</cx:pt>
          <cx:pt idx="236">Beatmung (SAP, 21 FALL)</cx:pt>
          <cx:pt idx="237">Beatmung (SAP, 21 FALL)</cx:pt>
          <cx:pt idx="238">Beatmung (SAP, 21 FALL)</cx:pt>
          <cx:pt idx="239">Beatmung (SAP, 21 FALL)</cx:pt>
          <cx:pt idx="240">Beatmung (SAP, 21 FALL)</cx:pt>
          <cx:pt idx="241">Beatmung (SAP, 21 FALL)</cx:pt>
          <cx:pt idx="242">Beatmung (SAP, 21 FALL)</cx:pt>
          <cx:pt idx="243">Beatmung (SAP, 21 FALL)</cx:pt>
          <cx:pt idx="244">Beatmung (SAP, 21 FALL)</cx:pt>
          <cx:pt idx="245">Beatmung (SAP, 21 FALL)</cx:pt>
          <cx:pt idx="246">Beatmung (SAP, 21 FALL)</cx:pt>
          <cx:pt idx="247">Beatmung (SAP, 21 FALL)</cx:pt>
          <cx:pt idx="248">Beatmung (SAP, 21 FALL)</cx:pt>
          <cx:pt idx="249">Beatmung (SAP, 21 FALL)</cx:pt>
          <cx:pt idx="250">Beatmung (SAP, 21 FALL)</cx:pt>
          <cx:pt idx="251">Beatmung (SAP, 21 FALL)</cx:pt>
          <cx:pt idx="252">Beatmung (SAP, 21 FALL)</cx:pt>
          <cx:pt idx="253">Beatmung (SAP, 21 FALL)</cx:pt>
          <cx:pt idx="254">Beatmung (SAP, 21 FALL)</cx:pt>
          <cx:pt idx="255">Beatmung (SAP, 21 FALL)</cx:pt>
          <cx:pt idx="256">Beatmung (SAP, 21 FALL)</cx:pt>
          <cx:pt idx="257">Beatmung (SAP, 21 FALL)</cx:pt>
          <cx:pt idx="258">Beatmung (SAP, 21 FALL)</cx:pt>
          <cx:pt idx="259">Beatmung (SAP, 21 FALL)</cx:pt>
          <cx:pt idx="260">Beatmung (SAP, 21 FALL)</cx:pt>
          <cx:pt idx="261">Beatmung (SAP, 21 FALL)</cx:pt>
          <cx:pt idx="262">Beatmung (SAP, 21 FALL)</cx:pt>
          <cx:pt idx="263">Beatmung (SAP, 21 FALL)</cx:pt>
          <cx:pt idx="264">Beatmung (SAP, 21 FALL)</cx:pt>
          <cx:pt idx="265">Beatmung (SAP, 21 FALL)</cx:pt>
          <cx:pt idx="266">Beatmung (SAP, 21 FALL)</cx:pt>
          <cx:pt idx="267">Beatmung (SAP, 21 FALL)</cx:pt>
          <cx:pt idx="268">Beatmung (SAP, 21 FALL)</cx:pt>
          <cx:pt idx="269">Beatmung (SAP, 21 FALL)</cx:pt>
          <cx:pt idx="270">Beatmung (SAP, 21 FALL)</cx:pt>
          <cx:pt idx="271">Beatmung (SAP, 21 FALL)</cx:pt>
          <cx:pt idx="272">Beatmung (SAP, 21 FALL)</cx:pt>
          <cx:pt idx="273">Beatmung (SAP, 21 FALL)</cx:pt>
          <cx:pt idx="274">Beatmung (SAP, 21 FALL)</cx:pt>
          <cx:pt idx="275">Beatmung (SAP, 21 FALL)</cx:pt>
          <cx:pt idx="276">Beatmung (SAP, 21 FALL)</cx:pt>
          <cx:pt idx="277">Beatmung (SAP, 21 FALL)</cx:pt>
          <cx:pt idx="278">Beatmung (SAP, 21 FALL)</cx:pt>
          <cx:pt idx="279">Beatmung (SAP, 21 FALL)</cx:pt>
          <cx:pt idx="280">Beatmung (SAP, 21 FALL)</cx:pt>
          <cx:pt idx="281">Beatmung (SAP, 21 FALL)</cx:pt>
          <cx:pt idx="282">Beatmung (SAP, 21 FALL)</cx:pt>
          <cx:pt idx="283">Beatmung (SAP, 21 FALL)</cx:pt>
          <cx:pt idx="284">Beatmung (SAP, 21 FALL)</cx:pt>
          <cx:pt idx="285">Beatmung (SAP, 21 FALL)</cx:pt>
          <cx:pt idx="286">Beatmung (SAP, 21 FALL)</cx:pt>
          <cx:pt idx="287">Beatmung (SAP, 21 FALL)</cx:pt>
          <cx:pt idx="288">Beatmung (SAP, 21 FALL)</cx:pt>
          <cx:pt idx="289">Beatmung (SAP, 21 FALL)</cx:pt>
          <cx:pt idx="290">Beatmung (SAP, 21 FALL)</cx:pt>
          <cx:pt idx="291">Beatmung (SAP, 21 FALL)</cx:pt>
          <cx:pt idx="292">Beatmung (SAP, 21 FALL)</cx:pt>
          <cx:pt idx="293">Beatmung (SAP, 21 FALL)</cx:pt>
          <cx:pt idx="294">Beatmung (SAP, 21 FALL)</cx:pt>
          <cx:pt idx="295">Beatmung (SAP, 21 FALL)</cx:pt>
          <cx:pt idx="296">Beatmung (SAP, 21 FALL)</cx:pt>
          <cx:pt idx="297">Beatmung (SAP, 21 FALL)</cx:pt>
          <cx:pt idx="298">Beatmung (SAP, 21 FALL)</cx:pt>
          <cx:pt idx="299">Beatmung (SAP, 21 FALL)</cx:pt>
          <cx:pt idx="300">Beatmung (SAP, 21 FALL)</cx:pt>
          <cx:pt idx="301">Beatmung (SAP, 21 FALL)</cx:pt>
          <cx:pt idx="302">Beatmung (SAP, 21 FALL)</cx:pt>
          <cx:pt idx="303">Beatmung (SAP, 21 FALL)</cx:pt>
          <cx:pt idx="304">Beatmung (SAP, 21 FALL)</cx:pt>
          <cx:pt idx="305">Beatmung (SAP, 21 FALL)</cx:pt>
          <cx:pt idx="306">Beatmung (SAP, 21 FALL)</cx:pt>
          <cx:pt idx="307">Beatmung (SAP, 21 FALL)</cx:pt>
          <cx:pt idx="308">Beatmung (SAP, 21 FALL)</cx:pt>
          <cx:pt idx="309">Beatmung (SAP, 21 FALL)</cx:pt>
          <cx:pt idx="310">Beatmung (SAP, 21 FALL)</cx:pt>
          <cx:pt idx="311">Beatmung (SAP, 21 FALL)</cx:pt>
          <cx:pt idx="312">Beatmung (SAP, 21 FALL)</cx:pt>
          <cx:pt idx="313">Beatmung (SAP, 21 FALL)</cx:pt>
          <cx:pt idx="314">Beatmung (SAP, 21 FALL)</cx:pt>
          <cx:pt idx="315">Beatmung (SAP, 21 FALL)</cx:pt>
          <cx:pt idx="316">Beatmung (SAP, 21 FALL)</cx:pt>
          <cx:pt idx="317">Beatmung (SAP, 21 FALL)</cx:pt>
          <cx:pt idx="318">Beatmung (SAP, 21 FALL)</cx:pt>
          <cx:pt idx="319">Beatmung (SAP, 21 FALL)</cx:pt>
          <cx:pt idx="320">Beatmung (SAP, 21 FALL)</cx:pt>
          <cx:pt idx="321">Beatmung (SAP, 21 FALL)</cx:pt>
          <cx:pt idx="322">Beatmung (SAP, 21 FALL)</cx:pt>
          <cx:pt idx="323">Beatmung (SAP, 21 FALL)</cx:pt>
          <cx:pt idx="324">Beatmung (SAP, 21 FALL)</cx:pt>
          <cx:pt idx="325">Beatmung (SAP, 21 FALL)</cx:pt>
          <cx:pt idx="326">Beatmung (SAP, 21 FALL)</cx:pt>
          <cx:pt idx="327">Beatmung (SAP, 21 FALL)</cx:pt>
          <cx:pt idx="328">Beatmung (SAP, 21 FALL)</cx:pt>
          <cx:pt idx="329">Beatmung (SAP, 21 FALL)</cx:pt>
          <cx:pt idx="330">Beatmung (SAP, 21 FALL)</cx:pt>
          <cx:pt idx="331">Beatmung (SAP, 21 FALL)</cx:pt>
          <cx:pt idx="332">Beatmung (SAP, 21 FALL)</cx:pt>
          <cx:pt idx="333">Beatmung (SAP, 21 FALL)</cx:pt>
          <cx:pt idx="334">Beatmung (SAP, 21 FALL)</cx:pt>
          <cx:pt idx="335">Beatmung (SAP, 21 FALL)</cx:pt>
          <cx:pt idx="336">Beatmung (SAP, 21 FALL)</cx:pt>
          <cx:pt idx="337">Beatmung (SAP, 21 FALL)</cx:pt>
          <cx:pt idx="338">Beatmung (SAP, 21 FALL)</cx:pt>
          <cx:pt idx="339">Beatmung (SAP, 21 FALL)</cx:pt>
          <cx:pt idx="340">Beatmung (SAP, 21 FALL)</cx:pt>
          <cx:pt idx="341">Beatmung (SAP, 21 FALL)</cx:pt>
          <cx:pt idx="342">Beatmung (SAP, 21 FALL)</cx:pt>
          <cx:pt idx="343">Beatmung (SAP, 21 FALL)</cx:pt>
          <cx:pt idx="344">Beatmung (SAP, 21 FALL)</cx:pt>
          <cx:pt idx="345">Beatmung (SAP, 21 FALL)</cx:pt>
          <cx:pt idx="346">Beatmung (SAP, 21 FALL)</cx:pt>
          <cx:pt idx="347">Beatmung (SAP, 21 FALL)</cx:pt>
          <cx:pt idx="348">Beatmung (SAP, 21 FALL)</cx:pt>
          <cx:pt idx="349">Beatmung (SAP, 21 FALL)</cx:pt>
          <cx:pt idx="350">Beatmung (SAP, 21 FALL)</cx:pt>
          <cx:pt idx="351">Beatmung (SAP, 21 FALL)</cx:pt>
          <cx:pt idx="352">Beatmung (SAP, 21 FALL)</cx:pt>
          <cx:pt idx="353">Beatmung (SAP, 21 FALL)</cx:pt>
          <cx:pt idx="354">Beatmung (SAP, 21 FALL)</cx:pt>
          <cx:pt idx="355">Beatmung (SAP, 21 FALL)</cx:pt>
          <cx:pt idx="356">Beatmung (SAP, 21 FALL)</cx:pt>
          <cx:pt idx="357">Beatmung (SAP, 21 FALL)</cx:pt>
          <cx:pt idx="358">Beatmung (SAP, 21 FALL)</cx:pt>
          <cx:pt idx="359">Beatmung (SAP, 21 FALL)</cx:pt>
          <cx:pt idx="360">Beatmung (SAP, 21 FALL)</cx:pt>
          <cx:pt idx="361">Beatmung (SAP, 21 FALL)</cx:pt>
          <cx:pt idx="362">Beatmung (SAP, 21 FALL)</cx:pt>
          <cx:pt idx="363">Beatmung (SAP, 21 FALL)</cx:pt>
          <cx:pt idx="364">Beatmung (SAP, 21 FALL)</cx:pt>
          <cx:pt idx="365">Beatmung (SAP, 21 FALL)</cx:pt>
          <cx:pt idx="366">Beatmung (SAP, 21 FALL)</cx:pt>
          <cx:pt idx="367">Beatmung (SAP, 21 FALL)</cx:pt>
          <cx:pt idx="368">Beatmung (SAP, 21 FALL)</cx:pt>
          <cx:pt idx="369">Beatmung (SAP, 21 FALL)</cx:pt>
          <cx:pt idx="370">Beatmung (SAP, 21 FALL)</cx:pt>
          <cx:pt idx="371">Beatmung (SAP, 21 FALL)</cx:pt>
          <cx:pt idx="372">Beatmung (SAP, 21 FALL)</cx:pt>
          <cx:pt idx="373">Beatmung (SAP, 21 FALL)</cx:pt>
          <cx:pt idx="374">Beatmung (SAP, 21 FALL)</cx:pt>
          <cx:pt idx="375">Beatmung (SAP, 21 FALL)</cx:pt>
          <cx:pt idx="376">Beatmung (SAP, 21 FALL)</cx:pt>
          <cx:pt idx="377">Beatmung (SAP, 21 FALL)</cx:pt>
          <cx:pt idx="378">Beatmung (SAP, 21 FALL)</cx:pt>
          <cx:pt idx="379">Beatmung (SAP, 21 FALL)</cx:pt>
          <cx:pt idx="380">Beatmung (SAP, 21 FALL)</cx:pt>
          <cx:pt idx="381">Beatmung (SAP, 21 FALL)</cx:pt>
          <cx:pt idx="382">Beatmung (SAP, 21 FALL)</cx:pt>
          <cx:pt idx="383">Beatmung (SAP, 21 FALL)</cx:pt>
          <cx:pt idx="384">Beatmung (SAP, 21 FALL)</cx:pt>
          <cx:pt idx="385">Beatmung (SAP, 21 FALL)</cx:pt>
          <cx:pt idx="386">Beatmung (SAP, 21 FALL)</cx:pt>
          <cx:pt idx="387">Beatmung (SAP, 21 FALL)</cx:pt>
          <cx:pt idx="388">Beatmung (SAP, 21 FALL)</cx:pt>
          <cx:pt idx="389">Beatmung (SAP, 21 FALL)</cx:pt>
          <cx:pt idx="390">Beatmung (SAP, 21 FALL)</cx:pt>
          <cx:pt idx="391">Beatmung (SAP, 21 FALL)</cx:pt>
          <cx:pt idx="392">Beatmung (SAP, 21 FALL)</cx:pt>
          <cx:pt idx="393">Beatmung (SAP, 21 FALL)</cx:pt>
          <cx:pt idx="394">Beatmung (SAP, 21 FALL)</cx:pt>
          <cx:pt idx="395">Beatmung (SAP, 21 FALL)</cx:pt>
          <cx:pt idx="396">Beatmung (SAP, 21 FALL)</cx:pt>
          <cx:pt idx="397">Beatmung (SAP, 21 FALL)</cx:pt>
          <cx:pt idx="398">Beatmung (SAP, 21 FALL)</cx:pt>
          <cx:pt idx="399">Beatmung (SAP, 21 FALL)</cx:pt>
          <cx:pt idx="400">Beatmung (SAP, 21 FALL)</cx:pt>
          <cx:pt idx="401">Beatmung (SAP, 21 FALL)</cx:pt>
          <cx:pt idx="402">Beatmung (SAP, 21 FALL)</cx:pt>
          <cx:pt idx="403">Beatmung (SAP, 21 FALL)</cx:pt>
          <cx:pt idx="404">Beatmung (SAP, 21 FALL)</cx:pt>
          <cx:pt idx="405">Beatmung (SAP, 21 FALL)</cx:pt>
          <cx:pt idx="406">Beatmung (SAP, 21 FALL)</cx:pt>
          <cx:pt idx="407">Beatmung (SAP, 21 FALL)</cx:pt>
          <cx:pt idx="408">Beatmung (SAP, 21 FALL)</cx:pt>
          <cx:pt idx="409">Beatmung (SAP, 21 FALL)</cx:pt>
          <cx:pt idx="410">Beatmung (SAP, 21 FALL)</cx:pt>
          <cx:pt idx="411">Beatmung (SAP, 21 FALL)</cx:pt>
          <cx:pt idx="412">Beatmung (SAP, 21 FALL)</cx:pt>
          <cx:pt idx="413">Beatmung (SAP, 21 FALL)</cx:pt>
          <cx:pt idx="414">Beatmung (SAP, 21 FALL)</cx:pt>
          <cx:pt idx="415">Beatmung (SAP, 21 FALL)</cx:pt>
          <cx:pt idx="416">Beatmung (SAP, 21 FALL)</cx:pt>
          <cx:pt idx="417">Beatmung (SAP, 21 FALL)</cx:pt>
          <cx:pt idx="418">Beatmung (SAP, 21 FALL)</cx:pt>
          <cx:pt idx="419">Beatmung (SAP, 21 FALL)</cx:pt>
          <cx:pt idx="420">Beatmung (SAP, 21 FALL)</cx:pt>
          <cx:pt idx="421">Beatmung (SAP, 21 FALL)</cx:pt>
          <cx:pt idx="422">Beatmung (SAP, 21 FALL)</cx:pt>
          <cx:pt idx="423">Beatmung (SAP, 21 FALL)</cx:pt>
          <cx:pt idx="424">Beatmung (SAP, 21 FALL)</cx:pt>
          <cx:pt idx="425">Beatmung (SAP, 21 FALL)</cx:pt>
          <cx:pt idx="426">Beatmung (SAP, 21 FALL)</cx:pt>
          <cx:pt idx="427">Beatmung (SAP, 21 FALL)</cx:pt>
          <cx:pt idx="428">Beatmung (SAP, 21 FALL)</cx:pt>
          <cx:pt idx="429">Beatmung (SAP, 21 FALL)</cx:pt>
          <cx:pt idx="430">Beatmung (SAP, 21 FALL)</cx:pt>
          <cx:pt idx="431">Beatmung (SAP, 21 FALL)</cx:pt>
          <cx:pt idx="432">Beatmung (SAP, 21 FALL)</cx:pt>
          <cx:pt idx="433">Beatmung (SAP, 21 FALL)</cx:pt>
          <cx:pt idx="434">Beatmung (SAP, 21 FALL)</cx:pt>
          <cx:pt idx="435">Beatmung (SAP, 21 FALL)</cx:pt>
          <cx:pt idx="436">Beatmung (SAP, 21 FALL)</cx:pt>
          <cx:pt idx="437">Beatmung (SAP, 21 FALL)</cx:pt>
          <cx:pt idx="438">Beatmung (SAP, 21 FALL)</cx:pt>
          <cx:pt idx="439">Beatmung (SAP, 21 FALL)</cx:pt>
          <cx:pt idx="440">Beatmung (SAP, 21 FALL)</cx:pt>
          <cx:pt idx="441">Beatmung (SAP, 21 FALL)</cx:pt>
          <cx:pt idx="442">Beatmung (SAP, 21 FALL)</cx:pt>
          <cx:pt idx="443">Beatmung (SAP, 21 FALL)</cx:pt>
          <cx:pt idx="444">Beatmung (SAP, 21 FALL)</cx:pt>
          <cx:pt idx="445">Beatmung (SAP, 21 FALL)</cx:pt>
          <cx:pt idx="446">Beatmung (SAP, 21 FALL)</cx:pt>
          <cx:pt idx="447">Beatmung (SAP, 21 FALL)</cx:pt>
          <cx:pt idx="448">Beatmung (SAP, 21 FALL)</cx:pt>
          <cx:pt idx="449">Beatmung (SAP, 21 FALL)</cx:pt>
          <cx:pt idx="450">Beatmung (SAP, 21 FALL)</cx:pt>
          <cx:pt idx="451">Beatmung (SAP, 21 FALL)</cx:pt>
          <cx:pt idx="452">Beatmung (SAP, 21 FALL)</cx:pt>
          <cx:pt idx="453">Beatmung (SAP, 21 FALL)</cx:pt>
          <cx:pt idx="454">Beatmung (SAP, 21 FALL)</cx:pt>
          <cx:pt idx="455">Beatmung (SAP, 21 FALL)</cx:pt>
          <cx:pt idx="456">Beatmung (SAP, 21 FALL)</cx:pt>
          <cx:pt idx="457">Beatmung (SAP, 21 FALL)</cx:pt>
          <cx:pt idx="458">Beatmung (SAP, 21 FALL)</cx:pt>
          <cx:pt idx="459">Beatmung (SAP, 21 FALL)</cx:pt>
          <cx:pt idx="460">Beatmung (SAP, 21 FALL)</cx:pt>
          <cx:pt idx="461">Beatmung (SAP, 21 FALL)</cx:pt>
          <cx:pt idx="462">Beatmung (SAP, 21 FALL)</cx:pt>
          <cx:pt idx="463">Beatmung (SAP, 21 FALL)</cx:pt>
          <cx:pt idx="464">Beatmung (SAP, 21 FALL)</cx:pt>
          <cx:pt idx="465">Beatmung (SAP, 21 FALL)</cx:pt>
          <cx:pt idx="466">Beatmung (SAP, 21 FALL)</cx:pt>
          <cx:pt idx="467">Beatmung (SAP, 21 FALL)</cx:pt>
          <cx:pt idx="468">Beatmung (SAP, 21 FALL)</cx:pt>
          <cx:pt idx="469">Beatmung (SAP, 21 FALL)</cx:pt>
          <cx:pt idx="470">Beatmung (SAP, 21 FALL)</cx:pt>
          <cx:pt idx="471">Beatmung (SAP, 21 FALL)</cx:pt>
          <cx:pt idx="472">Beatmung (SAP, 21 FALL)</cx:pt>
          <cx:pt idx="473">Beatmung (SAP, 21 FALL)</cx:pt>
          <cx:pt idx="474">Beatmung (SAP, 21 FALL)</cx:pt>
          <cx:pt idx="475">Beatmung (SAP, 21 FALL)</cx:pt>
          <cx:pt idx="476">Beatmung (SAP, 21 FALL)</cx:pt>
          <cx:pt idx="477">Beatmung (SAP, 21 FALL)</cx:pt>
          <cx:pt idx="478">Beatmung (SAP, 21 FALL)</cx:pt>
          <cx:pt idx="479">Beatmung (SAP, 21 FALL)</cx:pt>
          <cx:pt idx="480">Beatmung (SAP, 21 FALL)</cx:pt>
          <cx:pt idx="481">Beatmung (SAP, 21 FALL)</cx:pt>
          <cx:pt idx="482">Beatmung (SAP, 21 FALL)</cx:pt>
          <cx:pt idx="483">Beatmung (SAP, 21 FALL)</cx:pt>
          <cx:pt idx="484">Beatmung (SAP, 21 FALL)</cx:pt>
          <cx:pt idx="485">Beatmung (SAP, 21 FALL)</cx:pt>
          <cx:pt idx="486">Beatmung (SAP, 21 FALL)</cx:pt>
          <cx:pt idx="487">Beatmung (SAP, 21 FALL)</cx:pt>
          <cx:pt idx="488">Beatmung (SAP, 21 FALL)</cx:pt>
          <cx:pt idx="489">Beatmung (SAP, 21 FALL)</cx:pt>
          <cx:pt idx="490">Beatmung (SAP, 21 FALL)</cx:pt>
          <cx:pt idx="491">Beatmung (SAP, 21 FALL)</cx:pt>
          <cx:pt idx="492">Beatmung (SAP, 21 FALL)</cx:pt>
          <cx:pt idx="493">Beatmung (SAP, 21 FALL)</cx:pt>
          <cx:pt idx="494">Beatmung (SAP, 21 FALL)</cx:pt>
          <cx:pt idx="495">Beatmung (SAP, 21 FALL)</cx:pt>
          <cx:pt idx="496">Beatmung (SAP, 21 FALL)</cx:pt>
          <cx:pt idx="497">Beatmung (SAP, 21 FALL)</cx:pt>
          <cx:pt idx="498">Beatmung (SAP, 21 FALL)</cx:pt>
          <cx:pt idx="499">Beatmung (SAP, 21 FALL)</cx:pt>
          <cx:pt idx="500">Beatmung (SAP, 21 FALL)</cx:pt>
          <cx:pt idx="501">Beatmung (SAP, 21 FALL)</cx:pt>
          <cx:pt idx="502">Beatmung (SAP, 21 FALL)</cx:pt>
          <cx:pt idx="503">Beatmung (SAP, 21 FALL)</cx:pt>
          <cx:pt idx="504">Beatmung (SAP, 21 FALL)</cx:pt>
          <cx:pt idx="505">Beatmung (SAP, 21 FALL)</cx:pt>
          <cx:pt idx="506">Beatmung (SAP, 21 FALL)</cx:pt>
          <cx:pt idx="507">Beatmung (SAP, 21 FALL)</cx:pt>
          <cx:pt idx="508">Beatmung (SAP, 21 FALL)</cx:pt>
          <cx:pt idx="509">Beatmung (SAP, 21 FALL)</cx:pt>
          <cx:pt idx="510">Beatmung (SAP, 21 FALL)</cx:pt>
          <cx:pt idx="511">Beatmung (SAP, 21 FALL)</cx:pt>
          <cx:pt idx="512">Beatmung (SAP, 21 FALL)</cx:pt>
          <cx:pt idx="513">Beatmung (SAP, 21 FALL)</cx:pt>
          <cx:pt idx="514">Beatmung (SAP, 21 FALL)</cx:pt>
          <cx:pt idx="515">Beatmung (SAP, 21 FALL)</cx:pt>
          <cx:pt idx="516">Beatmung (SAP, 21 FALL)</cx:pt>
          <cx:pt idx="517">Beatmung (SAP, 21 FALL)</cx:pt>
          <cx:pt idx="518">Beatmung (SAP, 21 FALL)</cx:pt>
          <cx:pt idx="519">Beatmung (SAP, 21 FALL)</cx:pt>
          <cx:pt idx="520">Beatmung (SAP, 21 FALL)</cx:pt>
          <cx:pt idx="521">Beatmung (SAP, 21 FALL)</cx:pt>
          <cx:pt idx="522">Beatmung (SAP, 21 FALL)</cx:pt>
          <cx:pt idx="523">Beatmung (SAP, 21 FALL)</cx:pt>
          <cx:pt idx="524">Beatmung (SAP, 21 FALL)</cx:pt>
          <cx:pt idx="525">Beatmung (SAP, 21 FALL)</cx:pt>
          <cx:pt idx="526">Beatmung (SAP, 21 FALL)</cx:pt>
          <cx:pt idx="527">Beatmung (SAP, 21 FALL)</cx:pt>
          <cx:pt idx="528">Beatmung (SAP, 21 FALL)</cx:pt>
          <cx:pt idx="529">Beatmung (SAP, 21 FALL)</cx:pt>
          <cx:pt idx="530">Beatmung (SAP, 21 FALL)</cx:pt>
          <cx:pt idx="531">Beatmung (SAP, 21 FALL)</cx:pt>
          <cx:pt idx="532">Beatmung (SAP, 21 FALL)</cx:pt>
          <cx:pt idx="533">Beatmung (SAP, 21 FALL)</cx:pt>
          <cx:pt idx="534">Beatmung (SAP, 21 FALL)</cx:pt>
          <cx:pt idx="535">Beatmung (SAP, 21 FALL)</cx:pt>
          <cx:pt idx="536">Beatmung (SAP, 21 FALL)</cx:pt>
          <cx:pt idx="537">Beatmung (SAP, 21 FALL)</cx:pt>
          <cx:pt idx="538">Beatmung (SAP, 21 FALL)</cx:pt>
          <cx:pt idx="539">Beatmung (SAP, 21 FALL)</cx:pt>
          <cx:pt idx="540">Beatmung (SAP, 21 FALL)</cx:pt>
          <cx:pt idx="541">Beatmung (SAP, 21 FALL)</cx:pt>
          <cx:pt idx="542">Beatmung (SAP, 21 FALL)</cx:pt>
          <cx:pt idx="543">Beatmung (SAP, 21 FALL)</cx:pt>
          <cx:pt idx="544">Beatmung (SAP, 21 FALL)</cx:pt>
          <cx:pt idx="545">Beatmung (SAP, 21 FALL)</cx:pt>
          <cx:pt idx="546">Beatmung (SAP, 21 FALL)</cx:pt>
          <cx:pt idx="547">Beatmung (SAP, 21 FALL)</cx:pt>
          <cx:pt idx="548">Beatmung (SAP, 21 FALL)</cx:pt>
          <cx:pt idx="549">Beatmung (SAP, 21 FALL)</cx:pt>
          <cx:pt idx="550">Beatmung (SAP, 21 FALL)</cx:pt>
          <cx:pt idx="551">Beatmung (SAP, 21 FALL)</cx:pt>
          <cx:pt idx="552">Beatmung (SAP, 21 FALL)</cx:pt>
          <cx:pt idx="553">Beatmung (SAP, 21 FALL)</cx:pt>
          <cx:pt idx="554">Beatmung (SAP, 21 FALL)</cx:pt>
          <cx:pt idx="555">Beatmung (SAP, 21 FALL)</cx:pt>
          <cx:pt idx="556">Beatmung (SAP, 21 FALL)</cx:pt>
          <cx:pt idx="557">Beatmung (SAP, 21 FALL)</cx:pt>
          <cx:pt idx="558">Beatmung (SAP, 21 FALL)</cx:pt>
          <cx:pt idx="559">Beatmung (SAP, 21 FALL)</cx:pt>
          <cx:pt idx="560">Beatmung (SAP, 21 FALL)</cx:pt>
          <cx:pt idx="561">Beatmung (SAP, 21 FALL)</cx:pt>
          <cx:pt idx="562">Beatmung (SAP, 21 FALL)</cx:pt>
          <cx:pt idx="563">Beatmung (SAP, 21 FALL)</cx:pt>
          <cx:pt idx="564">Beatmung (SAP, 21 FALL)</cx:pt>
          <cx:pt idx="565">Beatmung (SAP, 21 FALL)</cx:pt>
          <cx:pt idx="566">Beatmung (SAP, 21 FALL)</cx:pt>
          <cx:pt idx="567">Beatmung (SAP, 21 FALL)</cx:pt>
          <cx:pt idx="568">Beatmung (SAP, 21 FALL)</cx:pt>
          <cx:pt idx="569">Beatmung (SAP, 21 FALL)</cx:pt>
          <cx:pt idx="570">Beatmung (SAP, 21 FALL)</cx:pt>
          <cx:pt idx="571">Beatmung (SAP, 21 FALL)</cx:pt>
          <cx:pt idx="572">Beatmung (SAP, 21 FALL)</cx:pt>
          <cx:pt idx="573">Beatmung (SAP, 21 FALL)</cx:pt>
          <cx:pt idx="574">Beatmung (SAP, 21 FALL)</cx:pt>
          <cx:pt idx="575">Beatmung (SAP, 21 FALL)</cx:pt>
          <cx:pt idx="576">Beatmung (SAP, 21 FALL)</cx:pt>
          <cx:pt idx="577">Beatmung (SAP, 21 FALL)</cx:pt>
          <cx:pt idx="578">Beatmung (SAP, 21 FALL)</cx:pt>
          <cx:pt idx="579">Beatmung (SAP, 21 FALL)</cx:pt>
          <cx:pt idx="580">Beatmung (SAP, 21 FALL)</cx:pt>
          <cx:pt idx="581">Beatmung (SAP, 21 FALL)</cx:pt>
          <cx:pt idx="582">Beatmung (SAP, 21 FALL)</cx:pt>
          <cx:pt idx="583">Beatmung (SAP, 21 FALL)</cx:pt>
          <cx:pt idx="584">Beatmung (SAP, 21 FALL)</cx:pt>
          <cx:pt idx="585">Beatmung (SAP, 21 FALL)</cx:pt>
          <cx:pt idx="586">Beatmung (SAP, 21 FALL)</cx:pt>
          <cx:pt idx="587">Beatmung (SAP, 21 FALL)</cx:pt>
          <cx:pt idx="588">Beatmung (SAP, 21 FALL)</cx:pt>
          <cx:pt idx="589">Beatmung (SAP, 21 FALL)</cx:pt>
          <cx:pt idx="590">Beatmung (SAP, 21 FALL)</cx:pt>
          <cx:pt idx="591">Beatmung (SAP, 21 FALL)</cx:pt>
          <cx:pt idx="592">Beatmung (SAP, 21 FALL)</cx:pt>
          <cx:pt idx="593">Beatmung (SAP, 21 FALL)</cx:pt>
          <cx:pt idx="594">Beatmung (SAP, 21 FALL)</cx:pt>
          <cx:pt idx="595">Beatmung (SAP, 21 FALL)</cx:pt>
          <cx:pt idx="596">Beatmung (SAP, 21 FALL)</cx:pt>
          <cx:pt idx="597">Beatmung (SAP, 21 FALL)</cx:pt>
          <cx:pt idx="598">Beatmung (SAP, 21 FALL)</cx:pt>
          <cx:pt idx="599">Beatmung (SAP, 21 FALL)</cx:pt>
          <cx:pt idx="600">Beatmung (SAP, 21 FALL)</cx:pt>
          <cx:pt idx="601">Beatmung (SAP, 21 FALL)</cx:pt>
          <cx:pt idx="602">Beatmung (SAP, 21 FALL)</cx:pt>
          <cx:pt idx="603">Beatmung (SAP, 21 FALL)</cx:pt>
          <cx:pt idx="604">Beatmung (SAP, 21 FALL)</cx:pt>
          <cx:pt idx="605">Beatmung (SAP, 21 FALL)</cx:pt>
          <cx:pt idx="606">Beatmung (SAP, 21 FALL)</cx:pt>
          <cx:pt idx="607">Beatmung (SAP, 21 FALL)</cx:pt>
          <cx:pt idx="608">Beatmung (SAP, 21 FALL)</cx:pt>
          <cx:pt idx="609">Beatmung (SAP, 21 FALL)</cx:pt>
          <cx:pt idx="610">Beatmung (SAP, 21 FALL)</cx:pt>
          <cx:pt idx="611">Beatmung (SAP, 21 FALL)</cx:pt>
          <cx:pt idx="612">Beatmung (SAP, 21 FALL)</cx:pt>
          <cx:pt idx="613">Beatmung (SAP, 21 FALL)</cx:pt>
          <cx:pt idx="614">Beatmung (SAP, 21 FALL)</cx:pt>
          <cx:pt idx="615">Beatmung (SAP, 21 FALL)</cx:pt>
          <cx:pt idx="616">Beatmung (SAP, 21 FALL)</cx:pt>
          <cx:pt idx="617">Beatmung (SAP, 21 FALL)</cx:pt>
          <cx:pt idx="618">Beatmung (SAP, 21 FALL)</cx:pt>
          <cx:pt idx="619">Beatmung (SAP, 21 FALL)</cx:pt>
          <cx:pt idx="620">Beatmung (SAP, 21 FALL)</cx:pt>
          <cx:pt idx="621">Beatmung (SAP, 21 FALL)</cx:pt>
          <cx:pt idx="622">Beatmung (SAP, 21 FALL)</cx:pt>
          <cx:pt idx="623">Beatmung (SAP, 21 FALL)</cx:pt>
          <cx:pt idx="624">Beatmung (SAP, 21 FALL)</cx:pt>
          <cx:pt idx="625">Beatmung (SAP, 21 FALL)</cx:pt>
          <cx:pt idx="626">Beatmung (SAP, 21 FALL)</cx:pt>
          <cx:pt idx="627">Beatmung (SAP, 21 FALL)</cx:pt>
          <cx:pt idx="628">Beatmung (SAP, 21 FALL)</cx:pt>
          <cx:pt idx="629">Beatmung (SAP, 21 FALL)</cx:pt>
          <cx:pt idx="630">Beatmung (SAP, 21 FALL)</cx:pt>
          <cx:pt idx="631">Beatmung (SAP, 21 FALL)</cx:pt>
          <cx:pt idx="632">Beatmung (SAP, 21 FALL)</cx:pt>
          <cx:pt idx="633">Beatmung (SAP, 21 FALL)</cx:pt>
          <cx:pt idx="634">Beatmung (SAP, 21 FALL)</cx:pt>
          <cx:pt idx="635">Beatmung (SAP, 21 FALL)</cx:pt>
          <cx:pt idx="636">Beatmung (SAP, 21 FALL)</cx:pt>
          <cx:pt idx="637">Beatmung (SAP, 21 FALL)</cx:pt>
          <cx:pt idx="638">Beatmung (SAP, 21 FALL)</cx:pt>
          <cx:pt idx="639">Beatmung (SAP, 21 FALL)</cx:pt>
          <cx:pt idx="640">Beatmung (SAP, 21 FALL)</cx:pt>
          <cx:pt idx="641">Beatmung (SAP, 21 FALL)</cx:pt>
          <cx:pt idx="642">Beatmung (SAP, 21 FALL)</cx:pt>
          <cx:pt idx="643">Beatmung (SAP, 21 FALL)</cx:pt>
          <cx:pt idx="644">Beatmung (SAP, 21 FALL)</cx:pt>
          <cx:pt idx="645">Beatmung (SAP, 21 FALL)</cx:pt>
          <cx:pt idx="646">Beatmung (SAP, 21 FALL)</cx:pt>
          <cx:pt idx="647">Beatmung (SAP, 21 FALL)</cx:pt>
          <cx:pt idx="648">Beatmung (SAP, 21 FALL)</cx:pt>
          <cx:pt idx="649">Beatmung (SAP, 21 FALL)</cx:pt>
          <cx:pt idx="650">Beatmung (SAP, 21 FALL)</cx:pt>
          <cx:pt idx="651">Beatmung (SAP, 21 FALL)</cx:pt>
          <cx:pt idx="652">Beatmung (SAP, 21 FALL)</cx:pt>
          <cx:pt idx="653">Beatmung (SAP, 21 FALL)</cx:pt>
          <cx:pt idx="654">Beatmung (SAP, 21 FALL)</cx:pt>
          <cx:pt idx="655">Beatmung (SAP, 21 FALL)</cx:pt>
          <cx:pt idx="656">Beatmung (SAP, 21 FALL)</cx:pt>
          <cx:pt idx="657">Beatmung (SAP, 21 FALL)</cx:pt>
          <cx:pt idx="658">Beatmung (SAP, 21 FALL)</cx:pt>
          <cx:pt idx="659">Beatmung (SAP, 21 FALL)</cx:pt>
          <cx:pt idx="660">Beatmung (SAP, 21 FALL)</cx:pt>
          <cx:pt idx="661">Beatmung (SAP, 21 FALL)</cx:pt>
          <cx:pt idx="662">Beatmung (SAP, 21 FALL)</cx:pt>
          <cx:pt idx="663">Beatmung (SAP, 21 FALL)</cx:pt>
          <cx:pt idx="664">Beatmung (SAP, 21 FALL)</cx:pt>
          <cx:pt idx="665">Beatmung (SAP, 21 FALL)</cx:pt>
          <cx:pt idx="666">Beatmung (SAP, 21 FALL)</cx:pt>
          <cx:pt idx="667">Beatmung (SAP, 21 FALL)</cx:pt>
          <cx:pt idx="668">Beatmung (SAP, 21 FALL)</cx:pt>
          <cx:pt idx="669">Beatmung (SAP, 21 FALL)</cx:pt>
          <cx:pt idx="670">Beatmung (SAP, 21 FALL)</cx:pt>
          <cx:pt idx="671">Beatmung (SAP, 21 FALL)</cx:pt>
          <cx:pt idx="672">Beatmung (SAP, 21 FALL)</cx:pt>
          <cx:pt idx="673">Beatmung (SAP, 21 FALL)</cx:pt>
          <cx:pt idx="674">Beatmung (SAP, 21 FALL)</cx:pt>
          <cx:pt idx="675">Beatmung (SAP, 21 FALL)</cx:pt>
          <cx:pt idx="676">Beatmung (SAP, 21 FALL)</cx:pt>
          <cx:pt idx="677">Beatmung (SAP, 21 FALL)</cx:pt>
          <cx:pt idx="678">Beatmung (SAP, 21 FALL)</cx:pt>
          <cx:pt idx="679">Beatmung (SAP, 21 FALL)</cx:pt>
          <cx:pt idx="680">Beatmung (SAP, 21 FALL)</cx:pt>
          <cx:pt idx="681">Beatmung (SAP, 21 FALL)</cx:pt>
          <cx:pt idx="682">Beatmung (SAP, 21 FALL)</cx:pt>
          <cx:pt idx="683">Beatmung (SAP, 21 FALL)</cx:pt>
          <cx:pt idx="684">Beatmung (SAP, 21 FALL)</cx:pt>
          <cx:pt idx="685">Beatmung (SAP, 21 FALL)</cx:pt>
          <cx:pt idx="686">Beatmung (SAP, 21 FALL)</cx:pt>
          <cx:pt idx="687">Beatmung (SAP, 21 FALL)</cx:pt>
          <cx:pt idx="688">Beatmung (SAP, 21 FALL)</cx:pt>
          <cx:pt idx="689">Beatmung (SAP, 21 FALL)</cx:pt>
          <cx:pt idx="690">Beatmung (SAP, 21 FALL)</cx:pt>
          <cx:pt idx="691">Beatmung (SAP, 21 FALL)</cx:pt>
          <cx:pt idx="692">Beatmung (SAP, 21 FALL)</cx:pt>
          <cx:pt idx="693">Beatmung (SAP, 21 FALL)</cx:pt>
          <cx:pt idx="694">Beatmung (SAP, 21 FALL)</cx:pt>
          <cx:pt idx="695">Beatmung (SAP, 21 FALL)</cx:pt>
          <cx:pt idx="696">Beatmung (SAP, 21 FALL)</cx:pt>
          <cx:pt idx="697">Beatmung (SAP, 21 FALL)</cx:pt>
          <cx:pt idx="698">Beatmung (SAP, 21 FALL)</cx:pt>
          <cx:pt idx="699">Beatmung (SAP, 21 FALL)</cx:pt>
          <cx:pt idx="700">Beatmung (SAP, 21 FALL)</cx:pt>
          <cx:pt idx="701">Beatmung (SAP, 21 FALL)</cx:pt>
          <cx:pt idx="702">Beatmung (SAP, 21 FALL)</cx:pt>
          <cx:pt idx="703">Beatmung (SAP, 21 FALL)</cx:pt>
          <cx:pt idx="704">Beatmung (SAP, 21 FALL)</cx:pt>
          <cx:pt idx="705">Beatmung (SAP, 21 FALL)</cx:pt>
          <cx:pt idx="706">Beatmung (SAP, 21 FALL)</cx:pt>
          <cx:pt idx="707">Beatmung (SAP, 21 FALL)</cx:pt>
          <cx:pt idx="708">Beatmung (SAP, 21 FALL)</cx:pt>
          <cx:pt idx="709">Beatmung (SAP, 21 FALL)</cx:pt>
          <cx:pt idx="710">Beatmung (SAP, 21 FALL)</cx:pt>
          <cx:pt idx="711">Beatmung (SAP, 21 FALL)</cx:pt>
          <cx:pt idx="712">Beatmung (SAP, 21 FALL)</cx:pt>
          <cx:pt idx="713">Beatmung (SAP, 21 FALL)</cx:pt>
          <cx:pt idx="714">Beatmung (SAP, 21 FALL)</cx:pt>
          <cx:pt idx="715">Beatmung (SAP, 21 FALL)</cx:pt>
          <cx:pt idx="716">Beatmung (SAP, 21 FALL)</cx:pt>
          <cx:pt idx="717">Beatmung (SAP, 21 FALL)</cx:pt>
          <cx:pt idx="718">Beatmung (SAP, 21 FALL)</cx:pt>
          <cx:pt idx="719">Beatmung (SAP, 21 FALL)</cx:pt>
          <cx:pt idx="720">Beatmung (SAP, 21 FALL)</cx:pt>
          <cx:pt idx="721">Beatmung (SAP, 21 FALL)</cx:pt>
          <cx:pt idx="722">Beatmung (SAP, 21 FALL)</cx:pt>
          <cx:pt idx="723">Beatmung (SAP, 21 FALL)</cx:pt>
          <cx:pt idx="724">Beatmung (SAP, 21 FALL)</cx:pt>
          <cx:pt idx="725">Beatmung (SAP, 21 FALL)</cx:pt>
          <cx:pt idx="726">Beatmung (SAP, 21 FALL)</cx:pt>
          <cx:pt idx="727">Beatmung (SAP, 21 FALL)</cx:pt>
          <cx:pt idx="728">Beatmung (SAP, 21 FALL)</cx:pt>
          <cx:pt idx="729">Beatmung (SAP, 21 FALL)</cx:pt>
          <cx:pt idx="730">Beatmung (SAP, 21 FALL)</cx:pt>
          <cx:pt idx="731">Beatmung (SAP, 21 FALL)</cx:pt>
          <cx:pt idx="732">Beatmung (SAP, 21 FALL)</cx:pt>
          <cx:pt idx="733">Beatmung (SAP, 21 FALL)</cx:pt>
          <cx:pt idx="734">Beatmung (SAP, 21 FALL)</cx:pt>
          <cx:pt idx="735">Beatmung (SAP, 21 FALL)</cx:pt>
          <cx:pt idx="736">Beatmung (SAP, 21 FALL)</cx:pt>
          <cx:pt idx="737">Beatmung (SAP, 21 FALL)</cx:pt>
          <cx:pt idx="738">Beatmung (SAP, 21 FALL)</cx:pt>
          <cx:pt idx="739">Beatmung (SAP, 21 FALL)</cx:pt>
          <cx:pt idx="740">Beatmung (SAP, 21 FALL)</cx:pt>
          <cx:pt idx="741">Beatmung (SAP, 21 FALL)</cx:pt>
          <cx:pt idx="742">Beatmung (SAP, 21 FALL)</cx:pt>
          <cx:pt idx="743">Beatmung (SAP, 21 FALL)</cx:pt>
          <cx:pt idx="744">Beatmung (SAP, 21 FALL)</cx:pt>
          <cx:pt idx="745">Beatmung (SAP, 21 FALL)</cx:pt>
          <cx:pt idx="746">Beatmung (SAP, 21 FALL)</cx:pt>
          <cx:pt idx="747">Beatmung (SAP, 21 FALL)</cx:pt>
          <cx:pt idx="748">Beatmung (SAP, 21 FALL)</cx:pt>
          <cx:pt idx="749">Beatmung (SAP, 21 FALL)</cx:pt>
          <cx:pt idx="750">Beatmung (SAP, 21 FALL)</cx:pt>
          <cx:pt idx="751">Beatmung (SAP, 21 FALL)</cx:pt>
          <cx:pt idx="752">Beatmung (SAP, 21 FALL)</cx:pt>
          <cx:pt idx="753">Beatmung (SAP, 21 FALL)</cx:pt>
          <cx:pt idx="754">Beatmung (SAP, 21 FALL)</cx:pt>
          <cx:pt idx="755">Beatmung (SAP, 21 FALL)</cx:pt>
          <cx:pt idx="756">Beatmung (SAP, 21 FALL)</cx:pt>
          <cx:pt idx="757">Beatmung (SAP, 21 FALL)</cx:pt>
          <cx:pt idx="758">Beatmung (SAP, 21 FALL)</cx:pt>
          <cx:pt idx="759">Beatmung (SAP, 21 FALL)</cx:pt>
          <cx:pt idx="760">Beatmung (SAP, 21 FALL)</cx:pt>
          <cx:pt idx="761">Beatmung (SAP, 21 FALL)</cx:pt>
          <cx:pt idx="762">Beatmung (SAP, 21 FALL)</cx:pt>
          <cx:pt idx="763">Beatmung (SAP, 21 FALL)</cx:pt>
          <cx:pt idx="764">Beatmung (SAP, 21 FALL)</cx:pt>
          <cx:pt idx="765">Beatmung (SAP, 21 FALL)</cx:pt>
          <cx:pt idx="766">Beatmung (SAP, 21 FALL)</cx:pt>
          <cx:pt idx="767">Beatmung (SAP, 21 FALL)</cx:pt>
          <cx:pt idx="768">Beatmung (SAP, 21 FALL)</cx:pt>
          <cx:pt idx="769">Beatmung (SAP, 21 FALL)</cx:pt>
          <cx:pt idx="770">Beatmung (SAP, 21 FALL)</cx:pt>
          <cx:pt idx="771">Beatmung (SAP, 21 FALL)</cx:pt>
          <cx:pt idx="772">Beatmung (SAP, 21 FALL)</cx:pt>
          <cx:pt idx="773">Beatmung (SAP, 21 FALL)</cx:pt>
          <cx:pt idx="774">Beatmung (SAP, 21 FALL)</cx:pt>
          <cx:pt idx="775">Beatmung (SAP, 21 FALL)</cx:pt>
          <cx:pt idx="776">Beatmung (SAP, 21 FALL)</cx:pt>
          <cx:pt idx="777">Beatmung (SAP, 21 FALL)</cx:pt>
          <cx:pt idx="778">Beatmung (SAP, 21 FALL)</cx:pt>
          <cx:pt idx="779">Beatmung (SAP, 21 FALL)</cx:pt>
          <cx:pt idx="780">Beatmung (SAP, 21 FALL)</cx:pt>
          <cx:pt idx="781">Beatmung (SAP, 21 FALL)</cx:pt>
          <cx:pt idx="782">Beatmung (SAP, 21 FALL)</cx:pt>
          <cx:pt idx="783">Beatmung (SAP, 21 FALL)</cx:pt>
          <cx:pt idx="784">Beatmung (SAP, 21 FALL)</cx:pt>
          <cx:pt idx="785">Beatmung (SAP, 21 FALL)</cx:pt>
          <cx:pt idx="786">Beatmung (SAP, 21 FALL)</cx:pt>
          <cx:pt idx="787">Beatmung (SAP, 21 FALL)</cx:pt>
          <cx:pt idx="788">Beatmung (SAP, 21 FALL)</cx:pt>
          <cx:pt idx="789">Beatmung (SAP, 21 FALL)</cx:pt>
          <cx:pt idx="790">Beatmung (SAP, 21 FALL)</cx:pt>
          <cx:pt idx="791">Beatmung (SAP, 21 FALL)</cx:pt>
          <cx:pt idx="792">Beatmung (SAP, 21 FALL)</cx:pt>
          <cx:pt idx="793">Beatmung (SAP, 21 FALL)</cx:pt>
          <cx:pt idx="794">Beatmung (SAP, 21 FALL)</cx:pt>
          <cx:pt idx="795">Beatmung (SAP, 21 FALL)</cx:pt>
          <cx:pt idx="796">Beatmung (SAP, 21 FALL)</cx:pt>
          <cx:pt idx="797">Beatmung (SAP, 21 FALL)</cx:pt>
          <cx:pt idx="798">Beatmung (SAP, 21 FALL)</cx:pt>
          <cx:pt idx="799">Beatmung (SAP, 21 FALL)</cx:pt>
          <cx:pt idx="800">Beatmung (SAP, 21 FALL)</cx:pt>
          <cx:pt idx="801">Beatmung (SAP, 21 FALL)</cx:pt>
          <cx:pt idx="802">Beatmung (SAP, 21 FALL)</cx:pt>
        </cx:lvl>
      </cx:strDim>
      <cx:numDim type="val">
        <cx:lvl ptCount="803" formatCode="General">
          <cx:pt idx="0">0</cx:pt>
          <cx:pt idx="1">0</cx:pt>
          <cx:pt idx="2">0</cx:pt>
          <cx:pt idx="3">0</cx:pt>
          <cx:pt idx="4">0</cx:pt>
          <cx:pt idx="5">0</cx:pt>
          <cx:pt idx="6">0</cx:pt>
          <cx:pt idx="7">0</cx:pt>
          <cx:pt idx="8">0</cx:pt>
          <cx:pt idx="9">0</cx:pt>
          <cx:pt idx="10">0</cx:pt>
          <cx:pt idx="11">0</cx:pt>
          <cx:pt idx="12">0</cx:pt>
          <cx:pt idx="13">0</cx:pt>
          <cx:pt idx="14">0</cx:pt>
          <cx:pt idx="15">0</cx:pt>
          <cx:pt idx="16">0</cx:pt>
          <cx:pt idx="17">0</cx:pt>
          <cx:pt idx="18">0</cx:pt>
          <cx:pt idx="19">0</cx:pt>
          <cx:pt idx="20">0</cx:pt>
          <cx:pt idx="21">0</cx:pt>
          <cx:pt idx="22">0</cx:pt>
          <cx:pt idx="23">0</cx:pt>
          <cx:pt idx="24">0</cx:pt>
          <cx:pt idx="25">0</cx:pt>
          <cx:pt idx="26">0</cx:pt>
          <cx:pt idx="27">0</cx:pt>
          <cx:pt idx="28">0</cx:pt>
          <cx:pt idx="29">0</cx:pt>
          <cx:pt idx="30">0</cx:pt>
          <cx:pt idx="31">0</cx:pt>
          <cx:pt idx="32">0</cx:pt>
          <cx:pt idx="33">0</cx:pt>
          <cx:pt idx="34">0</cx:pt>
          <cx:pt idx="35">0</cx:pt>
          <cx:pt idx="36">0</cx:pt>
          <cx:pt idx="37">0</cx:pt>
          <cx:pt idx="38">0</cx:pt>
          <cx:pt idx="39">0</cx:pt>
          <cx:pt idx="40">0</cx:pt>
          <cx:pt idx="41">0</cx:pt>
          <cx:pt idx="42">0</cx:pt>
          <cx:pt idx="43">0</cx:pt>
          <cx:pt idx="44">0</cx:pt>
          <cx:pt idx="45">0</cx:pt>
          <cx:pt idx="46">0</cx:pt>
          <cx:pt idx="47">0</cx:pt>
          <cx:pt idx="48">0</cx:pt>
          <cx:pt idx="49">0</cx:pt>
          <cx:pt idx="50">0</cx:pt>
          <cx:pt idx="51">0</cx:pt>
          <cx:pt idx="52">0</cx:pt>
          <cx:pt idx="53">0</cx:pt>
          <cx:pt idx="54">0</cx:pt>
          <cx:pt idx="55">0</cx:pt>
          <cx:pt idx="56">0</cx:pt>
          <cx:pt idx="57">0</cx:pt>
          <cx:pt idx="58">0</cx:pt>
          <cx:pt idx="59">0</cx:pt>
          <cx:pt idx="60">0</cx:pt>
          <cx:pt idx="61">0</cx:pt>
          <cx:pt idx="62">0</cx:pt>
          <cx:pt idx="63">0</cx:pt>
          <cx:pt idx="64">0</cx:pt>
          <cx:pt idx="65">0</cx:pt>
          <cx:pt idx="66">0</cx:pt>
          <cx:pt idx="67">0</cx:pt>
          <cx:pt idx="68">0</cx:pt>
          <cx:pt idx="69">0</cx:pt>
          <cx:pt idx="70">0</cx:pt>
          <cx:pt idx="71">0</cx:pt>
          <cx:pt idx="72">0</cx:pt>
          <cx:pt idx="73">0</cx:pt>
          <cx:pt idx="74">0</cx:pt>
          <cx:pt idx="75">0</cx:pt>
          <cx:pt idx="76">0</cx:pt>
          <cx:pt idx="77">0</cx:pt>
          <cx:pt idx="78">0</cx:pt>
          <cx:pt idx="79">0</cx:pt>
          <cx:pt idx="80">0</cx:pt>
          <cx:pt idx="81">0</cx:pt>
          <cx:pt idx="82">0</cx:pt>
          <cx:pt idx="83">0</cx:pt>
          <cx:pt idx="84">0</cx:pt>
          <cx:pt idx="85">0</cx:pt>
          <cx:pt idx="86">0</cx:pt>
          <cx:pt idx="87">0</cx:pt>
          <cx:pt idx="88">0</cx:pt>
          <cx:pt idx="89">0</cx:pt>
          <cx:pt idx="90">0</cx:pt>
          <cx:pt idx="91">0</cx:pt>
          <cx:pt idx="92">0</cx:pt>
          <cx:pt idx="93">0</cx:pt>
          <cx:pt idx="94">0</cx:pt>
          <cx:pt idx="95">0</cx:pt>
          <cx:pt idx="96">0</cx:pt>
          <cx:pt idx="97">0</cx:pt>
          <cx:pt idx="98">0</cx:pt>
          <cx:pt idx="99">0</cx:pt>
          <cx:pt idx="100">0</cx:pt>
          <cx:pt idx="101">0</cx:pt>
          <cx:pt idx="102">0</cx:pt>
          <cx:pt idx="103">0</cx:pt>
          <cx:pt idx="104">0</cx:pt>
          <cx:pt idx="105">0</cx:pt>
          <cx:pt idx="106">0</cx:pt>
          <cx:pt idx="107">0</cx:pt>
          <cx:pt idx="108">0</cx:pt>
          <cx:pt idx="109">0</cx:pt>
          <cx:pt idx="110">0</cx:pt>
          <cx:pt idx="111">0</cx:pt>
          <cx:pt idx="112">0</cx:pt>
          <cx:pt idx="113">0</cx:pt>
          <cx:pt idx="114">0</cx:pt>
          <cx:pt idx="115">0</cx:pt>
          <cx:pt idx="116">0</cx:pt>
          <cx:pt idx="117">0</cx:pt>
          <cx:pt idx="118">0</cx:pt>
          <cx:pt idx="119">0</cx:pt>
          <cx:pt idx="120">0</cx:pt>
          <cx:pt idx="121">0</cx:pt>
          <cx:pt idx="122">0</cx:pt>
          <cx:pt idx="123">0</cx:pt>
          <cx:pt idx="124">0</cx:pt>
          <cx:pt idx="125">0</cx:pt>
          <cx:pt idx="126">0</cx:pt>
          <cx:pt idx="127">0</cx:pt>
          <cx:pt idx="128">0</cx:pt>
          <cx:pt idx="129">0</cx:pt>
          <cx:pt idx="130">0</cx:pt>
          <cx:pt idx="131">0</cx:pt>
          <cx:pt idx="132">0</cx:pt>
          <cx:pt idx="133">0</cx:pt>
          <cx:pt idx="134">0</cx:pt>
          <cx:pt idx="135">0</cx:pt>
          <cx:pt idx="136">0</cx:pt>
          <cx:pt idx="137">0</cx:pt>
          <cx:pt idx="138">0</cx:pt>
          <cx:pt idx="139">0</cx:pt>
          <cx:pt idx="140">0</cx:pt>
          <cx:pt idx="141">0</cx:pt>
          <cx:pt idx="142">0</cx:pt>
          <cx:pt idx="143">0</cx:pt>
          <cx:pt idx="144">0</cx:pt>
          <cx:pt idx="145">0</cx:pt>
          <cx:pt idx="146">0</cx:pt>
          <cx:pt idx="147">0</cx:pt>
          <cx:pt idx="148">0</cx:pt>
          <cx:pt idx="149">0</cx:pt>
          <cx:pt idx="150">0</cx:pt>
          <cx:pt idx="151">0</cx:pt>
          <cx:pt idx="152">0</cx:pt>
          <cx:pt idx="153">0</cx:pt>
          <cx:pt idx="154">0</cx:pt>
          <cx:pt idx="155">0</cx:pt>
          <cx:pt idx="156">0</cx:pt>
          <cx:pt idx="157">0</cx:pt>
          <cx:pt idx="158">0</cx:pt>
          <cx:pt idx="159">0</cx:pt>
          <cx:pt idx="160">0</cx:pt>
          <cx:pt idx="161">0</cx:pt>
          <cx:pt idx="162">0</cx:pt>
          <cx:pt idx="163">0</cx:pt>
          <cx:pt idx="164">0</cx:pt>
          <cx:pt idx="165">0</cx:pt>
          <cx:pt idx="166">0</cx:pt>
          <cx:pt idx="167">0</cx:pt>
          <cx:pt idx="168">0</cx:pt>
          <cx:pt idx="169">0</cx:pt>
          <cx:pt idx="170">0</cx:pt>
          <cx:pt idx="171">0</cx:pt>
          <cx:pt idx="172">0</cx:pt>
          <cx:pt idx="173">0</cx:pt>
          <cx:pt idx="174">0</cx:pt>
          <cx:pt idx="175">0</cx:pt>
          <cx:pt idx="176">0</cx:pt>
          <cx:pt idx="177">0</cx:pt>
          <cx:pt idx="178">0</cx:pt>
          <cx:pt idx="179">0</cx:pt>
          <cx:pt idx="180">0</cx:pt>
          <cx:pt idx="181">0</cx:pt>
          <cx:pt idx="182">0</cx:pt>
          <cx:pt idx="183">0</cx:pt>
          <cx:pt idx="184">0</cx:pt>
          <cx:pt idx="185">0</cx:pt>
          <cx:pt idx="186">0</cx:pt>
          <cx:pt idx="187">0</cx:pt>
          <cx:pt idx="188">0</cx:pt>
          <cx:pt idx="189">0</cx:pt>
          <cx:pt idx="190">0</cx:pt>
          <cx:pt idx="191">0</cx:pt>
          <cx:pt idx="192">0</cx:pt>
          <cx:pt idx="193">0</cx:pt>
          <cx:pt idx="194">0</cx:pt>
          <cx:pt idx="195">0</cx:pt>
          <cx:pt idx="196">0</cx:pt>
          <cx:pt idx="197">0</cx:pt>
          <cx:pt idx="198">0</cx:pt>
          <cx:pt idx="199">0</cx:pt>
          <cx:pt idx="200">0</cx:pt>
          <cx:pt idx="201">0</cx:pt>
          <cx:pt idx="202">0</cx:pt>
          <cx:pt idx="203">0</cx:pt>
          <cx:pt idx="204">0</cx:pt>
          <cx:pt idx="205">0</cx:pt>
          <cx:pt idx="206">0</cx:pt>
          <cx:pt idx="207">0</cx:pt>
          <cx:pt idx="208">0</cx:pt>
          <cx:pt idx="209">0</cx:pt>
          <cx:pt idx="210">0</cx:pt>
          <cx:pt idx="211">0</cx:pt>
          <cx:pt idx="212">0</cx:pt>
          <cx:pt idx="213">0</cx:pt>
          <cx:pt idx="214">0</cx:pt>
          <cx:pt idx="215">0</cx:pt>
          <cx:pt idx="216">0</cx:pt>
          <cx:pt idx="217">0</cx:pt>
          <cx:pt idx="218">0</cx:pt>
          <cx:pt idx="219">0</cx:pt>
          <cx:pt idx="220">0</cx:pt>
          <cx:pt idx="221">0</cx:pt>
          <cx:pt idx="222">0</cx:pt>
          <cx:pt idx="223">0</cx:pt>
          <cx:pt idx="224">0</cx:pt>
          <cx:pt idx="225">0</cx:pt>
          <cx:pt idx="226">0</cx:pt>
          <cx:pt idx="227">0</cx:pt>
          <cx:pt idx="228">0</cx:pt>
          <cx:pt idx="229">0</cx:pt>
          <cx:pt idx="230">0</cx:pt>
          <cx:pt idx="231">0</cx:pt>
          <cx:pt idx="232">0</cx:pt>
          <cx:pt idx="233">0</cx:pt>
          <cx:pt idx="234">0</cx:pt>
          <cx:pt idx="235">0</cx:pt>
          <cx:pt idx="236">0</cx:pt>
          <cx:pt idx="237">0</cx:pt>
          <cx:pt idx="238">1</cx:pt>
          <cx:pt idx="239">1</cx:pt>
          <cx:pt idx="240">1</cx:pt>
          <cx:pt idx="241">1</cx:pt>
          <cx:pt idx="242">1</cx:pt>
          <cx:pt idx="243">1</cx:pt>
          <cx:pt idx="244">1</cx:pt>
          <cx:pt idx="245">1</cx:pt>
          <cx:pt idx="246">2</cx:pt>
          <cx:pt idx="247">2</cx:pt>
          <cx:pt idx="248">2</cx:pt>
          <cx:pt idx="249">4</cx:pt>
          <cx:pt idx="250">5</cx:pt>
          <cx:pt idx="251">7</cx:pt>
          <cx:pt idx="252">7</cx:pt>
          <cx:pt idx="253">8</cx:pt>
          <cx:pt idx="254">8</cx:pt>
          <cx:pt idx="255">8</cx:pt>
          <cx:pt idx="256">9</cx:pt>
          <cx:pt idx="257">10</cx:pt>
          <cx:pt idx="258">11</cx:pt>
          <cx:pt idx="259">12</cx:pt>
          <cx:pt idx="260">12</cx:pt>
          <cx:pt idx="261">13</cx:pt>
          <cx:pt idx="262">13</cx:pt>
          <cx:pt idx="263">14</cx:pt>
          <cx:pt idx="264">15</cx:pt>
          <cx:pt idx="265">15</cx:pt>
          <cx:pt idx="266">16</cx:pt>
          <cx:pt idx="267">17</cx:pt>
          <cx:pt idx="268">17</cx:pt>
          <cx:pt idx="269">17</cx:pt>
          <cx:pt idx="270">18</cx:pt>
          <cx:pt idx="271">19</cx:pt>
          <cx:pt idx="272">19</cx:pt>
          <cx:pt idx="273">19</cx:pt>
          <cx:pt idx="274">20</cx:pt>
          <cx:pt idx="275">20</cx:pt>
          <cx:pt idx="276">20</cx:pt>
          <cx:pt idx="277">21</cx:pt>
          <cx:pt idx="278">21</cx:pt>
          <cx:pt idx="279">22</cx:pt>
          <cx:pt idx="280">23</cx:pt>
          <cx:pt idx="281">23</cx:pt>
          <cx:pt idx="282">23</cx:pt>
          <cx:pt idx="283">24</cx:pt>
          <cx:pt idx="284">24</cx:pt>
          <cx:pt idx="285">24</cx:pt>
          <cx:pt idx="286">24</cx:pt>
          <cx:pt idx="287">25</cx:pt>
          <cx:pt idx="288">25</cx:pt>
          <cx:pt idx="289">25</cx:pt>
          <cx:pt idx="290">25</cx:pt>
          <cx:pt idx="291">25</cx:pt>
          <cx:pt idx="292">25</cx:pt>
          <cx:pt idx="293">25</cx:pt>
          <cx:pt idx="294">26</cx:pt>
          <cx:pt idx="295">26</cx:pt>
          <cx:pt idx="296">26</cx:pt>
          <cx:pt idx="297">26</cx:pt>
          <cx:pt idx="298">26</cx:pt>
          <cx:pt idx="299">27</cx:pt>
          <cx:pt idx="300">27</cx:pt>
          <cx:pt idx="301">27</cx:pt>
          <cx:pt idx="302">27</cx:pt>
          <cx:pt idx="303">27</cx:pt>
          <cx:pt idx="304">28</cx:pt>
          <cx:pt idx="305">28</cx:pt>
          <cx:pt idx="306">28</cx:pt>
          <cx:pt idx="307">28</cx:pt>
          <cx:pt idx="308">28</cx:pt>
          <cx:pt idx="309">28</cx:pt>
          <cx:pt idx="310">28</cx:pt>
          <cx:pt idx="311">29</cx:pt>
          <cx:pt idx="312">29</cx:pt>
          <cx:pt idx="313">29</cx:pt>
          <cx:pt idx="314">29</cx:pt>
          <cx:pt idx="315">29</cx:pt>
          <cx:pt idx="316">29</cx:pt>
          <cx:pt idx="317">29</cx:pt>
          <cx:pt idx="318">31</cx:pt>
          <cx:pt idx="319">32</cx:pt>
          <cx:pt idx="320">32</cx:pt>
          <cx:pt idx="321">33</cx:pt>
          <cx:pt idx="322">33</cx:pt>
          <cx:pt idx="323">33</cx:pt>
          <cx:pt idx="324">33</cx:pt>
          <cx:pt idx="325">33</cx:pt>
          <cx:pt idx="326">34</cx:pt>
          <cx:pt idx="327">34</cx:pt>
          <cx:pt idx="328">34</cx:pt>
          <cx:pt idx="329">35</cx:pt>
          <cx:pt idx="330">35</cx:pt>
          <cx:pt idx="331">35</cx:pt>
          <cx:pt idx="332">35</cx:pt>
          <cx:pt idx="333">36</cx:pt>
          <cx:pt idx="334">36</cx:pt>
          <cx:pt idx="335">38</cx:pt>
          <cx:pt idx="336">38</cx:pt>
          <cx:pt idx="337">38</cx:pt>
          <cx:pt idx="338">38</cx:pt>
          <cx:pt idx="339">38</cx:pt>
          <cx:pt idx="340">38</cx:pt>
          <cx:pt idx="341">40</cx:pt>
          <cx:pt idx="342">40</cx:pt>
          <cx:pt idx="343">42</cx:pt>
          <cx:pt idx="344">42</cx:pt>
          <cx:pt idx="345">42</cx:pt>
          <cx:pt idx="346">43</cx:pt>
          <cx:pt idx="347">43</cx:pt>
          <cx:pt idx="348">43</cx:pt>
          <cx:pt idx="349">43</cx:pt>
          <cx:pt idx="350">45</cx:pt>
          <cx:pt idx="351">45</cx:pt>
          <cx:pt idx="352">46</cx:pt>
          <cx:pt idx="353">46</cx:pt>
          <cx:pt idx="354">46</cx:pt>
          <cx:pt idx="355">47</cx:pt>
          <cx:pt idx="356">47</cx:pt>
          <cx:pt idx="357">47</cx:pt>
          <cx:pt idx="358">48</cx:pt>
          <cx:pt idx="359">48</cx:pt>
          <cx:pt idx="360">48</cx:pt>
          <cx:pt idx="361">48</cx:pt>
          <cx:pt idx="362">48</cx:pt>
          <cx:pt idx="363">48</cx:pt>
          <cx:pt idx="364">49</cx:pt>
          <cx:pt idx="365">49</cx:pt>
          <cx:pt idx="366">50</cx:pt>
          <cx:pt idx="367">50</cx:pt>
          <cx:pt idx="368">50</cx:pt>
          <cx:pt idx="369">51</cx:pt>
          <cx:pt idx="370">51</cx:pt>
          <cx:pt idx="371">51</cx:pt>
          <cx:pt idx="372">51</cx:pt>
          <cx:pt idx="373">51</cx:pt>
          <cx:pt idx="374">51</cx:pt>
          <cx:pt idx="375">52</cx:pt>
          <cx:pt idx="376">52</cx:pt>
          <cx:pt idx="377">53</cx:pt>
          <cx:pt idx="378">53</cx:pt>
          <cx:pt idx="379">53</cx:pt>
          <cx:pt idx="380">53</cx:pt>
          <cx:pt idx="381">53</cx:pt>
          <cx:pt idx="382">54</cx:pt>
          <cx:pt idx="383">54</cx:pt>
          <cx:pt idx="384">55</cx:pt>
          <cx:pt idx="385">55</cx:pt>
          <cx:pt idx="386">55</cx:pt>
          <cx:pt idx="387">56</cx:pt>
          <cx:pt idx="388">56</cx:pt>
          <cx:pt idx="389">56</cx:pt>
          <cx:pt idx="390">56</cx:pt>
          <cx:pt idx="391">57</cx:pt>
          <cx:pt idx="392">57</cx:pt>
          <cx:pt idx="393">57</cx:pt>
          <cx:pt idx="394">57</cx:pt>
          <cx:pt idx="395">57</cx:pt>
          <cx:pt idx="396">58</cx:pt>
          <cx:pt idx="397">58</cx:pt>
          <cx:pt idx="398">58</cx:pt>
          <cx:pt idx="399">58</cx:pt>
          <cx:pt idx="400">59</cx:pt>
          <cx:pt idx="401">60</cx:pt>
          <cx:pt idx="402">60</cx:pt>
          <cx:pt idx="403">60</cx:pt>
          <cx:pt idx="404">61</cx:pt>
          <cx:pt idx="405">61</cx:pt>
          <cx:pt idx="406">61</cx:pt>
          <cx:pt idx="407">61</cx:pt>
          <cx:pt idx="408">61</cx:pt>
          <cx:pt idx="409">63</cx:pt>
          <cx:pt idx="410">64</cx:pt>
          <cx:pt idx="411">64</cx:pt>
          <cx:pt idx="412">64</cx:pt>
          <cx:pt idx="413">66</cx:pt>
          <cx:pt idx="414">66</cx:pt>
          <cx:pt idx="415">66</cx:pt>
          <cx:pt idx="416">67</cx:pt>
          <cx:pt idx="417">67</cx:pt>
          <cx:pt idx="418">67</cx:pt>
          <cx:pt idx="419">68</cx:pt>
          <cx:pt idx="420">68</cx:pt>
          <cx:pt idx="421">69</cx:pt>
          <cx:pt idx="422">69</cx:pt>
          <cx:pt idx="423">69</cx:pt>
          <cx:pt idx="424">69</cx:pt>
          <cx:pt idx="425">70</cx:pt>
          <cx:pt idx="426">70</cx:pt>
          <cx:pt idx="427">70</cx:pt>
          <cx:pt idx="428">70</cx:pt>
          <cx:pt idx="429">72</cx:pt>
          <cx:pt idx="430">72</cx:pt>
          <cx:pt idx="431">72</cx:pt>
          <cx:pt idx="432">73</cx:pt>
          <cx:pt idx="433">74</cx:pt>
          <cx:pt idx="434">74</cx:pt>
          <cx:pt idx="435">74</cx:pt>
          <cx:pt idx="436">75</cx:pt>
          <cx:pt idx="437">76</cx:pt>
          <cx:pt idx="438">77</cx:pt>
          <cx:pt idx="439">78</cx:pt>
          <cx:pt idx="440">78</cx:pt>
          <cx:pt idx="441">78</cx:pt>
          <cx:pt idx="442">79</cx:pt>
          <cx:pt idx="443">79</cx:pt>
          <cx:pt idx="444">79</cx:pt>
          <cx:pt idx="445">80</cx:pt>
          <cx:pt idx="446">80</cx:pt>
          <cx:pt idx="447">81</cx:pt>
          <cx:pt idx="448">81</cx:pt>
          <cx:pt idx="449">82</cx:pt>
          <cx:pt idx="450">82</cx:pt>
          <cx:pt idx="451">83</cx:pt>
          <cx:pt idx="452">83</cx:pt>
          <cx:pt idx="453">83</cx:pt>
          <cx:pt idx="454">83</cx:pt>
          <cx:pt idx="455">84</cx:pt>
          <cx:pt idx="456">85</cx:pt>
          <cx:pt idx="457">85</cx:pt>
          <cx:pt idx="458">85</cx:pt>
          <cx:pt idx="459">85</cx:pt>
          <cx:pt idx="460">86</cx:pt>
          <cx:pt idx="461">86</cx:pt>
          <cx:pt idx="462">86</cx:pt>
          <cx:pt idx="463">86</cx:pt>
          <cx:pt idx="464">86</cx:pt>
          <cx:pt idx="465">86</cx:pt>
          <cx:pt idx="466">86</cx:pt>
          <cx:pt idx="467">86</cx:pt>
          <cx:pt idx="468">87</cx:pt>
          <cx:pt idx="469">88</cx:pt>
          <cx:pt idx="470">89</cx:pt>
          <cx:pt idx="471">89</cx:pt>
          <cx:pt idx="472">89</cx:pt>
          <cx:pt idx="473">92</cx:pt>
          <cx:pt idx="474">92</cx:pt>
          <cx:pt idx="475">92</cx:pt>
          <cx:pt idx="476">94</cx:pt>
          <cx:pt idx="477">94</cx:pt>
          <cx:pt idx="478">95</cx:pt>
          <cx:pt idx="479">98</cx:pt>
          <cx:pt idx="480">98</cx:pt>
          <cx:pt idx="481">98</cx:pt>
          <cx:pt idx="482">98</cx:pt>
          <cx:pt idx="483">98</cx:pt>
          <cx:pt idx="484">99</cx:pt>
          <cx:pt idx="485">99</cx:pt>
          <cx:pt idx="486">99</cx:pt>
          <cx:pt idx="487">100</cx:pt>
          <cx:pt idx="488">100</cx:pt>
          <cx:pt idx="489">100</cx:pt>
          <cx:pt idx="490">101</cx:pt>
          <cx:pt idx="491">101</cx:pt>
          <cx:pt idx="492">101</cx:pt>
          <cx:pt idx="493">101</cx:pt>
          <cx:pt idx="494">102</cx:pt>
          <cx:pt idx="495">102</cx:pt>
          <cx:pt idx="496">103</cx:pt>
          <cx:pt idx="497">103</cx:pt>
          <cx:pt idx="498">103</cx:pt>
          <cx:pt idx="499">104</cx:pt>
          <cx:pt idx="500">104</cx:pt>
          <cx:pt idx="501">104</cx:pt>
          <cx:pt idx="502">104</cx:pt>
          <cx:pt idx="503">105</cx:pt>
          <cx:pt idx="504">105</cx:pt>
          <cx:pt idx="505">105</cx:pt>
          <cx:pt idx="506">105</cx:pt>
          <cx:pt idx="507">105</cx:pt>
          <cx:pt idx="508">105</cx:pt>
          <cx:pt idx="509">106</cx:pt>
          <cx:pt idx="510">106</cx:pt>
          <cx:pt idx="511">106</cx:pt>
          <cx:pt idx="512">106</cx:pt>
          <cx:pt idx="513">107</cx:pt>
          <cx:pt idx="514">107</cx:pt>
          <cx:pt idx="515">108</cx:pt>
          <cx:pt idx="516">108</cx:pt>
          <cx:pt idx="517">108</cx:pt>
          <cx:pt idx="518">110</cx:pt>
          <cx:pt idx="519">111</cx:pt>
          <cx:pt idx="520">112</cx:pt>
          <cx:pt idx="521">115</cx:pt>
          <cx:pt idx="522">116</cx:pt>
          <cx:pt idx="523">117</cx:pt>
          <cx:pt idx="524">118</cx:pt>
          <cx:pt idx="525">119</cx:pt>
          <cx:pt idx="526">119</cx:pt>
          <cx:pt idx="527">119</cx:pt>
          <cx:pt idx="528">120</cx:pt>
          <cx:pt idx="529">120</cx:pt>
          <cx:pt idx="530">121</cx:pt>
          <cx:pt idx="531">121</cx:pt>
          <cx:pt idx="532">121</cx:pt>
          <cx:pt idx="533">122</cx:pt>
          <cx:pt idx="534">122</cx:pt>
          <cx:pt idx="535">122</cx:pt>
          <cx:pt idx="536">122</cx:pt>
          <cx:pt idx="537">123</cx:pt>
          <cx:pt idx="538">123</cx:pt>
          <cx:pt idx="539">124</cx:pt>
          <cx:pt idx="540">125</cx:pt>
          <cx:pt idx="541">125</cx:pt>
          <cx:pt idx="542">126</cx:pt>
          <cx:pt idx="543">126</cx:pt>
          <cx:pt idx="544">126</cx:pt>
          <cx:pt idx="545">126</cx:pt>
          <cx:pt idx="546">127</cx:pt>
          <cx:pt idx="547">127</cx:pt>
          <cx:pt idx="548">128</cx:pt>
          <cx:pt idx="549">128</cx:pt>
          <cx:pt idx="550">129</cx:pt>
          <cx:pt idx="551">130</cx:pt>
          <cx:pt idx="552">131</cx:pt>
          <cx:pt idx="553">131</cx:pt>
          <cx:pt idx="554">131</cx:pt>
          <cx:pt idx="555">131</cx:pt>
          <cx:pt idx="556">133</cx:pt>
          <cx:pt idx="557">133</cx:pt>
          <cx:pt idx="558">133</cx:pt>
          <cx:pt idx="559">134</cx:pt>
          <cx:pt idx="560">134</cx:pt>
          <cx:pt idx="561">135</cx:pt>
          <cx:pt idx="562">136</cx:pt>
          <cx:pt idx="563">136</cx:pt>
          <cx:pt idx="564">136</cx:pt>
          <cx:pt idx="565">138</cx:pt>
          <cx:pt idx="566">139</cx:pt>
          <cx:pt idx="567">139</cx:pt>
          <cx:pt idx="568">140</cx:pt>
          <cx:pt idx="569">140</cx:pt>
          <cx:pt idx="570">141</cx:pt>
          <cx:pt idx="571">142</cx:pt>
          <cx:pt idx="572">145</cx:pt>
          <cx:pt idx="573">145</cx:pt>
          <cx:pt idx="574">146</cx:pt>
          <cx:pt idx="575">147</cx:pt>
          <cx:pt idx="576">147</cx:pt>
          <cx:pt idx="577">148</cx:pt>
          <cx:pt idx="578">148</cx:pt>
          <cx:pt idx="579">149</cx:pt>
          <cx:pt idx="580">149</cx:pt>
          <cx:pt idx="581">149</cx:pt>
          <cx:pt idx="582">150</cx:pt>
          <cx:pt idx="583">150</cx:pt>
          <cx:pt idx="584">151</cx:pt>
          <cx:pt idx="585">154</cx:pt>
          <cx:pt idx="586">155</cx:pt>
          <cx:pt idx="587">156</cx:pt>
          <cx:pt idx="588">157</cx:pt>
          <cx:pt idx="589">158</cx:pt>
          <cx:pt idx="590">159</cx:pt>
          <cx:pt idx="591">159</cx:pt>
          <cx:pt idx="592">161</cx:pt>
          <cx:pt idx="593">161</cx:pt>
          <cx:pt idx="594">162</cx:pt>
          <cx:pt idx="595">163</cx:pt>
          <cx:pt idx="596">163</cx:pt>
          <cx:pt idx="597">165</cx:pt>
          <cx:pt idx="598">166</cx:pt>
          <cx:pt idx="599">166</cx:pt>
          <cx:pt idx="600">166</cx:pt>
          <cx:pt idx="601">167</cx:pt>
          <cx:pt idx="602">167</cx:pt>
          <cx:pt idx="603">167</cx:pt>
          <cx:pt idx="604">167</cx:pt>
          <cx:pt idx="605">168</cx:pt>
          <cx:pt idx="606">168</cx:pt>
          <cx:pt idx="607">169</cx:pt>
          <cx:pt idx="608">172</cx:pt>
          <cx:pt idx="609">173</cx:pt>
          <cx:pt idx="610">173</cx:pt>
          <cx:pt idx="611">173</cx:pt>
          <cx:pt idx="612">174</cx:pt>
          <cx:pt idx="613">174</cx:pt>
          <cx:pt idx="614">174</cx:pt>
          <cx:pt idx="615">178</cx:pt>
          <cx:pt idx="616">179</cx:pt>
          <cx:pt idx="617">180</cx:pt>
          <cx:pt idx="618">181</cx:pt>
          <cx:pt idx="619">181</cx:pt>
          <cx:pt idx="620">182</cx:pt>
          <cx:pt idx="621">182</cx:pt>
          <cx:pt idx="622">184</cx:pt>
          <cx:pt idx="623">186</cx:pt>
          <cx:pt idx="624">187</cx:pt>
          <cx:pt idx="625">188</cx:pt>
          <cx:pt idx="626">191</cx:pt>
          <cx:pt idx="627">191</cx:pt>
          <cx:pt idx="628">194</cx:pt>
          <cx:pt idx="629">196</cx:pt>
          <cx:pt idx="630">200</cx:pt>
          <cx:pt idx="631">201</cx:pt>
          <cx:pt idx="632">201</cx:pt>
          <cx:pt idx="633">204</cx:pt>
          <cx:pt idx="634">205</cx:pt>
          <cx:pt idx="635">206</cx:pt>
          <cx:pt idx="636">207</cx:pt>
          <cx:pt idx="637">210</cx:pt>
          <cx:pt idx="638">214</cx:pt>
          <cx:pt idx="639">217</cx:pt>
          <cx:pt idx="640">218</cx:pt>
          <cx:pt idx="641">222</cx:pt>
          <cx:pt idx="642">224</cx:pt>
          <cx:pt idx="643">226</cx:pt>
          <cx:pt idx="644">227</cx:pt>
          <cx:pt idx="645">227</cx:pt>
          <cx:pt idx="646">231</cx:pt>
          <cx:pt idx="647">232</cx:pt>
          <cx:pt idx="648">233</cx:pt>
          <cx:pt idx="649">235</cx:pt>
          <cx:pt idx="650">236</cx:pt>
          <cx:pt idx="651">236</cx:pt>
          <cx:pt idx="652">237</cx:pt>
          <cx:pt idx="653">239</cx:pt>
          <cx:pt idx="654">239</cx:pt>
          <cx:pt idx="655">240</cx:pt>
          <cx:pt idx="656">243</cx:pt>
          <cx:pt idx="657">243</cx:pt>
          <cx:pt idx="658">244</cx:pt>
          <cx:pt idx="659">245</cx:pt>
          <cx:pt idx="660">245</cx:pt>
          <cx:pt idx="661">249</cx:pt>
          <cx:pt idx="662">250</cx:pt>
          <cx:pt idx="663">261</cx:pt>
          <cx:pt idx="664">263</cx:pt>
          <cx:pt idx="665">263</cx:pt>
          <cx:pt idx="666">264</cx:pt>
          <cx:pt idx="667">278</cx:pt>
          <cx:pt idx="668">278</cx:pt>
          <cx:pt idx="669">279</cx:pt>
          <cx:pt idx="670">280</cx:pt>
          <cx:pt idx="671">284</cx:pt>
          <cx:pt idx="672">284</cx:pt>
          <cx:pt idx="673">285</cx:pt>
          <cx:pt idx="674">287</cx:pt>
          <cx:pt idx="675">288</cx:pt>
          <cx:pt idx="676">289</cx:pt>
          <cx:pt idx="677">292</cx:pt>
          <cx:pt idx="678">294</cx:pt>
          <cx:pt idx="679">297</cx:pt>
          <cx:pt idx="680">299</cx:pt>
          <cx:pt idx="681">300</cx:pt>
          <cx:pt idx="682">302</cx:pt>
          <cx:pt idx="683">304</cx:pt>
          <cx:pt idx="684">305</cx:pt>
          <cx:pt idx="685">305</cx:pt>
          <cx:pt idx="686">315</cx:pt>
          <cx:pt idx="687">319</cx:pt>
          <cx:pt idx="688">319</cx:pt>
          <cx:pt idx="689">320</cx:pt>
          <cx:pt idx="690">322</cx:pt>
          <cx:pt idx="691">333</cx:pt>
          <cx:pt idx="692">333</cx:pt>
          <cx:pt idx="693">344</cx:pt>
          <cx:pt idx="694">353</cx:pt>
          <cx:pt idx="695">362</cx:pt>
          <cx:pt idx="696">365</cx:pt>
          <cx:pt idx="697">373</cx:pt>
          <cx:pt idx="698">374</cx:pt>
          <cx:pt idx="699">374</cx:pt>
          <cx:pt idx="700">375</cx:pt>
          <cx:pt idx="701">378</cx:pt>
          <cx:pt idx="702">384</cx:pt>
          <cx:pt idx="703">390</cx:pt>
          <cx:pt idx="704">392</cx:pt>
          <cx:pt idx="705">395</cx:pt>
          <cx:pt idx="706">398</cx:pt>
          <cx:pt idx="707">401</cx:pt>
          <cx:pt idx="708">404</cx:pt>
          <cx:pt idx="709">404</cx:pt>
          <cx:pt idx="710">406</cx:pt>
          <cx:pt idx="711">413</cx:pt>
          <cx:pt idx="712">424</cx:pt>
          <cx:pt idx="713">425</cx:pt>
          <cx:pt idx="714">428</cx:pt>
          <cx:pt idx="715">430</cx:pt>
          <cx:pt idx="716">432</cx:pt>
          <cx:pt idx="717">441</cx:pt>
          <cx:pt idx="718">448</cx:pt>
          <cx:pt idx="719">450</cx:pt>
          <cx:pt idx="720">453</cx:pt>
          <cx:pt idx="721">466</cx:pt>
          <cx:pt idx="722">466</cx:pt>
          <cx:pt idx="723">467</cx:pt>
          <cx:pt idx="724">469</cx:pt>
          <cx:pt idx="725">471</cx:pt>
          <cx:pt idx="726">471</cx:pt>
          <cx:pt idx="727">474</cx:pt>
          <cx:pt idx="728">479</cx:pt>
          <cx:pt idx="729">480</cx:pt>
          <cx:pt idx="730">482</cx:pt>
          <cx:pt idx="731">485</cx:pt>
          <cx:pt idx="732">486</cx:pt>
          <cx:pt idx="733">489</cx:pt>
          <cx:pt idx="734">490</cx:pt>
          <cx:pt idx="735">506</cx:pt>
          <cx:pt idx="736">507</cx:pt>
          <cx:pt idx="737">511</cx:pt>
          <cx:pt idx="738">512</cx:pt>
          <cx:pt idx="739">518</cx:pt>
          <cx:pt idx="740">519</cx:pt>
          <cx:pt idx="741">522</cx:pt>
          <cx:pt idx="742">522</cx:pt>
          <cx:pt idx="743">530</cx:pt>
          <cx:pt idx="744">535</cx:pt>
          <cx:pt idx="745">544</cx:pt>
          <cx:pt idx="746">564</cx:pt>
          <cx:pt idx="747">565</cx:pt>
          <cx:pt idx="748">569</cx:pt>
          <cx:pt idx="749">573</cx:pt>
          <cx:pt idx="750">577</cx:pt>
          <cx:pt idx="751">578</cx:pt>
          <cx:pt idx="752">580</cx:pt>
          <cx:pt idx="753">596</cx:pt>
          <cx:pt idx="754">598</cx:pt>
          <cx:pt idx="755">614</cx:pt>
          <cx:pt idx="756">619</cx:pt>
          <cx:pt idx="757">624</cx:pt>
          <cx:pt idx="758">627</cx:pt>
          <cx:pt idx="759">627</cx:pt>
          <cx:pt idx="760">639</cx:pt>
          <cx:pt idx="761">639</cx:pt>
          <cx:pt idx="762">644</cx:pt>
          <cx:pt idx="763">662</cx:pt>
          <cx:pt idx="764">666</cx:pt>
          <cx:pt idx="765">691</cx:pt>
          <cx:pt idx="766">709</cx:pt>
          <cx:pt idx="767">744</cx:pt>
          <cx:pt idx="768">747</cx:pt>
          <cx:pt idx="769">754</cx:pt>
          <cx:pt idx="770">762</cx:pt>
          <cx:pt idx="771">785</cx:pt>
          <cx:pt idx="772">792</cx:pt>
          <cx:pt idx="773">799</cx:pt>
          <cx:pt idx="774">803</cx:pt>
          <cx:pt idx="775">809</cx:pt>
          <cx:pt idx="776">812</cx:pt>
          <cx:pt idx="777">814</cx:pt>
          <cx:pt idx="778">817</cx:pt>
          <cx:pt idx="779">820</cx:pt>
          <cx:pt idx="780">841</cx:pt>
          <cx:pt idx="781">884</cx:pt>
          <cx:pt idx="782">912</cx:pt>
          <cx:pt idx="783">916</cx:pt>
          <cx:pt idx="784">918</cx:pt>
          <cx:pt idx="785">964</cx:pt>
          <cx:pt idx="786">983</cx:pt>
          <cx:pt idx="787">987</cx:pt>
          <cx:pt idx="788">1116</cx:pt>
          <cx:pt idx="789">1148</cx:pt>
          <cx:pt idx="790">1171</cx:pt>
          <cx:pt idx="791">1251</cx:pt>
          <cx:pt idx="792">1267</cx:pt>
          <cx:pt idx="793">1295</cx:pt>
          <cx:pt idx="794">1302</cx:pt>
          <cx:pt idx="795">1339</cx:pt>
          <cx:pt idx="796">1353</cx:pt>
          <cx:pt idx="797">1399</cx:pt>
          <cx:pt idx="798">1411</cx:pt>
          <cx:pt idx="799">1506</cx:pt>
          <cx:pt idx="800">1897</cx:pt>
          <cx:pt idx="801">2608</cx:pt>
          <cx:pt idx="802">2658</cx:pt>
        </cx:lvl>
      </cx:numDim>
    </cx:data>
  </cx:chartData>
  <cx:chart>
    <cx:title pos="t" align="ctr" overlay="0">
      <cx:tx>
        <cx:txData>
          <cx:v/>
        </cx:txData>
      </cx:tx>
      <cx:txPr>
        <a:bodyPr spcFirstLastPara="1" vertOverflow="ellipsis" wrap="square" lIns="0" tIns="0" rIns="0" bIns="0" anchor="ctr" anchorCtr="1"/>
        <a:lstStyle/>
        <a:p>
          <a:pPr algn="ctr">
            <a:defRPr/>
          </a:pPr>
          <a:endParaRPr/>
        </a:p>
      </cx:txPr>
    </cx:title>
    <cx:plotArea>
      <cx:plotAreaRegion>
        <cx:series layoutId="boxWhisker" uniqueId="{4182C088-BBF1-40C3-8A6B-46B290DE937D}">
          <cx:dataId val="0"/>
          <cx:layoutPr>
            <cx:visibility meanLine="0" meanMarker="1" nonoutliers="0" outliers="1"/>
            <cx:statistics quartileMethod="exclusive"/>
          </cx:layoutPr>
        </cx:series>
      </cx:plotAreaRegion>
      <cx:axis id="0">
        <cx:catScaling gapWidth="1"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tickLabels/>
      </cx:axis>
      <cx:axis id="1">
        <cx:valScaling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majorGridlines/>
        <cx:tickLabels/>
      </cx:axis>
    </cx:plotArea>
  </cx:chart>
</cx:chartSpace>
</file>

<file path=ppt/charts/chartEx9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lvl ptCount="803">
          <cx:pt idx="0">BWR pro Tag</cx:pt>
          <cx:pt idx="1">BWR pro Tag</cx:pt>
          <cx:pt idx="2">BWR pro Tag</cx:pt>
          <cx:pt idx="3">BWR pro Tag</cx:pt>
          <cx:pt idx="4">BWR pro Tag</cx:pt>
          <cx:pt idx="5">BWR pro Tag</cx:pt>
          <cx:pt idx="6">BWR pro Tag</cx:pt>
          <cx:pt idx="7">BWR pro Tag</cx:pt>
          <cx:pt idx="8">BWR pro Tag</cx:pt>
          <cx:pt idx="9">BWR pro Tag</cx:pt>
          <cx:pt idx="10">BWR pro Tag</cx:pt>
          <cx:pt idx="11">BWR pro Tag</cx:pt>
          <cx:pt idx="12">BWR pro Tag</cx:pt>
          <cx:pt idx="13">BWR pro Tag</cx:pt>
          <cx:pt idx="14">BWR pro Tag</cx:pt>
          <cx:pt idx="15">BWR pro Tag</cx:pt>
          <cx:pt idx="16">BWR pro Tag</cx:pt>
          <cx:pt idx="17">BWR pro Tag</cx:pt>
          <cx:pt idx="18">BWR pro Tag</cx:pt>
          <cx:pt idx="19">BWR pro Tag</cx:pt>
          <cx:pt idx="20">BWR pro Tag</cx:pt>
          <cx:pt idx="21">BWR pro Tag</cx:pt>
          <cx:pt idx="22">BWR pro Tag</cx:pt>
          <cx:pt idx="23">BWR pro Tag</cx:pt>
          <cx:pt idx="24">BWR pro Tag</cx:pt>
          <cx:pt idx="25">BWR pro Tag</cx:pt>
          <cx:pt idx="26">BWR pro Tag</cx:pt>
          <cx:pt idx="27">BWR pro Tag</cx:pt>
          <cx:pt idx="28">BWR pro Tag</cx:pt>
          <cx:pt idx="29">BWR pro Tag</cx:pt>
          <cx:pt idx="30">BWR pro Tag</cx:pt>
          <cx:pt idx="31">BWR pro Tag</cx:pt>
          <cx:pt idx="32">BWR pro Tag</cx:pt>
          <cx:pt idx="33">BWR pro Tag</cx:pt>
          <cx:pt idx="34">BWR pro Tag</cx:pt>
          <cx:pt idx="35">BWR pro Tag</cx:pt>
          <cx:pt idx="36">BWR pro Tag</cx:pt>
          <cx:pt idx="37">BWR pro Tag</cx:pt>
          <cx:pt idx="38">BWR pro Tag</cx:pt>
          <cx:pt idx="39">BWR pro Tag</cx:pt>
          <cx:pt idx="40">BWR pro Tag</cx:pt>
          <cx:pt idx="41">BWR pro Tag</cx:pt>
          <cx:pt idx="42">BWR pro Tag</cx:pt>
          <cx:pt idx="43">BWR pro Tag</cx:pt>
          <cx:pt idx="44">BWR pro Tag</cx:pt>
          <cx:pt idx="45">BWR pro Tag</cx:pt>
          <cx:pt idx="46">BWR pro Tag</cx:pt>
          <cx:pt idx="47">BWR pro Tag</cx:pt>
          <cx:pt idx="48">BWR pro Tag</cx:pt>
          <cx:pt idx="49">BWR pro Tag</cx:pt>
          <cx:pt idx="50">BWR pro Tag</cx:pt>
          <cx:pt idx="51">BWR pro Tag</cx:pt>
          <cx:pt idx="52">BWR pro Tag</cx:pt>
          <cx:pt idx="53">BWR pro Tag</cx:pt>
          <cx:pt idx="54">BWR pro Tag</cx:pt>
          <cx:pt idx="55">BWR pro Tag</cx:pt>
          <cx:pt idx="56">BWR pro Tag</cx:pt>
          <cx:pt idx="57">BWR pro Tag</cx:pt>
          <cx:pt idx="58">BWR pro Tag</cx:pt>
          <cx:pt idx="59">BWR pro Tag</cx:pt>
          <cx:pt idx="60">BWR pro Tag</cx:pt>
          <cx:pt idx="61">BWR pro Tag</cx:pt>
          <cx:pt idx="62">BWR pro Tag</cx:pt>
          <cx:pt idx="63">BWR pro Tag</cx:pt>
          <cx:pt idx="64">BWR pro Tag</cx:pt>
          <cx:pt idx="65">BWR pro Tag</cx:pt>
          <cx:pt idx="66">BWR pro Tag</cx:pt>
          <cx:pt idx="67">BWR pro Tag</cx:pt>
          <cx:pt idx="68">BWR pro Tag</cx:pt>
          <cx:pt idx="69">BWR pro Tag</cx:pt>
          <cx:pt idx="70">BWR pro Tag</cx:pt>
          <cx:pt idx="71">BWR pro Tag</cx:pt>
          <cx:pt idx="72">BWR pro Tag</cx:pt>
          <cx:pt idx="73">BWR pro Tag</cx:pt>
          <cx:pt idx="74">BWR pro Tag</cx:pt>
          <cx:pt idx="75">BWR pro Tag</cx:pt>
          <cx:pt idx="76">BWR pro Tag</cx:pt>
          <cx:pt idx="77">BWR pro Tag</cx:pt>
          <cx:pt idx="78">BWR pro Tag</cx:pt>
          <cx:pt idx="79">BWR pro Tag</cx:pt>
          <cx:pt idx="80">BWR pro Tag</cx:pt>
          <cx:pt idx="81">BWR pro Tag</cx:pt>
          <cx:pt idx="82">BWR pro Tag</cx:pt>
          <cx:pt idx="83">BWR pro Tag</cx:pt>
          <cx:pt idx="84">BWR pro Tag</cx:pt>
          <cx:pt idx="85">BWR pro Tag</cx:pt>
          <cx:pt idx="86">BWR pro Tag</cx:pt>
          <cx:pt idx="87">BWR pro Tag</cx:pt>
          <cx:pt idx="88">BWR pro Tag</cx:pt>
          <cx:pt idx="89">BWR pro Tag</cx:pt>
          <cx:pt idx="90">BWR pro Tag</cx:pt>
          <cx:pt idx="91">BWR pro Tag</cx:pt>
          <cx:pt idx="92">BWR pro Tag</cx:pt>
          <cx:pt idx="93">BWR pro Tag</cx:pt>
          <cx:pt idx="94">BWR pro Tag</cx:pt>
          <cx:pt idx="95">BWR pro Tag</cx:pt>
          <cx:pt idx="96">BWR pro Tag</cx:pt>
          <cx:pt idx="97">BWR pro Tag</cx:pt>
          <cx:pt idx="98">BWR pro Tag</cx:pt>
          <cx:pt idx="99">BWR pro Tag</cx:pt>
          <cx:pt idx="100">BWR pro Tag</cx:pt>
          <cx:pt idx="101">BWR pro Tag</cx:pt>
          <cx:pt idx="102">BWR pro Tag</cx:pt>
          <cx:pt idx="103">BWR pro Tag</cx:pt>
          <cx:pt idx="104">BWR pro Tag</cx:pt>
          <cx:pt idx="105">BWR pro Tag</cx:pt>
          <cx:pt idx="106">BWR pro Tag</cx:pt>
          <cx:pt idx="107">BWR pro Tag</cx:pt>
          <cx:pt idx="108">BWR pro Tag</cx:pt>
          <cx:pt idx="109">BWR pro Tag</cx:pt>
          <cx:pt idx="110">BWR pro Tag</cx:pt>
          <cx:pt idx="111">BWR pro Tag</cx:pt>
          <cx:pt idx="112">BWR pro Tag</cx:pt>
          <cx:pt idx="113">BWR pro Tag</cx:pt>
          <cx:pt idx="114">BWR pro Tag</cx:pt>
          <cx:pt idx="115">BWR pro Tag</cx:pt>
          <cx:pt idx="116">BWR pro Tag</cx:pt>
          <cx:pt idx="117">BWR pro Tag</cx:pt>
          <cx:pt idx="118">BWR pro Tag</cx:pt>
          <cx:pt idx="119">BWR pro Tag</cx:pt>
          <cx:pt idx="120">BWR pro Tag</cx:pt>
          <cx:pt idx="121">BWR pro Tag</cx:pt>
          <cx:pt idx="122">BWR pro Tag</cx:pt>
          <cx:pt idx="123">BWR pro Tag</cx:pt>
          <cx:pt idx="124">BWR pro Tag</cx:pt>
          <cx:pt idx="125">BWR pro Tag</cx:pt>
          <cx:pt idx="126">BWR pro Tag</cx:pt>
          <cx:pt idx="127">BWR pro Tag</cx:pt>
          <cx:pt idx="128">BWR pro Tag</cx:pt>
          <cx:pt idx="129">BWR pro Tag</cx:pt>
          <cx:pt idx="130">BWR pro Tag</cx:pt>
          <cx:pt idx="131">BWR pro Tag</cx:pt>
          <cx:pt idx="132">BWR pro Tag</cx:pt>
          <cx:pt idx="133">BWR pro Tag</cx:pt>
          <cx:pt idx="134">BWR pro Tag</cx:pt>
          <cx:pt idx="135">BWR pro Tag</cx:pt>
          <cx:pt idx="136">BWR pro Tag</cx:pt>
          <cx:pt idx="137">BWR pro Tag</cx:pt>
          <cx:pt idx="138">BWR pro Tag</cx:pt>
          <cx:pt idx="139">BWR pro Tag</cx:pt>
          <cx:pt idx="140">BWR pro Tag</cx:pt>
          <cx:pt idx="141">BWR pro Tag</cx:pt>
          <cx:pt idx="142">BWR pro Tag</cx:pt>
          <cx:pt idx="143">BWR pro Tag</cx:pt>
          <cx:pt idx="144">BWR pro Tag</cx:pt>
          <cx:pt idx="145">BWR pro Tag</cx:pt>
          <cx:pt idx="146">BWR pro Tag</cx:pt>
          <cx:pt idx="147">BWR pro Tag</cx:pt>
          <cx:pt idx="148">BWR pro Tag</cx:pt>
          <cx:pt idx="149">BWR pro Tag</cx:pt>
          <cx:pt idx="150">BWR pro Tag</cx:pt>
          <cx:pt idx="151">BWR pro Tag</cx:pt>
          <cx:pt idx="152">BWR pro Tag</cx:pt>
          <cx:pt idx="153">BWR pro Tag</cx:pt>
          <cx:pt idx="154">BWR pro Tag</cx:pt>
          <cx:pt idx="155">BWR pro Tag</cx:pt>
          <cx:pt idx="156">BWR pro Tag</cx:pt>
          <cx:pt idx="157">BWR pro Tag</cx:pt>
          <cx:pt idx="158">BWR pro Tag</cx:pt>
          <cx:pt idx="159">BWR pro Tag</cx:pt>
          <cx:pt idx="160">BWR pro Tag</cx:pt>
          <cx:pt idx="161">BWR pro Tag</cx:pt>
          <cx:pt idx="162">BWR pro Tag</cx:pt>
          <cx:pt idx="163">BWR pro Tag</cx:pt>
          <cx:pt idx="164">BWR pro Tag</cx:pt>
          <cx:pt idx="165">BWR pro Tag</cx:pt>
          <cx:pt idx="166">BWR pro Tag</cx:pt>
          <cx:pt idx="167">BWR pro Tag</cx:pt>
          <cx:pt idx="168">BWR pro Tag</cx:pt>
          <cx:pt idx="169">BWR pro Tag</cx:pt>
          <cx:pt idx="170">BWR pro Tag</cx:pt>
          <cx:pt idx="171">BWR pro Tag</cx:pt>
          <cx:pt idx="172">BWR pro Tag</cx:pt>
          <cx:pt idx="173">BWR pro Tag</cx:pt>
          <cx:pt idx="174">BWR pro Tag</cx:pt>
          <cx:pt idx="175">BWR pro Tag</cx:pt>
          <cx:pt idx="176">BWR pro Tag</cx:pt>
          <cx:pt idx="177">BWR pro Tag</cx:pt>
          <cx:pt idx="178">BWR pro Tag</cx:pt>
          <cx:pt idx="179">BWR pro Tag</cx:pt>
          <cx:pt idx="180">BWR pro Tag</cx:pt>
          <cx:pt idx="181">BWR pro Tag</cx:pt>
          <cx:pt idx="182">BWR pro Tag</cx:pt>
          <cx:pt idx="183">BWR pro Tag</cx:pt>
          <cx:pt idx="184">BWR pro Tag</cx:pt>
          <cx:pt idx="185">BWR pro Tag</cx:pt>
          <cx:pt idx="186">BWR pro Tag</cx:pt>
          <cx:pt idx="187">BWR pro Tag</cx:pt>
          <cx:pt idx="188">BWR pro Tag</cx:pt>
          <cx:pt idx="189">BWR pro Tag</cx:pt>
          <cx:pt idx="190">BWR pro Tag</cx:pt>
          <cx:pt idx="191">BWR pro Tag</cx:pt>
          <cx:pt idx="192">BWR pro Tag</cx:pt>
          <cx:pt idx="193">BWR pro Tag</cx:pt>
          <cx:pt idx="194">BWR pro Tag</cx:pt>
          <cx:pt idx="195">BWR pro Tag</cx:pt>
          <cx:pt idx="196">BWR pro Tag</cx:pt>
          <cx:pt idx="197">BWR pro Tag</cx:pt>
          <cx:pt idx="198">BWR pro Tag</cx:pt>
          <cx:pt idx="199">BWR pro Tag</cx:pt>
          <cx:pt idx="200">BWR pro Tag</cx:pt>
          <cx:pt idx="201">BWR pro Tag</cx:pt>
          <cx:pt idx="202">BWR pro Tag</cx:pt>
          <cx:pt idx="203">BWR pro Tag</cx:pt>
          <cx:pt idx="204">BWR pro Tag</cx:pt>
          <cx:pt idx="205">BWR pro Tag</cx:pt>
          <cx:pt idx="206">BWR pro Tag</cx:pt>
          <cx:pt idx="207">BWR pro Tag</cx:pt>
          <cx:pt idx="208">BWR pro Tag</cx:pt>
          <cx:pt idx="209">BWR pro Tag</cx:pt>
          <cx:pt idx="210">BWR pro Tag</cx:pt>
          <cx:pt idx="211">BWR pro Tag</cx:pt>
          <cx:pt idx="212">BWR pro Tag</cx:pt>
          <cx:pt idx="213">BWR pro Tag</cx:pt>
          <cx:pt idx="214">BWR pro Tag</cx:pt>
          <cx:pt idx="215">BWR pro Tag</cx:pt>
          <cx:pt idx="216">BWR pro Tag</cx:pt>
          <cx:pt idx="217">BWR pro Tag</cx:pt>
          <cx:pt idx="218">BWR pro Tag</cx:pt>
          <cx:pt idx="219">BWR pro Tag</cx:pt>
          <cx:pt idx="220">BWR pro Tag</cx:pt>
          <cx:pt idx="221">BWR pro Tag</cx:pt>
          <cx:pt idx="222">BWR pro Tag</cx:pt>
          <cx:pt idx="223">BWR pro Tag</cx:pt>
          <cx:pt idx="224">BWR pro Tag</cx:pt>
          <cx:pt idx="225">BWR pro Tag</cx:pt>
          <cx:pt idx="226">BWR pro Tag</cx:pt>
          <cx:pt idx="227">BWR pro Tag</cx:pt>
          <cx:pt idx="228">BWR pro Tag</cx:pt>
          <cx:pt idx="229">BWR pro Tag</cx:pt>
          <cx:pt idx="230">BWR pro Tag</cx:pt>
          <cx:pt idx="231">BWR pro Tag</cx:pt>
          <cx:pt idx="232">BWR pro Tag</cx:pt>
          <cx:pt idx="233">BWR pro Tag</cx:pt>
          <cx:pt idx="234">BWR pro Tag</cx:pt>
          <cx:pt idx="235">BWR pro Tag</cx:pt>
          <cx:pt idx="236">BWR pro Tag</cx:pt>
          <cx:pt idx="237">BWR pro Tag</cx:pt>
          <cx:pt idx="238">BWR pro Tag</cx:pt>
          <cx:pt idx="239">BWR pro Tag</cx:pt>
          <cx:pt idx="240">BWR pro Tag</cx:pt>
          <cx:pt idx="241">BWR pro Tag</cx:pt>
          <cx:pt idx="242">BWR pro Tag</cx:pt>
          <cx:pt idx="243">BWR pro Tag</cx:pt>
          <cx:pt idx="244">BWR pro Tag</cx:pt>
          <cx:pt idx="245">BWR pro Tag</cx:pt>
          <cx:pt idx="246">BWR pro Tag</cx:pt>
          <cx:pt idx="247">BWR pro Tag</cx:pt>
          <cx:pt idx="248">BWR pro Tag</cx:pt>
          <cx:pt idx="249">BWR pro Tag</cx:pt>
          <cx:pt idx="250">BWR pro Tag</cx:pt>
          <cx:pt idx="251">BWR pro Tag</cx:pt>
          <cx:pt idx="252">BWR pro Tag</cx:pt>
          <cx:pt idx="253">BWR pro Tag</cx:pt>
          <cx:pt idx="254">BWR pro Tag</cx:pt>
          <cx:pt idx="255">BWR pro Tag</cx:pt>
          <cx:pt idx="256">BWR pro Tag</cx:pt>
          <cx:pt idx="257">BWR pro Tag</cx:pt>
          <cx:pt idx="258">BWR pro Tag</cx:pt>
          <cx:pt idx="259">BWR pro Tag</cx:pt>
          <cx:pt idx="260">BWR pro Tag</cx:pt>
          <cx:pt idx="261">BWR pro Tag</cx:pt>
          <cx:pt idx="262">BWR pro Tag</cx:pt>
          <cx:pt idx="263">BWR pro Tag</cx:pt>
          <cx:pt idx="264">BWR pro Tag</cx:pt>
          <cx:pt idx="265">BWR pro Tag</cx:pt>
          <cx:pt idx="266">BWR pro Tag</cx:pt>
          <cx:pt idx="267">BWR pro Tag</cx:pt>
          <cx:pt idx="268">BWR pro Tag</cx:pt>
          <cx:pt idx="269">BWR pro Tag</cx:pt>
          <cx:pt idx="270">BWR pro Tag</cx:pt>
          <cx:pt idx="271">BWR pro Tag</cx:pt>
          <cx:pt idx="272">BWR pro Tag</cx:pt>
          <cx:pt idx="273">BWR pro Tag</cx:pt>
          <cx:pt idx="274">BWR pro Tag</cx:pt>
          <cx:pt idx="275">BWR pro Tag</cx:pt>
          <cx:pt idx="276">BWR pro Tag</cx:pt>
          <cx:pt idx="277">BWR pro Tag</cx:pt>
          <cx:pt idx="278">BWR pro Tag</cx:pt>
          <cx:pt idx="279">BWR pro Tag</cx:pt>
          <cx:pt idx="280">BWR pro Tag</cx:pt>
          <cx:pt idx="281">BWR pro Tag</cx:pt>
          <cx:pt idx="282">BWR pro Tag</cx:pt>
          <cx:pt idx="283">BWR pro Tag</cx:pt>
          <cx:pt idx="284">BWR pro Tag</cx:pt>
          <cx:pt idx="285">BWR pro Tag</cx:pt>
          <cx:pt idx="286">BWR pro Tag</cx:pt>
          <cx:pt idx="287">BWR pro Tag</cx:pt>
          <cx:pt idx="288">BWR pro Tag</cx:pt>
          <cx:pt idx="289">BWR pro Tag</cx:pt>
          <cx:pt idx="290">BWR pro Tag</cx:pt>
          <cx:pt idx="291">BWR pro Tag</cx:pt>
          <cx:pt idx="292">BWR pro Tag</cx:pt>
          <cx:pt idx="293">BWR pro Tag</cx:pt>
          <cx:pt idx="294">BWR pro Tag</cx:pt>
          <cx:pt idx="295">BWR pro Tag</cx:pt>
          <cx:pt idx="296">BWR pro Tag</cx:pt>
          <cx:pt idx="297">BWR pro Tag</cx:pt>
          <cx:pt idx="298">BWR pro Tag</cx:pt>
          <cx:pt idx="299">BWR pro Tag</cx:pt>
          <cx:pt idx="300">BWR pro Tag</cx:pt>
          <cx:pt idx="301">BWR pro Tag</cx:pt>
          <cx:pt idx="302">BWR pro Tag</cx:pt>
          <cx:pt idx="303">BWR pro Tag</cx:pt>
          <cx:pt idx="304">BWR pro Tag</cx:pt>
          <cx:pt idx="305">BWR pro Tag</cx:pt>
          <cx:pt idx="306">BWR pro Tag</cx:pt>
          <cx:pt idx="307">BWR pro Tag</cx:pt>
          <cx:pt idx="308">BWR pro Tag</cx:pt>
          <cx:pt idx="309">BWR pro Tag</cx:pt>
          <cx:pt idx="310">BWR pro Tag</cx:pt>
          <cx:pt idx="311">BWR pro Tag</cx:pt>
          <cx:pt idx="312">BWR pro Tag</cx:pt>
          <cx:pt idx="313">BWR pro Tag</cx:pt>
          <cx:pt idx="314">BWR pro Tag</cx:pt>
          <cx:pt idx="315">BWR pro Tag</cx:pt>
          <cx:pt idx="316">BWR pro Tag</cx:pt>
          <cx:pt idx="317">BWR pro Tag</cx:pt>
          <cx:pt idx="318">BWR pro Tag</cx:pt>
          <cx:pt idx="319">BWR pro Tag</cx:pt>
          <cx:pt idx="320">BWR pro Tag</cx:pt>
          <cx:pt idx="321">BWR pro Tag</cx:pt>
          <cx:pt idx="322">BWR pro Tag</cx:pt>
          <cx:pt idx="323">BWR pro Tag</cx:pt>
          <cx:pt idx="324">BWR pro Tag</cx:pt>
          <cx:pt idx="325">BWR pro Tag</cx:pt>
          <cx:pt idx="326">BWR pro Tag</cx:pt>
          <cx:pt idx="327">BWR pro Tag</cx:pt>
          <cx:pt idx="328">BWR pro Tag</cx:pt>
          <cx:pt idx="329">BWR pro Tag</cx:pt>
          <cx:pt idx="330">BWR pro Tag</cx:pt>
          <cx:pt idx="331">BWR pro Tag</cx:pt>
          <cx:pt idx="332">BWR pro Tag</cx:pt>
          <cx:pt idx="333">BWR pro Tag</cx:pt>
          <cx:pt idx="334">BWR pro Tag</cx:pt>
          <cx:pt idx="335">BWR pro Tag</cx:pt>
          <cx:pt idx="336">BWR pro Tag</cx:pt>
          <cx:pt idx="337">BWR pro Tag</cx:pt>
          <cx:pt idx="338">BWR pro Tag</cx:pt>
          <cx:pt idx="339">BWR pro Tag</cx:pt>
          <cx:pt idx="340">BWR pro Tag</cx:pt>
          <cx:pt idx="341">BWR pro Tag</cx:pt>
          <cx:pt idx="342">BWR pro Tag</cx:pt>
          <cx:pt idx="343">BWR pro Tag</cx:pt>
          <cx:pt idx="344">BWR pro Tag</cx:pt>
          <cx:pt idx="345">BWR pro Tag</cx:pt>
          <cx:pt idx="346">BWR pro Tag</cx:pt>
          <cx:pt idx="347">BWR pro Tag</cx:pt>
          <cx:pt idx="348">BWR pro Tag</cx:pt>
          <cx:pt idx="349">BWR pro Tag</cx:pt>
          <cx:pt idx="350">BWR pro Tag</cx:pt>
          <cx:pt idx="351">BWR pro Tag</cx:pt>
          <cx:pt idx="352">BWR pro Tag</cx:pt>
          <cx:pt idx="353">BWR pro Tag</cx:pt>
          <cx:pt idx="354">BWR pro Tag</cx:pt>
          <cx:pt idx="355">BWR pro Tag</cx:pt>
          <cx:pt idx="356">BWR pro Tag</cx:pt>
          <cx:pt idx="357">BWR pro Tag</cx:pt>
          <cx:pt idx="358">BWR pro Tag</cx:pt>
          <cx:pt idx="359">BWR pro Tag</cx:pt>
          <cx:pt idx="360">BWR pro Tag</cx:pt>
          <cx:pt idx="361">BWR pro Tag</cx:pt>
          <cx:pt idx="362">BWR pro Tag</cx:pt>
          <cx:pt idx="363">BWR pro Tag</cx:pt>
          <cx:pt idx="364">BWR pro Tag</cx:pt>
          <cx:pt idx="365">BWR pro Tag</cx:pt>
          <cx:pt idx="366">BWR pro Tag</cx:pt>
          <cx:pt idx="367">BWR pro Tag</cx:pt>
          <cx:pt idx="368">BWR pro Tag</cx:pt>
          <cx:pt idx="369">BWR pro Tag</cx:pt>
          <cx:pt idx="370">BWR pro Tag</cx:pt>
          <cx:pt idx="371">BWR pro Tag</cx:pt>
          <cx:pt idx="372">BWR pro Tag</cx:pt>
          <cx:pt idx="373">BWR pro Tag</cx:pt>
          <cx:pt idx="374">BWR pro Tag</cx:pt>
          <cx:pt idx="375">BWR pro Tag</cx:pt>
          <cx:pt idx="376">BWR pro Tag</cx:pt>
          <cx:pt idx="377">BWR pro Tag</cx:pt>
          <cx:pt idx="378">BWR pro Tag</cx:pt>
          <cx:pt idx="379">BWR pro Tag</cx:pt>
          <cx:pt idx="380">BWR pro Tag</cx:pt>
          <cx:pt idx="381">BWR pro Tag</cx:pt>
          <cx:pt idx="382">BWR pro Tag</cx:pt>
          <cx:pt idx="383">BWR pro Tag</cx:pt>
          <cx:pt idx="384">BWR pro Tag</cx:pt>
          <cx:pt idx="385">BWR pro Tag</cx:pt>
          <cx:pt idx="386">BWR pro Tag</cx:pt>
          <cx:pt idx="387">BWR pro Tag</cx:pt>
          <cx:pt idx="388">BWR pro Tag</cx:pt>
          <cx:pt idx="389">BWR pro Tag</cx:pt>
          <cx:pt idx="390">BWR pro Tag</cx:pt>
          <cx:pt idx="391">BWR pro Tag</cx:pt>
          <cx:pt idx="392">BWR pro Tag</cx:pt>
          <cx:pt idx="393">BWR pro Tag</cx:pt>
          <cx:pt idx="394">BWR pro Tag</cx:pt>
          <cx:pt idx="395">BWR pro Tag</cx:pt>
          <cx:pt idx="396">BWR pro Tag</cx:pt>
          <cx:pt idx="397">BWR pro Tag</cx:pt>
          <cx:pt idx="398">BWR pro Tag</cx:pt>
          <cx:pt idx="399">BWR pro Tag</cx:pt>
          <cx:pt idx="400">BWR pro Tag</cx:pt>
          <cx:pt idx="401">BWR pro Tag</cx:pt>
          <cx:pt idx="402">BWR pro Tag</cx:pt>
          <cx:pt idx="403">BWR pro Tag</cx:pt>
          <cx:pt idx="404">BWR pro Tag</cx:pt>
          <cx:pt idx="405">BWR pro Tag</cx:pt>
          <cx:pt idx="406">BWR pro Tag</cx:pt>
          <cx:pt idx="407">BWR pro Tag</cx:pt>
          <cx:pt idx="408">BWR pro Tag</cx:pt>
          <cx:pt idx="409">BWR pro Tag</cx:pt>
          <cx:pt idx="410">BWR pro Tag</cx:pt>
          <cx:pt idx="411">BWR pro Tag</cx:pt>
          <cx:pt idx="412">BWR pro Tag</cx:pt>
          <cx:pt idx="413">BWR pro Tag</cx:pt>
          <cx:pt idx="414">BWR pro Tag</cx:pt>
          <cx:pt idx="415">BWR pro Tag</cx:pt>
          <cx:pt idx="416">BWR pro Tag</cx:pt>
          <cx:pt idx="417">BWR pro Tag</cx:pt>
          <cx:pt idx="418">BWR pro Tag</cx:pt>
          <cx:pt idx="419">BWR pro Tag</cx:pt>
          <cx:pt idx="420">BWR pro Tag</cx:pt>
          <cx:pt idx="421">BWR pro Tag</cx:pt>
          <cx:pt idx="422">BWR pro Tag</cx:pt>
          <cx:pt idx="423">BWR pro Tag</cx:pt>
          <cx:pt idx="424">BWR pro Tag</cx:pt>
          <cx:pt idx="425">BWR pro Tag</cx:pt>
          <cx:pt idx="426">BWR pro Tag</cx:pt>
          <cx:pt idx="427">BWR pro Tag</cx:pt>
          <cx:pt idx="428">BWR pro Tag</cx:pt>
          <cx:pt idx="429">BWR pro Tag</cx:pt>
          <cx:pt idx="430">BWR pro Tag</cx:pt>
          <cx:pt idx="431">BWR pro Tag</cx:pt>
          <cx:pt idx="432">BWR pro Tag</cx:pt>
          <cx:pt idx="433">BWR pro Tag</cx:pt>
          <cx:pt idx="434">BWR pro Tag</cx:pt>
          <cx:pt idx="435">BWR pro Tag</cx:pt>
          <cx:pt idx="436">BWR pro Tag</cx:pt>
          <cx:pt idx="437">BWR pro Tag</cx:pt>
          <cx:pt idx="438">BWR pro Tag</cx:pt>
          <cx:pt idx="439">BWR pro Tag</cx:pt>
          <cx:pt idx="440">BWR pro Tag</cx:pt>
          <cx:pt idx="441">BWR pro Tag</cx:pt>
          <cx:pt idx="442">BWR pro Tag</cx:pt>
          <cx:pt idx="443">BWR pro Tag</cx:pt>
          <cx:pt idx="444">BWR pro Tag</cx:pt>
          <cx:pt idx="445">BWR pro Tag</cx:pt>
          <cx:pt idx="446">BWR pro Tag</cx:pt>
          <cx:pt idx="447">BWR pro Tag</cx:pt>
          <cx:pt idx="448">BWR pro Tag</cx:pt>
          <cx:pt idx="449">BWR pro Tag</cx:pt>
          <cx:pt idx="450">BWR pro Tag</cx:pt>
          <cx:pt idx="451">BWR pro Tag</cx:pt>
          <cx:pt idx="452">BWR pro Tag</cx:pt>
          <cx:pt idx="453">BWR pro Tag</cx:pt>
          <cx:pt idx="454">BWR pro Tag</cx:pt>
          <cx:pt idx="455">BWR pro Tag</cx:pt>
          <cx:pt idx="456">BWR pro Tag</cx:pt>
          <cx:pt idx="457">BWR pro Tag</cx:pt>
          <cx:pt idx="458">BWR pro Tag</cx:pt>
          <cx:pt idx="459">BWR pro Tag</cx:pt>
          <cx:pt idx="460">BWR pro Tag</cx:pt>
          <cx:pt idx="461">BWR pro Tag</cx:pt>
          <cx:pt idx="462">BWR pro Tag</cx:pt>
          <cx:pt idx="463">BWR pro Tag</cx:pt>
          <cx:pt idx="464">BWR pro Tag</cx:pt>
          <cx:pt idx="465">BWR pro Tag</cx:pt>
          <cx:pt idx="466">BWR pro Tag</cx:pt>
          <cx:pt idx="467">BWR pro Tag</cx:pt>
          <cx:pt idx="468">BWR pro Tag</cx:pt>
          <cx:pt idx="469">BWR pro Tag</cx:pt>
          <cx:pt idx="470">BWR pro Tag</cx:pt>
          <cx:pt idx="471">BWR pro Tag</cx:pt>
          <cx:pt idx="472">BWR pro Tag</cx:pt>
          <cx:pt idx="473">BWR pro Tag</cx:pt>
          <cx:pt idx="474">BWR pro Tag</cx:pt>
          <cx:pt idx="475">BWR pro Tag</cx:pt>
          <cx:pt idx="476">BWR pro Tag</cx:pt>
          <cx:pt idx="477">BWR pro Tag</cx:pt>
          <cx:pt idx="478">BWR pro Tag</cx:pt>
          <cx:pt idx="479">BWR pro Tag</cx:pt>
          <cx:pt idx="480">BWR pro Tag</cx:pt>
          <cx:pt idx="481">BWR pro Tag</cx:pt>
          <cx:pt idx="482">BWR pro Tag</cx:pt>
          <cx:pt idx="483">BWR pro Tag</cx:pt>
          <cx:pt idx="484">BWR pro Tag</cx:pt>
          <cx:pt idx="485">BWR pro Tag</cx:pt>
          <cx:pt idx="486">BWR pro Tag</cx:pt>
          <cx:pt idx="487">BWR pro Tag</cx:pt>
          <cx:pt idx="488">BWR pro Tag</cx:pt>
          <cx:pt idx="489">BWR pro Tag</cx:pt>
          <cx:pt idx="490">BWR pro Tag</cx:pt>
          <cx:pt idx="491">BWR pro Tag</cx:pt>
          <cx:pt idx="492">BWR pro Tag</cx:pt>
          <cx:pt idx="493">BWR pro Tag</cx:pt>
          <cx:pt idx="494">BWR pro Tag</cx:pt>
          <cx:pt idx="495">BWR pro Tag</cx:pt>
          <cx:pt idx="496">BWR pro Tag</cx:pt>
          <cx:pt idx="497">BWR pro Tag</cx:pt>
          <cx:pt idx="498">BWR pro Tag</cx:pt>
          <cx:pt idx="499">BWR pro Tag</cx:pt>
          <cx:pt idx="500">BWR pro Tag</cx:pt>
          <cx:pt idx="501">BWR pro Tag</cx:pt>
          <cx:pt idx="502">BWR pro Tag</cx:pt>
          <cx:pt idx="503">BWR pro Tag</cx:pt>
          <cx:pt idx="504">BWR pro Tag</cx:pt>
          <cx:pt idx="505">BWR pro Tag</cx:pt>
          <cx:pt idx="506">BWR pro Tag</cx:pt>
          <cx:pt idx="507">BWR pro Tag</cx:pt>
          <cx:pt idx="508">BWR pro Tag</cx:pt>
          <cx:pt idx="509">BWR pro Tag</cx:pt>
          <cx:pt idx="510">BWR pro Tag</cx:pt>
          <cx:pt idx="511">BWR pro Tag</cx:pt>
          <cx:pt idx="512">BWR pro Tag</cx:pt>
          <cx:pt idx="513">BWR pro Tag</cx:pt>
          <cx:pt idx="514">BWR pro Tag</cx:pt>
          <cx:pt idx="515">BWR pro Tag</cx:pt>
          <cx:pt idx="516">BWR pro Tag</cx:pt>
          <cx:pt idx="517">BWR pro Tag</cx:pt>
          <cx:pt idx="518">BWR pro Tag</cx:pt>
          <cx:pt idx="519">BWR pro Tag</cx:pt>
          <cx:pt idx="520">BWR pro Tag</cx:pt>
          <cx:pt idx="521">BWR pro Tag</cx:pt>
          <cx:pt idx="522">BWR pro Tag</cx:pt>
          <cx:pt idx="523">BWR pro Tag</cx:pt>
          <cx:pt idx="524">BWR pro Tag</cx:pt>
          <cx:pt idx="525">BWR pro Tag</cx:pt>
          <cx:pt idx="526">BWR pro Tag</cx:pt>
          <cx:pt idx="527">BWR pro Tag</cx:pt>
          <cx:pt idx="528">BWR pro Tag</cx:pt>
          <cx:pt idx="529">BWR pro Tag</cx:pt>
          <cx:pt idx="530">BWR pro Tag</cx:pt>
          <cx:pt idx="531">BWR pro Tag</cx:pt>
          <cx:pt idx="532">BWR pro Tag</cx:pt>
          <cx:pt idx="533">BWR pro Tag</cx:pt>
          <cx:pt idx="534">BWR pro Tag</cx:pt>
          <cx:pt idx="535">BWR pro Tag</cx:pt>
          <cx:pt idx="536">BWR pro Tag</cx:pt>
          <cx:pt idx="537">BWR pro Tag</cx:pt>
          <cx:pt idx="538">BWR pro Tag</cx:pt>
          <cx:pt idx="539">BWR pro Tag</cx:pt>
          <cx:pt idx="540">BWR pro Tag</cx:pt>
          <cx:pt idx="541">BWR pro Tag</cx:pt>
          <cx:pt idx="542">BWR pro Tag</cx:pt>
          <cx:pt idx="543">BWR pro Tag</cx:pt>
          <cx:pt idx="544">BWR pro Tag</cx:pt>
          <cx:pt idx="545">BWR pro Tag</cx:pt>
          <cx:pt idx="546">BWR pro Tag</cx:pt>
          <cx:pt idx="547">BWR pro Tag</cx:pt>
          <cx:pt idx="548">BWR pro Tag</cx:pt>
          <cx:pt idx="549">BWR pro Tag</cx:pt>
          <cx:pt idx="550">BWR pro Tag</cx:pt>
          <cx:pt idx="551">BWR pro Tag</cx:pt>
          <cx:pt idx="552">BWR pro Tag</cx:pt>
          <cx:pt idx="553">BWR pro Tag</cx:pt>
          <cx:pt idx="554">BWR pro Tag</cx:pt>
          <cx:pt idx="555">BWR pro Tag</cx:pt>
          <cx:pt idx="556">BWR pro Tag</cx:pt>
          <cx:pt idx="557">BWR pro Tag</cx:pt>
          <cx:pt idx="558">BWR pro Tag</cx:pt>
          <cx:pt idx="559">BWR pro Tag</cx:pt>
          <cx:pt idx="560">BWR pro Tag</cx:pt>
          <cx:pt idx="561">BWR pro Tag</cx:pt>
          <cx:pt idx="562">BWR pro Tag</cx:pt>
          <cx:pt idx="563">BWR pro Tag</cx:pt>
          <cx:pt idx="564">BWR pro Tag</cx:pt>
          <cx:pt idx="565">BWR pro Tag</cx:pt>
          <cx:pt idx="566">BWR pro Tag</cx:pt>
          <cx:pt idx="567">BWR pro Tag</cx:pt>
          <cx:pt idx="568">BWR pro Tag</cx:pt>
          <cx:pt idx="569">BWR pro Tag</cx:pt>
          <cx:pt idx="570">BWR pro Tag</cx:pt>
          <cx:pt idx="571">BWR pro Tag</cx:pt>
          <cx:pt idx="572">BWR pro Tag</cx:pt>
          <cx:pt idx="573">BWR pro Tag</cx:pt>
          <cx:pt idx="574">BWR pro Tag</cx:pt>
          <cx:pt idx="575">BWR pro Tag</cx:pt>
          <cx:pt idx="576">BWR pro Tag</cx:pt>
          <cx:pt idx="577">BWR pro Tag</cx:pt>
          <cx:pt idx="578">BWR pro Tag</cx:pt>
          <cx:pt idx="579">BWR pro Tag</cx:pt>
          <cx:pt idx="580">BWR pro Tag</cx:pt>
          <cx:pt idx="581">BWR pro Tag</cx:pt>
          <cx:pt idx="582">BWR pro Tag</cx:pt>
          <cx:pt idx="583">BWR pro Tag</cx:pt>
          <cx:pt idx="584">BWR pro Tag</cx:pt>
          <cx:pt idx="585">BWR pro Tag</cx:pt>
          <cx:pt idx="586">BWR pro Tag</cx:pt>
          <cx:pt idx="587">BWR pro Tag</cx:pt>
          <cx:pt idx="588">BWR pro Tag</cx:pt>
          <cx:pt idx="589">BWR pro Tag</cx:pt>
          <cx:pt idx="590">BWR pro Tag</cx:pt>
          <cx:pt idx="591">BWR pro Tag</cx:pt>
          <cx:pt idx="592">BWR pro Tag</cx:pt>
          <cx:pt idx="593">BWR pro Tag</cx:pt>
          <cx:pt idx="594">BWR pro Tag</cx:pt>
          <cx:pt idx="595">BWR pro Tag</cx:pt>
          <cx:pt idx="596">BWR pro Tag</cx:pt>
          <cx:pt idx="597">BWR pro Tag</cx:pt>
          <cx:pt idx="598">BWR pro Tag</cx:pt>
          <cx:pt idx="599">BWR pro Tag</cx:pt>
          <cx:pt idx="600">BWR pro Tag</cx:pt>
          <cx:pt idx="601">BWR pro Tag</cx:pt>
          <cx:pt idx="602">BWR pro Tag</cx:pt>
          <cx:pt idx="603">BWR pro Tag</cx:pt>
          <cx:pt idx="604">BWR pro Tag</cx:pt>
          <cx:pt idx="605">BWR pro Tag</cx:pt>
          <cx:pt idx="606">BWR pro Tag</cx:pt>
          <cx:pt idx="607">BWR pro Tag</cx:pt>
          <cx:pt idx="608">BWR pro Tag</cx:pt>
          <cx:pt idx="609">BWR pro Tag</cx:pt>
          <cx:pt idx="610">BWR pro Tag</cx:pt>
          <cx:pt idx="611">BWR pro Tag</cx:pt>
          <cx:pt idx="612">BWR pro Tag</cx:pt>
          <cx:pt idx="613">BWR pro Tag</cx:pt>
          <cx:pt idx="614">BWR pro Tag</cx:pt>
          <cx:pt idx="615">BWR pro Tag</cx:pt>
          <cx:pt idx="616">BWR pro Tag</cx:pt>
          <cx:pt idx="617">BWR pro Tag</cx:pt>
          <cx:pt idx="618">BWR pro Tag</cx:pt>
          <cx:pt idx="619">BWR pro Tag</cx:pt>
          <cx:pt idx="620">BWR pro Tag</cx:pt>
          <cx:pt idx="621">BWR pro Tag</cx:pt>
          <cx:pt idx="622">BWR pro Tag</cx:pt>
          <cx:pt idx="623">BWR pro Tag</cx:pt>
          <cx:pt idx="624">BWR pro Tag</cx:pt>
          <cx:pt idx="625">BWR pro Tag</cx:pt>
          <cx:pt idx="626">BWR pro Tag</cx:pt>
          <cx:pt idx="627">BWR pro Tag</cx:pt>
          <cx:pt idx="628">BWR pro Tag</cx:pt>
          <cx:pt idx="629">BWR pro Tag</cx:pt>
          <cx:pt idx="630">BWR pro Tag</cx:pt>
          <cx:pt idx="631">BWR pro Tag</cx:pt>
          <cx:pt idx="632">BWR pro Tag</cx:pt>
          <cx:pt idx="633">BWR pro Tag</cx:pt>
          <cx:pt idx="634">BWR pro Tag</cx:pt>
          <cx:pt idx="635">BWR pro Tag</cx:pt>
          <cx:pt idx="636">BWR pro Tag</cx:pt>
          <cx:pt idx="637">BWR pro Tag</cx:pt>
          <cx:pt idx="638">BWR pro Tag</cx:pt>
          <cx:pt idx="639">BWR pro Tag</cx:pt>
          <cx:pt idx="640">BWR pro Tag</cx:pt>
          <cx:pt idx="641">BWR pro Tag</cx:pt>
          <cx:pt idx="642">BWR pro Tag</cx:pt>
          <cx:pt idx="643">BWR pro Tag</cx:pt>
          <cx:pt idx="644">BWR pro Tag</cx:pt>
          <cx:pt idx="645">BWR pro Tag</cx:pt>
          <cx:pt idx="646">BWR pro Tag</cx:pt>
          <cx:pt idx="647">BWR pro Tag</cx:pt>
          <cx:pt idx="648">BWR pro Tag</cx:pt>
          <cx:pt idx="649">BWR pro Tag</cx:pt>
          <cx:pt idx="650">BWR pro Tag</cx:pt>
          <cx:pt idx="651">BWR pro Tag</cx:pt>
          <cx:pt idx="652">BWR pro Tag</cx:pt>
          <cx:pt idx="653">BWR pro Tag</cx:pt>
          <cx:pt idx="654">BWR pro Tag</cx:pt>
          <cx:pt idx="655">BWR pro Tag</cx:pt>
          <cx:pt idx="656">BWR pro Tag</cx:pt>
          <cx:pt idx="657">BWR pro Tag</cx:pt>
          <cx:pt idx="658">BWR pro Tag</cx:pt>
          <cx:pt idx="659">BWR pro Tag</cx:pt>
          <cx:pt idx="660">BWR pro Tag</cx:pt>
          <cx:pt idx="661">BWR pro Tag</cx:pt>
          <cx:pt idx="662">BWR pro Tag</cx:pt>
          <cx:pt idx="663">BWR pro Tag</cx:pt>
          <cx:pt idx="664">BWR pro Tag</cx:pt>
          <cx:pt idx="665">BWR pro Tag</cx:pt>
          <cx:pt idx="666">BWR pro Tag</cx:pt>
          <cx:pt idx="667">BWR pro Tag</cx:pt>
          <cx:pt idx="668">BWR pro Tag</cx:pt>
          <cx:pt idx="669">BWR pro Tag</cx:pt>
          <cx:pt idx="670">BWR pro Tag</cx:pt>
          <cx:pt idx="671">BWR pro Tag</cx:pt>
          <cx:pt idx="672">BWR pro Tag</cx:pt>
          <cx:pt idx="673">BWR pro Tag</cx:pt>
          <cx:pt idx="674">BWR pro Tag</cx:pt>
          <cx:pt idx="675">BWR pro Tag</cx:pt>
          <cx:pt idx="676">BWR pro Tag</cx:pt>
          <cx:pt idx="677">BWR pro Tag</cx:pt>
          <cx:pt idx="678">BWR pro Tag</cx:pt>
          <cx:pt idx="679">BWR pro Tag</cx:pt>
          <cx:pt idx="680">BWR pro Tag</cx:pt>
          <cx:pt idx="681">BWR pro Tag</cx:pt>
          <cx:pt idx="682">BWR pro Tag</cx:pt>
          <cx:pt idx="683">BWR pro Tag</cx:pt>
          <cx:pt idx="684">BWR pro Tag</cx:pt>
          <cx:pt idx="685">BWR pro Tag</cx:pt>
          <cx:pt idx="686">BWR pro Tag</cx:pt>
          <cx:pt idx="687">BWR pro Tag</cx:pt>
          <cx:pt idx="688">BWR pro Tag</cx:pt>
          <cx:pt idx="689">BWR pro Tag</cx:pt>
          <cx:pt idx="690">BWR pro Tag</cx:pt>
          <cx:pt idx="691">BWR pro Tag</cx:pt>
          <cx:pt idx="692">BWR pro Tag</cx:pt>
          <cx:pt idx="693">BWR pro Tag</cx:pt>
          <cx:pt idx="694">BWR pro Tag</cx:pt>
          <cx:pt idx="695">BWR pro Tag</cx:pt>
          <cx:pt idx="696">BWR pro Tag</cx:pt>
          <cx:pt idx="697">BWR pro Tag</cx:pt>
          <cx:pt idx="698">BWR pro Tag</cx:pt>
          <cx:pt idx="699">BWR pro Tag</cx:pt>
          <cx:pt idx="700">BWR pro Tag</cx:pt>
          <cx:pt idx="701">BWR pro Tag</cx:pt>
          <cx:pt idx="702">BWR pro Tag</cx:pt>
          <cx:pt idx="703">BWR pro Tag</cx:pt>
          <cx:pt idx="704">BWR pro Tag</cx:pt>
          <cx:pt idx="705">BWR pro Tag</cx:pt>
          <cx:pt idx="706">BWR pro Tag</cx:pt>
          <cx:pt idx="707">BWR pro Tag</cx:pt>
          <cx:pt idx="708">BWR pro Tag</cx:pt>
          <cx:pt idx="709">BWR pro Tag</cx:pt>
          <cx:pt idx="710">BWR pro Tag</cx:pt>
          <cx:pt idx="711">BWR pro Tag</cx:pt>
          <cx:pt idx="712">BWR pro Tag</cx:pt>
          <cx:pt idx="713">BWR pro Tag</cx:pt>
          <cx:pt idx="714">BWR pro Tag</cx:pt>
          <cx:pt idx="715">BWR pro Tag</cx:pt>
          <cx:pt idx="716">BWR pro Tag</cx:pt>
          <cx:pt idx="717">BWR pro Tag</cx:pt>
          <cx:pt idx="718">BWR pro Tag</cx:pt>
          <cx:pt idx="719">BWR pro Tag</cx:pt>
          <cx:pt idx="720">BWR pro Tag</cx:pt>
          <cx:pt idx="721">BWR pro Tag</cx:pt>
          <cx:pt idx="722">BWR pro Tag</cx:pt>
          <cx:pt idx="723">BWR pro Tag</cx:pt>
          <cx:pt idx="724">BWR pro Tag</cx:pt>
          <cx:pt idx="725">BWR pro Tag</cx:pt>
          <cx:pt idx="726">BWR pro Tag</cx:pt>
          <cx:pt idx="727">BWR pro Tag</cx:pt>
          <cx:pt idx="728">BWR pro Tag</cx:pt>
          <cx:pt idx="729">BWR pro Tag</cx:pt>
          <cx:pt idx="730">BWR pro Tag</cx:pt>
          <cx:pt idx="731">BWR pro Tag</cx:pt>
          <cx:pt idx="732">BWR pro Tag</cx:pt>
          <cx:pt idx="733">BWR pro Tag</cx:pt>
          <cx:pt idx="734">BWR pro Tag</cx:pt>
          <cx:pt idx="735">BWR pro Tag</cx:pt>
          <cx:pt idx="736">BWR pro Tag</cx:pt>
          <cx:pt idx="737">BWR pro Tag</cx:pt>
          <cx:pt idx="738">BWR pro Tag</cx:pt>
          <cx:pt idx="739">BWR pro Tag</cx:pt>
          <cx:pt idx="740">BWR pro Tag</cx:pt>
          <cx:pt idx="741">BWR pro Tag</cx:pt>
          <cx:pt idx="742">BWR pro Tag</cx:pt>
          <cx:pt idx="743">BWR pro Tag</cx:pt>
          <cx:pt idx="744">BWR pro Tag</cx:pt>
          <cx:pt idx="745">BWR pro Tag</cx:pt>
          <cx:pt idx="746">BWR pro Tag</cx:pt>
          <cx:pt idx="747">BWR pro Tag</cx:pt>
          <cx:pt idx="748">BWR pro Tag</cx:pt>
          <cx:pt idx="749">BWR pro Tag</cx:pt>
          <cx:pt idx="750">BWR pro Tag</cx:pt>
          <cx:pt idx="751">BWR pro Tag</cx:pt>
          <cx:pt idx="752">BWR pro Tag</cx:pt>
          <cx:pt idx="753">BWR pro Tag</cx:pt>
          <cx:pt idx="754">BWR pro Tag</cx:pt>
          <cx:pt idx="755">BWR pro Tag</cx:pt>
          <cx:pt idx="756">BWR pro Tag</cx:pt>
          <cx:pt idx="757">BWR pro Tag</cx:pt>
          <cx:pt idx="758">BWR pro Tag</cx:pt>
          <cx:pt idx="759">BWR pro Tag</cx:pt>
          <cx:pt idx="760">BWR pro Tag</cx:pt>
          <cx:pt idx="761">BWR pro Tag</cx:pt>
          <cx:pt idx="762">BWR pro Tag</cx:pt>
          <cx:pt idx="763">BWR pro Tag</cx:pt>
          <cx:pt idx="764">BWR pro Tag</cx:pt>
          <cx:pt idx="765">BWR pro Tag</cx:pt>
          <cx:pt idx="766">BWR pro Tag</cx:pt>
          <cx:pt idx="767">BWR pro Tag</cx:pt>
          <cx:pt idx="768">BWR pro Tag</cx:pt>
          <cx:pt idx="769">BWR pro Tag</cx:pt>
          <cx:pt idx="770">BWR pro Tag</cx:pt>
          <cx:pt idx="771">BWR pro Tag</cx:pt>
          <cx:pt idx="772">BWR pro Tag</cx:pt>
          <cx:pt idx="773">BWR pro Tag</cx:pt>
          <cx:pt idx="774">BWR pro Tag</cx:pt>
          <cx:pt idx="775">BWR pro Tag</cx:pt>
          <cx:pt idx="776">BWR pro Tag</cx:pt>
          <cx:pt idx="777">BWR pro Tag</cx:pt>
          <cx:pt idx="778">BWR pro Tag</cx:pt>
          <cx:pt idx="779">BWR pro Tag</cx:pt>
          <cx:pt idx="780">BWR pro Tag</cx:pt>
          <cx:pt idx="781">BWR pro Tag</cx:pt>
          <cx:pt idx="782">BWR pro Tag</cx:pt>
          <cx:pt idx="783">BWR pro Tag</cx:pt>
          <cx:pt idx="784">BWR pro Tag</cx:pt>
          <cx:pt idx="785">BWR pro Tag</cx:pt>
          <cx:pt idx="786">BWR pro Tag</cx:pt>
          <cx:pt idx="787">BWR pro Tag</cx:pt>
          <cx:pt idx="788">BWR pro Tag</cx:pt>
          <cx:pt idx="789">BWR pro Tag</cx:pt>
          <cx:pt idx="790">BWR pro Tag</cx:pt>
          <cx:pt idx="791">BWR pro Tag</cx:pt>
          <cx:pt idx="792">BWR pro Tag</cx:pt>
          <cx:pt idx="793">BWR pro Tag</cx:pt>
          <cx:pt idx="794">BWR pro Tag</cx:pt>
          <cx:pt idx="795">BWR pro Tag</cx:pt>
          <cx:pt idx="796">BWR pro Tag</cx:pt>
          <cx:pt idx="797">BWR pro Tag</cx:pt>
          <cx:pt idx="798">BWR pro Tag</cx:pt>
          <cx:pt idx="799">BWR pro Tag</cx:pt>
          <cx:pt idx="800">BWR pro Tag</cx:pt>
          <cx:pt idx="801">BWR pro Tag</cx:pt>
          <cx:pt idx="802">BWR pro Tag</cx:pt>
        </cx:lvl>
      </cx:strDim>
      <cx:numDim type="val">
        <cx:lvl ptCount="803" formatCode="General">
          <cx:pt idx="0">0.061461538461538463</cx:pt>
          <cx:pt idx="1">0.065153846153846146</cx:pt>
          <cx:pt idx="2">0.066923076923076918</cx:pt>
          <cx:pt idx="3">0.067272727272727276</cx:pt>
          <cx:pt idx="4">0.06876666666666667</cx:pt>
          <cx:pt idx="5">0.072738095238095241</cx:pt>
          <cx:pt idx="6">0.073749999999999996</cx:pt>
          <cx:pt idx="7">0.077206896551724136</cx:pt>
          <cx:pt idx="8">0.078875000000000001</cx:pt>
          <cx:pt idx="9">0.081574999999999995</cx:pt>
          <cx:pt idx="10">0.081666666666666665</cx:pt>
          <cx:pt idx="11">0.081892857142857142</cx:pt>
          <cx:pt idx="12">0.086199999999999999</cx:pt>
          <cx:pt idx="13">0.088333333333333333</cx:pt>
          <cx:pt idx="14">0.090117647058823525</cx:pt>
          <cx:pt idx="15">0.094111111111111104</cx:pt>
          <cx:pt idx="16">0.097099999999999992</cx:pt>
          <cx:pt idx="17">0.097199999999999995</cx:pt>
          <cx:pt idx="18">0.099599999999999994</cx:pt>
          <cx:pt idx="19">0.1000588235294118</cx:pt>
          <cx:pt idx="20">0.1014375</cx:pt>
          <cx:pt idx="21">0.1022</cx:pt>
          <cx:pt idx="22">0.1036363636363636</cx:pt>
          <cx:pt idx="23">0.1037</cx:pt>
          <cx:pt idx="24">0.10375</cx:pt>
          <cx:pt idx="25">0.1038666666666667</cx:pt>
          <cx:pt idx="26">0.103974358974359</cx:pt>
          <cx:pt idx="27">0.10625</cx:pt>
          <cx:pt idx="28">0.10858823529411769</cx:pt>
          <cx:pt idx="29">0.1197894736842105</cx:pt>
          <cx:pt idx="30">0.1199285714285714</cx:pt>
          <cx:pt idx="31">0.1202727272727273</cx:pt>
          <cx:pt idx="32">0.1246</cx:pt>
          <cx:pt idx="33">0.12512121212121211</cx:pt>
          <cx:pt idx="34">0.12712499999999999</cx:pt>
          <cx:pt idx="35">0.12713793103448279</cx:pt>
          <cx:pt idx="36">0.1277142857142857</cx:pt>
          <cx:pt idx="37">0.1282105263157895</cx:pt>
          <cx:pt idx="38">0.13142857142857139</cx:pt>
          <cx:pt idx="39">0.13257142857142859</cx:pt>
          <cx:pt idx="40">0.13566666666666671</cx:pt>
          <cx:pt idx="41">0.13644444444444451</cx:pt>
          <cx:pt idx="42">0.13700000000000001</cx:pt>
          <cx:pt idx="43">0.13775000000000001</cx:pt>
          <cx:pt idx="44">0.1392727272727273</cx:pt>
          <cx:pt idx="45">0.1417272727272727</cx:pt>
          <cx:pt idx="46">0.14199999999999999</cx:pt>
          <cx:pt idx="47">0.14346666666666669</cx:pt>
          <cx:pt idx="48">0.1439090909090909</cx:pt>
          <cx:pt idx="49">0.14563999999999999</cx:pt>
          <cx:pt idx="50">0.14566666666666669</cx:pt>
          <cx:pt idx="51">0.1466666666666667</cx:pt>
          <cx:pt idx="52">0.1493214285714286</cx:pt>
          <cx:pt idx="53">0.14949999999999999</cx:pt>
          <cx:pt idx="54">0.151</cx:pt>
          <cx:pt idx="55">0.152</cx:pt>
          <cx:pt idx="56">0.15281249999999999</cx:pt>
          <cx:pt idx="57">0.15395833333333331</cx:pt>
          <cx:pt idx="58">0.15494117647058819</cx:pt>
          <cx:pt idx="59">0.155</cx:pt>
          <cx:pt idx="60">0.1555</cx:pt>
          <cx:pt idx="61">0.15590000000000001</cx:pt>
          <cx:pt idx="62">0.15866666666666671</cx:pt>
          <cx:pt idx="63">0.1612105263157895</cx:pt>
          <cx:pt idx="64">0.16188888888888889</cx:pt>
          <cx:pt idx="65">0.16359016393442621</cx:pt>
          <cx:pt idx="66">0.16733333333333331</cx:pt>
          <cx:pt idx="67">0.16800000000000001</cx:pt>
          <cx:pt idx="68">0.16800000000000001</cx:pt>
          <cx:pt idx="69">0.170875</cx:pt>
          <cx:pt idx="70">0.17096551724137929</cx:pt>
          <cx:pt idx="71">0.17150000000000001</cx:pt>
          <cx:pt idx="72">0.1725416666666667</cx:pt>
          <cx:pt idx="73">0.17266666666666669</cx:pt>
          <cx:pt idx="74">0.17456250000000001</cx:pt>
          <cx:pt idx="75">0.17610714285714291</cx:pt>
          <cx:pt idx="76">0.17649999999999999</cx:pt>
          <cx:pt idx="77">0.17649999999999999</cx:pt>
          <cx:pt idx="78">0.17771428571428571</cx:pt>
          <cx:pt idx="79">0.17771428571428571</cx:pt>
          <cx:pt idx="80">0.17946666666666669</cx:pt>
          <cx:pt idx="81">0.1804166666666667</cx:pt>
          <cx:pt idx="82">0.18170588235294119</cx:pt>
          <cx:pt idx="83">0.18275</cx:pt>
          <cx:pt idx="84">0.1865</cx:pt>
          <cx:pt idx="85">0.188</cx:pt>
          <cx:pt idx="86">0.19</cx:pt>
          <cx:pt idx="87">0.19087499999999999</cx:pt>
          <cx:pt idx="88">0.1909411764705882</cx:pt>
          <cx:pt idx="89">0.191825</cx:pt>
          <cx:pt idx="90">0.19363461538461541</cx:pt>
          <cx:pt idx="91">0.19563636363636361</cx:pt>
          <cx:pt idx="92">0.19657142857142859</cx:pt>
          <cx:pt idx="93">0.19716666666666671</cx:pt>
          <cx:pt idx="94">0.1978571428571429</cx:pt>
          <cx:pt idx="95">0.19833333333333331</cx:pt>
          <cx:pt idx="96">0.1985625</cx:pt>
          <cx:pt idx="97">0.1998125</cx:pt>
          <cx:pt idx="98">0.20227777777777781</cx:pt>
          <cx:pt idx="99">0.202875</cx:pt>
          <cx:pt idx="100">0.203625</cx:pt>
          <cx:pt idx="101">0.2037272727272727</cx:pt>
          <cx:pt idx="102">0.20374999999999999</cx:pt>
          <cx:pt idx="103">0.2053571428571429</cx:pt>
          <cx:pt idx="104">0.20574999999999999</cx:pt>
          <cx:pt idx="105">0.2062380952380953</cx:pt>
          <cx:pt idx="106">0.21061764705882349</cx:pt>
          <cx:pt idx="107">0.21347619047619051</cx:pt>
          <cx:pt idx="108">0.2135</cx:pt>
          <cx:pt idx="109">0.21364</cx:pt>
          <cx:pt idx="110">0.21642857142857139</cx:pt>
          <cx:pt idx="111">0.2172</cx:pt>
          <cx:pt idx="112">0.218</cx:pt>
          <cx:pt idx="113">0.22</cx:pt>
          <cx:pt idx="114">0.22040909090909089</cx:pt>
          <cx:pt idx="115">0.2205</cx:pt>
          <cx:pt idx="116">0.22303999999999999</cx:pt>
          <cx:pt idx="117">0.22500000000000001</cx:pt>
          <cx:pt idx="118">0.22522727272727269</cx:pt>
          <cx:pt idx="119">0.2253636363636364</cx:pt>
          <cx:pt idx="120">0.22592000000000001</cx:pt>
          <cx:pt idx="121">0.2263260869565217</cx:pt>
          <cx:pt idx="122">0.2263333333333333</cx:pt>
          <cx:pt idx="123">0.22637499999999999</cx:pt>
          <cx:pt idx="124">0.2278333333333333</cx:pt>
          <cx:pt idx="125">0.2278333333333333</cx:pt>
          <cx:pt idx="126">0.22860655737704921</cx:pt>
          <cx:pt idx="127">0.22950000000000001</cx:pt>
          <cx:pt idx="128">0.2295454545454545</cx:pt>
          <cx:pt idx="129">0.23008695652173911</cx:pt>
          <cx:pt idx="130">0.23044999999999999</cx:pt>
          <cx:pt idx="131">0.23058333333333331</cx:pt>
          <cx:pt idx="132">0.2311470588235294</cx:pt>
          <cx:pt idx="133">0.23208510638297869</cx:pt>
          <cx:pt idx="134">0.23228571428571429</cx:pt>
          <cx:pt idx="135">0.23236363636363641</cx:pt>
          <cx:pt idx="136">0.23275000000000001</cx:pt>
          <cx:pt idx="137">0.23300000000000001</cx:pt>
          <cx:pt idx="138">0.2333529411764706</cx:pt>
          <cx:pt idx="139">0.23350000000000001</cx:pt>
          <cx:pt idx="140">0.23588461538461539</cx:pt>
          <cx:pt idx="141">0.23774999999999999</cx:pt>
          <cx:pt idx="142">0.23788135593220339</cx:pt>
          <cx:pt idx="143">0.23854545454545459</cx:pt>
          <cx:pt idx="144">0.23924137931034481</cx:pt>
          <cx:pt idx="145">0.24054545454545451</cx:pt>
          <cx:pt idx="146">0.2426666666666667</cx:pt>
          <cx:pt idx="147">0.24295833333333339</cx:pt>
          <cx:pt idx="148">0.2433030303030303</cx:pt>
          <cx:pt idx="149">0.24372413793103451</cx:pt>
          <cx:pt idx="150">0.24442857142857141</cx:pt>
          <cx:pt idx="151">0.245</cx:pt>
          <cx:pt idx="152">0.2463823529411765</cx:pt>
          <cx:pt idx="153">0.2463823529411765</cx:pt>
          <cx:pt idx="154">0.24663636363636371</cx:pt>
          <cx:pt idx="155">0.24831578947368421</cx:pt>
          <cx:pt idx="156">0.24959999999999999</cx:pt>
          <cx:pt idx="157">0.24970588235294119</cx:pt>
          <cx:pt idx="158">0.24970588235294119</cx:pt>
          <cx:pt idx="159">0.25</cx:pt>
          <cx:pt idx="160">0.25146511627906981</cx:pt>
          <cx:pt idx="161">0.25253846153846149</cx:pt>
          <cx:pt idx="162">0.25462499999999999</cx:pt>
          <cx:pt idx="163">0.25530769230769229</cx:pt>
          <cx:pt idx="164">0.25633333333333341</cx:pt>
          <cx:pt idx="165">0.25638461538461538</cx:pt>
          <cx:pt idx="166">0.25672727272727269</cx:pt>
          <cx:pt idx="167">0.25714285714285717</cx:pt>
          <cx:pt idx="168">0.26096551724137929</cx:pt>
          <cx:pt idx="169">0.26111111111111113</cx:pt>
          <cx:pt idx="170">0.26111111111111113</cx:pt>
          <cx:pt idx="171">0.2621904761904762</cx:pt>
          <cx:pt idx="172">0.26288888888888889</cx:pt>
          <cx:pt idx="173">0.26477272727272733</cx:pt>
          <cx:pt idx="174">0.26504545454545458</cx:pt>
          <cx:pt idx="175">0.26531250000000001</cx:pt>
          <cx:pt idx="176">0.26531250000000001</cx:pt>
          <cx:pt idx="177">0.26627586206896547</cx:pt>
          <cx:pt idx="178">0.26678571428571429</cx:pt>
          <cx:pt idx="179">0.26868292682926831</cx:pt>
          <cx:pt idx="180">0.27068750000000003</cx:pt>
          <cx:pt idx="181">0.27151999999999998</cx:pt>
          <cx:pt idx="182">0.27174999999999999</cx:pt>
          <cx:pt idx="183">0.27287499999999998</cx:pt>
          <cx:pt idx="184">0.27339999999999998</cx:pt>
          <cx:pt idx="185">0.27339999999999998</cx:pt>
          <cx:pt idx="186">0.27339999999999998</cx:pt>
          <cx:pt idx="187">0.27400000000000002</cx:pt>
          <cx:pt idx="188">0.2765833333333334</cx:pt>
          <cx:pt idx="189">0.27687499999999998</cx:pt>
          <cx:pt idx="190">0.27775</cx:pt>
          <cx:pt idx="191">0.27902777777777782</cx:pt>
          <cx:pt idx="192">0.28128571428571431</cx:pt>
          <cx:pt idx="193">0.2826285714285714</cx:pt>
          <cx:pt idx="194">0.28275</cx:pt>
          <cx:pt idx="195">0.28275</cx:pt>
          <cx:pt idx="196">0.28377777777777768</cx:pt>
          <cx:pt idx="197">0.28403773584905662</cx:pt>
          <cx:pt idx="198">0.28466666666666668</cx:pt>
          <cx:pt idx="199">0.28881818181818181</cx:pt>
          <cx:pt idx="200">0.28881818181818181</cx:pt>
          <cx:pt idx="201">0.28936363636363632</cx:pt>
          <cx:pt idx="202">0.2906071428571429</cx:pt>
          <cx:pt idx="203">0.29383333333333328</cx:pt>
          <cx:pt idx="204">0.29449999999999998</cx:pt>
          <cx:pt idx="205">0.29594736842105263</cx:pt>
          <cx:pt idx="206">0.29917857142857152</cx:pt>
          <cx:pt idx="207">0.29917857142857152</cx:pt>
          <cx:pt idx="208">0.30004999999999998</cx:pt>
          <cx:pt idx="209">0.30020833333333341</cx:pt>
          <cx:pt idx="210">0.30045833333333333</cx:pt>
          <cx:pt idx="211">0.30062499999999998</cx:pt>
          <cx:pt idx="212">0.30099999999999999</cx:pt>
          <cx:pt idx="213">0.30376190476190468</cx:pt>
          <cx:pt idx="214">0.30689473684210528</cx:pt>
          <cx:pt idx="215">0.307</cx:pt>
          <cx:pt idx="216">0.307</cx:pt>
          <cx:pt idx="217">0.30730434782608701</cx:pt>
          <cx:pt idx="218">0.30816666666666659</cx:pt>
          <cx:pt idx="219">0.30890000000000001</cx:pt>
          <cx:pt idx="220">0.30987500000000001</cx:pt>
          <cx:pt idx="221">0.30989473684210528</cx:pt>
          <cx:pt idx="222">0.31025925925925929</cx:pt>
          <cx:pt idx="223">0.31025925925925929</cx:pt>
          <cx:pt idx="224">0.31129411764705878</cx:pt>
          <cx:pt idx="225">0.31242857142857139</cx:pt>
          <cx:pt idx="226">0.31242857142857139</cx:pt>
          <cx:pt idx="227">0.3133333333333333</cx:pt>
          <cx:pt idx="228">0.316</cx:pt>
          <cx:pt idx="229">0.3165</cx:pt>
          <cx:pt idx="230">0.31683333333333341</cx:pt>
          <cx:pt idx="231">0.3174285714285715</cx:pt>
          <cx:pt idx="232">0.31769999999999998</cx:pt>
          <cx:pt idx="233">0.31769999999999998</cx:pt>
          <cx:pt idx="234">0.31790000000000002</cx:pt>
          <cx:pt idx="235">0.318</cx:pt>
          <cx:pt idx="236">0.318</cx:pt>
          <cx:pt idx="237">0.31858333333333327</cx:pt>
          <cx:pt idx="238">0.31950000000000001</cx:pt>
          <cx:pt idx="239">0.32219230769230772</cx:pt>
          <cx:pt idx="240">0.32219230769230772</cx:pt>
          <cx:pt idx="241">0.3236</cx:pt>
          <cx:pt idx="242">0.32516666666666671</cx:pt>
          <cx:pt idx="243">0.32611111111111107</cx:pt>
          <cx:pt idx="244">0.3278571428571429</cx:pt>
          <cx:pt idx="245">0.32940000000000003</cx:pt>
          <cx:pt idx="246">0.33024999999999999</cx:pt>
          <cx:pt idx="247">0.33061538461538459</cx:pt>
          <cx:pt idx="248">0.33061538461538459</cx:pt>
          <cx:pt idx="249">0.33074999999999999</cx:pt>
          <cx:pt idx="250">0.33223529411764702</cx:pt>
          <cx:pt idx="251">0.33223529411764702</cx:pt>
          <cx:pt idx="252">0.33300000000000002</cx:pt>
          <cx:pt idx="253">0.33360869565217388</cx:pt>
          <cx:pt idx="254">0.33381818181818179</cx:pt>
          <cx:pt idx="255">0.33505263157894732</cx:pt>
          <cx:pt idx="256">0.33507999999999999</cx:pt>
          <cx:pt idx="257">0.33507999999999999</cx:pt>
          <cx:pt idx="258">0.33657142857142858</cx:pt>
          <cx:pt idx="259">0.33689999999999998</cx:pt>
          <cx:pt idx="260">0.33700000000000002</cx:pt>
          <cx:pt idx="261">0.33700000000000002</cx:pt>
          <cx:pt idx="262">0.33700000000000002</cx:pt>
          <cx:pt idx="263">0.33750000000000002</cx:pt>
          <cx:pt idx="264">0.33800000000000002</cx:pt>
          <cx:pt idx="265">0.34175</cx:pt>
          <cx:pt idx="266">0.34175</cx:pt>
          <cx:pt idx="267">0.34175</cx:pt>
          <cx:pt idx="268">0.3422</cx:pt>
          <cx:pt idx="269">0.34222727272727271</cx:pt>
          <cx:pt idx="270">0.34309523809523812</cx:pt>
          <cx:pt idx="271">0.34644444444444439</cx:pt>
          <cx:pt idx="272">0.34727272727272718</cx:pt>
          <cx:pt idx="273">0.34833333333333327</cx:pt>
          <cx:pt idx="274">0.34868965517241379</cx:pt>
          <cx:pt idx="275">0.34904166666666669</cx:pt>
          <cx:pt idx="276">0.34904166666666669</cx:pt>
          <cx:pt idx="277">0.34989999999999999</cx:pt>
          <cx:pt idx="278">0.35084848484848491</cx:pt>
          <cx:pt idx="279">0.35099999999999998</cx:pt>
          <cx:pt idx="280">0.35166666666666668</cx:pt>
          <cx:pt idx="281">0.35299999999999998</cx:pt>
          <cx:pt idx="282">0.35312962962962963</cx:pt>
          <cx:pt idx="283">0.35375000000000001</cx:pt>
          <cx:pt idx="284">0.35499999999999998</cx:pt>
          <cx:pt idx="285">0.35535483870967738</cx:pt>
          <cx:pt idx="286">0.3560666666666667</cx:pt>
          <cx:pt idx="287">0.3560666666666667</cx:pt>
          <cx:pt idx="288">0.3574</cx:pt>
          <cx:pt idx="289">0.35909090909090913</cx:pt>
          <cx:pt idx="290">0.36062499999999997</cx:pt>
          <cx:pt idx="291">0.36071428571428571</cx:pt>
          <cx:pt idx="292">0.36181249999999998</cx:pt>
          <cx:pt idx="293">0.3624</cx:pt>
          <cx:pt idx="294">0.36421739130434788</cx:pt>
          <cx:pt idx="295">0.36421739130434788</cx:pt>
          <cx:pt idx="296">0.36421739130434788</cx:pt>
          <cx:pt idx="297">0.36425000000000002</cx:pt>
          <cx:pt idx="298">0.36720000000000003</cx:pt>
          <cx:pt idx="299">0.36720000000000003</cx:pt>
          <cx:pt idx="300">0.36879411764705877</cx:pt>
          <cx:pt idx="301">0.37044736842105258</cx:pt>
          <cx:pt idx="302">0.3708636363636364</cx:pt>
          <cx:pt idx="303">0.37223809523809531</cx:pt>
          <cx:pt idx="304">0.37373913043478257</cx:pt>
          <cx:pt idx="305">0.37614285714285722</cx:pt>
          <cx:pt idx="306">0.37653333333333328</cx:pt>
          <cx:pt idx="307">0.377</cx:pt>
          <cx:pt idx="308">0.37859999999999999</cx:pt>
          <cx:pt idx="309">0.38019999999999998</cx:pt>
          <cx:pt idx="310">0.38019999999999998</cx:pt>
          <cx:pt idx="311">0.3806956521739131</cx:pt>
          <cx:pt idx="312">0.38077272727272732</cx:pt>
          <cx:pt idx="313">0.38077272727272732</cx:pt>
          <cx:pt idx="314">0.38077272727272732</cx:pt>
          <cx:pt idx="315">0.38077272727272732</cx:pt>
          <cx:pt idx="316">0.38077272727272732</cx:pt>
          <cx:pt idx="317">0.3813333333333333</cx:pt>
          <cx:pt idx="318">0.38590909090909092</cx:pt>
          <cx:pt idx="319">0.38590909090909092</cx:pt>
          <cx:pt idx="320">0.38590909090909092</cx:pt>
          <cx:pt idx="321">0.38892307692307693</cx:pt>
          <cx:pt idx="322">0.38950000000000001</cx:pt>
          <cx:pt idx="323">0.39016666666666672</cx:pt>
          <cx:pt idx="324">0.39107142857142863</cx:pt>
          <cx:pt idx="325">0.39266666666666672</cx:pt>
          <cx:pt idx="326">0.39316666666666672</cx:pt>
          <cx:pt idx="327">0.39500000000000002</cx:pt>
          <cx:pt idx="328">0.39533333333333331</cx:pt>
          <cx:pt idx="329">0.395625</cx:pt>
          <cx:pt idx="330">0.39851999999999999</cx:pt>
          <cx:pt idx="331">0.39890476190476187</cx:pt>
          <cx:pt idx="332">0.40177777777777779</cx:pt>
          <cx:pt idx="333">0.40180769230769231</cx:pt>
          <cx:pt idx="334">0.40264912280701748</cx:pt>
          <cx:pt idx="335">0.40342857142857141</cx:pt>
          <cx:pt idx="336">0.40412068965517239</cx:pt>
          <cx:pt idx="337">0.40421052631578952</cx:pt>
          <cx:pt idx="338">0.40448000000000001</cx:pt>
          <cx:pt idx="339">0.40649999999999997</cx:pt>
          <cx:pt idx="340">0.40707692307692311</cx:pt>
          <cx:pt idx="341">0.4078461538461538</cx:pt>
          <cx:pt idx="342">0.40832000000000002</cx:pt>
          <cx:pt idx="343">0.40933333333333333</cx:pt>
          <cx:pt idx="344">0.4105185185185185</cx:pt>
          <cx:pt idx="345">0.41084615384615392</cx:pt>
          <cx:pt idx="346">0.41142105263157902</cx:pt>
          <cx:pt idx="347">0.41178947368421048</cx:pt>
          <cx:pt idx="348">0.4167142857142857</cx:pt>
          <cx:pt idx="349">0.41885000000000011</cx:pt>
          <cx:pt idx="350">0.41899999999999998</cx:pt>
          <cx:pt idx="351">0.42018749999999999</cx:pt>
          <cx:pt idx="352">0.42057746478873242</cx:pt>
          <cx:pt idx="353">0.42133333333333328</cx:pt>
          <cx:pt idx="354">0.42199999999999999</cx:pt>
          <cx:pt idx="355">0.42449999999999999</cx:pt>
          <cx:pt idx="356">0.42641772151898732</cx:pt>
          <cx:pt idx="357">0.42699999999999999</cx:pt>
          <cx:pt idx="358">0.42881481481481482</cx:pt>
          <cx:pt idx="359">0.42980000000000002</cx:pt>
          <cx:pt idx="360">0.43033333333333329</cx:pt>
          <cx:pt idx="361">0.43446153846153851</cx:pt>
          <cx:pt idx="362">0.43807142857142861</cx:pt>
          <cx:pt idx="363">0.43922222222222218</cx:pt>
          <cx:pt idx="364">0.44089473684210528</cx:pt>
          <cx:pt idx="365">0.44089473684210528</cx:pt>
          <cx:pt idx="366">0.4413653846153846</cx:pt>
          <cx:pt idx="367">0.4428823529411765</cx:pt>
          <cx:pt idx="368">0.443</cx:pt>
          <cx:pt idx="369">0.44719999999999999</cx:pt>
          <cx:pt idx="370">0.44719999999999999</cx:pt>
          <cx:pt idx="371">0.45001960784313733</cx:pt>
          <cx:pt idx="372">0.45045454545454539</cx:pt>
          <cx:pt idx="373">0.45409677419354838</cx:pt>
          <cx:pt idx="374">0.4542173913043478</cx:pt>
          <cx:pt idx="375">0.45566666666666672</cx:pt>
          <cx:pt idx="376">0.45600000000000002</cx:pt>
          <cx:pt idx="377">0.45963636363636362</cx:pt>
          <cx:pt idx="378">0.46124999999999999</cx:pt>
          <cx:pt idx="379">0.46311999999999998</cx:pt>
          <cx:pt idx="380">0.46475510204081633</cx:pt>
          <cx:pt idx="381">0.46538888888888891</cx:pt>
          <cx:pt idx="382">0.46538888888888891</cx:pt>
          <cx:pt idx="383">0.46538888888888891</cx:pt>
          <cx:pt idx="384">0.46538888888888891</cx:pt>
          <cx:pt idx="385">0.46538888888888891</cx:pt>
          <cx:pt idx="386">0.46609090909090911</cx:pt>
          <cx:pt idx="387">0.46609090909090911</cx:pt>
          <cx:pt idx="388">0.46709523809523812</cx:pt>
          <cx:pt idx="389">0.46923333333333328</cx:pt>
          <cx:pt idx="390">0.47033333333333333</cx:pt>
          <cx:pt idx="391">0.4703846153846154</cx:pt>
          <cx:pt idx="392">0.47056249999999999</cx:pt>
          <cx:pt idx="393">0.47066666666666662</cx:pt>
          <cx:pt idx="394">0.47120000000000001</cx:pt>
          <cx:pt idx="395">0.47166666666666668</cx:pt>
          <cx:pt idx="396">0.47166666666666668</cx:pt>
          <cx:pt idx="397">0.47166666666666668</cx:pt>
          <cx:pt idx="398">0.4718</cx:pt>
          <cx:pt idx="399">0.4726111111111112</cx:pt>
          <cx:pt idx="400">0.47525000000000001</cx:pt>
          <cx:pt idx="401">0.47830000000000011</cx:pt>
          <cx:pt idx="402">0.48152380952380952</cx:pt>
          <cx:pt idx="403">0.48326190476190478</cx:pt>
          <cx:pt idx="404">0.48545454545454542</cx:pt>
          <cx:pt idx="405">0.48828571428571432</cx:pt>
          <cx:pt idx="406">0.4896923076923077</cx:pt>
          <cx:pt idx="407">0.4896923076923077</cx:pt>
          <cx:pt idx="408">0.49184615384615388</cx:pt>
          <cx:pt idx="409">0.49184615384615388</cx:pt>
          <cx:pt idx="410">0.49276470588235299</cx:pt>
          <cx:pt idx="411">0.49276470588235299</cx:pt>
          <cx:pt idx="412">0.49276470588235299</cx:pt>
          <cx:pt idx="413">0.49276470588235299</cx:pt>
          <cx:pt idx="414">0.49276470588235299</cx:pt>
          <cx:pt idx="415">0.50115384615384617</cx:pt>
          <cx:pt idx="416">0.50156000000000001</cx:pt>
          <cx:pt idx="417">0.50224999999999997</cx:pt>
          <cx:pt idx="418">0.50339130434782609</cx:pt>
          <cx:pt idx="419">0.50339130434782609</cx:pt>
          <cx:pt idx="420">0.50439999999999996</cx:pt>
          <cx:pt idx="421">0.50560000000000005</cx:pt>
          <cx:pt idx="422">0.50564705882352945</cx:pt>
          <cx:pt idx="423">0.50564705882352945</cx:pt>
          <cx:pt idx="424">0.50724999999999998</cx:pt>
          <cx:pt idx="425">0.50724999999999998</cx:pt>
          <cx:pt idx="426">0.50724999999999998</cx:pt>
          <cx:pt idx="427">0.50828571428571423</cx:pt>
          <cx:pt idx="428">0.50958333333333328</cx:pt>
          <cx:pt idx="429">0.51222222222222225</cx:pt>
          <cx:pt idx="430">0.51276923076923075</cx:pt>
          <cx:pt idx="431">0.51345454545454539</cx:pt>
          <cx:pt idx="432">0.51464285714285718</cx:pt>
          <cx:pt idx="433">0.51715384615384619</cx:pt>
          <cx:pt idx="434">0.51863076923076923</cx:pt>
          <cx:pt idx="435">0.51966666666666661</cx:pt>
          <cx:pt idx="436">0.52137037037037037</cx:pt>
          <cx:pt idx="437">0.52356250000000004</cx:pt>
          <cx:pt idx="438">0.52356250000000004</cx:pt>
          <cx:pt idx="439">0.52414285714285713</cx:pt>
          <cx:pt idx="440">0.52457142857142858</cx:pt>
          <cx:pt idx="441">0.52627272727272723</cx:pt>
          <cx:pt idx="442">0.52715789473684216</cx:pt>
          <cx:pt idx="443">0.52780952380952384</cx:pt>
          <cx:pt idx="444">0.52865000000000006</cx:pt>
          <cx:pt idx="445">0.52871428571428569</cx:pt>
          <cx:pt idx="446">0.53049999999999997</cx:pt>
          <cx:pt idx="447">0.53062500000000001</cx:pt>
          <cx:pt idx="448">0.53062500000000001</cx:pt>
          <cx:pt idx="449">0.53062500000000001</cx:pt>
          <cx:pt idx="450">0.53062500000000001</cx:pt>
          <cx:pt idx="451">0.53062500000000001</cx:pt>
          <cx:pt idx="452">0.53062500000000001</cx:pt>
          <cx:pt idx="453">0.53062500000000001</cx:pt>
          <cx:pt idx="454">0.53062500000000001</cx:pt>
          <cx:pt idx="455">0.53221052631578947</cx:pt>
          <cx:pt idx="456">0.53364035087719297</cx:pt>
          <cx:pt idx="457">0.53439999999999999</cx:pt>
          <cx:pt idx="458">0.53666666666666663</cx:pt>
          <cx:pt idx="459">0.53778571428571431</cx:pt>
          <cx:pt idx="460">0.53933333333333333</cx:pt>
          <cx:pt idx="461">0.53933333333333333</cx:pt>
          <cx:pt idx="462">0.53955882352941176</cx:pt>
          <cx:pt idx="463">0.53968421052631577</cx:pt>
          <cx:pt idx="464">0.5414230769230769</cx:pt>
          <cx:pt idx="465">0.5436923076923077</cx:pt>
          <cx:pt idx="466">0.54645238095238091</cx:pt>
          <cx:pt idx="467">0.54645238095238091</cx:pt>
          <cx:pt idx="468">0.54716666666666669</cx:pt>
          <cx:pt idx="469">0.5498421052631578</cx:pt>
          <cx:pt idx="470">0.55462500000000003</cx:pt>
          <cx:pt idx="471">0.5577037037037037</cx:pt>
          <cx:pt idx="472">0.55811926605504592</cx:pt>
          <cx:pt idx="473">0.55846666666666667</cx:pt>
          <cx:pt idx="474">0.55846666666666667</cx:pt>
          <cx:pt idx="475">0.56159999999999999</cx:pt>
          <cx:pt idx="476">0.56177777777777782</cx:pt>
          <cx:pt idx="477">0.57047058823529417</cx:pt>
          <cx:pt idx="478">0.57136842105263153</cx:pt>
          <cx:pt idx="479">0.57198412698412693</cx:pt>
          <cx:pt idx="480">0.57198412698412693</cx:pt>
          <cx:pt idx="481">0.57306666666666672</cx:pt>
          <cx:pt idx="482">0.57306666666666672</cx:pt>
          <cx:pt idx="483">0.57328124999999996</cx:pt>
          <cx:pt idx="484">0.57377500000000003</cx:pt>
          <cx:pt idx="485">0.57520000000000004</cx:pt>
          <cx:pt idx="486">0.57872727272727265</cx:pt>
          <cx:pt idx="487">0.57872727272727265</cx:pt>
          <cx:pt idx="488">0.57889999999999997</cx:pt>
          <cx:pt idx="489">0.57889999999999997</cx:pt>
          <cx:pt idx="490">0.57889999999999997</cx:pt>
          <cx:pt idx="491">0.57978947368421052</cx:pt>
          <cx:pt idx="492">0.58566666666666667</cx:pt>
          <cx:pt idx="493">0.58899999999999997</cx:pt>
          <cx:pt idx="494">0.58975</cx:pt>
          <cx:pt idx="495">0.59227272727272728</cx:pt>
          <cx:pt idx="496">0.59799999999999998</cx:pt>
          <cx:pt idx="497">0.59835714285714292</cx:pt>
          <cx:pt idx="498">0.59835714285714292</cx:pt>
          <cx:pt idx="499">0.59835714285714292</cx:pt>
          <cx:pt idx="500">0.59835714285714292</cx:pt>
          <cx:pt idx="501">0.59835714285714292</cx:pt>
          <cx:pt idx="502">0.59835714285714292</cx:pt>
          <cx:pt idx="503">0.60058333333333325</cx:pt>
          <cx:pt idx="504">0.60231999999999997</cx:pt>
          <cx:pt idx="505">0.60317647058823531</cx:pt>
          <cx:pt idx="506">0.60317647058823531</cx:pt>
          <cx:pt idx="507">0.60642857142857143</cx:pt>
          <cx:pt idx="508">0.60642857142857143</cx:pt>
          <cx:pt idx="509">0.60642857142857143</cx:pt>
          <cx:pt idx="510">0.60642857142857143</cx:pt>
          <cx:pt idx="511">0.60642857142857143</cx:pt>
          <cx:pt idx="512">0.60642857142857143</cx:pt>
          <cx:pt idx="513">0.60914285714285721</cx:pt>
          <cx:pt idx="514">0.61118181818181816</cx:pt>
          <cx:pt idx="515">0.61399999999999999</cx:pt>
          <cx:pt idx="516">0.61452941176470588</cx:pt>
          <cx:pt idx="517">0.6213333333333334</cx:pt>
          <cx:pt idx="518">0.62741666666666662</cx:pt>
          <cx:pt idx="519">0.62741666666666662</cx:pt>
          <cx:pt idx="520">0.62849999999999995</cx:pt>
          <cx:pt idx="521">0.63124999999999998</cx:pt>
          <cx:pt idx="522">0.63138888888888889</cx:pt>
          <cx:pt idx="523">0.63200000000000001</cx:pt>
          <cx:pt idx="524">0.63258620689655165</cx:pt>
          <cx:pt idx="525">0.63366666666666671</cx:pt>
          <cx:pt idx="526">0.63366666666666671</cx:pt>
          <cx:pt idx="527">0.63659999999999994</cx:pt>
          <cx:pt idx="528">0.6375277777777778</cx:pt>
          <cx:pt idx="529">0.63863333333333328</cx:pt>
          <cx:pt idx="530">0.63941666666666663</cx:pt>
          <cx:pt idx="531">0.63986363636363641</cx:pt>
          <cx:pt idx="532">0.64087499999999997</cx:pt>
          <cx:pt idx="533">0.64438461538461544</cx:pt>
          <cx:pt idx="534">0.64438461538461544</cx:pt>
          <cx:pt idx="535">0.64438461538461544</cx:pt>
          <cx:pt idx="536">0.64438461538461544</cx:pt>
          <cx:pt idx="537">0.64438461538461544</cx:pt>
          <cx:pt idx="538">0.64438461538461544</cx:pt>
          <cx:pt idx="539">0.64471428571428568</cx:pt>
          <cx:pt idx="540">0.64471428571428568</cx:pt>
          <cx:pt idx="541">0.64471428571428568</cx:pt>
          <cx:pt idx="542">0.64471428571428568</cx:pt>
          <cx:pt idx="543">0.65469565217391301</cx:pt>
          <cx:pt idx="544">0.65517857142857139</cx:pt>
          <cx:pt idx="545">0.65518181818181809</cx:pt>
          <cx:pt idx="546">0.66099999999999992</cx:pt>
          <cx:pt idx="547">0.66123076923076929</cx:pt>
          <cx:pt idx="548">0.66149999999999998</cx:pt>
          <cx:pt idx="549">0.67166666666666675</cx:pt>
          <cx:pt idx="550">0.67502941176470588</cx:pt>
          <cx:pt idx="551">0.67944444444444441</cx:pt>
          <cx:pt idx="552">0.67990566037735845</cx:pt>
          <cx:pt idx="553">0.68105882352941172</cx:pt>
          <cx:pt idx="554">0.6818333333333334</cx:pt>
          <cx:pt idx="555">0.6818333333333334</cx:pt>
          <cx:pt idx="556">0.6818333333333334</cx:pt>
          <cx:pt idx="557">0.6825</cx:pt>
          <cx:pt idx="558">0.68359999999999999</cx:pt>
          <cx:pt idx="559">0.68359999999999999</cx:pt>
          <cx:pt idx="560">0.68366666666666676</cx:pt>
          <cx:pt idx="561">0.68424999999999991</cx:pt>
          <cx:pt idx="562">0.69228571428571428</cx:pt>
          <cx:pt idx="563">0.69228571428571428</cx:pt>
          <cx:pt idx="564">0.69548484848484848</cx:pt>
          <cx:pt idx="565">0.69548484848484848</cx:pt>
          <cx:pt idx="566">0.69808333333333339</cx:pt>
          <cx:pt idx="567">0.69808333333333339</cx:pt>
          <cx:pt idx="568">0.69808333333333339</cx:pt>
          <cx:pt idx="569">0.69808333333333339</cx:pt>
          <cx:pt idx="570">0.69808333333333339</cx:pt>
          <cx:pt idx="571">0.69808333333333339</cx:pt>
          <cx:pt idx="572">0.69808333333333339</cx:pt>
          <cx:pt idx="573">0.70384999999999998</cx:pt>
          <cx:pt idx="574">0.70384999999999998</cx:pt>
          <cx:pt idx="575">0.70384999999999998</cx:pt>
          <cx:pt idx="576">0.70486666666666664</cx:pt>
          <cx:pt idx="577">0.70557692307692299</cx:pt>
          <cx:pt idx="578">0.70733333333333326</cx:pt>
          <cx:pt idx="579">0.70750000000000002</cx:pt>
          <cx:pt idx="580">0.70750000000000002</cx:pt>
          <cx:pt idx="581">0.70750000000000002</cx:pt>
          <cx:pt idx="582">0.70750000000000002</cx:pt>
          <cx:pt idx="583">0.70750000000000002</cx:pt>
          <cx:pt idx="584">0.70750000000000002</cx:pt>
          <cx:pt idx="585">0.70750000000000002</cx:pt>
          <cx:pt idx="586">0.70750000000000002</cx:pt>
          <cx:pt idx="587">0.70785714285714285</cx:pt>
          <cx:pt idx="588">0.70959259259259255</cx:pt>
          <cx:pt idx="589">0.71260000000000001</cx:pt>
          <cx:pt idx="590">0.71542857142857141</cx:pt>
          <cx:pt idx="591">0.71633333333333338</cx:pt>
          <cx:pt idx="592">0.72050000000000003</cx:pt>
          <cx:pt idx="593">0.72228571428571431</cx:pt>
          <cx:pt idx="594">0.72362499999999996</cx:pt>
          <cx:pt idx="595">0.72362499999999996</cx:pt>
          <cx:pt idx="596">0.72362499999999996</cx:pt>
          <cx:pt idx="597">0.72640000000000005</cx:pt>
          <cx:pt idx="598">0.72887500000000005</cx:pt>
          <cx:pt idx="599">0.73242857142857143</cx:pt>
          <cx:pt idx="600">0.73242857142857143</cx:pt>
          <cx:pt idx="601">0.73242857142857143</cx:pt>
          <cx:pt idx="602">0.73242857142857143</cx:pt>
          <cx:pt idx="603">0.73242857142857143</cx:pt>
          <cx:pt idx="604">0.73242857142857143</cx:pt>
          <cx:pt idx="605">0.74913333333333332</cx:pt>
          <cx:pt idx="606">0.75070491803278683</cx:pt>
          <cx:pt idx="607">0.75290000000000001</cx:pt>
          <cx:pt idx="608">0.75290000000000001</cx:pt>
          <cx:pt idx="609">0.76154545454545464</cx:pt>
          <cx:pt idx="610">0.76154545454545464</cx:pt>
          <cx:pt idx="611">0.76154545454545464</cx:pt>
          <cx:pt idx="612">0.76154545454545464</cx:pt>
          <cx:pt idx="613">0.76154545454545464</cx:pt>
          <cx:pt idx="614">0.76154545454545464</cx:pt>
          <cx:pt idx="615">0.76503333333333334</cx:pt>
          <cx:pt idx="616">0.76503333333333334</cx:pt>
          <cx:pt idx="617">0.76503333333333334</cx:pt>
          <cx:pt idx="618">0.76503333333333334</cx:pt>
          <cx:pt idx="619">0.77006329113924055</cx:pt>
          <cx:pt idx="620">0.77731249999999996</cx:pt>
          <cx:pt idx="621">0.77731249999999996</cx:pt>
          <cx:pt idx="622">0.77733333333333332</cx:pt>
          <cx:pt idx="623">0.77784615384615385</cx:pt>
          <cx:pt idx="624">0.77784615384615385</cx:pt>
          <cx:pt idx="625">0.78170000000000006</cx:pt>
          <cx:pt idx="626">0.7820555555555555</cx:pt>
          <cx:pt idx="627">0.7820555555555555</cx:pt>
          <cx:pt idx="628">0.78360000000000007</cx:pt>
          <cx:pt idx="629">0.78360000000000007</cx:pt>
          <cx:pt idx="630">0.78533333333333333</cx:pt>
          <cx:pt idx="631">0.78876923076923078</cx:pt>
          <cx:pt idx="632">0.7895344827586207</cx:pt>
          <cx:pt idx="633">0.79574999999999996</cx:pt>
          <cx:pt idx="634">0.79574999999999996</cx:pt>
          <cx:pt idx="635">0.79760869565217385</cx:pt>
          <cx:pt idx="636">0.79760869565217385</cx:pt>
          <cx:pt idx="637">0.80055555555555558</cx:pt>
          <cx:pt idx="638">0.81084999999999996</cx:pt>
          <cx:pt idx="639">0.8177321428571428</cx:pt>
          <cx:pt idx="640">0.81967857142857148</cx:pt>
          <cx:pt idx="641">0.81967857142857148</cx:pt>
          <cx:pt idx="642">0.82699999999999996</cx:pt>
          <cx:pt idx="643">0.82805882352941174</cx:pt>
          <cx:pt idx="644">0.82805882352941174</cx:pt>
          <cx:pt idx="645">0.82913333333333328</cx:pt>
          <cx:pt idx="646">0.83325000000000005</cx:pt>
          <cx:pt idx="647">0.83386363636363636</cx:pt>
          <cx:pt idx="648">0.83507692307692305</cx:pt>
          <cx:pt idx="649">0.83770000000000011</cx:pt>
          <cx:pt idx="650">0.83770000000000011</cx:pt>
          <cx:pt idx="651">0.83770000000000011</cx:pt>
          <cx:pt idx="652">0.83770000000000011</cx:pt>
          <cx:pt idx="653">0.84266666666666667</cx:pt>
          <cx:pt idx="654">0.84899999999999998</cx:pt>
          <cx:pt idx="655">0.84899999999999998</cx:pt>
          <cx:pt idx="656">0.84899999999999998</cx:pt>
          <cx:pt idx="657">0.84899999999999998</cx:pt>
          <cx:pt idx="658">0.84899999999999998</cx:pt>
          <cx:pt idx="659">0.85216666666666674</cx:pt>
          <cx:pt idx="660">0.85449999999999993</cx:pt>
          <cx:pt idx="661">0.85960000000000003</cx:pt>
          <cx:pt idx="662">0.86657142857142855</cx:pt>
          <cx:pt idx="663">0.86657142857142855</cx:pt>
          <cx:pt idx="664">0.86657142857142855</cx:pt>
          <cx:pt idx="665">0.86657142857142855</cx:pt>
          <cx:pt idx="666">0.87357142857142855</cx:pt>
          <cx:pt idx="667">0.8798125</cx:pt>
          <cx:pt idx="668">0.88200000000000001</cx:pt>
          <cx:pt idx="669">0.88273076923076921</cx:pt>
          <cx:pt idx="670">0.88273076923076921</cx:pt>
          <cx:pt idx="671">0.88273076923076921</cx:pt>
          <cx:pt idx="672">0.8857647058823529</cx:pt>
          <cx:pt idx="673">0.88713157894736838</cx:pt>
          <cx:pt idx="674">0.88963636363636356</cx:pt>
          <cx:pt idx="675">0.89061538461538459</cx:pt>
          <cx:pt idx="676">0.89061538461538459</cx:pt>
          <cx:pt idx="677">0.89640000000000009</cx:pt>
          <cx:pt idx="678">0.90942857142857136</cx:pt>
          <cx:pt idx="679">0.91800000000000004</cx:pt>
          <cx:pt idx="680">0.91803999999999997</cx:pt>
          <cx:pt idx="681">0.91803999999999997</cx:pt>
          <cx:pt idx="682">0.93077777777777781</cx:pt>
          <cx:pt idx="683">0.93077777777777781</cx:pt>
          <cx:pt idx="684">0.93077777777777781</cx:pt>
          <cx:pt idx="685">0.93077777777777781</cx:pt>
          <cx:pt idx="686">0.93077777777777781</cx:pt>
          <cx:pt idx="687">0.93077777777777781</cx:pt>
          <cx:pt idx="688">0.93077777777777781</cx:pt>
          <cx:pt idx="689">0.93077777777777781</cx:pt>
          <cx:pt idx="690">0.93077777777777781</cx:pt>
          <cx:pt idx="691">0.93077777777777781</cx:pt>
          <cx:pt idx="692">0.93077777777777781</cx:pt>
          <cx:pt idx="693">0.93077777777777781</cx:pt>
          <cx:pt idx="694">0.93218181818181811</cx:pt>
          <cx:pt idx="695">0.93218181818181811</cx:pt>
          <cx:pt idx="696">0.93218181818181811</cx:pt>
          <cx:pt idx="697">0.93218181818181811</cx:pt>
          <cx:pt idx="698">0.93218181818181811</cx:pt>
          <cx:pt idx="699">0.93846666666666667</cx:pt>
          <cx:pt idx="700">0.95300000000000007</cx:pt>
          <cx:pt idx="701">0.95511111111111113</cx:pt>
          <cx:pt idx="702">0.95629166666666665</cx:pt>
          <cx:pt idx="703">0.95629166666666665</cx:pt>
          <cx:pt idx="704">0.95629166666666665</cx:pt>
          <cx:pt idx="705">0.95629166666666665</cx:pt>
          <cx:pt idx="706">0.95669230769230762</cx:pt>
          <cx:pt idx="707">0.95750000000000002</cx:pt>
          <cx:pt idx="708">0.96483333333333332</cx:pt>
          <cx:pt idx="709">0.96483333333333332</cx:pt>
          <cx:pt idx="710">0.96483333333333332</cx:pt>
          <cx:pt idx="711">0.96483333333333332</cx:pt>
          <cx:pt idx="712">0.96883333333333332</cx:pt>
          <cx:pt idx="713">0.997</cx:pt>
          <cx:pt idx="714">1.00065</cx:pt>
          <cx:pt idx="715">1.0075000000000001</cx:pt>
          <cx:pt idx="716">1.008368421052632</cx:pt>
          <cx:pt idx="717">1.0112000000000001</cx:pt>
          <cx:pt idx="718">1.01485</cx:pt>
          <cx:pt idx="719">1.0292857142857139</cx:pt>
          <cx:pt idx="720">1.0432272727272729</cx:pt>
          <cx:pt idx="721">1.0432272727272729</cx:pt>
          <cx:pt idx="722">1.0432272727272729</cx:pt>
          <cx:pt idx="723">1.0432272727272729</cx:pt>
          <cx:pt idx="724">1.0432272727272729</cx:pt>
          <cx:pt idx="725">1.0432272727272729</cx:pt>
          <cx:pt idx="726">1.0471250000000001</cx:pt>
          <cx:pt idx="727">1.0471250000000001</cx:pt>
          <cx:pt idx="728">1.0471250000000001</cx:pt>
          <cx:pt idx="729">1.0471250000000001</cx:pt>
          <cx:pt idx="730">1.0471250000000001</cx:pt>
          <cx:pt idx="731">1.0471250000000001</cx:pt>
          <cx:pt idx="732">1.0471250000000001</cx:pt>
          <cx:pt idx="733">1.0471250000000001</cx:pt>
          <cx:pt idx="734">1.0471250000000001</cx:pt>
          <cx:pt idx="735">1.0471250000000001</cx:pt>
          <cx:pt idx="736">1.0471250000000001</cx:pt>
          <cx:pt idx="737">1.0525454545454549</cx:pt>
          <cx:pt idx="738">1.0526666666666671</cx:pt>
          <cx:pt idx="739">1.0584</cx:pt>
          <cx:pt idx="740">1.0609999999999999</cx:pt>
          <cx:pt idx="741">1.06125</cx:pt>
          <cx:pt idx="742">1.06125</cx:pt>
          <cx:pt idx="743">1.06125</cx:pt>
          <cx:pt idx="744">1.06125</cx:pt>
          <cx:pt idx="745">1.06125</cx:pt>
          <cx:pt idx="746">1.082846153846154</cx:pt>
          <cx:pt idx="747">1.084888888888889</cx:pt>
          <cx:pt idx="748">1.1015999999999999</cx:pt>
          <cx:pt idx="749">1.1084000000000001</cx:pt>
          <cx:pt idx="750">1.1235555555555561</cx:pt>
          <cx:pt idx="751">1.1235555555555561</cx:pt>
          <cx:pt idx="752">1.1235555555555561</cx:pt>
          <cx:pt idx="753">1.127</cx:pt>
          <cx:pt idx="754">1.1393333333333331</cx:pt>
          <cx:pt idx="755">1.1393333333333331</cx:pt>
          <cx:pt idx="756">1.1393333333333331</cx:pt>
          <cx:pt idx="757">1.1393333333333331</cx:pt>
          <cx:pt idx="758">1.139909090909091</cx:pt>
          <cx:pt idx="759">1.154333333333333</cx:pt>
          <cx:pt idx="760">1.1577999999999999</cx:pt>
          <cx:pt idx="761">1.158307692307692</cx:pt>
          <cx:pt idx="762">1.16475</cx:pt>
          <cx:pt idx="763">1.173083333333333</cx:pt>
          <cx:pt idx="764">1.1797500000000001</cx:pt>
          <cx:pt idx="765">1.1967142857142861</cx:pt>
          <cx:pt idx="766">1.1967142857142861</cx:pt>
          <cx:pt idx="767">1.1967142857142861</cx:pt>
          <cx:pt idx="768">1.1967142857142861</cx:pt>
          <cx:pt idx="769">1.1967142857142861</cx:pt>
          <cx:pt idx="770">1.1967142857142861</cx:pt>
          <cx:pt idx="771">1.1967142857142861</cx:pt>
          <cx:pt idx="772">1.224</cx:pt>
          <cx:pt idx="773">1.2450000000000001</cx:pt>
          <cx:pt idx="774">1.2450000000000001</cx:pt>
          <cx:pt idx="775">1.2450000000000001</cx:pt>
          <cx:pt idx="776">1.2450000000000001</cx:pt>
          <cx:pt idx="777">1.2450000000000001</cx:pt>
          <cx:pt idx="778">1.2450000000000001</cx:pt>
          <cx:pt idx="779">1.264</cx:pt>
          <cx:pt idx="780">1.264</cx:pt>
          <cx:pt idx="781">1.264</cx:pt>
          <cx:pt idx="782">1.2732000000000001</cx:pt>
          <cx:pt idx="783">1.277266666666667</cx:pt>
          <cx:pt idx="784">1.2817499999999999</cx:pt>
          <cx:pt idx="785">1.2817499999999999</cx:pt>
          <cx:pt idx="786">1.2817499999999999</cx:pt>
          <cx:pt idx="787">1.2817499999999999</cx:pt>
          <cx:pt idx="788">1.2817499999999999</cx:pt>
          <cx:pt idx="789">1.3126</cx:pt>
          <cx:pt idx="790">1.3126</cx:pt>
          <cx:pt idx="791">1.4035</cx:pt>
          <cx:pt idx="792">1.4035</cx:pt>
          <cx:pt idx="793">1.4648571428571431</cx:pt>
          <cx:pt idx="794">1.4648571428571431</cx:pt>
          <cx:pt idx="795">1.4648571428571431</cx:pt>
          <cx:pt idx="796">1.4648571428571431</cx:pt>
          <cx:pt idx="797">1.5009999999999999</cx:pt>
          <cx:pt idx="798">1.6693333333333329</cx:pt>
          <cx:pt idx="799">1.7090000000000001</cx:pt>
          <cx:pt idx="800">1.7090000000000001</cx:pt>
          <cx:pt idx="801">2.0150000000000001</cx:pt>
          <cx:pt idx="802">2.0508000000000002</cx:pt>
        </cx:lvl>
      </cx:numDim>
    </cx:data>
  </cx:chartData>
  <cx:chart>
    <cx:title pos="t" align="ctr" overlay="0">
      <cx:tx>
        <cx:txData>
          <cx:v/>
        </cx:txData>
      </cx:tx>
      <cx:txPr>
        <a:bodyPr spcFirstLastPara="1" vertOverflow="ellipsis" wrap="square" lIns="0" tIns="0" rIns="0" bIns="0" anchor="ctr" anchorCtr="1"/>
        <a:lstStyle/>
        <a:p>
          <a:pPr algn="ctr">
            <a:defRPr/>
          </a:pPr>
          <a:endParaRPr/>
        </a:p>
      </cx:txPr>
    </cx:title>
    <cx:plotArea>
      <cx:plotAreaRegion>
        <cx:series layoutId="boxWhisker" uniqueId="{4182C088-BBF1-40C3-8A6B-46B290DE937D}">
          <cx:dataId val="0"/>
          <cx:layoutPr>
            <cx:visibility meanLine="0" meanMarker="1" nonoutliers="0" outliers="1"/>
            <cx:statistics quartileMethod="exclusive"/>
          </cx:layoutPr>
        </cx:series>
      </cx:plotAreaRegion>
      <cx:axis id="0">
        <cx:catScaling gapWidth="1"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tickLabels/>
      </cx:axis>
      <cx:axis id="1">
        <cx:valScaling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majorGridlines/>
        <cx:tickLabels/>
      </cx:axis>
    </cx:plotArea>
  </cx:chart>
</cx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10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3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4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5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6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7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8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9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F2C84-B101-406A-A792-5C3B57B301B1}" type="datetimeFigureOut">
              <a:rPr lang="de-DE" smtClean="0"/>
              <a:t>22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C2104-F8E9-4010-82B0-FD3BC9FEC9D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439089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F2C84-B101-406A-A792-5C3B57B301B1}" type="datetimeFigureOut">
              <a:rPr lang="de-DE" smtClean="0"/>
              <a:t>22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C2104-F8E9-4010-82B0-FD3BC9FEC9D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222175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F2C84-B101-406A-A792-5C3B57B301B1}" type="datetimeFigureOut">
              <a:rPr lang="de-DE" smtClean="0"/>
              <a:t>22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C2104-F8E9-4010-82B0-FD3BC9FEC9D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561073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F2C84-B101-406A-A792-5C3B57B301B1}" type="datetimeFigureOut">
              <a:rPr lang="de-DE" smtClean="0"/>
              <a:t>22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C2104-F8E9-4010-82B0-FD3BC9FEC9D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454413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F2C84-B101-406A-A792-5C3B57B301B1}" type="datetimeFigureOut">
              <a:rPr lang="de-DE" smtClean="0"/>
              <a:t>22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C2104-F8E9-4010-82B0-FD3BC9FEC9D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473837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F2C84-B101-406A-A792-5C3B57B301B1}" type="datetimeFigureOut">
              <a:rPr lang="de-DE" smtClean="0"/>
              <a:t>22.08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C2104-F8E9-4010-82B0-FD3BC9FEC9D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564674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F2C84-B101-406A-A792-5C3B57B301B1}" type="datetimeFigureOut">
              <a:rPr lang="de-DE" smtClean="0"/>
              <a:t>22.08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C2104-F8E9-4010-82B0-FD3BC9FEC9D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389117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F2C84-B101-406A-A792-5C3B57B301B1}" type="datetimeFigureOut">
              <a:rPr lang="de-DE" smtClean="0"/>
              <a:t>22.08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C2104-F8E9-4010-82B0-FD3BC9FEC9D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48740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F2C84-B101-406A-A792-5C3B57B301B1}" type="datetimeFigureOut">
              <a:rPr lang="de-DE" smtClean="0"/>
              <a:t>22.08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C2104-F8E9-4010-82B0-FD3BC9FEC9D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520182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F2C84-B101-406A-A792-5C3B57B301B1}" type="datetimeFigureOut">
              <a:rPr lang="de-DE" smtClean="0"/>
              <a:t>22.08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C2104-F8E9-4010-82B0-FD3BC9FEC9D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649318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F2C84-B101-406A-A792-5C3B57B301B1}" type="datetimeFigureOut">
              <a:rPr lang="de-DE" smtClean="0"/>
              <a:t>22.08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C2104-F8E9-4010-82B0-FD3BC9FEC9D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406181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BF2C84-B101-406A-A792-5C3B57B301B1}" type="datetimeFigureOut">
              <a:rPr lang="de-DE" smtClean="0"/>
              <a:t>22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AC2104-F8E9-4010-82B0-FD3BC9FEC9D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190418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14/relationships/chartEx" Target="../charts/chartEx4.xml"/><Relationship Id="rId13" Type="http://schemas.openxmlformats.org/officeDocument/2006/relationships/image" Target="../media/image6.png"/><Relationship Id="rId18" Type="http://schemas.microsoft.com/office/2014/relationships/chartEx" Target="../charts/chartEx9.xml"/><Relationship Id="rId3" Type="http://schemas.openxmlformats.org/officeDocument/2006/relationships/image" Target="../media/image1.png"/><Relationship Id="rId21" Type="http://schemas.openxmlformats.org/officeDocument/2006/relationships/image" Target="../media/image10.png"/><Relationship Id="rId7" Type="http://schemas.openxmlformats.org/officeDocument/2006/relationships/image" Target="../media/image3.png"/><Relationship Id="rId12" Type="http://schemas.microsoft.com/office/2014/relationships/chartEx" Target="../charts/chartEx6.xml"/><Relationship Id="rId17" Type="http://schemas.openxmlformats.org/officeDocument/2006/relationships/image" Target="../media/image8.png"/><Relationship Id="rId2" Type="http://schemas.microsoft.com/office/2014/relationships/chartEx" Target="../charts/chartEx1.xml"/><Relationship Id="rId16" Type="http://schemas.microsoft.com/office/2014/relationships/chartEx" Target="../charts/chartEx8.xml"/><Relationship Id="rId20" Type="http://schemas.microsoft.com/office/2014/relationships/chartEx" Target="../charts/chartEx10.xml"/><Relationship Id="rId1" Type="http://schemas.openxmlformats.org/officeDocument/2006/relationships/slideLayout" Target="../slideLayouts/slideLayout1.xml"/><Relationship Id="rId6" Type="http://schemas.microsoft.com/office/2014/relationships/chartEx" Target="../charts/chartEx3.xml"/><Relationship Id="rId11" Type="http://schemas.openxmlformats.org/officeDocument/2006/relationships/image" Target="../media/image5.png"/><Relationship Id="rId5" Type="http://schemas.openxmlformats.org/officeDocument/2006/relationships/image" Target="../media/image2.png"/><Relationship Id="rId15" Type="http://schemas.openxmlformats.org/officeDocument/2006/relationships/image" Target="../media/image7.png"/><Relationship Id="rId10" Type="http://schemas.microsoft.com/office/2014/relationships/chartEx" Target="../charts/chartEx5.xml"/><Relationship Id="rId19" Type="http://schemas.openxmlformats.org/officeDocument/2006/relationships/image" Target="../media/image9.png"/><Relationship Id="rId4" Type="http://schemas.microsoft.com/office/2014/relationships/chartEx" Target="../charts/chartEx2.xml"/><Relationship Id="rId9" Type="http://schemas.openxmlformats.org/officeDocument/2006/relationships/image" Target="../media/image4.png"/><Relationship Id="rId14" Type="http://schemas.microsoft.com/office/2014/relationships/chartEx" Target="../charts/chartEx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5" name="Chart 7"/>
              <p:cNvGraphicFramePr/>
              <p:nvPr>
                <p:extLst>
                  <p:ext uri="{D42A27DB-BD31-4B8C-83A1-F6EECF244321}">
                    <p14:modId xmlns:p14="http://schemas.microsoft.com/office/powerpoint/2010/main" val="2525189081"/>
                  </p:ext>
                </p:extLst>
              </p:nvPr>
            </p:nvGraphicFramePr>
            <p:xfrm>
              <a:off x="5325439" y="2057400"/>
              <a:ext cx="1707222" cy="27432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2"/>
              </a:graphicData>
            </a:graphic>
          </p:graphicFrame>
        </mc:Choice>
        <mc:Fallback xmlns="">
          <p:pic>
            <p:nvPicPr>
              <p:cNvPr id="5" name="Chart 7"/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5325439" y="2057400"/>
                <a:ext cx="1707222" cy="27432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6" name="Chart 7"/>
              <p:cNvGraphicFramePr/>
              <p:nvPr>
                <p:extLst>
                  <p:ext uri="{D42A27DB-BD31-4B8C-83A1-F6EECF244321}">
                    <p14:modId xmlns:p14="http://schemas.microsoft.com/office/powerpoint/2010/main" val="2107358546"/>
                  </p:ext>
                </p:extLst>
              </p:nvPr>
            </p:nvGraphicFramePr>
            <p:xfrm>
              <a:off x="3667875" y="2057400"/>
              <a:ext cx="1695236" cy="27432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4"/>
              </a:graphicData>
            </a:graphic>
          </p:graphicFrame>
        </mc:Choice>
        <mc:Fallback xmlns="">
          <p:pic>
            <p:nvPicPr>
              <p:cNvPr id="6" name="Chart 7"/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3667875" y="2057400"/>
                <a:ext cx="1695236" cy="27432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7" name="Chart 7"/>
              <p:cNvGraphicFramePr/>
              <p:nvPr>
                <p:extLst>
                  <p:ext uri="{D42A27DB-BD31-4B8C-83A1-F6EECF244321}">
                    <p14:modId xmlns:p14="http://schemas.microsoft.com/office/powerpoint/2010/main" val="3825678394"/>
                  </p:ext>
                </p:extLst>
              </p:nvPr>
            </p:nvGraphicFramePr>
            <p:xfrm>
              <a:off x="7106129" y="2072811"/>
              <a:ext cx="1876746" cy="27432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6"/>
              </a:graphicData>
            </a:graphic>
          </p:graphicFrame>
        </mc:Choice>
        <mc:Fallback xmlns="">
          <p:pic>
            <p:nvPicPr>
              <p:cNvPr id="7" name="Chart 7"/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7106129" y="2072811"/>
                <a:ext cx="1876746" cy="27432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8" name="Chart 7"/>
              <p:cNvGraphicFramePr/>
              <p:nvPr>
                <p:extLst>
                  <p:ext uri="{D42A27DB-BD31-4B8C-83A1-F6EECF244321}">
                    <p14:modId xmlns:p14="http://schemas.microsoft.com/office/powerpoint/2010/main" val="363947449"/>
                  </p:ext>
                </p:extLst>
              </p:nvPr>
            </p:nvGraphicFramePr>
            <p:xfrm>
              <a:off x="8797036" y="2057400"/>
              <a:ext cx="1553532" cy="27432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8"/>
              </a:graphicData>
            </a:graphic>
          </p:graphicFrame>
        </mc:Choice>
        <mc:Fallback xmlns="">
          <p:pic>
            <p:nvPicPr>
              <p:cNvPr id="8" name="Chart 7"/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8797036" y="2057400"/>
                <a:ext cx="1553532" cy="27432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9" name="Chart 7"/>
              <p:cNvGraphicFramePr/>
              <p:nvPr>
                <p:extLst>
                  <p:ext uri="{D42A27DB-BD31-4B8C-83A1-F6EECF244321}">
                    <p14:modId xmlns:p14="http://schemas.microsoft.com/office/powerpoint/2010/main" val="709752734"/>
                  </p:ext>
                </p:extLst>
              </p:nvPr>
            </p:nvGraphicFramePr>
            <p:xfrm>
              <a:off x="10200526" y="2057400"/>
              <a:ext cx="1690099" cy="27432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10"/>
              </a:graphicData>
            </a:graphic>
          </p:graphicFrame>
        </mc:Choice>
        <mc:Fallback xmlns="">
          <p:pic>
            <p:nvPicPr>
              <p:cNvPr id="9" name="Chart 7"/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10200526" y="2057400"/>
                <a:ext cx="1690099" cy="2743200"/>
              </a:xfrm>
              <a:prstGeom prst="rect">
                <a:avLst/>
              </a:prstGeom>
            </p:spPr>
          </p:pic>
        </mc:Fallback>
      </mc:AlternateContent>
      <p:sp>
        <p:nvSpPr>
          <p:cNvPr id="10" name="Rechteck 9"/>
          <p:cNvSpPr/>
          <p:nvPr/>
        </p:nvSpPr>
        <p:spPr>
          <a:xfrm>
            <a:off x="1875035" y="2388742"/>
            <a:ext cx="1335640" cy="23137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hieved</a:t>
            </a:r>
          </a:p>
        </p:txBody>
      </p:sp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11" name="Chart 7"/>
              <p:cNvGraphicFramePr/>
              <p:nvPr>
                <p:extLst>
                  <p:ext uri="{D42A27DB-BD31-4B8C-83A1-F6EECF244321}">
                    <p14:modId xmlns:p14="http://schemas.microsoft.com/office/powerpoint/2010/main" val="2914592466"/>
                  </p:ext>
                </p:extLst>
              </p:nvPr>
            </p:nvGraphicFramePr>
            <p:xfrm>
              <a:off x="3622078" y="-209764"/>
              <a:ext cx="1793691" cy="27432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12"/>
              </a:graphicData>
            </a:graphic>
          </p:graphicFrame>
        </mc:Choice>
        <mc:Fallback xmlns="">
          <p:pic>
            <p:nvPicPr>
              <p:cNvPr id="11" name="Chart 7"/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3622078" y="-209764"/>
                <a:ext cx="1793691" cy="27432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12" name="Chart 7"/>
              <p:cNvGraphicFramePr/>
              <p:nvPr>
                <p:extLst>
                  <p:ext uri="{D42A27DB-BD31-4B8C-83A1-F6EECF244321}">
                    <p14:modId xmlns:p14="http://schemas.microsoft.com/office/powerpoint/2010/main" val="4203879884"/>
                  </p:ext>
                </p:extLst>
              </p:nvPr>
            </p:nvGraphicFramePr>
            <p:xfrm>
              <a:off x="5308958" y="-247436"/>
              <a:ext cx="1830514" cy="27432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14"/>
              </a:graphicData>
            </a:graphic>
          </p:graphicFrame>
        </mc:Choice>
        <mc:Fallback xmlns="">
          <p:pic>
            <p:nvPicPr>
              <p:cNvPr id="12" name="Chart 7"/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5308958" y="-247436"/>
                <a:ext cx="1830514" cy="27432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13" name="Chart 7"/>
              <p:cNvGraphicFramePr/>
              <p:nvPr>
                <p:extLst>
                  <p:ext uri="{D42A27DB-BD31-4B8C-83A1-F6EECF244321}">
                    <p14:modId xmlns:p14="http://schemas.microsoft.com/office/powerpoint/2010/main" val="593314101"/>
                  </p:ext>
                </p:extLst>
              </p:nvPr>
            </p:nvGraphicFramePr>
            <p:xfrm>
              <a:off x="7135400" y="-247436"/>
              <a:ext cx="1859623" cy="27432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16"/>
              </a:graphicData>
            </a:graphic>
          </p:graphicFrame>
        </mc:Choice>
        <mc:Fallback xmlns="">
          <p:pic>
            <p:nvPicPr>
              <p:cNvPr id="13" name="Chart 7"/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17"/>
              <a:stretch>
                <a:fillRect/>
              </a:stretch>
            </p:blipFill>
            <p:spPr>
              <a:xfrm>
                <a:off x="7135400" y="-247436"/>
                <a:ext cx="1859623" cy="27432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14" name="Chart 7"/>
              <p:cNvGraphicFramePr/>
              <p:nvPr>
                <p:extLst>
                  <p:ext uri="{D42A27DB-BD31-4B8C-83A1-F6EECF244321}">
                    <p14:modId xmlns:p14="http://schemas.microsoft.com/office/powerpoint/2010/main" val="2122970562"/>
                  </p:ext>
                </p:extLst>
              </p:nvPr>
            </p:nvGraphicFramePr>
            <p:xfrm>
              <a:off x="8859103" y="-209764"/>
              <a:ext cx="1491465" cy="27432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18"/>
              </a:graphicData>
            </a:graphic>
          </p:graphicFrame>
        </mc:Choice>
        <mc:Fallback xmlns="">
          <p:pic>
            <p:nvPicPr>
              <p:cNvPr id="14" name="Chart 7"/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19"/>
              <a:stretch>
                <a:fillRect/>
              </a:stretch>
            </p:blipFill>
            <p:spPr>
              <a:xfrm>
                <a:off x="8859103" y="-209764"/>
                <a:ext cx="1491465" cy="27432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15" name="Chart 7"/>
              <p:cNvGraphicFramePr/>
              <p:nvPr>
                <p:extLst>
                  <p:ext uri="{D42A27DB-BD31-4B8C-83A1-F6EECF244321}">
                    <p14:modId xmlns:p14="http://schemas.microsoft.com/office/powerpoint/2010/main" val="875550204"/>
                  </p:ext>
                </p:extLst>
              </p:nvPr>
            </p:nvGraphicFramePr>
            <p:xfrm>
              <a:off x="10352926" y="-209764"/>
              <a:ext cx="1402422" cy="27432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20"/>
              </a:graphicData>
            </a:graphic>
          </p:graphicFrame>
        </mc:Choice>
        <mc:Fallback xmlns="">
          <p:pic>
            <p:nvPicPr>
              <p:cNvPr id="15" name="Chart 7"/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21"/>
              <a:stretch>
                <a:fillRect/>
              </a:stretch>
            </p:blipFill>
            <p:spPr>
              <a:xfrm>
                <a:off x="10352926" y="-209764"/>
                <a:ext cx="1402422" cy="2743200"/>
              </a:xfrm>
              <a:prstGeom prst="rect">
                <a:avLst/>
              </a:prstGeom>
            </p:spPr>
          </p:pic>
        </mc:Fallback>
      </mc:AlternateContent>
      <p:sp>
        <p:nvSpPr>
          <p:cNvPr id="16" name="Rechteck 15"/>
          <p:cNvSpPr/>
          <p:nvPr/>
        </p:nvSpPr>
        <p:spPr>
          <a:xfrm>
            <a:off x="1875035" y="113872"/>
            <a:ext cx="1335640" cy="215158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t achieved</a:t>
            </a:r>
          </a:p>
        </p:txBody>
      </p:sp>
      <p:sp>
        <p:nvSpPr>
          <p:cNvPr id="17" name="Rechteck 16"/>
          <p:cNvSpPr/>
          <p:nvPr/>
        </p:nvSpPr>
        <p:spPr>
          <a:xfrm>
            <a:off x="359596" y="124146"/>
            <a:ext cx="1335640" cy="457836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in monitoring adherence</a:t>
            </a:r>
            <a:endParaRPr lang="de-DE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8" name="Tabelle 1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78688462"/>
              </p:ext>
            </p:extLst>
          </p:nvPr>
        </p:nvGraphicFramePr>
        <p:xfrm>
          <a:off x="4102865" y="4367226"/>
          <a:ext cx="7881938" cy="282321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511168">
                  <a:extLst>
                    <a:ext uri="{9D8B030D-6E8A-4147-A177-3AD203B41FA5}">
                      <a16:colId xmlns:a16="http://schemas.microsoft.com/office/drawing/2014/main" val="842850166"/>
                    </a:ext>
                  </a:extLst>
                </a:gridCol>
                <a:gridCol w="1665207">
                  <a:extLst>
                    <a:ext uri="{9D8B030D-6E8A-4147-A177-3AD203B41FA5}">
                      <a16:colId xmlns:a16="http://schemas.microsoft.com/office/drawing/2014/main" val="840039100"/>
                    </a:ext>
                  </a:extLst>
                </a:gridCol>
                <a:gridCol w="1740415">
                  <a:extLst>
                    <a:ext uri="{9D8B030D-6E8A-4147-A177-3AD203B41FA5}">
                      <a16:colId xmlns:a16="http://schemas.microsoft.com/office/drawing/2014/main" val="983577393"/>
                    </a:ext>
                  </a:extLst>
                </a:gridCol>
                <a:gridCol w="1482574">
                  <a:extLst>
                    <a:ext uri="{9D8B030D-6E8A-4147-A177-3AD203B41FA5}">
                      <a16:colId xmlns:a16="http://schemas.microsoft.com/office/drawing/2014/main" val="947577543"/>
                    </a:ext>
                  </a:extLst>
                </a:gridCol>
                <a:gridCol w="1482574">
                  <a:extLst>
                    <a:ext uri="{9D8B030D-6E8A-4147-A177-3AD203B41FA5}">
                      <a16:colId xmlns:a16="http://schemas.microsoft.com/office/drawing/2014/main" val="248680300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ospital LoS</a:t>
                      </a:r>
                      <a:endParaRPr lang="de-DE" sz="1100" b="1" kern="1200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CU LoS</a:t>
                      </a:r>
                      <a:endParaRPr lang="de-DE" sz="1100" b="1" kern="1200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uration of MV</a:t>
                      </a:r>
                      <a:endParaRPr lang="de-DE" sz="1100" b="1" kern="1200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de-DE" sz="1100" b="1" kern="1200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se Mix per day</a:t>
                      </a:r>
                    </a:p>
                  </a:txBody>
                  <a:tcPr marL="17780" marR="177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de-DE" sz="1100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rofit per day</a:t>
                      </a:r>
                    </a:p>
                  </a:txBody>
                  <a:tcPr marL="17780" marR="17780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60111285"/>
                  </a:ext>
                </a:extLst>
              </a:tr>
            </a:tbl>
          </a:graphicData>
        </a:graphic>
      </p:graphicFrame>
      <p:graphicFrame>
        <p:nvGraphicFramePr>
          <p:cNvPr id="19" name="Tabelle 1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22721749"/>
              </p:ext>
            </p:extLst>
          </p:nvPr>
        </p:nvGraphicFramePr>
        <p:xfrm>
          <a:off x="4124242" y="2072811"/>
          <a:ext cx="7881938" cy="282321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511168">
                  <a:extLst>
                    <a:ext uri="{9D8B030D-6E8A-4147-A177-3AD203B41FA5}">
                      <a16:colId xmlns:a16="http://schemas.microsoft.com/office/drawing/2014/main" val="842850166"/>
                    </a:ext>
                  </a:extLst>
                </a:gridCol>
                <a:gridCol w="1665207">
                  <a:extLst>
                    <a:ext uri="{9D8B030D-6E8A-4147-A177-3AD203B41FA5}">
                      <a16:colId xmlns:a16="http://schemas.microsoft.com/office/drawing/2014/main" val="840039100"/>
                    </a:ext>
                  </a:extLst>
                </a:gridCol>
                <a:gridCol w="1740415">
                  <a:extLst>
                    <a:ext uri="{9D8B030D-6E8A-4147-A177-3AD203B41FA5}">
                      <a16:colId xmlns:a16="http://schemas.microsoft.com/office/drawing/2014/main" val="983577393"/>
                    </a:ext>
                  </a:extLst>
                </a:gridCol>
                <a:gridCol w="1482574">
                  <a:extLst>
                    <a:ext uri="{9D8B030D-6E8A-4147-A177-3AD203B41FA5}">
                      <a16:colId xmlns:a16="http://schemas.microsoft.com/office/drawing/2014/main" val="947577543"/>
                    </a:ext>
                  </a:extLst>
                </a:gridCol>
                <a:gridCol w="1482574">
                  <a:extLst>
                    <a:ext uri="{9D8B030D-6E8A-4147-A177-3AD203B41FA5}">
                      <a16:colId xmlns:a16="http://schemas.microsoft.com/office/drawing/2014/main" val="248680300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ospital LoS</a:t>
                      </a:r>
                      <a:endParaRPr lang="de-DE" sz="1100" b="1" kern="1200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CU LoS</a:t>
                      </a:r>
                      <a:endParaRPr lang="de-DE" sz="1100" b="1" kern="1200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uration of MV</a:t>
                      </a:r>
                      <a:endParaRPr lang="de-DE" sz="1100" b="1" kern="1200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de-DE" sz="1100" b="1" kern="1200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se Mix per day</a:t>
                      </a:r>
                    </a:p>
                  </a:txBody>
                  <a:tcPr marL="17780" marR="177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de-DE" sz="1100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rofit per day</a:t>
                      </a:r>
                    </a:p>
                  </a:txBody>
                  <a:tcPr marL="17780" marR="17780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60111285"/>
                  </a:ext>
                </a:extLst>
              </a:tr>
            </a:tbl>
          </a:graphicData>
        </a:graphic>
      </p:graphicFrame>
      <p:sp>
        <p:nvSpPr>
          <p:cNvPr id="2" name="Rechteck 1"/>
          <p:cNvSpPr/>
          <p:nvPr/>
        </p:nvSpPr>
        <p:spPr>
          <a:xfrm>
            <a:off x="359596" y="4825796"/>
            <a:ext cx="48247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GB" i="1" dirty="0">
                <a:solidFill>
                  <a:srgbClr val="44546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1 Fig 1: Boxplots for pain monitoring adherence</a:t>
            </a:r>
            <a:endParaRPr lang="de-DE" i="1" dirty="0">
              <a:solidFill>
                <a:srgbClr val="44546A"/>
              </a:solidFill>
              <a:latin typeface="Arial Narrow" panose="020B0606020202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607563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3</Words>
  <Application>Microsoft Office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Arial Narrow</vt:lpstr>
      <vt:lpstr>Calibri</vt:lpstr>
      <vt:lpstr>Calibri Light</vt:lpstr>
      <vt:lpstr>Times New Roman</vt:lpstr>
      <vt:lpstr>Office</vt:lpstr>
      <vt:lpstr>PowerPoint Presentation</vt:lpstr>
    </vt:vector>
  </TitlesOfParts>
  <Company>Charité Universitaetsmedizin Berli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effland, Marc</dc:creator>
  <cp:lastModifiedBy>chn off29</cp:lastModifiedBy>
  <cp:revision>11</cp:revision>
  <dcterms:created xsi:type="dcterms:W3CDTF">2020-04-18T09:39:36Z</dcterms:created>
  <dcterms:modified xsi:type="dcterms:W3CDTF">2020-08-22T13:05:18Z</dcterms:modified>
</cp:coreProperties>
</file>